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301" r:id="rId2"/>
    <p:sldId id="289" r:id="rId3"/>
    <p:sldId id="293" r:id="rId4"/>
    <p:sldId id="298" r:id="rId5"/>
    <p:sldId id="300" r:id="rId6"/>
    <p:sldId id="302" r:id="rId7"/>
    <p:sldId id="303" r:id="rId8"/>
  </p:sldIdLst>
  <p:sldSz cx="6858000" cy="9144000" type="screen4x3"/>
  <p:notesSz cx="6797675" cy="9926638"/>
  <p:defaultTextStyle>
    <a:defPPr>
      <a:defRPr lang="it-IT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00CC00"/>
    <a:srgbClr val="5F5F5F"/>
    <a:srgbClr val="FF9900"/>
    <a:srgbClr val="CC00FF"/>
    <a:srgbClr val="0000FF"/>
    <a:srgbClr val="78A888"/>
    <a:srgbClr val="00FF00"/>
    <a:srgbClr val="66FF33"/>
    <a:srgbClr val="4CD45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50EEF2B-F101-4710-9E96-E006CC520A49}" v="7" dt="2022-03-25T14:34:54.80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ile medio 2 - Colore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Stile medio 2 - Colore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75DCB02-9BB8-47FD-8907-85C794F793BA}" styleName="Stile con tema 1 - Colore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EB344D84-9AFB-497E-A393-DC336BA19D2E}" styleName="Stile medio 3 - Colore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83" autoAdjust="0"/>
    <p:restoredTop sz="95683" autoAdjust="0"/>
  </p:normalViewPr>
  <p:slideViewPr>
    <p:cSldViewPr>
      <p:cViewPr>
        <p:scale>
          <a:sx n="125" d="100"/>
          <a:sy n="125" d="100"/>
        </p:scale>
        <p:origin x="1212" y="-1158"/>
      </p:cViewPr>
      <p:guideLst>
        <p:guide orient="horz" pos="2880"/>
        <p:guide pos="2160"/>
      </p:guideLst>
    </p:cSldViewPr>
  </p:slideViewPr>
  <p:outlineViewPr>
    <p:cViewPr>
      <p:scale>
        <a:sx n="75" d="100"/>
        <a:sy n="75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ilippo Acconcia" userId="844af49c-a8a0-47ac-a7dd-14a44b60cd18" providerId="ADAL" clId="{4E01D738-D0C1-4B9B-B836-CF053EEC4C53}"/>
    <pc:docChg chg="undo custSel addSld modSld">
      <pc:chgData name="Filippo Acconcia" userId="844af49c-a8a0-47ac-a7dd-14a44b60cd18" providerId="ADAL" clId="{4E01D738-D0C1-4B9B-B836-CF053EEC4C53}" dt="2022-03-16T14:09:03.033" v="1920" actId="553"/>
      <pc:docMkLst>
        <pc:docMk/>
      </pc:docMkLst>
      <pc:sldChg chg="modSp">
        <pc:chgData name="Filippo Acconcia" userId="844af49c-a8a0-47ac-a7dd-14a44b60cd18" providerId="ADAL" clId="{4E01D738-D0C1-4B9B-B836-CF053EEC4C53}" dt="2022-03-16T08:35:31.402" v="753"/>
        <pc:sldMkLst>
          <pc:docMk/>
          <pc:sldMk cId="714323932" sldId="289"/>
        </pc:sldMkLst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714323932" sldId="289"/>
            <ac:spMk id="258" creationId="{90C7810D-84C2-4CAC-84CF-7711423E293E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714323932" sldId="289"/>
            <ac:spMk id="259" creationId="{6DECAA21-94F0-44F2-984F-C566F3F4EDB7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714323932" sldId="289"/>
            <ac:spMk id="260" creationId="{9519ECF2-D9B9-4590-8BD6-C9DAF593D459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714323932" sldId="289"/>
            <ac:spMk id="261" creationId="{D8B34ED6-60D5-4087-B8EF-68955D7A1244}"/>
          </ac:spMkLst>
        </pc:spChg>
      </pc:sldChg>
      <pc:sldChg chg="modSp">
        <pc:chgData name="Filippo Acconcia" userId="844af49c-a8a0-47ac-a7dd-14a44b60cd18" providerId="ADAL" clId="{4E01D738-D0C1-4B9B-B836-CF053EEC4C53}" dt="2022-03-16T08:36:09.424" v="756"/>
        <pc:sldMkLst>
          <pc:docMk/>
          <pc:sldMk cId="908504430" sldId="293"/>
        </pc:sldMkLst>
        <pc:spChg chg="mod">
          <ac:chgData name="Filippo Acconcia" userId="844af49c-a8a0-47ac-a7dd-14a44b60cd18" providerId="ADAL" clId="{4E01D738-D0C1-4B9B-B836-CF053EEC4C53}" dt="2022-03-16T08:36:09.424" v="756"/>
          <ac:spMkLst>
            <pc:docMk/>
            <pc:sldMk cId="908504430" sldId="293"/>
            <ac:spMk id="4" creationId="{9765AF81-DF08-4C43-8E8C-73B1FEB2D0AC}"/>
          </ac:spMkLst>
        </pc:spChg>
        <pc:spChg chg="mod">
          <ac:chgData name="Filippo Acconcia" userId="844af49c-a8a0-47ac-a7dd-14a44b60cd18" providerId="ADAL" clId="{4E01D738-D0C1-4B9B-B836-CF053EEC4C53}" dt="2022-03-16T08:36:09.424" v="756"/>
          <ac:spMkLst>
            <pc:docMk/>
            <pc:sldMk cId="908504430" sldId="293"/>
            <ac:spMk id="5" creationId="{0A60C100-5F5F-478E-B0E2-59FBED849F62}"/>
          </ac:spMkLst>
        </pc:spChg>
        <pc:spChg chg="mod">
          <ac:chgData name="Filippo Acconcia" userId="844af49c-a8a0-47ac-a7dd-14a44b60cd18" providerId="ADAL" clId="{4E01D738-D0C1-4B9B-B836-CF053EEC4C53}" dt="2022-03-16T08:36:09.424" v="756"/>
          <ac:spMkLst>
            <pc:docMk/>
            <pc:sldMk cId="908504430" sldId="293"/>
            <ac:spMk id="6" creationId="{06DCB194-56AB-4AB2-9999-2EAE0B846C73}"/>
          </ac:spMkLst>
        </pc:spChg>
        <pc:spChg chg="mod">
          <ac:chgData name="Filippo Acconcia" userId="844af49c-a8a0-47ac-a7dd-14a44b60cd18" providerId="ADAL" clId="{4E01D738-D0C1-4B9B-B836-CF053EEC4C53}" dt="2022-03-16T08:36:09.424" v="756"/>
          <ac:spMkLst>
            <pc:docMk/>
            <pc:sldMk cId="908504430" sldId="293"/>
            <ac:spMk id="7" creationId="{9D83196F-5257-4625-B72C-E6EEA553FBBE}"/>
          </ac:spMkLst>
        </pc:spChg>
        <pc:spChg chg="mod">
          <ac:chgData name="Filippo Acconcia" userId="844af49c-a8a0-47ac-a7dd-14a44b60cd18" providerId="ADAL" clId="{4E01D738-D0C1-4B9B-B836-CF053EEC4C53}" dt="2022-03-16T08:36:09.424" v="756"/>
          <ac:spMkLst>
            <pc:docMk/>
            <pc:sldMk cId="908504430" sldId="293"/>
            <ac:spMk id="8" creationId="{69EA7D3A-80D8-44DB-BA6D-94DACABCB2CF}"/>
          </ac:spMkLst>
        </pc:spChg>
        <pc:spChg chg="mod">
          <ac:chgData name="Filippo Acconcia" userId="844af49c-a8a0-47ac-a7dd-14a44b60cd18" providerId="ADAL" clId="{4E01D738-D0C1-4B9B-B836-CF053EEC4C53}" dt="2022-03-16T08:36:09.424" v="756"/>
          <ac:spMkLst>
            <pc:docMk/>
            <pc:sldMk cId="908504430" sldId="293"/>
            <ac:spMk id="9" creationId="{170156DF-984A-413A-A98E-110035561C4C}"/>
          </ac:spMkLst>
        </pc:spChg>
        <pc:spChg chg="mod">
          <ac:chgData name="Filippo Acconcia" userId="844af49c-a8a0-47ac-a7dd-14a44b60cd18" providerId="ADAL" clId="{4E01D738-D0C1-4B9B-B836-CF053EEC4C53}" dt="2022-03-16T08:36:09.424" v="756"/>
          <ac:spMkLst>
            <pc:docMk/>
            <pc:sldMk cId="908504430" sldId="293"/>
            <ac:spMk id="11" creationId="{A9158AFE-B6A4-44E4-A598-A11752410FF1}"/>
          </ac:spMkLst>
        </pc:spChg>
        <pc:spChg chg="mod">
          <ac:chgData name="Filippo Acconcia" userId="844af49c-a8a0-47ac-a7dd-14a44b60cd18" providerId="ADAL" clId="{4E01D738-D0C1-4B9B-B836-CF053EEC4C53}" dt="2022-03-16T08:36:09.424" v="756"/>
          <ac:spMkLst>
            <pc:docMk/>
            <pc:sldMk cId="908504430" sldId="293"/>
            <ac:spMk id="12" creationId="{7FC1DE70-2414-4E9E-A320-A490681B4527}"/>
          </ac:spMkLst>
        </pc:spChg>
        <pc:spChg chg="mod">
          <ac:chgData name="Filippo Acconcia" userId="844af49c-a8a0-47ac-a7dd-14a44b60cd18" providerId="ADAL" clId="{4E01D738-D0C1-4B9B-B836-CF053EEC4C53}" dt="2022-03-16T08:36:09.424" v="756"/>
          <ac:spMkLst>
            <pc:docMk/>
            <pc:sldMk cId="908504430" sldId="293"/>
            <ac:spMk id="13" creationId="{C9D34849-A4C2-4450-9330-2CF6422288FB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908504430" sldId="293"/>
            <ac:spMk id="49" creationId="{FB0B382A-9C8F-4516-A5C0-C8CDF599AB05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908504430" sldId="293"/>
            <ac:spMk id="87" creationId="{25ACC2EB-6853-4700-9F53-196A3DB123E0}"/>
          </ac:spMkLst>
        </pc:spChg>
        <pc:grpChg chg="mod">
          <ac:chgData name="Filippo Acconcia" userId="844af49c-a8a0-47ac-a7dd-14a44b60cd18" providerId="ADAL" clId="{4E01D738-D0C1-4B9B-B836-CF053EEC4C53}" dt="2022-03-16T08:36:09.424" v="756"/>
          <ac:grpSpMkLst>
            <pc:docMk/>
            <pc:sldMk cId="908504430" sldId="293"/>
            <ac:grpSpMk id="3" creationId="{D28D9807-C44F-4F76-B4BE-E0222825C87B}"/>
          </ac:grpSpMkLst>
        </pc:grpChg>
        <pc:picChg chg="mod">
          <ac:chgData name="Filippo Acconcia" userId="844af49c-a8a0-47ac-a7dd-14a44b60cd18" providerId="ADAL" clId="{4E01D738-D0C1-4B9B-B836-CF053EEC4C53}" dt="2022-03-16T08:36:09.424" v="756"/>
          <ac:picMkLst>
            <pc:docMk/>
            <pc:sldMk cId="908504430" sldId="293"/>
            <ac:picMk id="14" creationId="{B175F52A-9E39-4759-870A-4394CB7556A1}"/>
          </ac:picMkLst>
        </pc:picChg>
        <pc:picChg chg="mod">
          <ac:chgData name="Filippo Acconcia" userId="844af49c-a8a0-47ac-a7dd-14a44b60cd18" providerId="ADAL" clId="{4E01D738-D0C1-4B9B-B836-CF053EEC4C53}" dt="2022-03-16T08:36:09.424" v="756"/>
          <ac:picMkLst>
            <pc:docMk/>
            <pc:sldMk cId="908504430" sldId="293"/>
            <ac:picMk id="15" creationId="{9E74E5E3-FD6C-4AA3-96F6-CAA151F0B03A}"/>
          </ac:picMkLst>
        </pc:picChg>
        <pc:cxnChg chg="mod">
          <ac:chgData name="Filippo Acconcia" userId="844af49c-a8a0-47ac-a7dd-14a44b60cd18" providerId="ADAL" clId="{4E01D738-D0C1-4B9B-B836-CF053EEC4C53}" dt="2022-03-16T08:36:09.424" v="756"/>
          <ac:cxnSpMkLst>
            <pc:docMk/>
            <pc:sldMk cId="908504430" sldId="293"/>
            <ac:cxnSpMk id="10" creationId="{43FFC361-4E64-4019-8425-4135C4116F96}"/>
          </ac:cxnSpMkLst>
        </pc:cxnChg>
      </pc:sldChg>
      <pc:sldChg chg="addSp delSp modSp mod">
        <pc:chgData name="Filippo Acconcia" userId="844af49c-a8a0-47ac-a7dd-14a44b60cd18" providerId="ADAL" clId="{4E01D738-D0C1-4B9B-B836-CF053EEC4C53}" dt="2022-03-16T08:35:59.242" v="755"/>
        <pc:sldMkLst>
          <pc:docMk/>
          <pc:sldMk cId="2323114696" sldId="300"/>
        </pc:sldMkLst>
        <pc:spChg chg="mod">
          <ac:chgData name="Filippo Acconcia" userId="844af49c-a8a0-47ac-a7dd-14a44b60cd18" providerId="ADAL" clId="{4E01D738-D0C1-4B9B-B836-CF053EEC4C53}" dt="2022-03-16T08:04:09.678" v="10" actId="1035"/>
          <ac:spMkLst>
            <pc:docMk/>
            <pc:sldMk cId="2323114696" sldId="300"/>
            <ac:spMk id="2" creationId="{2620E1D6-1454-4D26-AB5B-F9DAAD59DD8D}"/>
          </ac:spMkLst>
        </pc:spChg>
        <pc:spChg chg="mod topLvl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32" creationId="{20815C4C-72BE-4261-B791-445B2FFA9F49}"/>
          </ac:spMkLst>
        </pc:spChg>
        <pc:spChg chg="mod topLvl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33" creationId="{7F240CB8-FBFE-4F72-95A1-D0ED8B50B1D6}"/>
          </ac:spMkLst>
        </pc:spChg>
        <pc:spChg chg="mod topLvl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34" creationId="{66521B2E-4558-4271-B03D-BE93D2745AD7}"/>
          </ac:spMkLst>
        </pc:spChg>
        <pc:spChg chg="mod">
          <ac:chgData name="Filippo Acconcia" userId="844af49c-a8a0-47ac-a7dd-14a44b60cd18" providerId="ADAL" clId="{4E01D738-D0C1-4B9B-B836-CF053EEC4C53}" dt="2022-03-16T08:20:22.525" v="484" actId="12788"/>
          <ac:spMkLst>
            <pc:docMk/>
            <pc:sldMk cId="2323114696" sldId="300"/>
            <ac:spMk id="37" creationId="{E9740C14-700A-4A5E-AAC5-2F68D9BA59C5}"/>
          </ac:spMkLst>
        </pc:spChg>
        <pc:spChg chg="mod">
          <ac:chgData name="Filippo Acconcia" userId="844af49c-a8a0-47ac-a7dd-14a44b60cd18" providerId="ADAL" clId="{4E01D738-D0C1-4B9B-B836-CF053EEC4C53}" dt="2022-03-16T08:20:29.913" v="487" actId="1037"/>
          <ac:spMkLst>
            <pc:docMk/>
            <pc:sldMk cId="2323114696" sldId="300"/>
            <ac:spMk id="38" creationId="{D60CA0BC-79E0-4AB9-BC7A-CDD96FE01E49}"/>
          </ac:spMkLst>
        </pc:spChg>
        <pc:spChg chg="mod topLvl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41" creationId="{906DA123-F188-4E6C-8EDF-88880260A030}"/>
          </ac:spMkLst>
        </pc:spChg>
        <pc:spChg chg="del mod topLvl">
          <ac:chgData name="Filippo Acconcia" userId="844af49c-a8a0-47ac-a7dd-14a44b60cd18" providerId="ADAL" clId="{4E01D738-D0C1-4B9B-B836-CF053EEC4C53}" dt="2022-03-16T08:13:46.966" v="365" actId="478"/>
          <ac:spMkLst>
            <pc:docMk/>
            <pc:sldMk cId="2323114696" sldId="300"/>
            <ac:spMk id="42" creationId="{5325CD4D-909E-4272-A13E-433303F661CA}"/>
          </ac:spMkLst>
        </pc:spChg>
        <pc:spChg chg="mod topLvl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43" creationId="{01B2CF38-BCD4-4699-9415-F84E894558BA}"/>
          </ac:spMkLst>
        </pc:spChg>
        <pc:spChg chg="del mod topLvl">
          <ac:chgData name="Filippo Acconcia" userId="844af49c-a8a0-47ac-a7dd-14a44b60cd18" providerId="ADAL" clId="{4E01D738-D0C1-4B9B-B836-CF053EEC4C53}" dt="2022-03-16T08:13:46.966" v="365" actId="478"/>
          <ac:spMkLst>
            <pc:docMk/>
            <pc:sldMk cId="2323114696" sldId="300"/>
            <ac:spMk id="44" creationId="{5CED1125-8664-4422-8A7F-AE7CAAA301E3}"/>
          </ac:spMkLst>
        </pc:spChg>
        <pc:spChg chg="del mod topLvl">
          <ac:chgData name="Filippo Acconcia" userId="844af49c-a8a0-47ac-a7dd-14a44b60cd18" providerId="ADAL" clId="{4E01D738-D0C1-4B9B-B836-CF053EEC4C53}" dt="2022-03-16T08:13:46.966" v="365" actId="478"/>
          <ac:spMkLst>
            <pc:docMk/>
            <pc:sldMk cId="2323114696" sldId="300"/>
            <ac:spMk id="45" creationId="{51713703-A8B1-4B0E-AB97-406C616A6391}"/>
          </ac:spMkLst>
        </pc:spChg>
        <pc:spChg chg="del mod topLvl">
          <ac:chgData name="Filippo Acconcia" userId="844af49c-a8a0-47ac-a7dd-14a44b60cd18" providerId="ADAL" clId="{4E01D738-D0C1-4B9B-B836-CF053EEC4C53}" dt="2022-03-16T08:13:46.966" v="365" actId="478"/>
          <ac:spMkLst>
            <pc:docMk/>
            <pc:sldMk cId="2323114696" sldId="300"/>
            <ac:spMk id="46" creationId="{8622B50D-1C45-4E1D-AB09-BF43A214AD09}"/>
          </ac:spMkLst>
        </pc:spChg>
        <pc:spChg chg="del mod topLvl">
          <ac:chgData name="Filippo Acconcia" userId="844af49c-a8a0-47ac-a7dd-14a44b60cd18" providerId="ADAL" clId="{4E01D738-D0C1-4B9B-B836-CF053EEC4C53}" dt="2022-03-16T08:13:46.966" v="365" actId="478"/>
          <ac:spMkLst>
            <pc:docMk/>
            <pc:sldMk cId="2323114696" sldId="300"/>
            <ac:spMk id="47" creationId="{5557EBF5-373D-4851-BAD2-EE47251CE60E}"/>
          </ac:spMkLst>
        </pc:spChg>
        <pc:spChg chg="del mod topLvl">
          <ac:chgData name="Filippo Acconcia" userId="844af49c-a8a0-47ac-a7dd-14a44b60cd18" providerId="ADAL" clId="{4E01D738-D0C1-4B9B-B836-CF053EEC4C53}" dt="2022-03-16T08:13:46.966" v="365" actId="478"/>
          <ac:spMkLst>
            <pc:docMk/>
            <pc:sldMk cId="2323114696" sldId="300"/>
            <ac:spMk id="48" creationId="{A5ED2185-D042-40DA-9CE8-76208248BBF0}"/>
          </ac:spMkLst>
        </pc:spChg>
        <pc:spChg chg="del mod topLvl">
          <ac:chgData name="Filippo Acconcia" userId="844af49c-a8a0-47ac-a7dd-14a44b60cd18" providerId="ADAL" clId="{4E01D738-D0C1-4B9B-B836-CF053EEC4C53}" dt="2022-03-16T08:13:46.966" v="365" actId="478"/>
          <ac:spMkLst>
            <pc:docMk/>
            <pc:sldMk cId="2323114696" sldId="300"/>
            <ac:spMk id="49" creationId="{55AB9475-5635-4C0A-A8EC-67075AFECD57}"/>
          </ac:spMkLst>
        </pc:spChg>
        <pc:spChg chg="del mod topLvl">
          <ac:chgData name="Filippo Acconcia" userId="844af49c-a8a0-47ac-a7dd-14a44b60cd18" providerId="ADAL" clId="{4E01D738-D0C1-4B9B-B836-CF053EEC4C53}" dt="2022-03-16T08:13:46.966" v="365" actId="478"/>
          <ac:spMkLst>
            <pc:docMk/>
            <pc:sldMk cId="2323114696" sldId="300"/>
            <ac:spMk id="50" creationId="{9EBFE9B7-6E19-42D5-BF65-D50C3B0BEC9B}"/>
          </ac:spMkLst>
        </pc:spChg>
        <pc:spChg chg="del mod topLvl">
          <ac:chgData name="Filippo Acconcia" userId="844af49c-a8a0-47ac-a7dd-14a44b60cd18" providerId="ADAL" clId="{4E01D738-D0C1-4B9B-B836-CF053EEC4C53}" dt="2022-03-16T08:13:46.966" v="365" actId="478"/>
          <ac:spMkLst>
            <pc:docMk/>
            <pc:sldMk cId="2323114696" sldId="300"/>
            <ac:spMk id="51" creationId="{EBD0CC37-4656-4283-BF46-063A1D6429E3}"/>
          </ac:spMkLst>
        </pc:spChg>
        <pc:spChg chg="del mod topLvl">
          <ac:chgData name="Filippo Acconcia" userId="844af49c-a8a0-47ac-a7dd-14a44b60cd18" providerId="ADAL" clId="{4E01D738-D0C1-4B9B-B836-CF053EEC4C53}" dt="2022-03-16T08:13:46.966" v="365" actId="478"/>
          <ac:spMkLst>
            <pc:docMk/>
            <pc:sldMk cId="2323114696" sldId="300"/>
            <ac:spMk id="53" creationId="{4DA390AA-2086-40CD-9375-40876EC670EE}"/>
          </ac:spMkLst>
        </pc:spChg>
        <pc:spChg chg="del mod topLvl">
          <ac:chgData name="Filippo Acconcia" userId="844af49c-a8a0-47ac-a7dd-14a44b60cd18" providerId="ADAL" clId="{4E01D738-D0C1-4B9B-B836-CF053EEC4C53}" dt="2022-03-16T08:13:46.966" v="365" actId="478"/>
          <ac:spMkLst>
            <pc:docMk/>
            <pc:sldMk cId="2323114696" sldId="300"/>
            <ac:spMk id="54" creationId="{3CF48823-BD8E-491C-AC14-6F73792B51FD}"/>
          </ac:spMkLst>
        </pc:spChg>
        <pc:spChg chg="del mod topLvl">
          <ac:chgData name="Filippo Acconcia" userId="844af49c-a8a0-47ac-a7dd-14a44b60cd18" providerId="ADAL" clId="{4E01D738-D0C1-4B9B-B836-CF053EEC4C53}" dt="2022-03-16T08:13:46.966" v="365" actId="478"/>
          <ac:spMkLst>
            <pc:docMk/>
            <pc:sldMk cId="2323114696" sldId="300"/>
            <ac:spMk id="55" creationId="{84D024A4-8C23-406F-AA63-10FC2AAF8C0F}"/>
          </ac:spMkLst>
        </pc:spChg>
        <pc:spChg chg="del mod topLvl">
          <ac:chgData name="Filippo Acconcia" userId="844af49c-a8a0-47ac-a7dd-14a44b60cd18" providerId="ADAL" clId="{4E01D738-D0C1-4B9B-B836-CF053EEC4C53}" dt="2022-03-16T08:13:46.966" v="365" actId="478"/>
          <ac:spMkLst>
            <pc:docMk/>
            <pc:sldMk cId="2323114696" sldId="300"/>
            <ac:spMk id="56" creationId="{BA916479-CE3F-4B5C-916C-450893098770}"/>
          </ac:spMkLst>
        </pc:spChg>
        <pc:spChg chg="add 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57" creationId="{886DF76C-8613-4D43-9717-61C92A39DD31}"/>
          </ac:spMkLst>
        </pc:spChg>
        <pc:spChg chg="add 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58" creationId="{D1B99F98-82BD-4E7B-AA35-4165C9AB646B}"/>
          </ac:spMkLst>
        </pc:spChg>
        <pc:spChg chg="add 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59" creationId="{DC89F48B-E7AE-4E43-9750-315C9C60FC0B}"/>
          </ac:spMkLst>
        </pc:spChg>
        <pc:spChg chg="add 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60" creationId="{5E5C825E-BD73-4154-A803-AF403C48245B}"/>
          </ac:spMkLst>
        </pc:spChg>
        <pc:spChg chg="mod">
          <ac:chgData name="Filippo Acconcia" userId="844af49c-a8a0-47ac-a7dd-14a44b60cd18" providerId="ADAL" clId="{4E01D738-D0C1-4B9B-B836-CF053EEC4C53}" dt="2022-03-16T08:08:09.924" v="114"/>
          <ac:spMkLst>
            <pc:docMk/>
            <pc:sldMk cId="2323114696" sldId="300"/>
            <ac:spMk id="62" creationId="{D237089F-65BF-4621-B9D3-08E4B6868727}"/>
          </ac:spMkLst>
        </pc:spChg>
        <pc:spChg chg="mod">
          <ac:chgData name="Filippo Acconcia" userId="844af49c-a8a0-47ac-a7dd-14a44b60cd18" providerId="ADAL" clId="{4E01D738-D0C1-4B9B-B836-CF053EEC4C53}" dt="2022-03-16T08:08:09.924" v="114"/>
          <ac:spMkLst>
            <pc:docMk/>
            <pc:sldMk cId="2323114696" sldId="300"/>
            <ac:spMk id="63" creationId="{5A733287-AA4D-43D3-9AAA-2D25A51232A3}"/>
          </ac:spMkLst>
        </pc:spChg>
        <pc:spChg chg="mod">
          <ac:chgData name="Filippo Acconcia" userId="844af49c-a8a0-47ac-a7dd-14a44b60cd18" providerId="ADAL" clId="{4E01D738-D0C1-4B9B-B836-CF053EEC4C53}" dt="2022-03-16T08:08:09.924" v="114"/>
          <ac:spMkLst>
            <pc:docMk/>
            <pc:sldMk cId="2323114696" sldId="300"/>
            <ac:spMk id="64" creationId="{9B1B445B-F8DD-4201-864B-2D3D27E0DD3B}"/>
          </ac:spMkLst>
        </pc:spChg>
        <pc:spChg chg="mod">
          <ac:chgData name="Filippo Acconcia" userId="844af49c-a8a0-47ac-a7dd-14a44b60cd18" providerId="ADAL" clId="{4E01D738-D0C1-4B9B-B836-CF053EEC4C53}" dt="2022-03-16T08:08:09.924" v="114"/>
          <ac:spMkLst>
            <pc:docMk/>
            <pc:sldMk cId="2323114696" sldId="300"/>
            <ac:spMk id="65" creationId="{5F2E72E5-5716-4769-8FD7-4F0D994E3F48}"/>
          </ac:spMkLst>
        </pc:spChg>
        <pc:spChg chg="mod topLvl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67" creationId="{7691E230-58DD-488A-BBA4-1249FCD6C4EE}"/>
          </ac:spMkLst>
        </pc:spChg>
        <pc:spChg chg="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69" creationId="{CAB4C77F-4F10-4A50-A274-521E44BC5500}"/>
          </ac:spMkLst>
        </pc:spChg>
        <pc:spChg chg="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70" creationId="{339ADA04-C96A-4984-B018-B237009B7621}"/>
          </ac:spMkLst>
        </pc:spChg>
        <pc:spChg chg="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71" creationId="{82CF2D00-1D82-4CA7-B69C-9D70B955AFB2}"/>
          </ac:spMkLst>
        </pc:spChg>
        <pc:spChg chg="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72" creationId="{F23409D5-CC58-497B-9EB3-2005D2B831B1}"/>
          </ac:spMkLst>
        </pc:spChg>
        <pc:spChg chg="mod topLvl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74" creationId="{A8B1B63C-D53D-41F3-A2FD-AFCA798C3353}"/>
          </ac:spMkLst>
        </pc:spChg>
        <pc:spChg chg="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76" creationId="{985AB88C-CF8E-47CC-93FC-7F9D8534001F}"/>
          </ac:spMkLst>
        </pc:spChg>
        <pc:spChg chg="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77" creationId="{F158D737-A6A7-4B79-A99A-6668D1098F5F}"/>
          </ac:spMkLst>
        </pc:spChg>
        <pc:spChg chg="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78" creationId="{1970B0D5-A6C1-43CC-88C8-FE2DD1A9CEB0}"/>
          </ac:spMkLst>
        </pc:spChg>
        <pc:spChg chg="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79" creationId="{93F36FCB-960D-4B4E-99BD-47C46F13E2A3}"/>
          </ac:spMkLst>
        </pc:spChg>
        <pc:spChg chg="mod topLvl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81" creationId="{F3D96847-DEAC-4558-B624-BE005ED73C68}"/>
          </ac:spMkLst>
        </pc:spChg>
        <pc:spChg chg="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83" creationId="{E150E46D-0436-4530-9358-5E7237FF48F2}"/>
          </ac:spMkLst>
        </pc:spChg>
        <pc:spChg chg="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84" creationId="{D8CA61E2-4B1E-4168-9EDD-F484D21F5D8F}"/>
          </ac:spMkLst>
        </pc:spChg>
        <pc:spChg chg="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85" creationId="{363D94E4-3734-449A-A720-661FDDD83742}"/>
          </ac:spMkLst>
        </pc:spChg>
        <pc:spChg chg="mod">
          <ac:chgData name="Filippo Acconcia" userId="844af49c-a8a0-47ac-a7dd-14a44b60cd18" providerId="ADAL" clId="{4E01D738-D0C1-4B9B-B836-CF053EEC4C53}" dt="2022-03-16T08:08:57.631" v="160" actId="165"/>
          <ac:spMkLst>
            <pc:docMk/>
            <pc:sldMk cId="2323114696" sldId="300"/>
            <ac:spMk id="86" creationId="{4D11BF0A-AC32-433B-8F46-BFE3B2BAC735}"/>
          </ac:spMkLst>
        </pc:spChg>
        <pc:spChg chg="mod topLvl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88" creationId="{749E51EB-1233-40D0-AB9E-BFD99EFC9F26}"/>
          </ac:spMkLst>
        </pc:spChg>
        <pc:spChg chg="mod topLvl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90" creationId="{DC438964-3C57-4526-9ABE-F0DA56C69BDE}"/>
          </ac:spMkLst>
        </pc:spChg>
        <pc:spChg chg="mod topLvl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91" creationId="{5C7BBDB3-97A3-4C5D-9367-A443FCBAD0EA}"/>
          </ac:spMkLst>
        </pc:spChg>
        <pc:spChg chg="mod topLvl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92" creationId="{3189AD19-462E-43E6-B47B-3C8718E303DE}"/>
          </ac:spMkLst>
        </pc:spChg>
        <pc:spChg chg="mod topLvl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93" creationId="{8B6188DE-458B-4714-BEEC-A45D8D6D7712}"/>
          </ac:spMkLst>
        </pc:spChg>
        <pc:spChg chg="add mod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94" creationId="{02CAF298-529A-4048-8D1B-BCC205692122}"/>
          </ac:spMkLst>
        </pc:spChg>
        <pc:spChg chg="add mod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98" creationId="{E9925801-23ED-43A9-B62C-D702DB4602B2}"/>
          </ac:spMkLst>
        </pc:spChg>
        <pc:spChg chg="add mod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99" creationId="{E1CABCD5-4BEA-4097-9254-BC9334ADFCB4}"/>
          </ac:spMkLst>
        </pc:spChg>
        <pc:spChg chg="add mod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100" creationId="{9218C579-8AF9-46C6-8538-44C27811B6CD}"/>
          </ac:spMkLst>
        </pc:spChg>
        <pc:spChg chg="add mod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101" creationId="{19FBEB37-B5AB-4272-BD66-7812D3C68545}"/>
          </ac:spMkLst>
        </pc:spChg>
        <pc:spChg chg="add mod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104" creationId="{60A62BDE-1153-431A-889B-BF4C43F527A5}"/>
          </ac:spMkLst>
        </pc:spChg>
        <pc:spChg chg="add mod">
          <ac:chgData name="Filippo Acconcia" userId="844af49c-a8a0-47ac-a7dd-14a44b60cd18" providerId="ADAL" clId="{4E01D738-D0C1-4B9B-B836-CF053EEC4C53}" dt="2022-03-16T08:14:45.564" v="394" actId="164"/>
          <ac:spMkLst>
            <pc:docMk/>
            <pc:sldMk cId="2323114696" sldId="300"/>
            <ac:spMk id="105" creationId="{22144CAC-FBEE-450F-98F2-CF336AE40989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09" creationId="{3B8D992B-B03F-4AA2-ADB4-821CD678556D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10" creationId="{94C4701B-A250-4ABF-918E-5FAE26393E28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11" creationId="{5A67AD35-7731-4B62-B2E0-9C4042076C27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12" creationId="{071251E0-C2C9-4E2B-9207-3D45A6FDA61D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13" creationId="{EDE56681-4D44-45DA-8D97-99CC0E8F18D1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15" creationId="{09976650-B0B6-45E1-B688-2CB09A6E9269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17" creationId="{CB386404-30E6-48FB-8597-91FDA49052B9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19" creationId="{C5A531D6-478F-4EFA-ABD7-5CE6B4FF42A9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21" creationId="{58B94D69-0158-4F3A-90C3-AD556F29D8E9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22" creationId="{B7DFF663-B195-437B-B776-F835A7A787DC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23" creationId="{C1C6C176-5F1F-409F-AEE4-114920E7769A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24" creationId="{F90D7889-CBD9-4FBE-B7FD-C37C54BDEC0C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25" creationId="{24065335-E7B1-4345-9904-B1E33C78A4DB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26" creationId="{CB94D18F-D99A-4746-A7B8-7C75A77542D6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32" creationId="{0EE6D78C-46E9-419F-9B95-EDBE6F184500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33" creationId="{5A186BBE-B05D-4761-967F-A0465C4FD4D2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34" creationId="{FAB24A7E-CF48-4FA0-8876-0683E494A67A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35" creationId="{B9EC4F1A-96E2-4CF5-AA2B-5B13565A95A8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37" creationId="{DB7388E7-E954-4A94-8053-F60C749BAB77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38" creationId="{4D31D52E-9D7E-4699-88FE-E756D06F2283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39" creationId="{A8C8147E-6AFE-4FBC-A1B9-B7948A484AD9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40" creationId="{8C43D94D-1B57-451F-987D-DF9AAE437961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41" creationId="{CC08FF8C-B94F-4B6B-AE68-6140531F61CA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42" creationId="{40B5E5FA-2142-4E99-9EF4-BA4BFEFCC248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43" creationId="{C8204791-CBCF-4E05-9FCC-386DA1A8CB8C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44" creationId="{8C7CFA72-4AF4-48D9-936D-235CF745911F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45" creationId="{6ACEF113-7B01-48A0-9877-CBC3A6E83037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46" creationId="{FA987230-3667-48BF-955B-23435B524539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47" creationId="{F000946D-3931-4DF9-925D-F9B2CBE57B2E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48" creationId="{3C4E22E8-7519-4156-BA0C-783059BAC876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49" creationId="{F5DCB03C-03E4-4017-BFA5-EBE15D8BF18B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50" creationId="{6E77FB48-24FE-4648-B564-10020DE5BBA5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51" creationId="{E3057A37-3184-42D3-AC89-BF5F88F2C211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52" creationId="{96356B8D-0079-48F1-B23A-C79B0E73408D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53" creationId="{6F14A7B3-FD6A-4EF7-BE32-28F9D460371B}"/>
          </ac:spMkLst>
        </pc:spChg>
        <pc:spChg chg="mod">
          <ac:chgData name="Filippo Acconcia" userId="844af49c-a8a0-47ac-a7dd-14a44b60cd18" providerId="ADAL" clId="{4E01D738-D0C1-4B9B-B836-CF053EEC4C53}" dt="2022-03-16T08:14:56.443" v="398"/>
          <ac:spMkLst>
            <pc:docMk/>
            <pc:sldMk cId="2323114696" sldId="300"/>
            <ac:spMk id="154" creationId="{C4783F06-D23A-43B3-8C67-BEDEFCBB7FD1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57" creationId="{01B8ED89-E7B8-4F8D-8A3D-F3FEA78C7416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58" creationId="{6B97C2AC-7333-4556-97FF-F9D174300721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59" creationId="{FEA86F7D-868E-41B8-BECD-C018A9869AD2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60" creationId="{7AEC4C28-8715-4FCE-8BB9-A62BEC4EA31A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61" creationId="{85A7C584-6A68-4BED-8C38-0CA0CD6D05A9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63" creationId="{6C1AB31D-FFD2-471B-B96E-9BE4BC2B0EA9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65" creationId="{86A8AA5F-377D-4DEB-A89D-7BD23E87BB75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67" creationId="{319E7283-7A43-4FF4-A98A-EE3B4A4819A5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69" creationId="{1154E3FA-6A58-4190-ADA6-339F9C2CAFE1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70" creationId="{8DE45499-3DFA-4D35-A2AB-EA827A4EE8DB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71" creationId="{F632BEF8-C7D2-42BF-B6F7-717B2435616B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72" creationId="{F66AA01D-BECC-4AEC-A1EE-4CF267D7F563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73" creationId="{7C8B71F2-3FB4-46FD-8E43-9B1D699C4A69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74" creationId="{973AF16D-3D18-4304-9221-51FF5BF0167F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80" creationId="{41BFD58A-2231-4F2E-8646-64CBE16D5D15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81" creationId="{B5022FBF-8E48-4508-8290-92F21B55277D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82" creationId="{8F1E7F8A-5CF5-40BB-9EF6-40BECCC08BB0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83" creationId="{F011D582-B014-47BC-ADF4-AE88698FD317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85" creationId="{3807C995-C620-4708-B154-F110C1F47245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86" creationId="{126213E7-E971-4AB8-8491-D19AFDC3D9A2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87" creationId="{8E5A2A73-BE28-4E27-81B9-042BFD98E009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88" creationId="{F42D9D86-07FA-4E3B-8711-85054E4E9FED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89" creationId="{A60CA224-2618-4DF4-8B78-0792312B9607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90" creationId="{B8756DF9-F9EA-4815-9124-8FBAD7F35F17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91" creationId="{6B1E538B-73C8-434E-91B3-A427665DB589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92" creationId="{AF81976F-A1B9-4878-87A5-E9A26B74924E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93" creationId="{005CF8D1-B7F7-43E6-A277-D3FC32E8AAF9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94" creationId="{D93E1A45-8B93-4B64-8EB1-0B623FF6DBD9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95" creationId="{95AB196D-543B-4F1F-99F1-048F026DD7A8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96" creationId="{FDC87C3D-9498-4AB4-BEFA-1004EAE037A9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97" creationId="{2F5571EA-822E-47CD-8364-486F10F8D5AF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98" creationId="{EC6A830A-25CC-4D2C-B2E0-C2EA4BF675E1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199" creationId="{244F494C-40F0-4B5D-866D-51AAC5228BF1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00" creationId="{998831B9-AC12-4E23-A7F9-954026BB0BD8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01" creationId="{498656C9-DFCE-450A-AAAA-58E2247BA1A2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02" creationId="{272661BD-0250-431C-9408-3BDB49EC600A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05" creationId="{9327F032-E4A3-4E10-ADF0-33D493BE24BF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06" creationId="{69F55844-C1D4-4C8A-9737-501B72955EDC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07" creationId="{C02577BA-660F-4159-BCE1-6329DFCBF82B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08" creationId="{561FDBD8-E337-4353-9F76-3CE0ABCBFBD3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09" creationId="{0D24D35B-B832-4530-967A-95076EE69517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11" creationId="{510D96A7-BA8D-4CC5-A2DD-84334DE96015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13" creationId="{0E69D974-89E1-48AD-B4CD-48C70606B38D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15" creationId="{6BCFE96C-6AEA-4618-857A-FA779B121681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17" creationId="{09132EB4-94FA-4241-88AF-270798385C39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18" creationId="{4D492806-93A2-45E0-ADF0-EE6232BBD2AC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19" creationId="{7DF18E0F-BBB2-4DED-8C50-9B3B3B118C76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20" creationId="{C3A8E25E-3D7C-49EB-9C7C-3480EA93A2E1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21" creationId="{6A60A871-E7F5-4044-A7E0-DEF274E388AE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22" creationId="{2B7C88D9-4CD3-4F39-B8D8-98C3F8F835ED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28" creationId="{F3868FB2-4CF6-477F-BB1C-6D9224AA3CAE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29" creationId="{0558267A-FA1B-4FED-A710-70FD042CA6E4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30" creationId="{D8F4D5DD-DFF4-4745-8083-81F307D50F06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31" creationId="{08135E61-A105-4EC7-8940-6C8C8C886B6A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33" creationId="{404B691D-8F4D-4794-8E74-4B15677F7B2C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34" creationId="{A22B4168-3FCA-4C5B-A40B-D302515973D6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35" creationId="{26C33A03-7738-480C-80D9-6855B2305C91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36" creationId="{85C5FBE4-6108-4BF1-BFC3-633C0BE5A5E1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37" creationId="{DF167183-A94C-4507-8264-506C6A79BCDC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38" creationId="{2E43595D-F626-4A5C-B821-07C76F182B58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39" creationId="{C0733363-6A8D-4E44-AD1B-FC3409A70799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40" creationId="{FF36B400-DCD5-4288-8064-981B8D3A722D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41" creationId="{2960EC9B-D45C-40ED-9BA1-682C52F07E2C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42" creationId="{07A04053-33DF-46C3-A11F-B9E3E54A9FC5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43" creationId="{8007CC14-1157-4739-A3DC-604A786F23A9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44" creationId="{A2872BF9-C4E4-408A-B4B6-1EAF23894BF0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45" creationId="{E5A430E1-38F5-4C20-92F2-46597B88926C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46" creationId="{0CBD2C06-296F-43E3-8DC2-8DED1976B7E3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47" creationId="{070CD6C4-C2A4-42BF-A303-118F4C32D5A7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48" creationId="{B8608316-6F87-473A-8EB0-1B5A63D041E3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49" creationId="{CF8635B4-102D-46E2-A919-2FEECF7576A4}"/>
          </ac:spMkLst>
        </pc:spChg>
        <pc:spChg chg="mod">
          <ac:chgData name="Filippo Acconcia" userId="844af49c-a8a0-47ac-a7dd-14a44b60cd18" providerId="ADAL" clId="{4E01D738-D0C1-4B9B-B836-CF053EEC4C53}" dt="2022-03-16T08:15:04.085" v="402"/>
          <ac:spMkLst>
            <pc:docMk/>
            <pc:sldMk cId="2323114696" sldId="300"/>
            <ac:spMk id="250" creationId="{A0948536-F957-41DD-BA1C-F6C139DC96E7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53" creationId="{A9908D27-92BB-42C5-A0B5-F252CB4D0989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54" creationId="{A74DC434-9CD2-4C12-962C-010D841FC3BD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55" creationId="{14915BFE-1030-4A3A-851C-D43242886D6E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56" creationId="{963ABDF4-BAA5-4371-9703-5C8839D3FC5C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57" creationId="{B5B3BFAB-CB0E-408D-820A-38B1CCE45914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59" creationId="{84CC3C1E-AA38-4955-9CD2-853AEA9A87AC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61" creationId="{CF2E3933-DCD8-435F-A090-48260FB311D6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63" creationId="{E4DD88EB-7127-44AC-8D93-291C1457D0A9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65" creationId="{5AAC3683-3708-4C25-AFC9-CDB645E21E18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66" creationId="{34697B5F-6F11-4B8E-A69D-3556682B1151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67" creationId="{B72BEE75-C10E-4CDA-9972-0581B55FFF1A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68" creationId="{4645E72D-BFEB-4C6F-B9FA-D37EA223EF6B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69" creationId="{7EBB8530-64DA-4D09-9FA3-BC2F4E811801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70" creationId="{8941AABE-7721-4ECF-A91B-263C0D7E73F5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76" creationId="{6E494669-B61C-44AC-AE7B-DD46EE6C9559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77" creationId="{93AAB494-5B77-4EDD-893A-4F4A7CD366BA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78" creationId="{46662123-3633-4818-AB4A-89D0894FFDE7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79" creationId="{4FF0BE44-314E-4816-8920-4B2D5D95B4D2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81" creationId="{81F7BDC1-3D0E-4BEC-AC0E-728E8266478B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82" creationId="{CFAD5328-45A2-44E6-9430-CE75A81EA701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83" creationId="{296A0E70-CBC0-4AEE-A355-1F3AD1D2B9B5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84" creationId="{7EDD1B30-A9E3-4F84-BC26-D57C4D81D3C1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85" creationId="{3649B85B-91CF-42A4-BB74-9688D01A39E1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86" creationId="{CAB9F6DA-8CE6-4FE5-8C3C-F5BCD7DEEE39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87" creationId="{C7F3FB3A-9E1C-413A-9ABE-0F36B4EBA2AF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88" creationId="{363FF547-5AD0-4BC7-8397-E0D3C1CD18CE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89" creationId="{5E90BF9D-C665-45FE-805D-5909586B8E33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90" creationId="{2270240C-5C0B-40DD-A186-107B99DE0BD8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91" creationId="{935DF708-5E0E-465F-AE4F-23DDCD5A2AD1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92" creationId="{C0777022-D2A1-4A80-9342-0AECFEB9B9F2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93" creationId="{220D75B4-56EA-4B0D-89ED-FFE1D8782BAF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94" creationId="{95FFFB3C-AB7B-4215-A061-8F99DAB40C71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95" creationId="{D630E2E6-ABA9-418B-A7F6-B82D8281C0C1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96" creationId="{6720EF62-03C4-47E3-AC0E-118DADF8FC50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97" creationId="{70B54DBE-3652-46C0-88DA-B63AC7C29054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298" creationId="{0A74FA61-DCD5-43DF-B339-7A3B9EC7A216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01" creationId="{0A2C0177-F0E9-4E0A-99FF-DCBBBD282BA5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02" creationId="{F4433823-073F-4DFC-B9DF-AABBB852F263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03" creationId="{0221B993-7856-493F-9D8E-6CCB107C4B1D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04" creationId="{1631A3D7-79D3-4053-8F87-34201FF10193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05" creationId="{7E514041-D8BB-4C0E-95DA-F562C0ECCDDF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07" creationId="{86603C61-C749-40ED-A860-73C96FC22E5F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09" creationId="{DFB7BB02-C058-4A8E-8643-A76E05430B88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11" creationId="{6A6CFE79-3964-437B-9613-2703DC131C3B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13" creationId="{7A59820A-C73C-4ECD-BB2C-D1B68226D1CA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14" creationId="{F4E14DD4-A170-458B-90EC-45C46D8CE711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15" creationId="{BEB5D84D-085E-4547-A754-7418371709DF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16" creationId="{687EC74C-EDE1-426E-AD99-4E4B4468ACB8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17" creationId="{C3FAC0DE-78CD-422E-93F5-0DD0703080CB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18" creationId="{1E84D745-C61E-4FD5-9225-1113C20B5954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24" creationId="{7BB0832D-FF11-4C14-99D4-8DD6D6B12E92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25" creationId="{F034F694-3994-4530-A45D-43C46A02E6D1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26" creationId="{E4D115ED-BA93-4FBB-BB16-BDB870F28AB1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27" creationId="{C4237864-0B5A-446C-A796-FA91C62A301A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29" creationId="{26635209-3CB7-41A8-BE28-08A438AD8E7E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30" creationId="{9F926986-A7D7-4BEA-946F-6C7243634FAD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31" creationId="{3026A0DE-E590-4DAB-B4F9-0413B405F14E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32" creationId="{E4801E8B-FC81-4797-BAF9-8004E3A1B4F7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33" creationId="{805AB1C3-DAC4-44FC-A268-2DCCB5F87112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34" creationId="{81A2EC15-C9A7-4218-9D40-C98F59AE8032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35" creationId="{91295A26-95D0-4010-8F63-B2C6EFE6B0B5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36" creationId="{0F2976B1-58FB-4A55-8D2D-0946DA31963F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37" creationId="{B60A1600-500F-42D9-8F48-2EAF31F8A967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38" creationId="{BAC02B44-9563-419F-ABBF-B7561E587F7E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39" creationId="{5C9A0E03-890E-41ED-B9B9-B40915CCF3DC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40" creationId="{8887C50E-0A94-4D4A-A59C-F6B0070F6A4B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41" creationId="{DD9C372D-78CC-433C-A915-215819ADB536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42" creationId="{19E86663-AFBC-469A-BEEF-ECD04F466BE1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43" creationId="{4948A403-C7AB-4C39-B14E-BE24A63F6ABE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44" creationId="{C74FDCD1-2B3C-4FCB-9DE0-39F1C1EF2030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45" creationId="{4D4E74F1-F26F-4F90-8972-9DB9C4E2BD7C}"/>
          </ac:spMkLst>
        </pc:spChg>
        <pc:spChg chg="mod">
          <ac:chgData name="Filippo Acconcia" userId="844af49c-a8a0-47ac-a7dd-14a44b60cd18" providerId="ADAL" clId="{4E01D738-D0C1-4B9B-B836-CF053EEC4C53}" dt="2022-03-16T08:15:07.319" v="404"/>
          <ac:spMkLst>
            <pc:docMk/>
            <pc:sldMk cId="2323114696" sldId="300"/>
            <ac:spMk id="346" creationId="{200FB48A-4F56-4494-A0A7-831AA9302A3A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49" creationId="{05456DD7-FF2E-40C1-B26D-2AD111FE79CF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50" creationId="{F3F24C0A-F54A-4D1E-8E50-1C1469FF763F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51" creationId="{42327D69-62B2-4400-A0B3-C68EB812B655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52" creationId="{67964EC0-EBD9-404F-8203-49A04C1896C3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53" creationId="{377E2D4A-C10E-4110-8175-4368CD6BECB0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55" creationId="{67990255-F6F0-46E2-A99B-31FD84B2A916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57" creationId="{9CFD502C-816D-47C9-89E8-49299BB7FF32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59" creationId="{DF938601-0425-4A5C-9AB0-35FF6CC115C3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61" creationId="{77714E3E-6FE7-40A1-8E5C-D7B802E07319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362" creationId="{A87B797C-750A-47AD-BC75-3C4BC919DAC1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363" creationId="{96825A2A-5E60-4878-BA5E-77C2A5F45F02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364" creationId="{B88F0745-1C81-4149-8DED-6A86727ACDB6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365" creationId="{F14CBC46-BC99-406A-9D3C-91929552A739}"/>
          </ac:spMkLst>
        </pc:spChg>
        <pc:spChg chg="mod">
          <ac:chgData name="Filippo Acconcia" userId="844af49c-a8a0-47ac-a7dd-14a44b60cd18" providerId="ADAL" clId="{4E01D738-D0C1-4B9B-B836-CF053EEC4C53}" dt="2022-03-16T08:25:33.466" v="574" actId="1037"/>
          <ac:spMkLst>
            <pc:docMk/>
            <pc:sldMk cId="2323114696" sldId="300"/>
            <ac:spMk id="366" creationId="{C923BE19-60F7-4248-A3A8-846D86BB00D2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72" creationId="{8DD02093-64AD-45DA-82C4-32D2D8B529C1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73" creationId="{0E925B84-4F8D-45BF-8B5C-F294F7E93425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74" creationId="{6F5744F3-B76B-4D1E-A770-3CEA27618FA5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75" creationId="{7219AB95-FA25-415B-9AF8-A038CA098491}"/>
          </ac:spMkLst>
        </pc:spChg>
        <pc:spChg chg="mod">
          <ac:chgData name="Filippo Acconcia" userId="844af49c-a8a0-47ac-a7dd-14a44b60cd18" providerId="ADAL" clId="{4E01D738-D0C1-4B9B-B836-CF053EEC4C53}" dt="2022-03-16T08:16:05.880" v="415"/>
          <ac:spMkLst>
            <pc:docMk/>
            <pc:sldMk cId="2323114696" sldId="300"/>
            <ac:spMk id="377" creationId="{D8B99B10-3512-4358-A15E-26BD34C1F210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378" creationId="{04382456-F3C0-4BD5-89D0-07536F9573AD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379" creationId="{67884001-E9B1-4068-A1D6-99591AB500C6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380" creationId="{7DDACA2C-5D4E-4A77-9E0B-8FD99C7126A9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381" creationId="{3ABF8424-A677-4376-93D4-ED3D12B02B42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382" creationId="{255CCA5D-2D33-4CAF-A947-2C2FC00FEDD7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383" creationId="{8426A3EB-F527-4BEC-9066-D554B410DC8E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384" creationId="{EC2E6E40-D346-4F63-A556-085C0C054E27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385" creationId="{6929F54C-0C32-4DF9-A39D-F896CC05CCB4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386" creationId="{9D2C446F-7C01-495C-A71C-E7AE6A9C921C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387" creationId="{C042993D-C665-491C-B33F-935847197EBB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388" creationId="{CCEACE2E-F024-4D36-8581-9EF983241D9C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389" creationId="{FA5CB010-9BBA-489E-AE9E-2F83D692F4F9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390" creationId="{2DFCA5E5-13F0-4CBE-84CE-570D2CADB7AF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391" creationId="{E4265CB9-9900-405A-8208-C1059DAFA61B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392" creationId="{FE331C7E-E7C3-4D60-860E-D7BFE2335FB5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393" creationId="{0A943136-5BD3-4E2F-BE3E-D6510E407C35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394" creationId="{16CA4D0E-1E9B-435E-897D-BC908BE06FD7}"/>
          </ac:spMkLst>
        </pc:spChg>
        <pc:spChg chg="mod topLvl">
          <ac:chgData name="Filippo Acconcia" userId="844af49c-a8a0-47ac-a7dd-14a44b60cd18" providerId="ADAL" clId="{4E01D738-D0C1-4B9B-B836-CF053EEC4C53}" dt="2022-03-16T08:21:02.006" v="489" actId="165"/>
          <ac:spMkLst>
            <pc:docMk/>
            <pc:sldMk cId="2323114696" sldId="300"/>
            <ac:spMk id="397" creationId="{182C66D8-0E0D-4763-980E-888A9A933DBF}"/>
          </ac:spMkLst>
        </pc:spChg>
        <pc:spChg chg="mod topLvl">
          <ac:chgData name="Filippo Acconcia" userId="844af49c-a8a0-47ac-a7dd-14a44b60cd18" providerId="ADAL" clId="{4E01D738-D0C1-4B9B-B836-CF053EEC4C53}" dt="2022-03-16T08:22:19.256" v="504" actId="164"/>
          <ac:spMkLst>
            <pc:docMk/>
            <pc:sldMk cId="2323114696" sldId="300"/>
            <ac:spMk id="398" creationId="{67FBDF8A-1512-49A7-8DD1-37BADDFE8FB7}"/>
          </ac:spMkLst>
        </pc:spChg>
        <pc:spChg chg="mod topLvl">
          <ac:chgData name="Filippo Acconcia" userId="844af49c-a8a0-47ac-a7dd-14a44b60cd18" providerId="ADAL" clId="{4E01D738-D0C1-4B9B-B836-CF053EEC4C53}" dt="2022-03-16T08:22:19.256" v="504" actId="164"/>
          <ac:spMkLst>
            <pc:docMk/>
            <pc:sldMk cId="2323114696" sldId="300"/>
            <ac:spMk id="399" creationId="{6EC1B413-FFFA-4FB6-B983-FA6E88DAEB7B}"/>
          </ac:spMkLst>
        </pc:spChg>
        <pc:spChg chg="mod topLvl">
          <ac:chgData name="Filippo Acconcia" userId="844af49c-a8a0-47ac-a7dd-14a44b60cd18" providerId="ADAL" clId="{4E01D738-D0C1-4B9B-B836-CF053EEC4C53}" dt="2022-03-16T08:22:19.256" v="504" actId="164"/>
          <ac:spMkLst>
            <pc:docMk/>
            <pc:sldMk cId="2323114696" sldId="300"/>
            <ac:spMk id="400" creationId="{FF1F8688-C1C1-4E7E-9EA3-41D92E3D3FE5}"/>
          </ac:spMkLst>
        </pc:spChg>
        <pc:spChg chg="mod topLvl">
          <ac:chgData name="Filippo Acconcia" userId="844af49c-a8a0-47ac-a7dd-14a44b60cd18" providerId="ADAL" clId="{4E01D738-D0C1-4B9B-B836-CF053EEC4C53}" dt="2022-03-16T08:22:19.256" v="504" actId="164"/>
          <ac:spMkLst>
            <pc:docMk/>
            <pc:sldMk cId="2323114696" sldId="300"/>
            <ac:spMk id="401" creationId="{104AC23E-0E22-4F2B-BE93-1551E774ECCD}"/>
          </ac:spMkLst>
        </pc:spChg>
        <pc:spChg chg="mod topLvl">
          <ac:chgData name="Filippo Acconcia" userId="844af49c-a8a0-47ac-a7dd-14a44b60cd18" providerId="ADAL" clId="{4E01D738-D0C1-4B9B-B836-CF053EEC4C53}" dt="2022-03-16T08:22:19.256" v="504" actId="164"/>
          <ac:spMkLst>
            <pc:docMk/>
            <pc:sldMk cId="2323114696" sldId="300"/>
            <ac:spMk id="403" creationId="{F5183F30-BB7B-42A9-BC0D-23C04D065BFE}"/>
          </ac:spMkLst>
        </pc:spChg>
        <pc:spChg chg="mod topLvl">
          <ac:chgData name="Filippo Acconcia" userId="844af49c-a8a0-47ac-a7dd-14a44b60cd18" providerId="ADAL" clId="{4E01D738-D0C1-4B9B-B836-CF053EEC4C53}" dt="2022-03-16T08:22:19.256" v="504" actId="164"/>
          <ac:spMkLst>
            <pc:docMk/>
            <pc:sldMk cId="2323114696" sldId="300"/>
            <ac:spMk id="405" creationId="{5DC07E36-A2DB-42C1-B89A-A2AC948C88E4}"/>
          </ac:spMkLst>
        </pc:spChg>
        <pc:spChg chg="mod topLvl">
          <ac:chgData name="Filippo Acconcia" userId="844af49c-a8a0-47ac-a7dd-14a44b60cd18" providerId="ADAL" clId="{4E01D738-D0C1-4B9B-B836-CF053EEC4C53}" dt="2022-03-16T08:22:19.256" v="504" actId="164"/>
          <ac:spMkLst>
            <pc:docMk/>
            <pc:sldMk cId="2323114696" sldId="300"/>
            <ac:spMk id="407" creationId="{53569202-1DFD-459E-AAC5-93886C2A628D}"/>
          </ac:spMkLst>
        </pc:spChg>
        <pc:spChg chg="mod topLvl">
          <ac:chgData name="Filippo Acconcia" userId="844af49c-a8a0-47ac-a7dd-14a44b60cd18" providerId="ADAL" clId="{4E01D738-D0C1-4B9B-B836-CF053EEC4C53}" dt="2022-03-16T08:22:19.256" v="504" actId="164"/>
          <ac:spMkLst>
            <pc:docMk/>
            <pc:sldMk cId="2323114696" sldId="300"/>
            <ac:spMk id="409" creationId="{1621492B-90EB-496F-9E3B-7B8EBFD15195}"/>
          </ac:spMkLst>
        </pc:spChg>
        <pc:spChg chg="mod topLvl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410" creationId="{33701A36-0EE0-45FB-939A-D4DE0BBE5A6C}"/>
          </ac:spMkLst>
        </pc:spChg>
        <pc:spChg chg="mod topLvl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411" creationId="{C9DE4895-5AAF-4D9D-A588-C4D4BB8906CB}"/>
          </ac:spMkLst>
        </pc:spChg>
        <pc:spChg chg="mod topLvl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412" creationId="{053FDB5D-C25E-49FC-8A69-3C149B170B4F}"/>
          </ac:spMkLst>
        </pc:spChg>
        <pc:spChg chg="mod topLvl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413" creationId="{E5428D00-B144-4F44-BE2B-B7F32D22CBD5}"/>
          </ac:spMkLst>
        </pc:spChg>
        <pc:spChg chg="mod topLvl">
          <ac:chgData name="Filippo Acconcia" userId="844af49c-a8a0-47ac-a7dd-14a44b60cd18" providerId="ADAL" clId="{4E01D738-D0C1-4B9B-B836-CF053EEC4C53}" dt="2022-03-16T08:26:02.125" v="595" actId="1037"/>
          <ac:spMkLst>
            <pc:docMk/>
            <pc:sldMk cId="2323114696" sldId="300"/>
            <ac:spMk id="414" creationId="{A28DB261-4963-49A7-89E5-59C991BD2278}"/>
          </ac:spMkLst>
        </pc:spChg>
        <pc:spChg chg="mod topLvl">
          <ac:chgData name="Filippo Acconcia" userId="844af49c-a8a0-47ac-a7dd-14a44b60cd18" providerId="ADAL" clId="{4E01D738-D0C1-4B9B-B836-CF053EEC4C53}" dt="2022-03-16T08:22:19.256" v="504" actId="164"/>
          <ac:spMkLst>
            <pc:docMk/>
            <pc:sldMk cId="2323114696" sldId="300"/>
            <ac:spMk id="420" creationId="{14AEDCD0-7C5A-429C-A81C-89DA6794EB5F}"/>
          </ac:spMkLst>
        </pc:spChg>
        <pc:spChg chg="mod topLvl">
          <ac:chgData name="Filippo Acconcia" userId="844af49c-a8a0-47ac-a7dd-14a44b60cd18" providerId="ADAL" clId="{4E01D738-D0C1-4B9B-B836-CF053EEC4C53}" dt="2022-03-16T08:22:19.256" v="504" actId="164"/>
          <ac:spMkLst>
            <pc:docMk/>
            <pc:sldMk cId="2323114696" sldId="300"/>
            <ac:spMk id="421" creationId="{21A40BAD-FA0C-4E88-939B-E881CDB46C28}"/>
          </ac:spMkLst>
        </pc:spChg>
        <pc:spChg chg="mod topLvl">
          <ac:chgData name="Filippo Acconcia" userId="844af49c-a8a0-47ac-a7dd-14a44b60cd18" providerId="ADAL" clId="{4E01D738-D0C1-4B9B-B836-CF053EEC4C53}" dt="2022-03-16T08:22:19.256" v="504" actId="164"/>
          <ac:spMkLst>
            <pc:docMk/>
            <pc:sldMk cId="2323114696" sldId="300"/>
            <ac:spMk id="422" creationId="{1688C910-F420-4B86-AEB8-C40B803ECFFF}"/>
          </ac:spMkLst>
        </pc:spChg>
        <pc:spChg chg="mod topLvl">
          <ac:chgData name="Filippo Acconcia" userId="844af49c-a8a0-47ac-a7dd-14a44b60cd18" providerId="ADAL" clId="{4E01D738-D0C1-4B9B-B836-CF053EEC4C53}" dt="2022-03-16T08:22:19.256" v="504" actId="164"/>
          <ac:spMkLst>
            <pc:docMk/>
            <pc:sldMk cId="2323114696" sldId="300"/>
            <ac:spMk id="423" creationId="{39CF7A3B-E979-4E12-9B73-59BCD9E203D1}"/>
          </ac:spMkLst>
        </pc:spChg>
        <pc:spChg chg="mod topLvl">
          <ac:chgData name="Filippo Acconcia" userId="844af49c-a8a0-47ac-a7dd-14a44b60cd18" providerId="ADAL" clId="{4E01D738-D0C1-4B9B-B836-CF053EEC4C53}" dt="2022-03-16T08:22:19.256" v="504" actId="164"/>
          <ac:spMkLst>
            <pc:docMk/>
            <pc:sldMk cId="2323114696" sldId="300"/>
            <ac:spMk id="425" creationId="{477CD04F-6D42-4A78-8EC6-1BD043924F36}"/>
          </ac:spMkLst>
        </pc:spChg>
        <pc:spChg chg="mod topLvl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426" creationId="{1159010B-6A26-4942-B381-4202EFA70CB5}"/>
          </ac:spMkLst>
        </pc:spChg>
        <pc:spChg chg="mod topLvl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427" creationId="{6CF4ADE8-2973-4D48-89F5-ECAF968E2529}"/>
          </ac:spMkLst>
        </pc:spChg>
        <pc:spChg chg="mod topLvl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428" creationId="{8B959984-3E26-465D-9182-004608B3AA19}"/>
          </ac:spMkLst>
        </pc:spChg>
        <pc:spChg chg="mod topLvl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429" creationId="{6D810E69-D5DA-4A29-A2EF-D745A19ECB25}"/>
          </ac:spMkLst>
        </pc:spChg>
        <pc:spChg chg="mod topLvl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430" creationId="{86745E1E-BF74-4D45-A3E9-AB34514BBC9E}"/>
          </ac:spMkLst>
        </pc:spChg>
        <pc:spChg chg="mod topLvl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431" creationId="{7A8E7D8E-87D9-45DF-904B-0621A8E43FF6}"/>
          </ac:spMkLst>
        </pc:spChg>
        <pc:spChg chg="mod topLvl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432" creationId="{D62CEEED-DAFE-48EA-A027-86623EE57698}"/>
          </ac:spMkLst>
        </pc:spChg>
        <pc:spChg chg="mod topLvl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433" creationId="{D6F760CE-1E15-4E1A-BAB3-6545B2E73992}"/>
          </ac:spMkLst>
        </pc:spChg>
        <pc:spChg chg="mod topLvl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434" creationId="{1EE76D02-5904-4218-A0DD-97141D0A42F8}"/>
          </ac:spMkLst>
        </pc:spChg>
        <pc:spChg chg="mod topLvl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435" creationId="{5988EE16-1D23-452A-8AE7-1B6AEBCE79CD}"/>
          </ac:spMkLst>
        </pc:spChg>
        <pc:spChg chg="mod topLvl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436" creationId="{065DF2B0-2154-4DD5-8EDA-959BA36C5993}"/>
          </ac:spMkLst>
        </pc:spChg>
        <pc:spChg chg="mod topLvl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437" creationId="{D744B632-CF83-42E3-9699-F69A7C844358}"/>
          </ac:spMkLst>
        </pc:spChg>
        <pc:spChg chg="mod topLvl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438" creationId="{150DB698-AFBC-45D2-83AF-419FF511FB3A}"/>
          </ac:spMkLst>
        </pc:spChg>
        <pc:spChg chg="mod topLvl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439" creationId="{70246226-B075-49E6-8781-383535AC0AFA}"/>
          </ac:spMkLst>
        </pc:spChg>
        <pc:spChg chg="mod topLvl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440" creationId="{7337A797-2D82-4DEF-8877-203A6B563D92}"/>
          </ac:spMkLst>
        </pc:spChg>
        <pc:spChg chg="mod topLvl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441" creationId="{689509D6-1635-4272-9CDD-AB6A7B975F85}"/>
          </ac:spMkLst>
        </pc:spChg>
        <pc:spChg chg="mod topLvl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442" creationId="{4DA44F70-A41D-4A21-AFCD-18ADC1764141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45" creationId="{0AE77E7D-A2E2-402D-AC36-4678B7013B0E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46" creationId="{A15CDCD6-4A3F-437B-A691-656C3A77CDCC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47" creationId="{25A96A51-528B-4923-B33B-A358708A9B1D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48" creationId="{F5AE53BB-2722-4E37-BDAD-9F6E3CFA38ED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49" creationId="{BE86C972-940A-4FD8-804D-E037277203FD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51" creationId="{A09D2338-524C-4744-9DB5-AE5F3EF8587E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53" creationId="{255E304E-683E-4E29-ADDC-4354FCBFD9FD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55" creationId="{E4A4AE21-98B2-4072-93EC-9787687D4B35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57" creationId="{F8B7500A-7ED2-47B6-8333-E57EF5E9F2D7}"/>
          </ac:spMkLst>
        </pc:spChg>
        <pc:spChg chg="mod topLvl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458" creationId="{B2AE8484-D877-456A-95F3-185A07C21BB6}"/>
          </ac:spMkLst>
        </pc:spChg>
        <pc:spChg chg="mod topLvl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459" creationId="{6D699543-A515-402A-AB13-C8AA2BACA402}"/>
          </ac:spMkLst>
        </pc:spChg>
        <pc:spChg chg="mod topLvl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460" creationId="{EB7EF885-FBB4-4794-BF2E-DEDEA5349E1E}"/>
          </ac:spMkLst>
        </pc:spChg>
        <pc:spChg chg="mod topLvl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461" creationId="{D5C30E10-E91F-4A70-8BED-286538D41F8D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62" creationId="{B7C480C7-A5B3-4B7F-8A1D-358B41BD9351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68" creationId="{149C2D6E-9141-4042-9136-7141471AE69B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69" creationId="{5FCE0756-4274-4E8E-ACB6-0E8B3B9DBC2A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70" creationId="{36052F19-6CC9-48CE-A767-553ECB875D1B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71" creationId="{EA287B41-28CC-4730-9DE6-2114F301E4CE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73" creationId="{D964FAE6-18EA-4A2F-8F42-9CD4EBF2D571}"/>
          </ac:spMkLst>
        </pc:spChg>
        <pc:spChg chg="mod topLvl">
          <ac:chgData name="Filippo Acconcia" userId="844af49c-a8a0-47ac-a7dd-14a44b60cd18" providerId="ADAL" clId="{4E01D738-D0C1-4B9B-B836-CF053EEC4C53}" dt="2022-03-16T08:26:20.489" v="606" actId="164"/>
          <ac:spMkLst>
            <pc:docMk/>
            <pc:sldMk cId="2323114696" sldId="300"/>
            <ac:spMk id="474" creationId="{CDE75734-949C-483A-BAB3-B5EFB6A694E0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475" creationId="{07F229A6-9E4D-4C20-A299-BD3E7B2A2837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476" creationId="{B78E6408-8198-470F-82AA-B6389EF4FEA2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477" creationId="{AFE1D37D-B0D5-4A2A-B967-2D218E3CFBCC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478" creationId="{43CE1CF4-164A-47DA-91F8-11E7E895F066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479" creationId="{7CBD2AEB-5EFC-431C-87B1-B6C96412CA07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480" creationId="{B9472588-B926-45D3-8F0F-4C188AF1DCC1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481" creationId="{D30A8F72-8572-4E08-B3F5-7DC20A8BE541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482" creationId="{B974925B-F4A1-43D1-90DE-5EB7BF44679A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483" creationId="{D66BC254-16B7-4D38-836B-E2056D972C2E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484" creationId="{406E0AEC-C828-4102-B0D1-5D71E6BEB590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485" creationId="{8ED713D5-2090-470E-9D4F-3E198FE64927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486" creationId="{2644428E-EF1F-4402-BE80-3161979BF888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487" creationId="{DC21D9CD-F082-4413-A70F-17CB6980E65D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488" creationId="{AAE156AB-850F-417D-894C-0B44D2302764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489" creationId="{AEBE5EBD-8463-4257-B850-1AF3FDF69682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490" creationId="{35873420-8B49-46B6-8645-90EF09D1746E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493" creationId="{8F8A3395-4C01-4B63-8711-DB051D5364D8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494" creationId="{EB66A413-665A-48BF-BBFD-B2E1719644F0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495" creationId="{9EC5C6A7-FF7E-46DA-927A-D49607370C5B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496" creationId="{9592C4A5-946A-45BA-9D3A-C03D0CACFE80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497" creationId="{B1750DC6-FACB-46F0-A483-391A24639ACB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499" creationId="{AB8654BD-EC8E-475A-A42B-EDDBA4E0F7C0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501" creationId="{506214B3-322D-4DA9-9E93-406AC9EC9057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503" creationId="{FE0797AF-0F1D-4F84-A6A7-32F4EAC13E85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505" creationId="{7A6F89C5-8046-41A1-8FF7-2E8D62F16423}"/>
          </ac:spMkLst>
        </pc:spChg>
        <pc:spChg chg="mod topLvl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506" creationId="{FC02F7F0-0C82-4B13-8EEE-F9A6F2B45C7B}"/>
          </ac:spMkLst>
        </pc:spChg>
        <pc:spChg chg="mod topLvl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507" creationId="{741A846B-BF6C-4D73-A1C4-CF02315DAB78}"/>
          </ac:spMkLst>
        </pc:spChg>
        <pc:spChg chg="mod topLvl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508" creationId="{AEEBBD4C-AB32-4A3D-87BE-2534D8CAB2E4}"/>
          </ac:spMkLst>
        </pc:spChg>
        <pc:spChg chg="mod topLvl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509" creationId="{9F8AA899-8505-4374-B6B4-D2044DF6EAB2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510" creationId="{E75488A4-607D-4799-99BB-658DBD983CA0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516" creationId="{E5D0DFB1-0115-4CF0-8D9C-65F521285CE4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517" creationId="{3EB52F5C-871E-4473-886E-65098533A660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518" creationId="{413D9821-24F8-4FA9-ADBA-6879A87E710C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519" creationId="{485ACBC2-3145-4789-A310-4131F77D804A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521" creationId="{E72D8EA0-E475-42CE-9DBF-2CF94A70D7C1}"/>
          </ac:spMkLst>
        </pc:spChg>
        <pc:spChg chg="mod topLvl">
          <ac:chgData name="Filippo Acconcia" userId="844af49c-a8a0-47ac-a7dd-14a44b60cd18" providerId="ADAL" clId="{4E01D738-D0C1-4B9B-B836-CF053EEC4C53}" dt="2022-03-16T08:28:26.776" v="656" actId="164"/>
          <ac:spMkLst>
            <pc:docMk/>
            <pc:sldMk cId="2323114696" sldId="300"/>
            <ac:spMk id="522" creationId="{D0E01DA4-8CD2-4297-B038-05C61AA07F41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523" creationId="{7224DAD6-A41B-4213-829A-958D7E965DE4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524" creationId="{C0426700-26E7-4590-8119-C5EEE479EC4F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525" creationId="{E08CE6B5-AB40-477A-8E12-40332D3D9C6D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526" creationId="{1A2A92E9-903F-4A93-B4DE-E8EED16073F9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527" creationId="{A60B9EFA-BCF4-4FDD-B5AC-1E39C2B236D8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528" creationId="{80742805-0828-4469-9382-B6F29E7B4953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529" creationId="{590DF2F5-5D47-4395-99D3-E0A6E081E3DD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530" creationId="{E0457763-A4FD-496C-B612-7D65374BD52C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531" creationId="{C4700DAF-E0D3-4D88-B6E2-BFE3650C8D58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532" creationId="{D88DB357-4B22-47B7-BBED-6B68BE021CAE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533" creationId="{4BED0A48-ABC9-46D9-9824-206D4E6454E5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534" creationId="{D809C376-8E20-4F18-836A-7939B8A56B78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535" creationId="{C1D3408A-A059-42DB-99A2-7AFAA26B05F6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536" creationId="{6B36DDE8-3CE6-4153-B394-15931710389F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537" creationId="{2B214EC8-118B-424C-986D-AEE89582DA3E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538" creationId="{6FB9FEF1-BCD9-4E4C-9820-D064C5449F65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41" creationId="{FAE9D894-2F9B-47C7-ADDA-995B28C88C14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42" creationId="{9DB6E175-D347-4D44-A895-9468212DE79F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43" creationId="{9D7B778E-D0A7-41DD-BDB3-81D13C96ED0A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44" creationId="{C6FC7836-7607-4053-AD31-F3CCB1ACFAA8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45" creationId="{6C76869A-6D03-4C78-9C69-6701F7FC3673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47" creationId="{4180C668-D8A1-4A51-95E8-82CB346B4D8A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49" creationId="{B90EB830-BEC4-48D1-A7BB-39502E3F2410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51" creationId="{95C2FBA3-E4C7-49AD-995C-310653E1CBB2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53" creationId="{7EE33591-F435-48C0-B962-8D1D1E475784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54" creationId="{01859D29-D43F-4B9D-9DD7-94DEC4F0EBC0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55" creationId="{EB50AA35-8B30-4B56-BAA1-C96485E0B1C2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56" creationId="{33AAF8ED-C3F5-4519-BFED-439D06C93C43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57" creationId="{AD078399-824F-43F0-996E-AD6BDD9F3119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58" creationId="{124B67D9-CEB0-492B-BE0F-45CAC29B7CDC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64" creationId="{9B6DD7A2-8F46-421B-817B-417EB7F45C0E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65" creationId="{E731FAF1-F68F-4DC5-BFC5-65990F97D6A6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66" creationId="{47FD995D-266B-444C-ACDB-26731AE742C7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67" creationId="{C63CD4DD-7D2E-4F51-AC66-D3CD38089C99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69" creationId="{A8C20D92-CBEF-45E4-B261-F11BC10EB59B}"/>
          </ac:spMkLst>
        </pc:spChg>
        <pc:spChg chg="add del mod topLvl">
          <ac:chgData name="Filippo Acconcia" userId="844af49c-a8a0-47ac-a7dd-14a44b60cd18" providerId="ADAL" clId="{4E01D738-D0C1-4B9B-B836-CF053EEC4C53}" dt="2022-03-16T08:30:53.140" v="686" actId="478"/>
          <ac:spMkLst>
            <pc:docMk/>
            <pc:sldMk cId="2323114696" sldId="300"/>
            <ac:spMk id="570" creationId="{E46EBE1C-5B77-4B62-A293-F7F65DAC6155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71" creationId="{3CE58432-F557-42B1-B78A-ED2DE039FA77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72" creationId="{66DD583D-2C04-4B55-ADA2-8F94B5079C29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73" creationId="{678DCEC7-BDCB-49A8-8958-9C0C00145A80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74" creationId="{7D8E16AA-6FAB-4E25-A780-A1EE2C6F626E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75" creationId="{5CCA92A0-B6BC-407E-81DF-4ED1EAC229A7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76" creationId="{58F2208A-7CEC-4331-BAEF-12CB99B62861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77" creationId="{BF3E8906-2507-4E8F-A4DA-B11DD381845C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78" creationId="{45732DE9-41E5-4E58-970C-F6029E1D4E22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79" creationId="{66A7D99F-DFAD-490C-9A18-575197478CB9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80" creationId="{229F0E0E-646C-4023-B77B-858B43CCFB70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81" creationId="{BBCE63B0-20FB-4936-8AA6-4CD6CA711ABA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82" creationId="{A1C025D3-41FC-402B-AC36-E98B5A12C4EE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83" creationId="{31D6D901-B07F-4C02-B522-A66892636B45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84" creationId="{DB6AD6ED-6CBD-4521-A4B5-F0E08E58A7B3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85" creationId="{83892BCB-B51F-413A-B1B9-BD084D6D3594}"/>
          </ac:spMkLst>
        </pc:spChg>
        <pc:spChg chg="mod">
          <ac:chgData name="Filippo Acconcia" userId="844af49c-a8a0-47ac-a7dd-14a44b60cd18" providerId="ADAL" clId="{4E01D738-D0C1-4B9B-B836-CF053EEC4C53}" dt="2022-03-16T08:28:37.154" v="657" actId="165"/>
          <ac:spMkLst>
            <pc:docMk/>
            <pc:sldMk cId="2323114696" sldId="300"/>
            <ac:spMk id="586" creationId="{DE10A4B1-37CD-4042-8520-A87772F050BB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589" creationId="{6E0DF1F5-637A-49A8-AC51-61AB0A94C533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590" creationId="{BFC5C06F-90BE-4E34-89EA-836A8ACFACD0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591" creationId="{02C54E61-EB21-4752-BB1B-47B3219A0AF6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592" creationId="{B7831C9C-8EB9-4E8B-831F-A01434CB4FB3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593" creationId="{53FDF580-07B7-4A39-B26E-593580AD202E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595" creationId="{77EC5409-D934-4CF8-9A6F-85EC6E590EDF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597" creationId="{ADDEA70B-86F6-44E5-A7F2-E6FD60988DD7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599" creationId="{8E1C77B2-4B09-46D9-961E-6AF37BA0E732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601" creationId="{0E277147-641A-4A30-8C58-F47226FE4043}"/>
          </ac:spMkLst>
        </pc:spChg>
        <pc:spChg chg="add del mod topLvl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602" creationId="{D04A359A-B36E-4606-857F-AD73E1CAD30C}"/>
          </ac:spMkLst>
        </pc:spChg>
        <pc:spChg chg="add del mod topLvl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603" creationId="{257EF9A7-FAF4-4670-A6C5-0A948AC6CF0B}"/>
          </ac:spMkLst>
        </pc:spChg>
        <pc:spChg chg="add del mod topLvl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604" creationId="{E7B15C83-CC04-463C-83A7-04DB96B1BA94}"/>
          </ac:spMkLst>
        </pc:spChg>
        <pc:spChg chg="add del mod topLvl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605" creationId="{8BBBF029-6C5A-4B80-B4D4-4A856A31A1A5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606" creationId="{CCF58735-059F-4197-B075-69777F6E57B1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612" creationId="{6E8AA96D-CE8B-48D7-A8B3-F7E6FAE88D40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613" creationId="{9239537C-15BC-4F42-A26E-7A6A2E33E6C7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614" creationId="{23D7BFDF-477C-43DC-B057-85CCC63E8F31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615" creationId="{08AE8B3A-A97D-4BFB-B7DF-E7527CC9FB8E}"/>
          </ac:spMkLst>
        </pc:spChg>
        <pc:spChg chg="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617" creationId="{DEC06A02-4AB9-4C1B-8E48-6EA66EB24B4C}"/>
          </ac:spMkLst>
        </pc:spChg>
        <pc:spChg chg="add del mod topLvl">
          <ac:chgData name="Filippo Acconcia" userId="844af49c-a8a0-47ac-a7dd-14a44b60cd18" providerId="ADAL" clId="{4E01D738-D0C1-4B9B-B836-CF053EEC4C53}" dt="2022-03-16T08:33:21.811" v="730" actId="164"/>
          <ac:spMkLst>
            <pc:docMk/>
            <pc:sldMk cId="2323114696" sldId="300"/>
            <ac:spMk id="618" creationId="{F19D73C7-8C4A-4DD4-BDD1-A15AD0D3348F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619" creationId="{816F01DE-FEE2-46AF-8B1D-50F2E3DA68C5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620" creationId="{12BC550C-91E9-421E-ADF1-798BA61B7FA9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621" creationId="{EF84994E-9AC4-4FBB-B9DA-07A8EFD53E96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622" creationId="{558FE6D6-FFC5-4835-984F-048DC337B742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623" creationId="{C4EF245E-8271-4FEC-A1D6-01081162F3CF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624" creationId="{9D1C002B-12E0-4B98-A1D2-4A433F678E9F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625" creationId="{628AE210-4265-4244-A9E4-ABC8337DB857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626" creationId="{11886847-0A3B-4285-B692-C21059AED659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627" creationId="{F4675958-9F06-436D-A289-B6FF7D9A1408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628" creationId="{B931B173-AF83-47A2-8A0D-349F42D348C1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629" creationId="{F28E01FC-5D13-4B80-8229-828E999EB840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630" creationId="{49D5B616-BF61-4AE5-81D4-DFD17A0E26C4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631" creationId="{A3E779B6-F8BE-4BC1-873C-00FE18E7687F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632" creationId="{139548C7-F647-48D1-A22F-9D2C8A831114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633" creationId="{4DD86099-E655-43A7-B959-696B2E1A5444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634" creationId="{7FD5B549-B3E6-4943-B587-6AF1CCB31865}"/>
          </ac:spMkLst>
        </pc:spChg>
        <pc:spChg chg="add del mod">
          <ac:chgData name="Filippo Acconcia" userId="844af49c-a8a0-47ac-a7dd-14a44b60cd18" providerId="ADAL" clId="{4E01D738-D0C1-4B9B-B836-CF053EEC4C53}" dt="2022-03-16T08:19:41.684" v="440" actId="478"/>
          <ac:spMkLst>
            <pc:docMk/>
            <pc:sldMk cId="2323114696" sldId="300"/>
            <ac:spMk id="635" creationId="{1399D2EE-AF75-461C-B86F-5681D32A3C6A}"/>
          </ac:spMkLst>
        </pc:spChg>
        <pc:spChg chg="add mod">
          <ac:chgData name="Filippo Acconcia" userId="844af49c-a8a0-47ac-a7dd-14a44b60cd18" providerId="ADAL" clId="{4E01D738-D0C1-4B9B-B836-CF053EEC4C53}" dt="2022-03-16T08:33:43.773" v="732" actId="1035"/>
          <ac:spMkLst>
            <pc:docMk/>
            <pc:sldMk cId="2323114696" sldId="300"/>
            <ac:spMk id="636" creationId="{06D7066F-C875-4483-86BD-F58DFEBB5B24}"/>
          </ac:spMkLst>
        </pc:spChg>
        <pc:spChg chg="add mod">
          <ac:chgData name="Filippo Acconcia" userId="844af49c-a8a0-47ac-a7dd-14a44b60cd18" providerId="ADAL" clId="{4E01D738-D0C1-4B9B-B836-CF053EEC4C53}" dt="2022-03-16T08:33:43.773" v="732" actId="1035"/>
          <ac:spMkLst>
            <pc:docMk/>
            <pc:sldMk cId="2323114696" sldId="300"/>
            <ac:spMk id="637" creationId="{377D7FCF-4A7B-48BF-A522-7235807EA575}"/>
          </ac:spMkLst>
        </pc:spChg>
        <pc:spChg chg="add mod">
          <ac:chgData name="Filippo Acconcia" userId="844af49c-a8a0-47ac-a7dd-14a44b60cd18" providerId="ADAL" clId="{4E01D738-D0C1-4B9B-B836-CF053EEC4C53}" dt="2022-03-16T08:20:22.525" v="484" actId="12788"/>
          <ac:spMkLst>
            <pc:docMk/>
            <pc:sldMk cId="2323114696" sldId="300"/>
            <ac:spMk id="638" creationId="{E589C829-C5D0-44B8-9530-FD8118A7E2F8}"/>
          </ac:spMkLst>
        </pc:spChg>
        <pc:spChg chg="add mod">
          <ac:chgData name="Filippo Acconcia" userId="844af49c-a8a0-47ac-a7dd-14a44b60cd18" providerId="ADAL" clId="{4E01D738-D0C1-4B9B-B836-CF053EEC4C53}" dt="2022-03-16T08:20:29.913" v="487" actId="1037"/>
          <ac:spMkLst>
            <pc:docMk/>
            <pc:sldMk cId="2323114696" sldId="300"/>
            <ac:spMk id="639" creationId="{03508E2D-80C0-448B-8DCE-EC1B4EEBE05A}"/>
          </ac:spMkLst>
        </pc:spChg>
        <pc:spChg chg="add mod">
          <ac:chgData name="Filippo Acconcia" userId="844af49c-a8a0-47ac-a7dd-14a44b60cd18" providerId="ADAL" clId="{4E01D738-D0C1-4B9B-B836-CF053EEC4C53}" dt="2022-03-16T08:20:22.525" v="484" actId="12788"/>
          <ac:spMkLst>
            <pc:docMk/>
            <pc:sldMk cId="2323114696" sldId="300"/>
            <ac:spMk id="640" creationId="{08181E49-649B-425F-B989-A165F57AC591}"/>
          </ac:spMkLst>
        </pc:spChg>
        <pc:spChg chg="add mod">
          <ac:chgData name="Filippo Acconcia" userId="844af49c-a8a0-47ac-a7dd-14a44b60cd18" providerId="ADAL" clId="{4E01D738-D0C1-4B9B-B836-CF053EEC4C53}" dt="2022-03-16T08:20:29.913" v="487" actId="1037"/>
          <ac:spMkLst>
            <pc:docMk/>
            <pc:sldMk cId="2323114696" sldId="300"/>
            <ac:spMk id="641" creationId="{A6E651EF-9FD9-4D32-ADAB-3E89EDAF7C09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51" creationId="{72486AAA-FB32-4629-BFB5-7D928C8A4F9A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52" creationId="{0A1D9A71-C4D8-45CE-B249-C1BE6B3B9993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53" creationId="{627D44F5-280C-4327-9651-B8D5EC5E784F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54" creationId="{76F804FE-02AB-4A9B-942F-02740A0A76BD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55" creationId="{A1553BC2-3D72-4920-AA47-60E30E3FFDE0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57" creationId="{B64A40E2-3CC4-4308-AE55-0FC15CB939DC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59" creationId="{A521BF26-7FCC-4217-AFC7-DF2F04904511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61" creationId="{0FD165A5-EE84-4408-AEA6-E265D9F43D2A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63" creationId="{48843BDA-23C0-45BE-B236-D5519DB375CA}"/>
          </ac:spMkLst>
        </pc:spChg>
        <pc:spChg chg="mod topLvl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664" creationId="{4D79EBBC-39EF-4D14-9A6D-0C5DE1F09D51}"/>
          </ac:spMkLst>
        </pc:spChg>
        <pc:spChg chg="mod topLvl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665" creationId="{4A8B83FB-7683-40C4-B22C-66BEFAE7A291}"/>
          </ac:spMkLst>
        </pc:spChg>
        <pc:spChg chg="mod topLvl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666" creationId="{AD84E5A6-C3E4-4E10-8672-1DB5DDC0BE05}"/>
          </ac:spMkLst>
        </pc:spChg>
        <pc:spChg chg="mod topLvl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667" creationId="{6CE01B75-A13C-4727-908D-9FF910329541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68" creationId="{9C520C53-B661-4008-BA7E-A8975FF6C8DE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74" creationId="{AF150BFE-0665-420C-86FF-8E616B31FA0D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75" creationId="{17DB7FF3-6E7D-4DCC-A89E-F27009A2D6B0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76" creationId="{47E6F595-C05E-473F-8C19-767DF52E407C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77" creationId="{1FD0A77B-CCBF-4160-B3C7-FE797478D7CD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79" creationId="{225CA7B7-FC9B-4465-B9CF-3689BBB76927}"/>
          </ac:spMkLst>
        </pc:spChg>
        <pc:spChg chg="mod topLvl">
          <ac:chgData name="Filippo Acconcia" userId="844af49c-a8a0-47ac-a7dd-14a44b60cd18" providerId="ADAL" clId="{4E01D738-D0C1-4B9B-B836-CF053EEC4C53}" dt="2022-03-16T08:31:52.134" v="710" actId="164"/>
          <ac:spMkLst>
            <pc:docMk/>
            <pc:sldMk cId="2323114696" sldId="300"/>
            <ac:spMk id="680" creationId="{2017158C-C55E-483F-90CB-F77B431FDC6A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681" creationId="{2DB2D750-363C-45C8-9F60-F3308E025614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682" creationId="{2CD4ECDB-D27A-48B0-89E6-78A953FE004B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683" creationId="{D85B523E-9F58-47FF-A556-08F0156DAAFB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684" creationId="{45963B42-19A6-432C-8A77-659CF5462CC6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685" creationId="{464496E9-59C9-4CB7-8E07-C80D4FD00D64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686" creationId="{9167C7A0-B068-486D-B85D-A62207CE620C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687" creationId="{2A71B22E-6E1A-43DF-B29E-44B3AA15C736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688" creationId="{73F7949D-83A2-4C42-B9BB-D34301E96D94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689" creationId="{8DA6F694-8787-49D9-BF05-6DC54B18EFC8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690" creationId="{7335A2D5-A75D-48F5-B3F8-480BACD4B825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691" creationId="{0C97A9AF-1738-40EA-AA5F-7FB0D8CF75CE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692" creationId="{5FD12E02-83A7-441E-BC56-FCAD7DFAC416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23114696" sldId="300"/>
            <ac:spMk id="693" creationId="{DCED0DB7-C41C-45F9-AABB-4F7D0FB7E0A8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23114696" sldId="300"/>
            <ac:spMk id="694" creationId="{A89737EF-0729-4B8E-A764-52B35949019B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23114696" sldId="300"/>
            <ac:spMk id="695" creationId="{EC87B18E-1AE1-4D23-8AC2-C928B5E82CD2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23114696" sldId="300"/>
            <ac:spMk id="696" creationId="{1D89C829-DBE0-47EB-9F91-265C596571D7}"/>
          </ac:spMkLst>
        </pc:spChg>
        <pc:grpChg chg="add mod topLvl">
          <ac:chgData name="Filippo Acconcia" userId="844af49c-a8a0-47ac-a7dd-14a44b60cd18" providerId="ADAL" clId="{4E01D738-D0C1-4B9B-B836-CF053EEC4C53}" dt="2022-03-16T08:14:45.564" v="394" actId="164"/>
          <ac:grpSpMkLst>
            <pc:docMk/>
            <pc:sldMk cId="2323114696" sldId="300"/>
            <ac:grpSpMk id="5" creationId="{79F03B6F-98C9-48B9-9EDA-EE9FFFC6C305}"/>
          </ac:grpSpMkLst>
        </pc:grpChg>
        <pc:grpChg chg="add del mod">
          <ac:chgData name="Filippo Acconcia" userId="844af49c-a8a0-47ac-a7dd-14a44b60cd18" providerId="ADAL" clId="{4E01D738-D0C1-4B9B-B836-CF053EEC4C53}" dt="2022-03-16T08:08:57.631" v="160" actId="165"/>
          <ac:grpSpMkLst>
            <pc:docMk/>
            <pc:sldMk cId="2323114696" sldId="300"/>
            <ac:grpSpMk id="14" creationId="{A5882B26-A4CF-4B30-8820-CA8A9FC764B6}"/>
          </ac:grpSpMkLst>
        </pc:grpChg>
        <pc:grpChg chg="add del mod">
          <ac:chgData name="Filippo Acconcia" userId="844af49c-a8a0-47ac-a7dd-14a44b60cd18" providerId="ADAL" clId="{4E01D738-D0C1-4B9B-B836-CF053EEC4C53}" dt="2022-03-16T08:04:34.656" v="20" actId="165"/>
          <ac:grpSpMkLst>
            <pc:docMk/>
            <pc:sldMk cId="2323114696" sldId="300"/>
            <ac:grpSpMk id="30" creationId="{0C0DE80E-7E37-44AF-BE3E-A34D46E4B456}"/>
          </ac:grpSpMkLst>
        </pc:grpChg>
        <pc:grpChg chg="mod">
          <ac:chgData name="Filippo Acconcia" userId="844af49c-a8a0-47ac-a7dd-14a44b60cd18" providerId="ADAL" clId="{4E01D738-D0C1-4B9B-B836-CF053EEC4C53}" dt="2022-03-16T08:04:13.210" v="11" actId="1035"/>
          <ac:grpSpMkLst>
            <pc:docMk/>
            <pc:sldMk cId="2323114696" sldId="300"/>
            <ac:grpSpMk id="40" creationId="{B3A815DF-90FD-4106-B7F7-B3E088192913}"/>
          </ac:grpSpMkLst>
        </pc:grpChg>
        <pc:grpChg chg="add del mod">
          <ac:chgData name="Filippo Acconcia" userId="844af49c-a8a0-47ac-a7dd-14a44b60cd18" providerId="ADAL" clId="{4E01D738-D0C1-4B9B-B836-CF053EEC4C53}" dt="2022-03-16T08:08:13.223" v="116" actId="478"/>
          <ac:grpSpMkLst>
            <pc:docMk/>
            <pc:sldMk cId="2323114696" sldId="300"/>
            <ac:grpSpMk id="61" creationId="{4A2BBACE-338C-4BC2-AAE6-D9D17E74F012}"/>
          </ac:grpSpMkLst>
        </pc:grpChg>
        <pc:grpChg chg="add del mod">
          <ac:chgData name="Filippo Acconcia" userId="844af49c-a8a0-47ac-a7dd-14a44b60cd18" providerId="ADAL" clId="{4E01D738-D0C1-4B9B-B836-CF053EEC4C53}" dt="2022-03-16T08:08:57.631" v="160" actId="165"/>
          <ac:grpSpMkLst>
            <pc:docMk/>
            <pc:sldMk cId="2323114696" sldId="300"/>
            <ac:grpSpMk id="66" creationId="{2E28BD13-29EB-417C-A5E5-90520615CCE7}"/>
          </ac:grpSpMkLst>
        </pc:grpChg>
        <pc:grpChg chg="mod topLvl">
          <ac:chgData name="Filippo Acconcia" userId="844af49c-a8a0-47ac-a7dd-14a44b60cd18" providerId="ADAL" clId="{4E01D738-D0C1-4B9B-B836-CF053EEC4C53}" dt="2022-03-16T08:14:45.564" v="394" actId="164"/>
          <ac:grpSpMkLst>
            <pc:docMk/>
            <pc:sldMk cId="2323114696" sldId="300"/>
            <ac:grpSpMk id="68" creationId="{1B52722F-B3BB-49E9-AA31-E6621ABFE87B}"/>
          </ac:grpSpMkLst>
        </pc:grpChg>
        <pc:grpChg chg="add del mod">
          <ac:chgData name="Filippo Acconcia" userId="844af49c-a8a0-47ac-a7dd-14a44b60cd18" providerId="ADAL" clId="{4E01D738-D0C1-4B9B-B836-CF053EEC4C53}" dt="2022-03-16T08:08:57.631" v="160" actId="165"/>
          <ac:grpSpMkLst>
            <pc:docMk/>
            <pc:sldMk cId="2323114696" sldId="300"/>
            <ac:grpSpMk id="73" creationId="{BC0DDB99-FCF0-4FD0-9541-99ACB6676039}"/>
          </ac:grpSpMkLst>
        </pc:grpChg>
        <pc:grpChg chg="mod topLvl">
          <ac:chgData name="Filippo Acconcia" userId="844af49c-a8a0-47ac-a7dd-14a44b60cd18" providerId="ADAL" clId="{4E01D738-D0C1-4B9B-B836-CF053EEC4C53}" dt="2022-03-16T08:14:45.564" v="394" actId="164"/>
          <ac:grpSpMkLst>
            <pc:docMk/>
            <pc:sldMk cId="2323114696" sldId="300"/>
            <ac:grpSpMk id="75" creationId="{42460019-69B7-430D-B05E-2FCCC54D5C71}"/>
          </ac:grpSpMkLst>
        </pc:grpChg>
        <pc:grpChg chg="add del mod">
          <ac:chgData name="Filippo Acconcia" userId="844af49c-a8a0-47ac-a7dd-14a44b60cd18" providerId="ADAL" clId="{4E01D738-D0C1-4B9B-B836-CF053EEC4C53}" dt="2022-03-16T08:08:57.631" v="160" actId="165"/>
          <ac:grpSpMkLst>
            <pc:docMk/>
            <pc:sldMk cId="2323114696" sldId="300"/>
            <ac:grpSpMk id="80" creationId="{4AC37950-2B2A-40C4-AD33-1CE56BEB5349}"/>
          </ac:grpSpMkLst>
        </pc:grpChg>
        <pc:grpChg chg="mod topLvl">
          <ac:chgData name="Filippo Acconcia" userId="844af49c-a8a0-47ac-a7dd-14a44b60cd18" providerId="ADAL" clId="{4E01D738-D0C1-4B9B-B836-CF053EEC4C53}" dt="2022-03-16T08:14:45.564" v="394" actId="164"/>
          <ac:grpSpMkLst>
            <pc:docMk/>
            <pc:sldMk cId="2323114696" sldId="300"/>
            <ac:grpSpMk id="82" creationId="{C18508EF-0BC3-455E-BCA6-86ACDE66C92F}"/>
          </ac:grpSpMkLst>
        </pc:grpChg>
        <pc:grpChg chg="add del mod">
          <ac:chgData name="Filippo Acconcia" userId="844af49c-a8a0-47ac-a7dd-14a44b60cd18" providerId="ADAL" clId="{4E01D738-D0C1-4B9B-B836-CF053EEC4C53}" dt="2022-03-16T08:08:52.266" v="159" actId="165"/>
          <ac:grpSpMkLst>
            <pc:docMk/>
            <pc:sldMk cId="2323114696" sldId="300"/>
            <ac:grpSpMk id="87" creationId="{B747B61C-6317-41EE-835F-7BC3685487A0}"/>
          </ac:grpSpMkLst>
        </pc:grpChg>
        <pc:grpChg chg="del mod topLvl">
          <ac:chgData name="Filippo Acconcia" userId="844af49c-a8a0-47ac-a7dd-14a44b60cd18" providerId="ADAL" clId="{4E01D738-D0C1-4B9B-B836-CF053EEC4C53}" dt="2022-03-16T08:08:57.631" v="160" actId="165"/>
          <ac:grpSpMkLst>
            <pc:docMk/>
            <pc:sldMk cId="2323114696" sldId="300"/>
            <ac:grpSpMk id="89" creationId="{3302DFE0-17F1-45C2-BF19-A4B73282FA0F}"/>
          </ac:grpSpMkLst>
        </pc:grpChg>
        <pc:grpChg chg="add del mod">
          <ac:chgData name="Filippo Acconcia" userId="844af49c-a8a0-47ac-a7dd-14a44b60cd18" providerId="ADAL" clId="{4E01D738-D0C1-4B9B-B836-CF053EEC4C53}" dt="2022-03-16T08:15:35.297" v="406" actId="21"/>
          <ac:grpSpMkLst>
            <pc:docMk/>
            <pc:sldMk cId="2323114696" sldId="300"/>
            <ac:grpSpMk id="106" creationId="{F4498538-92C3-4549-86C1-626E48A02733}"/>
          </ac:grpSpMkLst>
        </pc:grpChg>
        <pc:grpChg chg="add del mod">
          <ac:chgData name="Filippo Acconcia" userId="844af49c-a8a0-47ac-a7dd-14a44b60cd18" providerId="ADAL" clId="{4E01D738-D0C1-4B9B-B836-CF053EEC4C53}" dt="2022-03-16T08:15:35.297" v="406" actId="21"/>
          <ac:grpSpMkLst>
            <pc:docMk/>
            <pc:sldMk cId="2323114696" sldId="300"/>
            <ac:grpSpMk id="107" creationId="{E0C087D9-E1F1-4372-BC1D-29055D0B4EF0}"/>
          </ac:grpSpMkLst>
        </pc:grpChg>
        <pc:grpChg chg="mod">
          <ac:chgData name="Filippo Acconcia" userId="844af49c-a8a0-47ac-a7dd-14a44b60cd18" providerId="ADAL" clId="{4E01D738-D0C1-4B9B-B836-CF053EEC4C53}" dt="2022-03-16T08:14:56.443" v="398"/>
          <ac:grpSpMkLst>
            <pc:docMk/>
            <pc:sldMk cId="2323114696" sldId="300"/>
            <ac:grpSpMk id="114" creationId="{584576DB-3837-4C5F-ADA9-05F48F4CF420}"/>
          </ac:grpSpMkLst>
        </pc:grpChg>
        <pc:grpChg chg="mod">
          <ac:chgData name="Filippo Acconcia" userId="844af49c-a8a0-47ac-a7dd-14a44b60cd18" providerId="ADAL" clId="{4E01D738-D0C1-4B9B-B836-CF053EEC4C53}" dt="2022-03-16T08:14:56.443" v="398"/>
          <ac:grpSpMkLst>
            <pc:docMk/>
            <pc:sldMk cId="2323114696" sldId="300"/>
            <ac:grpSpMk id="116" creationId="{0CEE9DD4-D275-4D00-8B15-8671463CA29B}"/>
          </ac:grpSpMkLst>
        </pc:grpChg>
        <pc:grpChg chg="mod">
          <ac:chgData name="Filippo Acconcia" userId="844af49c-a8a0-47ac-a7dd-14a44b60cd18" providerId="ADAL" clId="{4E01D738-D0C1-4B9B-B836-CF053EEC4C53}" dt="2022-03-16T08:14:56.443" v="398"/>
          <ac:grpSpMkLst>
            <pc:docMk/>
            <pc:sldMk cId="2323114696" sldId="300"/>
            <ac:grpSpMk id="118" creationId="{654F4224-085A-4D36-987D-B44CD4293794}"/>
          </ac:grpSpMkLst>
        </pc:grpChg>
        <pc:grpChg chg="mod">
          <ac:chgData name="Filippo Acconcia" userId="844af49c-a8a0-47ac-a7dd-14a44b60cd18" providerId="ADAL" clId="{4E01D738-D0C1-4B9B-B836-CF053EEC4C53}" dt="2022-03-16T08:14:56.443" v="398"/>
          <ac:grpSpMkLst>
            <pc:docMk/>
            <pc:sldMk cId="2323114696" sldId="300"/>
            <ac:grpSpMk id="120" creationId="{C011A37C-0720-4008-947C-DE722AC3888F}"/>
          </ac:grpSpMkLst>
        </pc:grpChg>
        <pc:grpChg chg="add del mod">
          <ac:chgData name="Filippo Acconcia" userId="844af49c-a8a0-47ac-a7dd-14a44b60cd18" providerId="ADAL" clId="{4E01D738-D0C1-4B9B-B836-CF053EEC4C53}" dt="2022-03-16T08:15:35.297" v="406" actId="21"/>
          <ac:grpSpMkLst>
            <pc:docMk/>
            <pc:sldMk cId="2323114696" sldId="300"/>
            <ac:grpSpMk id="155" creationId="{7BD34AC1-B005-4050-A55A-07862E04D853}"/>
          </ac:grpSpMkLst>
        </pc:grpChg>
        <pc:grpChg chg="mod">
          <ac:chgData name="Filippo Acconcia" userId="844af49c-a8a0-47ac-a7dd-14a44b60cd18" providerId="ADAL" clId="{4E01D738-D0C1-4B9B-B836-CF053EEC4C53}" dt="2022-03-16T08:15:04.085" v="402"/>
          <ac:grpSpMkLst>
            <pc:docMk/>
            <pc:sldMk cId="2323114696" sldId="300"/>
            <ac:grpSpMk id="162" creationId="{7F556582-5E74-4317-A2A9-66A5EC01F025}"/>
          </ac:grpSpMkLst>
        </pc:grpChg>
        <pc:grpChg chg="mod">
          <ac:chgData name="Filippo Acconcia" userId="844af49c-a8a0-47ac-a7dd-14a44b60cd18" providerId="ADAL" clId="{4E01D738-D0C1-4B9B-B836-CF053EEC4C53}" dt="2022-03-16T08:15:04.085" v="402"/>
          <ac:grpSpMkLst>
            <pc:docMk/>
            <pc:sldMk cId="2323114696" sldId="300"/>
            <ac:grpSpMk id="164" creationId="{9D17FFDC-D92A-4DD1-BEC6-0791494E13C9}"/>
          </ac:grpSpMkLst>
        </pc:grpChg>
        <pc:grpChg chg="mod">
          <ac:chgData name="Filippo Acconcia" userId="844af49c-a8a0-47ac-a7dd-14a44b60cd18" providerId="ADAL" clId="{4E01D738-D0C1-4B9B-B836-CF053EEC4C53}" dt="2022-03-16T08:15:04.085" v="402"/>
          <ac:grpSpMkLst>
            <pc:docMk/>
            <pc:sldMk cId="2323114696" sldId="300"/>
            <ac:grpSpMk id="166" creationId="{D9D90DA6-EED3-4435-9841-FD1F095494ED}"/>
          </ac:grpSpMkLst>
        </pc:grpChg>
        <pc:grpChg chg="mod">
          <ac:chgData name="Filippo Acconcia" userId="844af49c-a8a0-47ac-a7dd-14a44b60cd18" providerId="ADAL" clId="{4E01D738-D0C1-4B9B-B836-CF053EEC4C53}" dt="2022-03-16T08:15:04.085" v="402"/>
          <ac:grpSpMkLst>
            <pc:docMk/>
            <pc:sldMk cId="2323114696" sldId="300"/>
            <ac:grpSpMk id="168" creationId="{282A28BF-8666-496D-AF20-4A21114AC8B9}"/>
          </ac:grpSpMkLst>
        </pc:grpChg>
        <pc:grpChg chg="add del mod">
          <ac:chgData name="Filippo Acconcia" userId="844af49c-a8a0-47ac-a7dd-14a44b60cd18" providerId="ADAL" clId="{4E01D738-D0C1-4B9B-B836-CF053EEC4C53}" dt="2022-03-16T08:15:35.297" v="406" actId="21"/>
          <ac:grpSpMkLst>
            <pc:docMk/>
            <pc:sldMk cId="2323114696" sldId="300"/>
            <ac:grpSpMk id="203" creationId="{5FC499A5-0168-4CB7-978A-C9B59BFA6686}"/>
          </ac:grpSpMkLst>
        </pc:grpChg>
        <pc:grpChg chg="mod">
          <ac:chgData name="Filippo Acconcia" userId="844af49c-a8a0-47ac-a7dd-14a44b60cd18" providerId="ADAL" clId="{4E01D738-D0C1-4B9B-B836-CF053EEC4C53}" dt="2022-03-16T08:15:04.085" v="402"/>
          <ac:grpSpMkLst>
            <pc:docMk/>
            <pc:sldMk cId="2323114696" sldId="300"/>
            <ac:grpSpMk id="210" creationId="{26DE75A7-5947-4A9F-A37A-B3B039ED5FE5}"/>
          </ac:grpSpMkLst>
        </pc:grpChg>
        <pc:grpChg chg="mod">
          <ac:chgData name="Filippo Acconcia" userId="844af49c-a8a0-47ac-a7dd-14a44b60cd18" providerId="ADAL" clId="{4E01D738-D0C1-4B9B-B836-CF053EEC4C53}" dt="2022-03-16T08:15:04.085" v="402"/>
          <ac:grpSpMkLst>
            <pc:docMk/>
            <pc:sldMk cId="2323114696" sldId="300"/>
            <ac:grpSpMk id="212" creationId="{6B70A257-45B4-476D-A847-7479A583E5AC}"/>
          </ac:grpSpMkLst>
        </pc:grpChg>
        <pc:grpChg chg="mod">
          <ac:chgData name="Filippo Acconcia" userId="844af49c-a8a0-47ac-a7dd-14a44b60cd18" providerId="ADAL" clId="{4E01D738-D0C1-4B9B-B836-CF053EEC4C53}" dt="2022-03-16T08:15:04.085" v="402"/>
          <ac:grpSpMkLst>
            <pc:docMk/>
            <pc:sldMk cId="2323114696" sldId="300"/>
            <ac:grpSpMk id="214" creationId="{910264C9-5754-4326-B86E-2B1D46F5372B}"/>
          </ac:grpSpMkLst>
        </pc:grpChg>
        <pc:grpChg chg="mod">
          <ac:chgData name="Filippo Acconcia" userId="844af49c-a8a0-47ac-a7dd-14a44b60cd18" providerId="ADAL" clId="{4E01D738-D0C1-4B9B-B836-CF053EEC4C53}" dt="2022-03-16T08:15:04.085" v="402"/>
          <ac:grpSpMkLst>
            <pc:docMk/>
            <pc:sldMk cId="2323114696" sldId="300"/>
            <ac:grpSpMk id="216" creationId="{6E2B0DFF-FA09-4690-A409-C37EBE546BB2}"/>
          </ac:grpSpMkLst>
        </pc:grpChg>
        <pc:grpChg chg="add del mod">
          <ac:chgData name="Filippo Acconcia" userId="844af49c-a8a0-47ac-a7dd-14a44b60cd18" providerId="ADAL" clId="{4E01D738-D0C1-4B9B-B836-CF053EEC4C53}" dt="2022-03-16T08:15:35.297" v="406" actId="21"/>
          <ac:grpSpMkLst>
            <pc:docMk/>
            <pc:sldMk cId="2323114696" sldId="300"/>
            <ac:grpSpMk id="251" creationId="{EDBBD5BB-9F6B-4A84-975F-419E81684E46}"/>
          </ac:grpSpMkLst>
        </pc:grpChg>
        <pc:grpChg chg="mod">
          <ac:chgData name="Filippo Acconcia" userId="844af49c-a8a0-47ac-a7dd-14a44b60cd18" providerId="ADAL" clId="{4E01D738-D0C1-4B9B-B836-CF053EEC4C53}" dt="2022-03-16T08:15:07.319" v="404"/>
          <ac:grpSpMkLst>
            <pc:docMk/>
            <pc:sldMk cId="2323114696" sldId="300"/>
            <ac:grpSpMk id="258" creationId="{180FF289-F98C-4672-BC52-014364A3479A}"/>
          </ac:grpSpMkLst>
        </pc:grpChg>
        <pc:grpChg chg="mod">
          <ac:chgData name="Filippo Acconcia" userId="844af49c-a8a0-47ac-a7dd-14a44b60cd18" providerId="ADAL" clId="{4E01D738-D0C1-4B9B-B836-CF053EEC4C53}" dt="2022-03-16T08:15:07.319" v="404"/>
          <ac:grpSpMkLst>
            <pc:docMk/>
            <pc:sldMk cId="2323114696" sldId="300"/>
            <ac:grpSpMk id="260" creationId="{ACBB84FD-157B-4F9C-874E-3A217F2CA6C1}"/>
          </ac:grpSpMkLst>
        </pc:grpChg>
        <pc:grpChg chg="mod">
          <ac:chgData name="Filippo Acconcia" userId="844af49c-a8a0-47ac-a7dd-14a44b60cd18" providerId="ADAL" clId="{4E01D738-D0C1-4B9B-B836-CF053EEC4C53}" dt="2022-03-16T08:15:07.319" v="404"/>
          <ac:grpSpMkLst>
            <pc:docMk/>
            <pc:sldMk cId="2323114696" sldId="300"/>
            <ac:grpSpMk id="262" creationId="{9F0984EC-3C41-4F7E-9F9C-AC8F658BCD2D}"/>
          </ac:grpSpMkLst>
        </pc:grpChg>
        <pc:grpChg chg="mod">
          <ac:chgData name="Filippo Acconcia" userId="844af49c-a8a0-47ac-a7dd-14a44b60cd18" providerId="ADAL" clId="{4E01D738-D0C1-4B9B-B836-CF053EEC4C53}" dt="2022-03-16T08:15:07.319" v="404"/>
          <ac:grpSpMkLst>
            <pc:docMk/>
            <pc:sldMk cId="2323114696" sldId="300"/>
            <ac:grpSpMk id="264" creationId="{53C0C8C1-EC08-46F5-A950-9319A23376F7}"/>
          </ac:grpSpMkLst>
        </pc:grpChg>
        <pc:grpChg chg="add del mod">
          <ac:chgData name="Filippo Acconcia" userId="844af49c-a8a0-47ac-a7dd-14a44b60cd18" providerId="ADAL" clId="{4E01D738-D0C1-4B9B-B836-CF053EEC4C53}" dt="2022-03-16T08:15:35.297" v="406" actId="21"/>
          <ac:grpSpMkLst>
            <pc:docMk/>
            <pc:sldMk cId="2323114696" sldId="300"/>
            <ac:grpSpMk id="299" creationId="{31FC3203-7A1A-4F87-850D-9555B61B95E0}"/>
          </ac:grpSpMkLst>
        </pc:grpChg>
        <pc:grpChg chg="mod">
          <ac:chgData name="Filippo Acconcia" userId="844af49c-a8a0-47ac-a7dd-14a44b60cd18" providerId="ADAL" clId="{4E01D738-D0C1-4B9B-B836-CF053EEC4C53}" dt="2022-03-16T08:15:07.319" v="404"/>
          <ac:grpSpMkLst>
            <pc:docMk/>
            <pc:sldMk cId="2323114696" sldId="300"/>
            <ac:grpSpMk id="306" creationId="{3A76464F-4B2F-4880-A6CE-42F4549774CC}"/>
          </ac:grpSpMkLst>
        </pc:grpChg>
        <pc:grpChg chg="mod">
          <ac:chgData name="Filippo Acconcia" userId="844af49c-a8a0-47ac-a7dd-14a44b60cd18" providerId="ADAL" clId="{4E01D738-D0C1-4B9B-B836-CF053EEC4C53}" dt="2022-03-16T08:15:07.319" v="404"/>
          <ac:grpSpMkLst>
            <pc:docMk/>
            <pc:sldMk cId="2323114696" sldId="300"/>
            <ac:grpSpMk id="308" creationId="{7F68F7A5-6179-4E4B-B3D5-0DA1DC03FA20}"/>
          </ac:grpSpMkLst>
        </pc:grpChg>
        <pc:grpChg chg="mod">
          <ac:chgData name="Filippo Acconcia" userId="844af49c-a8a0-47ac-a7dd-14a44b60cd18" providerId="ADAL" clId="{4E01D738-D0C1-4B9B-B836-CF053EEC4C53}" dt="2022-03-16T08:15:07.319" v="404"/>
          <ac:grpSpMkLst>
            <pc:docMk/>
            <pc:sldMk cId="2323114696" sldId="300"/>
            <ac:grpSpMk id="310" creationId="{612CDE78-D263-4E13-A6BA-BDFAC1984277}"/>
          </ac:grpSpMkLst>
        </pc:grpChg>
        <pc:grpChg chg="mod">
          <ac:chgData name="Filippo Acconcia" userId="844af49c-a8a0-47ac-a7dd-14a44b60cd18" providerId="ADAL" clId="{4E01D738-D0C1-4B9B-B836-CF053EEC4C53}" dt="2022-03-16T08:15:07.319" v="404"/>
          <ac:grpSpMkLst>
            <pc:docMk/>
            <pc:sldMk cId="2323114696" sldId="300"/>
            <ac:grpSpMk id="312" creationId="{D2E21788-BEA9-4130-B933-A266CE1B6F84}"/>
          </ac:grpSpMkLst>
        </pc:grpChg>
        <pc:grpChg chg="add mod">
          <ac:chgData name="Filippo Acconcia" userId="844af49c-a8a0-47ac-a7dd-14a44b60cd18" providerId="ADAL" clId="{4E01D738-D0C1-4B9B-B836-CF053EEC4C53}" dt="2022-03-16T08:19:29.242" v="437" actId="1035"/>
          <ac:grpSpMkLst>
            <pc:docMk/>
            <pc:sldMk cId="2323114696" sldId="300"/>
            <ac:grpSpMk id="347" creationId="{DD634BF5-24BA-48AA-A0A8-FCE763180BE0}"/>
          </ac:grpSpMkLst>
        </pc:grpChg>
        <pc:grpChg chg="mod">
          <ac:chgData name="Filippo Acconcia" userId="844af49c-a8a0-47ac-a7dd-14a44b60cd18" providerId="ADAL" clId="{4E01D738-D0C1-4B9B-B836-CF053EEC4C53}" dt="2022-03-16T08:16:05.880" v="415"/>
          <ac:grpSpMkLst>
            <pc:docMk/>
            <pc:sldMk cId="2323114696" sldId="300"/>
            <ac:grpSpMk id="354" creationId="{73D6D072-6ACE-494B-8782-0F1C1CC6BE38}"/>
          </ac:grpSpMkLst>
        </pc:grpChg>
        <pc:grpChg chg="mod">
          <ac:chgData name="Filippo Acconcia" userId="844af49c-a8a0-47ac-a7dd-14a44b60cd18" providerId="ADAL" clId="{4E01D738-D0C1-4B9B-B836-CF053EEC4C53}" dt="2022-03-16T08:16:05.880" v="415"/>
          <ac:grpSpMkLst>
            <pc:docMk/>
            <pc:sldMk cId="2323114696" sldId="300"/>
            <ac:grpSpMk id="356" creationId="{9F93ABF3-EEB4-4D29-8E53-B50B66F3E00C}"/>
          </ac:grpSpMkLst>
        </pc:grpChg>
        <pc:grpChg chg="mod">
          <ac:chgData name="Filippo Acconcia" userId="844af49c-a8a0-47ac-a7dd-14a44b60cd18" providerId="ADAL" clId="{4E01D738-D0C1-4B9B-B836-CF053EEC4C53}" dt="2022-03-16T08:16:05.880" v="415"/>
          <ac:grpSpMkLst>
            <pc:docMk/>
            <pc:sldMk cId="2323114696" sldId="300"/>
            <ac:grpSpMk id="358" creationId="{C41A578D-09C8-41EF-812D-3E2C05161813}"/>
          </ac:grpSpMkLst>
        </pc:grpChg>
        <pc:grpChg chg="mod">
          <ac:chgData name="Filippo Acconcia" userId="844af49c-a8a0-47ac-a7dd-14a44b60cd18" providerId="ADAL" clId="{4E01D738-D0C1-4B9B-B836-CF053EEC4C53}" dt="2022-03-16T08:16:05.880" v="415"/>
          <ac:grpSpMkLst>
            <pc:docMk/>
            <pc:sldMk cId="2323114696" sldId="300"/>
            <ac:grpSpMk id="360" creationId="{08AE25C5-9AD8-40A5-83B1-064CE94463ED}"/>
          </ac:grpSpMkLst>
        </pc:grpChg>
        <pc:grpChg chg="add del mod">
          <ac:chgData name="Filippo Acconcia" userId="844af49c-a8a0-47ac-a7dd-14a44b60cd18" providerId="ADAL" clId="{4E01D738-D0C1-4B9B-B836-CF053EEC4C53}" dt="2022-03-16T08:21:02.006" v="489" actId="165"/>
          <ac:grpSpMkLst>
            <pc:docMk/>
            <pc:sldMk cId="2323114696" sldId="300"/>
            <ac:grpSpMk id="395" creationId="{D1ED3239-B623-440F-B8FF-2FABD439ADA5}"/>
          </ac:grpSpMkLst>
        </pc:grpChg>
        <pc:grpChg chg="del mod topLvl">
          <ac:chgData name="Filippo Acconcia" userId="844af49c-a8a0-47ac-a7dd-14a44b60cd18" providerId="ADAL" clId="{4E01D738-D0C1-4B9B-B836-CF053EEC4C53}" dt="2022-03-16T08:22:09.175" v="503" actId="165"/>
          <ac:grpSpMkLst>
            <pc:docMk/>
            <pc:sldMk cId="2323114696" sldId="300"/>
            <ac:grpSpMk id="402" creationId="{24779E56-DF2C-4CCA-9E39-72FEDE830D2C}"/>
          </ac:grpSpMkLst>
        </pc:grpChg>
        <pc:grpChg chg="del mod topLvl">
          <ac:chgData name="Filippo Acconcia" userId="844af49c-a8a0-47ac-a7dd-14a44b60cd18" providerId="ADAL" clId="{4E01D738-D0C1-4B9B-B836-CF053EEC4C53}" dt="2022-03-16T08:22:09.175" v="503" actId="165"/>
          <ac:grpSpMkLst>
            <pc:docMk/>
            <pc:sldMk cId="2323114696" sldId="300"/>
            <ac:grpSpMk id="404" creationId="{4125AE36-2260-4B4A-9779-27F0BDFA7408}"/>
          </ac:grpSpMkLst>
        </pc:grpChg>
        <pc:grpChg chg="del mod topLvl">
          <ac:chgData name="Filippo Acconcia" userId="844af49c-a8a0-47ac-a7dd-14a44b60cd18" providerId="ADAL" clId="{4E01D738-D0C1-4B9B-B836-CF053EEC4C53}" dt="2022-03-16T08:22:09.175" v="503" actId="165"/>
          <ac:grpSpMkLst>
            <pc:docMk/>
            <pc:sldMk cId="2323114696" sldId="300"/>
            <ac:grpSpMk id="406" creationId="{3C9E807C-6CEA-4E75-9552-34C0904D1621}"/>
          </ac:grpSpMkLst>
        </pc:grpChg>
        <pc:grpChg chg="del mod topLvl">
          <ac:chgData name="Filippo Acconcia" userId="844af49c-a8a0-47ac-a7dd-14a44b60cd18" providerId="ADAL" clId="{4E01D738-D0C1-4B9B-B836-CF053EEC4C53}" dt="2022-03-16T08:22:09.175" v="503" actId="165"/>
          <ac:grpSpMkLst>
            <pc:docMk/>
            <pc:sldMk cId="2323114696" sldId="300"/>
            <ac:grpSpMk id="408" creationId="{692F69A5-C382-4B36-8600-2F34DE029B21}"/>
          </ac:grpSpMkLst>
        </pc:grpChg>
        <pc:grpChg chg="add del mod">
          <ac:chgData name="Filippo Acconcia" userId="844af49c-a8a0-47ac-a7dd-14a44b60cd18" providerId="ADAL" clId="{4E01D738-D0C1-4B9B-B836-CF053EEC4C53}" dt="2022-03-16T08:22:52.514" v="506" actId="165"/>
          <ac:grpSpMkLst>
            <pc:docMk/>
            <pc:sldMk cId="2323114696" sldId="300"/>
            <ac:grpSpMk id="443" creationId="{A7791DD9-0B3F-4FB4-AF1A-239756A6AD6C}"/>
          </ac:grpSpMkLst>
        </pc:grpChg>
        <pc:grpChg chg="mod topLvl">
          <ac:chgData name="Filippo Acconcia" userId="844af49c-a8a0-47ac-a7dd-14a44b60cd18" providerId="ADAL" clId="{4E01D738-D0C1-4B9B-B836-CF053EEC4C53}" dt="2022-03-16T08:26:20.489" v="606" actId="164"/>
          <ac:grpSpMkLst>
            <pc:docMk/>
            <pc:sldMk cId="2323114696" sldId="300"/>
            <ac:grpSpMk id="450" creationId="{2888366A-2C7E-4E15-BD57-B0B380EC2DB5}"/>
          </ac:grpSpMkLst>
        </pc:grpChg>
        <pc:grpChg chg="mod topLvl">
          <ac:chgData name="Filippo Acconcia" userId="844af49c-a8a0-47ac-a7dd-14a44b60cd18" providerId="ADAL" clId="{4E01D738-D0C1-4B9B-B836-CF053EEC4C53}" dt="2022-03-16T08:26:20.489" v="606" actId="164"/>
          <ac:grpSpMkLst>
            <pc:docMk/>
            <pc:sldMk cId="2323114696" sldId="300"/>
            <ac:grpSpMk id="452" creationId="{8351CFCB-3E84-427A-947C-A744214809E7}"/>
          </ac:grpSpMkLst>
        </pc:grpChg>
        <pc:grpChg chg="mod topLvl">
          <ac:chgData name="Filippo Acconcia" userId="844af49c-a8a0-47ac-a7dd-14a44b60cd18" providerId="ADAL" clId="{4E01D738-D0C1-4B9B-B836-CF053EEC4C53}" dt="2022-03-16T08:26:20.489" v="606" actId="164"/>
          <ac:grpSpMkLst>
            <pc:docMk/>
            <pc:sldMk cId="2323114696" sldId="300"/>
            <ac:grpSpMk id="454" creationId="{12AD2840-4819-46E3-B4AC-AB0052DD1154}"/>
          </ac:grpSpMkLst>
        </pc:grpChg>
        <pc:grpChg chg="mod topLvl">
          <ac:chgData name="Filippo Acconcia" userId="844af49c-a8a0-47ac-a7dd-14a44b60cd18" providerId="ADAL" clId="{4E01D738-D0C1-4B9B-B836-CF053EEC4C53}" dt="2022-03-16T08:26:20.489" v="606" actId="164"/>
          <ac:grpSpMkLst>
            <pc:docMk/>
            <pc:sldMk cId="2323114696" sldId="300"/>
            <ac:grpSpMk id="456" creationId="{D773E3BA-AAAC-49BF-9688-8726E987A516}"/>
          </ac:grpSpMkLst>
        </pc:grpChg>
        <pc:grpChg chg="add del mod">
          <ac:chgData name="Filippo Acconcia" userId="844af49c-a8a0-47ac-a7dd-14a44b60cd18" providerId="ADAL" clId="{4E01D738-D0C1-4B9B-B836-CF053EEC4C53}" dt="2022-03-16T08:26:49.873" v="631" actId="165"/>
          <ac:grpSpMkLst>
            <pc:docMk/>
            <pc:sldMk cId="2323114696" sldId="300"/>
            <ac:grpSpMk id="491" creationId="{DC1C7BB7-2DDD-4883-8B58-5EB78CD9D8CB}"/>
          </ac:grpSpMkLst>
        </pc:grpChg>
        <pc:grpChg chg="mod topLvl">
          <ac:chgData name="Filippo Acconcia" userId="844af49c-a8a0-47ac-a7dd-14a44b60cd18" providerId="ADAL" clId="{4E01D738-D0C1-4B9B-B836-CF053EEC4C53}" dt="2022-03-16T08:28:26.776" v="656" actId="164"/>
          <ac:grpSpMkLst>
            <pc:docMk/>
            <pc:sldMk cId="2323114696" sldId="300"/>
            <ac:grpSpMk id="498" creationId="{9924296E-293E-43B9-8AB8-1B629E170C9F}"/>
          </ac:grpSpMkLst>
        </pc:grpChg>
        <pc:grpChg chg="mod topLvl">
          <ac:chgData name="Filippo Acconcia" userId="844af49c-a8a0-47ac-a7dd-14a44b60cd18" providerId="ADAL" clId="{4E01D738-D0C1-4B9B-B836-CF053EEC4C53}" dt="2022-03-16T08:28:26.776" v="656" actId="164"/>
          <ac:grpSpMkLst>
            <pc:docMk/>
            <pc:sldMk cId="2323114696" sldId="300"/>
            <ac:grpSpMk id="500" creationId="{F803A680-EFF6-4053-80DF-3BC0934F87A7}"/>
          </ac:grpSpMkLst>
        </pc:grpChg>
        <pc:grpChg chg="mod topLvl">
          <ac:chgData name="Filippo Acconcia" userId="844af49c-a8a0-47ac-a7dd-14a44b60cd18" providerId="ADAL" clId="{4E01D738-D0C1-4B9B-B836-CF053EEC4C53}" dt="2022-03-16T08:28:26.776" v="656" actId="164"/>
          <ac:grpSpMkLst>
            <pc:docMk/>
            <pc:sldMk cId="2323114696" sldId="300"/>
            <ac:grpSpMk id="502" creationId="{5B83387E-8483-49AE-BCC0-6D7B6FE9EAF6}"/>
          </ac:grpSpMkLst>
        </pc:grpChg>
        <pc:grpChg chg="mod topLvl">
          <ac:chgData name="Filippo Acconcia" userId="844af49c-a8a0-47ac-a7dd-14a44b60cd18" providerId="ADAL" clId="{4E01D738-D0C1-4B9B-B836-CF053EEC4C53}" dt="2022-03-16T08:28:26.776" v="656" actId="164"/>
          <ac:grpSpMkLst>
            <pc:docMk/>
            <pc:sldMk cId="2323114696" sldId="300"/>
            <ac:grpSpMk id="504" creationId="{FCD7A0B3-AA41-4DB3-B321-11BB27E3232C}"/>
          </ac:grpSpMkLst>
        </pc:grpChg>
        <pc:grpChg chg="add del mod">
          <ac:chgData name="Filippo Acconcia" userId="844af49c-a8a0-47ac-a7dd-14a44b60cd18" providerId="ADAL" clId="{4E01D738-D0C1-4B9B-B836-CF053EEC4C53}" dt="2022-03-16T08:28:37.154" v="657" actId="165"/>
          <ac:grpSpMkLst>
            <pc:docMk/>
            <pc:sldMk cId="2323114696" sldId="300"/>
            <ac:grpSpMk id="539" creationId="{776242F6-6690-4A52-AD8F-CF880BD22758}"/>
          </ac:grpSpMkLst>
        </pc:grpChg>
        <pc:grpChg chg="add del mod topLvl">
          <ac:chgData name="Filippo Acconcia" userId="844af49c-a8a0-47ac-a7dd-14a44b60cd18" providerId="ADAL" clId="{4E01D738-D0C1-4B9B-B836-CF053EEC4C53}" dt="2022-03-16T08:30:53.140" v="686" actId="478"/>
          <ac:grpSpMkLst>
            <pc:docMk/>
            <pc:sldMk cId="2323114696" sldId="300"/>
            <ac:grpSpMk id="546" creationId="{7B94A938-F64A-4A24-96AF-3B78FA36DA70}"/>
          </ac:grpSpMkLst>
        </pc:grpChg>
        <pc:grpChg chg="add del mod topLvl">
          <ac:chgData name="Filippo Acconcia" userId="844af49c-a8a0-47ac-a7dd-14a44b60cd18" providerId="ADAL" clId="{4E01D738-D0C1-4B9B-B836-CF053EEC4C53}" dt="2022-03-16T08:30:53.140" v="686" actId="478"/>
          <ac:grpSpMkLst>
            <pc:docMk/>
            <pc:sldMk cId="2323114696" sldId="300"/>
            <ac:grpSpMk id="548" creationId="{BF38961D-6A00-4390-A1FB-F81FBA55458E}"/>
          </ac:grpSpMkLst>
        </pc:grpChg>
        <pc:grpChg chg="add del mod topLvl">
          <ac:chgData name="Filippo Acconcia" userId="844af49c-a8a0-47ac-a7dd-14a44b60cd18" providerId="ADAL" clId="{4E01D738-D0C1-4B9B-B836-CF053EEC4C53}" dt="2022-03-16T08:30:53.140" v="686" actId="478"/>
          <ac:grpSpMkLst>
            <pc:docMk/>
            <pc:sldMk cId="2323114696" sldId="300"/>
            <ac:grpSpMk id="550" creationId="{1D339DB0-B987-494D-A459-375CB7244AC5}"/>
          </ac:grpSpMkLst>
        </pc:grpChg>
        <pc:grpChg chg="add del mod topLvl">
          <ac:chgData name="Filippo Acconcia" userId="844af49c-a8a0-47ac-a7dd-14a44b60cd18" providerId="ADAL" clId="{4E01D738-D0C1-4B9B-B836-CF053EEC4C53}" dt="2022-03-16T08:30:53.140" v="686" actId="478"/>
          <ac:grpSpMkLst>
            <pc:docMk/>
            <pc:sldMk cId="2323114696" sldId="300"/>
            <ac:grpSpMk id="552" creationId="{DCAF8D7E-A696-4151-92A4-55ADB0A20410}"/>
          </ac:grpSpMkLst>
        </pc:grpChg>
        <pc:grpChg chg="add del mod">
          <ac:chgData name="Filippo Acconcia" userId="844af49c-a8a0-47ac-a7dd-14a44b60cd18" providerId="ADAL" clId="{4E01D738-D0C1-4B9B-B836-CF053EEC4C53}" dt="2022-03-16T08:28:37.154" v="657" actId="165"/>
          <ac:grpSpMkLst>
            <pc:docMk/>
            <pc:sldMk cId="2323114696" sldId="300"/>
            <ac:grpSpMk id="587" creationId="{350C5C04-D723-4C78-B67B-8B8451125211}"/>
          </ac:grpSpMkLst>
        </pc:grpChg>
        <pc:grpChg chg="add del mod topLvl">
          <ac:chgData name="Filippo Acconcia" userId="844af49c-a8a0-47ac-a7dd-14a44b60cd18" providerId="ADAL" clId="{4E01D738-D0C1-4B9B-B836-CF053EEC4C53}" dt="2022-03-16T08:33:21.811" v="730" actId="164"/>
          <ac:grpSpMkLst>
            <pc:docMk/>
            <pc:sldMk cId="2323114696" sldId="300"/>
            <ac:grpSpMk id="594" creationId="{61BEA5F9-F8CC-45E0-B4D1-AAFCCE37BE3E}"/>
          </ac:grpSpMkLst>
        </pc:grpChg>
        <pc:grpChg chg="add del mod topLvl">
          <ac:chgData name="Filippo Acconcia" userId="844af49c-a8a0-47ac-a7dd-14a44b60cd18" providerId="ADAL" clId="{4E01D738-D0C1-4B9B-B836-CF053EEC4C53}" dt="2022-03-16T08:33:21.811" v="730" actId="164"/>
          <ac:grpSpMkLst>
            <pc:docMk/>
            <pc:sldMk cId="2323114696" sldId="300"/>
            <ac:grpSpMk id="596" creationId="{BD443815-970A-49F3-93F6-57A08B231337}"/>
          </ac:grpSpMkLst>
        </pc:grpChg>
        <pc:grpChg chg="add del mod topLvl">
          <ac:chgData name="Filippo Acconcia" userId="844af49c-a8a0-47ac-a7dd-14a44b60cd18" providerId="ADAL" clId="{4E01D738-D0C1-4B9B-B836-CF053EEC4C53}" dt="2022-03-16T08:33:21.811" v="730" actId="164"/>
          <ac:grpSpMkLst>
            <pc:docMk/>
            <pc:sldMk cId="2323114696" sldId="300"/>
            <ac:grpSpMk id="598" creationId="{B7AC5287-1246-4BD1-8293-3C8C6A33F841}"/>
          </ac:grpSpMkLst>
        </pc:grpChg>
        <pc:grpChg chg="add del mod topLvl">
          <ac:chgData name="Filippo Acconcia" userId="844af49c-a8a0-47ac-a7dd-14a44b60cd18" providerId="ADAL" clId="{4E01D738-D0C1-4B9B-B836-CF053EEC4C53}" dt="2022-03-16T08:33:21.811" v="730" actId="164"/>
          <ac:grpSpMkLst>
            <pc:docMk/>
            <pc:sldMk cId="2323114696" sldId="300"/>
            <ac:grpSpMk id="600" creationId="{584ED147-ADF2-495D-8665-E1C68F67C041}"/>
          </ac:grpSpMkLst>
        </pc:grpChg>
        <pc:grpChg chg="add mod">
          <ac:chgData name="Filippo Acconcia" userId="844af49c-a8a0-47ac-a7dd-14a44b60cd18" providerId="ADAL" clId="{4E01D738-D0C1-4B9B-B836-CF053EEC4C53}" dt="2022-03-16T08:22:19.256" v="504" actId="164"/>
          <ac:grpSpMkLst>
            <pc:docMk/>
            <pc:sldMk cId="2323114696" sldId="300"/>
            <ac:grpSpMk id="643" creationId="{577AE676-C9F6-4523-AF10-F056AD35324F}"/>
          </ac:grpSpMkLst>
        </pc:grpChg>
        <pc:grpChg chg="add mod">
          <ac:chgData name="Filippo Acconcia" userId="844af49c-a8a0-47ac-a7dd-14a44b60cd18" providerId="ADAL" clId="{4E01D738-D0C1-4B9B-B836-CF053EEC4C53}" dt="2022-03-16T08:30:59.761" v="689" actId="552"/>
          <ac:grpSpMkLst>
            <pc:docMk/>
            <pc:sldMk cId="2323114696" sldId="300"/>
            <ac:grpSpMk id="645" creationId="{612AF593-28AA-4846-9B1A-FF80E8AF4289}"/>
          </ac:grpSpMkLst>
        </pc:grpChg>
        <pc:grpChg chg="add mod">
          <ac:chgData name="Filippo Acconcia" userId="844af49c-a8a0-47ac-a7dd-14a44b60cd18" providerId="ADAL" clId="{4E01D738-D0C1-4B9B-B836-CF053EEC4C53}" dt="2022-03-16T08:28:26.776" v="656" actId="164"/>
          <ac:grpSpMkLst>
            <pc:docMk/>
            <pc:sldMk cId="2323114696" sldId="300"/>
            <ac:grpSpMk id="647" creationId="{FCDCDFDE-9988-4D6D-A70B-EB7615DBADE9}"/>
          </ac:grpSpMkLst>
        </pc:grpChg>
        <pc:grpChg chg="add del mod">
          <ac:chgData name="Filippo Acconcia" userId="844af49c-a8a0-47ac-a7dd-14a44b60cd18" providerId="ADAL" clId="{4E01D738-D0C1-4B9B-B836-CF053EEC4C53}" dt="2022-03-16T08:31:22.484" v="693" actId="165"/>
          <ac:grpSpMkLst>
            <pc:docMk/>
            <pc:sldMk cId="2323114696" sldId="300"/>
            <ac:grpSpMk id="649" creationId="{4F2136F0-6D06-4F64-AD07-B36E9CD2401D}"/>
          </ac:grpSpMkLst>
        </pc:grpChg>
        <pc:grpChg chg="mod topLvl">
          <ac:chgData name="Filippo Acconcia" userId="844af49c-a8a0-47ac-a7dd-14a44b60cd18" providerId="ADAL" clId="{4E01D738-D0C1-4B9B-B836-CF053EEC4C53}" dt="2022-03-16T08:31:52.134" v="710" actId="164"/>
          <ac:grpSpMkLst>
            <pc:docMk/>
            <pc:sldMk cId="2323114696" sldId="300"/>
            <ac:grpSpMk id="656" creationId="{2B242927-F3C4-4BB5-9EBE-E2C7FF3CB00F}"/>
          </ac:grpSpMkLst>
        </pc:grpChg>
        <pc:grpChg chg="mod topLvl">
          <ac:chgData name="Filippo Acconcia" userId="844af49c-a8a0-47ac-a7dd-14a44b60cd18" providerId="ADAL" clId="{4E01D738-D0C1-4B9B-B836-CF053EEC4C53}" dt="2022-03-16T08:31:52.134" v="710" actId="164"/>
          <ac:grpSpMkLst>
            <pc:docMk/>
            <pc:sldMk cId="2323114696" sldId="300"/>
            <ac:grpSpMk id="658" creationId="{C4F0FD67-3E64-43D7-9DA4-753D056DAB45}"/>
          </ac:grpSpMkLst>
        </pc:grpChg>
        <pc:grpChg chg="mod topLvl">
          <ac:chgData name="Filippo Acconcia" userId="844af49c-a8a0-47ac-a7dd-14a44b60cd18" providerId="ADAL" clId="{4E01D738-D0C1-4B9B-B836-CF053EEC4C53}" dt="2022-03-16T08:31:52.134" v="710" actId="164"/>
          <ac:grpSpMkLst>
            <pc:docMk/>
            <pc:sldMk cId="2323114696" sldId="300"/>
            <ac:grpSpMk id="660" creationId="{9CD500B6-4F83-41F0-8DD3-22D1008864E3}"/>
          </ac:grpSpMkLst>
        </pc:grpChg>
        <pc:grpChg chg="mod topLvl">
          <ac:chgData name="Filippo Acconcia" userId="844af49c-a8a0-47ac-a7dd-14a44b60cd18" providerId="ADAL" clId="{4E01D738-D0C1-4B9B-B836-CF053EEC4C53}" dt="2022-03-16T08:31:52.134" v="710" actId="164"/>
          <ac:grpSpMkLst>
            <pc:docMk/>
            <pc:sldMk cId="2323114696" sldId="300"/>
            <ac:grpSpMk id="662" creationId="{CBF9B478-9BA6-4277-8F1C-D9744BBB33A3}"/>
          </ac:grpSpMkLst>
        </pc:grpChg>
        <pc:grpChg chg="add del mod">
          <ac:chgData name="Filippo Acconcia" userId="844af49c-a8a0-47ac-a7dd-14a44b60cd18" providerId="ADAL" clId="{4E01D738-D0C1-4B9B-B836-CF053EEC4C53}" dt="2022-03-16T08:32:27.014" v="723" actId="165"/>
          <ac:grpSpMkLst>
            <pc:docMk/>
            <pc:sldMk cId="2323114696" sldId="300"/>
            <ac:grpSpMk id="697" creationId="{ED0ADAFA-A042-4A45-BEBB-6C7A3B889172}"/>
          </ac:grpSpMkLst>
        </pc:grpChg>
        <pc:grpChg chg="add mod">
          <ac:chgData name="Filippo Acconcia" userId="844af49c-a8a0-47ac-a7dd-14a44b60cd18" providerId="ADAL" clId="{4E01D738-D0C1-4B9B-B836-CF053EEC4C53}" dt="2022-03-16T08:31:52.134" v="710" actId="164"/>
          <ac:grpSpMkLst>
            <pc:docMk/>
            <pc:sldMk cId="2323114696" sldId="300"/>
            <ac:grpSpMk id="698" creationId="{7D28CDCB-6F49-4A1B-8D8C-95AEAE83E860}"/>
          </ac:grpSpMkLst>
        </pc:grpChg>
        <pc:grpChg chg="add mod">
          <ac:chgData name="Filippo Acconcia" userId="844af49c-a8a0-47ac-a7dd-14a44b60cd18" providerId="ADAL" clId="{4E01D738-D0C1-4B9B-B836-CF053EEC4C53}" dt="2022-03-16T08:33:21.811" v="730" actId="164"/>
          <ac:grpSpMkLst>
            <pc:docMk/>
            <pc:sldMk cId="2323114696" sldId="300"/>
            <ac:grpSpMk id="700" creationId="{18473F21-C422-40C6-8B4B-06579E10DC59}"/>
          </ac:grpSpMkLst>
        </pc:grpChg>
        <pc:picChg chg="mod">
          <ac:chgData name="Filippo Acconcia" userId="844af49c-a8a0-47ac-a7dd-14a44b60cd18" providerId="ADAL" clId="{4E01D738-D0C1-4B9B-B836-CF053EEC4C53}" dt="2022-03-16T08:04:13.210" v="11" actId="1035"/>
          <ac:picMkLst>
            <pc:docMk/>
            <pc:sldMk cId="2323114696" sldId="300"/>
            <ac:picMk id="3" creationId="{CA1A5C8D-C184-42C9-B057-41BC9F75F5FF}"/>
          </ac:picMkLst>
        </pc:picChg>
        <pc:picChg chg="mod">
          <ac:chgData name="Filippo Acconcia" userId="844af49c-a8a0-47ac-a7dd-14a44b60cd18" providerId="ADAL" clId="{4E01D738-D0C1-4B9B-B836-CF053EEC4C53}" dt="2022-03-16T08:14:45.564" v="394" actId="164"/>
          <ac:picMkLst>
            <pc:docMk/>
            <pc:sldMk cId="2323114696" sldId="300"/>
            <ac:picMk id="4" creationId="{03D40985-2F86-4D00-B934-6B6618979088}"/>
          </ac:picMkLst>
        </pc:picChg>
        <pc:picChg chg="del mod topLvl">
          <ac:chgData name="Filippo Acconcia" userId="844af49c-a8a0-47ac-a7dd-14a44b60cd18" providerId="ADAL" clId="{4E01D738-D0C1-4B9B-B836-CF053EEC4C53}" dt="2022-03-16T08:04:40.328" v="21" actId="478"/>
          <ac:picMkLst>
            <pc:docMk/>
            <pc:sldMk cId="2323114696" sldId="300"/>
            <ac:picMk id="31" creationId="{3EC56B70-0860-4CC5-BFD4-3B0929D10886}"/>
          </ac:picMkLst>
        </pc:picChg>
        <pc:picChg chg="mod">
          <ac:chgData name="Filippo Acconcia" userId="844af49c-a8a0-47ac-a7dd-14a44b60cd18" providerId="ADAL" clId="{4E01D738-D0C1-4B9B-B836-CF053EEC4C53}" dt="2022-03-16T08:14:56.443" v="398"/>
          <ac:picMkLst>
            <pc:docMk/>
            <pc:sldMk cId="2323114696" sldId="300"/>
            <ac:picMk id="108" creationId="{97373378-D3C8-4A95-B64D-9629F9CC1637}"/>
          </ac:picMkLst>
        </pc:picChg>
        <pc:picChg chg="mod">
          <ac:chgData name="Filippo Acconcia" userId="844af49c-a8a0-47ac-a7dd-14a44b60cd18" providerId="ADAL" clId="{4E01D738-D0C1-4B9B-B836-CF053EEC4C53}" dt="2022-03-16T08:15:04.085" v="402"/>
          <ac:picMkLst>
            <pc:docMk/>
            <pc:sldMk cId="2323114696" sldId="300"/>
            <ac:picMk id="156" creationId="{3AA7DC5B-5D56-4B10-96EA-2F9422CDB600}"/>
          </ac:picMkLst>
        </pc:picChg>
        <pc:picChg chg="mod">
          <ac:chgData name="Filippo Acconcia" userId="844af49c-a8a0-47ac-a7dd-14a44b60cd18" providerId="ADAL" clId="{4E01D738-D0C1-4B9B-B836-CF053EEC4C53}" dt="2022-03-16T08:15:04.085" v="402"/>
          <ac:picMkLst>
            <pc:docMk/>
            <pc:sldMk cId="2323114696" sldId="300"/>
            <ac:picMk id="204" creationId="{B6D125D6-17BB-4C13-B07F-2CCEF6EF4CD9}"/>
          </ac:picMkLst>
        </pc:picChg>
        <pc:picChg chg="mod">
          <ac:chgData name="Filippo Acconcia" userId="844af49c-a8a0-47ac-a7dd-14a44b60cd18" providerId="ADAL" clId="{4E01D738-D0C1-4B9B-B836-CF053EEC4C53}" dt="2022-03-16T08:15:07.319" v="404"/>
          <ac:picMkLst>
            <pc:docMk/>
            <pc:sldMk cId="2323114696" sldId="300"/>
            <ac:picMk id="252" creationId="{0F39CC6A-1043-4519-9511-988255BC9933}"/>
          </ac:picMkLst>
        </pc:picChg>
        <pc:picChg chg="mod">
          <ac:chgData name="Filippo Acconcia" userId="844af49c-a8a0-47ac-a7dd-14a44b60cd18" providerId="ADAL" clId="{4E01D738-D0C1-4B9B-B836-CF053EEC4C53}" dt="2022-03-16T08:15:07.319" v="404"/>
          <ac:picMkLst>
            <pc:docMk/>
            <pc:sldMk cId="2323114696" sldId="300"/>
            <ac:picMk id="300" creationId="{ECDCB2EC-F6F8-4E67-9F33-6801A96D3401}"/>
          </ac:picMkLst>
        </pc:picChg>
        <pc:picChg chg="mod">
          <ac:chgData name="Filippo Acconcia" userId="844af49c-a8a0-47ac-a7dd-14a44b60cd18" providerId="ADAL" clId="{4E01D738-D0C1-4B9B-B836-CF053EEC4C53}" dt="2022-03-16T08:16:05.880" v="415"/>
          <ac:picMkLst>
            <pc:docMk/>
            <pc:sldMk cId="2323114696" sldId="300"/>
            <ac:picMk id="348" creationId="{C980596B-8395-40A4-87AE-4408AED42C80}"/>
          </ac:picMkLst>
        </pc:picChg>
        <pc:picChg chg="del mod topLvl">
          <ac:chgData name="Filippo Acconcia" userId="844af49c-a8a0-47ac-a7dd-14a44b60cd18" providerId="ADAL" clId="{4E01D738-D0C1-4B9B-B836-CF053EEC4C53}" dt="2022-03-16T08:21:21.461" v="497" actId="478"/>
          <ac:picMkLst>
            <pc:docMk/>
            <pc:sldMk cId="2323114696" sldId="300"/>
            <ac:picMk id="396" creationId="{EB83C22B-F272-4427-A534-155EAD35E2EF}"/>
          </ac:picMkLst>
        </pc:picChg>
        <pc:picChg chg="del mod topLvl">
          <ac:chgData name="Filippo Acconcia" userId="844af49c-a8a0-47ac-a7dd-14a44b60cd18" providerId="ADAL" clId="{4E01D738-D0C1-4B9B-B836-CF053EEC4C53}" dt="2022-03-16T08:23:17.782" v="511" actId="478"/>
          <ac:picMkLst>
            <pc:docMk/>
            <pc:sldMk cId="2323114696" sldId="300"/>
            <ac:picMk id="444" creationId="{47F90BD5-2C95-43E6-A714-C811A869298D}"/>
          </ac:picMkLst>
        </pc:picChg>
        <pc:picChg chg="del mod topLvl">
          <ac:chgData name="Filippo Acconcia" userId="844af49c-a8a0-47ac-a7dd-14a44b60cd18" providerId="ADAL" clId="{4E01D738-D0C1-4B9B-B836-CF053EEC4C53}" dt="2022-03-16T08:27:40.399" v="644" actId="478"/>
          <ac:picMkLst>
            <pc:docMk/>
            <pc:sldMk cId="2323114696" sldId="300"/>
            <ac:picMk id="492" creationId="{FE81B849-FD8C-446A-AF63-B1457BDC3151}"/>
          </ac:picMkLst>
        </pc:picChg>
        <pc:picChg chg="add del mod topLvl">
          <ac:chgData name="Filippo Acconcia" userId="844af49c-a8a0-47ac-a7dd-14a44b60cd18" providerId="ADAL" clId="{4E01D738-D0C1-4B9B-B836-CF053EEC4C53}" dt="2022-03-16T08:30:53.140" v="686" actId="478"/>
          <ac:picMkLst>
            <pc:docMk/>
            <pc:sldMk cId="2323114696" sldId="300"/>
            <ac:picMk id="540" creationId="{0995948F-EECC-4687-87E4-941D09092AAD}"/>
          </ac:picMkLst>
        </pc:picChg>
        <pc:picChg chg="add del mod topLvl">
          <ac:chgData name="Filippo Acconcia" userId="844af49c-a8a0-47ac-a7dd-14a44b60cd18" providerId="ADAL" clId="{4E01D738-D0C1-4B9B-B836-CF053EEC4C53}" dt="2022-03-16T08:33:16.748" v="729" actId="478"/>
          <ac:picMkLst>
            <pc:docMk/>
            <pc:sldMk cId="2323114696" sldId="300"/>
            <ac:picMk id="588" creationId="{B8CBE3AD-C58C-44D6-9717-5B292D4E8774}"/>
          </ac:picMkLst>
        </pc:picChg>
        <pc:picChg chg="mod ord">
          <ac:chgData name="Filippo Acconcia" userId="844af49c-a8a0-47ac-a7dd-14a44b60cd18" providerId="ADAL" clId="{4E01D738-D0C1-4B9B-B836-CF053EEC4C53}" dt="2022-03-16T08:22:19.256" v="504" actId="164"/>
          <ac:picMkLst>
            <pc:docMk/>
            <pc:sldMk cId="2323114696" sldId="300"/>
            <ac:picMk id="642" creationId="{18E420A0-498C-46A8-8C78-97AA3EE1DF5F}"/>
          </ac:picMkLst>
        </pc:picChg>
        <pc:picChg chg="mod ord">
          <ac:chgData name="Filippo Acconcia" userId="844af49c-a8a0-47ac-a7dd-14a44b60cd18" providerId="ADAL" clId="{4E01D738-D0C1-4B9B-B836-CF053EEC4C53}" dt="2022-03-16T08:26:20.489" v="606" actId="164"/>
          <ac:picMkLst>
            <pc:docMk/>
            <pc:sldMk cId="2323114696" sldId="300"/>
            <ac:picMk id="644" creationId="{BDBC5ECA-37F6-4C56-A990-9ADE528033B3}"/>
          </ac:picMkLst>
        </pc:picChg>
        <pc:picChg chg="mod ord">
          <ac:chgData name="Filippo Acconcia" userId="844af49c-a8a0-47ac-a7dd-14a44b60cd18" providerId="ADAL" clId="{4E01D738-D0C1-4B9B-B836-CF053EEC4C53}" dt="2022-03-16T08:28:26.776" v="656" actId="164"/>
          <ac:picMkLst>
            <pc:docMk/>
            <pc:sldMk cId="2323114696" sldId="300"/>
            <ac:picMk id="646" creationId="{C2EEB9F1-78E6-456A-8DA3-99D3C2C7163A}"/>
          </ac:picMkLst>
        </pc:picChg>
        <pc:picChg chg="mod">
          <ac:chgData name="Filippo Acconcia" userId="844af49c-a8a0-47ac-a7dd-14a44b60cd18" providerId="ADAL" clId="{4E01D738-D0C1-4B9B-B836-CF053EEC4C53}" dt="2022-03-16T08:31:52.134" v="710" actId="164"/>
          <ac:picMkLst>
            <pc:docMk/>
            <pc:sldMk cId="2323114696" sldId="300"/>
            <ac:picMk id="648" creationId="{877CCD5D-2865-4767-9BB1-BE76FF2B3311}"/>
          </ac:picMkLst>
        </pc:picChg>
        <pc:picChg chg="del mod topLvl">
          <ac:chgData name="Filippo Acconcia" userId="844af49c-a8a0-47ac-a7dd-14a44b60cd18" providerId="ADAL" clId="{4E01D738-D0C1-4B9B-B836-CF053EEC4C53}" dt="2022-03-16T08:31:38.192" v="697" actId="478"/>
          <ac:picMkLst>
            <pc:docMk/>
            <pc:sldMk cId="2323114696" sldId="300"/>
            <ac:picMk id="650" creationId="{84C88BB3-16ED-4D26-8ED7-2F29A377D6CD}"/>
          </ac:picMkLst>
        </pc:picChg>
        <pc:picChg chg="mod ord">
          <ac:chgData name="Filippo Acconcia" userId="844af49c-a8a0-47ac-a7dd-14a44b60cd18" providerId="ADAL" clId="{4E01D738-D0C1-4B9B-B836-CF053EEC4C53}" dt="2022-03-16T08:33:21.811" v="730" actId="164"/>
          <ac:picMkLst>
            <pc:docMk/>
            <pc:sldMk cId="2323114696" sldId="300"/>
            <ac:picMk id="699" creationId="{4F7021EE-0FA7-47C8-9F38-60C8B83560EC}"/>
          </ac:picMkLst>
        </pc:picChg>
        <pc:cxnChg chg="add del mod">
          <ac:chgData name="Filippo Acconcia" userId="844af49c-a8a0-47ac-a7dd-14a44b60cd18" providerId="ADAL" clId="{4E01D738-D0C1-4B9B-B836-CF053EEC4C53}" dt="2022-03-16T08:09:38.550" v="188" actId="478"/>
          <ac:cxnSpMkLst>
            <pc:docMk/>
            <pc:sldMk cId="2323114696" sldId="300"/>
            <ac:cxnSpMk id="23" creationId="{2903D7FE-1DFB-4B8F-88EE-795B2C593C66}"/>
          </ac:cxnSpMkLst>
        </pc:cxnChg>
        <pc:cxnChg chg="add mod">
          <ac:chgData name="Filippo Acconcia" userId="844af49c-a8a0-47ac-a7dd-14a44b60cd18" providerId="ADAL" clId="{4E01D738-D0C1-4B9B-B836-CF053EEC4C53}" dt="2022-03-16T08:14:45.564" v="394" actId="164"/>
          <ac:cxnSpMkLst>
            <pc:docMk/>
            <pc:sldMk cId="2323114696" sldId="300"/>
            <ac:cxnSpMk id="25" creationId="{0A9D2CF8-5757-4677-BB58-006470BDA3C9}"/>
          </ac:cxnSpMkLst>
        </pc:cxnChg>
        <pc:cxnChg chg="add mod">
          <ac:chgData name="Filippo Acconcia" userId="844af49c-a8a0-47ac-a7dd-14a44b60cd18" providerId="ADAL" clId="{4E01D738-D0C1-4B9B-B836-CF053EEC4C53}" dt="2022-03-16T08:14:45.564" v="394" actId="164"/>
          <ac:cxnSpMkLst>
            <pc:docMk/>
            <pc:sldMk cId="2323114696" sldId="300"/>
            <ac:cxnSpMk id="27" creationId="{D0F67AB2-CF0C-4D9A-AFC1-B5E365BB1F30}"/>
          </ac:cxnSpMkLst>
        </pc:cxnChg>
        <pc:cxnChg chg="del mod topLvl">
          <ac:chgData name="Filippo Acconcia" userId="844af49c-a8a0-47ac-a7dd-14a44b60cd18" providerId="ADAL" clId="{4E01D738-D0C1-4B9B-B836-CF053EEC4C53}" dt="2022-03-16T08:13:46.966" v="365" actId="478"/>
          <ac:cxnSpMkLst>
            <pc:docMk/>
            <pc:sldMk cId="2323114696" sldId="300"/>
            <ac:cxnSpMk id="52" creationId="{45D60ED1-2EE4-44AA-A811-10404756FE54}"/>
          </ac:cxnSpMkLst>
        </pc:cxnChg>
        <pc:cxnChg chg="add mod">
          <ac:chgData name="Filippo Acconcia" userId="844af49c-a8a0-47ac-a7dd-14a44b60cd18" providerId="ADAL" clId="{4E01D738-D0C1-4B9B-B836-CF053EEC4C53}" dt="2022-03-16T08:14:45.564" v="394" actId="164"/>
          <ac:cxnSpMkLst>
            <pc:docMk/>
            <pc:sldMk cId="2323114696" sldId="300"/>
            <ac:cxnSpMk id="95" creationId="{8273905F-C002-4976-96A0-FDAD2B38417F}"/>
          </ac:cxnSpMkLst>
        </pc:cxnChg>
        <pc:cxnChg chg="add mod">
          <ac:chgData name="Filippo Acconcia" userId="844af49c-a8a0-47ac-a7dd-14a44b60cd18" providerId="ADAL" clId="{4E01D738-D0C1-4B9B-B836-CF053EEC4C53}" dt="2022-03-16T08:14:45.564" v="394" actId="164"/>
          <ac:cxnSpMkLst>
            <pc:docMk/>
            <pc:sldMk cId="2323114696" sldId="300"/>
            <ac:cxnSpMk id="96" creationId="{8AB07B2E-05E4-4BC2-859B-03A7B1688959}"/>
          </ac:cxnSpMkLst>
        </pc:cxnChg>
        <pc:cxnChg chg="add mod">
          <ac:chgData name="Filippo Acconcia" userId="844af49c-a8a0-47ac-a7dd-14a44b60cd18" providerId="ADAL" clId="{4E01D738-D0C1-4B9B-B836-CF053EEC4C53}" dt="2022-03-16T08:14:45.564" v="394" actId="164"/>
          <ac:cxnSpMkLst>
            <pc:docMk/>
            <pc:sldMk cId="2323114696" sldId="300"/>
            <ac:cxnSpMk id="97" creationId="{9CAAAF50-0DE1-4F06-B855-2290229C06F3}"/>
          </ac:cxnSpMkLst>
        </pc:cxnChg>
        <pc:cxnChg chg="add mod">
          <ac:chgData name="Filippo Acconcia" userId="844af49c-a8a0-47ac-a7dd-14a44b60cd18" providerId="ADAL" clId="{4E01D738-D0C1-4B9B-B836-CF053EEC4C53}" dt="2022-03-16T08:14:45.564" v="394" actId="164"/>
          <ac:cxnSpMkLst>
            <pc:docMk/>
            <pc:sldMk cId="2323114696" sldId="300"/>
            <ac:cxnSpMk id="103" creationId="{CF5B7A8D-0087-44F7-8A2D-ED45DE1A9E13}"/>
          </ac:cxnSpMkLst>
        </pc:cxnChg>
        <pc:cxnChg chg="mod">
          <ac:chgData name="Filippo Acconcia" userId="844af49c-a8a0-47ac-a7dd-14a44b60cd18" providerId="ADAL" clId="{4E01D738-D0C1-4B9B-B836-CF053EEC4C53}" dt="2022-03-16T08:14:56.443" v="398"/>
          <ac:cxnSpMkLst>
            <pc:docMk/>
            <pc:sldMk cId="2323114696" sldId="300"/>
            <ac:cxnSpMk id="127" creationId="{929DDBC8-522D-4FF9-A9C1-6E0CC384D17E}"/>
          </ac:cxnSpMkLst>
        </pc:cxnChg>
        <pc:cxnChg chg="mod">
          <ac:chgData name="Filippo Acconcia" userId="844af49c-a8a0-47ac-a7dd-14a44b60cd18" providerId="ADAL" clId="{4E01D738-D0C1-4B9B-B836-CF053EEC4C53}" dt="2022-03-16T08:14:56.443" v="398"/>
          <ac:cxnSpMkLst>
            <pc:docMk/>
            <pc:sldMk cId="2323114696" sldId="300"/>
            <ac:cxnSpMk id="128" creationId="{114CA831-2EE6-4BEB-A79A-81A745E0D761}"/>
          </ac:cxnSpMkLst>
        </pc:cxnChg>
        <pc:cxnChg chg="mod">
          <ac:chgData name="Filippo Acconcia" userId="844af49c-a8a0-47ac-a7dd-14a44b60cd18" providerId="ADAL" clId="{4E01D738-D0C1-4B9B-B836-CF053EEC4C53}" dt="2022-03-16T08:14:56.443" v="398"/>
          <ac:cxnSpMkLst>
            <pc:docMk/>
            <pc:sldMk cId="2323114696" sldId="300"/>
            <ac:cxnSpMk id="129" creationId="{AA3C5FE8-8FBD-4997-B68E-4143C4A1CDEA}"/>
          </ac:cxnSpMkLst>
        </pc:cxnChg>
        <pc:cxnChg chg="mod">
          <ac:chgData name="Filippo Acconcia" userId="844af49c-a8a0-47ac-a7dd-14a44b60cd18" providerId="ADAL" clId="{4E01D738-D0C1-4B9B-B836-CF053EEC4C53}" dt="2022-03-16T08:14:56.443" v="398"/>
          <ac:cxnSpMkLst>
            <pc:docMk/>
            <pc:sldMk cId="2323114696" sldId="300"/>
            <ac:cxnSpMk id="130" creationId="{3F9A4C9B-CD11-4DB5-843A-7612DF409D3C}"/>
          </ac:cxnSpMkLst>
        </pc:cxnChg>
        <pc:cxnChg chg="mod">
          <ac:chgData name="Filippo Acconcia" userId="844af49c-a8a0-47ac-a7dd-14a44b60cd18" providerId="ADAL" clId="{4E01D738-D0C1-4B9B-B836-CF053EEC4C53}" dt="2022-03-16T08:14:56.443" v="398"/>
          <ac:cxnSpMkLst>
            <pc:docMk/>
            <pc:sldMk cId="2323114696" sldId="300"/>
            <ac:cxnSpMk id="131" creationId="{B537E857-31AD-479D-AEB0-A3E919C9C2EE}"/>
          </ac:cxnSpMkLst>
        </pc:cxnChg>
        <pc:cxnChg chg="mod">
          <ac:chgData name="Filippo Acconcia" userId="844af49c-a8a0-47ac-a7dd-14a44b60cd18" providerId="ADAL" clId="{4E01D738-D0C1-4B9B-B836-CF053EEC4C53}" dt="2022-03-16T08:14:56.443" v="398"/>
          <ac:cxnSpMkLst>
            <pc:docMk/>
            <pc:sldMk cId="2323114696" sldId="300"/>
            <ac:cxnSpMk id="136" creationId="{DF54F322-0482-42C6-84CE-32D6282F1A3B}"/>
          </ac:cxnSpMkLst>
        </pc:cxnChg>
        <pc:cxnChg chg="mod">
          <ac:chgData name="Filippo Acconcia" userId="844af49c-a8a0-47ac-a7dd-14a44b60cd18" providerId="ADAL" clId="{4E01D738-D0C1-4B9B-B836-CF053EEC4C53}" dt="2022-03-16T08:15:04.085" v="402"/>
          <ac:cxnSpMkLst>
            <pc:docMk/>
            <pc:sldMk cId="2323114696" sldId="300"/>
            <ac:cxnSpMk id="175" creationId="{1E08DCE6-8C79-42BF-B630-9E2548100918}"/>
          </ac:cxnSpMkLst>
        </pc:cxnChg>
        <pc:cxnChg chg="mod">
          <ac:chgData name="Filippo Acconcia" userId="844af49c-a8a0-47ac-a7dd-14a44b60cd18" providerId="ADAL" clId="{4E01D738-D0C1-4B9B-B836-CF053EEC4C53}" dt="2022-03-16T08:15:04.085" v="402"/>
          <ac:cxnSpMkLst>
            <pc:docMk/>
            <pc:sldMk cId="2323114696" sldId="300"/>
            <ac:cxnSpMk id="176" creationId="{9AD7D610-AED2-4387-AB83-448BA9782F81}"/>
          </ac:cxnSpMkLst>
        </pc:cxnChg>
        <pc:cxnChg chg="mod">
          <ac:chgData name="Filippo Acconcia" userId="844af49c-a8a0-47ac-a7dd-14a44b60cd18" providerId="ADAL" clId="{4E01D738-D0C1-4B9B-B836-CF053EEC4C53}" dt="2022-03-16T08:15:04.085" v="402"/>
          <ac:cxnSpMkLst>
            <pc:docMk/>
            <pc:sldMk cId="2323114696" sldId="300"/>
            <ac:cxnSpMk id="177" creationId="{65192005-9121-46A5-9D58-BFB1DE0EDD58}"/>
          </ac:cxnSpMkLst>
        </pc:cxnChg>
        <pc:cxnChg chg="mod">
          <ac:chgData name="Filippo Acconcia" userId="844af49c-a8a0-47ac-a7dd-14a44b60cd18" providerId="ADAL" clId="{4E01D738-D0C1-4B9B-B836-CF053EEC4C53}" dt="2022-03-16T08:15:04.085" v="402"/>
          <ac:cxnSpMkLst>
            <pc:docMk/>
            <pc:sldMk cId="2323114696" sldId="300"/>
            <ac:cxnSpMk id="178" creationId="{027C245E-EEBC-4706-AC97-D9976597432B}"/>
          </ac:cxnSpMkLst>
        </pc:cxnChg>
        <pc:cxnChg chg="mod">
          <ac:chgData name="Filippo Acconcia" userId="844af49c-a8a0-47ac-a7dd-14a44b60cd18" providerId="ADAL" clId="{4E01D738-D0C1-4B9B-B836-CF053EEC4C53}" dt="2022-03-16T08:15:04.085" v="402"/>
          <ac:cxnSpMkLst>
            <pc:docMk/>
            <pc:sldMk cId="2323114696" sldId="300"/>
            <ac:cxnSpMk id="179" creationId="{54200050-6FF1-4711-B9E0-6E5988081BC2}"/>
          </ac:cxnSpMkLst>
        </pc:cxnChg>
        <pc:cxnChg chg="mod">
          <ac:chgData name="Filippo Acconcia" userId="844af49c-a8a0-47ac-a7dd-14a44b60cd18" providerId="ADAL" clId="{4E01D738-D0C1-4B9B-B836-CF053EEC4C53}" dt="2022-03-16T08:15:04.085" v="402"/>
          <ac:cxnSpMkLst>
            <pc:docMk/>
            <pc:sldMk cId="2323114696" sldId="300"/>
            <ac:cxnSpMk id="184" creationId="{8193D5F5-D91B-4627-8916-2C4FD475E1FF}"/>
          </ac:cxnSpMkLst>
        </pc:cxnChg>
        <pc:cxnChg chg="mod">
          <ac:chgData name="Filippo Acconcia" userId="844af49c-a8a0-47ac-a7dd-14a44b60cd18" providerId="ADAL" clId="{4E01D738-D0C1-4B9B-B836-CF053EEC4C53}" dt="2022-03-16T08:15:04.085" v="402"/>
          <ac:cxnSpMkLst>
            <pc:docMk/>
            <pc:sldMk cId="2323114696" sldId="300"/>
            <ac:cxnSpMk id="223" creationId="{578E12A2-A99B-4F67-B127-D55E9F593016}"/>
          </ac:cxnSpMkLst>
        </pc:cxnChg>
        <pc:cxnChg chg="mod">
          <ac:chgData name="Filippo Acconcia" userId="844af49c-a8a0-47ac-a7dd-14a44b60cd18" providerId="ADAL" clId="{4E01D738-D0C1-4B9B-B836-CF053EEC4C53}" dt="2022-03-16T08:15:04.085" v="402"/>
          <ac:cxnSpMkLst>
            <pc:docMk/>
            <pc:sldMk cId="2323114696" sldId="300"/>
            <ac:cxnSpMk id="224" creationId="{3D26BEA6-D685-4949-8FB9-EC621349DF71}"/>
          </ac:cxnSpMkLst>
        </pc:cxnChg>
        <pc:cxnChg chg="mod">
          <ac:chgData name="Filippo Acconcia" userId="844af49c-a8a0-47ac-a7dd-14a44b60cd18" providerId="ADAL" clId="{4E01D738-D0C1-4B9B-B836-CF053EEC4C53}" dt="2022-03-16T08:15:04.085" v="402"/>
          <ac:cxnSpMkLst>
            <pc:docMk/>
            <pc:sldMk cId="2323114696" sldId="300"/>
            <ac:cxnSpMk id="225" creationId="{AD4AE68B-2A6F-4032-8E52-72E435A4D80F}"/>
          </ac:cxnSpMkLst>
        </pc:cxnChg>
        <pc:cxnChg chg="mod">
          <ac:chgData name="Filippo Acconcia" userId="844af49c-a8a0-47ac-a7dd-14a44b60cd18" providerId="ADAL" clId="{4E01D738-D0C1-4B9B-B836-CF053EEC4C53}" dt="2022-03-16T08:15:04.085" v="402"/>
          <ac:cxnSpMkLst>
            <pc:docMk/>
            <pc:sldMk cId="2323114696" sldId="300"/>
            <ac:cxnSpMk id="226" creationId="{EF494CB6-8D10-4305-9E31-5C84101B6175}"/>
          </ac:cxnSpMkLst>
        </pc:cxnChg>
        <pc:cxnChg chg="mod">
          <ac:chgData name="Filippo Acconcia" userId="844af49c-a8a0-47ac-a7dd-14a44b60cd18" providerId="ADAL" clId="{4E01D738-D0C1-4B9B-B836-CF053EEC4C53}" dt="2022-03-16T08:15:04.085" v="402"/>
          <ac:cxnSpMkLst>
            <pc:docMk/>
            <pc:sldMk cId="2323114696" sldId="300"/>
            <ac:cxnSpMk id="227" creationId="{AF57F20A-BDAC-4CE0-BAF3-8A11D4C5C927}"/>
          </ac:cxnSpMkLst>
        </pc:cxnChg>
        <pc:cxnChg chg="mod">
          <ac:chgData name="Filippo Acconcia" userId="844af49c-a8a0-47ac-a7dd-14a44b60cd18" providerId="ADAL" clId="{4E01D738-D0C1-4B9B-B836-CF053EEC4C53}" dt="2022-03-16T08:15:04.085" v="402"/>
          <ac:cxnSpMkLst>
            <pc:docMk/>
            <pc:sldMk cId="2323114696" sldId="300"/>
            <ac:cxnSpMk id="232" creationId="{92105AB4-8945-444A-971F-FF55685E9C6D}"/>
          </ac:cxnSpMkLst>
        </pc:cxnChg>
        <pc:cxnChg chg="mod">
          <ac:chgData name="Filippo Acconcia" userId="844af49c-a8a0-47ac-a7dd-14a44b60cd18" providerId="ADAL" clId="{4E01D738-D0C1-4B9B-B836-CF053EEC4C53}" dt="2022-03-16T08:15:07.319" v="404"/>
          <ac:cxnSpMkLst>
            <pc:docMk/>
            <pc:sldMk cId="2323114696" sldId="300"/>
            <ac:cxnSpMk id="271" creationId="{018834FD-0F81-485B-99FB-EF85B72597DA}"/>
          </ac:cxnSpMkLst>
        </pc:cxnChg>
        <pc:cxnChg chg="mod">
          <ac:chgData name="Filippo Acconcia" userId="844af49c-a8a0-47ac-a7dd-14a44b60cd18" providerId="ADAL" clId="{4E01D738-D0C1-4B9B-B836-CF053EEC4C53}" dt="2022-03-16T08:15:07.319" v="404"/>
          <ac:cxnSpMkLst>
            <pc:docMk/>
            <pc:sldMk cId="2323114696" sldId="300"/>
            <ac:cxnSpMk id="272" creationId="{02153D82-08C1-4A20-869F-49CB284E8738}"/>
          </ac:cxnSpMkLst>
        </pc:cxnChg>
        <pc:cxnChg chg="mod">
          <ac:chgData name="Filippo Acconcia" userId="844af49c-a8a0-47ac-a7dd-14a44b60cd18" providerId="ADAL" clId="{4E01D738-D0C1-4B9B-B836-CF053EEC4C53}" dt="2022-03-16T08:15:07.319" v="404"/>
          <ac:cxnSpMkLst>
            <pc:docMk/>
            <pc:sldMk cId="2323114696" sldId="300"/>
            <ac:cxnSpMk id="273" creationId="{12ECFE26-9154-4973-9829-2472F4677AF4}"/>
          </ac:cxnSpMkLst>
        </pc:cxnChg>
        <pc:cxnChg chg="mod">
          <ac:chgData name="Filippo Acconcia" userId="844af49c-a8a0-47ac-a7dd-14a44b60cd18" providerId="ADAL" clId="{4E01D738-D0C1-4B9B-B836-CF053EEC4C53}" dt="2022-03-16T08:15:07.319" v="404"/>
          <ac:cxnSpMkLst>
            <pc:docMk/>
            <pc:sldMk cId="2323114696" sldId="300"/>
            <ac:cxnSpMk id="274" creationId="{465AB0C7-285E-403A-A0DE-774B2546DC0E}"/>
          </ac:cxnSpMkLst>
        </pc:cxnChg>
        <pc:cxnChg chg="mod">
          <ac:chgData name="Filippo Acconcia" userId="844af49c-a8a0-47ac-a7dd-14a44b60cd18" providerId="ADAL" clId="{4E01D738-D0C1-4B9B-B836-CF053EEC4C53}" dt="2022-03-16T08:15:07.319" v="404"/>
          <ac:cxnSpMkLst>
            <pc:docMk/>
            <pc:sldMk cId="2323114696" sldId="300"/>
            <ac:cxnSpMk id="275" creationId="{919A6240-63E8-4ADA-987B-F93EC59C6CCC}"/>
          </ac:cxnSpMkLst>
        </pc:cxnChg>
        <pc:cxnChg chg="mod">
          <ac:chgData name="Filippo Acconcia" userId="844af49c-a8a0-47ac-a7dd-14a44b60cd18" providerId="ADAL" clId="{4E01D738-D0C1-4B9B-B836-CF053EEC4C53}" dt="2022-03-16T08:15:07.319" v="404"/>
          <ac:cxnSpMkLst>
            <pc:docMk/>
            <pc:sldMk cId="2323114696" sldId="300"/>
            <ac:cxnSpMk id="280" creationId="{3DAAFCDB-FB5B-4DC4-8DB4-F37945BBD63D}"/>
          </ac:cxnSpMkLst>
        </pc:cxnChg>
        <pc:cxnChg chg="mod">
          <ac:chgData name="Filippo Acconcia" userId="844af49c-a8a0-47ac-a7dd-14a44b60cd18" providerId="ADAL" clId="{4E01D738-D0C1-4B9B-B836-CF053EEC4C53}" dt="2022-03-16T08:15:07.319" v="404"/>
          <ac:cxnSpMkLst>
            <pc:docMk/>
            <pc:sldMk cId="2323114696" sldId="300"/>
            <ac:cxnSpMk id="319" creationId="{35EB913F-DF16-4F1C-AA19-E03A44D0BF70}"/>
          </ac:cxnSpMkLst>
        </pc:cxnChg>
        <pc:cxnChg chg="mod">
          <ac:chgData name="Filippo Acconcia" userId="844af49c-a8a0-47ac-a7dd-14a44b60cd18" providerId="ADAL" clId="{4E01D738-D0C1-4B9B-B836-CF053EEC4C53}" dt="2022-03-16T08:15:07.319" v="404"/>
          <ac:cxnSpMkLst>
            <pc:docMk/>
            <pc:sldMk cId="2323114696" sldId="300"/>
            <ac:cxnSpMk id="320" creationId="{3F34950A-256D-4094-974C-EFEECD55D870}"/>
          </ac:cxnSpMkLst>
        </pc:cxnChg>
        <pc:cxnChg chg="mod">
          <ac:chgData name="Filippo Acconcia" userId="844af49c-a8a0-47ac-a7dd-14a44b60cd18" providerId="ADAL" clId="{4E01D738-D0C1-4B9B-B836-CF053EEC4C53}" dt="2022-03-16T08:15:07.319" v="404"/>
          <ac:cxnSpMkLst>
            <pc:docMk/>
            <pc:sldMk cId="2323114696" sldId="300"/>
            <ac:cxnSpMk id="321" creationId="{25A5973B-3119-45D0-9FAF-152E1D90E968}"/>
          </ac:cxnSpMkLst>
        </pc:cxnChg>
        <pc:cxnChg chg="mod">
          <ac:chgData name="Filippo Acconcia" userId="844af49c-a8a0-47ac-a7dd-14a44b60cd18" providerId="ADAL" clId="{4E01D738-D0C1-4B9B-B836-CF053EEC4C53}" dt="2022-03-16T08:15:07.319" v="404"/>
          <ac:cxnSpMkLst>
            <pc:docMk/>
            <pc:sldMk cId="2323114696" sldId="300"/>
            <ac:cxnSpMk id="322" creationId="{682C5986-6BC1-4870-BFE5-CE72536FF796}"/>
          </ac:cxnSpMkLst>
        </pc:cxnChg>
        <pc:cxnChg chg="mod">
          <ac:chgData name="Filippo Acconcia" userId="844af49c-a8a0-47ac-a7dd-14a44b60cd18" providerId="ADAL" clId="{4E01D738-D0C1-4B9B-B836-CF053EEC4C53}" dt="2022-03-16T08:15:07.319" v="404"/>
          <ac:cxnSpMkLst>
            <pc:docMk/>
            <pc:sldMk cId="2323114696" sldId="300"/>
            <ac:cxnSpMk id="323" creationId="{5F430A47-0112-42A8-B1F3-1C756F1BDC4F}"/>
          </ac:cxnSpMkLst>
        </pc:cxnChg>
        <pc:cxnChg chg="mod">
          <ac:chgData name="Filippo Acconcia" userId="844af49c-a8a0-47ac-a7dd-14a44b60cd18" providerId="ADAL" clId="{4E01D738-D0C1-4B9B-B836-CF053EEC4C53}" dt="2022-03-16T08:15:07.319" v="404"/>
          <ac:cxnSpMkLst>
            <pc:docMk/>
            <pc:sldMk cId="2323114696" sldId="300"/>
            <ac:cxnSpMk id="328" creationId="{A21BEE4C-933F-4570-93A2-6DEF61CA3C4B}"/>
          </ac:cxnSpMkLst>
        </pc:cxnChg>
        <pc:cxnChg chg="mod">
          <ac:chgData name="Filippo Acconcia" userId="844af49c-a8a0-47ac-a7dd-14a44b60cd18" providerId="ADAL" clId="{4E01D738-D0C1-4B9B-B836-CF053EEC4C53}" dt="2022-03-16T08:16:05.880" v="415"/>
          <ac:cxnSpMkLst>
            <pc:docMk/>
            <pc:sldMk cId="2323114696" sldId="300"/>
            <ac:cxnSpMk id="367" creationId="{A3D4E4BA-C029-4B80-9209-410AA5FEF6A2}"/>
          </ac:cxnSpMkLst>
        </pc:cxnChg>
        <pc:cxnChg chg="mod">
          <ac:chgData name="Filippo Acconcia" userId="844af49c-a8a0-47ac-a7dd-14a44b60cd18" providerId="ADAL" clId="{4E01D738-D0C1-4B9B-B836-CF053EEC4C53}" dt="2022-03-16T08:16:05.880" v="415"/>
          <ac:cxnSpMkLst>
            <pc:docMk/>
            <pc:sldMk cId="2323114696" sldId="300"/>
            <ac:cxnSpMk id="368" creationId="{D8667110-6B9F-42D4-A837-B7ECC5C03BF4}"/>
          </ac:cxnSpMkLst>
        </pc:cxnChg>
        <pc:cxnChg chg="mod">
          <ac:chgData name="Filippo Acconcia" userId="844af49c-a8a0-47ac-a7dd-14a44b60cd18" providerId="ADAL" clId="{4E01D738-D0C1-4B9B-B836-CF053EEC4C53}" dt="2022-03-16T08:16:05.880" v="415"/>
          <ac:cxnSpMkLst>
            <pc:docMk/>
            <pc:sldMk cId="2323114696" sldId="300"/>
            <ac:cxnSpMk id="369" creationId="{33B461B4-81B1-4383-8964-5FBD586CD9A4}"/>
          </ac:cxnSpMkLst>
        </pc:cxnChg>
        <pc:cxnChg chg="mod">
          <ac:chgData name="Filippo Acconcia" userId="844af49c-a8a0-47ac-a7dd-14a44b60cd18" providerId="ADAL" clId="{4E01D738-D0C1-4B9B-B836-CF053EEC4C53}" dt="2022-03-16T08:16:05.880" v="415"/>
          <ac:cxnSpMkLst>
            <pc:docMk/>
            <pc:sldMk cId="2323114696" sldId="300"/>
            <ac:cxnSpMk id="370" creationId="{51F64FD9-B534-4CEF-9782-CEE781AA92B5}"/>
          </ac:cxnSpMkLst>
        </pc:cxnChg>
        <pc:cxnChg chg="mod">
          <ac:chgData name="Filippo Acconcia" userId="844af49c-a8a0-47ac-a7dd-14a44b60cd18" providerId="ADAL" clId="{4E01D738-D0C1-4B9B-B836-CF053EEC4C53}" dt="2022-03-16T08:16:05.880" v="415"/>
          <ac:cxnSpMkLst>
            <pc:docMk/>
            <pc:sldMk cId="2323114696" sldId="300"/>
            <ac:cxnSpMk id="371" creationId="{96D09F37-E805-4B1D-9223-3B1EF23CCE2C}"/>
          </ac:cxnSpMkLst>
        </pc:cxnChg>
        <pc:cxnChg chg="mod">
          <ac:chgData name="Filippo Acconcia" userId="844af49c-a8a0-47ac-a7dd-14a44b60cd18" providerId="ADAL" clId="{4E01D738-D0C1-4B9B-B836-CF053EEC4C53}" dt="2022-03-16T08:16:05.880" v="415"/>
          <ac:cxnSpMkLst>
            <pc:docMk/>
            <pc:sldMk cId="2323114696" sldId="300"/>
            <ac:cxnSpMk id="376" creationId="{27260A3C-2D65-4A7F-8CA1-93B777791039}"/>
          </ac:cxnSpMkLst>
        </pc:cxnChg>
        <pc:cxnChg chg="mod topLvl">
          <ac:chgData name="Filippo Acconcia" userId="844af49c-a8a0-47ac-a7dd-14a44b60cd18" providerId="ADAL" clId="{4E01D738-D0C1-4B9B-B836-CF053EEC4C53}" dt="2022-03-16T08:22:19.256" v="504" actId="164"/>
          <ac:cxnSpMkLst>
            <pc:docMk/>
            <pc:sldMk cId="2323114696" sldId="300"/>
            <ac:cxnSpMk id="415" creationId="{51643AA1-F1D3-4C0D-97F5-60FB8E334FAD}"/>
          </ac:cxnSpMkLst>
        </pc:cxnChg>
        <pc:cxnChg chg="mod topLvl">
          <ac:chgData name="Filippo Acconcia" userId="844af49c-a8a0-47ac-a7dd-14a44b60cd18" providerId="ADAL" clId="{4E01D738-D0C1-4B9B-B836-CF053EEC4C53}" dt="2022-03-16T08:22:19.256" v="504" actId="164"/>
          <ac:cxnSpMkLst>
            <pc:docMk/>
            <pc:sldMk cId="2323114696" sldId="300"/>
            <ac:cxnSpMk id="416" creationId="{06EA5968-7AD4-48FD-9DE3-3D01D15B785B}"/>
          </ac:cxnSpMkLst>
        </pc:cxnChg>
        <pc:cxnChg chg="mod topLvl">
          <ac:chgData name="Filippo Acconcia" userId="844af49c-a8a0-47ac-a7dd-14a44b60cd18" providerId="ADAL" clId="{4E01D738-D0C1-4B9B-B836-CF053EEC4C53}" dt="2022-03-16T08:22:19.256" v="504" actId="164"/>
          <ac:cxnSpMkLst>
            <pc:docMk/>
            <pc:sldMk cId="2323114696" sldId="300"/>
            <ac:cxnSpMk id="417" creationId="{08F50063-E44A-4EE0-BE6D-5CBF39033C80}"/>
          </ac:cxnSpMkLst>
        </pc:cxnChg>
        <pc:cxnChg chg="mod topLvl">
          <ac:chgData name="Filippo Acconcia" userId="844af49c-a8a0-47ac-a7dd-14a44b60cd18" providerId="ADAL" clId="{4E01D738-D0C1-4B9B-B836-CF053EEC4C53}" dt="2022-03-16T08:22:19.256" v="504" actId="164"/>
          <ac:cxnSpMkLst>
            <pc:docMk/>
            <pc:sldMk cId="2323114696" sldId="300"/>
            <ac:cxnSpMk id="418" creationId="{AD644D38-893E-49BD-8FC0-59B4A85C184B}"/>
          </ac:cxnSpMkLst>
        </pc:cxnChg>
        <pc:cxnChg chg="mod topLvl">
          <ac:chgData name="Filippo Acconcia" userId="844af49c-a8a0-47ac-a7dd-14a44b60cd18" providerId="ADAL" clId="{4E01D738-D0C1-4B9B-B836-CF053EEC4C53}" dt="2022-03-16T08:22:19.256" v="504" actId="164"/>
          <ac:cxnSpMkLst>
            <pc:docMk/>
            <pc:sldMk cId="2323114696" sldId="300"/>
            <ac:cxnSpMk id="419" creationId="{4E7F61D2-4DF7-4DDB-BC15-C71C248B28C0}"/>
          </ac:cxnSpMkLst>
        </pc:cxnChg>
        <pc:cxnChg chg="mod topLvl">
          <ac:chgData name="Filippo Acconcia" userId="844af49c-a8a0-47ac-a7dd-14a44b60cd18" providerId="ADAL" clId="{4E01D738-D0C1-4B9B-B836-CF053EEC4C53}" dt="2022-03-16T08:22:19.256" v="504" actId="164"/>
          <ac:cxnSpMkLst>
            <pc:docMk/>
            <pc:sldMk cId="2323114696" sldId="300"/>
            <ac:cxnSpMk id="424" creationId="{BF89F917-31A5-4E85-AACB-800C781B8869}"/>
          </ac:cxnSpMkLst>
        </pc:cxnChg>
        <pc:cxnChg chg="mod topLvl">
          <ac:chgData name="Filippo Acconcia" userId="844af49c-a8a0-47ac-a7dd-14a44b60cd18" providerId="ADAL" clId="{4E01D738-D0C1-4B9B-B836-CF053EEC4C53}" dt="2022-03-16T08:26:20.489" v="606" actId="164"/>
          <ac:cxnSpMkLst>
            <pc:docMk/>
            <pc:sldMk cId="2323114696" sldId="300"/>
            <ac:cxnSpMk id="463" creationId="{E21672B7-C4EA-4633-95B0-4978220DA534}"/>
          </ac:cxnSpMkLst>
        </pc:cxnChg>
        <pc:cxnChg chg="mod topLvl">
          <ac:chgData name="Filippo Acconcia" userId="844af49c-a8a0-47ac-a7dd-14a44b60cd18" providerId="ADAL" clId="{4E01D738-D0C1-4B9B-B836-CF053EEC4C53}" dt="2022-03-16T08:26:20.489" v="606" actId="164"/>
          <ac:cxnSpMkLst>
            <pc:docMk/>
            <pc:sldMk cId="2323114696" sldId="300"/>
            <ac:cxnSpMk id="464" creationId="{0FD4ECAA-B422-432A-B511-89C7AAE2DE31}"/>
          </ac:cxnSpMkLst>
        </pc:cxnChg>
        <pc:cxnChg chg="mod topLvl">
          <ac:chgData name="Filippo Acconcia" userId="844af49c-a8a0-47ac-a7dd-14a44b60cd18" providerId="ADAL" clId="{4E01D738-D0C1-4B9B-B836-CF053EEC4C53}" dt="2022-03-16T08:26:20.489" v="606" actId="164"/>
          <ac:cxnSpMkLst>
            <pc:docMk/>
            <pc:sldMk cId="2323114696" sldId="300"/>
            <ac:cxnSpMk id="465" creationId="{068A4C13-7B5E-4D18-B6CE-8CBF57B1A6FE}"/>
          </ac:cxnSpMkLst>
        </pc:cxnChg>
        <pc:cxnChg chg="mod topLvl">
          <ac:chgData name="Filippo Acconcia" userId="844af49c-a8a0-47ac-a7dd-14a44b60cd18" providerId="ADAL" clId="{4E01D738-D0C1-4B9B-B836-CF053EEC4C53}" dt="2022-03-16T08:26:20.489" v="606" actId="164"/>
          <ac:cxnSpMkLst>
            <pc:docMk/>
            <pc:sldMk cId="2323114696" sldId="300"/>
            <ac:cxnSpMk id="466" creationId="{4A551048-81F4-4565-8E01-4F2226C40007}"/>
          </ac:cxnSpMkLst>
        </pc:cxnChg>
        <pc:cxnChg chg="mod topLvl">
          <ac:chgData name="Filippo Acconcia" userId="844af49c-a8a0-47ac-a7dd-14a44b60cd18" providerId="ADAL" clId="{4E01D738-D0C1-4B9B-B836-CF053EEC4C53}" dt="2022-03-16T08:26:20.489" v="606" actId="164"/>
          <ac:cxnSpMkLst>
            <pc:docMk/>
            <pc:sldMk cId="2323114696" sldId="300"/>
            <ac:cxnSpMk id="467" creationId="{3B506123-5E01-43A8-914F-10F4F0CF1B39}"/>
          </ac:cxnSpMkLst>
        </pc:cxnChg>
        <pc:cxnChg chg="mod topLvl">
          <ac:chgData name="Filippo Acconcia" userId="844af49c-a8a0-47ac-a7dd-14a44b60cd18" providerId="ADAL" clId="{4E01D738-D0C1-4B9B-B836-CF053EEC4C53}" dt="2022-03-16T08:26:20.489" v="606" actId="164"/>
          <ac:cxnSpMkLst>
            <pc:docMk/>
            <pc:sldMk cId="2323114696" sldId="300"/>
            <ac:cxnSpMk id="472" creationId="{0D0A9239-5DFD-48AF-9AE4-7285CB9C0AC0}"/>
          </ac:cxnSpMkLst>
        </pc:cxnChg>
        <pc:cxnChg chg="mod topLvl">
          <ac:chgData name="Filippo Acconcia" userId="844af49c-a8a0-47ac-a7dd-14a44b60cd18" providerId="ADAL" clId="{4E01D738-D0C1-4B9B-B836-CF053EEC4C53}" dt="2022-03-16T08:28:26.776" v="656" actId="164"/>
          <ac:cxnSpMkLst>
            <pc:docMk/>
            <pc:sldMk cId="2323114696" sldId="300"/>
            <ac:cxnSpMk id="511" creationId="{28985A15-5A7B-429D-A8F3-E5355A40F787}"/>
          </ac:cxnSpMkLst>
        </pc:cxnChg>
        <pc:cxnChg chg="mod topLvl">
          <ac:chgData name="Filippo Acconcia" userId="844af49c-a8a0-47ac-a7dd-14a44b60cd18" providerId="ADAL" clId="{4E01D738-D0C1-4B9B-B836-CF053EEC4C53}" dt="2022-03-16T08:28:26.776" v="656" actId="164"/>
          <ac:cxnSpMkLst>
            <pc:docMk/>
            <pc:sldMk cId="2323114696" sldId="300"/>
            <ac:cxnSpMk id="512" creationId="{ACCBEF80-7992-4B64-B54C-E4D30A8F2296}"/>
          </ac:cxnSpMkLst>
        </pc:cxnChg>
        <pc:cxnChg chg="mod topLvl">
          <ac:chgData name="Filippo Acconcia" userId="844af49c-a8a0-47ac-a7dd-14a44b60cd18" providerId="ADAL" clId="{4E01D738-D0C1-4B9B-B836-CF053EEC4C53}" dt="2022-03-16T08:28:26.776" v="656" actId="164"/>
          <ac:cxnSpMkLst>
            <pc:docMk/>
            <pc:sldMk cId="2323114696" sldId="300"/>
            <ac:cxnSpMk id="513" creationId="{2BF5D0D2-52B9-4F80-A895-4D6892D8E6D9}"/>
          </ac:cxnSpMkLst>
        </pc:cxnChg>
        <pc:cxnChg chg="mod topLvl">
          <ac:chgData name="Filippo Acconcia" userId="844af49c-a8a0-47ac-a7dd-14a44b60cd18" providerId="ADAL" clId="{4E01D738-D0C1-4B9B-B836-CF053EEC4C53}" dt="2022-03-16T08:28:26.776" v="656" actId="164"/>
          <ac:cxnSpMkLst>
            <pc:docMk/>
            <pc:sldMk cId="2323114696" sldId="300"/>
            <ac:cxnSpMk id="514" creationId="{1CC1669D-226F-4999-9F21-F13BB3CC1729}"/>
          </ac:cxnSpMkLst>
        </pc:cxnChg>
        <pc:cxnChg chg="mod topLvl">
          <ac:chgData name="Filippo Acconcia" userId="844af49c-a8a0-47ac-a7dd-14a44b60cd18" providerId="ADAL" clId="{4E01D738-D0C1-4B9B-B836-CF053EEC4C53}" dt="2022-03-16T08:28:26.776" v="656" actId="164"/>
          <ac:cxnSpMkLst>
            <pc:docMk/>
            <pc:sldMk cId="2323114696" sldId="300"/>
            <ac:cxnSpMk id="515" creationId="{9695440E-48B3-4099-B5A6-45319191F190}"/>
          </ac:cxnSpMkLst>
        </pc:cxnChg>
        <pc:cxnChg chg="mod topLvl">
          <ac:chgData name="Filippo Acconcia" userId="844af49c-a8a0-47ac-a7dd-14a44b60cd18" providerId="ADAL" clId="{4E01D738-D0C1-4B9B-B836-CF053EEC4C53}" dt="2022-03-16T08:28:26.776" v="656" actId="164"/>
          <ac:cxnSpMkLst>
            <pc:docMk/>
            <pc:sldMk cId="2323114696" sldId="300"/>
            <ac:cxnSpMk id="520" creationId="{8A2895EA-3DF6-4FC9-BB2E-E4B30B765F8F}"/>
          </ac:cxnSpMkLst>
        </pc:cxnChg>
        <pc:cxnChg chg="add del mod topLvl">
          <ac:chgData name="Filippo Acconcia" userId="844af49c-a8a0-47ac-a7dd-14a44b60cd18" providerId="ADAL" clId="{4E01D738-D0C1-4B9B-B836-CF053EEC4C53}" dt="2022-03-16T08:30:53.140" v="686" actId="478"/>
          <ac:cxnSpMkLst>
            <pc:docMk/>
            <pc:sldMk cId="2323114696" sldId="300"/>
            <ac:cxnSpMk id="559" creationId="{FDE3F200-4B78-4D4F-9787-A2124FD0A299}"/>
          </ac:cxnSpMkLst>
        </pc:cxnChg>
        <pc:cxnChg chg="add del mod topLvl">
          <ac:chgData name="Filippo Acconcia" userId="844af49c-a8a0-47ac-a7dd-14a44b60cd18" providerId="ADAL" clId="{4E01D738-D0C1-4B9B-B836-CF053EEC4C53}" dt="2022-03-16T08:30:53.140" v="686" actId="478"/>
          <ac:cxnSpMkLst>
            <pc:docMk/>
            <pc:sldMk cId="2323114696" sldId="300"/>
            <ac:cxnSpMk id="560" creationId="{7B49C0FF-F53E-410B-A0C4-8B78FB5B3819}"/>
          </ac:cxnSpMkLst>
        </pc:cxnChg>
        <pc:cxnChg chg="add del mod topLvl">
          <ac:chgData name="Filippo Acconcia" userId="844af49c-a8a0-47ac-a7dd-14a44b60cd18" providerId="ADAL" clId="{4E01D738-D0C1-4B9B-B836-CF053EEC4C53}" dt="2022-03-16T08:30:53.140" v="686" actId="478"/>
          <ac:cxnSpMkLst>
            <pc:docMk/>
            <pc:sldMk cId="2323114696" sldId="300"/>
            <ac:cxnSpMk id="561" creationId="{064DDD04-1842-4B72-A2D6-011A6693BF1B}"/>
          </ac:cxnSpMkLst>
        </pc:cxnChg>
        <pc:cxnChg chg="add del mod topLvl">
          <ac:chgData name="Filippo Acconcia" userId="844af49c-a8a0-47ac-a7dd-14a44b60cd18" providerId="ADAL" clId="{4E01D738-D0C1-4B9B-B836-CF053EEC4C53}" dt="2022-03-16T08:30:53.140" v="686" actId="478"/>
          <ac:cxnSpMkLst>
            <pc:docMk/>
            <pc:sldMk cId="2323114696" sldId="300"/>
            <ac:cxnSpMk id="562" creationId="{67F4175A-597D-4B57-9BED-D9F70B399CE0}"/>
          </ac:cxnSpMkLst>
        </pc:cxnChg>
        <pc:cxnChg chg="add del mod topLvl">
          <ac:chgData name="Filippo Acconcia" userId="844af49c-a8a0-47ac-a7dd-14a44b60cd18" providerId="ADAL" clId="{4E01D738-D0C1-4B9B-B836-CF053EEC4C53}" dt="2022-03-16T08:30:53.140" v="686" actId="478"/>
          <ac:cxnSpMkLst>
            <pc:docMk/>
            <pc:sldMk cId="2323114696" sldId="300"/>
            <ac:cxnSpMk id="563" creationId="{34E5A170-1E25-45CB-BC8A-94CBC5E06978}"/>
          </ac:cxnSpMkLst>
        </pc:cxnChg>
        <pc:cxnChg chg="add del mod topLvl">
          <ac:chgData name="Filippo Acconcia" userId="844af49c-a8a0-47ac-a7dd-14a44b60cd18" providerId="ADAL" clId="{4E01D738-D0C1-4B9B-B836-CF053EEC4C53}" dt="2022-03-16T08:30:53.140" v="686" actId="478"/>
          <ac:cxnSpMkLst>
            <pc:docMk/>
            <pc:sldMk cId="2323114696" sldId="300"/>
            <ac:cxnSpMk id="568" creationId="{2727735E-DF79-4653-83BC-69B17DCAE33A}"/>
          </ac:cxnSpMkLst>
        </pc:cxnChg>
        <pc:cxnChg chg="add del mod topLvl">
          <ac:chgData name="Filippo Acconcia" userId="844af49c-a8a0-47ac-a7dd-14a44b60cd18" providerId="ADAL" clId="{4E01D738-D0C1-4B9B-B836-CF053EEC4C53}" dt="2022-03-16T08:33:21.811" v="730" actId="164"/>
          <ac:cxnSpMkLst>
            <pc:docMk/>
            <pc:sldMk cId="2323114696" sldId="300"/>
            <ac:cxnSpMk id="607" creationId="{C1B93300-BA25-4BCA-AB8E-446812609807}"/>
          </ac:cxnSpMkLst>
        </pc:cxnChg>
        <pc:cxnChg chg="add del mod topLvl">
          <ac:chgData name="Filippo Acconcia" userId="844af49c-a8a0-47ac-a7dd-14a44b60cd18" providerId="ADAL" clId="{4E01D738-D0C1-4B9B-B836-CF053EEC4C53}" dt="2022-03-16T08:33:21.811" v="730" actId="164"/>
          <ac:cxnSpMkLst>
            <pc:docMk/>
            <pc:sldMk cId="2323114696" sldId="300"/>
            <ac:cxnSpMk id="608" creationId="{7D801328-C6FB-462C-9B6E-B144CE3DB605}"/>
          </ac:cxnSpMkLst>
        </pc:cxnChg>
        <pc:cxnChg chg="add del mod topLvl">
          <ac:chgData name="Filippo Acconcia" userId="844af49c-a8a0-47ac-a7dd-14a44b60cd18" providerId="ADAL" clId="{4E01D738-D0C1-4B9B-B836-CF053EEC4C53}" dt="2022-03-16T08:33:21.811" v="730" actId="164"/>
          <ac:cxnSpMkLst>
            <pc:docMk/>
            <pc:sldMk cId="2323114696" sldId="300"/>
            <ac:cxnSpMk id="609" creationId="{FB8FD791-F69B-40EA-99BD-4BD84F15E368}"/>
          </ac:cxnSpMkLst>
        </pc:cxnChg>
        <pc:cxnChg chg="add del mod topLvl">
          <ac:chgData name="Filippo Acconcia" userId="844af49c-a8a0-47ac-a7dd-14a44b60cd18" providerId="ADAL" clId="{4E01D738-D0C1-4B9B-B836-CF053EEC4C53}" dt="2022-03-16T08:33:21.811" v="730" actId="164"/>
          <ac:cxnSpMkLst>
            <pc:docMk/>
            <pc:sldMk cId="2323114696" sldId="300"/>
            <ac:cxnSpMk id="610" creationId="{311F021D-38D8-4CD8-A03B-1B4704350332}"/>
          </ac:cxnSpMkLst>
        </pc:cxnChg>
        <pc:cxnChg chg="add del mod topLvl">
          <ac:chgData name="Filippo Acconcia" userId="844af49c-a8a0-47ac-a7dd-14a44b60cd18" providerId="ADAL" clId="{4E01D738-D0C1-4B9B-B836-CF053EEC4C53}" dt="2022-03-16T08:33:21.811" v="730" actId="164"/>
          <ac:cxnSpMkLst>
            <pc:docMk/>
            <pc:sldMk cId="2323114696" sldId="300"/>
            <ac:cxnSpMk id="611" creationId="{F6EA1893-5D35-4DE8-9410-DF51FCBD92B7}"/>
          </ac:cxnSpMkLst>
        </pc:cxnChg>
        <pc:cxnChg chg="add del mod topLvl">
          <ac:chgData name="Filippo Acconcia" userId="844af49c-a8a0-47ac-a7dd-14a44b60cd18" providerId="ADAL" clId="{4E01D738-D0C1-4B9B-B836-CF053EEC4C53}" dt="2022-03-16T08:33:21.811" v="730" actId="164"/>
          <ac:cxnSpMkLst>
            <pc:docMk/>
            <pc:sldMk cId="2323114696" sldId="300"/>
            <ac:cxnSpMk id="616" creationId="{C0EC531F-887D-47EB-B4FC-3A27DE3FEBF6}"/>
          </ac:cxnSpMkLst>
        </pc:cxnChg>
        <pc:cxnChg chg="mod topLvl">
          <ac:chgData name="Filippo Acconcia" userId="844af49c-a8a0-47ac-a7dd-14a44b60cd18" providerId="ADAL" clId="{4E01D738-D0C1-4B9B-B836-CF053EEC4C53}" dt="2022-03-16T08:31:52.134" v="710" actId="164"/>
          <ac:cxnSpMkLst>
            <pc:docMk/>
            <pc:sldMk cId="2323114696" sldId="300"/>
            <ac:cxnSpMk id="669" creationId="{910B2DF2-2F6C-4E3B-8401-450A027540F6}"/>
          </ac:cxnSpMkLst>
        </pc:cxnChg>
        <pc:cxnChg chg="mod topLvl">
          <ac:chgData name="Filippo Acconcia" userId="844af49c-a8a0-47ac-a7dd-14a44b60cd18" providerId="ADAL" clId="{4E01D738-D0C1-4B9B-B836-CF053EEC4C53}" dt="2022-03-16T08:31:52.134" v="710" actId="164"/>
          <ac:cxnSpMkLst>
            <pc:docMk/>
            <pc:sldMk cId="2323114696" sldId="300"/>
            <ac:cxnSpMk id="670" creationId="{D00E41E2-6E10-4390-A0AF-1C639CCAD89A}"/>
          </ac:cxnSpMkLst>
        </pc:cxnChg>
        <pc:cxnChg chg="mod topLvl">
          <ac:chgData name="Filippo Acconcia" userId="844af49c-a8a0-47ac-a7dd-14a44b60cd18" providerId="ADAL" clId="{4E01D738-D0C1-4B9B-B836-CF053EEC4C53}" dt="2022-03-16T08:31:52.134" v="710" actId="164"/>
          <ac:cxnSpMkLst>
            <pc:docMk/>
            <pc:sldMk cId="2323114696" sldId="300"/>
            <ac:cxnSpMk id="671" creationId="{B424E7AA-78C4-462C-BCD1-054C3EE14629}"/>
          </ac:cxnSpMkLst>
        </pc:cxnChg>
        <pc:cxnChg chg="mod topLvl">
          <ac:chgData name="Filippo Acconcia" userId="844af49c-a8a0-47ac-a7dd-14a44b60cd18" providerId="ADAL" clId="{4E01D738-D0C1-4B9B-B836-CF053EEC4C53}" dt="2022-03-16T08:31:52.134" v="710" actId="164"/>
          <ac:cxnSpMkLst>
            <pc:docMk/>
            <pc:sldMk cId="2323114696" sldId="300"/>
            <ac:cxnSpMk id="672" creationId="{A044A848-773E-40AC-B8A4-268957B5BC8F}"/>
          </ac:cxnSpMkLst>
        </pc:cxnChg>
        <pc:cxnChg chg="mod topLvl">
          <ac:chgData name="Filippo Acconcia" userId="844af49c-a8a0-47ac-a7dd-14a44b60cd18" providerId="ADAL" clId="{4E01D738-D0C1-4B9B-B836-CF053EEC4C53}" dt="2022-03-16T08:31:52.134" v="710" actId="164"/>
          <ac:cxnSpMkLst>
            <pc:docMk/>
            <pc:sldMk cId="2323114696" sldId="300"/>
            <ac:cxnSpMk id="673" creationId="{E15F4F53-4730-4E39-97E4-DB85771E5CE6}"/>
          </ac:cxnSpMkLst>
        </pc:cxnChg>
        <pc:cxnChg chg="mod topLvl">
          <ac:chgData name="Filippo Acconcia" userId="844af49c-a8a0-47ac-a7dd-14a44b60cd18" providerId="ADAL" clId="{4E01D738-D0C1-4B9B-B836-CF053EEC4C53}" dt="2022-03-16T08:31:52.134" v="710" actId="164"/>
          <ac:cxnSpMkLst>
            <pc:docMk/>
            <pc:sldMk cId="2323114696" sldId="300"/>
            <ac:cxnSpMk id="678" creationId="{D7A76228-28AB-4E7D-A0E0-2B26F685992B}"/>
          </ac:cxnSpMkLst>
        </pc:cxnChg>
      </pc:sldChg>
      <pc:sldChg chg="addSp delSp modSp mod">
        <pc:chgData name="Filippo Acconcia" userId="844af49c-a8a0-47ac-a7dd-14a44b60cd18" providerId="ADAL" clId="{4E01D738-D0C1-4B9B-B836-CF053EEC4C53}" dt="2022-03-16T14:09:03.033" v="1920" actId="553"/>
        <pc:sldMkLst>
          <pc:docMk/>
          <pc:sldMk cId="2898367101" sldId="301"/>
        </pc:sldMkLst>
        <pc:spChg chg="mod">
          <ac:chgData name="Filippo Acconcia" userId="844af49c-a8a0-47ac-a7dd-14a44b60cd18" providerId="ADAL" clId="{4E01D738-D0C1-4B9B-B836-CF053EEC4C53}" dt="2022-03-16T14:09:03.033" v="1920" actId="553"/>
          <ac:spMkLst>
            <pc:docMk/>
            <pc:sldMk cId="2898367101" sldId="301"/>
            <ac:spMk id="3" creationId="{C87E7A78-E592-4730-A163-FBD8EE08EC99}"/>
          </ac:spMkLst>
        </pc:spChg>
        <pc:spChg chg="mod">
          <ac:chgData name="Filippo Acconcia" userId="844af49c-a8a0-47ac-a7dd-14a44b60cd18" providerId="ADAL" clId="{4E01D738-D0C1-4B9B-B836-CF053EEC4C53}" dt="2022-03-16T14:08:58.038" v="1919" actId="553"/>
          <ac:spMkLst>
            <pc:docMk/>
            <pc:sldMk cId="2898367101" sldId="301"/>
            <ac:spMk id="4" creationId="{6B669F2F-B6BB-4C1B-B4E9-2D96049267C9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898367101" sldId="301"/>
            <ac:spMk id="7" creationId="{A6CFB1FB-CEA1-446F-8720-0ED65F5C01DB}"/>
          </ac:spMkLst>
        </pc:spChg>
        <pc:spChg chg="del mod topLvl">
          <ac:chgData name="Filippo Acconcia" userId="844af49c-a8a0-47ac-a7dd-14a44b60cd18" providerId="ADAL" clId="{4E01D738-D0C1-4B9B-B836-CF053EEC4C53}" dt="2022-03-16T14:02:49.827" v="1643" actId="478"/>
          <ac:spMkLst>
            <pc:docMk/>
            <pc:sldMk cId="2898367101" sldId="301"/>
            <ac:spMk id="55" creationId="{EB85DACC-FD70-4D42-BCC6-C0FCD5037913}"/>
          </ac:spMkLst>
        </pc:spChg>
        <pc:spChg chg="del mod topLvl">
          <ac:chgData name="Filippo Acconcia" userId="844af49c-a8a0-47ac-a7dd-14a44b60cd18" providerId="ADAL" clId="{4E01D738-D0C1-4B9B-B836-CF053EEC4C53}" dt="2022-03-16T14:02:49.827" v="1643" actId="478"/>
          <ac:spMkLst>
            <pc:docMk/>
            <pc:sldMk cId="2898367101" sldId="301"/>
            <ac:spMk id="56" creationId="{21B9B5ED-4C6C-4709-A2B1-0DC71866CF9E}"/>
          </ac:spMkLst>
        </pc:spChg>
        <pc:spChg chg="del mod topLvl">
          <ac:chgData name="Filippo Acconcia" userId="844af49c-a8a0-47ac-a7dd-14a44b60cd18" providerId="ADAL" clId="{4E01D738-D0C1-4B9B-B836-CF053EEC4C53}" dt="2022-03-16T14:02:49.827" v="1643" actId="478"/>
          <ac:spMkLst>
            <pc:docMk/>
            <pc:sldMk cId="2898367101" sldId="301"/>
            <ac:spMk id="57" creationId="{009C4CC1-C7AC-455F-8353-51387043AC57}"/>
          </ac:spMkLst>
        </pc:spChg>
        <pc:spChg chg="del mod topLvl">
          <ac:chgData name="Filippo Acconcia" userId="844af49c-a8a0-47ac-a7dd-14a44b60cd18" providerId="ADAL" clId="{4E01D738-D0C1-4B9B-B836-CF053EEC4C53}" dt="2022-03-16T14:02:48.131" v="1642" actId="478"/>
          <ac:spMkLst>
            <pc:docMk/>
            <pc:sldMk cId="2898367101" sldId="301"/>
            <ac:spMk id="58" creationId="{FD3ACF50-086B-4319-86D2-B74BF1282206}"/>
          </ac:spMkLst>
        </pc:spChg>
        <pc:spChg chg="mod topLvl">
          <ac:chgData name="Filippo Acconcia" userId="844af49c-a8a0-47ac-a7dd-14a44b60cd18" providerId="ADAL" clId="{4E01D738-D0C1-4B9B-B836-CF053EEC4C53}" dt="2022-03-16T14:08:23.757" v="1882" actId="164"/>
          <ac:spMkLst>
            <pc:docMk/>
            <pc:sldMk cId="2898367101" sldId="301"/>
            <ac:spMk id="59" creationId="{3AE27A51-B173-4882-A079-6ED7957177BE}"/>
          </ac:spMkLst>
        </pc:spChg>
        <pc:spChg chg="del mod topLvl">
          <ac:chgData name="Filippo Acconcia" userId="844af49c-a8a0-47ac-a7dd-14a44b60cd18" providerId="ADAL" clId="{4E01D738-D0C1-4B9B-B836-CF053EEC4C53}" dt="2022-03-16T14:02:52.747" v="1646" actId="478"/>
          <ac:spMkLst>
            <pc:docMk/>
            <pc:sldMk cId="2898367101" sldId="301"/>
            <ac:spMk id="60" creationId="{87B83EE7-CC0C-4D7F-8258-8E5B12B307AB}"/>
          </ac:spMkLst>
        </pc:spChg>
        <pc:spChg chg="del mod topLvl">
          <ac:chgData name="Filippo Acconcia" userId="844af49c-a8a0-47ac-a7dd-14a44b60cd18" providerId="ADAL" clId="{4E01D738-D0C1-4B9B-B836-CF053EEC4C53}" dt="2022-03-16T14:02:50.955" v="1644" actId="478"/>
          <ac:spMkLst>
            <pc:docMk/>
            <pc:sldMk cId="2898367101" sldId="301"/>
            <ac:spMk id="61" creationId="{A5C23B56-DEB0-4CD0-98A5-82112A647E94}"/>
          </ac:spMkLst>
        </pc:spChg>
        <pc:spChg chg="del mod topLvl">
          <ac:chgData name="Filippo Acconcia" userId="844af49c-a8a0-47ac-a7dd-14a44b60cd18" providerId="ADAL" clId="{4E01D738-D0C1-4B9B-B836-CF053EEC4C53}" dt="2022-03-16T14:02:49.827" v="1643" actId="478"/>
          <ac:spMkLst>
            <pc:docMk/>
            <pc:sldMk cId="2898367101" sldId="301"/>
            <ac:spMk id="62" creationId="{6C9A498F-BC40-4D44-9446-91FD06C22FDD}"/>
          </ac:spMkLst>
        </pc:spChg>
        <pc:spChg chg="del mod topLvl">
          <ac:chgData name="Filippo Acconcia" userId="844af49c-a8a0-47ac-a7dd-14a44b60cd18" providerId="ADAL" clId="{4E01D738-D0C1-4B9B-B836-CF053EEC4C53}" dt="2022-03-16T14:02:48.131" v="1642" actId="478"/>
          <ac:spMkLst>
            <pc:docMk/>
            <pc:sldMk cId="2898367101" sldId="301"/>
            <ac:spMk id="63" creationId="{FA711155-6CBA-4CED-9802-92FBF8B71C0A}"/>
          </ac:spMkLst>
        </pc:spChg>
        <pc:spChg chg="del mod topLvl">
          <ac:chgData name="Filippo Acconcia" userId="844af49c-a8a0-47ac-a7dd-14a44b60cd18" providerId="ADAL" clId="{4E01D738-D0C1-4B9B-B836-CF053EEC4C53}" dt="2022-03-16T14:02:48.131" v="1642" actId="478"/>
          <ac:spMkLst>
            <pc:docMk/>
            <pc:sldMk cId="2898367101" sldId="301"/>
            <ac:spMk id="64" creationId="{2BC182CC-D33E-4FF0-8EE4-DA7D2FB4C86B}"/>
          </ac:spMkLst>
        </pc:spChg>
        <pc:spChg chg="del mod topLvl">
          <ac:chgData name="Filippo Acconcia" userId="844af49c-a8a0-47ac-a7dd-14a44b60cd18" providerId="ADAL" clId="{4E01D738-D0C1-4B9B-B836-CF053EEC4C53}" dt="2022-03-16T14:02:48.131" v="1642" actId="478"/>
          <ac:spMkLst>
            <pc:docMk/>
            <pc:sldMk cId="2898367101" sldId="301"/>
            <ac:spMk id="65" creationId="{B19FBFA5-DE1C-48DD-9E78-2DDF3CFC21E2}"/>
          </ac:spMkLst>
        </pc:spChg>
        <pc:spChg chg="del mod topLvl">
          <ac:chgData name="Filippo Acconcia" userId="844af49c-a8a0-47ac-a7dd-14a44b60cd18" providerId="ADAL" clId="{4E01D738-D0C1-4B9B-B836-CF053EEC4C53}" dt="2022-03-16T14:02:48.131" v="1642" actId="478"/>
          <ac:spMkLst>
            <pc:docMk/>
            <pc:sldMk cId="2898367101" sldId="301"/>
            <ac:spMk id="66" creationId="{8151F548-0B48-429D-A4B8-8EA2BA9C2E78}"/>
          </ac:spMkLst>
        </pc:spChg>
        <pc:spChg chg="mod topLvl">
          <ac:chgData name="Filippo Acconcia" userId="844af49c-a8a0-47ac-a7dd-14a44b60cd18" providerId="ADAL" clId="{4E01D738-D0C1-4B9B-B836-CF053EEC4C53}" dt="2022-03-16T14:08:23.757" v="1882" actId="164"/>
          <ac:spMkLst>
            <pc:docMk/>
            <pc:sldMk cId="2898367101" sldId="301"/>
            <ac:spMk id="72" creationId="{1F966943-00D9-4A79-BA08-31C844E68008}"/>
          </ac:spMkLst>
        </pc:spChg>
        <pc:spChg chg="mod topLvl">
          <ac:chgData name="Filippo Acconcia" userId="844af49c-a8a0-47ac-a7dd-14a44b60cd18" providerId="ADAL" clId="{4E01D738-D0C1-4B9B-B836-CF053EEC4C53}" dt="2022-03-16T14:08:23.757" v="1882" actId="164"/>
          <ac:spMkLst>
            <pc:docMk/>
            <pc:sldMk cId="2898367101" sldId="301"/>
            <ac:spMk id="73" creationId="{468E6A9A-8261-4C8F-AEF5-B35669F54A25}"/>
          </ac:spMkLst>
        </pc:spChg>
        <pc:spChg chg="mod topLvl">
          <ac:chgData name="Filippo Acconcia" userId="844af49c-a8a0-47ac-a7dd-14a44b60cd18" providerId="ADAL" clId="{4E01D738-D0C1-4B9B-B836-CF053EEC4C53}" dt="2022-03-16T14:08:23.757" v="1882" actId="164"/>
          <ac:spMkLst>
            <pc:docMk/>
            <pc:sldMk cId="2898367101" sldId="301"/>
            <ac:spMk id="74" creationId="{0F218BBB-7C36-4145-9FE8-9C1EB8D19CEA}"/>
          </ac:spMkLst>
        </pc:spChg>
        <pc:spChg chg="mod topLvl">
          <ac:chgData name="Filippo Acconcia" userId="844af49c-a8a0-47ac-a7dd-14a44b60cd18" providerId="ADAL" clId="{4E01D738-D0C1-4B9B-B836-CF053EEC4C53}" dt="2022-03-16T14:08:23.757" v="1882" actId="164"/>
          <ac:spMkLst>
            <pc:docMk/>
            <pc:sldMk cId="2898367101" sldId="301"/>
            <ac:spMk id="75" creationId="{3BBBA2E8-C340-49EB-9820-7EA19C7A93A4}"/>
          </ac:spMkLst>
        </pc:spChg>
        <pc:spChg chg="mod topLvl">
          <ac:chgData name="Filippo Acconcia" userId="844af49c-a8a0-47ac-a7dd-14a44b60cd18" providerId="ADAL" clId="{4E01D738-D0C1-4B9B-B836-CF053EEC4C53}" dt="2022-03-16T14:08:23.757" v="1882" actId="164"/>
          <ac:spMkLst>
            <pc:docMk/>
            <pc:sldMk cId="2898367101" sldId="301"/>
            <ac:spMk id="76" creationId="{ACE57ACB-D13F-47A6-8065-F4EF462FA5EF}"/>
          </ac:spMkLst>
        </pc:spChg>
        <pc:spChg chg="mod topLvl">
          <ac:chgData name="Filippo Acconcia" userId="844af49c-a8a0-47ac-a7dd-14a44b60cd18" providerId="ADAL" clId="{4E01D738-D0C1-4B9B-B836-CF053EEC4C53}" dt="2022-03-16T14:08:23.757" v="1882" actId="164"/>
          <ac:spMkLst>
            <pc:docMk/>
            <pc:sldMk cId="2898367101" sldId="301"/>
            <ac:spMk id="77" creationId="{868912A5-4F58-4ED1-8541-734ED753F2A7}"/>
          </ac:spMkLst>
        </pc:spChg>
        <pc:spChg chg="mod topLvl">
          <ac:chgData name="Filippo Acconcia" userId="844af49c-a8a0-47ac-a7dd-14a44b60cd18" providerId="ADAL" clId="{4E01D738-D0C1-4B9B-B836-CF053EEC4C53}" dt="2022-03-16T14:08:23.757" v="1882" actId="164"/>
          <ac:spMkLst>
            <pc:docMk/>
            <pc:sldMk cId="2898367101" sldId="301"/>
            <ac:spMk id="79" creationId="{4B66F6DB-F246-4B99-A766-2A5E01265D7C}"/>
          </ac:spMkLst>
        </pc:spChg>
        <pc:spChg chg="add del mod">
          <ac:chgData name="Filippo Acconcia" userId="844af49c-a8a0-47ac-a7dd-14a44b60cd18" providerId="ADAL" clId="{4E01D738-D0C1-4B9B-B836-CF053EEC4C53}" dt="2022-03-16T14:08:18.228" v="1881" actId="478"/>
          <ac:spMkLst>
            <pc:docMk/>
            <pc:sldMk cId="2898367101" sldId="301"/>
            <ac:spMk id="81" creationId="{CE74456D-6C1A-4482-96BB-2C13D4D01D28}"/>
          </ac:spMkLst>
        </pc:spChg>
        <pc:spChg chg="del mod topLvl">
          <ac:chgData name="Filippo Acconcia" userId="844af49c-a8a0-47ac-a7dd-14a44b60cd18" providerId="ADAL" clId="{4E01D738-D0C1-4B9B-B836-CF053EEC4C53}" dt="2022-03-16T14:08:18.228" v="1881" actId="478"/>
          <ac:spMkLst>
            <pc:docMk/>
            <pc:sldMk cId="2898367101" sldId="301"/>
            <ac:spMk id="83" creationId="{0921B191-6BA0-414C-8ED6-90F56A03EF4A}"/>
          </ac:spMkLst>
        </pc:spChg>
        <pc:spChg chg="del mod topLvl">
          <ac:chgData name="Filippo Acconcia" userId="844af49c-a8a0-47ac-a7dd-14a44b60cd18" providerId="ADAL" clId="{4E01D738-D0C1-4B9B-B836-CF053EEC4C53}" dt="2022-03-16T14:08:18.228" v="1881" actId="478"/>
          <ac:spMkLst>
            <pc:docMk/>
            <pc:sldMk cId="2898367101" sldId="301"/>
            <ac:spMk id="84" creationId="{8E99E043-1A94-4F0B-898C-396295341612}"/>
          </ac:spMkLst>
        </pc:spChg>
        <pc:spChg chg="del mod topLvl">
          <ac:chgData name="Filippo Acconcia" userId="844af49c-a8a0-47ac-a7dd-14a44b60cd18" providerId="ADAL" clId="{4E01D738-D0C1-4B9B-B836-CF053EEC4C53}" dt="2022-03-16T14:08:18.228" v="1881" actId="478"/>
          <ac:spMkLst>
            <pc:docMk/>
            <pc:sldMk cId="2898367101" sldId="301"/>
            <ac:spMk id="85" creationId="{BB5443D7-0F59-4EB2-A4DE-87FFD49C6DB4}"/>
          </ac:spMkLst>
        </pc:spChg>
        <pc:spChg chg="del mod topLvl">
          <ac:chgData name="Filippo Acconcia" userId="844af49c-a8a0-47ac-a7dd-14a44b60cd18" providerId="ADAL" clId="{4E01D738-D0C1-4B9B-B836-CF053EEC4C53}" dt="2022-03-16T14:08:18.228" v="1881" actId="478"/>
          <ac:spMkLst>
            <pc:docMk/>
            <pc:sldMk cId="2898367101" sldId="301"/>
            <ac:spMk id="86" creationId="{38684B51-9A16-4EE9-8E5A-26EB0850E299}"/>
          </ac:spMkLst>
        </pc:spChg>
        <pc:spChg chg="del mod topLvl">
          <ac:chgData name="Filippo Acconcia" userId="844af49c-a8a0-47ac-a7dd-14a44b60cd18" providerId="ADAL" clId="{4E01D738-D0C1-4B9B-B836-CF053EEC4C53}" dt="2022-03-16T14:08:18.228" v="1881" actId="478"/>
          <ac:spMkLst>
            <pc:docMk/>
            <pc:sldMk cId="2898367101" sldId="301"/>
            <ac:spMk id="87" creationId="{133041FB-B271-4973-8504-62D3BD630743}"/>
          </ac:spMkLst>
        </pc:spChg>
        <pc:spChg chg="del mod topLvl">
          <ac:chgData name="Filippo Acconcia" userId="844af49c-a8a0-47ac-a7dd-14a44b60cd18" providerId="ADAL" clId="{4E01D738-D0C1-4B9B-B836-CF053EEC4C53}" dt="2022-03-16T14:08:18.228" v="1881" actId="478"/>
          <ac:spMkLst>
            <pc:docMk/>
            <pc:sldMk cId="2898367101" sldId="301"/>
            <ac:spMk id="88" creationId="{7D5C82B3-A4ED-489F-B1D8-787FF1498317}"/>
          </ac:spMkLst>
        </pc:spChg>
        <pc:spChg chg="del mod topLvl">
          <ac:chgData name="Filippo Acconcia" userId="844af49c-a8a0-47ac-a7dd-14a44b60cd18" providerId="ADAL" clId="{4E01D738-D0C1-4B9B-B836-CF053EEC4C53}" dt="2022-03-16T14:08:18.228" v="1881" actId="478"/>
          <ac:spMkLst>
            <pc:docMk/>
            <pc:sldMk cId="2898367101" sldId="301"/>
            <ac:spMk id="90" creationId="{62D52CD4-3617-4651-BE18-7B4240C0686C}"/>
          </ac:spMkLst>
        </pc:spChg>
        <pc:spChg chg="add mod">
          <ac:chgData name="Filippo Acconcia" userId="844af49c-a8a0-47ac-a7dd-14a44b60cd18" providerId="ADAL" clId="{4E01D738-D0C1-4B9B-B836-CF053EEC4C53}" dt="2022-03-16T14:08:16.355" v="1880" actId="164"/>
          <ac:spMkLst>
            <pc:docMk/>
            <pc:sldMk cId="2898367101" sldId="301"/>
            <ac:spMk id="94" creationId="{F38ACBCA-5C2D-4E24-862A-CBD81AAA5C21}"/>
          </ac:spMkLst>
        </pc:spChg>
        <pc:spChg chg="add mod">
          <ac:chgData name="Filippo Acconcia" userId="844af49c-a8a0-47ac-a7dd-14a44b60cd18" providerId="ADAL" clId="{4E01D738-D0C1-4B9B-B836-CF053EEC4C53}" dt="2022-03-16T14:08:16.355" v="1880" actId="164"/>
          <ac:spMkLst>
            <pc:docMk/>
            <pc:sldMk cId="2898367101" sldId="301"/>
            <ac:spMk id="98" creationId="{228A1D0F-8D90-48CA-8771-FD0F31024198}"/>
          </ac:spMkLst>
        </pc:spChg>
        <pc:spChg chg="add mod">
          <ac:chgData name="Filippo Acconcia" userId="844af49c-a8a0-47ac-a7dd-14a44b60cd18" providerId="ADAL" clId="{4E01D738-D0C1-4B9B-B836-CF053EEC4C53}" dt="2022-03-16T14:08:16.355" v="1880" actId="164"/>
          <ac:spMkLst>
            <pc:docMk/>
            <pc:sldMk cId="2898367101" sldId="301"/>
            <ac:spMk id="99" creationId="{7DF61D0F-1C36-4913-A47A-59C81355FDB0}"/>
          </ac:spMkLst>
        </pc:spChg>
        <pc:spChg chg="add mod">
          <ac:chgData name="Filippo Acconcia" userId="844af49c-a8a0-47ac-a7dd-14a44b60cd18" providerId="ADAL" clId="{4E01D738-D0C1-4B9B-B836-CF053EEC4C53}" dt="2022-03-16T14:08:16.355" v="1880" actId="164"/>
          <ac:spMkLst>
            <pc:docMk/>
            <pc:sldMk cId="2898367101" sldId="301"/>
            <ac:spMk id="100" creationId="{643BADCE-DAA0-4CF8-8977-1F54DE9C0732}"/>
          </ac:spMkLst>
        </pc:spChg>
        <pc:spChg chg="add mod">
          <ac:chgData name="Filippo Acconcia" userId="844af49c-a8a0-47ac-a7dd-14a44b60cd18" providerId="ADAL" clId="{4E01D738-D0C1-4B9B-B836-CF053EEC4C53}" dt="2022-03-16T14:08:16.355" v="1880" actId="164"/>
          <ac:spMkLst>
            <pc:docMk/>
            <pc:sldMk cId="2898367101" sldId="301"/>
            <ac:spMk id="101" creationId="{D61286CB-C585-4E83-BC18-6BE0563E77B4}"/>
          </ac:spMkLst>
        </pc:spChg>
        <pc:spChg chg="add mod">
          <ac:chgData name="Filippo Acconcia" userId="844af49c-a8a0-47ac-a7dd-14a44b60cd18" providerId="ADAL" clId="{4E01D738-D0C1-4B9B-B836-CF053EEC4C53}" dt="2022-03-16T14:08:16.355" v="1880" actId="164"/>
          <ac:spMkLst>
            <pc:docMk/>
            <pc:sldMk cId="2898367101" sldId="301"/>
            <ac:spMk id="102" creationId="{159C6311-9408-4DD9-A12E-EC2CAEE7650E}"/>
          </ac:spMkLst>
        </pc:spChg>
        <pc:spChg chg="add mod">
          <ac:chgData name="Filippo Acconcia" userId="844af49c-a8a0-47ac-a7dd-14a44b60cd18" providerId="ADAL" clId="{4E01D738-D0C1-4B9B-B836-CF053EEC4C53}" dt="2022-03-16T14:08:16.355" v="1880" actId="164"/>
          <ac:spMkLst>
            <pc:docMk/>
            <pc:sldMk cId="2898367101" sldId="301"/>
            <ac:spMk id="103" creationId="{877E5133-4F57-41CB-AAB2-5DE8ACD6E5CD}"/>
          </ac:spMkLst>
        </pc:spChg>
        <pc:spChg chg="add mod">
          <ac:chgData name="Filippo Acconcia" userId="844af49c-a8a0-47ac-a7dd-14a44b60cd18" providerId="ADAL" clId="{4E01D738-D0C1-4B9B-B836-CF053EEC4C53}" dt="2022-03-16T14:08:16.355" v="1880" actId="164"/>
          <ac:spMkLst>
            <pc:docMk/>
            <pc:sldMk cId="2898367101" sldId="301"/>
            <ac:spMk id="105" creationId="{2EFD1BA4-E258-4BEE-A25B-1A61F015FE8A}"/>
          </ac:spMkLst>
        </pc:spChg>
        <pc:spChg chg="add mod">
          <ac:chgData name="Filippo Acconcia" userId="844af49c-a8a0-47ac-a7dd-14a44b60cd18" providerId="ADAL" clId="{4E01D738-D0C1-4B9B-B836-CF053EEC4C53}" dt="2022-03-16T14:09:03.033" v="1920" actId="553"/>
          <ac:spMkLst>
            <pc:docMk/>
            <pc:sldMk cId="2898367101" sldId="301"/>
            <ac:spMk id="108" creationId="{F78640A8-F501-4342-8743-960CDACC9017}"/>
          </ac:spMkLst>
        </pc:spChg>
        <pc:spChg chg="add mod">
          <ac:chgData name="Filippo Acconcia" userId="844af49c-a8a0-47ac-a7dd-14a44b60cd18" providerId="ADAL" clId="{4E01D738-D0C1-4B9B-B836-CF053EEC4C53}" dt="2022-03-16T14:08:58.038" v="1919" actId="553"/>
          <ac:spMkLst>
            <pc:docMk/>
            <pc:sldMk cId="2898367101" sldId="301"/>
            <ac:spMk id="109" creationId="{26753312-09A3-447F-AD66-7109FDC76B85}"/>
          </ac:spMkLst>
        </pc:spChg>
        <pc:grpChg chg="add del mod">
          <ac:chgData name="Filippo Acconcia" userId="844af49c-a8a0-47ac-a7dd-14a44b60cd18" providerId="ADAL" clId="{4E01D738-D0C1-4B9B-B836-CF053EEC4C53}" dt="2022-03-16T14:02:36.060" v="1637" actId="165"/>
          <ac:grpSpMkLst>
            <pc:docMk/>
            <pc:sldMk cId="2898367101" sldId="301"/>
            <ac:grpSpMk id="53" creationId="{6487D61B-F5C6-4962-BE3B-84E570DE2862}"/>
          </ac:grpSpMkLst>
        </pc:grpChg>
        <pc:grpChg chg="add del mod">
          <ac:chgData name="Filippo Acconcia" userId="844af49c-a8a0-47ac-a7dd-14a44b60cd18" providerId="ADAL" clId="{4E01D738-D0C1-4B9B-B836-CF053EEC4C53}" dt="2022-03-16T14:03:40.199" v="1671" actId="165"/>
          <ac:grpSpMkLst>
            <pc:docMk/>
            <pc:sldMk cId="2898367101" sldId="301"/>
            <ac:grpSpMk id="68" creationId="{32B7A8D2-12A7-41EC-8AFD-6897344C722A}"/>
          </ac:grpSpMkLst>
        </pc:grpChg>
        <pc:grpChg chg="add del mod">
          <ac:chgData name="Filippo Acconcia" userId="844af49c-a8a0-47ac-a7dd-14a44b60cd18" providerId="ADAL" clId="{4E01D738-D0C1-4B9B-B836-CF053EEC4C53}" dt="2022-03-16T14:03:05.697" v="1654" actId="165"/>
          <ac:grpSpMkLst>
            <pc:docMk/>
            <pc:sldMk cId="2898367101" sldId="301"/>
            <ac:grpSpMk id="82" creationId="{2389E66F-F9FC-42CA-9932-6D07A31DD1C1}"/>
          </ac:grpSpMkLst>
        </pc:grpChg>
        <pc:grpChg chg="add mod">
          <ac:chgData name="Filippo Acconcia" userId="844af49c-a8a0-47ac-a7dd-14a44b60cd18" providerId="ADAL" clId="{4E01D738-D0C1-4B9B-B836-CF053EEC4C53}" dt="2022-03-16T14:08:42.821" v="1914" actId="1036"/>
          <ac:grpSpMkLst>
            <pc:docMk/>
            <pc:sldMk cId="2898367101" sldId="301"/>
            <ac:grpSpMk id="106" creationId="{75F22434-CC31-449D-9D0F-0ABE5E91E8AE}"/>
          </ac:grpSpMkLst>
        </pc:grpChg>
        <pc:grpChg chg="add mod">
          <ac:chgData name="Filippo Acconcia" userId="844af49c-a8a0-47ac-a7dd-14a44b60cd18" providerId="ADAL" clId="{4E01D738-D0C1-4B9B-B836-CF053EEC4C53}" dt="2022-03-16T14:08:42.821" v="1914" actId="1036"/>
          <ac:grpSpMkLst>
            <pc:docMk/>
            <pc:sldMk cId="2898367101" sldId="301"/>
            <ac:grpSpMk id="107" creationId="{6F14921F-B604-4C2F-AEDF-598971B3064F}"/>
          </ac:grpSpMkLst>
        </pc:grpChg>
        <pc:picChg chg="del mod topLvl">
          <ac:chgData name="Filippo Acconcia" userId="844af49c-a8a0-47ac-a7dd-14a44b60cd18" providerId="ADAL" clId="{4E01D738-D0C1-4B9B-B836-CF053EEC4C53}" dt="2022-03-16T14:02:37.259" v="1638" actId="478"/>
          <ac:picMkLst>
            <pc:docMk/>
            <pc:sldMk cId="2898367101" sldId="301"/>
            <ac:picMk id="54" creationId="{DB5FA9B4-0997-4AC7-A686-C0EC4C78B9AB}"/>
          </ac:picMkLst>
        </pc:picChg>
        <pc:picChg chg="del mod topLvl">
          <ac:chgData name="Filippo Acconcia" userId="844af49c-a8a0-47ac-a7dd-14a44b60cd18" providerId="ADAL" clId="{4E01D738-D0C1-4B9B-B836-CF053EEC4C53}" dt="2022-03-16T14:02:49.827" v="1643" actId="478"/>
          <ac:picMkLst>
            <pc:docMk/>
            <pc:sldMk cId="2898367101" sldId="301"/>
            <ac:picMk id="67" creationId="{2C9E3186-F47F-486D-AD3B-2249B6883BD9}"/>
          </ac:picMkLst>
        </pc:picChg>
        <pc:picChg chg="mod topLvl">
          <ac:chgData name="Filippo Acconcia" userId="844af49c-a8a0-47ac-a7dd-14a44b60cd18" providerId="ADAL" clId="{4E01D738-D0C1-4B9B-B836-CF053EEC4C53}" dt="2022-03-16T14:08:23.757" v="1882" actId="164"/>
          <ac:picMkLst>
            <pc:docMk/>
            <pc:sldMk cId="2898367101" sldId="301"/>
            <ac:picMk id="69" creationId="{88F17B7A-3CA8-4166-914E-5E86317D2436}"/>
          </ac:picMkLst>
        </pc:picChg>
        <pc:picChg chg="mod topLvl">
          <ac:chgData name="Filippo Acconcia" userId="844af49c-a8a0-47ac-a7dd-14a44b60cd18" providerId="ADAL" clId="{4E01D738-D0C1-4B9B-B836-CF053EEC4C53}" dt="2022-03-16T14:08:23.757" v="1882" actId="164"/>
          <ac:picMkLst>
            <pc:docMk/>
            <pc:sldMk cId="2898367101" sldId="301"/>
            <ac:picMk id="70" creationId="{DE610C82-3871-4844-8661-1D646FE0EFA5}"/>
          </ac:picMkLst>
        </pc:picChg>
        <pc:picChg chg="mod topLvl">
          <ac:chgData name="Filippo Acconcia" userId="844af49c-a8a0-47ac-a7dd-14a44b60cd18" providerId="ADAL" clId="{4E01D738-D0C1-4B9B-B836-CF053EEC4C53}" dt="2022-03-16T14:08:23.757" v="1882" actId="164"/>
          <ac:picMkLst>
            <pc:docMk/>
            <pc:sldMk cId="2898367101" sldId="301"/>
            <ac:picMk id="71" creationId="{7AF5B02D-798C-4B1C-BB65-1BC4BE674882}"/>
          </ac:picMkLst>
        </pc:picChg>
        <pc:picChg chg="add del mod">
          <ac:chgData name="Filippo Acconcia" userId="844af49c-a8a0-47ac-a7dd-14a44b60cd18" providerId="ADAL" clId="{4E01D738-D0C1-4B9B-B836-CF053EEC4C53}" dt="2022-03-16T14:02:42.579" v="1640" actId="478"/>
          <ac:picMkLst>
            <pc:docMk/>
            <pc:sldMk cId="2898367101" sldId="301"/>
            <ac:picMk id="80" creationId="{0E1A7E41-48A8-475B-A8E6-582BD00529F5}"/>
          </ac:picMkLst>
        </pc:picChg>
        <pc:picChg chg="mod topLvl">
          <ac:chgData name="Filippo Acconcia" userId="844af49c-a8a0-47ac-a7dd-14a44b60cd18" providerId="ADAL" clId="{4E01D738-D0C1-4B9B-B836-CF053EEC4C53}" dt="2022-03-16T14:08:16.355" v="1880" actId="164"/>
          <ac:picMkLst>
            <pc:docMk/>
            <pc:sldMk cId="2898367101" sldId="301"/>
            <ac:picMk id="91" creationId="{A743E07C-756E-4434-8C37-3253AC0C678F}"/>
          </ac:picMkLst>
        </pc:picChg>
        <pc:picChg chg="mod topLvl">
          <ac:chgData name="Filippo Acconcia" userId="844af49c-a8a0-47ac-a7dd-14a44b60cd18" providerId="ADAL" clId="{4E01D738-D0C1-4B9B-B836-CF053EEC4C53}" dt="2022-03-16T14:08:16.355" v="1880" actId="164"/>
          <ac:picMkLst>
            <pc:docMk/>
            <pc:sldMk cId="2898367101" sldId="301"/>
            <ac:picMk id="92" creationId="{905C8474-2052-4F5F-A833-2F6C460DB2C0}"/>
          </ac:picMkLst>
        </pc:picChg>
        <pc:picChg chg="mod topLvl">
          <ac:chgData name="Filippo Acconcia" userId="844af49c-a8a0-47ac-a7dd-14a44b60cd18" providerId="ADAL" clId="{4E01D738-D0C1-4B9B-B836-CF053EEC4C53}" dt="2022-03-16T14:08:16.355" v="1880" actId="164"/>
          <ac:picMkLst>
            <pc:docMk/>
            <pc:sldMk cId="2898367101" sldId="301"/>
            <ac:picMk id="93" creationId="{999F38A6-FB78-4EB0-891D-50DA26A903E6}"/>
          </ac:picMkLst>
        </pc:picChg>
        <pc:picChg chg="add del mod">
          <ac:chgData name="Filippo Acconcia" userId="844af49c-a8a0-47ac-a7dd-14a44b60cd18" providerId="ADAL" clId="{4E01D738-D0C1-4B9B-B836-CF053EEC4C53}" dt="2022-03-16T14:08:11.242" v="1879" actId="478"/>
          <ac:picMkLst>
            <pc:docMk/>
            <pc:sldMk cId="2898367101" sldId="301"/>
            <ac:picMk id="95" creationId="{A8D17C21-722B-4482-9C1A-F68D18B381CF}"/>
          </ac:picMkLst>
        </pc:picChg>
        <pc:picChg chg="add del mod">
          <ac:chgData name="Filippo Acconcia" userId="844af49c-a8a0-47ac-a7dd-14a44b60cd18" providerId="ADAL" clId="{4E01D738-D0C1-4B9B-B836-CF053EEC4C53}" dt="2022-03-16T14:08:02.187" v="1877" actId="478"/>
          <ac:picMkLst>
            <pc:docMk/>
            <pc:sldMk cId="2898367101" sldId="301"/>
            <ac:picMk id="96" creationId="{D01C2B47-2360-486A-9811-35A9F6829987}"/>
          </ac:picMkLst>
        </pc:picChg>
        <pc:picChg chg="add del mod">
          <ac:chgData name="Filippo Acconcia" userId="844af49c-a8a0-47ac-a7dd-14a44b60cd18" providerId="ADAL" clId="{4E01D738-D0C1-4B9B-B836-CF053EEC4C53}" dt="2022-03-16T14:08:01.093" v="1876" actId="478"/>
          <ac:picMkLst>
            <pc:docMk/>
            <pc:sldMk cId="2898367101" sldId="301"/>
            <ac:picMk id="97" creationId="{D7AF7D6F-BFD0-4296-AD5F-419A81FC084F}"/>
          </ac:picMkLst>
        </pc:picChg>
        <pc:cxnChg chg="mod topLvl">
          <ac:chgData name="Filippo Acconcia" userId="844af49c-a8a0-47ac-a7dd-14a44b60cd18" providerId="ADAL" clId="{4E01D738-D0C1-4B9B-B836-CF053EEC4C53}" dt="2022-03-16T14:08:23.757" v="1882" actId="164"/>
          <ac:cxnSpMkLst>
            <pc:docMk/>
            <pc:sldMk cId="2898367101" sldId="301"/>
            <ac:cxnSpMk id="78" creationId="{C8763473-0BD8-458F-8D8B-63643E78997C}"/>
          </ac:cxnSpMkLst>
        </pc:cxnChg>
        <pc:cxnChg chg="del mod topLvl">
          <ac:chgData name="Filippo Acconcia" userId="844af49c-a8a0-47ac-a7dd-14a44b60cd18" providerId="ADAL" clId="{4E01D738-D0C1-4B9B-B836-CF053EEC4C53}" dt="2022-03-16T14:08:18.228" v="1881" actId="478"/>
          <ac:cxnSpMkLst>
            <pc:docMk/>
            <pc:sldMk cId="2898367101" sldId="301"/>
            <ac:cxnSpMk id="89" creationId="{40ED00AC-DE77-46A1-83E6-2A92D3BB5E84}"/>
          </ac:cxnSpMkLst>
        </pc:cxnChg>
        <pc:cxnChg chg="add mod">
          <ac:chgData name="Filippo Acconcia" userId="844af49c-a8a0-47ac-a7dd-14a44b60cd18" providerId="ADAL" clId="{4E01D738-D0C1-4B9B-B836-CF053EEC4C53}" dt="2022-03-16T14:08:16.355" v="1880" actId="164"/>
          <ac:cxnSpMkLst>
            <pc:docMk/>
            <pc:sldMk cId="2898367101" sldId="301"/>
            <ac:cxnSpMk id="104" creationId="{339FE0BE-7D03-430B-A299-D3E9DB614E37}"/>
          </ac:cxnSpMkLst>
        </pc:cxnChg>
      </pc:sldChg>
      <pc:sldChg chg="addSp delSp modSp new mod">
        <pc:chgData name="Filippo Acconcia" userId="844af49c-a8a0-47ac-a7dd-14a44b60cd18" providerId="ADAL" clId="{4E01D738-D0C1-4B9B-B836-CF053EEC4C53}" dt="2022-03-16T08:49:12.255" v="943" actId="1036"/>
        <pc:sldMkLst>
          <pc:docMk/>
          <pc:sldMk cId="2335018827" sldId="302"/>
        </pc:sldMkLst>
        <pc:spChg chg="add mod">
          <ac:chgData name="Filippo Acconcia" userId="844af49c-a8a0-47ac-a7dd-14a44b60cd18" providerId="ADAL" clId="{4E01D738-D0C1-4B9B-B836-CF053EEC4C53}" dt="2022-03-15T16:45:09.102" v="2" actId="20577"/>
          <ac:spMkLst>
            <pc:docMk/>
            <pc:sldMk cId="2335018827" sldId="302"/>
            <ac:spMk id="2" creationId="{6E29DCE7-AB1E-4E29-A6CB-A53944649AC9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5" creationId="{1EDC1973-3F4D-4141-9F41-BF46B6899EF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6" creationId="{D4476061-32C6-43ED-97B0-E0BC33E3EBF6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7" creationId="{DA898F5B-78D6-47C7-8CD4-7C619A277E70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8" creationId="{2E0458D1-1F59-4393-AB11-91EFC30BDF4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9" creationId="{BB8EC6AE-9D11-4635-9929-54BAF2E3466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1" creationId="{E24119FB-F261-4762-840A-43EC3038DA3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3" creationId="{DAD3D416-9DCE-4F55-8AFA-B67955EC9AD6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5" creationId="{22F38E25-62B1-4F6D-B289-4028A65A747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7" creationId="{D048A769-10D3-4808-AAD8-4FBDE6D1A6D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8" creationId="{8B4F6A94-A98C-40FB-8227-57099EA83980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9" creationId="{CB2A1C93-992F-4A80-BD65-190706A7F03A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0" creationId="{13536782-D832-4BDE-88F6-47DAC1993B1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1" creationId="{DBA978E6-E03C-4D22-A4B2-F2D6513C5D69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2" creationId="{41C5CC0C-26B9-4AF5-AF02-AD230A9A042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8" creationId="{B9266FBA-288F-4ACE-B3E8-BBA5895CCDF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9" creationId="{480892B9-EFA6-41B1-B4DE-711CFF29ADE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30" creationId="{174D75A3-E28C-4E6A-AAFE-8CBB2B8130F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31" creationId="{242D0E85-EA50-4A04-BBC9-E964EF048BA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33" creationId="{0635E557-2204-450B-9A64-A71CF90E993A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34" creationId="{D2211384-BF9A-4539-A21A-8705B4B19D0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35" creationId="{588AD047-B4FD-4BC9-A3AC-BA21456CD633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36" creationId="{EDFDDAD7-1B1D-4EAF-9746-E718136CA323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37" creationId="{4BC2879F-648D-4221-A2A3-C515ECF4CEE6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38" creationId="{A61B1A90-EC33-4CB5-8577-7F655A179B3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39" creationId="{E53B3A37-67E5-4859-BDD5-DB56D8A4126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40" creationId="{E3B3B347-C849-4861-A527-7174E22C41A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41" creationId="{0EDBC88D-5ACF-4F0A-B90E-F2F7F680BFF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42" creationId="{6C6BE8ED-5948-484C-AC54-006958F69D9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43" creationId="{F13404EE-B4EE-4A94-AE98-94168CAD4CFA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44" creationId="{0752AF45-CF17-49E6-96AA-068CF901594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45" creationId="{E6BEBED9-F759-4009-9612-941B39DDD2F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46" creationId="{DD5BD7E1-A99C-45E9-9347-4ABDB940C163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47" creationId="{D705FB87-6F72-4859-9D10-5EB2636EBF73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48" creationId="{24AE914F-D854-497D-8196-EFCD81BF851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49" creationId="{CCCA4911-E16B-4467-A374-719CB02B00F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50" creationId="{5DCC459F-4C77-45EA-AED9-08616839037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53" creationId="{7146CC29-580F-44F0-82D5-9CE31820D2F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54" creationId="{9A3CCECF-A9F0-401D-BEBD-2E467F1AE10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55" creationId="{CC4B13D7-C4C8-44F0-95D6-294981347506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56" creationId="{750B9A22-3371-44FA-9A83-3E8D4B050B1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57" creationId="{2C34EE58-887B-465F-8144-60E225314F3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59" creationId="{C1D2B9EE-7829-4C91-A0E6-6DF080FF0B6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61" creationId="{CA7EA657-727B-4247-9050-8B49A6F2B03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63" creationId="{D066FCAC-DE9C-4873-8E74-94A4570A830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65" creationId="{2154A513-02E7-4D41-837A-008A5F31FE2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66" creationId="{FD213056-9DD5-45DE-A0EF-50CE6758F35B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67" creationId="{716DEF2E-5B6A-4B5B-A13D-1F6DD93D93A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68" creationId="{94AC59EA-1E48-4650-9908-C9E8A0C954F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69" creationId="{D7CB80F7-31BB-41EB-951C-6E92D91B0F7F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70" creationId="{B0E07ADB-F35C-426D-A2D6-485F7231532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76" creationId="{5CFA04DF-CCC1-45A3-83E6-7AE3AF48DC0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77" creationId="{951D1BE6-F0CA-44D1-AE37-6F8736132A96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78" creationId="{88CEEBC0-DC2F-4F82-B0EB-6F39BDC1DA8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79" creationId="{A38913C4-C335-4CAB-B12F-80C98729BBD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81" creationId="{7A80495E-FEC8-4A49-9C0F-E2804E2729C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82" creationId="{75C0C309-45B1-4F6D-9538-AC2C3B5CE5DB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83" creationId="{F964FB20-0857-4EC7-9286-45CF87934CFA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84" creationId="{4D1FFC7C-97EF-476F-B05B-F2AC40A2493F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85" creationId="{B0E75299-35FE-44A8-8EB0-90B098724640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86" creationId="{A56174DE-0619-439C-BA23-6C312A864CC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87" creationId="{892F2093-8AFC-45F2-B4DF-65CA40A5A12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88" creationId="{90430FE8-83A6-4DAD-AD96-70FC067E33B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89" creationId="{2DAB38B6-84C8-46BA-AB53-F3B680590CE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90" creationId="{1D88D64D-084D-452A-8140-91371423188B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91" creationId="{C23D7411-3AAC-443B-9530-B4FDFBB517A6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92" creationId="{93614505-7A85-4CFC-869E-E5BDA1CD289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93" creationId="{AE05A18D-19F3-4C6D-8B3D-914A4D849A7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94" creationId="{A070101F-3115-46F9-9ABC-F0850658704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95" creationId="{8D3DCA6D-11B7-4D98-AEDA-78D9518A70B6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96" creationId="{E1A8216A-D8EF-40A2-80A7-6AAAAE7E1C1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97" creationId="{61609BD8-ECDA-49B2-AD44-4F3CF52EA39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98" creationId="{2AEA2878-8185-4084-8D39-8E96219FAC6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01" creationId="{5248A2B3-396E-4F48-8905-CEB5F265B5A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02" creationId="{D55FA5CC-80A6-41FC-BF45-535920C34E8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03" creationId="{B546CC18-2FFF-41F1-A9E4-F73E25B50C20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04" creationId="{C9575F44-B537-4228-9E36-2BF98550799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05" creationId="{990A4F0E-3502-408F-9858-0B32E6C8A4E6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07" creationId="{FF6A8FA7-F1C9-4CDB-83C7-A2D6700AE5E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09" creationId="{C4CBE788-DBCF-4A0E-845C-09C1F7C084A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11" creationId="{BB4F64C0-7372-4A02-A8AD-2FF0A368B92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13" creationId="{94E8DC06-0FF4-4122-B721-DF93F234E433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14" creationId="{DB4E07D8-8ACF-4204-B59B-EB03D542B7B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15" creationId="{AC9A7C6C-F7C8-4611-BA52-DD0A3CC4B10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16" creationId="{7E77052D-F585-4F71-B042-4D4C126CFF9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17" creationId="{B388E365-E21E-48C5-95DB-E2101B7812F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18" creationId="{6AC2BC6F-8A89-420F-AF55-B6418646EE0A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24" creationId="{23776EE9-06DC-447F-BDB0-B71C67FB6373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25" creationId="{EDF98917-67B2-48D6-8112-56D2D80AFEB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26" creationId="{51FA1024-5C43-4DD1-8420-50B364B50756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27" creationId="{FDDA3C1C-DF21-4D0C-84EF-E0FA5C5E526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29" creationId="{E7F0FE92-7AA3-466C-AB8E-04B039725A4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30" creationId="{DD067631-3EF0-47E9-B666-904BD4A2ACC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31" creationId="{C785676F-2E56-481B-9F61-3515AC4BDD50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32" creationId="{ABC60B81-F1E5-4E4D-8EB3-5193571F69B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33" creationId="{D4417DEA-7656-4C00-8C7C-0489155755F6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34" creationId="{CDDAB3AA-3B5B-48F5-8CD9-3907828194D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35" creationId="{4745EEDB-F30F-4632-BC05-ECC647C9F10B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36" creationId="{D01712F3-68D4-4181-B09E-2B336D67812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37" creationId="{A004AED4-9F79-48A4-838E-ABD3D3BF9B6B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38" creationId="{6EF65A80-B712-4710-B100-B5C1C69E2033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39" creationId="{8DEB52BF-493F-4248-8E41-4D69DC029D9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40" creationId="{7F3B5223-6417-451F-A843-B58CF7B0B36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41" creationId="{E414702D-D81A-4B88-B0BC-5A93746A98AA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42" creationId="{6B9BC7D1-267E-433C-86C3-ED903F0AF680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43" creationId="{8F76DDD4-68DB-4DD5-ACB9-BA55F04FE32B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44" creationId="{0FE2E0FC-5C5A-43CE-B3E7-9309DD0B8C9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45" creationId="{9930BF7A-2629-4CF2-B7FC-2146C723428F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46" creationId="{260C8BC9-3EEE-4410-B483-0D9B4FEF4803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49" creationId="{3FDA2368-E77C-4BA6-9423-C5DD882B9AD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50" creationId="{BD73D1C5-A3A5-4AAD-9599-5070926E6DDB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51" creationId="{33340593-5353-437E-91A4-3DC7423E845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52" creationId="{08CAE148-E7E6-4742-96B0-F4BDE47D60B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53" creationId="{A5A1D538-DC8F-43AC-BB43-A2D588974C5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55" creationId="{D9BCF039-C9F0-4BA4-80C9-4CC8884034F9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57" creationId="{32CB0A9F-4A4B-48FE-82B6-D40116BB1BC3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59" creationId="{2F321AA7-FA08-41DB-A777-1D0AEB090FF9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61" creationId="{4C550E8E-13D2-4962-AE91-18F9AA12113A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62" creationId="{5345374B-8DA9-4B36-8CF4-A7177A11CDA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63" creationId="{BF69712A-1E15-4E9B-B8E0-A6DD6C2441C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64" creationId="{F76FF7DF-F1D8-4146-A0A6-500FAA160F0F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65" creationId="{3EA99DA7-5CA3-49B6-AFA5-C43C77B49FC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66" creationId="{2325348E-0D3B-4C2C-8093-6F05304D1EE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72" creationId="{7C4AA62A-F609-4667-AB00-2568FD54F59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73" creationId="{8447F268-EA4B-4B0A-A106-51768D55181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74" creationId="{AC0704E1-CC2B-446D-A84E-5C4D1EFE5F8B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75" creationId="{60D35598-CC6C-4378-BF4F-2F54DD062BE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77" creationId="{F1074963-23B7-4E00-8B89-CFA528F26C26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78" creationId="{255688E1-B537-4ECA-B537-9137CD74F79A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79" creationId="{536E8835-6B97-41C6-955C-0D8A5EB32A8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80" creationId="{FA357091-9440-4651-9F04-4F963346E973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81" creationId="{BC1EE3D3-924D-4348-BC9F-167038B7A3FA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82" creationId="{2243473B-27B1-4B97-AB8F-D77FDDC651A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83" creationId="{057AC87D-7F13-43B8-9816-EDD58EF7F9F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84" creationId="{DCBD0304-92CD-44B7-B298-C6D14D6DB64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85" creationId="{C7A1E1FB-6A0C-4296-A564-89C4DEFC5DC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86" creationId="{B92B7801-254E-43F0-BBF9-B46501B0CF3B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87" creationId="{00CD9709-4715-4F99-BCEC-23D8D25FAD7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88" creationId="{E2F12373-A353-4E9E-9D25-D2980581F249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89" creationId="{C16C9C80-805D-4E2B-A803-050E00DABCC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90" creationId="{E562D2CF-35DE-4DA8-958A-0BC3A0CC57A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91" creationId="{5332310D-EA2D-4C9B-AB30-F662EA6EA3D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92" creationId="{F019E0DE-E16D-4178-A10E-A9C26E163DD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93" creationId="{87B44412-120C-4F3F-815B-675712DE2C8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94" creationId="{F10F3572-FBD5-47D3-8260-643AA83E337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97" creationId="{10F334FD-8279-40C0-AA64-D35896CD899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98" creationId="{E167170C-8C83-4274-B649-430FB9FCC5FB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199" creationId="{62D30557-47C6-48B7-A5F2-8932EF85230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00" creationId="{20919721-F5F0-497C-9A2D-D2AA36D6C510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01" creationId="{9ED32479-AC21-44AD-B1C4-D393C100A79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03" creationId="{4DD3273B-80CE-40F8-8785-329F3E0F42B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05" creationId="{C6504DA6-8AD4-4106-A340-0C03D03A78F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07" creationId="{C72CC299-B4E0-471C-B37B-57DC5C314B4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09" creationId="{405335B3-7D93-4888-927E-200617C45B5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10" creationId="{0E9F6091-FED8-478D-9BB4-AFDD590CAA4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11" creationId="{74C48D2D-2377-4552-AF6E-E137EE99909F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12" creationId="{23214730-4FF7-4166-B65A-6E4A5C604E0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13" creationId="{5C08A2CA-817C-44F6-A7B2-A1F648E646E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14" creationId="{32FD97AC-F391-4823-99B0-A82E6E9D38A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20" creationId="{646C7AB3-D6EB-4A9B-B3F8-2AD293FAD74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21" creationId="{F20C94BE-D6C5-41FA-B2D8-A5F11CD4102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22" creationId="{1260459F-A303-419F-90A2-1FDA51A58A3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23" creationId="{EB67FBE3-44C9-4312-8774-C340877B843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25" creationId="{EA2EDF23-2AF7-4255-90F3-45846F0FC1C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26" creationId="{E9D1A3D2-1A15-4835-A5F1-77FD550D5CB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27" creationId="{32A4F228-4530-4BA4-A1BB-45F2584E651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28" creationId="{2267A3E0-484E-4D58-8926-5D61CD6F14E0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29" creationId="{E244A61E-4FF2-4741-B599-13E5C088F9B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30" creationId="{4FA8C592-A609-448A-917E-BA250920A24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31" creationId="{4F7823A8-5367-484A-B927-14579AB9881A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32" creationId="{D1623A91-D9D7-4853-8936-739E62E389D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33" creationId="{3522041B-F233-45C0-9596-C7B0DC38772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34" creationId="{66658535-2858-48B0-B350-CB4115CE982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35" creationId="{0A14A566-EF2F-4BB3-8D27-D1F789D105B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36" creationId="{0A008C8A-4200-4A5D-BF74-16C99495B970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37" creationId="{DC6436A1-77CA-46FE-8F3B-1F5636EE6BF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38" creationId="{A47EEC22-5E55-4313-B9CA-869CC03388D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39" creationId="{303FAF61-2610-4FF5-897E-F38765F0686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40" creationId="{A0677D65-796E-4CCE-891C-B52CBB2F93E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41" creationId="{EEDF8FE0-FB60-459C-A467-01A18BF4670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42" creationId="{1563A960-47ED-4C9B-8896-3530F0E8C10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45" creationId="{A819FC11-CC44-4DF1-9147-19E4626E65F3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46" creationId="{68DBF8D2-9479-4CD8-BD6C-EBB40D6868D3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47" creationId="{C27F3F08-7A73-44CF-84CD-F785CF96171A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48" creationId="{2E20D481-1BDC-4450-B96D-53937C3B973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49" creationId="{09E2D10A-7D3C-484A-B386-516C4D05CDB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51" creationId="{B45011E9-FFA2-4360-A266-A35CA05F9F4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53" creationId="{D9961907-070E-4C53-AE00-4046B52531EB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55" creationId="{595DFED2-D0FD-4CC8-9AB0-0B5169C1B7C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57" creationId="{96ED2C96-0FAD-4325-B7B6-219A2F4499FC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58" creationId="{EB03AE5A-E996-4992-9A3D-C0CA19FCDFA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59" creationId="{A0EAAE3F-70AA-4B27-B8BD-4E51833555CA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60" creationId="{4E819B02-28C2-4E7C-9F37-9B683E81797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61" creationId="{09D5DDDD-76A0-40E9-BDAA-6E66B8665B7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62" creationId="{1F7E9D15-6134-47B9-9374-CD8C84ACAD6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68" creationId="{523EBAC2-F184-4541-B3B7-0F03B0CA801B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69" creationId="{F3ED45F2-6AF0-4AC7-8E6F-8AB4DAF65B8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70" creationId="{AB438505-BA7E-4BF2-88C7-D54C6401B1C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71" creationId="{AD886A44-3877-4BC9-B45C-851D29F6090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73" creationId="{5B5E0966-097A-4DE6-B280-0D714FC4FBB5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74" creationId="{C2F5FD86-D8AC-4430-B342-3C21969CCE4B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75" creationId="{953DDDFA-44C5-43E9-95B9-4FEEEEBA1800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76" creationId="{233B0143-D8A3-4064-AE3C-C58294BF1D3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77" creationId="{9E0EB14C-0950-43D1-A569-214204714B3D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78" creationId="{D8DF5FCC-E004-4F51-963D-E45A833204F4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79" creationId="{D039314E-50A6-43B4-BF01-AC20D3C2A59F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80" creationId="{9EC556DC-84D0-4108-8038-0B13DEDB701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81" creationId="{9C4D37DB-FAFE-435C-B7E7-E6C37375FB16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82" creationId="{4942C5A9-5673-4320-8689-B1E160905EEA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83" creationId="{3EEA1190-7A74-421B-B228-AE7D008211B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84" creationId="{26390D55-EAA4-40A9-85C5-394BCE0B247E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85" creationId="{912D140C-D1DD-41ED-8D95-4D097FC14F43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86" creationId="{DD2CADAB-8661-46B7-8954-005AE4005A91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87" creationId="{CE09CEE7-A61E-4916-98D6-5D8838D2ECD2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88" creationId="{F8611AD0-DF24-441F-A257-9EE9D991F707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89" creationId="{BA9CD32A-5FFD-4A06-B809-5CE3A5F301F8}"/>
          </ac:spMkLst>
        </pc:spChg>
        <pc:spChg chg="mod">
          <ac:chgData name="Filippo Acconcia" userId="844af49c-a8a0-47ac-a7dd-14a44b60cd18" providerId="ADAL" clId="{4E01D738-D0C1-4B9B-B836-CF053EEC4C53}" dt="2022-03-16T08:15:38.736" v="407"/>
          <ac:spMkLst>
            <pc:docMk/>
            <pc:sldMk cId="2335018827" sldId="302"/>
            <ac:spMk id="290" creationId="{43FBF6DB-825D-4183-A1CE-07C416643C88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293" creationId="{6C665057-0B4D-4024-9808-E18D5B6AED6E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294" creationId="{670E918C-EF98-4157-A1D6-CECF9F4A3C25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295" creationId="{1558BDF1-94A2-466B-BE94-0D078ABEA2D0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296" creationId="{349CFA50-50A2-4AC4-8BAF-A0AC12EC307F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297" creationId="{3F1A09CE-ECB0-4214-B4BA-0D006E45393C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299" creationId="{05F3EA6B-47E9-40B3-9EDE-8EF40015DAE7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01" creationId="{1D35CA4F-F9A2-48A3-A0E7-C8778DDB64F6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03" creationId="{ACC4F661-B8DA-4387-8FBD-0BED3467FFCB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05" creationId="{0B358572-792F-4247-B088-4E6B380CFDDA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06" creationId="{9CCBA469-7E8E-4F1F-B12E-33CC645C8960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07" creationId="{D7094199-059C-49C1-9E7A-13950DEBCD3C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08" creationId="{DB8C24F2-A5C9-49E3-9D00-F1E5BAD047BC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09" creationId="{D5AAB84C-F8C1-436E-994E-1CCE7D718A51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10" creationId="{EB5D93CA-C0CB-4B38-9E6D-ED8AE75A34AE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16" creationId="{4EB52646-2478-4079-984D-15936BA651DB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17" creationId="{7EFFBF7F-6376-4A7E-9BF4-0BB1D30B8639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18" creationId="{19BF59FB-AB92-4F02-9F91-C17D2B285D4F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19" creationId="{46CBD84F-C335-42DE-BC7F-CC57E593C2B8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21" creationId="{16C631D4-B498-4978-80AD-DB9A446649A4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22" creationId="{499573F8-0DBF-4B56-A7D0-B91FE7915127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23" creationId="{AA7BCF41-0687-4955-8945-335C4BB99CDE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24" creationId="{4C498107-71CC-4DD3-AACB-A74ABA866BA2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25" creationId="{158660F0-72E4-4A95-A2F3-26457ECB4807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26" creationId="{EE1743AB-12EA-419E-911E-DD1E68D461D4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27" creationId="{E5EE6C49-8186-438E-A9F1-B059747E034B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28" creationId="{6BFE6E0D-AE85-4C97-9705-4BE9D41CF689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29" creationId="{8F197231-98E3-4758-8139-699541B367CA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30" creationId="{1B87D398-4AEC-4242-B0E6-276EB7495F26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31" creationId="{562BE7A4-E32C-45AA-94EE-40875DE2A780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32" creationId="{BEAAC004-E7DE-44F8-A86F-C588FAE36217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33" creationId="{24A11F3F-4E5C-4919-BE1C-24FD0CFA2381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34" creationId="{B043ABEB-3078-42CE-BED7-13D46E976883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35" creationId="{B5DED8BC-867E-4293-96E7-FE08A287783B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36" creationId="{D1604F53-4DE5-485A-8D49-5C5E1E9A854F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37" creationId="{7D63CE86-D0F4-461C-AC26-2BCBF47ED7FA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38" creationId="{D4DD0345-942A-4C49-AF63-A516FF839B44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41" creationId="{DE4CBF96-C136-4929-AB77-A44047984E7F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42" creationId="{0C4D62EB-BA81-44BA-AD74-77A86287BF60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43" creationId="{40C7EFAD-74E2-4BA2-BA61-20F2ED991AC2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44" creationId="{EF6BFC77-49EE-4C91-B33D-D7057B104C52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45" creationId="{E38A0102-C7A2-4113-B31B-3C0846626033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47" creationId="{DD22D288-5E53-4E77-B633-C75F0460178A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49" creationId="{2399369E-3F12-4151-B992-1643E0AC6E48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51" creationId="{469C9D53-0CCE-44DE-9820-DEB64E180A0C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53" creationId="{8E47D9EA-77DD-40C2-A9D9-4F9C56F8F34F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54" creationId="{80DCED84-2258-4A42-9407-796C936B1593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55" creationId="{CE174C5F-2FF1-46CA-989E-BED511D21E99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56" creationId="{88B5949E-7610-4C68-A1AB-462A0D65D3BE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57" creationId="{8E9AD559-6DFF-4E64-9BE0-46D962388872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58" creationId="{C6636A09-F3BD-4AC0-BACD-7168D02540E9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64" creationId="{97A68ED3-868F-48CF-9640-C91AD6EE82A2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65" creationId="{70CC4261-6CE1-4B98-8958-7B78F945B43B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66" creationId="{C4980A9D-76EB-4AA5-A3EC-DB32639B2161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67" creationId="{039AD9B5-6C13-4568-A76E-426B064196BA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69" creationId="{655EEE4F-0DDE-4F05-AEE9-3958512C0E65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70" creationId="{E88D2154-67B4-4461-BADD-B844BCA0DE85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71" creationId="{2BA8F6E8-6CBA-49FE-9C99-1C00B98C286D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72" creationId="{2D04B6E4-603D-40AF-8945-BA4956453165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73" creationId="{05BD1C34-59CD-4B52-B09E-F32D94E121F7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74" creationId="{D18D4285-3058-4A4D-BC0E-1F548F4253B6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75" creationId="{779D3854-0E8A-498F-8FD1-87979290E888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76" creationId="{1D1B09AD-085B-420B-BE56-F4E5CE6583F0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77" creationId="{62B203EA-CDA2-413F-B92E-F67A276C688B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78" creationId="{6EAD2476-E9B9-443B-B796-D3B6C5C5809C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79" creationId="{7CFBE935-1CCC-4AB8-B106-E869DDF56C1B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80" creationId="{DA66852E-766C-47BB-A5C2-2CF3ED84E661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81" creationId="{D1D02F3E-92B1-405B-B380-DD2815A63F56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82" creationId="{A56664EC-2989-4257-863E-CC78AD038C48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83" creationId="{D928B27E-B654-49FD-8B66-62F400EB91CE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84" creationId="{DF5506F9-7B1D-4911-810F-72E0FEA11B6B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85" creationId="{B5B2F2E3-5486-4604-8CA2-832DEF885874}"/>
          </ac:spMkLst>
        </pc:spChg>
        <pc:spChg chg="mod">
          <ac:chgData name="Filippo Acconcia" userId="844af49c-a8a0-47ac-a7dd-14a44b60cd18" providerId="ADAL" clId="{4E01D738-D0C1-4B9B-B836-CF053EEC4C53}" dt="2022-03-16T08:15:51.080" v="410"/>
          <ac:spMkLst>
            <pc:docMk/>
            <pc:sldMk cId="2335018827" sldId="302"/>
            <ac:spMk id="386" creationId="{32456109-288B-4225-8E7B-CDB416A798D6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389" creationId="{D6CD130D-76D2-4ED9-B253-D702455B351A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390" creationId="{06F65BD3-9496-4327-8FD4-42C4E9A8FEE2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391" creationId="{847BAA29-5A76-44C4-A05B-D86FA7AF0797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392" creationId="{39E80366-1101-4F2C-8510-219B15E34C5F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393" creationId="{B59C1997-8C7F-4155-B550-DBD36B0410D4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395" creationId="{B5C1DCD4-8018-4E36-B178-C553741748DD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397" creationId="{48166DC8-D722-40AD-A880-B61A9CA9228B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399" creationId="{82F103D9-E549-4D10-8870-EB5CC3458E58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401" creationId="{6F2001C1-4F00-4BAD-B734-C966226873F7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402" creationId="{F1B69D0C-2A37-42C2-B18C-82645154D63C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403" creationId="{3CC04BE0-CA7B-428C-813C-43C62667C448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404" creationId="{7BBE2406-145B-4A74-BA37-5223B15DD774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405" creationId="{6198F5B4-8479-4F2F-8EBE-55F5193B3CC9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406" creationId="{425C79CA-E756-47EB-B3CF-40F9518BB929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412" creationId="{F852F2BD-CE20-4496-8DAD-DAAE2555AF7E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413" creationId="{8107D37F-FEAC-4A6B-B504-05D2E3D9B725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414" creationId="{3ADC988F-0CBA-47AF-A0F2-3AF97931D75C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415" creationId="{9CE8D511-A1BF-4342-B984-246942855E7A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417" creationId="{53024E97-FBF7-47F0-A2A9-978B4D0DCB8E}"/>
          </ac:spMkLst>
        </pc:spChg>
        <pc:spChg chg="del mod topLvl">
          <ac:chgData name="Filippo Acconcia" userId="844af49c-a8a0-47ac-a7dd-14a44b60cd18" providerId="ADAL" clId="{4E01D738-D0C1-4B9B-B836-CF053EEC4C53}" dt="2022-03-16T08:40:03.920" v="773" actId="478"/>
          <ac:spMkLst>
            <pc:docMk/>
            <pc:sldMk cId="2335018827" sldId="302"/>
            <ac:spMk id="418" creationId="{520478BB-DB3B-4B58-9BEA-C83E6CDF985D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19" creationId="{AE582CC0-002B-4C61-B050-9995AFE1058A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20" creationId="{6425AD9D-916C-4FEC-93E6-F3B8F942B41B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21" creationId="{305A2736-184D-441C-8D06-E7CE10319067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22" creationId="{AFD8FE72-FE57-4293-AFF6-E65CF818A340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23" creationId="{91032D50-77CA-44C1-8748-A3C4D718EACE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24" creationId="{C88E40A7-62A0-4A88-98DF-6F32098C0953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25" creationId="{AB417694-E7FA-45D4-B2EF-B09C1C1C90D1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26" creationId="{F887703F-37AF-4C00-A305-B84F461FCBA1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27" creationId="{C0152A62-E022-4798-BC16-6B60099B1945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28" creationId="{A53A8860-1F2B-4B2C-80D7-8D52640DF077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29" creationId="{40ABBC68-08E5-46DA-9B23-7A2928ED331D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30" creationId="{FFDA3E74-E272-43B0-BCB7-452DB4ECB8BD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31" creationId="{E37C30B7-5C6B-4D3D-9714-7176F90AEE4E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32" creationId="{87CF41E3-F3BA-4E51-BB8F-82A842D83DEA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33" creationId="{73786C29-67FC-4380-B890-915DD35CCB04}"/>
          </ac:spMkLst>
        </pc:spChg>
        <pc:spChg chg="mod topLvl">
          <ac:chgData name="Filippo Acconcia" userId="844af49c-a8a0-47ac-a7dd-14a44b60cd18" providerId="ADAL" clId="{4E01D738-D0C1-4B9B-B836-CF053EEC4C53}" dt="2022-03-16T08:36:10.502" v="759" actId="165"/>
          <ac:spMkLst>
            <pc:docMk/>
            <pc:sldMk cId="2335018827" sldId="302"/>
            <ac:spMk id="434" creationId="{544EC8CD-A9AC-4932-BC42-EFA5DF5AA893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37" creationId="{DC5C54B7-47D6-42F2-8CC1-BA6EFADDCFFC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38" creationId="{BA69F849-AB6A-43E8-8EAC-86429E318B4C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39" creationId="{37A37B55-62AF-4D21-922A-EB6EA6F62083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40" creationId="{0774BD0E-E60E-43CF-8065-02075F5ED3C9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41" creationId="{7A69EFB7-3C97-483F-B211-6B1DB5F8D831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43" creationId="{EB99D2EB-EB1A-4F4B-A5BF-020BE21B1448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45" creationId="{758C4386-5F85-4E5E-A600-3055B99B95F8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47" creationId="{30A8B3CC-0978-4E7A-AA40-8950219D75DF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49" creationId="{23A7589F-7990-4AE7-B0EB-7DE9142ABE16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35018827" sldId="302"/>
            <ac:spMk id="450" creationId="{F3FFC8C9-EA93-4C0F-9E19-1E4CE6A4E80D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35018827" sldId="302"/>
            <ac:spMk id="451" creationId="{D3DD416E-47E1-4C33-97B2-0EBF4A845996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35018827" sldId="302"/>
            <ac:spMk id="452" creationId="{DD497DDA-0CD4-46F0-9E91-3C0FDBBE98EE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35018827" sldId="302"/>
            <ac:spMk id="453" creationId="{CB9DF6B4-1DEF-40C3-A212-80E700DF68C8}"/>
          </ac:spMkLst>
        </pc:spChg>
        <pc:spChg chg="mod">
          <ac:chgData name="Filippo Acconcia" userId="844af49c-a8a0-47ac-a7dd-14a44b60cd18" providerId="ADAL" clId="{4E01D738-D0C1-4B9B-B836-CF053EEC4C53}" dt="2022-03-16T08:36:49.134" v="766" actId="20577"/>
          <ac:spMkLst>
            <pc:docMk/>
            <pc:sldMk cId="2335018827" sldId="302"/>
            <ac:spMk id="454" creationId="{8821AE19-412D-4ED6-9061-1389D2F75701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60" creationId="{1E0B61FA-EA2E-49F4-AB8C-8E8ECC8AFF36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61" creationId="{2B1A3D92-3431-4482-91BB-D6C1858BF111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62" creationId="{47CD077B-C25A-4FE2-A744-59F78270AB3C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63" creationId="{38308F4F-F4E7-49AD-82FF-DE0F80B923F7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65" creationId="{F1A60668-C1F2-4ECA-AB88-D36BDF604B00}"/>
          </ac:spMkLst>
        </pc:spChg>
        <pc:spChg chg="mod">
          <ac:chgData name="Filippo Acconcia" userId="844af49c-a8a0-47ac-a7dd-14a44b60cd18" providerId="ADAL" clId="{4E01D738-D0C1-4B9B-B836-CF053EEC4C53}" dt="2022-03-16T08:36:56.366" v="772" actId="113"/>
          <ac:spMkLst>
            <pc:docMk/>
            <pc:sldMk cId="2335018827" sldId="302"/>
            <ac:spMk id="466" creationId="{E7926B6D-3BAE-4292-92B9-56CD4D15EBB9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35018827" sldId="302"/>
            <ac:spMk id="467" creationId="{BABE128C-0588-4491-9A10-6E9A34AC3C1C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35018827" sldId="302"/>
            <ac:spMk id="468" creationId="{516626C0-A544-4101-BA57-A2AD6570AB00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35018827" sldId="302"/>
            <ac:spMk id="469" creationId="{0BF0961E-74EB-48F0-9FD0-22C1324B9CCD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35018827" sldId="302"/>
            <ac:spMk id="470" creationId="{272F6362-D813-4E5A-B8C1-E4EFBBF2A703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35018827" sldId="302"/>
            <ac:spMk id="471" creationId="{A03A353D-A228-4481-8802-AF62CB161B5A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35018827" sldId="302"/>
            <ac:spMk id="472" creationId="{8968AD23-D424-45C7-AC4A-B2B88AFED8CB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35018827" sldId="302"/>
            <ac:spMk id="473" creationId="{16321E00-4EA4-4ABE-87C7-54653A3FE66D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35018827" sldId="302"/>
            <ac:spMk id="474" creationId="{84EEF6CC-FC05-4188-B58F-B49F2576909B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35018827" sldId="302"/>
            <ac:spMk id="475" creationId="{7E1F50CC-1F24-4282-B890-B11077C0CA9D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35018827" sldId="302"/>
            <ac:spMk id="476" creationId="{8CDDF367-0BBC-4984-AC2D-8EB21ABF086D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35018827" sldId="302"/>
            <ac:spMk id="477" creationId="{606D4BA7-2ABC-4DBC-AE76-B1C03BAA9CFC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35018827" sldId="302"/>
            <ac:spMk id="478" creationId="{8783D62A-D8D9-40E9-A2F8-A44F92A3D846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35018827" sldId="302"/>
            <ac:spMk id="479" creationId="{38C9C1E0-68AC-4534-BEC0-5E8847C43CDE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35018827" sldId="302"/>
            <ac:spMk id="480" creationId="{2C5360AF-E409-45FB-B166-0725302004C0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35018827" sldId="302"/>
            <ac:spMk id="481" creationId="{0C3AA0D3-2123-4390-9DA5-C11AD70D3054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35018827" sldId="302"/>
            <ac:spMk id="482" creationId="{9A124497-EF35-4B12-A69F-F6635B714495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85" creationId="{A9C6668B-5F2B-4AEF-88D7-E2EB07388482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86" creationId="{63F0F1A6-F0DB-4BEB-84AC-119F03F89FAE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87" creationId="{0B4AD14A-ED0B-4946-9F57-CD8B2F6E0B2C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88" creationId="{08DA5657-8155-448D-B07E-47E2E0E920C8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89" creationId="{CE9D4182-ED20-429F-BC25-459E5E84B040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91" creationId="{8C1F5B8E-FC9F-4F56-9962-095535EFEDCF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93" creationId="{5C054D93-FCB5-40D8-AFF7-59D24047FE64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95" creationId="{F78D3EEB-6020-4AFA-96F5-76C0C95C3209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497" creationId="{9A210DAB-3203-426F-8E89-301323A4B2B8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35018827" sldId="302"/>
            <ac:spMk id="498" creationId="{2F4DB730-365A-4F41-8F29-DE8B71001D0A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35018827" sldId="302"/>
            <ac:spMk id="499" creationId="{294566EB-3110-4744-922D-F0E1CFF747BA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35018827" sldId="302"/>
            <ac:spMk id="500" creationId="{E52F0560-C887-4D43-B4BF-C1887438FC25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35018827" sldId="302"/>
            <ac:spMk id="501" creationId="{303502CB-9600-43F9-A80F-616E40A1FF0F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502" creationId="{E0EBB62A-6D4E-4101-9E5F-4C0751D37636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508" creationId="{D648EB8E-86A0-4574-99A2-B8195AE1754F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509" creationId="{996DC70F-5051-4B09-B1E4-7770D7FF3888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510" creationId="{D4C97358-8A5F-4164-95EF-515F9095A4E6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511" creationId="{72F9E44E-E618-4E18-A70F-DEE035D2715C}"/>
          </ac:spMkLst>
        </pc:spChg>
        <pc:spChg chg="mod">
          <ac:chgData name="Filippo Acconcia" userId="844af49c-a8a0-47ac-a7dd-14a44b60cd18" providerId="ADAL" clId="{4E01D738-D0C1-4B9B-B836-CF053EEC4C53}" dt="2022-03-16T08:16:14.931" v="417"/>
          <ac:spMkLst>
            <pc:docMk/>
            <pc:sldMk cId="2335018827" sldId="302"/>
            <ac:spMk id="513" creationId="{8F5EDC6E-634B-4EA3-8A2B-F1DA57248D53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35018827" sldId="302"/>
            <ac:spMk id="514" creationId="{7313E01D-6509-4765-A086-D671F29124DD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35018827" sldId="302"/>
            <ac:spMk id="515" creationId="{ADB8CECC-2C1B-40F0-9CD1-29977F7871C8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35018827" sldId="302"/>
            <ac:spMk id="516" creationId="{D9DDC507-1A95-44EC-B908-E1F15A241B4C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35018827" sldId="302"/>
            <ac:spMk id="517" creationId="{30806633-7DFF-4CFB-8E35-08E51689C3C1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35018827" sldId="302"/>
            <ac:spMk id="518" creationId="{E8ABA814-D009-47E1-BEC7-D46D576F18BC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35018827" sldId="302"/>
            <ac:spMk id="519" creationId="{DB9DC98C-E6EE-4B63-8212-4F74DD482A51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35018827" sldId="302"/>
            <ac:spMk id="520" creationId="{2B2897D9-F136-4038-B7D9-A212D7FDD762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35018827" sldId="302"/>
            <ac:spMk id="521" creationId="{78ECBB2B-AFFC-4172-8FA4-1ADFC7646814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35018827" sldId="302"/>
            <ac:spMk id="522" creationId="{6611695F-70FD-4DED-9B49-A79FE75A0935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35018827" sldId="302"/>
            <ac:spMk id="523" creationId="{C33A7ECF-E6FC-44B9-B753-8A250679192C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35018827" sldId="302"/>
            <ac:spMk id="524" creationId="{DE2B12A5-F030-4EEB-BD9A-5EE780702DF8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35018827" sldId="302"/>
            <ac:spMk id="525" creationId="{545287C4-2ACF-4F1A-ADD4-22275D283EA2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35018827" sldId="302"/>
            <ac:spMk id="526" creationId="{75E78F43-D656-4BCD-BD4B-94ECDA2F3FD2}"/>
          </ac:spMkLst>
        </pc:spChg>
        <pc:spChg chg="mod">
          <ac:chgData name="Filippo Acconcia" userId="844af49c-a8a0-47ac-a7dd-14a44b60cd18" providerId="ADAL" clId="{4E01D738-D0C1-4B9B-B836-CF053EEC4C53}" dt="2022-03-16T08:35:59.242" v="755"/>
          <ac:spMkLst>
            <pc:docMk/>
            <pc:sldMk cId="2335018827" sldId="302"/>
            <ac:spMk id="527" creationId="{EF94C705-3FAB-44E5-BA0E-0DFA8833CCE1}"/>
          </ac:spMkLst>
        </pc:spChg>
        <pc:spChg chg="mod">
          <ac:chgData name="Filippo Acconcia" userId="844af49c-a8a0-47ac-a7dd-14a44b60cd18" providerId="ADAL" clId="{4E01D738-D0C1-4B9B-B836-CF053EEC4C53}" dt="2022-03-16T08:35:41.714" v="754"/>
          <ac:spMkLst>
            <pc:docMk/>
            <pc:sldMk cId="2335018827" sldId="302"/>
            <ac:spMk id="528" creationId="{E5853219-1F7C-4785-ADE3-3EF82D532815}"/>
          </ac:spMkLst>
        </pc:spChg>
        <pc:spChg chg="mod">
          <ac:chgData name="Filippo Acconcia" userId="844af49c-a8a0-47ac-a7dd-14a44b60cd18" providerId="ADAL" clId="{4E01D738-D0C1-4B9B-B836-CF053EEC4C53}" dt="2022-03-16T08:35:31.402" v="753"/>
          <ac:spMkLst>
            <pc:docMk/>
            <pc:sldMk cId="2335018827" sldId="302"/>
            <ac:spMk id="529" creationId="{AE57E905-4A4B-4C61-96F9-9CBB90E7C7C8}"/>
          </ac:spMkLst>
        </pc:spChg>
        <pc:spChg chg="mod">
          <ac:chgData name="Filippo Acconcia" userId="844af49c-a8a0-47ac-a7dd-14a44b60cd18" providerId="ADAL" clId="{4E01D738-D0C1-4B9B-B836-CF053EEC4C53}" dt="2022-03-16T08:35:17.053" v="752"/>
          <ac:spMkLst>
            <pc:docMk/>
            <pc:sldMk cId="2335018827" sldId="302"/>
            <ac:spMk id="530" creationId="{25550243-5778-447F-B4AE-9220F442C696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34" creationId="{CA836182-8E4C-4322-BB13-DE0509F74950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35" creationId="{85C85E81-E475-4E6F-B746-196FA8177178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36" creationId="{646055CD-52C5-4212-90B6-239FA020D886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37" creationId="{7E10F50C-9285-446B-AEE7-6F03EA46FD10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38" creationId="{40E2D885-ACB8-442E-9FFB-93DDB49F783B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39" creationId="{3AB89551-E8D4-4502-964A-3F68DA96C1D1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40" creationId="{8F707A4A-7C61-47E1-8A2B-5A7003B7FCE7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41" creationId="{DAAF4BEF-1A8A-4230-BE63-51137A4BA7BF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42" creationId="{5537EFA8-22E1-4F5C-9DB0-C8E9C8FA4F0F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43" creationId="{4B07BB2E-CA81-4FF3-9AD6-CCA2620EDA6C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44" creationId="{7BDA8293-3346-4B02-984C-B5F56208F9A2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45" creationId="{D795A4EF-CE43-4C8A-B162-964027CAAFC8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46" creationId="{03E12725-B193-4422-AF83-8C955FDA8E03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47" creationId="{A007CC5A-4ACB-4251-A35A-0FFEC9006C92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48" creationId="{906E6E06-423F-4358-B972-6072E4DA4174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49" creationId="{D3DB3FA2-1455-4396-9FBB-901BAECA1AAC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50" creationId="{F2026D6A-4954-43B9-AE4A-E67C2B8107A2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51" creationId="{AAC2D11E-32AB-48F3-A5E0-1F22D54041A6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52" creationId="{47DD5080-2F9D-4459-BC3B-6698E6409CC6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53" creationId="{93A79475-B35B-48F2-9EC9-5C26986A66F5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54" creationId="{796833AE-CC9A-4918-B478-1E15FE39A820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55" creationId="{FF80CF12-390A-4604-94BD-D445CD584D1E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56" creationId="{0A391A7C-57B4-4BCF-9350-81B57D4C27A1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57" creationId="{5E56B103-613B-4ACB-9DC0-05B379EF73B2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58" creationId="{E701F582-5C45-4F49-B62B-3BB3363E7E68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59" creationId="{ED637667-19E6-458F-AC4B-0D5C8CDA6835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60" creationId="{F924D9C3-BD53-480B-ADF5-04C71B4D7076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61" creationId="{9BEFC0AB-C4F5-4D44-A54C-32FBB859A077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62" creationId="{A661DF9B-D063-4D3F-A50B-ACDB178AC973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63" creationId="{3A9656F0-0BA9-430B-885F-57C7D68C8038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69" creationId="{D4DC2AD2-FE4A-475A-BCFA-09B37D015E4C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70" creationId="{51F73A60-7493-4561-9E16-C5C05BEEEA23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71" creationId="{1B3278AE-011F-47B4-AF47-8E3D16A8AF7D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72" creationId="{3853A2E1-790E-4093-80B5-AF1FF44A9162}"/>
          </ac:spMkLst>
        </pc:spChg>
        <pc:spChg chg="mod">
          <ac:chgData name="Filippo Acconcia" userId="844af49c-a8a0-47ac-a7dd-14a44b60cd18" providerId="ADAL" clId="{4E01D738-D0C1-4B9B-B836-CF053EEC4C53}" dt="2022-03-16T08:40:05.670" v="774"/>
          <ac:spMkLst>
            <pc:docMk/>
            <pc:sldMk cId="2335018827" sldId="302"/>
            <ac:spMk id="574" creationId="{B375F4B2-3821-4488-B967-7A9FF47CCE84}"/>
          </ac:spMkLst>
        </pc:spChg>
        <pc:spChg chg="mod">
          <ac:chgData name="Filippo Acconcia" userId="844af49c-a8a0-47ac-a7dd-14a44b60cd18" providerId="ADAL" clId="{4E01D738-D0C1-4B9B-B836-CF053EEC4C53}" dt="2022-03-16T08:41:18.905" v="800" actId="1037"/>
          <ac:spMkLst>
            <pc:docMk/>
            <pc:sldMk cId="2335018827" sldId="302"/>
            <ac:spMk id="575" creationId="{9A64B2E8-A524-4D01-9510-E936BE777123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78" creationId="{A3F74C7B-49EA-48B3-9BD9-00722578AFA3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79" creationId="{1F03AFA5-5FA6-4BB3-B5D0-7FBF7FFAA007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80" creationId="{6A1B7071-35C7-4FF1-A2E1-A2E43BD9F53F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81" creationId="{B603EC2C-5752-4BC0-9C48-1F5737D3B721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82" creationId="{103615C6-33E5-4A01-8F8D-789C0C244CB5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83" creationId="{F5723645-033A-4215-ABA6-A8CF8AC8AC89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84" creationId="{BCEDE46F-4EBD-41B5-AFE6-9FACF6776D04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85" creationId="{277D8E70-6575-4A7D-A2A0-6D4D65439D7D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86" creationId="{BFC383B3-38E0-4E1D-8FBA-624B252EE2C4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87" creationId="{F986337F-A07C-496A-BB2E-A88D0F865131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88" creationId="{1F8E59DA-7059-4C2E-9D0D-71F3168E6FF3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89" creationId="{0034A421-0F78-48A2-8C47-E853C87E3787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90" creationId="{AF6DEE7F-0D53-4DD5-BB87-A8DE71959C84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91" creationId="{2967C632-0B27-4E09-8BA8-9291E4DAF61B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92" creationId="{4635BC04-83C4-44B3-8C11-48EC34164B67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93" creationId="{4C527652-EFC8-45F4-9092-D4C63ED2FBE7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94" creationId="{AFEABBFF-8F8F-4581-9395-F9F98CD6D0F4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95" creationId="{45C2123E-0B17-4368-AE4F-BB5EB27E1142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96" creationId="{D1A90839-1148-413C-BBEB-7F4548EAA411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97" creationId="{19E4E7A9-836C-496D-8033-8F7EBAF5BEF3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98" creationId="{4C4D1C6B-A94A-4A52-85FF-11015B5ADC82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599" creationId="{8E7CCD5B-DBC9-4B96-8E87-92F330914529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600" creationId="{351AF5FE-6879-4511-962F-90CA7B47D51C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601" creationId="{D4C191C0-CB2F-474D-BA81-9AFE6062EFDD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602" creationId="{34B768BB-4B91-4E2F-97DB-2F2CAA6D60E0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603" creationId="{D9F95FC4-C208-4117-A107-CD313D407C22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604" creationId="{A3814CB8-A397-4F54-B422-36A68439C1F3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605" creationId="{EDB3E428-5D82-4F8F-98A6-92F76DEE51AF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606" creationId="{AA8FA861-A8D2-4BBC-99A7-08B18FED17AB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607" creationId="{5F1BF572-3CE9-421C-9737-9D505F038F20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613" creationId="{E1A41F39-704C-4742-8759-44B183672EA6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614" creationId="{D8AA8F34-8DF6-415C-9D85-A1DA5482B827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615" creationId="{4E15D0D9-4E66-4C7B-81CD-0ACF1779207E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616" creationId="{2D3EF69D-C198-4DDF-9F27-2C8052396B3B}"/>
          </ac:spMkLst>
        </pc:spChg>
        <pc:spChg chg="mod topLvl">
          <ac:chgData name="Filippo Acconcia" userId="844af49c-a8a0-47ac-a7dd-14a44b60cd18" providerId="ADAL" clId="{4E01D738-D0C1-4B9B-B836-CF053EEC4C53}" dt="2022-03-16T08:43:07.642" v="832" actId="1038"/>
          <ac:spMkLst>
            <pc:docMk/>
            <pc:sldMk cId="2335018827" sldId="302"/>
            <ac:spMk id="618" creationId="{227AD1C1-D34A-4E19-A4F7-F8873161CCD0}"/>
          </ac:spMkLst>
        </pc:spChg>
        <pc:spChg chg="mod topLvl">
          <ac:chgData name="Filippo Acconcia" userId="844af49c-a8a0-47ac-a7dd-14a44b60cd18" providerId="ADAL" clId="{4E01D738-D0C1-4B9B-B836-CF053EEC4C53}" dt="2022-03-16T08:42:22.602" v="831" actId="164"/>
          <ac:spMkLst>
            <pc:docMk/>
            <pc:sldMk cId="2335018827" sldId="302"/>
            <ac:spMk id="619" creationId="{55CD3976-C9A9-40FD-A612-441A43C9C693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24" creationId="{ED82B03B-E458-40A6-9E66-7A18DEC3FEB9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25" creationId="{8FFC123A-F9CB-439D-B7FF-DA091F856D4F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26" creationId="{93069D97-8F74-48FB-80B5-642302242216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27" creationId="{BF5E7729-96B6-4167-849A-703ADE566A92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29" creationId="{DCD45FD2-F210-4679-9CFC-7944FF3809D1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35" creationId="{0E8C5F0C-7D98-4B36-A492-E800C7FB3DA3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36" creationId="{D890609C-510C-454E-8D09-CDC9B3529082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37" creationId="{D8948756-9BBD-4CA2-9FA5-8F87083CFAB6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38" creationId="{11B75646-8B92-44A5-AD1E-B158FD098C30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40" creationId="{82F1F096-BC8F-4D59-AD41-1B39D2117F9F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41" creationId="{04D391D7-13E3-44B9-B2C1-C1A60B30BA6D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46" creationId="{7CF55756-4DA8-43FB-AE17-DBD54EA3C1E6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48" creationId="{9191C5B0-8515-4159-8AC7-1791B1E46756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49" creationId="{537E4774-8D49-42E4-8174-E4B79C9D5D7A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50" creationId="{1D903A1E-949E-44C2-984D-133AE316FF78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51" creationId="{162319D0-6074-4B18-8299-B955BCA2C8E4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52" creationId="{3C187B63-ED91-4978-834F-2E677F9E9037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54" creationId="{5B0A27B5-A21E-4417-82A5-678BE1AE1C8E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55" creationId="{DAFF8041-C662-4565-B8BC-A6A760D7EBFC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56" creationId="{E98F0E94-0C0F-47B0-ADEE-6F7BF6AC8BD6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57" creationId="{ED9B5E9C-E396-4CB0-A9C6-398F4D3A1BD1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58" creationId="{9B9951BD-D141-403A-BC04-046CFF2C8A89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60" creationId="{D29A38BC-B737-455A-BF5F-D310C6722D2B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61" creationId="{7C178CB7-BDF4-4D8A-A50A-B759028F88AE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62" creationId="{DC04CEE0-9203-4FA3-8F92-C619E2060142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63" creationId="{56847B7F-094F-43E2-BB57-0B338EC6DBDB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64" creationId="{567D9D6D-64EA-445E-AF7D-F275453B7319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66" creationId="{1FD5DA5D-BD04-4554-88A6-9883CBD107CD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67" creationId="{DEB16ECB-B6F5-4FD7-8471-FC33CFFC240D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68" creationId="{7718D6FA-7CCF-4C48-B6DC-D91ECA1F05C8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69" creationId="{44010134-A4A6-4EF1-87EF-F1D692E0CB16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70" creationId="{D552CA6B-EEE8-40B1-AA39-AC1E085E8874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72" creationId="{6FB314D6-F4B0-4D4D-9137-39938B94CF25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73" creationId="{049F8967-8B1E-4522-837F-B03A3808771A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74" creationId="{0D2A5F1D-B1BE-4EBC-BFD7-EE36E69E387D}"/>
          </ac:spMkLst>
        </pc:spChg>
        <pc:spChg chg="mod">
          <ac:chgData name="Filippo Acconcia" userId="844af49c-a8a0-47ac-a7dd-14a44b60cd18" providerId="ADAL" clId="{4E01D738-D0C1-4B9B-B836-CF053EEC4C53}" dt="2022-03-16T08:48:20.860" v="833"/>
          <ac:spMkLst>
            <pc:docMk/>
            <pc:sldMk cId="2335018827" sldId="302"/>
            <ac:spMk id="675" creationId="{3EDE07E5-92F8-4F3D-A3C3-65769DC37F63}"/>
          </ac:spMkLst>
        </pc:spChg>
        <pc:spChg chg="add mod">
          <ac:chgData name="Filippo Acconcia" userId="844af49c-a8a0-47ac-a7dd-14a44b60cd18" providerId="ADAL" clId="{4E01D738-D0C1-4B9B-B836-CF053EEC4C53}" dt="2022-03-16T08:48:54.058" v="899" actId="1036"/>
          <ac:spMkLst>
            <pc:docMk/>
            <pc:sldMk cId="2335018827" sldId="302"/>
            <ac:spMk id="676" creationId="{1F42CF4F-133F-48BE-97C6-6CC82A510D0F}"/>
          </ac:spMkLst>
        </pc:spChg>
        <pc:spChg chg="add mod">
          <ac:chgData name="Filippo Acconcia" userId="844af49c-a8a0-47ac-a7dd-14a44b60cd18" providerId="ADAL" clId="{4E01D738-D0C1-4B9B-B836-CF053EEC4C53}" dt="2022-03-16T08:48:54.058" v="899" actId="1036"/>
          <ac:spMkLst>
            <pc:docMk/>
            <pc:sldMk cId="2335018827" sldId="302"/>
            <ac:spMk id="677" creationId="{1C4FA949-6C2E-4A45-AA60-7F28B5E8A91B}"/>
          </ac:spMkLst>
        </pc:spChg>
        <pc:spChg chg="add mod">
          <ac:chgData name="Filippo Acconcia" userId="844af49c-a8a0-47ac-a7dd-14a44b60cd18" providerId="ADAL" clId="{4E01D738-D0C1-4B9B-B836-CF053EEC4C53}" dt="2022-03-16T08:49:09.033" v="934" actId="1036"/>
          <ac:spMkLst>
            <pc:docMk/>
            <pc:sldMk cId="2335018827" sldId="302"/>
            <ac:spMk id="678" creationId="{56A50454-E681-4BED-B0CC-5AA325F581D7}"/>
          </ac:spMkLst>
        </pc:spChg>
        <pc:grpChg chg="add del mod">
          <ac:chgData name="Filippo Acconcia" userId="844af49c-a8a0-47ac-a7dd-14a44b60cd18" providerId="ADAL" clId="{4E01D738-D0C1-4B9B-B836-CF053EEC4C53}" dt="2022-03-16T08:16:02.834" v="414" actId="21"/>
          <ac:grpSpMkLst>
            <pc:docMk/>
            <pc:sldMk cId="2335018827" sldId="302"/>
            <ac:grpSpMk id="3" creationId="{A558C1B6-ACBC-4556-9D08-0171246F2FC6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10" creationId="{61654210-79D7-47F1-93FA-ED58E41DE21C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12" creationId="{C1321944-6185-42F1-8638-22D139052D1D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14" creationId="{55804EE3-C4B7-42EB-937F-B2FB03E3E104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16" creationId="{A1C510E0-2F6F-4E57-BC33-E2E8A661952B}"/>
          </ac:grpSpMkLst>
        </pc:grpChg>
        <pc:grpChg chg="add del mod">
          <ac:chgData name="Filippo Acconcia" userId="844af49c-a8a0-47ac-a7dd-14a44b60cd18" providerId="ADAL" clId="{4E01D738-D0C1-4B9B-B836-CF053EEC4C53}" dt="2022-03-16T08:16:02.834" v="414" actId="21"/>
          <ac:grpSpMkLst>
            <pc:docMk/>
            <pc:sldMk cId="2335018827" sldId="302"/>
            <ac:grpSpMk id="51" creationId="{8D50443C-FE50-4EC9-87ED-F86BE4342A28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58" creationId="{E167D84D-CD71-4234-A6BA-52FE360043C0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60" creationId="{DBE096FF-1D56-41DD-8177-8629C5F55C74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62" creationId="{7D238087-37BE-493F-A39B-0630688DED7F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64" creationId="{5FDB8E03-74CE-4C8E-9B20-81D668DF0494}"/>
          </ac:grpSpMkLst>
        </pc:grpChg>
        <pc:grpChg chg="add del mod">
          <ac:chgData name="Filippo Acconcia" userId="844af49c-a8a0-47ac-a7dd-14a44b60cd18" providerId="ADAL" clId="{4E01D738-D0C1-4B9B-B836-CF053EEC4C53}" dt="2022-03-16T08:16:02.834" v="414" actId="21"/>
          <ac:grpSpMkLst>
            <pc:docMk/>
            <pc:sldMk cId="2335018827" sldId="302"/>
            <ac:grpSpMk id="99" creationId="{A4FD4ABA-F71A-487B-A3C8-D38A9B51C39C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106" creationId="{C377FF1C-E226-46F8-8C65-34228E3EF304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108" creationId="{7B2047C8-D803-4EFF-A8A9-C492220E139B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110" creationId="{5A30F987-2551-4C3A-9C79-FAAE14B439FE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112" creationId="{F08A8B01-CF3C-4CA0-86E5-263E597F43E8}"/>
          </ac:grpSpMkLst>
        </pc:grpChg>
        <pc:grpChg chg="add del mod">
          <ac:chgData name="Filippo Acconcia" userId="844af49c-a8a0-47ac-a7dd-14a44b60cd18" providerId="ADAL" clId="{4E01D738-D0C1-4B9B-B836-CF053EEC4C53}" dt="2022-03-16T08:16:02.834" v="414" actId="21"/>
          <ac:grpSpMkLst>
            <pc:docMk/>
            <pc:sldMk cId="2335018827" sldId="302"/>
            <ac:grpSpMk id="147" creationId="{639FF53B-8F90-4C4C-B430-17D575601DFC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154" creationId="{DC80EAB6-0D9A-44B1-9020-EE760B279191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156" creationId="{1F8BE7DA-F191-4D2A-86CA-D320FE52BF1D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158" creationId="{FDB217A8-E6DA-4AFC-A7BD-04F48193A373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160" creationId="{B7E04219-F7A6-4EBE-85B3-AA1870DC9C9B}"/>
          </ac:grpSpMkLst>
        </pc:grpChg>
        <pc:grpChg chg="add del mod">
          <ac:chgData name="Filippo Acconcia" userId="844af49c-a8a0-47ac-a7dd-14a44b60cd18" providerId="ADAL" clId="{4E01D738-D0C1-4B9B-B836-CF053EEC4C53}" dt="2022-03-16T08:16:02.834" v="414" actId="21"/>
          <ac:grpSpMkLst>
            <pc:docMk/>
            <pc:sldMk cId="2335018827" sldId="302"/>
            <ac:grpSpMk id="195" creationId="{71ADE785-C231-45A9-AF07-ED30157E12CD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202" creationId="{8CF334F3-33D7-4BF8-8FDE-F7919C0CF61D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204" creationId="{476C1643-1785-4149-B8EB-28DC460EF802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206" creationId="{27E56CEE-2950-4928-A426-C1ABC612E8B2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208" creationId="{BF424E70-1717-4121-8005-5FDCA02C5F5F}"/>
          </ac:grpSpMkLst>
        </pc:grpChg>
        <pc:grpChg chg="add del mod">
          <ac:chgData name="Filippo Acconcia" userId="844af49c-a8a0-47ac-a7dd-14a44b60cd18" providerId="ADAL" clId="{4E01D738-D0C1-4B9B-B836-CF053EEC4C53}" dt="2022-03-16T08:16:02.834" v="414" actId="21"/>
          <ac:grpSpMkLst>
            <pc:docMk/>
            <pc:sldMk cId="2335018827" sldId="302"/>
            <ac:grpSpMk id="243" creationId="{00C5A1E6-F5B0-4A5D-A9A4-D7A2214DAE7A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250" creationId="{5EEB6703-8E9B-4F93-B77E-AEEE106A1BED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252" creationId="{0A713E09-CA04-4D75-9A68-600442AAC096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254" creationId="{6CA54A79-FB3B-43AA-B08D-1C9F9139C1A8}"/>
          </ac:grpSpMkLst>
        </pc:grpChg>
        <pc:grpChg chg="mod">
          <ac:chgData name="Filippo Acconcia" userId="844af49c-a8a0-47ac-a7dd-14a44b60cd18" providerId="ADAL" clId="{4E01D738-D0C1-4B9B-B836-CF053EEC4C53}" dt="2022-03-16T08:15:38.736" v="407"/>
          <ac:grpSpMkLst>
            <pc:docMk/>
            <pc:sldMk cId="2335018827" sldId="302"/>
            <ac:grpSpMk id="256" creationId="{BDEE6C0C-1344-446A-9EE5-882514816CED}"/>
          </ac:grpSpMkLst>
        </pc:grpChg>
        <pc:grpChg chg="add del mod">
          <ac:chgData name="Filippo Acconcia" userId="844af49c-a8a0-47ac-a7dd-14a44b60cd18" providerId="ADAL" clId="{4E01D738-D0C1-4B9B-B836-CF053EEC4C53}" dt="2022-03-16T08:15:59.379" v="413" actId="21"/>
          <ac:grpSpMkLst>
            <pc:docMk/>
            <pc:sldMk cId="2335018827" sldId="302"/>
            <ac:grpSpMk id="291" creationId="{7B35C58B-40D1-4526-A3BF-014E6BF18DC0}"/>
          </ac:grpSpMkLst>
        </pc:grpChg>
        <pc:grpChg chg="mod">
          <ac:chgData name="Filippo Acconcia" userId="844af49c-a8a0-47ac-a7dd-14a44b60cd18" providerId="ADAL" clId="{4E01D738-D0C1-4B9B-B836-CF053EEC4C53}" dt="2022-03-16T08:15:51.080" v="410"/>
          <ac:grpSpMkLst>
            <pc:docMk/>
            <pc:sldMk cId="2335018827" sldId="302"/>
            <ac:grpSpMk id="298" creationId="{585D3994-6F7F-40EC-882D-0638C608FB82}"/>
          </ac:grpSpMkLst>
        </pc:grpChg>
        <pc:grpChg chg="mod">
          <ac:chgData name="Filippo Acconcia" userId="844af49c-a8a0-47ac-a7dd-14a44b60cd18" providerId="ADAL" clId="{4E01D738-D0C1-4B9B-B836-CF053EEC4C53}" dt="2022-03-16T08:15:51.080" v="410"/>
          <ac:grpSpMkLst>
            <pc:docMk/>
            <pc:sldMk cId="2335018827" sldId="302"/>
            <ac:grpSpMk id="300" creationId="{742C142F-47AD-4E02-8550-2D4E43E7F8C2}"/>
          </ac:grpSpMkLst>
        </pc:grpChg>
        <pc:grpChg chg="mod">
          <ac:chgData name="Filippo Acconcia" userId="844af49c-a8a0-47ac-a7dd-14a44b60cd18" providerId="ADAL" clId="{4E01D738-D0C1-4B9B-B836-CF053EEC4C53}" dt="2022-03-16T08:15:51.080" v="410"/>
          <ac:grpSpMkLst>
            <pc:docMk/>
            <pc:sldMk cId="2335018827" sldId="302"/>
            <ac:grpSpMk id="302" creationId="{9E08AA92-B81D-4A26-9164-1D3482BBC4F2}"/>
          </ac:grpSpMkLst>
        </pc:grpChg>
        <pc:grpChg chg="mod">
          <ac:chgData name="Filippo Acconcia" userId="844af49c-a8a0-47ac-a7dd-14a44b60cd18" providerId="ADAL" clId="{4E01D738-D0C1-4B9B-B836-CF053EEC4C53}" dt="2022-03-16T08:15:51.080" v="410"/>
          <ac:grpSpMkLst>
            <pc:docMk/>
            <pc:sldMk cId="2335018827" sldId="302"/>
            <ac:grpSpMk id="304" creationId="{9A285242-E1A8-40BA-A248-D183CD739B56}"/>
          </ac:grpSpMkLst>
        </pc:grpChg>
        <pc:grpChg chg="add del mod">
          <ac:chgData name="Filippo Acconcia" userId="844af49c-a8a0-47ac-a7dd-14a44b60cd18" providerId="ADAL" clId="{4E01D738-D0C1-4B9B-B836-CF053EEC4C53}" dt="2022-03-16T08:15:59.379" v="413" actId="21"/>
          <ac:grpSpMkLst>
            <pc:docMk/>
            <pc:sldMk cId="2335018827" sldId="302"/>
            <ac:grpSpMk id="339" creationId="{45A921BF-93F3-4C2A-B32F-6F30A38F12BB}"/>
          </ac:grpSpMkLst>
        </pc:grpChg>
        <pc:grpChg chg="mod">
          <ac:chgData name="Filippo Acconcia" userId="844af49c-a8a0-47ac-a7dd-14a44b60cd18" providerId="ADAL" clId="{4E01D738-D0C1-4B9B-B836-CF053EEC4C53}" dt="2022-03-16T08:15:51.080" v="410"/>
          <ac:grpSpMkLst>
            <pc:docMk/>
            <pc:sldMk cId="2335018827" sldId="302"/>
            <ac:grpSpMk id="346" creationId="{D66BB993-B9E0-469C-A891-D748EF1C7FE6}"/>
          </ac:grpSpMkLst>
        </pc:grpChg>
        <pc:grpChg chg="mod">
          <ac:chgData name="Filippo Acconcia" userId="844af49c-a8a0-47ac-a7dd-14a44b60cd18" providerId="ADAL" clId="{4E01D738-D0C1-4B9B-B836-CF053EEC4C53}" dt="2022-03-16T08:15:51.080" v="410"/>
          <ac:grpSpMkLst>
            <pc:docMk/>
            <pc:sldMk cId="2335018827" sldId="302"/>
            <ac:grpSpMk id="348" creationId="{DC6780F5-5A12-4DB5-A282-17216AFE5926}"/>
          </ac:grpSpMkLst>
        </pc:grpChg>
        <pc:grpChg chg="mod">
          <ac:chgData name="Filippo Acconcia" userId="844af49c-a8a0-47ac-a7dd-14a44b60cd18" providerId="ADAL" clId="{4E01D738-D0C1-4B9B-B836-CF053EEC4C53}" dt="2022-03-16T08:15:51.080" v="410"/>
          <ac:grpSpMkLst>
            <pc:docMk/>
            <pc:sldMk cId="2335018827" sldId="302"/>
            <ac:grpSpMk id="350" creationId="{DA16FCE1-3B96-40E1-B393-595D39730E8F}"/>
          </ac:grpSpMkLst>
        </pc:grpChg>
        <pc:grpChg chg="mod">
          <ac:chgData name="Filippo Acconcia" userId="844af49c-a8a0-47ac-a7dd-14a44b60cd18" providerId="ADAL" clId="{4E01D738-D0C1-4B9B-B836-CF053EEC4C53}" dt="2022-03-16T08:15:51.080" v="410"/>
          <ac:grpSpMkLst>
            <pc:docMk/>
            <pc:sldMk cId="2335018827" sldId="302"/>
            <ac:grpSpMk id="352" creationId="{62A544E0-2B0D-40D1-BD6C-8A28DFA0163D}"/>
          </ac:grpSpMkLst>
        </pc:grpChg>
        <pc:grpChg chg="add del mod">
          <ac:chgData name="Filippo Acconcia" userId="844af49c-a8a0-47ac-a7dd-14a44b60cd18" providerId="ADAL" clId="{4E01D738-D0C1-4B9B-B836-CF053EEC4C53}" dt="2022-03-16T08:34:19.398" v="733" actId="165"/>
          <ac:grpSpMkLst>
            <pc:docMk/>
            <pc:sldMk cId="2335018827" sldId="302"/>
            <ac:grpSpMk id="387" creationId="{730CE78D-DB36-4C6D-81FC-BEF4842ABCE5}"/>
          </ac:grpSpMkLst>
        </pc:grpChg>
        <pc:grpChg chg="add del mod topLvl">
          <ac:chgData name="Filippo Acconcia" userId="844af49c-a8a0-47ac-a7dd-14a44b60cd18" providerId="ADAL" clId="{4E01D738-D0C1-4B9B-B836-CF053EEC4C53}" dt="2022-03-16T08:40:03.920" v="773" actId="478"/>
          <ac:grpSpMkLst>
            <pc:docMk/>
            <pc:sldMk cId="2335018827" sldId="302"/>
            <ac:grpSpMk id="394" creationId="{DE0AFE4A-7C62-40A3-AA35-EDBDDAA04EB4}"/>
          </ac:grpSpMkLst>
        </pc:grpChg>
        <pc:grpChg chg="add del mod topLvl">
          <ac:chgData name="Filippo Acconcia" userId="844af49c-a8a0-47ac-a7dd-14a44b60cd18" providerId="ADAL" clId="{4E01D738-D0C1-4B9B-B836-CF053EEC4C53}" dt="2022-03-16T08:40:03.920" v="773" actId="478"/>
          <ac:grpSpMkLst>
            <pc:docMk/>
            <pc:sldMk cId="2335018827" sldId="302"/>
            <ac:grpSpMk id="396" creationId="{BE3D78CF-6A37-4E89-A08C-B498FC40DD39}"/>
          </ac:grpSpMkLst>
        </pc:grpChg>
        <pc:grpChg chg="add del mod topLvl">
          <ac:chgData name="Filippo Acconcia" userId="844af49c-a8a0-47ac-a7dd-14a44b60cd18" providerId="ADAL" clId="{4E01D738-D0C1-4B9B-B836-CF053EEC4C53}" dt="2022-03-16T08:40:03.920" v="773" actId="478"/>
          <ac:grpSpMkLst>
            <pc:docMk/>
            <pc:sldMk cId="2335018827" sldId="302"/>
            <ac:grpSpMk id="398" creationId="{CF3F3532-6A82-404C-B338-A32326D8E202}"/>
          </ac:grpSpMkLst>
        </pc:grpChg>
        <pc:grpChg chg="add del mod topLvl">
          <ac:chgData name="Filippo Acconcia" userId="844af49c-a8a0-47ac-a7dd-14a44b60cd18" providerId="ADAL" clId="{4E01D738-D0C1-4B9B-B836-CF053EEC4C53}" dt="2022-03-16T08:40:03.920" v="773" actId="478"/>
          <ac:grpSpMkLst>
            <pc:docMk/>
            <pc:sldMk cId="2335018827" sldId="302"/>
            <ac:grpSpMk id="400" creationId="{F2C3C02F-0A96-4F8F-8F88-E30C660B05A0}"/>
          </ac:grpSpMkLst>
        </pc:grpChg>
        <pc:grpChg chg="add del mod">
          <ac:chgData name="Filippo Acconcia" userId="844af49c-a8a0-47ac-a7dd-14a44b60cd18" providerId="ADAL" clId="{4E01D738-D0C1-4B9B-B836-CF053EEC4C53}" dt="2022-03-16T08:40:13.425" v="776" actId="478"/>
          <ac:grpSpMkLst>
            <pc:docMk/>
            <pc:sldMk cId="2335018827" sldId="302"/>
            <ac:grpSpMk id="435" creationId="{F8AB267F-43DC-428C-9EE3-D3F5B39F6098}"/>
          </ac:grpSpMkLst>
        </pc:grpChg>
        <pc:grpChg chg="mod">
          <ac:chgData name="Filippo Acconcia" userId="844af49c-a8a0-47ac-a7dd-14a44b60cd18" providerId="ADAL" clId="{4E01D738-D0C1-4B9B-B836-CF053EEC4C53}" dt="2022-03-16T08:16:14.931" v="417"/>
          <ac:grpSpMkLst>
            <pc:docMk/>
            <pc:sldMk cId="2335018827" sldId="302"/>
            <ac:grpSpMk id="442" creationId="{9735DDE7-46AC-4C0E-922A-762D69F46B90}"/>
          </ac:grpSpMkLst>
        </pc:grpChg>
        <pc:grpChg chg="mod">
          <ac:chgData name="Filippo Acconcia" userId="844af49c-a8a0-47ac-a7dd-14a44b60cd18" providerId="ADAL" clId="{4E01D738-D0C1-4B9B-B836-CF053EEC4C53}" dt="2022-03-16T08:16:14.931" v="417"/>
          <ac:grpSpMkLst>
            <pc:docMk/>
            <pc:sldMk cId="2335018827" sldId="302"/>
            <ac:grpSpMk id="444" creationId="{AB14DC8A-B7D0-4ECA-A19F-069910FC13E8}"/>
          </ac:grpSpMkLst>
        </pc:grpChg>
        <pc:grpChg chg="mod">
          <ac:chgData name="Filippo Acconcia" userId="844af49c-a8a0-47ac-a7dd-14a44b60cd18" providerId="ADAL" clId="{4E01D738-D0C1-4B9B-B836-CF053EEC4C53}" dt="2022-03-16T08:16:14.931" v="417"/>
          <ac:grpSpMkLst>
            <pc:docMk/>
            <pc:sldMk cId="2335018827" sldId="302"/>
            <ac:grpSpMk id="446" creationId="{C17F8A79-18C7-4B12-AA78-0C39721E3F41}"/>
          </ac:grpSpMkLst>
        </pc:grpChg>
        <pc:grpChg chg="mod">
          <ac:chgData name="Filippo Acconcia" userId="844af49c-a8a0-47ac-a7dd-14a44b60cd18" providerId="ADAL" clId="{4E01D738-D0C1-4B9B-B836-CF053EEC4C53}" dt="2022-03-16T08:16:14.931" v="417"/>
          <ac:grpSpMkLst>
            <pc:docMk/>
            <pc:sldMk cId="2335018827" sldId="302"/>
            <ac:grpSpMk id="448" creationId="{537D76F3-5015-4FF9-B19A-9518D234BAEF}"/>
          </ac:grpSpMkLst>
        </pc:grpChg>
        <pc:grpChg chg="add del mod">
          <ac:chgData name="Filippo Acconcia" userId="844af49c-a8a0-47ac-a7dd-14a44b60cd18" providerId="ADAL" clId="{4E01D738-D0C1-4B9B-B836-CF053EEC4C53}" dt="2022-03-16T08:40:14.487" v="777" actId="478"/>
          <ac:grpSpMkLst>
            <pc:docMk/>
            <pc:sldMk cId="2335018827" sldId="302"/>
            <ac:grpSpMk id="483" creationId="{97D88F0F-3B1C-4CB8-9A88-C58738059B18}"/>
          </ac:grpSpMkLst>
        </pc:grpChg>
        <pc:grpChg chg="mod">
          <ac:chgData name="Filippo Acconcia" userId="844af49c-a8a0-47ac-a7dd-14a44b60cd18" providerId="ADAL" clId="{4E01D738-D0C1-4B9B-B836-CF053EEC4C53}" dt="2022-03-16T08:16:14.931" v="417"/>
          <ac:grpSpMkLst>
            <pc:docMk/>
            <pc:sldMk cId="2335018827" sldId="302"/>
            <ac:grpSpMk id="490" creationId="{C80ADB62-C723-4BEC-86A3-DF157006AC1B}"/>
          </ac:grpSpMkLst>
        </pc:grpChg>
        <pc:grpChg chg="mod">
          <ac:chgData name="Filippo Acconcia" userId="844af49c-a8a0-47ac-a7dd-14a44b60cd18" providerId="ADAL" clId="{4E01D738-D0C1-4B9B-B836-CF053EEC4C53}" dt="2022-03-16T08:16:14.931" v="417"/>
          <ac:grpSpMkLst>
            <pc:docMk/>
            <pc:sldMk cId="2335018827" sldId="302"/>
            <ac:grpSpMk id="492" creationId="{C6D16759-B1AA-4267-A3FB-C847515AECA8}"/>
          </ac:grpSpMkLst>
        </pc:grpChg>
        <pc:grpChg chg="mod">
          <ac:chgData name="Filippo Acconcia" userId="844af49c-a8a0-47ac-a7dd-14a44b60cd18" providerId="ADAL" clId="{4E01D738-D0C1-4B9B-B836-CF053EEC4C53}" dt="2022-03-16T08:16:14.931" v="417"/>
          <ac:grpSpMkLst>
            <pc:docMk/>
            <pc:sldMk cId="2335018827" sldId="302"/>
            <ac:grpSpMk id="494" creationId="{B49F29D5-A9A1-4A71-80E7-095B75E0230D}"/>
          </ac:grpSpMkLst>
        </pc:grpChg>
        <pc:grpChg chg="mod">
          <ac:chgData name="Filippo Acconcia" userId="844af49c-a8a0-47ac-a7dd-14a44b60cd18" providerId="ADAL" clId="{4E01D738-D0C1-4B9B-B836-CF053EEC4C53}" dt="2022-03-16T08:16:14.931" v="417"/>
          <ac:grpSpMkLst>
            <pc:docMk/>
            <pc:sldMk cId="2335018827" sldId="302"/>
            <ac:grpSpMk id="496" creationId="{A68BDA8E-FD1A-423F-8835-C5D31C361740}"/>
          </ac:grpSpMkLst>
        </pc:grpChg>
        <pc:grpChg chg="add del mod">
          <ac:chgData name="Filippo Acconcia" userId="844af49c-a8a0-47ac-a7dd-14a44b60cd18" providerId="ADAL" clId="{4E01D738-D0C1-4B9B-B836-CF053EEC4C53}" dt="2022-03-16T08:34:36.302" v="742" actId="165"/>
          <ac:grpSpMkLst>
            <pc:docMk/>
            <pc:sldMk cId="2335018827" sldId="302"/>
            <ac:grpSpMk id="531" creationId="{DBD0824C-9B17-4E14-BD00-280BAA979EB0}"/>
          </ac:grpSpMkLst>
        </pc:grpChg>
        <pc:grpChg chg="add mod">
          <ac:chgData name="Filippo Acconcia" userId="844af49c-a8a0-47ac-a7dd-14a44b60cd18" providerId="ADAL" clId="{4E01D738-D0C1-4B9B-B836-CF053EEC4C53}" dt="2022-03-16T08:49:12.255" v="943" actId="1036"/>
          <ac:grpSpMkLst>
            <pc:docMk/>
            <pc:sldMk cId="2335018827" sldId="302"/>
            <ac:grpSpMk id="532" creationId="{6D688B7D-D2D1-4CE8-9394-E3AB16CE60D2}"/>
          </ac:grpSpMkLst>
        </pc:grpChg>
        <pc:grpChg chg="add del mod">
          <ac:chgData name="Filippo Acconcia" userId="844af49c-a8a0-47ac-a7dd-14a44b60cd18" providerId="ADAL" clId="{4E01D738-D0C1-4B9B-B836-CF053EEC4C53}" dt="2022-03-16T08:40:48.444" v="781" actId="165"/>
          <ac:grpSpMkLst>
            <pc:docMk/>
            <pc:sldMk cId="2335018827" sldId="302"/>
            <ac:grpSpMk id="576" creationId="{AA1253D9-FB39-41F6-BCDB-D6AF8C7A434F}"/>
          </ac:grpSpMkLst>
        </pc:grpChg>
        <pc:grpChg chg="add mod">
          <ac:chgData name="Filippo Acconcia" userId="844af49c-a8a0-47ac-a7dd-14a44b60cd18" providerId="ADAL" clId="{4E01D738-D0C1-4B9B-B836-CF053EEC4C53}" dt="2022-03-16T08:49:10.489" v="940" actId="1036"/>
          <ac:grpSpMkLst>
            <pc:docMk/>
            <pc:sldMk cId="2335018827" sldId="302"/>
            <ac:grpSpMk id="621" creationId="{8292B586-EA83-4F53-9AEA-3B7EFBC6B831}"/>
          </ac:grpSpMkLst>
        </pc:grpChg>
        <pc:grpChg chg="add mod">
          <ac:chgData name="Filippo Acconcia" userId="844af49c-a8a0-47ac-a7dd-14a44b60cd18" providerId="ADAL" clId="{4E01D738-D0C1-4B9B-B836-CF053EEC4C53}" dt="2022-03-16T08:49:04.002" v="924" actId="1036"/>
          <ac:grpSpMkLst>
            <pc:docMk/>
            <pc:sldMk cId="2335018827" sldId="302"/>
            <ac:grpSpMk id="622" creationId="{CA0465DF-B29F-4C03-A883-FA4D37170FFB}"/>
          </ac:grpSpMkLst>
        </pc:grpChg>
        <pc:grpChg chg="mod">
          <ac:chgData name="Filippo Acconcia" userId="844af49c-a8a0-47ac-a7dd-14a44b60cd18" providerId="ADAL" clId="{4E01D738-D0C1-4B9B-B836-CF053EEC4C53}" dt="2022-03-16T08:48:20.860" v="833"/>
          <ac:grpSpMkLst>
            <pc:docMk/>
            <pc:sldMk cId="2335018827" sldId="302"/>
            <ac:grpSpMk id="628" creationId="{F1106617-CE4F-48F6-9F40-154362B1A39A}"/>
          </ac:grpSpMkLst>
        </pc:grpChg>
        <pc:grpChg chg="mod">
          <ac:chgData name="Filippo Acconcia" userId="844af49c-a8a0-47ac-a7dd-14a44b60cd18" providerId="ADAL" clId="{4E01D738-D0C1-4B9B-B836-CF053EEC4C53}" dt="2022-03-16T08:48:20.860" v="833"/>
          <ac:grpSpMkLst>
            <pc:docMk/>
            <pc:sldMk cId="2335018827" sldId="302"/>
            <ac:grpSpMk id="642" creationId="{09D16CA6-2DD6-4B82-95D7-CA21D17804C5}"/>
          </ac:grpSpMkLst>
        </pc:grpChg>
        <pc:grpChg chg="mod">
          <ac:chgData name="Filippo Acconcia" userId="844af49c-a8a0-47ac-a7dd-14a44b60cd18" providerId="ADAL" clId="{4E01D738-D0C1-4B9B-B836-CF053EEC4C53}" dt="2022-03-16T08:48:20.860" v="833"/>
          <ac:grpSpMkLst>
            <pc:docMk/>
            <pc:sldMk cId="2335018827" sldId="302"/>
            <ac:grpSpMk id="643" creationId="{3FBBB281-459A-4732-8CAE-EA3678837323}"/>
          </ac:grpSpMkLst>
        </pc:grpChg>
        <pc:grpChg chg="mod">
          <ac:chgData name="Filippo Acconcia" userId="844af49c-a8a0-47ac-a7dd-14a44b60cd18" providerId="ADAL" clId="{4E01D738-D0C1-4B9B-B836-CF053EEC4C53}" dt="2022-03-16T08:48:20.860" v="833"/>
          <ac:grpSpMkLst>
            <pc:docMk/>
            <pc:sldMk cId="2335018827" sldId="302"/>
            <ac:grpSpMk id="644" creationId="{F8CDC4ED-3DC1-4063-AC84-4F158E00D3F9}"/>
          </ac:grpSpMkLst>
        </pc:grpChg>
        <pc:grpChg chg="mod">
          <ac:chgData name="Filippo Acconcia" userId="844af49c-a8a0-47ac-a7dd-14a44b60cd18" providerId="ADAL" clId="{4E01D738-D0C1-4B9B-B836-CF053EEC4C53}" dt="2022-03-16T08:48:20.860" v="833"/>
          <ac:grpSpMkLst>
            <pc:docMk/>
            <pc:sldMk cId="2335018827" sldId="302"/>
            <ac:grpSpMk id="645" creationId="{B95C8970-CCFE-48AB-9DCC-9CC7DF312876}"/>
          </ac:grpSpMkLst>
        </pc:grpChg>
        <pc:grpChg chg="mod">
          <ac:chgData name="Filippo Acconcia" userId="844af49c-a8a0-47ac-a7dd-14a44b60cd18" providerId="ADAL" clId="{4E01D738-D0C1-4B9B-B836-CF053EEC4C53}" dt="2022-03-16T08:48:20.860" v="833"/>
          <ac:grpSpMkLst>
            <pc:docMk/>
            <pc:sldMk cId="2335018827" sldId="302"/>
            <ac:grpSpMk id="647" creationId="{C1FAFFC3-23DF-40C7-BEEB-5081EFC17195}"/>
          </ac:grpSpMkLst>
        </pc:grpChg>
        <pc:grpChg chg="mod">
          <ac:chgData name="Filippo Acconcia" userId="844af49c-a8a0-47ac-a7dd-14a44b60cd18" providerId="ADAL" clId="{4E01D738-D0C1-4B9B-B836-CF053EEC4C53}" dt="2022-03-16T08:48:20.860" v="833"/>
          <ac:grpSpMkLst>
            <pc:docMk/>
            <pc:sldMk cId="2335018827" sldId="302"/>
            <ac:grpSpMk id="653" creationId="{2E6CE36A-0921-4F3B-ABE4-24112C644A99}"/>
          </ac:grpSpMkLst>
        </pc:grpChg>
        <pc:grpChg chg="mod">
          <ac:chgData name="Filippo Acconcia" userId="844af49c-a8a0-47ac-a7dd-14a44b60cd18" providerId="ADAL" clId="{4E01D738-D0C1-4B9B-B836-CF053EEC4C53}" dt="2022-03-16T08:48:20.860" v="833"/>
          <ac:grpSpMkLst>
            <pc:docMk/>
            <pc:sldMk cId="2335018827" sldId="302"/>
            <ac:grpSpMk id="659" creationId="{27E86569-D0AA-4209-8525-597CAEDF74DE}"/>
          </ac:grpSpMkLst>
        </pc:grpChg>
        <pc:grpChg chg="mod">
          <ac:chgData name="Filippo Acconcia" userId="844af49c-a8a0-47ac-a7dd-14a44b60cd18" providerId="ADAL" clId="{4E01D738-D0C1-4B9B-B836-CF053EEC4C53}" dt="2022-03-16T08:48:20.860" v="833"/>
          <ac:grpSpMkLst>
            <pc:docMk/>
            <pc:sldMk cId="2335018827" sldId="302"/>
            <ac:grpSpMk id="665" creationId="{25654170-BDFD-4BE5-A125-037BD2C784B0}"/>
          </ac:grpSpMkLst>
        </pc:grpChg>
        <pc:grpChg chg="mod">
          <ac:chgData name="Filippo Acconcia" userId="844af49c-a8a0-47ac-a7dd-14a44b60cd18" providerId="ADAL" clId="{4E01D738-D0C1-4B9B-B836-CF053EEC4C53}" dt="2022-03-16T08:48:20.860" v="833"/>
          <ac:grpSpMkLst>
            <pc:docMk/>
            <pc:sldMk cId="2335018827" sldId="302"/>
            <ac:grpSpMk id="671" creationId="{BE34F4D1-8B6E-44E1-A6EF-462284D62099}"/>
          </ac:grpSpMkLst>
        </pc:grpChg>
        <pc:picChg chg="mod">
          <ac:chgData name="Filippo Acconcia" userId="844af49c-a8a0-47ac-a7dd-14a44b60cd18" providerId="ADAL" clId="{4E01D738-D0C1-4B9B-B836-CF053EEC4C53}" dt="2022-03-16T08:15:38.736" v="407"/>
          <ac:picMkLst>
            <pc:docMk/>
            <pc:sldMk cId="2335018827" sldId="302"/>
            <ac:picMk id="4" creationId="{E45B48CF-5399-44FC-BC8F-E5FE0C9AA06B}"/>
          </ac:picMkLst>
        </pc:picChg>
        <pc:picChg chg="mod">
          <ac:chgData name="Filippo Acconcia" userId="844af49c-a8a0-47ac-a7dd-14a44b60cd18" providerId="ADAL" clId="{4E01D738-D0C1-4B9B-B836-CF053EEC4C53}" dt="2022-03-16T08:15:38.736" v="407"/>
          <ac:picMkLst>
            <pc:docMk/>
            <pc:sldMk cId="2335018827" sldId="302"/>
            <ac:picMk id="52" creationId="{AA2DEAB4-45AD-4D0A-928B-F305A0D76054}"/>
          </ac:picMkLst>
        </pc:picChg>
        <pc:picChg chg="mod">
          <ac:chgData name="Filippo Acconcia" userId="844af49c-a8a0-47ac-a7dd-14a44b60cd18" providerId="ADAL" clId="{4E01D738-D0C1-4B9B-B836-CF053EEC4C53}" dt="2022-03-16T08:15:38.736" v="407"/>
          <ac:picMkLst>
            <pc:docMk/>
            <pc:sldMk cId="2335018827" sldId="302"/>
            <ac:picMk id="100" creationId="{13A4EC6B-F568-4BE2-93C1-F073BB8253A7}"/>
          </ac:picMkLst>
        </pc:picChg>
        <pc:picChg chg="mod">
          <ac:chgData name="Filippo Acconcia" userId="844af49c-a8a0-47ac-a7dd-14a44b60cd18" providerId="ADAL" clId="{4E01D738-D0C1-4B9B-B836-CF053EEC4C53}" dt="2022-03-16T08:15:38.736" v="407"/>
          <ac:picMkLst>
            <pc:docMk/>
            <pc:sldMk cId="2335018827" sldId="302"/>
            <ac:picMk id="148" creationId="{FD77D29E-5379-422F-9562-B0E8BA77F51D}"/>
          </ac:picMkLst>
        </pc:picChg>
        <pc:picChg chg="mod">
          <ac:chgData name="Filippo Acconcia" userId="844af49c-a8a0-47ac-a7dd-14a44b60cd18" providerId="ADAL" clId="{4E01D738-D0C1-4B9B-B836-CF053EEC4C53}" dt="2022-03-16T08:15:38.736" v="407"/>
          <ac:picMkLst>
            <pc:docMk/>
            <pc:sldMk cId="2335018827" sldId="302"/>
            <ac:picMk id="196" creationId="{519F9A09-A89F-45C1-AE70-5C789C911F10}"/>
          </ac:picMkLst>
        </pc:picChg>
        <pc:picChg chg="mod">
          <ac:chgData name="Filippo Acconcia" userId="844af49c-a8a0-47ac-a7dd-14a44b60cd18" providerId="ADAL" clId="{4E01D738-D0C1-4B9B-B836-CF053EEC4C53}" dt="2022-03-16T08:15:38.736" v="407"/>
          <ac:picMkLst>
            <pc:docMk/>
            <pc:sldMk cId="2335018827" sldId="302"/>
            <ac:picMk id="244" creationId="{D1F58947-3AB1-4BD4-8E4F-8C089EF058B1}"/>
          </ac:picMkLst>
        </pc:picChg>
        <pc:picChg chg="mod">
          <ac:chgData name="Filippo Acconcia" userId="844af49c-a8a0-47ac-a7dd-14a44b60cd18" providerId="ADAL" clId="{4E01D738-D0C1-4B9B-B836-CF053EEC4C53}" dt="2022-03-16T08:15:51.080" v="410"/>
          <ac:picMkLst>
            <pc:docMk/>
            <pc:sldMk cId="2335018827" sldId="302"/>
            <ac:picMk id="292" creationId="{0F6DEF46-1215-405E-AA21-B0E13F85BCA6}"/>
          </ac:picMkLst>
        </pc:picChg>
        <pc:picChg chg="mod">
          <ac:chgData name="Filippo Acconcia" userId="844af49c-a8a0-47ac-a7dd-14a44b60cd18" providerId="ADAL" clId="{4E01D738-D0C1-4B9B-B836-CF053EEC4C53}" dt="2022-03-16T08:15:51.080" v="410"/>
          <ac:picMkLst>
            <pc:docMk/>
            <pc:sldMk cId="2335018827" sldId="302"/>
            <ac:picMk id="340" creationId="{FD822399-8A76-4C33-837D-06DA8F1076D7}"/>
          </ac:picMkLst>
        </pc:picChg>
        <pc:picChg chg="del mod topLvl">
          <ac:chgData name="Filippo Acconcia" userId="844af49c-a8a0-47ac-a7dd-14a44b60cd18" providerId="ADAL" clId="{4E01D738-D0C1-4B9B-B836-CF053EEC4C53}" dt="2022-03-16T08:40:03.920" v="773" actId="478"/>
          <ac:picMkLst>
            <pc:docMk/>
            <pc:sldMk cId="2335018827" sldId="302"/>
            <ac:picMk id="388" creationId="{CFF09AE9-CDD8-4A6B-9B87-1910BAD7F108}"/>
          </ac:picMkLst>
        </pc:picChg>
        <pc:picChg chg="mod">
          <ac:chgData name="Filippo Acconcia" userId="844af49c-a8a0-47ac-a7dd-14a44b60cd18" providerId="ADAL" clId="{4E01D738-D0C1-4B9B-B836-CF053EEC4C53}" dt="2022-03-16T08:16:14.931" v="417"/>
          <ac:picMkLst>
            <pc:docMk/>
            <pc:sldMk cId="2335018827" sldId="302"/>
            <ac:picMk id="436" creationId="{B604AC13-87C7-49B5-BA64-B23663CACF64}"/>
          </ac:picMkLst>
        </pc:picChg>
        <pc:picChg chg="mod">
          <ac:chgData name="Filippo Acconcia" userId="844af49c-a8a0-47ac-a7dd-14a44b60cd18" providerId="ADAL" clId="{4E01D738-D0C1-4B9B-B836-CF053EEC4C53}" dt="2022-03-16T08:16:14.931" v="417"/>
          <ac:picMkLst>
            <pc:docMk/>
            <pc:sldMk cId="2335018827" sldId="302"/>
            <ac:picMk id="484" creationId="{6B7ED400-4A5F-48B4-B229-A3A3F11845EF}"/>
          </ac:picMkLst>
        </pc:picChg>
        <pc:picChg chg="mod">
          <ac:chgData name="Filippo Acconcia" userId="844af49c-a8a0-47ac-a7dd-14a44b60cd18" providerId="ADAL" clId="{4E01D738-D0C1-4B9B-B836-CF053EEC4C53}" dt="2022-03-16T08:40:05.670" v="774"/>
          <ac:picMkLst>
            <pc:docMk/>
            <pc:sldMk cId="2335018827" sldId="302"/>
            <ac:picMk id="533" creationId="{BEC8CE7D-2755-499E-9C6A-7C36A42A6B8A}"/>
          </ac:picMkLst>
        </pc:picChg>
        <pc:picChg chg="del mod topLvl">
          <ac:chgData name="Filippo Acconcia" userId="844af49c-a8a0-47ac-a7dd-14a44b60cd18" providerId="ADAL" clId="{4E01D738-D0C1-4B9B-B836-CF053EEC4C53}" dt="2022-03-16T08:41:05.229" v="786" actId="478"/>
          <ac:picMkLst>
            <pc:docMk/>
            <pc:sldMk cId="2335018827" sldId="302"/>
            <ac:picMk id="577" creationId="{4E3CD430-8D96-45B3-A629-50B24A5DDBC8}"/>
          </ac:picMkLst>
        </pc:picChg>
        <pc:picChg chg="mod ord">
          <ac:chgData name="Filippo Acconcia" userId="844af49c-a8a0-47ac-a7dd-14a44b60cd18" providerId="ADAL" clId="{4E01D738-D0C1-4B9B-B836-CF053EEC4C53}" dt="2022-03-16T08:42:22.602" v="831" actId="164"/>
          <ac:picMkLst>
            <pc:docMk/>
            <pc:sldMk cId="2335018827" sldId="302"/>
            <ac:picMk id="620" creationId="{491CA75E-FC1C-4A9C-8F88-EA38DD448515}"/>
          </ac:picMkLst>
        </pc:picChg>
        <pc:picChg chg="mod">
          <ac:chgData name="Filippo Acconcia" userId="844af49c-a8a0-47ac-a7dd-14a44b60cd18" providerId="ADAL" clId="{4E01D738-D0C1-4B9B-B836-CF053EEC4C53}" dt="2022-03-16T08:48:20.860" v="833"/>
          <ac:picMkLst>
            <pc:docMk/>
            <pc:sldMk cId="2335018827" sldId="302"/>
            <ac:picMk id="623" creationId="{67937900-2629-40DE-8C1E-C0E6132B0491}"/>
          </ac:picMkLst>
        </pc:pic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3" creationId="{B90F0482-0FDA-494A-9D13-C96D35348F26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4" creationId="{763535F8-9DDE-4C81-A53E-31175B69EEC1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5" creationId="{99925BE1-09D5-4090-9ABB-E6B80927F644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6" creationId="{A36F50B8-B50A-4018-BACC-061E64648C0A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7" creationId="{E3570737-4888-40D5-AA22-DA85A52225DD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32" creationId="{05755E2A-6210-4D0C-A265-A54007F20660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71" creationId="{47064E54-083C-4F7E-AE4F-5C1A5BB0AC7D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72" creationId="{82143AA1-F77B-478E-9216-37300C794BDA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73" creationId="{A65915DF-039B-4AD7-9FF5-5636E4F8DED9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74" creationId="{CE3336C2-DF8E-4AB0-A0DE-4695FFB33DE0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75" creationId="{631E08E3-5FD8-412D-B785-58DC24DDF1DB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80" creationId="{3A9EC7B5-D83D-4F12-A690-571C4D6F4D14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119" creationId="{CEA9CD87-85E2-44AD-9520-C586C08AD67B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120" creationId="{5D1B5A63-2DB4-4BCE-97E2-BE1A983BCF12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121" creationId="{4CE492CA-529B-4AE2-9144-A5463B5CB592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122" creationId="{7251F669-F0C6-40C9-86E6-9B16523953A3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123" creationId="{F07787A6-4F06-471E-A293-41DF72EAAF5B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128" creationId="{CBA93FBB-25D1-4442-B3CE-07874C754AA3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167" creationId="{601A1007-9C03-4142-A908-1B8337BFDBD1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168" creationId="{685C90A1-9DC3-46C6-92E6-2793355F93AD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169" creationId="{ADA1587B-EC02-4F85-ADF9-F632D9D6B0AA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170" creationId="{50F10E1C-8187-4838-86C7-A0D352504AA5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171" creationId="{A599B82C-1118-4558-AF45-0F0E36B0DB1A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176" creationId="{4FFA5199-D216-482D-B18E-CDF523D64F6A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15" creationId="{C3BB9D94-C5A5-444A-8F50-EC2D4D2A968F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16" creationId="{4291A81E-7968-4010-BD6C-224453DE9320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17" creationId="{0518EF65-C557-49E3-93F2-3BF252FDDCAB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18" creationId="{9385594E-F109-4944-B6A2-50B99B61A440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19" creationId="{D4E9DAA1-F67A-4AB9-A94A-66DCCF5498BC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24" creationId="{373658B7-C918-43BE-B689-C47B84832506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63" creationId="{92E769D0-3087-4882-9579-4C81FE7E65E8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64" creationId="{E08FD6A8-9CC4-4A56-86A4-13271A7847D5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65" creationId="{B7935B92-EB0A-4E46-89F0-A2AFA81793DD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66" creationId="{A784E27C-7751-4AD1-BB9A-9F34174D3E56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67" creationId="{4CD82B1E-6FA1-4108-AB6C-0C0C7C44F8F5}"/>
          </ac:cxnSpMkLst>
        </pc:cxnChg>
        <pc:cxnChg chg="mod">
          <ac:chgData name="Filippo Acconcia" userId="844af49c-a8a0-47ac-a7dd-14a44b60cd18" providerId="ADAL" clId="{4E01D738-D0C1-4B9B-B836-CF053EEC4C53}" dt="2022-03-16T08:15:38.736" v="407"/>
          <ac:cxnSpMkLst>
            <pc:docMk/>
            <pc:sldMk cId="2335018827" sldId="302"/>
            <ac:cxnSpMk id="272" creationId="{D50F7E7B-3E30-41CD-82A0-A53B5223A958}"/>
          </ac:cxnSpMkLst>
        </pc:cxnChg>
        <pc:cxnChg chg="mod">
          <ac:chgData name="Filippo Acconcia" userId="844af49c-a8a0-47ac-a7dd-14a44b60cd18" providerId="ADAL" clId="{4E01D738-D0C1-4B9B-B836-CF053EEC4C53}" dt="2022-03-16T08:15:51.080" v="410"/>
          <ac:cxnSpMkLst>
            <pc:docMk/>
            <pc:sldMk cId="2335018827" sldId="302"/>
            <ac:cxnSpMk id="311" creationId="{755E67B8-F34F-4ADD-825E-439609A0BCDB}"/>
          </ac:cxnSpMkLst>
        </pc:cxnChg>
        <pc:cxnChg chg="mod">
          <ac:chgData name="Filippo Acconcia" userId="844af49c-a8a0-47ac-a7dd-14a44b60cd18" providerId="ADAL" clId="{4E01D738-D0C1-4B9B-B836-CF053EEC4C53}" dt="2022-03-16T08:15:51.080" v="410"/>
          <ac:cxnSpMkLst>
            <pc:docMk/>
            <pc:sldMk cId="2335018827" sldId="302"/>
            <ac:cxnSpMk id="312" creationId="{DA017503-4564-4F57-81B9-253E97686EF0}"/>
          </ac:cxnSpMkLst>
        </pc:cxnChg>
        <pc:cxnChg chg="mod">
          <ac:chgData name="Filippo Acconcia" userId="844af49c-a8a0-47ac-a7dd-14a44b60cd18" providerId="ADAL" clId="{4E01D738-D0C1-4B9B-B836-CF053EEC4C53}" dt="2022-03-16T08:15:51.080" v="410"/>
          <ac:cxnSpMkLst>
            <pc:docMk/>
            <pc:sldMk cId="2335018827" sldId="302"/>
            <ac:cxnSpMk id="313" creationId="{97F709C2-FACD-4AA5-8AA5-E47B20399B34}"/>
          </ac:cxnSpMkLst>
        </pc:cxnChg>
        <pc:cxnChg chg="mod">
          <ac:chgData name="Filippo Acconcia" userId="844af49c-a8a0-47ac-a7dd-14a44b60cd18" providerId="ADAL" clId="{4E01D738-D0C1-4B9B-B836-CF053EEC4C53}" dt="2022-03-16T08:15:51.080" v="410"/>
          <ac:cxnSpMkLst>
            <pc:docMk/>
            <pc:sldMk cId="2335018827" sldId="302"/>
            <ac:cxnSpMk id="314" creationId="{0A29AF6B-D977-4C0E-9838-C2686E45DC08}"/>
          </ac:cxnSpMkLst>
        </pc:cxnChg>
        <pc:cxnChg chg="mod">
          <ac:chgData name="Filippo Acconcia" userId="844af49c-a8a0-47ac-a7dd-14a44b60cd18" providerId="ADAL" clId="{4E01D738-D0C1-4B9B-B836-CF053EEC4C53}" dt="2022-03-16T08:15:51.080" v="410"/>
          <ac:cxnSpMkLst>
            <pc:docMk/>
            <pc:sldMk cId="2335018827" sldId="302"/>
            <ac:cxnSpMk id="315" creationId="{85172B59-A1DD-4ED2-93EA-C8CF9831A803}"/>
          </ac:cxnSpMkLst>
        </pc:cxnChg>
        <pc:cxnChg chg="mod">
          <ac:chgData name="Filippo Acconcia" userId="844af49c-a8a0-47ac-a7dd-14a44b60cd18" providerId="ADAL" clId="{4E01D738-D0C1-4B9B-B836-CF053EEC4C53}" dt="2022-03-16T08:15:51.080" v="410"/>
          <ac:cxnSpMkLst>
            <pc:docMk/>
            <pc:sldMk cId="2335018827" sldId="302"/>
            <ac:cxnSpMk id="320" creationId="{0D229A02-1AC9-4568-8168-AB90C0B5DB97}"/>
          </ac:cxnSpMkLst>
        </pc:cxnChg>
        <pc:cxnChg chg="mod">
          <ac:chgData name="Filippo Acconcia" userId="844af49c-a8a0-47ac-a7dd-14a44b60cd18" providerId="ADAL" clId="{4E01D738-D0C1-4B9B-B836-CF053EEC4C53}" dt="2022-03-16T08:15:51.080" v="410"/>
          <ac:cxnSpMkLst>
            <pc:docMk/>
            <pc:sldMk cId="2335018827" sldId="302"/>
            <ac:cxnSpMk id="359" creationId="{667F4300-9802-401A-BB60-D4BF49DA6A0A}"/>
          </ac:cxnSpMkLst>
        </pc:cxnChg>
        <pc:cxnChg chg="mod">
          <ac:chgData name="Filippo Acconcia" userId="844af49c-a8a0-47ac-a7dd-14a44b60cd18" providerId="ADAL" clId="{4E01D738-D0C1-4B9B-B836-CF053EEC4C53}" dt="2022-03-16T08:15:51.080" v="410"/>
          <ac:cxnSpMkLst>
            <pc:docMk/>
            <pc:sldMk cId="2335018827" sldId="302"/>
            <ac:cxnSpMk id="360" creationId="{1286287A-95C5-4240-99B0-C9534C0DD96D}"/>
          </ac:cxnSpMkLst>
        </pc:cxnChg>
        <pc:cxnChg chg="mod">
          <ac:chgData name="Filippo Acconcia" userId="844af49c-a8a0-47ac-a7dd-14a44b60cd18" providerId="ADAL" clId="{4E01D738-D0C1-4B9B-B836-CF053EEC4C53}" dt="2022-03-16T08:15:51.080" v="410"/>
          <ac:cxnSpMkLst>
            <pc:docMk/>
            <pc:sldMk cId="2335018827" sldId="302"/>
            <ac:cxnSpMk id="361" creationId="{185AE7EE-E186-4689-85D8-AB2C9BD4AB8B}"/>
          </ac:cxnSpMkLst>
        </pc:cxnChg>
        <pc:cxnChg chg="mod">
          <ac:chgData name="Filippo Acconcia" userId="844af49c-a8a0-47ac-a7dd-14a44b60cd18" providerId="ADAL" clId="{4E01D738-D0C1-4B9B-B836-CF053EEC4C53}" dt="2022-03-16T08:15:51.080" v="410"/>
          <ac:cxnSpMkLst>
            <pc:docMk/>
            <pc:sldMk cId="2335018827" sldId="302"/>
            <ac:cxnSpMk id="362" creationId="{FEEE7B76-8F6E-48A1-B9EC-5682B4DE4E48}"/>
          </ac:cxnSpMkLst>
        </pc:cxnChg>
        <pc:cxnChg chg="mod">
          <ac:chgData name="Filippo Acconcia" userId="844af49c-a8a0-47ac-a7dd-14a44b60cd18" providerId="ADAL" clId="{4E01D738-D0C1-4B9B-B836-CF053EEC4C53}" dt="2022-03-16T08:15:51.080" v="410"/>
          <ac:cxnSpMkLst>
            <pc:docMk/>
            <pc:sldMk cId="2335018827" sldId="302"/>
            <ac:cxnSpMk id="363" creationId="{F54F61F9-12AE-4F81-836E-8677E462FF53}"/>
          </ac:cxnSpMkLst>
        </pc:cxnChg>
        <pc:cxnChg chg="mod">
          <ac:chgData name="Filippo Acconcia" userId="844af49c-a8a0-47ac-a7dd-14a44b60cd18" providerId="ADAL" clId="{4E01D738-D0C1-4B9B-B836-CF053EEC4C53}" dt="2022-03-16T08:15:51.080" v="410"/>
          <ac:cxnSpMkLst>
            <pc:docMk/>
            <pc:sldMk cId="2335018827" sldId="302"/>
            <ac:cxnSpMk id="368" creationId="{7E75C2B0-B0C3-4FB9-BE05-819CF168B74D}"/>
          </ac:cxnSpMkLst>
        </pc:cxnChg>
        <pc:cxnChg chg="del mod topLvl">
          <ac:chgData name="Filippo Acconcia" userId="844af49c-a8a0-47ac-a7dd-14a44b60cd18" providerId="ADAL" clId="{4E01D738-D0C1-4B9B-B836-CF053EEC4C53}" dt="2022-03-16T08:40:03.920" v="773" actId="478"/>
          <ac:cxnSpMkLst>
            <pc:docMk/>
            <pc:sldMk cId="2335018827" sldId="302"/>
            <ac:cxnSpMk id="407" creationId="{38F136AD-618C-4D3B-A271-050B0E14CD8A}"/>
          </ac:cxnSpMkLst>
        </pc:cxnChg>
        <pc:cxnChg chg="del mod topLvl">
          <ac:chgData name="Filippo Acconcia" userId="844af49c-a8a0-47ac-a7dd-14a44b60cd18" providerId="ADAL" clId="{4E01D738-D0C1-4B9B-B836-CF053EEC4C53}" dt="2022-03-16T08:40:03.920" v="773" actId="478"/>
          <ac:cxnSpMkLst>
            <pc:docMk/>
            <pc:sldMk cId="2335018827" sldId="302"/>
            <ac:cxnSpMk id="408" creationId="{222531D5-7FDB-4C1F-AE5C-2C72EC3BFD37}"/>
          </ac:cxnSpMkLst>
        </pc:cxnChg>
        <pc:cxnChg chg="del mod topLvl">
          <ac:chgData name="Filippo Acconcia" userId="844af49c-a8a0-47ac-a7dd-14a44b60cd18" providerId="ADAL" clId="{4E01D738-D0C1-4B9B-B836-CF053EEC4C53}" dt="2022-03-16T08:40:03.920" v="773" actId="478"/>
          <ac:cxnSpMkLst>
            <pc:docMk/>
            <pc:sldMk cId="2335018827" sldId="302"/>
            <ac:cxnSpMk id="409" creationId="{03B51B7D-93B6-4987-95C8-511B32F8D133}"/>
          </ac:cxnSpMkLst>
        </pc:cxnChg>
        <pc:cxnChg chg="del mod topLvl">
          <ac:chgData name="Filippo Acconcia" userId="844af49c-a8a0-47ac-a7dd-14a44b60cd18" providerId="ADAL" clId="{4E01D738-D0C1-4B9B-B836-CF053EEC4C53}" dt="2022-03-16T08:40:03.920" v="773" actId="478"/>
          <ac:cxnSpMkLst>
            <pc:docMk/>
            <pc:sldMk cId="2335018827" sldId="302"/>
            <ac:cxnSpMk id="410" creationId="{B46F476B-4DD8-4197-A1B9-A83BA46BE62D}"/>
          </ac:cxnSpMkLst>
        </pc:cxnChg>
        <pc:cxnChg chg="del mod topLvl">
          <ac:chgData name="Filippo Acconcia" userId="844af49c-a8a0-47ac-a7dd-14a44b60cd18" providerId="ADAL" clId="{4E01D738-D0C1-4B9B-B836-CF053EEC4C53}" dt="2022-03-16T08:40:03.920" v="773" actId="478"/>
          <ac:cxnSpMkLst>
            <pc:docMk/>
            <pc:sldMk cId="2335018827" sldId="302"/>
            <ac:cxnSpMk id="411" creationId="{086F0750-4563-4433-A991-A09CE30072FB}"/>
          </ac:cxnSpMkLst>
        </pc:cxnChg>
        <pc:cxnChg chg="del mod topLvl">
          <ac:chgData name="Filippo Acconcia" userId="844af49c-a8a0-47ac-a7dd-14a44b60cd18" providerId="ADAL" clId="{4E01D738-D0C1-4B9B-B836-CF053EEC4C53}" dt="2022-03-16T08:40:03.920" v="773" actId="478"/>
          <ac:cxnSpMkLst>
            <pc:docMk/>
            <pc:sldMk cId="2335018827" sldId="302"/>
            <ac:cxnSpMk id="416" creationId="{55967580-8E39-4211-B4A3-6C3B4CF47900}"/>
          </ac:cxnSpMkLst>
        </pc:cxnChg>
        <pc:cxnChg chg="mod">
          <ac:chgData name="Filippo Acconcia" userId="844af49c-a8a0-47ac-a7dd-14a44b60cd18" providerId="ADAL" clId="{4E01D738-D0C1-4B9B-B836-CF053EEC4C53}" dt="2022-03-16T08:16:14.931" v="417"/>
          <ac:cxnSpMkLst>
            <pc:docMk/>
            <pc:sldMk cId="2335018827" sldId="302"/>
            <ac:cxnSpMk id="455" creationId="{614EDCF2-9E92-4DE1-90DD-932977E47C22}"/>
          </ac:cxnSpMkLst>
        </pc:cxnChg>
        <pc:cxnChg chg="mod">
          <ac:chgData name="Filippo Acconcia" userId="844af49c-a8a0-47ac-a7dd-14a44b60cd18" providerId="ADAL" clId="{4E01D738-D0C1-4B9B-B836-CF053EEC4C53}" dt="2022-03-16T08:16:14.931" v="417"/>
          <ac:cxnSpMkLst>
            <pc:docMk/>
            <pc:sldMk cId="2335018827" sldId="302"/>
            <ac:cxnSpMk id="456" creationId="{3623DDA3-56D9-4897-9D55-C82FE1AFEBD1}"/>
          </ac:cxnSpMkLst>
        </pc:cxnChg>
        <pc:cxnChg chg="mod">
          <ac:chgData name="Filippo Acconcia" userId="844af49c-a8a0-47ac-a7dd-14a44b60cd18" providerId="ADAL" clId="{4E01D738-D0C1-4B9B-B836-CF053EEC4C53}" dt="2022-03-16T08:16:14.931" v="417"/>
          <ac:cxnSpMkLst>
            <pc:docMk/>
            <pc:sldMk cId="2335018827" sldId="302"/>
            <ac:cxnSpMk id="457" creationId="{B53E06F9-08E4-4E4D-AFC5-7729D50D940E}"/>
          </ac:cxnSpMkLst>
        </pc:cxnChg>
        <pc:cxnChg chg="mod">
          <ac:chgData name="Filippo Acconcia" userId="844af49c-a8a0-47ac-a7dd-14a44b60cd18" providerId="ADAL" clId="{4E01D738-D0C1-4B9B-B836-CF053EEC4C53}" dt="2022-03-16T08:16:14.931" v="417"/>
          <ac:cxnSpMkLst>
            <pc:docMk/>
            <pc:sldMk cId="2335018827" sldId="302"/>
            <ac:cxnSpMk id="458" creationId="{4A95B19C-62B1-44E8-9B69-008C4BAE16A5}"/>
          </ac:cxnSpMkLst>
        </pc:cxnChg>
        <pc:cxnChg chg="mod">
          <ac:chgData name="Filippo Acconcia" userId="844af49c-a8a0-47ac-a7dd-14a44b60cd18" providerId="ADAL" clId="{4E01D738-D0C1-4B9B-B836-CF053EEC4C53}" dt="2022-03-16T08:16:14.931" v="417"/>
          <ac:cxnSpMkLst>
            <pc:docMk/>
            <pc:sldMk cId="2335018827" sldId="302"/>
            <ac:cxnSpMk id="459" creationId="{5E47505B-99D9-4B60-AD39-AD768ED18FBB}"/>
          </ac:cxnSpMkLst>
        </pc:cxnChg>
        <pc:cxnChg chg="mod">
          <ac:chgData name="Filippo Acconcia" userId="844af49c-a8a0-47ac-a7dd-14a44b60cd18" providerId="ADAL" clId="{4E01D738-D0C1-4B9B-B836-CF053EEC4C53}" dt="2022-03-16T08:16:14.931" v="417"/>
          <ac:cxnSpMkLst>
            <pc:docMk/>
            <pc:sldMk cId="2335018827" sldId="302"/>
            <ac:cxnSpMk id="464" creationId="{693F8CE1-BB47-429D-8381-AB7140C78B0A}"/>
          </ac:cxnSpMkLst>
        </pc:cxnChg>
        <pc:cxnChg chg="mod">
          <ac:chgData name="Filippo Acconcia" userId="844af49c-a8a0-47ac-a7dd-14a44b60cd18" providerId="ADAL" clId="{4E01D738-D0C1-4B9B-B836-CF053EEC4C53}" dt="2022-03-16T08:16:14.931" v="417"/>
          <ac:cxnSpMkLst>
            <pc:docMk/>
            <pc:sldMk cId="2335018827" sldId="302"/>
            <ac:cxnSpMk id="503" creationId="{078A0155-47AA-4136-8469-BE80C741ADEA}"/>
          </ac:cxnSpMkLst>
        </pc:cxnChg>
        <pc:cxnChg chg="mod">
          <ac:chgData name="Filippo Acconcia" userId="844af49c-a8a0-47ac-a7dd-14a44b60cd18" providerId="ADAL" clId="{4E01D738-D0C1-4B9B-B836-CF053EEC4C53}" dt="2022-03-16T08:16:14.931" v="417"/>
          <ac:cxnSpMkLst>
            <pc:docMk/>
            <pc:sldMk cId="2335018827" sldId="302"/>
            <ac:cxnSpMk id="504" creationId="{3A4BED68-420F-41F1-9BFD-5458D2305076}"/>
          </ac:cxnSpMkLst>
        </pc:cxnChg>
        <pc:cxnChg chg="mod">
          <ac:chgData name="Filippo Acconcia" userId="844af49c-a8a0-47ac-a7dd-14a44b60cd18" providerId="ADAL" clId="{4E01D738-D0C1-4B9B-B836-CF053EEC4C53}" dt="2022-03-16T08:16:14.931" v="417"/>
          <ac:cxnSpMkLst>
            <pc:docMk/>
            <pc:sldMk cId="2335018827" sldId="302"/>
            <ac:cxnSpMk id="505" creationId="{9F3A69AE-AC55-41DB-A868-08A116A5E23F}"/>
          </ac:cxnSpMkLst>
        </pc:cxnChg>
        <pc:cxnChg chg="mod">
          <ac:chgData name="Filippo Acconcia" userId="844af49c-a8a0-47ac-a7dd-14a44b60cd18" providerId="ADAL" clId="{4E01D738-D0C1-4B9B-B836-CF053EEC4C53}" dt="2022-03-16T08:16:14.931" v="417"/>
          <ac:cxnSpMkLst>
            <pc:docMk/>
            <pc:sldMk cId="2335018827" sldId="302"/>
            <ac:cxnSpMk id="506" creationId="{94DEFE61-7A3D-4D6C-A451-4C343F5E8011}"/>
          </ac:cxnSpMkLst>
        </pc:cxnChg>
        <pc:cxnChg chg="mod">
          <ac:chgData name="Filippo Acconcia" userId="844af49c-a8a0-47ac-a7dd-14a44b60cd18" providerId="ADAL" clId="{4E01D738-D0C1-4B9B-B836-CF053EEC4C53}" dt="2022-03-16T08:16:14.931" v="417"/>
          <ac:cxnSpMkLst>
            <pc:docMk/>
            <pc:sldMk cId="2335018827" sldId="302"/>
            <ac:cxnSpMk id="507" creationId="{783F961C-427C-414F-9BA9-B3CE115AC196}"/>
          </ac:cxnSpMkLst>
        </pc:cxnChg>
        <pc:cxnChg chg="mod">
          <ac:chgData name="Filippo Acconcia" userId="844af49c-a8a0-47ac-a7dd-14a44b60cd18" providerId="ADAL" clId="{4E01D738-D0C1-4B9B-B836-CF053EEC4C53}" dt="2022-03-16T08:16:14.931" v="417"/>
          <ac:cxnSpMkLst>
            <pc:docMk/>
            <pc:sldMk cId="2335018827" sldId="302"/>
            <ac:cxnSpMk id="512" creationId="{027AD64A-AD44-414C-82E5-DD5C0735FD4D}"/>
          </ac:cxnSpMkLst>
        </pc:cxnChg>
        <pc:cxnChg chg="mod">
          <ac:chgData name="Filippo Acconcia" userId="844af49c-a8a0-47ac-a7dd-14a44b60cd18" providerId="ADAL" clId="{4E01D738-D0C1-4B9B-B836-CF053EEC4C53}" dt="2022-03-16T08:40:05.670" v="774"/>
          <ac:cxnSpMkLst>
            <pc:docMk/>
            <pc:sldMk cId="2335018827" sldId="302"/>
            <ac:cxnSpMk id="564" creationId="{3E5A0A9B-A2EB-4ACA-A42E-8014F6A600F0}"/>
          </ac:cxnSpMkLst>
        </pc:cxnChg>
        <pc:cxnChg chg="mod">
          <ac:chgData name="Filippo Acconcia" userId="844af49c-a8a0-47ac-a7dd-14a44b60cd18" providerId="ADAL" clId="{4E01D738-D0C1-4B9B-B836-CF053EEC4C53}" dt="2022-03-16T08:40:05.670" v="774"/>
          <ac:cxnSpMkLst>
            <pc:docMk/>
            <pc:sldMk cId="2335018827" sldId="302"/>
            <ac:cxnSpMk id="565" creationId="{2687C28F-84A3-465A-9977-0B362F62D1EC}"/>
          </ac:cxnSpMkLst>
        </pc:cxnChg>
        <pc:cxnChg chg="mod">
          <ac:chgData name="Filippo Acconcia" userId="844af49c-a8a0-47ac-a7dd-14a44b60cd18" providerId="ADAL" clId="{4E01D738-D0C1-4B9B-B836-CF053EEC4C53}" dt="2022-03-16T08:40:05.670" v="774"/>
          <ac:cxnSpMkLst>
            <pc:docMk/>
            <pc:sldMk cId="2335018827" sldId="302"/>
            <ac:cxnSpMk id="566" creationId="{0D056DAF-4CF1-40FA-B200-3E202335E028}"/>
          </ac:cxnSpMkLst>
        </pc:cxnChg>
        <pc:cxnChg chg="mod">
          <ac:chgData name="Filippo Acconcia" userId="844af49c-a8a0-47ac-a7dd-14a44b60cd18" providerId="ADAL" clId="{4E01D738-D0C1-4B9B-B836-CF053EEC4C53}" dt="2022-03-16T08:40:05.670" v="774"/>
          <ac:cxnSpMkLst>
            <pc:docMk/>
            <pc:sldMk cId="2335018827" sldId="302"/>
            <ac:cxnSpMk id="567" creationId="{32B69136-63EA-4BB0-B268-61CD14FFAC0B}"/>
          </ac:cxnSpMkLst>
        </pc:cxnChg>
        <pc:cxnChg chg="mod">
          <ac:chgData name="Filippo Acconcia" userId="844af49c-a8a0-47ac-a7dd-14a44b60cd18" providerId="ADAL" clId="{4E01D738-D0C1-4B9B-B836-CF053EEC4C53}" dt="2022-03-16T08:40:05.670" v="774"/>
          <ac:cxnSpMkLst>
            <pc:docMk/>
            <pc:sldMk cId="2335018827" sldId="302"/>
            <ac:cxnSpMk id="568" creationId="{3DFD4DE8-93E0-4493-A579-BFDBAF683359}"/>
          </ac:cxnSpMkLst>
        </pc:cxnChg>
        <pc:cxnChg chg="mod">
          <ac:chgData name="Filippo Acconcia" userId="844af49c-a8a0-47ac-a7dd-14a44b60cd18" providerId="ADAL" clId="{4E01D738-D0C1-4B9B-B836-CF053EEC4C53}" dt="2022-03-16T08:40:05.670" v="774"/>
          <ac:cxnSpMkLst>
            <pc:docMk/>
            <pc:sldMk cId="2335018827" sldId="302"/>
            <ac:cxnSpMk id="573" creationId="{93E915FA-1CA2-4366-A9B2-1D6A0C9B0A41}"/>
          </ac:cxnSpMkLst>
        </pc:cxnChg>
        <pc:cxnChg chg="mod topLvl">
          <ac:chgData name="Filippo Acconcia" userId="844af49c-a8a0-47ac-a7dd-14a44b60cd18" providerId="ADAL" clId="{4E01D738-D0C1-4B9B-B836-CF053EEC4C53}" dt="2022-03-16T08:42:22.602" v="831" actId="164"/>
          <ac:cxnSpMkLst>
            <pc:docMk/>
            <pc:sldMk cId="2335018827" sldId="302"/>
            <ac:cxnSpMk id="608" creationId="{A7D0EA16-28A7-4592-90C8-DAA7DEE3F3BD}"/>
          </ac:cxnSpMkLst>
        </pc:cxnChg>
        <pc:cxnChg chg="mod topLvl">
          <ac:chgData name="Filippo Acconcia" userId="844af49c-a8a0-47ac-a7dd-14a44b60cd18" providerId="ADAL" clId="{4E01D738-D0C1-4B9B-B836-CF053EEC4C53}" dt="2022-03-16T08:42:22.602" v="831" actId="164"/>
          <ac:cxnSpMkLst>
            <pc:docMk/>
            <pc:sldMk cId="2335018827" sldId="302"/>
            <ac:cxnSpMk id="609" creationId="{450C561C-7B1F-4A18-B82E-07437B9C9BE1}"/>
          </ac:cxnSpMkLst>
        </pc:cxnChg>
        <pc:cxnChg chg="mod topLvl">
          <ac:chgData name="Filippo Acconcia" userId="844af49c-a8a0-47ac-a7dd-14a44b60cd18" providerId="ADAL" clId="{4E01D738-D0C1-4B9B-B836-CF053EEC4C53}" dt="2022-03-16T08:42:22.602" v="831" actId="164"/>
          <ac:cxnSpMkLst>
            <pc:docMk/>
            <pc:sldMk cId="2335018827" sldId="302"/>
            <ac:cxnSpMk id="610" creationId="{575637B9-05A3-4950-A3A7-56C07760582E}"/>
          </ac:cxnSpMkLst>
        </pc:cxnChg>
        <pc:cxnChg chg="mod topLvl">
          <ac:chgData name="Filippo Acconcia" userId="844af49c-a8a0-47ac-a7dd-14a44b60cd18" providerId="ADAL" clId="{4E01D738-D0C1-4B9B-B836-CF053EEC4C53}" dt="2022-03-16T08:42:22.602" v="831" actId="164"/>
          <ac:cxnSpMkLst>
            <pc:docMk/>
            <pc:sldMk cId="2335018827" sldId="302"/>
            <ac:cxnSpMk id="611" creationId="{221DB1F5-4C86-47EA-87C0-57EF41B40492}"/>
          </ac:cxnSpMkLst>
        </pc:cxnChg>
        <pc:cxnChg chg="mod topLvl">
          <ac:chgData name="Filippo Acconcia" userId="844af49c-a8a0-47ac-a7dd-14a44b60cd18" providerId="ADAL" clId="{4E01D738-D0C1-4B9B-B836-CF053EEC4C53}" dt="2022-03-16T08:42:22.602" v="831" actId="164"/>
          <ac:cxnSpMkLst>
            <pc:docMk/>
            <pc:sldMk cId="2335018827" sldId="302"/>
            <ac:cxnSpMk id="612" creationId="{B8DAF2B6-9DB8-47C7-BFD9-86B0B0E591EB}"/>
          </ac:cxnSpMkLst>
        </pc:cxnChg>
        <pc:cxnChg chg="mod topLvl">
          <ac:chgData name="Filippo Acconcia" userId="844af49c-a8a0-47ac-a7dd-14a44b60cd18" providerId="ADAL" clId="{4E01D738-D0C1-4B9B-B836-CF053EEC4C53}" dt="2022-03-16T08:42:22.602" v="831" actId="164"/>
          <ac:cxnSpMkLst>
            <pc:docMk/>
            <pc:sldMk cId="2335018827" sldId="302"/>
            <ac:cxnSpMk id="617" creationId="{FD133923-3095-4010-9F54-412015A01B2D}"/>
          </ac:cxnSpMkLst>
        </pc:cxnChg>
        <pc:cxnChg chg="mod">
          <ac:chgData name="Filippo Acconcia" userId="844af49c-a8a0-47ac-a7dd-14a44b60cd18" providerId="ADAL" clId="{4E01D738-D0C1-4B9B-B836-CF053EEC4C53}" dt="2022-03-16T08:48:20.860" v="833"/>
          <ac:cxnSpMkLst>
            <pc:docMk/>
            <pc:sldMk cId="2335018827" sldId="302"/>
            <ac:cxnSpMk id="630" creationId="{FF1B9C34-FE62-4181-9956-90C7958BF730}"/>
          </ac:cxnSpMkLst>
        </pc:cxnChg>
        <pc:cxnChg chg="mod">
          <ac:chgData name="Filippo Acconcia" userId="844af49c-a8a0-47ac-a7dd-14a44b60cd18" providerId="ADAL" clId="{4E01D738-D0C1-4B9B-B836-CF053EEC4C53}" dt="2022-03-16T08:48:20.860" v="833"/>
          <ac:cxnSpMkLst>
            <pc:docMk/>
            <pc:sldMk cId="2335018827" sldId="302"/>
            <ac:cxnSpMk id="631" creationId="{52A8BC37-2FF7-4E87-9905-56883B6C75B7}"/>
          </ac:cxnSpMkLst>
        </pc:cxnChg>
        <pc:cxnChg chg="mod">
          <ac:chgData name="Filippo Acconcia" userId="844af49c-a8a0-47ac-a7dd-14a44b60cd18" providerId="ADAL" clId="{4E01D738-D0C1-4B9B-B836-CF053EEC4C53}" dt="2022-03-16T08:48:20.860" v="833"/>
          <ac:cxnSpMkLst>
            <pc:docMk/>
            <pc:sldMk cId="2335018827" sldId="302"/>
            <ac:cxnSpMk id="632" creationId="{00CF9B13-34A0-452D-BCAE-A2ABAA87A04B}"/>
          </ac:cxnSpMkLst>
        </pc:cxnChg>
        <pc:cxnChg chg="mod">
          <ac:chgData name="Filippo Acconcia" userId="844af49c-a8a0-47ac-a7dd-14a44b60cd18" providerId="ADAL" clId="{4E01D738-D0C1-4B9B-B836-CF053EEC4C53}" dt="2022-03-16T08:48:20.860" v="833"/>
          <ac:cxnSpMkLst>
            <pc:docMk/>
            <pc:sldMk cId="2335018827" sldId="302"/>
            <ac:cxnSpMk id="633" creationId="{492EBEB2-4462-45F6-BC73-1D87BB899024}"/>
          </ac:cxnSpMkLst>
        </pc:cxnChg>
        <pc:cxnChg chg="mod">
          <ac:chgData name="Filippo Acconcia" userId="844af49c-a8a0-47ac-a7dd-14a44b60cd18" providerId="ADAL" clId="{4E01D738-D0C1-4B9B-B836-CF053EEC4C53}" dt="2022-03-16T08:48:20.860" v="833"/>
          <ac:cxnSpMkLst>
            <pc:docMk/>
            <pc:sldMk cId="2335018827" sldId="302"/>
            <ac:cxnSpMk id="634" creationId="{3673D0D4-9287-4B69-A2AF-4857FAE132F8}"/>
          </ac:cxnSpMkLst>
        </pc:cxnChg>
        <pc:cxnChg chg="mod">
          <ac:chgData name="Filippo Acconcia" userId="844af49c-a8a0-47ac-a7dd-14a44b60cd18" providerId="ADAL" clId="{4E01D738-D0C1-4B9B-B836-CF053EEC4C53}" dt="2022-03-16T08:48:20.860" v="833"/>
          <ac:cxnSpMkLst>
            <pc:docMk/>
            <pc:sldMk cId="2335018827" sldId="302"/>
            <ac:cxnSpMk id="639" creationId="{A15BE080-6580-42D1-A5C2-7FF16D8F7F24}"/>
          </ac:cxnSpMkLst>
        </pc:cxnChg>
      </pc:sldChg>
      <pc:sldChg chg="addSp delSp modSp new mod">
        <pc:chgData name="Filippo Acconcia" userId="844af49c-a8a0-47ac-a7dd-14a44b60cd18" providerId="ADAL" clId="{4E01D738-D0C1-4B9B-B836-CF053EEC4C53}" dt="2022-03-16T11:02:30.010" v="1634" actId="554"/>
        <pc:sldMkLst>
          <pc:docMk/>
          <pc:sldMk cId="2336920806" sldId="303"/>
        </pc:sldMkLst>
        <pc:spChg chg="add mod">
          <ac:chgData name="Filippo Acconcia" userId="844af49c-a8a0-47ac-a7dd-14a44b60cd18" providerId="ADAL" clId="{4E01D738-D0C1-4B9B-B836-CF053EEC4C53}" dt="2022-03-16T08:16:25.901" v="421" actId="20577"/>
          <ac:spMkLst>
            <pc:docMk/>
            <pc:sldMk cId="2336920806" sldId="303"/>
            <ac:spMk id="2" creationId="{49806123-6EB8-4F24-94BE-1C0DBFF7ED11}"/>
          </ac:spMkLst>
        </pc:spChg>
        <pc:spChg chg="del mod topLvl">
          <ac:chgData name="Filippo Acconcia" userId="844af49c-a8a0-47ac-a7dd-14a44b60cd18" providerId="ADAL" clId="{4E01D738-D0C1-4B9B-B836-CF053EEC4C53}" dt="2022-03-16T10:19:13.468" v="1182" actId="478"/>
          <ac:spMkLst>
            <pc:docMk/>
            <pc:sldMk cId="2336920806" sldId="303"/>
            <ac:spMk id="5" creationId="{1EB6B2A0-D2CD-4235-A79F-5490ABB436DD}"/>
          </ac:spMkLst>
        </pc:spChg>
        <pc:spChg chg="del mod topLvl">
          <ac:chgData name="Filippo Acconcia" userId="844af49c-a8a0-47ac-a7dd-14a44b60cd18" providerId="ADAL" clId="{4E01D738-D0C1-4B9B-B836-CF053EEC4C53}" dt="2022-03-16T10:19:13.468" v="1182" actId="478"/>
          <ac:spMkLst>
            <pc:docMk/>
            <pc:sldMk cId="2336920806" sldId="303"/>
            <ac:spMk id="6" creationId="{4FDBAEC0-81D8-4206-81A5-E2646125190C}"/>
          </ac:spMkLst>
        </pc:spChg>
        <pc:spChg chg="mod topLvl">
          <ac:chgData name="Filippo Acconcia" userId="844af49c-a8a0-47ac-a7dd-14a44b60cd18" providerId="ADAL" clId="{4E01D738-D0C1-4B9B-B836-CF053EEC4C53}" dt="2022-03-16T10:17:10.919" v="1161" actId="164"/>
          <ac:spMkLst>
            <pc:docMk/>
            <pc:sldMk cId="2336920806" sldId="303"/>
            <ac:spMk id="7" creationId="{0DDFF897-6DE9-4FFF-BC49-32018AD6B99F}"/>
          </ac:spMkLst>
        </pc:spChg>
        <pc:spChg chg="del mod topLvl">
          <ac:chgData name="Filippo Acconcia" userId="844af49c-a8a0-47ac-a7dd-14a44b60cd18" providerId="ADAL" clId="{4E01D738-D0C1-4B9B-B836-CF053EEC4C53}" dt="2022-03-16T10:19:13.468" v="1182" actId="478"/>
          <ac:spMkLst>
            <pc:docMk/>
            <pc:sldMk cId="2336920806" sldId="303"/>
            <ac:spMk id="8" creationId="{B71EA32A-00D2-446C-B30D-97111332BC3B}"/>
          </ac:spMkLst>
        </pc:spChg>
        <pc:spChg chg="del mod topLvl">
          <ac:chgData name="Filippo Acconcia" userId="844af49c-a8a0-47ac-a7dd-14a44b60cd18" providerId="ADAL" clId="{4E01D738-D0C1-4B9B-B836-CF053EEC4C53}" dt="2022-03-16T10:19:13.468" v="1182" actId="478"/>
          <ac:spMkLst>
            <pc:docMk/>
            <pc:sldMk cId="2336920806" sldId="303"/>
            <ac:spMk id="9" creationId="{3847E1DB-0B31-4F40-B498-C18BFBF0920F}"/>
          </ac:spMkLst>
        </pc:spChg>
        <pc:spChg chg="del mod topLvl">
          <ac:chgData name="Filippo Acconcia" userId="844af49c-a8a0-47ac-a7dd-14a44b60cd18" providerId="ADAL" clId="{4E01D738-D0C1-4B9B-B836-CF053EEC4C53}" dt="2022-03-16T10:13:36.388" v="1060" actId="478"/>
          <ac:spMkLst>
            <pc:docMk/>
            <pc:sldMk cId="2336920806" sldId="303"/>
            <ac:spMk id="11" creationId="{6E12AB84-F948-46E8-AADB-3456B9B5BAE3}"/>
          </ac:spMkLst>
        </pc:spChg>
        <pc:spChg chg="del mod topLvl">
          <ac:chgData name="Filippo Acconcia" userId="844af49c-a8a0-47ac-a7dd-14a44b60cd18" providerId="ADAL" clId="{4E01D738-D0C1-4B9B-B836-CF053EEC4C53}" dt="2022-03-16T10:13:36.388" v="1060" actId="478"/>
          <ac:spMkLst>
            <pc:docMk/>
            <pc:sldMk cId="2336920806" sldId="303"/>
            <ac:spMk id="12" creationId="{EA55D9DA-F933-442A-83A5-F0E9D0C30374}"/>
          </ac:spMkLst>
        </pc:spChg>
        <pc:spChg chg="del mod topLvl">
          <ac:chgData name="Filippo Acconcia" userId="844af49c-a8a0-47ac-a7dd-14a44b60cd18" providerId="ADAL" clId="{4E01D738-D0C1-4B9B-B836-CF053EEC4C53}" dt="2022-03-16T10:13:36.388" v="1060" actId="478"/>
          <ac:spMkLst>
            <pc:docMk/>
            <pc:sldMk cId="2336920806" sldId="303"/>
            <ac:spMk id="13" creationId="{829DF642-D6B7-40A0-A45F-9E433E02E550}"/>
          </ac:spMkLst>
        </pc:spChg>
        <pc:spChg chg="del mod topLvl">
          <ac:chgData name="Filippo Acconcia" userId="844af49c-a8a0-47ac-a7dd-14a44b60cd18" providerId="ADAL" clId="{4E01D738-D0C1-4B9B-B836-CF053EEC4C53}" dt="2022-03-16T10:13:36.388" v="1060" actId="478"/>
          <ac:spMkLst>
            <pc:docMk/>
            <pc:sldMk cId="2336920806" sldId="303"/>
            <ac:spMk id="14" creationId="{36B1634B-5CB1-4196-8E60-EF8E1FFAE431}"/>
          </ac:spMkLst>
        </pc:spChg>
        <pc:spChg chg="mod topLvl">
          <ac:chgData name="Filippo Acconcia" userId="844af49c-a8a0-47ac-a7dd-14a44b60cd18" providerId="ADAL" clId="{4E01D738-D0C1-4B9B-B836-CF053EEC4C53}" dt="2022-03-16T10:17:10.919" v="1161" actId="164"/>
          <ac:spMkLst>
            <pc:docMk/>
            <pc:sldMk cId="2336920806" sldId="303"/>
            <ac:spMk id="15" creationId="{922710B2-5EED-40E6-9D11-04568DBCAF8A}"/>
          </ac:spMkLst>
        </pc:spChg>
        <pc:spChg chg="mod topLvl">
          <ac:chgData name="Filippo Acconcia" userId="844af49c-a8a0-47ac-a7dd-14a44b60cd18" providerId="ADAL" clId="{4E01D738-D0C1-4B9B-B836-CF053EEC4C53}" dt="2022-03-16T10:14:07.082" v="1073" actId="164"/>
          <ac:spMkLst>
            <pc:docMk/>
            <pc:sldMk cId="2336920806" sldId="303"/>
            <ac:spMk id="17" creationId="{724583B1-F84C-4575-AAF5-393BDE32F3C6}"/>
          </ac:spMkLst>
        </pc:spChg>
        <pc:spChg chg="mod topLvl">
          <ac:chgData name="Filippo Acconcia" userId="844af49c-a8a0-47ac-a7dd-14a44b60cd18" providerId="ADAL" clId="{4E01D738-D0C1-4B9B-B836-CF053EEC4C53}" dt="2022-03-16T10:14:07.082" v="1073" actId="164"/>
          <ac:spMkLst>
            <pc:docMk/>
            <pc:sldMk cId="2336920806" sldId="303"/>
            <ac:spMk id="18" creationId="{B08FEB7C-6C81-4BA4-A0C2-BCEB60BAF4DC}"/>
          </ac:spMkLst>
        </pc:spChg>
        <pc:spChg chg="mod topLvl">
          <ac:chgData name="Filippo Acconcia" userId="844af49c-a8a0-47ac-a7dd-14a44b60cd18" providerId="ADAL" clId="{4E01D738-D0C1-4B9B-B836-CF053EEC4C53}" dt="2022-03-16T10:14:07.082" v="1073" actId="164"/>
          <ac:spMkLst>
            <pc:docMk/>
            <pc:sldMk cId="2336920806" sldId="303"/>
            <ac:spMk id="19" creationId="{3C1B3FDA-9C98-4F1F-8218-E2ACB970C6E6}"/>
          </ac:spMkLst>
        </pc:spChg>
        <pc:spChg chg="mod topLvl">
          <ac:chgData name="Filippo Acconcia" userId="844af49c-a8a0-47ac-a7dd-14a44b60cd18" providerId="ADAL" clId="{4E01D738-D0C1-4B9B-B836-CF053EEC4C53}" dt="2022-03-16T10:14:07.082" v="1073" actId="164"/>
          <ac:spMkLst>
            <pc:docMk/>
            <pc:sldMk cId="2336920806" sldId="303"/>
            <ac:spMk id="20" creationId="{0ADD6E72-A098-4FF9-AF10-634FED87F6CE}"/>
          </ac:spMkLst>
        </pc:spChg>
        <pc:spChg chg="mod topLvl">
          <ac:chgData name="Filippo Acconcia" userId="844af49c-a8a0-47ac-a7dd-14a44b60cd18" providerId="ADAL" clId="{4E01D738-D0C1-4B9B-B836-CF053EEC4C53}" dt="2022-03-16T10:17:10.919" v="1161" actId="164"/>
          <ac:spMkLst>
            <pc:docMk/>
            <pc:sldMk cId="2336920806" sldId="303"/>
            <ac:spMk id="21" creationId="{E354511C-C467-4213-910F-8DD58C101524}"/>
          </ac:spMkLst>
        </pc:spChg>
        <pc:spChg chg="del mod topLvl">
          <ac:chgData name="Filippo Acconcia" userId="844af49c-a8a0-47ac-a7dd-14a44b60cd18" providerId="ADAL" clId="{4E01D738-D0C1-4B9B-B836-CF053EEC4C53}" dt="2022-03-16T10:13:36.388" v="1060" actId="478"/>
          <ac:spMkLst>
            <pc:docMk/>
            <pc:sldMk cId="2336920806" sldId="303"/>
            <ac:spMk id="23" creationId="{19995C9C-0C4D-4A17-8CBE-B0E748696A5D}"/>
          </ac:spMkLst>
        </pc:spChg>
        <pc:spChg chg="del mod topLvl">
          <ac:chgData name="Filippo Acconcia" userId="844af49c-a8a0-47ac-a7dd-14a44b60cd18" providerId="ADAL" clId="{4E01D738-D0C1-4B9B-B836-CF053EEC4C53}" dt="2022-03-16T10:13:36.388" v="1060" actId="478"/>
          <ac:spMkLst>
            <pc:docMk/>
            <pc:sldMk cId="2336920806" sldId="303"/>
            <ac:spMk id="24" creationId="{573632B6-0FE4-4181-8DCA-7E673E78F452}"/>
          </ac:spMkLst>
        </pc:spChg>
        <pc:spChg chg="del mod topLvl">
          <ac:chgData name="Filippo Acconcia" userId="844af49c-a8a0-47ac-a7dd-14a44b60cd18" providerId="ADAL" clId="{4E01D738-D0C1-4B9B-B836-CF053EEC4C53}" dt="2022-03-16T10:13:36.388" v="1060" actId="478"/>
          <ac:spMkLst>
            <pc:docMk/>
            <pc:sldMk cId="2336920806" sldId="303"/>
            <ac:spMk id="25" creationId="{DD993E58-C8D0-42F6-830B-91E50B5CB29C}"/>
          </ac:spMkLst>
        </pc:spChg>
        <pc:spChg chg="del mod topLvl">
          <ac:chgData name="Filippo Acconcia" userId="844af49c-a8a0-47ac-a7dd-14a44b60cd18" providerId="ADAL" clId="{4E01D738-D0C1-4B9B-B836-CF053EEC4C53}" dt="2022-03-16T10:13:36.388" v="1060" actId="478"/>
          <ac:spMkLst>
            <pc:docMk/>
            <pc:sldMk cId="2336920806" sldId="303"/>
            <ac:spMk id="26" creationId="{5E50C1BF-2D54-4EA6-962E-2551EEF0105B}"/>
          </ac:spMkLst>
        </pc:spChg>
        <pc:spChg chg="mod topLvl">
          <ac:chgData name="Filippo Acconcia" userId="844af49c-a8a0-47ac-a7dd-14a44b60cd18" providerId="ADAL" clId="{4E01D738-D0C1-4B9B-B836-CF053EEC4C53}" dt="2022-03-16T10:17:10.919" v="1161" actId="164"/>
          <ac:spMkLst>
            <pc:docMk/>
            <pc:sldMk cId="2336920806" sldId="303"/>
            <ac:spMk id="27" creationId="{4BB1EA8D-6450-4C1C-A6C3-436E48331EA3}"/>
          </ac:spMkLst>
        </pc:spChg>
        <pc:spChg chg="del mod topLvl">
          <ac:chgData name="Filippo Acconcia" userId="844af49c-a8a0-47ac-a7dd-14a44b60cd18" providerId="ADAL" clId="{4E01D738-D0C1-4B9B-B836-CF053EEC4C53}" dt="2022-03-16T10:13:36.388" v="1060" actId="478"/>
          <ac:spMkLst>
            <pc:docMk/>
            <pc:sldMk cId="2336920806" sldId="303"/>
            <ac:spMk id="29" creationId="{37B3A439-1585-46E7-A834-221F93590DF8}"/>
          </ac:spMkLst>
        </pc:spChg>
        <pc:spChg chg="del mod topLvl">
          <ac:chgData name="Filippo Acconcia" userId="844af49c-a8a0-47ac-a7dd-14a44b60cd18" providerId="ADAL" clId="{4E01D738-D0C1-4B9B-B836-CF053EEC4C53}" dt="2022-03-16T10:13:36.388" v="1060" actId="478"/>
          <ac:spMkLst>
            <pc:docMk/>
            <pc:sldMk cId="2336920806" sldId="303"/>
            <ac:spMk id="30" creationId="{A0CD436B-6649-48A7-8841-DE0F16968B09}"/>
          </ac:spMkLst>
        </pc:spChg>
        <pc:spChg chg="del mod topLvl">
          <ac:chgData name="Filippo Acconcia" userId="844af49c-a8a0-47ac-a7dd-14a44b60cd18" providerId="ADAL" clId="{4E01D738-D0C1-4B9B-B836-CF053EEC4C53}" dt="2022-03-16T10:13:36.388" v="1060" actId="478"/>
          <ac:spMkLst>
            <pc:docMk/>
            <pc:sldMk cId="2336920806" sldId="303"/>
            <ac:spMk id="31" creationId="{80093536-B29F-40EE-AA2D-C21AC5F9008E}"/>
          </ac:spMkLst>
        </pc:spChg>
        <pc:spChg chg="del mod topLvl">
          <ac:chgData name="Filippo Acconcia" userId="844af49c-a8a0-47ac-a7dd-14a44b60cd18" providerId="ADAL" clId="{4E01D738-D0C1-4B9B-B836-CF053EEC4C53}" dt="2022-03-16T10:13:36.388" v="1060" actId="478"/>
          <ac:spMkLst>
            <pc:docMk/>
            <pc:sldMk cId="2336920806" sldId="303"/>
            <ac:spMk id="32" creationId="{BE8356BB-9E9A-4291-A77C-2E002C07B811}"/>
          </ac:spMkLst>
        </pc:spChg>
        <pc:spChg chg="mod topLvl">
          <ac:chgData name="Filippo Acconcia" userId="844af49c-a8a0-47ac-a7dd-14a44b60cd18" providerId="ADAL" clId="{4E01D738-D0C1-4B9B-B836-CF053EEC4C53}" dt="2022-03-16T10:17:10.919" v="1161" actId="164"/>
          <ac:spMkLst>
            <pc:docMk/>
            <pc:sldMk cId="2336920806" sldId="303"/>
            <ac:spMk id="33" creationId="{F0D92F94-2A15-42A6-8E8C-B3B7B30413F6}"/>
          </ac:spMkLst>
        </pc:spChg>
        <pc:spChg chg="mod topLvl">
          <ac:chgData name="Filippo Acconcia" userId="844af49c-a8a0-47ac-a7dd-14a44b60cd18" providerId="ADAL" clId="{4E01D738-D0C1-4B9B-B836-CF053EEC4C53}" dt="2022-03-16T10:14:23.147" v="1080" actId="164"/>
          <ac:spMkLst>
            <pc:docMk/>
            <pc:sldMk cId="2336920806" sldId="303"/>
            <ac:spMk id="35" creationId="{2CE14159-01AE-44EF-BB29-89C261C6E4B4}"/>
          </ac:spMkLst>
        </pc:spChg>
        <pc:spChg chg="mod topLvl">
          <ac:chgData name="Filippo Acconcia" userId="844af49c-a8a0-47ac-a7dd-14a44b60cd18" providerId="ADAL" clId="{4E01D738-D0C1-4B9B-B836-CF053EEC4C53}" dt="2022-03-16T10:14:23.147" v="1080" actId="164"/>
          <ac:spMkLst>
            <pc:docMk/>
            <pc:sldMk cId="2336920806" sldId="303"/>
            <ac:spMk id="36" creationId="{F8C4383D-DFE7-4746-B2D7-A8C449044141}"/>
          </ac:spMkLst>
        </pc:spChg>
        <pc:spChg chg="mod topLvl">
          <ac:chgData name="Filippo Acconcia" userId="844af49c-a8a0-47ac-a7dd-14a44b60cd18" providerId="ADAL" clId="{4E01D738-D0C1-4B9B-B836-CF053EEC4C53}" dt="2022-03-16T10:14:23.147" v="1080" actId="164"/>
          <ac:spMkLst>
            <pc:docMk/>
            <pc:sldMk cId="2336920806" sldId="303"/>
            <ac:spMk id="37" creationId="{F3FF3AB5-9BB7-41B2-A33B-1E0BFB02160D}"/>
          </ac:spMkLst>
        </pc:spChg>
        <pc:spChg chg="mod topLvl">
          <ac:chgData name="Filippo Acconcia" userId="844af49c-a8a0-47ac-a7dd-14a44b60cd18" providerId="ADAL" clId="{4E01D738-D0C1-4B9B-B836-CF053EEC4C53}" dt="2022-03-16T10:14:23.147" v="1080" actId="164"/>
          <ac:spMkLst>
            <pc:docMk/>
            <pc:sldMk cId="2336920806" sldId="303"/>
            <ac:spMk id="38" creationId="{B80AC9C6-43F7-480D-B70A-572451654237}"/>
          </ac:spMkLst>
        </pc:spChg>
        <pc:spChg chg="mod topLvl">
          <ac:chgData name="Filippo Acconcia" userId="844af49c-a8a0-47ac-a7dd-14a44b60cd18" providerId="ADAL" clId="{4E01D738-D0C1-4B9B-B836-CF053EEC4C53}" dt="2022-03-16T10:17:10.919" v="1161" actId="164"/>
          <ac:spMkLst>
            <pc:docMk/>
            <pc:sldMk cId="2336920806" sldId="303"/>
            <ac:spMk id="39" creationId="{28C9C284-F8CD-4DAC-ADAE-AC2EF0AD05F6}"/>
          </ac:spMkLst>
        </pc:spChg>
        <pc:spChg chg="mod">
          <ac:chgData name="Filippo Acconcia" userId="844af49c-a8a0-47ac-a7dd-14a44b60cd18" providerId="ADAL" clId="{4E01D738-D0C1-4B9B-B836-CF053EEC4C53}" dt="2022-03-16T10:10:56.038" v="954" actId="165"/>
          <ac:spMkLst>
            <pc:docMk/>
            <pc:sldMk cId="2336920806" sldId="303"/>
            <ac:spMk id="43" creationId="{4A80252F-B864-47B3-B8D5-0C319F24056F}"/>
          </ac:spMkLst>
        </pc:spChg>
        <pc:spChg chg="mod">
          <ac:chgData name="Filippo Acconcia" userId="844af49c-a8a0-47ac-a7dd-14a44b60cd18" providerId="ADAL" clId="{4E01D738-D0C1-4B9B-B836-CF053EEC4C53}" dt="2022-03-16T10:10:56.038" v="954" actId="165"/>
          <ac:spMkLst>
            <pc:docMk/>
            <pc:sldMk cId="2336920806" sldId="303"/>
            <ac:spMk id="44" creationId="{DFB4847B-69A7-42B9-8934-FB89A25CE3C7}"/>
          </ac:spMkLst>
        </pc:spChg>
        <pc:spChg chg="mod">
          <ac:chgData name="Filippo Acconcia" userId="844af49c-a8a0-47ac-a7dd-14a44b60cd18" providerId="ADAL" clId="{4E01D738-D0C1-4B9B-B836-CF053EEC4C53}" dt="2022-03-16T10:10:56.038" v="954" actId="165"/>
          <ac:spMkLst>
            <pc:docMk/>
            <pc:sldMk cId="2336920806" sldId="303"/>
            <ac:spMk id="45" creationId="{D029DC30-AEDB-4824-B7D6-7BE3C84C4AC5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48" creationId="{C55BB473-F770-45DA-BAC8-46EB2B04D725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49" creationId="{6B66538B-64D7-4848-8539-B07145902B9A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50" creationId="{08372740-CD91-487A-89BF-7FEC14B1413E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51" creationId="{C52DB5CA-ECC0-4663-B959-2144AEAF25CF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52" creationId="{33EEB2A6-4F5B-449F-97EE-4A9698277ED9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54" creationId="{76B8F541-B58F-4D0E-BF56-136B1D1B03DD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55" creationId="{FA81D87A-EDE6-4B42-A699-406FB61BFFF3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56" creationId="{5BDA1B7E-AF0F-476C-90F9-31638F7EBF5F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57" creationId="{E320C7AA-6D09-478B-9D04-E0B21C0C9962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58" creationId="{85479986-1354-4D15-9A2E-91295589DAF9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60" creationId="{7917606B-46B5-4CF7-9DA3-F47F1EA42B77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61" creationId="{1F1E5126-D46A-445C-AE73-3B70D94EFCBB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62" creationId="{7D957620-4FFE-4A1D-8DB8-71D60283D079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63" creationId="{1D9D3803-1585-4334-BDC7-E5FE13948073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64" creationId="{6DF578B1-B0B5-4CC9-ACBB-91AD7F45D435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66" creationId="{2A655EC7-E80C-4E75-AD97-0B9001469CA1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67" creationId="{0918B751-0035-4A0A-889A-6CA502AE341E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68" creationId="{DC9C81EC-03FE-4054-9275-15CB29FCD8BF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69" creationId="{38B60B1B-743C-4D89-A00C-F7D182FD6952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70" creationId="{C3A21BFB-7327-4274-9B13-00C4428FB851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72" creationId="{49F354E8-1BAB-4EE8-822D-5216B03518EB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73" creationId="{EA1B732D-9125-4F27-AC76-43635DE09EA9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74" creationId="{CD5C244A-7B33-4E14-B203-9EBD98B46C2B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75" creationId="{164824E3-BA1D-43C6-9ECC-5758C0364A8D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76" creationId="{4622D960-142F-4BFE-A5D0-B75BCBA5219B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78" creationId="{CB66DFD1-A3F1-41A9-9D19-C47F59A6C95F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79" creationId="{7A239410-D20F-4CD4-BA00-E1515B7E1A4B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80" creationId="{70660BEB-A0DD-42B1-AE91-AE6B36030BFD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81" creationId="{BAD4F926-238C-401C-A70D-5E3008176E79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82" creationId="{6126B79E-B617-400F-9502-E8E97F1A37C2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86" creationId="{248CC9CE-9F07-4E15-A60D-98D2F6CE529E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87" creationId="{1EC41766-65D0-4893-98A6-93F7E4C6E3A5}"/>
          </ac:spMkLst>
        </pc:spChg>
        <pc:spChg chg="mod">
          <ac:chgData name="Filippo Acconcia" userId="844af49c-a8a0-47ac-a7dd-14a44b60cd18" providerId="ADAL" clId="{4E01D738-D0C1-4B9B-B836-CF053EEC4C53}" dt="2022-03-16T10:08:21.535" v="944"/>
          <ac:spMkLst>
            <pc:docMk/>
            <pc:sldMk cId="2336920806" sldId="303"/>
            <ac:spMk id="88" creationId="{B868DF65-3E5F-465C-99D0-86C228FE54D3}"/>
          </ac:spMkLst>
        </pc:spChg>
        <pc:spChg chg="mod">
          <ac:chgData name="Filippo Acconcia" userId="844af49c-a8a0-47ac-a7dd-14a44b60cd18" providerId="ADAL" clId="{4E01D738-D0C1-4B9B-B836-CF053EEC4C53}" dt="2022-03-16T10:08:33.114" v="946"/>
          <ac:spMkLst>
            <pc:docMk/>
            <pc:sldMk cId="2336920806" sldId="303"/>
            <ac:spMk id="93" creationId="{6748AE60-53ED-4E98-8E6F-269890849C94}"/>
          </ac:spMkLst>
        </pc:spChg>
        <pc:spChg chg="mod">
          <ac:chgData name="Filippo Acconcia" userId="844af49c-a8a0-47ac-a7dd-14a44b60cd18" providerId="ADAL" clId="{4E01D738-D0C1-4B9B-B836-CF053EEC4C53}" dt="2022-03-16T10:08:33.114" v="946"/>
          <ac:spMkLst>
            <pc:docMk/>
            <pc:sldMk cId="2336920806" sldId="303"/>
            <ac:spMk id="94" creationId="{4DE8105D-4A36-4600-9B3C-B6776ADC3300}"/>
          </ac:spMkLst>
        </pc:spChg>
        <pc:spChg chg="mod">
          <ac:chgData name="Filippo Acconcia" userId="844af49c-a8a0-47ac-a7dd-14a44b60cd18" providerId="ADAL" clId="{4E01D738-D0C1-4B9B-B836-CF053EEC4C53}" dt="2022-03-16T10:08:33.114" v="946"/>
          <ac:spMkLst>
            <pc:docMk/>
            <pc:sldMk cId="2336920806" sldId="303"/>
            <ac:spMk id="95" creationId="{DFB83B0E-0A6D-4A4F-A189-D05E95423B30}"/>
          </ac:spMkLst>
        </pc:spChg>
        <pc:spChg chg="mod">
          <ac:chgData name="Filippo Acconcia" userId="844af49c-a8a0-47ac-a7dd-14a44b60cd18" providerId="ADAL" clId="{4E01D738-D0C1-4B9B-B836-CF053EEC4C53}" dt="2022-03-16T10:08:33.114" v="946"/>
          <ac:spMkLst>
            <pc:docMk/>
            <pc:sldMk cId="2336920806" sldId="303"/>
            <ac:spMk id="96" creationId="{BDCB38CA-CA5E-44E4-9512-1BACF23A62A0}"/>
          </ac:spMkLst>
        </pc:spChg>
        <pc:spChg chg="mod">
          <ac:chgData name="Filippo Acconcia" userId="844af49c-a8a0-47ac-a7dd-14a44b60cd18" providerId="ADAL" clId="{4E01D738-D0C1-4B9B-B836-CF053EEC4C53}" dt="2022-03-16T10:08:33.114" v="946"/>
          <ac:spMkLst>
            <pc:docMk/>
            <pc:sldMk cId="2336920806" sldId="303"/>
            <ac:spMk id="98" creationId="{BFCAAC42-3DF6-4D30-AD1E-925566F6834A}"/>
          </ac:spMkLst>
        </pc:spChg>
        <pc:spChg chg="mod">
          <ac:chgData name="Filippo Acconcia" userId="844af49c-a8a0-47ac-a7dd-14a44b60cd18" providerId="ADAL" clId="{4E01D738-D0C1-4B9B-B836-CF053EEC4C53}" dt="2022-03-16T10:08:33.114" v="946"/>
          <ac:spMkLst>
            <pc:docMk/>
            <pc:sldMk cId="2336920806" sldId="303"/>
            <ac:spMk id="99" creationId="{0E8AC7FC-7D05-4E45-B250-0F3CEF81C50A}"/>
          </ac:spMkLst>
        </pc:spChg>
        <pc:spChg chg="mod">
          <ac:chgData name="Filippo Acconcia" userId="844af49c-a8a0-47ac-a7dd-14a44b60cd18" providerId="ADAL" clId="{4E01D738-D0C1-4B9B-B836-CF053EEC4C53}" dt="2022-03-16T10:08:33.114" v="946"/>
          <ac:spMkLst>
            <pc:docMk/>
            <pc:sldMk cId="2336920806" sldId="303"/>
            <ac:spMk id="100" creationId="{46E29EDB-08AC-4FE5-A34F-293150C77D75}"/>
          </ac:spMkLst>
        </pc:spChg>
        <pc:spChg chg="mod">
          <ac:chgData name="Filippo Acconcia" userId="844af49c-a8a0-47ac-a7dd-14a44b60cd18" providerId="ADAL" clId="{4E01D738-D0C1-4B9B-B836-CF053EEC4C53}" dt="2022-03-16T10:08:33.114" v="946"/>
          <ac:spMkLst>
            <pc:docMk/>
            <pc:sldMk cId="2336920806" sldId="303"/>
            <ac:spMk id="101" creationId="{3CC71356-274E-4DF2-8117-9E84DE766698}"/>
          </ac:spMkLst>
        </pc:spChg>
        <pc:spChg chg="mod">
          <ac:chgData name="Filippo Acconcia" userId="844af49c-a8a0-47ac-a7dd-14a44b60cd18" providerId="ADAL" clId="{4E01D738-D0C1-4B9B-B836-CF053EEC4C53}" dt="2022-03-16T10:08:33.114" v="946"/>
          <ac:spMkLst>
            <pc:docMk/>
            <pc:sldMk cId="2336920806" sldId="303"/>
            <ac:spMk id="102" creationId="{F4FAEC64-F0D3-47FE-9BA3-653403B48534}"/>
          </ac:spMkLst>
        </pc:spChg>
        <pc:spChg chg="mod">
          <ac:chgData name="Filippo Acconcia" userId="844af49c-a8a0-47ac-a7dd-14a44b60cd18" providerId="ADAL" clId="{4E01D738-D0C1-4B9B-B836-CF053EEC4C53}" dt="2022-03-16T10:08:33.114" v="946"/>
          <ac:spMkLst>
            <pc:docMk/>
            <pc:sldMk cId="2336920806" sldId="303"/>
            <ac:spMk id="103" creationId="{EE9E76CD-E498-47C0-9DED-71A7768B2511}"/>
          </ac:spMkLst>
        </pc:spChg>
        <pc:spChg chg="mod">
          <ac:chgData name="Filippo Acconcia" userId="844af49c-a8a0-47ac-a7dd-14a44b60cd18" providerId="ADAL" clId="{4E01D738-D0C1-4B9B-B836-CF053EEC4C53}" dt="2022-03-16T10:08:33.114" v="946"/>
          <ac:spMkLst>
            <pc:docMk/>
            <pc:sldMk cId="2336920806" sldId="303"/>
            <ac:spMk id="105" creationId="{92EB28D9-639E-4DED-B488-78E7C0D34202}"/>
          </ac:spMkLst>
        </pc:spChg>
        <pc:spChg chg="mod">
          <ac:chgData name="Filippo Acconcia" userId="844af49c-a8a0-47ac-a7dd-14a44b60cd18" providerId="ADAL" clId="{4E01D738-D0C1-4B9B-B836-CF053EEC4C53}" dt="2022-03-16T10:08:33.114" v="946"/>
          <ac:spMkLst>
            <pc:docMk/>
            <pc:sldMk cId="2336920806" sldId="303"/>
            <ac:spMk id="106" creationId="{981375DD-567E-45FB-B214-8F7D92FBC109}"/>
          </ac:spMkLst>
        </pc:spChg>
        <pc:spChg chg="mod">
          <ac:chgData name="Filippo Acconcia" userId="844af49c-a8a0-47ac-a7dd-14a44b60cd18" providerId="ADAL" clId="{4E01D738-D0C1-4B9B-B836-CF053EEC4C53}" dt="2022-03-16T10:08:33.114" v="946"/>
          <ac:spMkLst>
            <pc:docMk/>
            <pc:sldMk cId="2336920806" sldId="303"/>
            <ac:spMk id="107" creationId="{25852079-201D-47D5-96FA-142F6F4841EF}"/>
          </ac:spMkLst>
        </pc:spChg>
        <pc:spChg chg="mod topLvl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112" creationId="{104CF94A-72E4-4877-905B-CD35A52523D4}"/>
          </ac:spMkLst>
        </pc:spChg>
        <pc:spChg chg="del mod topLvl">
          <ac:chgData name="Filippo Acconcia" userId="844af49c-a8a0-47ac-a7dd-14a44b60cd18" providerId="ADAL" clId="{4E01D738-D0C1-4B9B-B836-CF053EEC4C53}" dt="2022-03-16T10:59:28.551" v="1555" actId="478"/>
          <ac:spMkLst>
            <pc:docMk/>
            <pc:sldMk cId="2336920806" sldId="303"/>
            <ac:spMk id="113" creationId="{20AA90AF-9D0C-4B01-9EF8-E46EACC745AE}"/>
          </ac:spMkLst>
        </pc:spChg>
        <pc:spChg chg="mod topLvl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114" creationId="{A1BD986B-0B05-4403-991B-A7654FE0C786}"/>
          </ac:spMkLst>
        </pc:spChg>
        <pc:spChg chg="mod topLvl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115" creationId="{EA5C8D52-CF10-4B79-91E9-9202823D9378}"/>
          </ac:spMkLst>
        </pc:spChg>
        <pc:spChg chg="del mod topLvl">
          <ac:chgData name="Filippo Acconcia" userId="844af49c-a8a0-47ac-a7dd-14a44b60cd18" providerId="ADAL" clId="{4E01D738-D0C1-4B9B-B836-CF053EEC4C53}" dt="2022-03-16T10:59:28.551" v="1555" actId="478"/>
          <ac:spMkLst>
            <pc:docMk/>
            <pc:sldMk cId="2336920806" sldId="303"/>
            <ac:spMk id="117" creationId="{E81D527F-A5AC-42F4-A23A-D326905B34D4}"/>
          </ac:spMkLst>
        </pc:spChg>
        <pc:spChg chg="del mod topLvl">
          <ac:chgData name="Filippo Acconcia" userId="844af49c-a8a0-47ac-a7dd-14a44b60cd18" providerId="ADAL" clId="{4E01D738-D0C1-4B9B-B836-CF053EEC4C53}" dt="2022-03-16T10:59:28.551" v="1555" actId="478"/>
          <ac:spMkLst>
            <pc:docMk/>
            <pc:sldMk cId="2336920806" sldId="303"/>
            <ac:spMk id="118" creationId="{F77B766C-00E9-4BE8-91F9-E80F540E60B8}"/>
          </ac:spMkLst>
        </pc:spChg>
        <pc:spChg chg="del mod topLvl">
          <ac:chgData name="Filippo Acconcia" userId="844af49c-a8a0-47ac-a7dd-14a44b60cd18" providerId="ADAL" clId="{4E01D738-D0C1-4B9B-B836-CF053EEC4C53}" dt="2022-03-16T10:59:28.551" v="1555" actId="478"/>
          <ac:spMkLst>
            <pc:docMk/>
            <pc:sldMk cId="2336920806" sldId="303"/>
            <ac:spMk id="119" creationId="{B6E05954-6EC7-4984-A2A2-713FDDF1B249}"/>
          </ac:spMkLst>
        </pc:spChg>
        <pc:spChg chg="del mod topLvl">
          <ac:chgData name="Filippo Acconcia" userId="844af49c-a8a0-47ac-a7dd-14a44b60cd18" providerId="ADAL" clId="{4E01D738-D0C1-4B9B-B836-CF053EEC4C53}" dt="2022-03-16T10:59:28.551" v="1555" actId="478"/>
          <ac:spMkLst>
            <pc:docMk/>
            <pc:sldMk cId="2336920806" sldId="303"/>
            <ac:spMk id="120" creationId="{23A64E28-B455-486A-9845-8318F3B1B975}"/>
          </ac:spMkLst>
        </pc:spChg>
        <pc:spChg chg="del mod topLvl">
          <ac:chgData name="Filippo Acconcia" userId="844af49c-a8a0-47ac-a7dd-14a44b60cd18" providerId="ADAL" clId="{4E01D738-D0C1-4B9B-B836-CF053EEC4C53}" dt="2022-03-16T10:59:28.551" v="1555" actId="478"/>
          <ac:spMkLst>
            <pc:docMk/>
            <pc:sldMk cId="2336920806" sldId="303"/>
            <ac:spMk id="121" creationId="{2460F45C-40A8-4545-AEF8-950840BC2E9A}"/>
          </ac:spMkLst>
        </pc:spChg>
        <pc:spChg chg="del mod topLvl">
          <ac:chgData name="Filippo Acconcia" userId="844af49c-a8a0-47ac-a7dd-14a44b60cd18" providerId="ADAL" clId="{4E01D738-D0C1-4B9B-B836-CF053EEC4C53}" dt="2022-03-16T10:59:28.551" v="1555" actId="478"/>
          <ac:spMkLst>
            <pc:docMk/>
            <pc:sldMk cId="2336920806" sldId="303"/>
            <ac:spMk id="122" creationId="{699D777B-4BF3-4752-8FD1-34A85033EF98}"/>
          </ac:spMkLst>
        </pc:spChg>
        <pc:spChg chg="del mod topLvl">
          <ac:chgData name="Filippo Acconcia" userId="844af49c-a8a0-47ac-a7dd-14a44b60cd18" providerId="ADAL" clId="{4E01D738-D0C1-4B9B-B836-CF053EEC4C53}" dt="2022-03-16T10:59:28.551" v="1555" actId="478"/>
          <ac:spMkLst>
            <pc:docMk/>
            <pc:sldMk cId="2336920806" sldId="303"/>
            <ac:spMk id="124" creationId="{349E7B98-0D34-4BEB-979D-5F75901094D5}"/>
          </ac:spMkLst>
        </pc:spChg>
        <pc:spChg chg="del mod topLvl">
          <ac:chgData name="Filippo Acconcia" userId="844af49c-a8a0-47ac-a7dd-14a44b60cd18" providerId="ADAL" clId="{4E01D738-D0C1-4B9B-B836-CF053EEC4C53}" dt="2022-03-16T10:59:28.551" v="1555" actId="478"/>
          <ac:spMkLst>
            <pc:docMk/>
            <pc:sldMk cId="2336920806" sldId="303"/>
            <ac:spMk id="125" creationId="{FD4F87A4-A7B7-463F-BDF6-D0BEC1EFB175}"/>
          </ac:spMkLst>
        </pc:spChg>
        <pc:spChg chg="del mod topLvl">
          <ac:chgData name="Filippo Acconcia" userId="844af49c-a8a0-47ac-a7dd-14a44b60cd18" providerId="ADAL" clId="{4E01D738-D0C1-4B9B-B836-CF053EEC4C53}" dt="2022-03-16T10:59:28.551" v="1555" actId="478"/>
          <ac:spMkLst>
            <pc:docMk/>
            <pc:sldMk cId="2336920806" sldId="303"/>
            <ac:spMk id="126" creationId="{95B767BE-D9C7-43DB-8CC8-2A4E92D1BCA7}"/>
          </ac:spMkLst>
        </pc:spChg>
        <pc:spChg chg="del mod topLvl">
          <ac:chgData name="Filippo Acconcia" userId="844af49c-a8a0-47ac-a7dd-14a44b60cd18" providerId="ADAL" clId="{4E01D738-D0C1-4B9B-B836-CF053EEC4C53}" dt="2022-03-16T10:19:13.468" v="1182" actId="478"/>
          <ac:spMkLst>
            <pc:docMk/>
            <pc:sldMk cId="2336920806" sldId="303"/>
            <ac:spMk id="129" creationId="{2E93F5E4-7514-4FD5-9F8E-571B49BA8AB4}"/>
          </ac:spMkLst>
        </pc:spChg>
        <pc:spChg chg="mod topLvl">
          <ac:chgData name="Filippo Acconcia" userId="844af49c-a8a0-47ac-a7dd-14a44b60cd18" providerId="ADAL" clId="{4E01D738-D0C1-4B9B-B836-CF053EEC4C53}" dt="2022-03-16T10:50:27.569" v="1274" actId="122"/>
          <ac:spMkLst>
            <pc:docMk/>
            <pc:sldMk cId="2336920806" sldId="303"/>
            <ac:spMk id="130" creationId="{E34B685F-AE94-46B0-9C98-56D4CE92BD49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33" creationId="{C4F3100B-88AF-4DCB-A3A3-BCB643E8B0A6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34" creationId="{C4FAF7F0-CF55-4CF0-9AB4-87EB5B8D31D0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36" creationId="{14A1FB54-080E-43F8-BF7E-C860518A37FF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37" creationId="{89662D97-2652-4DB1-82DF-BD4C042B306F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38" creationId="{EF58C44A-3D97-4A37-89C6-DE091F45D3C8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39" creationId="{D7F1E918-1A24-4885-B765-74D9FB0D5A98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40" creationId="{812BC261-F58D-4141-B56F-34F66B395FAF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44" creationId="{9269EFE6-9382-43BD-B418-A391FF7D6274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45" creationId="{1294CE6F-2F6F-4FDC-88EA-9E8550753A34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46" creationId="{06C11181-675C-4711-AA7F-CD2282491DA5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47" creationId="{F5ACF069-E8A3-4FF4-9827-04B60F91F833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52" creationId="{BDBBCD5E-DD4E-49AF-A969-71EEF50A7ECA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53" creationId="{936D9EB3-378D-48C5-818D-88EA78402952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54" creationId="{65BAD0F6-478A-4ED5-A495-4E9D2802CF6E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55" creationId="{AB397164-8633-42B5-BD11-3109F1865162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56" creationId="{9E3D3B37-E08F-4F2D-81BC-88AA326EB08D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57" creationId="{BD2A8280-4CC9-4229-B517-530E325F2842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58" creationId="{B8F5D480-3F15-41ED-9D97-D6BB30FE79F2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59" creationId="{A29CB549-6E8E-421C-8489-E4486393333F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60" creationId="{15449EFE-3E51-420F-8E4C-E8EB6A14C1D4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61" creationId="{EC8745B5-5A42-49EE-A882-907DA2FF75B7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62" creationId="{02B542BE-97D9-4411-832A-98214ABA974E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63" creationId="{D7CA1C2D-FA60-447E-BC85-79A44397F3A7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64" creationId="{F5204930-755A-4EF0-BA26-214AFB787663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65" creationId="{D946CAB3-549B-4DEF-A8A2-D22BCA9F3A68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66" creationId="{D639C3BC-7B0C-4886-853A-169F56F087B7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67" creationId="{8A416A58-9859-4C99-9854-67B7A0CE32B6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68" creationId="{C8CC7961-D101-49E0-AB0F-54E8B7674E5E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69" creationId="{B77C15C0-8CB4-4B05-8E6B-A4A48A8BBFA4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70" creationId="{DA6C45DD-D509-484B-A210-5A64E1F34702}"/>
          </ac:spMkLst>
        </pc:spChg>
        <pc:spChg chg="mod">
          <ac:chgData name="Filippo Acconcia" userId="844af49c-a8a0-47ac-a7dd-14a44b60cd18" providerId="ADAL" clId="{4E01D738-D0C1-4B9B-B836-CF053EEC4C53}" dt="2022-03-16T10:10:29.648" v="951" actId="165"/>
          <ac:spMkLst>
            <pc:docMk/>
            <pc:sldMk cId="2336920806" sldId="303"/>
            <ac:spMk id="171" creationId="{C4711EB3-C78F-42B6-ABD7-815A75042FDD}"/>
          </ac:spMkLst>
        </pc:spChg>
        <pc:spChg chg="add mod">
          <ac:chgData name="Filippo Acconcia" userId="844af49c-a8a0-47ac-a7dd-14a44b60cd18" providerId="ADAL" clId="{4E01D738-D0C1-4B9B-B836-CF053EEC4C53}" dt="2022-03-16T10:13:55.813" v="1064" actId="164"/>
          <ac:spMkLst>
            <pc:docMk/>
            <pc:sldMk cId="2336920806" sldId="303"/>
            <ac:spMk id="172" creationId="{D7A624BB-BA6B-4A8C-AC05-824181D20ACB}"/>
          </ac:spMkLst>
        </pc:spChg>
        <pc:spChg chg="add mod">
          <ac:chgData name="Filippo Acconcia" userId="844af49c-a8a0-47ac-a7dd-14a44b60cd18" providerId="ADAL" clId="{4E01D738-D0C1-4B9B-B836-CF053EEC4C53}" dt="2022-03-16T10:13:55.813" v="1064" actId="164"/>
          <ac:spMkLst>
            <pc:docMk/>
            <pc:sldMk cId="2336920806" sldId="303"/>
            <ac:spMk id="173" creationId="{B18F2CDC-848A-4F46-BB9B-0C7BBCAB999F}"/>
          </ac:spMkLst>
        </pc:spChg>
        <pc:spChg chg="mod">
          <ac:chgData name="Filippo Acconcia" userId="844af49c-a8a0-47ac-a7dd-14a44b60cd18" providerId="ADAL" clId="{4E01D738-D0C1-4B9B-B836-CF053EEC4C53}" dt="2022-03-16T10:14:08.051" v="1074"/>
          <ac:spMkLst>
            <pc:docMk/>
            <pc:sldMk cId="2336920806" sldId="303"/>
            <ac:spMk id="177" creationId="{371F0A0A-9FB3-463B-B7E0-90DA8DAA5F26}"/>
          </ac:spMkLst>
        </pc:spChg>
        <pc:spChg chg="mod">
          <ac:chgData name="Filippo Acconcia" userId="844af49c-a8a0-47ac-a7dd-14a44b60cd18" providerId="ADAL" clId="{4E01D738-D0C1-4B9B-B836-CF053EEC4C53}" dt="2022-03-16T10:14:08.051" v="1074"/>
          <ac:spMkLst>
            <pc:docMk/>
            <pc:sldMk cId="2336920806" sldId="303"/>
            <ac:spMk id="178" creationId="{A2F3E442-4427-4115-8A9F-00FE3A429413}"/>
          </ac:spMkLst>
        </pc:spChg>
        <pc:spChg chg="mod">
          <ac:chgData name="Filippo Acconcia" userId="844af49c-a8a0-47ac-a7dd-14a44b60cd18" providerId="ADAL" clId="{4E01D738-D0C1-4B9B-B836-CF053EEC4C53}" dt="2022-03-16T10:14:08.051" v="1074"/>
          <ac:spMkLst>
            <pc:docMk/>
            <pc:sldMk cId="2336920806" sldId="303"/>
            <ac:spMk id="179" creationId="{6BFA1507-7795-4D90-8EFB-7DA1D0FC4EBD}"/>
          </ac:spMkLst>
        </pc:spChg>
        <pc:spChg chg="mod">
          <ac:chgData name="Filippo Acconcia" userId="844af49c-a8a0-47ac-a7dd-14a44b60cd18" providerId="ADAL" clId="{4E01D738-D0C1-4B9B-B836-CF053EEC4C53}" dt="2022-03-16T10:14:08.051" v="1074"/>
          <ac:spMkLst>
            <pc:docMk/>
            <pc:sldMk cId="2336920806" sldId="303"/>
            <ac:spMk id="180" creationId="{66BB1519-A55D-414A-AD39-DDF9282DFF77}"/>
          </ac:spMkLst>
        </pc:spChg>
        <pc:spChg chg="mod">
          <ac:chgData name="Filippo Acconcia" userId="844af49c-a8a0-47ac-a7dd-14a44b60cd18" providerId="ADAL" clId="{4E01D738-D0C1-4B9B-B836-CF053EEC4C53}" dt="2022-03-16T10:14:14.161" v="1076"/>
          <ac:spMkLst>
            <pc:docMk/>
            <pc:sldMk cId="2336920806" sldId="303"/>
            <ac:spMk id="182" creationId="{9042A1CB-B31A-43F3-BFE5-F439BB8EE801}"/>
          </ac:spMkLst>
        </pc:spChg>
        <pc:spChg chg="mod">
          <ac:chgData name="Filippo Acconcia" userId="844af49c-a8a0-47ac-a7dd-14a44b60cd18" providerId="ADAL" clId="{4E01D738-D0C1-4B9B-B836-CF053EEC4C53}" dt="2022-03-16T10:14:14.161" v="1076"/>
          <ac:spMkLst>
            <pc:docMk/>
            <pc:sldMk cId="2336920806" sldId="303"/>
            <ac:spMk id="183" creationId="{AE913C32-546E-45E1-8143-22360A8C3AA1}"/>
          </ac:spMkLst>
        </pc:spChg>
        <pc:spChg chg="mod">
          <ac:chgData name="Filippo Acconcia" userId="844af49c-a8a0-47ac-a7dd-14a44b60cd18" providerId="ADAL" clId="{4E01D738-D0C1-4B9B-B836-CF053EEC4C53}" dt="2022-03-16T10:14:14.161" v="1076"/>
          <ac:spMkLst>
            <pc:docMk/>
            <pc:sldMk cId="2336920806" sldId="303"/>
            <ac:spMk id="184" creationId="{F6AD805D-F2BE-489F-8CA9-E5E16121F945}"/>
          </ac:spMkLst>
        </pc:spChg>
        <pc:spChg chg="mod">
          <ac:chgData name="Filippo Acconcia" userId="844af49c-a8a0-47ac-a7dd-14a44b60cd18" providerId="ADAL" clId="{4E01D738-D0C1-4B9B-B836-CF053EEC4C53}" dt="2022-03-16T10:14:14.161" v="1076"/>
          <ac:spMkLst>
            <pc:docMk/>
            <pc:sldMk cId="2336920806" sldId="303"/>
            <ac:spMk id="185" creationId="{B4050953-907B-4FBB-BB47-AE022508915E}"/>
          </ac:spMkLst>
        </pc:spChg>
        <pc:spChg chg="mod">
          <ac:chgData name="Filippo Acconcia" userId="844af49c-a8a0-47ac-a7dd-14a44b60cd18" providerId="ADAL" clId="{4E01D738-D0C1-4B9B-B836-CF053EEC4C53}" dt="2022-03-16T10:14:17.522" v="1078"/>
          <ac:spMkLst>
            <pc:docMk/>
            <pc:sldMk cId="2336920806" sldId="303"/>
            <ac:spMk id="187" creationId="{4AC6D943-3326-45CA-9FFF-D60C53903011}"/>
          </ac:spMkLst>
        </pc:spChg>
        <pc:spChg chg="mod">
          <ac:chgData name="Filippo Acconcia" userId="844af49c-a8a0-47ac-a7dd-14a44b60cd18" providerId="ADAL" clId="{4E01D738-D0C1-4B9B-B836-CF053EEC4C53}" dt="2022-03-16T10:14:17.522" v="1078"/>
          <ac:spMkLst>
            <pc:docMk/>
            <pc:sldMk cId="2336920806" sldId="303"/>
            <ac:spMk id="188" creationId="{711F7B37-ADF5-41FD-907F-F4F9D7A51AD2}"/>
          </ac:spMkLst>
        </pc:spChg>
        <pc:spChg chg="mod">
          <ac:chgData name="Filippo Acconcia" userId="844af49c-a8a0-47ac-a7dd-14a44b60cd18" providerId="ADAL" clId="{4E01D738-D0C1-4B9B-B836-CF053EEC4C53}" dt="2022-03-16T10:14:17.522" v="1078"/>
          <ac:spMkLst>
            <pc:docMk/>
            <pc:sldMk cId="2336920806" sldId="303"/>
            <ac:spMk id="189" creationId="{04FB3B33-BD86-4008-A6A2-5BB6EC86F22C}"/>
          </ac:spMkLst>
        </pc:spChg>
        <pc:spChg chg="mod">
          <ac:chgData name="Filippo Acconcia" userId="844af49c-a8a0-47ac-a7dd-14a44b60cd18" providerId="ADAL" clId="{4E01D738-D0C1-4B9B-B836-CF053EEC4C53}" dt="2022-03-16T10:14:17.522" v="1078"/>
          <ac:spMkLst>
            <pc:docMk/>
            <pc:sldMk cId="2336920806" sldId="303"/>
            <ac:spMk id="190" creationId="{AB22C0D7-F054-4B8C-AEF6-E932E6E99BB5}"/>
          </ac:spMkLst>
        </pc:spChg>
        <pc:spChg chg="add mod">
          <ac:chgData name="Filippo Acconcia" userId="844af49c-a8a0-47ac-a7dd-14a44b60cd18" providerId="ADAL" clId="{4E01D738-D0C1-4B9B-B836-CF053EEC4C53}" dt="2022-03-16T10:17:10.919" v="1161" actId="164"/>
          <ac:spMkLst>
            <pc:docMk/>
            <pc:sldMk cId="2336920806" sldId="303"/>
            <ac:spMk id="198" creationId="{3D868067-E2FD-4489-AAD3-3F276908733A}"/>
          </ac:spMkLst>
        </pc:spChg>
        <pc:spChg chg="add mod">
          <ac:chgData name="Filippo Acconcia" userId="844af49c-a8a0-47ac-a7dd-14a44b60cd18" providerId="ADAL" clId="{4E01D738-D0C1-4B9B-B836-CF053EEC4C53}" dt="2022-03-16T10:17:10.919" v="1161" actId="164"/>
          <ac:spMkLst>
            <pc:docMk/>
            <pc:sldMk cId="2336920806" sldId="303"/>
            <ac:spMk id="199" creationId="{C6D13FBD-4597-4C57-9FA3-12107866B7B0}"/>
          </ac:spMkLst>
        </pc:spChg>
        <pc:spChg chg="add mod">
          <ac:chgData name="Filippo Acconcia" userId="844af49c-a8a0-47ac-a7dd-14a44b60cd18" providerId="ADAL" clId="{4E01D738-D0C1-4B9B-B836-CF053EEC4C53}" dt="2022-03-16T10:17:10.919" v="1161" actId="164"/>
          <ac:spMkLst>
            <pc:docMk/>
            <pc:sldMk cId="2336920806" sldId="303"/>
            <ac:spMk id="200" creationId="{A97A4A86-8064-4A54-98B3-BB6408200E90}"/>
          </ac:spMkLst>
        </pc:spChg>
        <pc:spChg chg="mod topLvl">
          <ac:chgData name="Filippo Acconcia" userId="844af49c-a8a0-47ac-a7dd-14a44b60cd18" providerId="ADAL" clId="{4E01D738-D0C1-4B9B-B836-CF053EEC4C53}" dt="2022-03-16T10:18:59.718" v="1179" actId="164"/>
          <ac:spMkLst>
            <pc:docMk/>
            <pc:sldMk cId="2336920806" sldId="303"/>
            <ac:spMk id="204" creationId="{5CA5C177-8038-4482-81BE-B740C0740375}"/>
          </ac:spMkLst>
        </pc:spChg>
        <pc:spChg chg="mod topLvl">
          <ac:chgData name="Filippo Acconcia" userId="844af49c-a8a0-47ac-a7dd-14a44b60cd18" providerId="ADAL" clId="{4E01D738-D0C1-4B9B-B836-CF053EEC4C53}" dt="2022-03-16T10:18:59.718" v="1179" actId="164"/>
          <ac:spMkLst>
            <pc:docMk/>
            <pc:sldMk cId="2336920806" sldId="303"/>
            <ac:spMk id="205" creationId="{D51EEB8D-36FA-4795-B17A-7426BB7305A0}"/>
          </ac:spMkLst>
        </pc:spChg>
        <pc:spChg chg="mod topLvl">
          <ac:chgData name="Filippo Acconcia" userId="844af49c-a8a0-47ac-a7dd-14a44b60cd18" providerId="ADAL" clId="{4E01D738-D0C1-4B9B-B836-CF053EEC4C53}" dt="2022-03-16T10:18:59.718" v="1179" actId="164"/>
          <ac:spMkLst>
            <pc:docMk/>
            <pc:sldMk cId="2336920806" sldId="303"/>
            <ac:spMk id="207" creationId="{E198B8C5-EC25-4D4F-9373-77822748CFB7}"/>
          </ac:spMkLst>
        </pc:spChg>
        <pc:spChg chg="mod topLvl">
          <ac:chgData name="Filippo Acconcia" userId="844af49c-a8a0-47ac-a7dd-14a44b60cd18" providerId="ADAL" clId="{4E01D738-D0C1-4B9B-B836-CF053EEC4C53}" dt="2022-03-16T10:18:59.718" v="1179" actId="164"/>
          <ac:spMkLst>
            <pc:docMk/>
            <pc:sldMk cId="2336920806" sldId="303"/>
            <ac:spMk id="208" creationId="{C1F291EB-FD24-4905-AD43-ABEEB0A77AEA}"/>
          </ac:spMkLst>
        </pc:spChg>
        <pc:spChg chg="mod topLvl">
          <ac:chgData name="Filippo Acconcia" userId="844af49c-a8a0-47ac-a7dd-14a44b60cd18" providerId="ADAL" clId="{4E01D738-D0C1-4B9B-B836-CF053EEC4C53}" dt="2022-03-16T10:18:59.718" v="1179" actId="164"/>
          <ac:spMkLst>
            <pc:docMk/>
            <pc:sldMk cId="2336920806" sldId="303"/>
            <ac:spMk id="209" creationId="{40489E15-D904-40D9-BA29-FE08CD690158}"/>
          </ac:spMkLst>
        </pc:spChg>
        <pc:spChg chg="mod topLvl">
          <ac:chgData name="Filippo Acconcia" userId="844af49c-a8a0-47ac-a7dd-14a44b60cd18" providerId="ADAL" clId="{4E01D738-D0C1-4B9B-B836-CF053EEC4C53}" dt="2022-03-16T10:18:59.718" v="1179" actId="164"/>
          <ac:spMkLst>
            <pc:docMk/>
            <pc:sldMk cId="2336920806" sldId="303"/>
            <ac:spMk id="211" creationId="{ACEBE25D-30F7-43C3-81E2-2CE598EB2D68}"/>
          </ac:spMkLst>
        </pc:spChg>
        <pc:spChg chg="mod topLvl">
          <ac:chgData name="Filippo Acconcia" userId="844af49c-a8a0-47ac-a7dd-14a44b60cd18" providerId="ADAL" clId="{4E01D738-D0C1-4B9B-B836-CF053EEC4C53}" dt="2022-03-16T10:50:25.080" v="1273" actId="122"/>
          <ac:spMkLst>
            <pc:docMk/>
            <pc:sldMk cId="2336920806" sldId="303"/>
            <ac:spMk id="212" creationId="{84752527-D27A-422E-AF3B-D7E843045826}"/>
          </ac:spMkLst>
        </pc:spChg>
        <pc:spChg chg="mod topLvl">
          <ac:chgData name="Filippo Acconcia" userId="844af49c-a8a0-47ac-a7dd-14a44b60cd18" providerId="ADAL" clId="{4E01D738-D0C1-4B9B-B836-CF053EEC4C53}" dt="2022-03-16T10:18:59.718" v="1179" actId="164"/>
          <ac:spMkLst>
            <pc:docMk/>
            <pc:sldMk cId="2336920806" sldId="303"/>
            <ac:spMk id="221" creationId="{7EB92A59-9A25-48F2-8E50-40FFD9945F06}"/>
          </ac:spMkLst>
        </pc:spChg>
        <pc:spChg chg="mod topLvl">
          <ac:chgData name="Filippo Acconcia" userId="844af49c-a8a0-47ac-a7dd-14a44b60cd18" providerId="ADAL" clId="{4E01D738-D0C1-4B9B-B836-CF053EEC4C53}" dt="2022-03-16T10:18:59.718" v="1179" actId="164"/>
          <ac:spMkLst>
            <pc:docMk/>
            <pc:sldMk cId="2336920806" sldId="303"/>
            <ac:spMk id="222" creationId="{10AD58BF-F29E-4D9D-9776-45E9EE689763}"/>
          </ac:spMkLst>
        </pc:spChg>
        <pc:spChg chg="mod topLvl">
          <ac:chgData name="Filippo Acconcia" userId="844af49c-a8a0-47ac-a7dd-14a44b60cd18" providerId="ADAL" clId="{4E01D738-D0C1-4B9B-B836-CF053EEC4C53}" dt="2022-03-16T10:18:59.718" v="1179" actId="164"/>
          <ac:spMkLst>
            <pc:docMk/>
            <pc:sldMk cId="2336920806" sldId="303"/>
            <ac:spMk id="223" creationId="{63C1A13A-1187-45A7-8F13-CAEC2DCA551B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24" creationId="{F83296F2-7D20-4678-860B-4CF1BCCF92D2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25" creationId="{BDDDD043-92CC-45A0-90EE-6532296D2148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26" creationId="{626B1528-B98C-4943-ADE3-10B8089E8D92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27" creationId="{3C6487EB-2557-463E-A4D1-B58E72BAD37A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28" creationId="{C535063A-8A2F-4479-8E9D-DF269790617F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29" creationId="{C41374ED-FE33-4F73-AD52-447C77EB62F2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30" creationId="{E5EA3F14-61E3-4F2B-8345-A4FCD548542C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31" creationId="{DB9B9C4F-8814-4FFA-9404-F1A8FFA7D70B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32" creationId="{5969BBF9-677D-46BE-A775-65B9868D1718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33" creationId="{1BEF739E-7F7A-4E5A-9489-A8FDCCB23094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34" creationId="{69A2BA7A-4FA8-452C-9840-92768D2C555A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35" creationId="{61811987-B2C6-4BB9-BE8F-C58CB9D62D7F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36" creationId="{5D225D50-5795-4BAA-96D1-C6EF481A0E31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37" creationId="{9C124EE9-0405-45C8-BA78-C43A1B8D06CD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38" creationId="{605BC0DA-58FC-4817-A8A0-F58BADBDD056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39" creationId="{3858709F-7907-4975-90D8-7C0D2F145A7E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40" creationId="{4088450F-DD76-4950-8535-C27A7BA3660B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41" creationId="{6E88BECF-76E5-48DF-AA7F-5B52118C76F9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42" creationId="{48336E8C-AD7C-4F3D-88F7-83AF0D43398C}"/>
          </ac:spMkLst>
        </pc:spChg>
        <pc:spChg chg="mod">
          <ac:chgData name="Filippo Acconcia" userId="844af49c-a8a0-47ac-a7dd-14a44b60cd18" providerId="ADAL" clId="{4E01D738-D0C1-4B9B-B836-CF053EEC4C53}" dt="2022-03-16T10:17:34.675" v="1171" actId="165"/>
          <ac:spMkLst>
            <pc:docMk/>
            <pc:sldMk cId="2336920806" sldId="303"/>
            <ac:spMk id="243" creationId="{8485EB3F-5733-4EC9-99E8-D6779E3D00EB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48" creationId="{F82AF4F2-AA58-4951-B4D1-ECCB64A77246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49" creationId="{FE6DA020-A1D0-4DE1-A3DC-E82844C14CD0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50" creationId="{BE497EC7-8BBA-454F-B5CA-1DEF6C758737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51" creationId="{E4C20D39-F7F0-4C1D-B0E7-BC69695985C7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52" creationId="{08CA1C4A-3BB7-447B-9E16-22158BF0EEDF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54" creationId="{A9460C65-D0F1-4A5B-9AA5-A3C824D10C0D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55" creationId="{8A49B25C-4816-45E4-993E-15B41C171552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56" creationId="{D1F234B3-AD90-47DD-B01C-710DF43D9E4F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57" creationId="{D1EBEC79-0B7D-42CF-B02D-C5AE6F3D6265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58" creationId="{151164D3-0704-4140-96EA-FB7DB7CFD674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60" creationId="{926F3F8B-45EF-4435-954D-955803795B24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61" creationId="{6779C60D-7110-45A0-9A75-9C5AB163A473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62" creationId="{A55DA215-C550-4595-9C02-A6C9EF5D1ECE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63" creationId="{70472310-0C2C-4A36-A0AF-514BD86D6238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64" creationId="{5CE8411F-34FC-4BC0-A64B-F7C4870FCB55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66" creationId="{A71A768A-193A-4128-9553-B65251B68174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67" creationId="{19B7ED94-7E3B-47C0-BCA6-EA1B9EAAB9DD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68" creationId="{83849AF4-6004-42FB-928D-4C33F8181C6F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69" creationId="{96D0130F-EC0A-4E76-A0AD-2C9BC1F6599E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70" creationId="{F887648D-DA50-4B89-A0F6-DE748945CCF5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72" creationId="{92292DF9-4F6D-4A0D-A959-3AC1A37E8307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73" creationId="{7EB4A06A-48E9-433A-BFBA-4AA4071C9E14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74" creationId="{151EECB3-0631-4409-A7E5-E94CBF59B16A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75" creationId="{881BEE43-DA84-486B-A011-6F6D65247902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76" creationId="{5F614B10-E7FE-4A9D-A483-EDED04D6D5FE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78" creationId="{19E687C8-E981-4AFC-91E8-56CCAF0FECCA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79" creationId="{890318C9-9F78-4006-8F4A-3620BB0EECAC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80" creationId="{D629A316-045F-4191-8D8E-25FB535EF69F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81" creationId="{567FFEBF-2BC5-43D6-B108-9E037E20CF4A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82" creationId="{600710C0-E9C9-414E-BEE4-D3DD55A5CF82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86" creationId="{DC2592D1-AE18-4D8E-91A8-10439B3C2B47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87" creationId="{901CEFFA-8819-449C-B8A9-FC4BB03E39DA}"/>
          </ac:spMkLst>
        </pc:spChg>
        <pc:spChg chg="mod">
          <ac:chgData name="Filippo Acconcia" userId="844af49c-a8a0-47ac-a7dd-14a44b60cd18" providerId="ADAL" clId="{4E01D738-D0C1-4B9B-B836-CF053EEC4C53}" dt="2022-03-16T10:19:30.265" v="1183"/>
          <ac:spMkLst>
            <pc:docMk/>
            <pc:sldMk cId="2336920806" sldId="303"/>
            <ac:spMk id="288" creationId="{5243A3B8-5DAF-4453-A6DD-A47B0C65D24B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291" creationId="{5D418339-C850-4B23-95EC-ADB90C616C67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292" creationId="{5A9D9306-56DA-423F-95CF-3FE35B803C9E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293" creationId="{BAD060B2-C6A2-4E9A-9887-AFE6CD3E47FD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294" creationId="{2A70A036-B2E4-4A06-A049-AE6E181DA933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296" creationId="{736CC767-C1EF-4E7F-91F2-9047545E34D4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297" creationId="{9D51E8BC-2E7A-4C5F-A674-58BAC88EDD4C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298" creationId="{EE74D080-3DE3-4695-8C87-E58226AC15D3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299" creationId="{E054C777-755A-4BCC-B5E8-CFE45A95B877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00" creationId="{ADBE0AE9-0B56-4D95-8A93-83696A688E75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02" creationId="{9E69162C-FE34-4B83-BD1B-E9A42C4D8702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03" creationId="{FF42F212-EF98-4AAB-9AE3-3F22BA18BE52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04" creationId="{61696FE9-2B2E-4D79-B8DE-05F1B656D7A6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05" creationId="{62134FA0-0876-41F1-9048-B0C00A4BF730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06" creationId="{CED24C8A-2194-45F4-B183-6CB7DD607DF6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08" creationId="{E2D36F3B-EFD8-42C9-B630-8753A5EB2001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09" creationId="{38621FA4-BDC9-4A80-AD4E-6EA9B97A2C35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10" creationId="{ED96116E-30B6-45C4-AD99-79F12B1CFCB2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11" creationId="{E8885861-86AF-458F-930D-3E70E011BBFF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12" creationId="{047F6721-2B22-4A2A-962F-81C4E06ABA78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14" creationId="{5990D8DC-8B81-475E-8C36-FE36FF903BE0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15" creationId="{C868A07D-4EBD-4C2C-96C5-1F8915974903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16" creationId="{F69D344F-3CFD-41D9-BA79-B7C587A892B7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17" creationId="{DB887E6C-2F02-45CF-A82A-ABF049D9585E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18" creationId="{79DA4EE3-8728-4AC7-95CC-352D4D3D1547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20" creationId="{020AE6D8-F861-4E24-B026-D4D899E011B0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21" creationId="{BC185C31-F57C-46D3-845F-25A54E320455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22" creationId="{DEAADFCE-9605-4064-805B-DB6E6D01D3A4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23" creationId="{F63519C2-6F7F-456E-8575-AD60BA5635B3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24" creationId="{C75CADC8-F889-43AD-8926-21DCA640C84B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28" creationId="{00099437-A70A-4A36-9DCE-50FBD9A81795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29" creationId="{28CE2931-0143-44C8-81D3-FA1066C2EFE2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30" creationId="{86BD228D-53D9-4F2C-9652-CCD8D8CAA490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33" creationId="{4AE42EDE-413E-4682-AA4D-FBA23137062F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34" creationId="{800D2BFA-4DAA-432B-8221-8EE3CE455019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35" creationId="{CBC9BBB9-EB9D-4B4F-B9A3-303DA65735F6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36" creationId="{464BF790-4FB4-49A5-A819-F6C8EB6D89F6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37" creationId="{0FFA7AB1-D226-49B1-8483-9F733B3A8617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39" creationId="{FD7851BE-CE7D-424C-84C8-E3A636540F45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40" creationId="{6F66F1FD-45F5-4CFB-8789-49EE58611868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41" creationId="{D754FBF5-5020-44AC-8F8C-8EC56BF6AE84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42" creationId="{6D39AAFF-377C-46EE-9CDF-BDAFFA8364E6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43" creationId="{EE686D14-5857-48EE-93F1-C3DF61246E9F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45" creationId="{DCA467CB-D2DA-4BCA-B709-5B9EACC34D0E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46" creationId="{9BEFD4BC-75E7-458A-94E1-2FF390BCB4EF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47" creationId="{5671B499-AD4C-4C9F-B58A-3A7D79C95D76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48" creationId="{A973B046-BC94-4CE5-8E1B-B48EEE53891B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49" creationId="{A4A79382-98FF-4B2A-AC65-2E1837EE0E80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51" creationId="{E621ABB7-9B16-4793-B005-2BE20660678B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52" creationId="{A55F07CB-59D4-43F3-82E3-FEB54AADB35D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53" creationId="{3A1170D1-BCBC-44D8-85FE-8D164B2B33A3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54" creationId="{F6E9F5B8-0B9C-4B7F-8558-1B72673603E5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55" creationId="{9B45A0E0-D2F5-407E-AF48-B8DCDEB1D06F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57" creationId="{64F822D1-7225-4533-B8D3-1AD0D5D7F651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58" creationId="{27EEB9A3-815D-4EDE-9D7A-4B729805A027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59" creationId="{8D83CA1A-62D0-40C0-BCA5-D106C2C0726A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60" creationId="{D6DA2720-8058-4F94-8641-33D1BAE2EF4A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61" creationId="{3C7D26DE-46D4-4B82-A933-9FFEA831D8A8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63" creationId="{7327170C-E92B-4B9E-A557-58909E387F93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64" creationId="{9E3C9723-DBB4-4135-9294-847CC33AC8C7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65" creationId="{F9A5274E-5DCE-4579-98DB-1326EF496427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66" creationId="{3F2FCE14-6F7F-4BB4-AF79-DCC9857CA5E8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67" creationId="{EA6C0CCC-3E8D-4A65-A61F-F2BD8E271D90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71" creationId="{9EA44EE9-E2A0-40DE-9C07-656F48D77ED6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72" creationId="{481B80DE-25C4-47FB-9E65-84DCAD52B4BA}"/>
          </ac:spMkLst>
        </pc:spChg>
        <pc:spChg chg="mod">
          <ac:chgData name="Filippo Acconcia" userId="844af49c-a8a0-47ac-a7dd-14a44b60cd18" providerId="ADAL" clId="{4E01D738-D0C1-4B9B-B836-CF053EEC4C53}" dt="2022-03-16T10:44:41.752" v="1189"/>
          <ac:spMkLst>
            <pc:docMk/>
            <pc:sldMk cId="2336920806" sldId="303"/>
            <ac:spMk id="373" creationId="{0206A608-3BED-4776-BE13-A33594F1004C}"/>
          </ac:spMkLst>
        </pc:spChg>
        <pc:spChg chg="mod topLvl">
          <ac:chgData name="Filippo Acconcia" userId="844af49c-a8a0-47ac-a7dd-14a44b60cd18" providerId="ADAL" clId="{4E01D738-D0C1-4B9B-B836-CF053EEC4C53}" dt="2022-03-16T10:48:48.519" v="1246" actId="164"/>
          <ac:spMkLst>
            <pc:docMk/>
            <pc:sldMk cId="2336920806" sldId="303"/>
            <ac:spMk id="376" creationId="{A8B52F98-09C4-4CBF-A45A-15072AEE4EF5}"/>
          </ac:spMkLst>
        </pc:spChg>
        <pc:spChg chg="mod topLvl">
          <ac:chgData name="Filippo Acconcia" userId="844af49c-a8a0-47ac-a7dd-14a44b60cd18" providerId="ADAL" clId="{4E01D738-D0C1-4B9B-B836-CF053EEC4C53}" dt="2022-03-16T10:48:48.519" v="1246" actId="164"/>
          <ac:spMkLst>
            <pc:docMk/>
            <pc:sldMk cId="2336920806" sldId="303"/>
            <ac:spMk id="377" creationId="{C7C5A1AB-9240-4743-903D-7C9A6A5130CE}"/>
          </ac:spMkLst>
        </pc:spChg>
        <pc:spChg chg="mod topLvl">
          <ac:chgData name="Filippo Acconcia" userId="844af49c-a8a0-47ac-a7dd-14a44b60cd18" providerId="ADAL" clId="{4E01D738-D0C1-4B9B-B836-CF053EEC4C53}" dt="2022-03-16T10:48:48.519" v="1246" actId="164"/>
          <ac:spMkLst>
            <pc:docMk/>
            <pc:sldMk cId="2336920806" sldId="303"/>
            <ac:spMk id="379" creationId="{0AE59FB5-AB75-4A1D-9694-8BE37891FB75}"/>
          </ac:spMkLst>
        </pc:spChg>
        <pc:spChg chg="mod topLvl">
          <ac:chgData name="Filippo Acconcia" userId="844af49c-a8a0-47ac-a7dd-14a44b60cd18" providerId="ADAL" clId="{4E01D738-D0C1-4B9B-B836-CF053EEC4C53}" dt="2022-03-16T10:48:48.519" v="1246" actId="164"/>
          <ac:spMkLst>
            <pc:docMk/>
            <pc:sldMk cId="2336920806" sldId="303"/>
            <ac:spMk id="380" creationId="{9C2F5A91-28F5-4770-9E3A-90238AF0E1F4}"/>
          </ac:spMkLst>
        </pc:spChg>
        <pc:spChg chg="mod topLvl">
          <ac:chgData name="Filippo Acconcia" userId="844af49c-a8a0-47ac-a7dd-14a44b60cd18" providerId="ADAL" clId="{4E01D738-D0C1-4B9B-B836-CF053EEC4C53}" dt="2022-03-16T10:48:48.519" v="1246" actId="164"/>
          <ac:spMkLst>
            <pc:docMk/>
            <pc:sldMk cId="2336920806" sldId="303"/>
            <ac:spMk id="381" creationId="{04585778-E12D-46AB-85BC-08C229899576}"/>
          </ac:spMkLst>
        </pc:spChg>
        <pc:spChg chg="mod topLvl">
          <ac:chgData name="Filippo Acconcia" userId="844af49c-a8a0-47ac-a7dd-14a44b60cd18" providerId="ADAL" clId="{4E01D738-D0C1-4B9B-B836-CF053EEC4C53}" dt="2022-03-16T10:48:48.519" v="1246" actId="164"/>
          <ac:spMkLst>
            <pc:docMk/>
            <pc:sldMk cId="2336920806" sldId="303"/>
            <ac:spMk id="383" creationId="{3F7C3A61-DCEB-4665-929D-76CF8571F7B2}"/>
          </ac:spMkLst>
        </pc:spChg>
        <pc:spChg chg="mod topLvl">
          <ac:chgData name="Filippo Acconcia" userId="844af49c-a8a0-47ac-a7dd-14a44b60cd18" providerId="ADAL" clId="{4E01D738-D0C1-4B9B-B836-CF053EEC4C53}" dt="2022-03-16T10:50:20.591" v="1272" actId="122"/>
          <ac:spMkLst>
            <pc:docMk/>
            <pc:sldMk cId="2336920806" sldId="303"/>
            <ac:spMk id="384" creationId="{D49FA9D5-2F9A-415E-9B73-BD975FCCD525}"/>
          </ac:spMkLst>
        </pc:spChg>
        <pc:spChg chg="mod topLvl">
          <ac:chgData name="Filippo Acconcia" userId="844af49c-a8a0-47ac-a7dd-14a44b60cd18" providerId="ADAL" clId="{4E01D738-D0C1-4B9B-B836-CF053EEC4C53}" dt="2022-03-16T10:48:48.519" v="1246" actId="164"/>
          <ac:spMkLst>
            <pc:docMk/>
            <pc:sldMk cId="2336920806" sldId="303"/>
            <ac:spMk id="393" creationId="{EC7356E7-3F31-42F1-8844-9E7483C33EFF}"/>
          </ac:spMkLst>
        </pc:spChg>
        <pc:spChg chg="mod topLvl">
          <ac:chgData name="Filippo Acconcia" userId="844af49c-a8a0-47ac-a7dd-14a44b60cd18" providerId="ADAL" clId="{4E01D738-D0C1-4B9B-B836-CF053EEC4C53}" dt="2022-03-16T10:48:48.519" v="1246" actId="164"/>
          <ac:spMkLst>
            <pc:docMk/>
            <pc:sldMk cId="2336920806" sldId="303"/>
            <ac:spMk id="394" creationId="{7253161A-8CAA-4A18-BD49-A1D2EF9BADF9}"/>
          </ac:spMkLst>
        </pc:spChg>
        <pc:spChg chg="mod topLvl">
          <ac:chgData name="Filippo Acconcia" userId="844af49c-a8a0-47ac-a7dd-14a44b60cd18" providerId="ADAL" clId="{4E01D738-D0C1-4B9B-B836-CF053EEC4C53}" dt="2022-03-16T10:48:48.519" v="1246" actId="164"/>
          <ac:spMkLst>
            <pc:docMk/>
            <pc:sldMk cId="2336920806" sldId="303"/>
            <ac:spMk id="395" creationId="{D7022A56-3782-4607-8D16-9B45DDE139E7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396" creationId="{BE9DC756-BBBD-4A87-A5E5-65387D04F818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397" creationId="{7D442AA9-E578-45BC-89B2-4F34C3855AD0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398" creationId="{5D7024A6-BFAC-443C-B128-0424287CD518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399" creationId="{57A15FCD-B8DD-4973-816C-6337C1509201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00" creationId="{7424BBC2-3B2C-466D-B968-EEAC604B384B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01" creationId="{4C05B479-6BC8-495C-9371-94D43CE4FC2D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02" creationId="{0A1AB195-7DCF-46E5-A1A3-D69F39DF3FF1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03" creationId="{618384D8-7A7E-47F6-834B-656734A88EE9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04" creationId="{A5A8FAAA-E879-4C9B-BC35-1EF35FCBAED2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05" creationId="{C6E7D5B6-BE12-4C5B-A29E-B709B55A7332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06" creationId="{FE573CB3-AEEA-4CAB-A87E-B2876F9B196E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07" creationId="{6819A1D6-EF0C-46AE-8426-0A2C07975818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08" creationId="{8A4A15DC-C1BF-4B31-AC8B-999BDCE2B9DE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09" creationId="{A51B961B-9426-4823-92FC-9F0C5C851BCB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10" creationId="{9047870A-80A4-41E8-B9F2-F6352540ACAF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11" creationId="{5156B84E-E031-44F3-A4AE-86C954EDB92C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12" creationId="{9C274B5E-C60C-4FA7-B7EB-714EC117A93F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13" creationId="{858D76F1-9A5E-4CC6-BFC0-9FB0247659B4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14" creationId="{FB28EDEC-1FD7-4B40-89C3-704FD0BA0035}"/>
          </ac:spMkLst>
        </pc:spChg>
        <pc:spChg chg="mod">
          <ac:chgData name="Filippo Acconcia" userId="844af49c-a8a0-47ac-a7dd-14a44b60cd18" providerId="ADAL" clId="{4E01D738-D0C1-4B9B-B836-CF053EEC4C53}" dt="2022-03-16T10:45:51.859" v="1198" actId="165"/>
          <ac:spMkLst>
            <pc:docMk/>
            <pc:sldMk cId="2336920806" sldId="303"/>
            <ac:spMk id="415" creationId="{CFE86D43-B4CA-4B13-B100-8555FDB83F6D}"/>
          </ac:spMkLst>
        </pc:spChg>
        <pc:spChg chg="mod topLvl">
          <ac:chgData name="Filippo Acconcia" userId="844af49c-a8a0-47ac-a7dd-14a44b60cd18" providerId="ADAL" clId="{4E01D738-D0C1-4B9B-B836-CF053EEC4C53}" dt="2022-03-16T10:48:44.497" v="1245" actId="164"/>
          <ac:spMkLst>
            <pc:docMk/>
            <pc:sldMk cId="2336920806" sldId="303"/>
            <ac:spMk id="418" creationId="{3C9AB41C-963D-4F49-BD5F-33E32669E337}"/>
          </ac:spMkLst>
        </pc:spChg>
        <pc:spChg chg="mod topLvl">
          <ac:chgData name="Filippo Acconcia" userId="844af49c-a8a0-47ac-a7dd-14a44b60cd18" providerId="ADAL" clId="{4E01D738-D0C1-4B9B-B836-CF053EEC4C53}" dt="2022-03-16T10:48:44.497" v="1245" actId="164"/>
          <ac:spMkLst>
            <pc:docMk/>
            <pc:sldMk cId="2336920806" sldId="303"/>
            <ac:spMk id="419" creationId="{E05755A4-D715-40B8-BF1E-DB25FC65F5FE}"/>
          </ac:spMkLst>
        </pc:spChg>
        <pc:spChg chg="mod topLvl">
          <ac:chgData name="Filippo Acconcia" userId="844af49c-a8a0-47ac-a7dd-14a44b60cd18" providerId="ADAL" clId="{4E01D738-D0C1-4B9B-B836-CF053EEC4C53}" dt="2022-03-16T10:48:44.497" v="1245" actId="164"/>
          <ac:spMkLst>
            <pc:docMk/>
            <pc:sldMk cId="2336920806" sldId="303"/>
            <ac:spMk id="421" creationId="{9385303F-B05C-48FB-B915-F4400DBBA58C}"/>
          </ac:spMkLst>
        </pc:spChg>
        <pc:spChg chg="mod topLvl">
          <ac:chgData name="Filippo Acconcia" userId="844af49c-a8a0-47ac-a7dd-14a44b60cd18" providerId="ADAL" clId="{4E01D738-D0C1-4B9B-B836-CF053EEC4C53}" dt="2022-03-16T10:48:44.497" v="1245" actId="164"/>
          <ac:spMkLst>
            <pc:docMk/>
            <pc:sldMk cId="2336920806" sldId="303"/>
            <ac:spMk id="422" creationId="{419CDAD8-4810-458D-BA9D-3BD75EA1C1FC}"/>
          </ac:spMkLst>
        </pc:spChg>
        <pc:spChg chg="mod topLvl">
          <ac:chgData name="Filippo Acconcia" userId="844af49c-a8a0-47ac-a7dd-14a44b60cd18" providerId="ADAL" clId="{4E01D738-D0C1-4B9B-B836-CF053EEC4C53}" dt="2022-03-16T10:48:44.497" v="1245" actId="164"/>
          <ac:spMkLst>
            <pc:docMk/>
            <pc:sldMk cId="2336920806" sldId="303"/>
            <ac:spMk id="423" creationId="{8C4C1BB4-3696-4899-B78A-D69A04CCF05C}"/>
          </ac:spMkLst>
        </pc:spChg>
        <pc:spChg chg="mod topLvl">
          <ac:chgData name="Filippo Acconcia" userId="844af49c-a8a0-47ac-a7dd-14a44b60cd18" providerId="ADAL" clId="{4E01D738-D0C1-4B9B-B836-CF053EEC4C53}" dt="2022-03-16T10:48:44.497" v="1245" actId="164"/>
          <ac:spMkLst>
            <pc:docMk/>
            <pc:sldMk cId="2336920806" sldId="303"/>
            <ac:spMk id="425" creationId="{36F02D1A-90E3-4F4E-9723-F4C9850B4079}"/>
          </ac:spMkLst>
        </pc:spChg>
        <pc:spChg chg="mod topLvl">
          <ac:chgData name="Filippo Acconcia" userId="844af49c-a8a0-47ac-a7dd-14a44b60cd18" providerId="ADAL" clId="{4E01D738-D0C1-4B9B-B836-CF053EEC4C53}" dt="2022-03-16T10:50:17.240" v="1271" actId="122"/>
          <ac:spMkLst>
            <pc:docMk/>
            <pc:sldMk cId="2336920806" sldId="303"/>
            <ac:spMk id="426" creationId="{A7955280-9A07-4693-896A-91CC6805293D}"/>
          </ac:spMkLst>
        </pc:spChg>
        <pc:spChg chg="mod topLvl">
          <ac:chgData name="Filippo Acconcia" userId="844af49c-a8a0-47ac-a7dd-14a44b60cd18" providerId="ADAL" clId="{4E01D738-D0C1-4B9B-B836-CF053EEC4C53}" dt="2022-03-16T10:48:44.497" v="1245" actId="164"/>
          <ac:spMkLst>
            <pc:docMk/>
            <pc:sldMk cId="2336920806" sldId="303"/>
            <ac:spMk id="435" creationId="{8F1FBF35-B26C-4ABF-9FDF-86C7D3D6D4AA}"/>
          </ac:spMkLst>
        </pc:spChg>
        <pc:spChg chg="mod topLvl">
          <ac:chgData name="Filippo Acconcia" userId="844af49c-a8a0-47ac-a7dd-14a44b60cd18" providerId="ADAL" clId="{4E01D738-D0C1-4B9B-B836-CF053EEC4C53}" dt="2022-03-16T10:48:44.497" v="1245" actId="164"/>
          <ac:spMkLst>
            <pc:docMk/>
            <pc:sldMk cId="2336920806" sldId="303"/>
            <ac:spMk id="436" creationId="{59CDCF72-B6F9-4BBE-AE32-A3207A35E999}"/>
          </ac:spMkLst>
        </pc:spChg>
        <pc:spChg chg="mod topLvl">
          <ac:chgData name="Filippo Acconcia" userId="844af49c-a8a0-47ac-a7dd-14a44b60cd18" providerId="ADAL" clId="{4E01D738-D0C1-4B9B-B836-CF053EEC4C53}" dt="2022-03-16T10:48:44.497" v="1245" actId="164"/>
          <ac:spMkLst>
            <pc:docMk/>
            <pc:sldMk cId="2336920806" sldId="303"/>
            <ac:spMk id="437" creationId="{E9C9C7E2-A7E4-4394-84BE-0581BBA2F305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38" creationId="{291BF666-5C36-4AAF-821E-E5675270F960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39" creationId="{FFD145BB-E989-4EFF-8D2C-B272BAE54090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40" creationId="{4C27F1BE-FA5A-4858-8FDF-36DF9B379313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41" creationId="{11DC2B6C-2B97-4F9C-A4DF-8CB05CB8EE19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42" creationId="{BFB2C689-173D-40FE-8CF3-5F71F359734B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43" creationId="{808E9B6E-CA33-42A7-A256-9A8163B77568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44" creationId="{65BEC701-7FA9-45A9-88AD-2A7230B37A8E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45" creationId="{10379524-05F6-49AD-9BDD-291D49F7A0D2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46" creationId="{95153423-3A62-498B-B9B7-451D8F3B24DD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47" creationId="{22BC765E-C743-4D86-89AB-A66155B1620D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48" creationId="{0D04E2F6-B50B-47DE-8C72-7CADC51632A4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49" creationId="{A12EDF2E-08E3-41B0-885D-82332271A806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50" creationId="{E76D6965-4747-427A-B14C-63DCF0DB3027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51" creationId="{163A034F-D7E0-48EF-8314-A6A3611A2CDA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52" creationId="{771FA0C3-DF6C-49BF-ACA2-69309BC6DE04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53" creationId="{F6E3E440-FB13-436A-B77C-1A489F5A8496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54" creationId="{5750FD1E-C70F-46BA-90A7-506B9CDDBDC8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55" creationId="{B54023EE-575F-4940-8D63-241D5E2065DF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56" creationId="{87165669-A65C-412F-B25E-8849E3FD8D38}"/>
          </ac:spMkLst>
        </pc:spChg>
        <pc:spChg chg="mod">
          <ac:chgData name="Filippo Acconcia" userId="844af49c-a8a0-47ac-a7dd-14a44b60cd18" providerId="ADAL" clId="{4E01D738-D0C1-4B9B-B836-CF053EEC4C53}" dt="2022-03-16T10:47:56.412" v="1227" actId="165"/>
          <ac:spMkLst>
            <pc:docMk/>
            <pc:sldMk cId="2336920806" sldId="303"/>
            <ac:spMk id="457" creationId="{78D52EA7-A821-43AB-ABD2-091A697B20DE}"/>
          </ac:spMkLst>
        </pc:spChg>
        <pc:spChg chg="mod topLvl">
          <ac:chgData name="Filippo Acconcia" userId="844af49c-a8a0-47ac-a7dd-14a44b60cd18" providerId="ADAL" clId="{4E01D738-D0C1-4B9B-B836-CF053EEC4C53}" dt="2022-03-16T10:53:09.412" v="1328" actId="164"/>
          <ac:spMkLst>
            <pc:docMk/>
            <pc:sldMk cId="2336920806" sldId="303"/>
            <ac:spMk id="464" creationId="{8AD83EFB-F87E-4636-B7C6-F99F34D93EAA}"/>
          </ac:spMkLst>
        </pc:spChg>
        <pc:spChg chg="mod topLvl">
          <ac:chgData name="Filippo Acconcia" userId="844af49c-a8a0-47ac-a7dd-14a44b60cd18" providerId="ADAL" clId="{4E01D738-D0C1-4B9B-B836-CF053EEC4C53}" dt="2022-03-16T10:53:09.412" v="1328" actId="164"/>
          <ac:spMkLst>
            <pc:docMk/>
            <pc:sldMk cId="2336920806" sldId="303"/>
            <ac:spMk id="465" creationId="{AF2E13E1-DC1B-40E5-95C2-B6285056F700}"/>
          </ac:spMkLst>
        </pc:spChg>
        <pc:spChg chg="mod topLvl">
          <ac:chgData name="Filippo Acconcia" userId="844af49c-a8a0-47ac-a7dd-14a44b60cd18" providerId="ADAL" clId="{4E01D738-D0C1-4B9B-B836-CF053EEC4C53}" dt="2022-03-16T10:53:09.412" v="1328" actId="164"/>
          <ac:spMkLst>
            <pc:docMk/>
            <pc:sldMk cId="2336920806" sldId="303"/>
            <ac:spMk id="467" creationId="{23928B5A-0BBD-4C61-B31A-5A157BB130D8}"/>
          </ac:spMkLst>
        </pc:spChg>
        <pc:spChg chg="mod topLvl">
          <ac:chgData name="Filippo Acconcia" userId="844af49c-a8a0-47ac-a7dd-14a44b60cd18" providerId="ADAL" clId="{4E01D738-D0C1-4B9B-B836-CF053EEC4C53}" dt="2022-03-16T10:53:09.412" v="1328" actId="164"/>
          <ac:spMkLst>
            <pc:docMk/>
            <pc:sldMk cId="2336920806" sldId="303"/>
            <ac:spMk id="468" creationId="{7BDC0BDB-4637-4219-976F-9E1DB6E5B1ED}"/>
          </ac:spMkLst>
        </pc:spChg>
        <pc:spChg chg="mod topLvl">
          <ac:chgData name="Filippo Acconcia" userId="844af49c-a8a0-47ac-a7dd-14a44b60cd18" providerId="ADAL" clId="{4E01D738-D0C1-4B9B-B836-CF053EEC4C53}" dt="2022-03-16T10:53:09.412" v="1328" actId="164"/>
          <ac:spMkLst>
            <pc:docMk/>
            <pc:sldMk cId="2336920806" sldId="303"/>
            <ac:spMk id="469" creationId="{DD26FFC7-52A2-46E7-8218-C5B242A31715}"/>
          </ac:spMkLst>
        </pc:spChg>
        <pc:spChg chg="mod topLvl">
          <ac:chgData name="Filippo Acconcia" userId="844af49c-a8a0-47ac-a7dd-14a44b60cd18" providerId="ADAL" clId="{4E01D738-D0C1-4B9B-B836-CF053EEC4C53}" dt="2022-03-16T10:53:09.412" v="1328" actId="164"/>
          <ac:spMkLst>
            <pc:docMk/>
            <pc:sldMk cId="2336920806" sldId="303"/>
            <ac:spMk id="471" creationId="{467A1F96-F92A-494D-8BD9-5C5FDA0BC23F}"/>
          </ac:spMkLst>
        </pc:spChg>
        <pc:spChg chg="mod topLvl">
          <ac:chgData name="Filippo Acconcia" userId="844af49c-a8a0-47ac-a7dd-14a44b60cd18" providerId="ADAL" clId="{4E01D738-D0C1-4B9B-B836-CF053EEC4C53}" dt="2022-03-16T10:53:09.412" v="1328" actId="164"/>
          <ac:spMkLst>
            <pc:docMk/>
            <pc:sldMk cId="2336920806" sldId="303"/>
            <ac:spMk id="472" creationId="{7EFEC295-AA1C-4B3C-B88C-587E17B21A88}"/>
          </ac:spMkLst>
        </pc:spChg>
        <pc:spChg chg="mod topLvl">
          <ac:chgData name="Filippo Acconcia" userId="844af49c-a8a0-47ac-a7dd-14a44b60cd18" providerId="ADAL" clId="{4E01D738-D0C1-4B9B-B836-CF053EEC4C53}" dt="2022-03-16T10:53:09.412" v="1328" actId="164"/>
          <ac:spMkLst>
            <pc:docMk/>
            <pc:sldMk cId="2336920806" sldId="303"/>
            <ac:spMk id="481" creationId="{73611061-F4F5-4435-B286-B36BFC8E09A5}"/>
          </ac:spMkLst>
        </pc:spChg>
        <pc:spChg chg="mod topLvl">
          <ac:chgData name="Filippo Acconcia" userId="844af49c-a8a0-47ac-a7dd-14a44b60cd18" providerId="ADAL" clId="{4E01D738-D0C1-4B9B-B836-CF053EEC4C53}" dt="2022-03-16T10:53:09.412" v="1328" actId="164"/>
          <ac:spMkLst>
            <pc:docMk/>
            <pc:sldMk cId="2336920806" sldId="303"/>
            <ac:spMk id="482" creationId="{A8420A2A-F6E7-4FFB-A30D-E5F571338C1C}"/>
          </ac:spMkLst>
        </pc:spChg>
        <pc:spChg chg="mod topLvl">
          <ac:chgData name="Filippo Acconcia" userId="844af49c-a8a0-47ac-a7dd-14a44b60cd18" providerId="ADAL" clId="{4E01D738-D0C1-4B9B-B836-CF053EEC4C53}" dt="2022-03-16T10:53:09.412" v="1328" actId="164"/>
          <ac:spMkLst>
            <pc:docMk/>
            <pc:sldMk cId="2336920806" sldId="303"/>
            <ac:spMk id="483" creationId="{249F6C9C-FC88-48A5-A238-4F32993D7B4C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84" creationId="{5AFBA8A2-E41C-4B18-A3A9-BED6A55D093E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85" creationId="{AFBE5987-B8B6-4AEC-A573-1ECDF070F659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86" creationId="{536F2756-8CF2-497A-9DD6-9CB25950B798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87" creationId="{65BDE917-A59F-4097-802A-BDECD6691443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88" creationId="{DC877569-16CF-48E5-81B4-6CD432CA5B52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89" creationId="{A3B770AD-C4B0-4D56-AD5D-DFDA796EFCBD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90" creationId="{48C18B6D-0D86-4D8F-94BD-08B6FDEF23E0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91" creationId="{6A7B0534-8F9F-4E6E-A215-3C99DC7DCF68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92" creationId="{7B027673-F4A2-4450-8ED2-B3C1D6ABAFB3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93" creationId="{092B5D96-048B-4A69-BE41-D05B5814EA74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94" creationId="{A93708E3-8CF1-4213-9487-9984E78E18BA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95" creationId="{21E77D77-87CA-477A-AC5A-76B115CB5208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96" creationId="{DF3D68DA-B5C1-4DA7-A768-891BD238B95C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97" creationId="{5D73D03A-F20A-4715-8B78-B229AF4726FB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98" creationId="{0C7EAB58-F83B-44AC-BE85-E42D0DF58548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499" creationId="{E045944D-4D7B-412A-8424-9AA0C37AA526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500" creationId="{0F0D2AD4-A5D5-4556-8C5A-AE504B9DDB4D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501" creationId="{76048FC3-AD5E-4159-ADBA-A117BAFEEC47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502" creationId="{1A05A1CB-FA2C-48B1-B653-F10A1A721215}"/>
          </ac:spMkLst>
        </pc:spChg>
        <pc:spChg chg="mod">
          <ac:chgData name="Filippo Acconcia" userId="844af49c-a8a0-47ac-a7dd-14a44b60cd18" providerId="ADAL" clId="{4E01D738-D0C1-4B9B-B836-CF053EEC4C53}" dt="2022-03-16T10:51:11.698" v="1276" actId="165"/>
          <ac:spMkLst>
            <pc:docMk/>
            <pc:sldMk cId="2336920806" sldId="303"/>
            <ac:spMk id="503" creationId="{20A2B465-489E-48C6-9236-0C52B0E21EB9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06" creationId="{BF1C9632-7072-4523-BE39-64D7FA166513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07" creationId="{78709AC7-FD3B-4A9F-86D4-B88528A60A27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09" creationId="{A7D059F4-9BC9-40D6-90BF-88BC18F1663A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10" creationId="{5EDAF961-6DE5-4408-8F95-5B03D70B1FE3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11" creationId="{22EB40A1-190C-4F25-B755-F0A3C98CE30A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13" creationId="{17AB62EF-14FD-4D06-8B61-C904B1170FEA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14" creationId="{94010458-0F15-4FAC-8C19-BACF478A41BE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23" creationId="{4DE11259-274F-43D3-8BAD-9A27C047B669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24" creationId="{23971413-ACBA-4CFB-8150-8A68B29E5936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25" creationId="{D0E35D94-290F-4C7D-BF1E-9CA3416F8F77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26" creationId="{BAF11D9A-7A1E-4794-8B58-CBFA3261478B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27" creationId="{8EA395B2-3437-4B0A-9597-8D53810BBD38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28" creationId="{F00DFD9E-7B12-4AFF-969B-B257E7E2884F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29" creationId="{5B3F7FEA-620C-4F4B-A9C9-C559096F71BA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30" creationId="{23920B44-A6A4-4E7B-B3B5-C05FD5958717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31" creationId="{D301E71C-8C9E-4CED-9232-152DA48DE1A7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32" creationId="{D77738A2-0F3D-4A59-B845-EF85C8F077A0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33" creationId="{6C301296-CF3A-4D51-B0C0-7608A80071B7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34" creationId="{042C27EB-6B56-4ABE-96CC-02686CAA2B9C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35" creationId="{5A589E98-7C30-4A73-98EA-E108789C7AA4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36" creationId="{734F1746-A08A-4276-B4A1-B42499076088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37" creationId="{F4B5A3F9-0C81-44E7-B0C1-A6B642C0AA16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38" creationId="{CB879206-C8F0-4FC2-AAF1-66E3E6761D44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39" creationId="{FA00AEC2-0607-4FCB-A436-C691CEAC4802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40" creationId="{F9A013E2-F2A7-4677-8805-D1BD10680BC1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41" creationId="{99D2068A-0142-45C0-AC2D-2071FD2C4D1E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42" creationId="{469DD4F8-DDEB-441A-BDF6-BC115EE1B8C1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43" creationId="{0CE5E570-53F2-4B62-812F-F17ECD668147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44" creationId="{5E666768-581C-4B87-AF5A-A2228B0198C6}"/>
          </ac:spMkLst>
        </pc:spChg>
        <pc:spChg chg="mod">
          <ac:chgData name="Filippo Acconcia" userId="844af49c-a8a0-47ac-a7dd-14a44b60cd18" providerId="ADAL" clId="{4E01D738-D0C1-4B9B-B836-CF053EEC4C53}" dt="2022-03-16T10:49:02.913" v="1247"/>
          <ac:spMkLst>
            <pc:docMk/>
            <pc:sldMk cId="2336920806" sldId="303"/>
            <ac:spMk id="545" creationId="{E00AC9DE-1AE2-41EE-866B-022C26799800}"/>
          </ac:spMkLst>
        </pc:spChg>
        <pc:spChg chg="mod">
          <ac:chgData name="Filippo Acconcia" userId="844af49c-a8a0-47ac-a7dd-14a44b60cd18" providerId="ADAL" clId="{4E01D738-D0C1-4B9B-B836-CF053EEC4C53}" dt="2022-03-16T10:50:04.660" v="1268" actId="20577"/>
          <ac:spMkLst>
            <pc:docMk/>
            <pc:sldMk cId="2336920806" sldId="303"/>
            <ac:spMk id="548" creationId="{23F45B49-9D40-45E4-A010-E8F3C690AC2C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49" creationId="{0B24E2EE-F3A6-4AF0-BAFD-E066A5B64D98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51" creationId="{EDD02017-8321-46E3-8773-2A66E742D65F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52" creationId="{C24683A0-0D6C-411C-8510-9D2A056B0A59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53" creationId="{5D1F8B75-ED55-4E09-9CCD-D374B48C1614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55" creationId="{12AE1ED4-EF41-44DF-BA09-9E0DDA2DF9B6}"/>
          </ac:spMkLst>
        </pc:spChg>
        <pc:spChg chg="mod">
          <ac:chgData name="Filippo Acconcia" userId="844af49c-a8a0-47ac-a7dd-14a44b60cd18" providerId="ADAL" clId="{4E01D738-D0C1-4B9B-B836-CF053EEC4C53}" dt="2022-03-16T10:50:15.285" v="1270" actId="122"/>
          <ac:spMkLst>
            <pc:docMk/>
            <pc:sldMk cId="2336920806" sldId="303"/>
            <ac:spMk id="556" creationId="{A14CBA07-E619-4123-A2FC-08C85B680B0C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65" creationId="{FF14A402-26A8-41DC-B756-04820A9C9D27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66" creationId="{ED67EA2D-7480-411F-B253-BC7DB805A6B0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67" creationId="{7695DC41-4A52-4F35-8513-3055AAE4769B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68" creationId="{BB885C3F-9635-4A19-969F-C59124674F5A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69" creationId="{80A1BD58-7BB1-4BAD-890B-9C5B2B8F3116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70" creationId="{BDD5C3FB-6CF9-493A-A092-755B6D5ECE6F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71" creationId="{45D3B3AD-04B8-4FEF-A493-C8F7B9CE875C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72" creationId="{519D2874-DB3D-4C90-AA12-FC4DDE33439D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73" creationId="{30388B16-05B9-4F01-9E52-094BAA23F62D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74" creationId="{EE83A4D2-B1AE-4B3C-AA4B-98D87CBAFF8C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75" creationId="{2BC4B129-ACB5-4F57-9366-3FF647BE9E90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76" creationId="{C584F7DE-D0F8-4BE4-B91A-EBD81859AC20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77" creationId="{D2A74697-921D-41AF-ACC4-9690124704C1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78" creationId="{D44B9E6C-DB02-4CC8-8971-054A69A3C376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79" creationId="{33DD36A7-3E0F-4542-8BE3-7A2C1BAA52B3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80" creationId="{9D640318-87C7-4160-87F6-ADA1CB50D1AF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81" creationId="{40EA5DD5-A1D2-4D24-9EA8-A3E654C1899B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82" creationId="{D31D7730-CF2C-429E-8589-6AD7E1613DF5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83" creationId="{043FE3F8-13AE-4AD8-8B98-DB718A8D0D57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84" creationId="{6294EE0F-7C5C-48B4-8F5E-02D97FB8EFC5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85" creationId="{09D48E5F-AF43-4150-9776-828DD77A9358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86" creationId="{B507F7F4-2F61-448B-B435-2B93BCE9C104}"/>
          </ac:spMkLst>
        </pc:spChg>
        <pc:spChg chg="mod">
          <ac:chgData name="Filippo Acconcia" userId="844af49c-a8a0-47ac-a7dd-14a44b60cd18" providerId="ADAL" clId="{4E01D738-D0C1-4B9B-B836-CF053EEC4C53}" dt="2022-03-16T10:49:59.150" v="1262"/>
          <ac:spMkLst>
            <pc:docMk/>
            <pc:sldMk cId="2336920806" sldId="303"/>
            <ac:spMk id="587" creationId="{F3D3758C-22D4-4902-86EF-757C1E92CAA3}"/>
          </ac:spMkLst>
        </pc:spChg>
        <pc:spChg chg="add mod">
          <ac:chgData name="Filippo Acconcia" userId="844af49c-a8a0-47ac-a7dd-14a44b60cd18" providerId="ADAL" clId="{4E01D738-D0C1-4B9B-B836-CF053EEC4C53}" dt="2022-03-16T10:53:05.724" v="1327" actId="164"/>
          <ac:spMkLst>
            <pc:docMk/>
            <pc:sldMk cId="2336920806" sldId="303"/>
            <ac:spMk id="590" creationId="{7C97C709-AE3E-44E5-8F3D-5B7DF7CADC05}"/>
          </ac:spMkLst>
        </pc:spChg>
        <pc:spChg chg="add mod">
          <ac:chgData name="Filippo Acconcia" userId="844af49c-a8a0-47ac-a7dd-14a44b60cd18" providerId="ADAL" clId="{4E01D738-D0C1-4B9B-B836-CF053EEC4C53}" dt="2022-03-16T10:53:05.724" v="1327" actId="164"/>
          <ac:spMkLst>
            <pc:docMk/>
            <pc:sldMk cId="2336920806" sldId="303"/>
            <ac:spMk id="591" creationId="{34BB8974-47AE-4CD1-A29A-FDFB1F977811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593" creationId="{5CAA7D12-0A2D-4288-B30E-2CC967BE8950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594" creationId="{07711340-0830-422F-9A93-330B4E07BF53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595" creationId="{C8234794-3ED3-4558-AC9C-4A5E9039046C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596" creationId="{13F7B650-E826-47A3-BF2A-BAD22803A4E4}"/>
          </ac:spMkLst>
        </pc:spChg>
        <pc:spChg chg="add mod">
          <ac:chgData name="Filippo Acconcia" userId="844af49c-a8a0-47ac-a7dd-14a44b60cd18" providerId="ADAL" clId="{4E01D738-D0C1-4B9B-B836-CF053EEC4C53}" dt="2022-03-16T10:53:05.724" v="1327" actId="164"/>
          <ac:spMkLst>
            <pc:docMk/>
            <pc:sldMk cId="2336920806" sldId="303"/>
            <ac:spMk id="597" creationId="{628937DB-5C5A-4393-ADE4-665A4FABA8D3}"/>
          </ac:spMkLst>
        </pc:spChg>
        <pc:spChg chg="add mod">
          <ac:chgData name="Filippo Acconcia" userId="844af49c-a8a0-47ac-a7dd-14a44b60cd18" providerId="ADAL" clId="{4E01D738-D0C1-4B9B-B836-CF053EEC4C53}" dt="2022-03-16T10:53:05.724" v="1327" actId="164"/>
          <ac:spMkLst>
            <pc:docMk/>
            <pc:sldMk cId="2336920806" sldId="303"/>
            <ac:spMk id="598" creationId="{412F04E8-FD7D-4B8A-B9FA-C58DEDADC242}"/>
          </ac:spMkLst>
        </pc:spChg>
        <pc:spChg chg="add mod">
          <ac:chgData name="Filippo Acconcia" userId="844af49c-a8a0-47ac-a7dd-14a44b60cd18" providerId="ADAL" clId="{4E01D738-D0C1-4B9B-B836-CF053EEC4C53}" dt="2022-03-16T10:53:05.724" v="1327" actId="164"/>
          <ac:spMkLst>
            <pc:docMk/>
            <pc:sldMk cId="2336920806" sldId="303"/>
            <ac:spMk id="599" creationId="{CB814AD2-41F1-4A42-89A8-8B50EBCB1C69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01" creationId="{EE589B38-1460-4F57-B477-4CE915E3FE67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02" creationId="{4AFF26A9-8CDD-4959-9FFD-F25158D2C8FE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03" creationId="{766B5342-0079-40DC-9E99-308EA100E6EE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04" creationId="{92DAB267-09BF-4530-BEA4-C8D8C322B8D6}"/>
          </ac:spMkLst>
        </pc:spChg>
        <pc:spChg chg="add mod">
          <ac:chgData name="Filippo Acconcia" userId="844af49c-a8a0-47ac-a7dd-14a44b60cd18" providerId="ADAL" clId="{4E01D738-D0C1-4B9B-B836-CF053EEC4C53}" dt="2022-03-16T10:53:05.724" v="1327" actId="164"/>
          <ac:spMkLst>
            <pc:docMk/>
            <pc:sldMk cId="2336920806" sldId="303"/>
            <ac:spMk id="605" creationId="{B6A68E76-8271-4DBB-906D-E7A7E7B9D377}"/>
          </ac:spMkLst>
        </pc:spChg>
        <pc:spChg chg="add mod">
          <ac:chgData name="Filippo Acconcia" userId="844af49c-a8a0-47ac-a7dd-14a44b60cd18" providerId="ADAL" clId="{4E01D738-D0C1-4B9B-B836-CF053EEC4C53}" dt="2022-03-16T10:53:05.724" v="1327" actId="164"/>
          <ac:spMkLst>
            <pc:docMk/>
            <pc:sldMk cId="2336920806" sldId="303"/>
            <ac:spMk id="606" creationId="{3FDEF42D-FD3E-435D-AC4D-73D023704244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08" creationId="{2C11F9DE-AF31-47E5-929A-0D4EDA2C632C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09" creationId="{EC032D37-700B-4822-AD81-6655BE9AE429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10" creationId="{D74E5089-D2E8-4482-8261-60E929A7C8D4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11" creationId="{5D7FDCD9-6693-4E4E-A76B-16D19D42991C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13" creationId="{62312CCA-3D1F-4C70-AFDF-39F8819CEDFA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14" creationId="{281965F8-2995-4E18-9167-CCBA1BF2F955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15" creationId="{3A35B3CA-3891-473D-89E1-C2189C57D684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16" creationId="{206FD3C8-A092-4DB0-BE23-1C7410B80933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18" creationId="{E7B88066-7DE7-4971-8D54-22C4DF4654A8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19" creationId="{3347B53D-0511-4CD4-B31A-0287E3996D6E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20" creationId="{EC70AEA2-DF30-4AA2-BBF7-E8B5CB98B4F9}"/>
          </ac:spMkLst>
        </pc:spChg>
        <pc:spChg chg="mod">
          <ac:chgData name="Filippo Acconcia" userId="844af49c-a8a0-47ac-a7dd-14a44b60cd18" providerId="ADAL" clId="{4E01D738-D0C1-4B9B-B836-CF053EEC4C53}" dt="2022-03-16T10:52:04.097" v="1312"/>
          <ac:spMkLst>
            <pc:docMk/>
            <pc:sldMk cId="2336920806" sldId="303"/>
            <ac:spMk id="621" creationId="{B0A01331-D937-4DAE-B53E-1234D0F23DE4}"/>
          </ac:spMkLst>
        </pc:spChg>
        <pc:spChg chg="add mod">
          <ac:chgData name="Filippo Acconcia" userId="844af49c-a8a0-47ac-a7dd-14a44b60cd18" providerId="ADAL" clId="{4E01D738-D0C1-4B9B-B836-CF053EEC4C53}" dt="2022-03-16T10:53:05.724" v="1327" actId="164"/>
          <ac:spMkLst>
            <pc:docMk/>
            <pc:sldMk cId="2336920806" sldId="303"/>
            <ac:spMk id="627" creationId="{325C96F4-7638-40EA-A7EC-599490BBD03A}"/>
          </ac:spMkLst>
        </pc:spChg>
        <pc:spChg chg="add mod">
          <ac:chgData name="Filippo Acconcia" userId="844af49c-a8a0-47ac-a7dd-14a44b60cd18" providerId="ADAL" clId="{4E01D738-D0C1-4B9B-B836-CF053EEC4C53}" dt="2022-03-16T10:53:05.724" v="1327" actId="164"/>
          <ac:spMkLst>
            <pc:docMk/>
            <pc:sldMk cId="2336920806" sldId="303"/>
            <ac:spMk id="628" creationId="{47CC8932-4048-4FC7-A266-878875285923}"/>
          </ac:spMkLst>
        </pc:spChg>
        <pc:spChg chg="add mod">
          <ac:chgData name="Filippo Acconcia" userId="844af49c-a8a0-47ac-a7dd-14a44b60cd18" providerId="ADAL" clId="{4E01D738-D0C1-4B9B-B836-CF053EEC4C53}" dt="2022-03-16T10:53:05.724" v="1327" actId="164"/>
          <ac:spMkLst>
            <pc:docMk/>
            <pc:sldMk cId="2336920806" sldId="303"/>
            <ac:spMk id="629" creationId="{9D78BE89-DF1D-4389-BC38-75BE69ED06EE}"/>
          </ac:spMkLst>
        </pc:spChg>
        <pc:spChg chg="add mod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635" creationId="{BE784ECA-9A07-4625-B54C-84C303788E45}"/>
          </ac:spMkLst>
        </pc:spChg>
        <pc:spChg chg="add mod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636" creationId="{9CD2330C-12AE-45D1-9A92-0D8EE6BC1644}"/>
          </ac:spMkLst>
        </pc:spChg>
        <pc:spChg chg="add mod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637" creationId="{C0693577-8F71-47D7-96D6-4ADD3894975A}"/>
          </ac:spMkLst>
        </pc:spChg>
        <pc:spChg chg="add mod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638" creationId="{D4598CFE-7C56-4E22-9980-84459DCC3BE5}"/>
          </ac:spMkLst>
        </pc:spChg>
        <pc:spChg chg="add mod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639" creationId="{AD6B4E77-FAF0-454A-9262-B42226CF8EDD}"/>
          </ac:spMkLst>
        </pc:spChg>
        <pc:spChg chg="add mod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640" creationId="{727386A9-E6C5-464F-8CB1-F96EECCA507B}"/>
          </ac:spMkLst>
        </pc:spChg>
        <pc:spChg chg="add mod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641" creationId="{C1DD63F2-A8FF-4685-AFC9-07A71B60D5B8}"/>
          </ac:spMkLst>
        </pc:spChg>
        <pc:spChg chg="add mod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642" creationId="{59879B6F-72AC-452E-BE9D-5109159119A7}"/>
          </ac:spMkLst>
        </pc:spChg>
        <pc:spChg chg="add mod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643" creationId="{5B94EBE7-3A41-43C5-A983-EF67190E451F}"/>
          </ac:spMkLst>
        </pc:spChg>
        <pc:spChg chg="add mod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644" creationId="{82129971-52FA-46D9-85CA-E3B0F86BABF4}"/>
          </ac:spMkLst>
        </pc:spChg>
        <pc:spChg chg="add mod">
          <ac:chgData name="Filippo Acconcia" userId="844af49c-a8a0-47ac-a7dd-14a44b60cd18" providerId="ADAL" clId="{4E01D738-D0C1-4B9B-B836-CF053EEC4C53}" dt="2022-03-16T11:00:52.825" v="1570" actId="164"/>
          <ac:spMkLst>
            <pc:docMk/>
            <pc:sldMk cId="2336920806" sldId="303"/>
            <ac:spMk id="645" creationId="{774021C9-938A-468D-8790-34FAC81C89CD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46" creationId="{6DFACB0B-141B-4E3D-9EA8-BBF5717D48B6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47" creationId="{2B0E1C1C-2F31-4DA3-9D2A-22A6DB6B8D23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48" creationId="{E62D167C-793D-4CD9-92A7-2A1CA2C8F26B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51" creationId="{C0F32B31-5A9B-4961-8ADB-03E49F31A7A8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52" creationId="{D90C61C0-D667-4ABD-BA9A-95B7C61CE38F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53" creationId="{6E2676A1-FFAF-42D9-842C-75E6252CBB4D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54" creationId="{FD78B50C-4494-4591-A37B-E84A22040212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55" creationId="{27C3DA2D-BB87-451C-8EE8-981EE04128DA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56" creationId="{2D4B08DC-B673-4AAE-8327-9EF603BA5DA5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57" creationId="{706B9D02-9C02-4CC0-BA11-A62B38F1D941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58" creationId="{3D839ED6-60C4-4CC2-8930-8F2FD58C81DC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59" creationId="{D84525FF-24F1-456F-8814-70BE1DDB83D8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60" creationId="{8F86B1BE-595D-428F-9654-A3EA8E68131D}"/>
          </ac:spMkLst>
        </pc:spChg>
        <pc:spChg chg="add mod">
          <ac:chgData name="Filippo Acconcia" userId="844af49c-a8a0-47ac-a7dd-14a44b60cd18" providerId="ADAL" clId="{4E01D738-D0C1-4B9B-B836-CF053EEC4C53}" dt="2022-03-16T11:00:49.170" v="1569" actId="164"/>
          <ac:spMkLst>
            <pc:docMk/>
            <pc:sldMk cId="2336920806" sldId="303"/>
            <ac:spMk id="661" creationId="{ADB6F71A-8B50-4234-8E2A-92BD23677A9F}"/>
          </ac:spMkLst>
        </pc:spChg>
        <pc:spChg chg="add mod">
          <ac:chgData name="Filippo Acconcia" userId="844af49c-a8a0-47ac-a7dd-14a44b60cd18" providerId="ADAL" clId="{4E01D738-D0C1-4B9B-B836-CF053EEC4C53}" dt="2022-03-16T11:01:50.069" v="1605" actId="1035"/>
          <ac:spMkLst>
            <pc:docMk/>
            <pc:sldMk cId="2336920806" sldId="303"/>
            <ac:spMk id="665" creationId="{C30AD504-8939-4AFE-B510-3149357D2E7B}"/>
          </ac:spMkLst>
        </pc:spChg>
        <pc:spChg chg="add mod">
          <ac:chgData name="Filippo Acconcia" userId="844af49c-a8a0-47ac-a7dd-14a44b60cd18" providerId="ADAL" clId="{4E01D738-D0C1-4B9B-B836-CF053EEC4C53}" dt="2022-03-16T11:02:04.512" v="1626" actId="20577"/>
          <ac:spMkLst>
            <pc:docMk/>
            <pc:sldMk cId="2336920806" sldId="303"/>
            <ac:spMk id="666" creationId="{7AD48628-674B-4EFD-8303-2441258707C5}"/>
          </ac:spMkLst>
        </pc:spChg>
        <pc:spChg chg="add mod">
          <ac:chgData name="Filippo Acconcia" userId="844af49c-a8a0-47ac-a7dd-14a44b60cd18" providerId="ADAL" clId="{4E01D738-D0C1-4B9B-B836-CF053EEC4C53}" dt="2022-03-16T11:02:13.740" v="1630" actId="554"/>
          <ac:spMkLst>
            <pc:docMk/>
            <pc:sldMk cId="2336920806" sldId="303"/>
            <ac:spMk id="667" creationId="{63DB0A4B-B65E-40A0-A874-5B61A4EDB3F1}"/>
          </ac:spMkLst>
        </pc:spChg>
        <pc:spChg chg="add mod">
          <ac:chgData name="Filippo Acconcia" userId="844af49c-a8a0-47ac-a7dd-14a44b60cd18" providerId="ADAL" clId="{4E01D738-D0C1-4B9B-B836-CF053EEC4C53}" dt="2022-03-16T11:02:13.740" v="1630" actId="554"/>
          <ac:spMkLst>
            <pc:docMk/>
            <pc:sldMk cId="2336920806" sldId="303"/>
            <ac:spMk id="668" creationId="{ABC334DD-252A-475E-8B59-93F90492C498}"/>
          </ac:spMkLst>
        </pc:spChg>
        <pc:spChg chg="add mod">
          <ac:chgData name="Filippo Acconcia" userId="844af49c-a8a0-47ac-a7dd-14a44b60cd18" providerId="ADAL" clId="{4E01D738-D0C1-4B9B-B836-CF053EEC4C53}" dt="2022-03-16T11:02:20.740" v="1632" actId="554"/>
          <ac:spMkLst>
            <pc:docMk/>
            <pc:sldMk cId="2336920806" sldId="303"/>
            <ac:spMk id="669" creationId="{337075A9-A06A-4CA5-AA6F-9061E50802EC}"/>
          </ac:spMkLst>
        </pc:spChg>
        <pc:spChg chg="add mod">
          <ac:chgData name="Filippo Acconcia" userId="844af49c-a8a0-47ac-a7dd-14a44b60cd18" providerId="ADAL" clId="{4E01D738-D0C1-4B9B-B836-CF053EEC4C53}" dt="2022-03-16T11:02:20.740" v="1632" actId="554"/>
          <ac:spMkLst>
            <pc:docMk/>
            <pc:sldMk cId="2336920806" sldId="303"/>
            <ac:spMk id="670" creationId="{A2A06F85-C998-4DD1-B442-D3A53E537960}"/>
          </ac:spMkLst>
        </pc:spChg>
        <pc:spChg chg="add mod">
          <ac:chgData name="Filippo Acconcia" userId="844af49c-a8a0-47ac-a7dd-14a44b60cd18" providerId="ADAL" clId="{4E01D738-D0C1-4B9B-B836-CF053EEC4C53}" dt="2022-03-16T11:02:30.010" v="1634" actId="554"/>
          <ac:spMkLst>
            <pc:docMk/>
            <pc:sldMk cId="2336920806" sldId="303"/>
            <ac:spMk id="671" creationId="{5C3B9A74-39CE-4C63-8B10-928CFD6A71FA}"/>
          </ac:spMkLst>
        </pc:spChg>
        <pc:spChg chg="add mod">
          <ac:chgData name="Filippo Acconcia" userId="844af49c-a8a0-47ac-a7dd-14a44b60cd18" providerId="ADAL" clId="{4E01D738-D0C1-4B9B-B836-CF053EEC4C53}" dt="2022-03-16T11:02:30.010" v="1634" actId="554"/>
          <ac:spMkLst>
            <pc:docMk/>
            <pc:sldMk cId="2336920806" sldId="303"/>
            <ac:spMk id="672" creationId="{73600A0C-6473-487C-9674-4B85DE71D5B6}"/>
          </ac:spMkLst>
        </pc:spChg>
        <pc:grpChg chg="add del mod">
          <ac:chgData name="Filippo Acconcia" userId="844af49c-a8a0-47ac-a7dd-14a44b60cd18" providerId="ADAL" clId="{4E01D738-D0C1-4B9B-B836-CF053EEC4C53}" dt="2022-03-16T10:10:56.038" v="954" actId="165"/>
          <ac:grpSpMkLst>
            <pc:docMk/>
            <pc:sldMk cId="2336920806" sldId="303"/>
            <ac:grpSpMk id="3" creationId="{3E02A2FF-4E35-47FA-94F4-61E57F48328B}"/>
          </ac:grpSpMkLst>
        </pc:grpChg>
        <pc:grpChg chg="del mod topLvl">
          <ac:chgData name="Filippo Acconcia" userId="844af49c-a8a0-47ac-a7dd-14a44b60cd18" providerId="ADAL" clId="{4E01D738-D0C1-4B9B-B836-CF053EEC4C53}" dt="2022-03-16T10:11:14.733" v="961" actId="478"/>
          <ac:grpSpMkLst>
            <pc:docMk/>
            <pc:sldMk cId="2336920806" sldId="303"/>
            <ac:grpSpMk id="41" creationId="{4A16A3ED-F976-47E1-B2AE-F07640E4C6A4}"/>
          </ac:grpSpMkLst>
        </pc:grpChg>
        <pc:grpChg chg="add del mod">
          <ac:chgData name="Filippo Acconcia" userId="844af49c-a8a0-47ac-a7dd-14a44b60cd18" providerId="ADAL" clId="{4E01D738-D0C1-4B9B-B836-CF053EEC4C53}" dt="2022-03-16T10:44:36.900" v="1188" actId="478"/>
          <ac:grpSpMkLst>
            <pc:docMk/>
            <pc:sldMk cId="2336920806" sldId="303"/>
            <ac:grpSpMk id="46" creationId="{0ADF8F44-8497-432C-A57D-B0F25A1CC6C9}"/>
          </ac:grpSpMkLst>
        </pc:grpChg>
        <pc:grpChg chg="mod">
          <ac:chgData name="Filippo Acconcia" userId="844af49c-a8a0-47ac-a7dd-14a44b60cd18" providerId="ADAL" clId="{4E01D738-D0C1-4B9B-B836-CF053EEC4C53}" dt="2022-03-16T10:08:21.535" v="944"/>
          <ac:grpSpMkLst>
            <pc:docMk/>
            <pc:sldMk cId="2336920806" sldId="303"/>
            <ac:grpSpMk id="84" creationId="{4E8D3CF0-7693-4B00-BDEF-80A0BB833325}"/>
          </ac:grpSpMkLst>
        </pc:grpChg>
        <pc:grpChg chg="add del mod">
          <ac:chgData name="Filippo Acconcia" userId="844af49c-a8a0-47ac-a7dd-14a44b60cd18" providerId="ADAL" clId="{4E01D738-D0C1-4B9B-B836-CF053EEC4C53}" dt="2022-03-16T10:59:24.028" v="1554" actId="478"/>
          <ac:grpSpMkLst>
            <pc:docMk/>
            <pc:sldMk cId="2336920806" sldId="303"/>
            <ac:grpSpMk id="89" creationId="{3DF3A651-D6E2-4FB2-AD4E-802159094842}"/>
          </ac:grpSpMkLst>
        </pc:grpChg>
        <pc:grpChg chg="mod">
          <ac:chgData name="Filippo Acconcia" userId="844af49c-a8a0-47ac-a7dd-14a44b60cd18" providerId="ADAL" clId="{4E01D738-D0C1-4B9B-B836-CF053EEC4C53}" dt="2022-03-16T10:08:33.114" v="946"/>
          <ac:grpSpMkLst>
            <pc:docMk/>
            <pc:sldMk cId="2336920806" sldId="303"/>
            <ac:grpSpMk id="90" creationId="{3FAF37D6-3574-4949-B0D7-5F850F60D973}"/>
          </ac:grpSpMkLst>
        </pc:grpChg>
        <pc:grpChg chg="mod">
          <ac:chgData name="Filippo Acconcia" userId="844af49c-a8a0-47ac-a7dd-14a44b60cd18" providerId="ADAL" clId="{4E01D738-D0C1-4B9B-B836-CF053EEC4C53}" dt="2022-03-16T10:08:33.114" v="946"/>
          <ac:grpSpMkLst>
            <pc:docMk/>
            <pc:sldMk cId="2336920806" sldId="303"/>
            <ac:grpSpMk id="91" creationId="{96C081E6-534B-4BF7-AAF6-DB4E913DBD5F}"/>
          </ac:grpSpMkLst>
        </pc:grpChg>
        <pc:grpChg chg="add del mod">
          <ac:chgData name="Filippo Acconcia" userId="844af49c-a8a0-47ac-a7dd-14a44b60cd18" providerId="ADAL" clId="{4E01D738-D0C1-4B9B-B836-CF053EEC4C53}" dt="2022-03-16T10:55:53.058" v="1416" actId="165"/>
          <ac:grpSpMkLst>
            <pc:docMk/>
            <pc:sldMk cId="2336920806" sldId="303"/>
            <ac:grpSpMk id="108" creationId="{6636F370-AEE0-473E-BB36-B064A63B917D}"/>
          </ac:grpSpMkLst>
        </pc:grpChg>
        <pc:grpChg chg="del mod topLvl">
          <ac:chgData name="Filippo Acconcia" userId="844af49c-a8a0-47ac-a7dd-14a44b60cd18" providerId="ADAL" clId="{4E01D738-D0C1-4B9B-B836-CF053EEC4C53}" dt="2022-03-16T10:55:56.062" v="1417" actId="165"/>
          <ac:grpSpMkLst>
            <pc:docMk/>
            <pc:sldMk cId="2336920806" sldId="303"/>
            <ac:grpSpMk id="109" creationId="{A02DBDCD-80F2-46C7-9B7E-59ACCBA4640D}"/>
          </ac:grpSpMkLst>
        </pc:grpChg>
        <pc:grpChg chg="del mod topLvl">
          <ac:chgData name="Filippo Acconcia" userId="844af49c-a8a0-47ac-a7dd-14a44b60cd18" providerId="ADAL" clId="{4E01D738-D0C1-4B9B-B836-CF053EEC4C53}" dt="2022-03-16T10:55:56.062" v="1417" actId="165"/>
          <ac:grpSpMkLst>
            <pc:docMk/>
            <pc:sldMk cId="2336920806" sldId="303"/>
            <ac:grpSpMk id="110" creationId="{39963E3A-C1BD-4B24-902D-F6A3AD51DB0C}"/>
          </ac:grpSpMkLst>
        </pc:grpChg>
        <pc:grpChg chg="add del mod">
          <ac:chgData name="Filippo Acconcia" userId="844af49c-a8a0-47ac-a7dd-14a44b60cd18" providerId="ADAL" clId="{4E01D738-D0C1-4B9B-B836-CF053EEC4C53}" dt="2022-03-16T10:10:29.648" v="951" actId="165"/>
          <ac:grpSpMkLst>
            <pc:docMk/>
            <pc:sldMk cId="2336920806" sldId="303"/>
            <ac:grpSpMk id="128" creationId="{47D654E7-1DE3-43A0-9445-EE7C3ED7C543}"/>
          </ac:grpSpMkLst>
        </pc:grpChg>
        <pc:grpChg chg="del mod topLvl">
          <ac:chgData name="Filippo Acconcia" userId="844af49c-a8a0-47ac-a7dd-14a44b60cd18" providerId="ADAL" clId="{4E01D738-D0C1-4B9B-B836-CF053EEC4C53}" dt="2022-03-16T10:19:13.468" v="1182" actId="478"/>
          <ac:grpSpMkLst>
            <pc:docMk/>
            <pc:sldMk cId="2336920806" sldId="303"/>
            <ac:grpSpMk id="131" creationId="{E6BCC282-4325-4632-A2A3-DC3BBDEE5217}"/>
          </ac:grpSpMkLst>
        </pc:grpChg>
        <pc:grpChg chg="mod">
          <ac:chgData name="Filippo Acconcia" userId="844af49c-a8a0-47ac-a7dd-14a44b60cd18" providerId="ADAL" clId="{4E01D738-D0C1-4B9B-B836-CF053EEC4C53}" dt="2022-03-16T10:10:29.648" v="951" actId="165"/>
          <ac:grpSpMkLst>
            <pc:docMk/>
            <pc:sldMk cId="2336920806" sldId="303"/>
            <ac:grpSpMk id="135" creationId="{7E77B1F9-CEFA-425E-BF23-FEA76EB3F96E}"/>
          </ac:grpSpMkLst>
        </pc:grpChg>
        <pc:grpChg chg="mod">
          <ac:chgData name="Filippo Acconcia" userId="844af49c-a8a0-47ac-a7dd-14a44b60cd18" providerId="ADAL" clId="{4E01D738-D0C1-4B9B-B836-CF053EEC4C53}" dt="2022-03-16T10:10:29.648" v="951" actId="165"/>
          <ac:grpSpMkLst>
            <pc:docMk/>
            <pc:sldMk cId="2336920806" sldId="303"/>
            <ac:grpSpMk id="141" creationId="{DA5E31EE-6BF9-4E6C-BAE9-2861E147FB19}"/>
          </ac:grpSpMkLst>
        </pc:grpChg>
        <pc:grpChg chg="mod">
          <ac:chgData name="Filippo Acconcia" userId="844af49c-a8a0-47ac-a7dd-14a44b60cd18" providerId="ADAL" clId="{4E01D738-D0C1-4B9B-B836-CF053EEC4C53}" dt="2022-03-16T10:10:29.648" v="951" actId="165"/>
          <ac:grpSpMkLst>
            <pc:docMk/>
            <pc:sldMk cId="2336920806" sldId="303"/>
            <ac:grpSpMk id="142" creationId="{B6C7393A-15BA-432B-8ABA-12E8224329D6}"/>
          </ac:grpSpMkLst>
        </pc:grpChg>
        <pc:grpChg chg="mod">
          <ac:chgData name="Filippo Acconcia" userId="844af49c-a8a0-47ac-a7dd-14a44b60cd18" providerId="ADAL" clId="{4E01D738-D0C1-4B9B-B836-CF053EEC4C53}" dt="2022-03-16T10:10:29.648" v="951" actId="165"/>
          <ac:grpSpMkLst>
            <pc:docMk/>
            <pc:sldMk cId="2336920806" sldId="303"/>
            <ac:grpSpMk id="143" creationId="{D7B24362-D99A-47FA-847E-9E48DB8DA681}"/>
          </ac:grpSpMkLst>
        </pc:grpChg>
        <pc:grpChg chg="add del mod">
          <ac:chgData name="Filippo Acconcia" userId="844af49c-a8a0-47ac-a7dd-14a44b60cd18" providerId="ADAL" clId="{4E01D738-D0C1-4B9B-B836-CF053EEC4C53}" dt="2022-03-16T10:13:57.173" v="1065" actId="478"/>
          <ac:grpSpMkLst>
            <pc:docMk/>
            <pc:sldMk cId="2336920806" sldId="303"/>
            <ac:grpSpMk id="174" creationId="{167D71D5-66F9-4932-8DD9-28C96440C6E6}"/>
          </ac:grpSpMkLst>
        </pc:grpChg>
        <pc:grpChg chg="add mod">
          <ac:chgData name="Filippo Acconcia" userId="844af49c-a8a0-47ac-a7dd-14a44b60cd18" providerId="ADAL" clId="{4E01D738-D0C1-4B9B-B836-CF053EEC4C53}" dt="2022-03-16T10:17:10.919" v="1161" actId="164"/>
          <ac:grpSpMkLst>
            <pc:docMk/>
            <pc:sldMk cId="2336920806" sldId="303"/>
            <ac:grpSpMk id="175" creationId="{E25CE2AA-2A14-4B1A-87FF-A4960BDC3A4C}"/>
          </ac:grpSpMkLst>
        </pc:grpChg>
        <pc:grpChg chg="add mod">
          <ac:chgData name="Filippo Acconcia" userId="844af49c-a8a0-47ac-a7dd-14a44b60cd18" providerId="ADAL" clId="{4E01D738-D0C1-4B9B-B836-CF053EEC4C53}" dt="2022-03-16T10:17:10.919" v="1161" actId="164"/>
          <ac:grpSpMkLst>
            <pc:docMk/>
            <pc:sldMk cId="2336920806" sldId="303"/>
            <ac:grpSpMk id="176" creationId="{F5936C58-B1BD-4AD8-A4C9-7BB00596DFF9}"/>
          </ac:grpSpMkLst>
        </pc:grpChg>
        <pc:grpChg chg="add mod">
          <ac:chgData name="Filippo Acconcia" userId="844af49c-a8a0-47ac-a7dd-14a44b60cd18" providerId="ADAL" clId="{4E01D738-D0C1-4B9B-B836-CF053EEC4C53}" dt="2022-03-16T10:17:10.919" v="1161" actId="164"/>
          <ac:grpSpMkLst>
            <pc:docMk/>
            <pc:sldMk cId="2336920806" sldId="303"/>
            <ac:grpSpMk id="181" creationId="{A2CD5478-C9F0-4BCA-A88B-D1D4D165117F}"/>
          </ac:grpSpMkLst>
        </pc:grpChg>
        <pc:grpChg chg="add mod">
          <ac:chgData name="Filippo Acconcia" userId="844af49c-a8a0-47ac-a7dd-14a44b60cd18" providerId="ADAL" clId="{4E01D738-D0C1-4B9B-B836-CF053EEC4C53}" dt="2022-03-16T10:17:10.919" v="1161" actId="164"/>
          <ac:grpSpMkLst>
            <pc:docMk/>
            <pc:sldMk cId="2336920806" sldId="303"/>
            <ac:grpSpMk id="186" creationId="{A939C31C-7A3F-4D08-AC98-7A612D0CBB24}"/>
          </ac:grpSpMkLst>
        </pc:grpChg>
        <pc:grpChg chg="add mod">
          <ac:chgData name="Filippo Acconcia" userId="844af49c-a8a0-47ac-a7dd-14a44b60cd18" providerId="ADAL" clId="{4E01D738-D0C1-4B9B-B836-CF053EEC4C53}" dt="2022-03-16T10:17:10.919" v="1161" actId="164"/>
          <ac:grpSpMkLst>
            <pc:docMk/>
            <pc:sldMk cId="2336920806" sldId="303"/>
            <ac:grpSpMk id="191" creationId="{7D8D11F8-9D91-4BAA-8BF1-4A3E05C0EAFF}"/>
          </ac:grpSpMkLst>
        </pc:grpChg>
        <pc:grpChg chg="add mod">
          <ac:chgData name="Filippo Acconcia" userId="844af49c-a8a0-47ac-a7dd-14a44b60cd18" providerId="ADAL" clId="{4E01D738-D0C1-4B9B-B836-CF053EEC4C53}" dt="2022-03-16T11:01:23.557" v="1588" actId="1038"/>
          <ac:grpSpMkLst>
            <pc:docMk/>
            <pc:sldMk cId="2336920806" sldId="303"/>
            <ac:grpSpMk id="201" creationId="{995619E0-F3E4-4A7D-98CB-BFA03F78540C}"/>
          </ac:grpSpMkLst>
        </pc:grpChg>
        <pc:grpChg chg="add del mod">
          <ac:chgData name="Filippo Acconcia" userId="844af49c-a8a0-47ac-a7dd-14a44b60cd18" providerId="ADAL" clId="{4E01D738-D0C1-4B9B-B836-CF053EEC4C53}" dt="2022-03-16T10:17:34.675" v="1171" actId="165"/>
          <ac:grpSpMkLst>
            <pc:docMk/>
            <pc:sldMk cId="2336920806" sldId="303"/>
            <ac:grpSpMk id="202" creationId="{AB6BE194-EB37-4F77-A63D-F27F1F18CE56}"/>
          </ac:grpSpMkLst>
        </pc:grpChg>
        <pc:grpChg chg="mod topLvl">
          <ac:chgData name="Filippo Acconcia" userId="844af49c-a8a0-47ac-a7dd-14a44b60cd18" providerId="ADAL" clId="{4E01D738-D0C1-4B9B-B836-CF053EEC4C53}" dt="2022-03-16T10:18:59.718" v="1179" actId="164"/>
          <ac:grpSpMkLst>
            <pc:docMk/>
            <pc:sldMk cId="2336920806" sldId="303"/>
            <ac:grpSpMk id="206" creationId="{B0C521EA-E3AE-4D71-82D9-79E18DAD2921}"/>
          </ac:grpSpMkLst>
        </pc:grpChg>
        <pc:grpChg chg="mod topLvl">
          <ac:chgData name="Filippo Acconcia" userId="844af49c-a8a0-47ac-a7dd-14a44b60cd18" providerId="ADAL" clId="{4E01D738-D0C1-4B9B-B836-CF053EEC4C53}" dt="2022-03-16T10:18:59.718" v="1179" actId="164"/>
          <ac:grpSpMkLst>
            <pc:docMk/>
            <pc:sldMk cId="2336920806" sldId="303"/>
            <ac:grpSpMk id="210" creationId="{682CEAC0-FB40-4982-B592-C7608E49F3CF}"/>
          </ac:grpSpMkLst>
        </pc:grpChg>
        <pc:grpChg chg="mod topLvl">
          <ac:chgData name="Filippo Acconcia" userId="844af49c-a8a0-47ac-a7dd-14a44b60cd18" providerId="ADAL" clId="{4E01D738-D0C1-4B9B-B836-CF053EEC4C53}" dt="2022-03-16T10:18:59.718" v="1179" actId="164"/>
          <ac:grpSpMkLst>
            <pc:docMk/>
            <pc:sldMk cId="2336920806" sldId="303"/>
            <ac:grpSpMk id="213" creationId="{0D9BCF0A-7766-473C-BB3B-9784C3AF6049}"/>
          </ac:grpSpMkLst>
        </pc:grpChg>
        <pc:grpChg chg="mod topLvl">
          <ac:chgData name="Filippo Acconcia" userId="844af49c-a8a0-47ac-a7dd-14a44b60cd18" providerId="ADAL" clId="{4E01D738-D0C1-4B9B-B836-CF053EEC4C53}" dt="2022-03-16T10:18:59.718" v="1179" actId="164"/>
          <ac:grpSpMkLst>
            <pc:docMk/>
            <pc:sldMk cId="2336920806" sldId="303"/>
            <ac:grpSpMk id="214" creationId="{C2B2AF62-BD0E-4D83-BA63-12E959CC181E}"/>
          </ac:grpSpMkLst>
        </pc:grpChg>
        <pc:grpChg chg="mod topLvl">
          <ac:chgData name="Filippo Acconcia" userId="844af49c-a8a0-47ac-a7dd-14a44b60cd18" providerId="ADAL" clId="{4E01D738-D0C1-4B9B-B836-CF053EEC4C53}" dt="2022-03-16T10:18:59.718" v="1179" actId="164"/>
          <ac:grpSpMkLst>
            <pc:docMk/>
            <pc:sldMk cId="2336920806" sldId="303"/>
            <ac:grpSpMk id="215" creationId="{3B5347A3-3895-4053-9A97-1AF4C63337E2}"/>
          </ac:grpSpMkLst>
        </pc:grpChg>
        <pc:grpChg chg="add mod">
          <ac:chgData name="Filippo Acconcia" userId="844af49c-a8a0-47ac-a7dd-14a44b60cd18" providerId="ADAL" clId="{4E01D738-D0C1-4B9B-B836-CF053EEC4C53}" dt="2022-03-16T11:01:29.835" v="1592" actId="1038"/>
          <ac:grpSpMkLst>
            <pc:docMk/>
            <pc:sldMk cId="2336920806" sldId="303"/>
            <ac:grpSpMk id="245" creationId="{422723CA-9B12-46F4-8AE4-DA5A6898E9CF}"/>
          </ac:grpSpMkLst>
        </pc:grpChg>
        <pc:grpChg chg="add del mod">
          <ac:chgData name="Filippo Acconcia" userId="844af49c-a8a0-47ac-a7dd-14a44b60cd18" providerId="ADAL" clId="{4E01D738-D0C1-4B9B-B836-CF053EEC4C53}" dt="2022-03-16T10:44:36.200" v="1187" actId="478"/>
          <ac:grpSpMkLst>
            <pc:docMk/>
            <pc:sldMk cId="2336920806" sldId="303"/>
            <ac:grpSpMk id="246" creationId="{A8CA8DAD-875F-4CA2-9419-846B79A01067}"/>
          </ac:grpSpMkLst>
        </pc:grpChg>
        <pc:grpChg chg="mod">
          <ac:chgData name="Filippo Acconcia" userId="844af49c-a8a0-47ac-a7dd-14a44b60cd18" providerId="ADAL" clId="{4E01D738-D0C1-4B9B-B836-CF053EEC4C53}" dt="2022-03-16T10:19:30.265" v="1183"/>
          <ac:grpSpMkLst>
            <pc:docMk/>
            <pc:sldMk cId="2336920806" sldId="303"/>
            <ac:grpSpMk id="284" creationId="{8891B480-4116-4DB0-90FA-ECB861B8B15C}"/>
          </ac:grpSpMkLst>
        </pc:grpChg>
        <pc:grpChg chg="add del mod">
          <ac:chgData name="Filippo Acconcia" userId="844af49c-a8a0-47ac-a7dd-14a44b60cd18" providerId="ADAL" clId="{4E01D738-D0C1-4B9B-B836-CF053EEC4C53}" dt="2022-03-16T10:53:00.586" v="1326" actId="478"/>
          <ac:grpSpMkLst>
            <pc:docMk/>
            <pc:sldMk cId="2336920806" sldId="303"/>
            <ac:grpSpMk id="289" creationId="{2D0C3154-E3D1-4DFE-8CD6-0B0759A830FB}"/>
          </ac:grpSpMkLst>
        </pc:grpChg>
        <pc:grpChg chg="mod">
          <ac:chgData name="Filippo Acconcia" userId="844af49c-a8a0-47ac-a7dd-14a44b60cd18" providerId="ADAL" clId="{4E01D738-D0C1-4B9B-B836-CF053EEC4C53}" dt="2022-03-16T10:44:41.752" v="1189"/>
          <ac:grpSpMkLst>
            <pc:docMk/>
            <pc:sldMk cId="2336920806" sldId="303"/>
            <ac:grpSpMk id="326" creationId="{96148D1E-0EDB-485B-9759-A5572F317A57}"/>
          </ac:grpSpMkLst>
        </pc:grpChg>
        <pc:grpChg chg="add del mod">
          <ac:chgData name="Filippo Acconcia" userId="844af49c-a8a0-47ac-a7dd-14a44b60cd18" providerId="ADAL" clId="{4E01D738-D0C1-4B9B-B836-CF053EEC4C53}" dt="2022-03-16T10:52:59.647" v="1325" actId="478"/>
          <ac:grpSpMkLst>
            <pc:docMk/>
            <pc:sldMk cId="2336920806" sldId="303"/>
            <ac:grpSpMk id="331" creationId="{348B444C-77FE-4BB8-8388-9B26A00D2A75}"/>
          </ac:grpSpMkLst>
        </pc:grpChg>
        <pc:grpChg chg="mod">
          <ac:chgData name="Filippo Acconcia" userId="844af49c-a8a0-47ac-a7dd-14a44b60cd18" providerId="ADAL" clId="{4E01D738-D0C1-4B9B-B836-CF053EEC4C53}" dt="2022-03-16T10:44:41.752" v="1189"/>
          <ac:grpSpMkLst>
            <pc:docMk/>
            <pc:sldMk cId="2336920806" sldId="303"/>
            <ac:grpSpMk id="369" creationId="{64E361D3-382B-4581-9B02-4DA62E8458D7}"/>
          </ac:grpSpMkLst>
        </pc:grpChg>
        <pc:grpChg chg="add del mod">
          <ac:chgData name="Filippo Acconcia" userId="844af49c-a8a0-47ac-a7dd-14a44b60cd18" providerId="ADAL" clId="{4E01D738-D0C1-4B9B-B836-CF053EEC4C53}" dt="2022-03-16T10:45:51.859" v="1198" actId="165"/>
          <ac:grpSpMkLst>
            <pc:docMk/>
            <pc:sldMk cId="2336920806" sldId="303"/>
            <ac:grpSpMk id="374" creationId="{C48000B3-9EFC-470D-B121-B8D30CEA1CD8}"/>
          </ac:grpSpMkLst>
        </pc:grpChg>
        <pc:grpChg chg="mod topLvl">
          <ac:chgData name="Filippo Acconcia" userId="844af49c-a8a0-47ac-a7dd-14a44b60cd18" providerId="ADAL" clId="{4E01D738-D0C1-4B9B-B836-CF053EEC4C53}" dt="2022-03-16T10:48:48.519" v="1246" actId="164"/>
          <ac:grpSpMkLst>
            <pc:docMk/>
            <pc:sldMk cId="2336920806" sldId="303"/>
            <ac:grpSpMk id="378" creationId="{7AFABCD1-A323-4EC3-8817-FA0E6EAE4132}"/>
          </ac:grpSpMkLst>
        </pc:grpChg>
        <pc:grpChg chg="mod topLvl">
          <ac:chgData name="Filippo Acconcia" userId="844af49c-a8a0-47ac-a7dd-14a44b60cd18" providerId="ADAL" clId="{4E01D738-D0C1-4B9B-B836-CF053EEC4C53}" dt="2022-03-16T10:48:48.519" v="1246" actId="164"/>
          <ac:grpSpMkLst>
            <pc:docMk/>
            <pc:sldMk cId="2336920806" sldId="303"/>
            <ac:grpSpMk id="382" creationId="{1C41919A-AD25-4F43-9B9E-C3777CCD260A}"/>
          </ac:grpSpMkLst>
        </pc:grpChg>
        <pc:grpChg chg="mod topLvl">
          <ac:chgData name="Filippo Acconcia" userId="844af49c-a8a0-47ac-a7dd-14a44b60cd18" providerId="ADAL" clId="{4E01D738-D0C1-4B9B-B836-CF053EEC4C53}" dt="2022-03-16T10:48:48.519" v="1246" actId="164"/>
          <ac:grpSpMkLst>
            <pc:docMk/>
            <pc:sldMk cId="2336920806" sldId="303"/>
            <ac:grpSpMk id="385" creationId="{7BD2FABF-A86E-4C26-87C8-2038B8FB49CB}"/>
          </ac:grpSpMkLst>
        </pc:grpChg>
        <pc:grpChg chg="mod topLvl">
          <ac:chgData name="Filippo Acconcia" userId="844af49c-a8a0-47ac-a7dd-14a44b60cd18" providerId="ADAL" clId="{4E01D738-D0C1-4B9B-B836-CF053EEC4C53}" dt="2022-03-16T10:48:48.519" v="1246" actId="164"/>
          <ac:grpSpMkLst>
            <pc:docMk/>
            <pc:sldMk cId="2336920806" sldId="303"/>
            <ac:grpSpMk id="386" creationId="{69C4BF2C-4743-45F0-95B6-C03A9AFDD4EB}"/>
          </ac:grpSpMkLst>
        </pc:grpChg>
        <pc:grpChg chg="mod topLvl">
          <ac:chgData name="Filippo Acconcia" userId="844af49c-a8a0-47ac-a7dd-14a44b60cd18" providerId="ADAL" clId="{4E01D738-D0C1-4B9B-B836-CF053EEC4C53}" dt="2022-03-16T10:48:48.519" v="1246" actId="164"/>
          <ac:grpSpMkLst>
            <pc:docMk/>
            <pc:sldMk cId="2336920806" sldId="303"/>
            <ac:grpSpMk id="387" creationId="{6DB79177-2D20-4070-A44E-59CA63588AB1}"/>
          </ac:grpSpMkLst>
        </pc:grpChg>
        <pc:grpChg chg="add del mod">
          <ac:chgData name="Filippo Acconcia" userId="844af49c-a8a0-47ac-a7dd-14a44b60cd18" providerId="ADAL" clId="{4E01D738-D0C1-4B9B-B836-CF053EEC4C53}" dt="2022-03-16T10:47:56.412" v="1227" actId="165"/>
          <ac:grpSpMkLst>
            <pc:docMk/>
            <pc:sldMk cId="2336920806" sldId="303"/>
            <ac:grpSpMk id="416" creationId="{EF68457A-B57F-4731-BBFD-FAD4F30ECA49}"/>
          </ac:grpSpMkLst>
        </pc:grpChg>
        <pc:grpChg chg="mod topLvl">
          <ac:chgData name="Filippo Acconcia" userId="844af49c-a8a0-47ac-a7dd-14a44b60cd18" providerId="ADAL" clId="{4E01D738-D0C1-4B9B-B836-CF053EEC4C53}" dt="2022-03-16T10:48:44.497" v="1245" actId="164"/>
          <ac:grpSpMkLst>
            <pc:docMk/>
            <pc:sldMk cId="2336920806" sldId="303"/>
            <ac:grpSpMk id="420" creationId="{6367D3C3-6493-4C3C-A4DE-22091D5EA330}"/>
          </ac:grpSpMkLst>
        </pc:grpChg>
        <pc:grpChg chg="mod topLvl">
          <ac:chgData name="Filippo Acconcia" userId="844af49c-a8a0-47ac-a7dd-14a44b60cd18" providerId="ADAL" clId="{4E01D738-D0C1-4B9B-B836-CF053EEC4C53}" dt="2022-03-16T10:48:44.497" v="1245" actId="164"/>
          <ac:grpSpMkLst>
            <pc:docMk/>
            <pc:sldMk cId="2336920806" sldId="303"/>
            <ac:grpSpMk id="424" creationId="{A01E6003-EF7A-49E9-8224-C16A6D58C197}"/>
          </ac:grpSpMkLst>
        </pc:grpChg>
        <pc:grpChg chg="mod topLvl">
          <ac:chgData name="Filippo Acconcia" userId="844af49c-a8a0-47ac-a7dd-14a44b60cd18" providerId="ADAL" clId="{4E01D738-D0C1-4B9B-B836-CF053EEC4C53}" dt="2022-03-16T10:48:44.497" v="1245" actId="164"/>
          <ac:grpSpMkLst>
            <pc:docMk/>
            <pc:sldMk cId="2336920806" sldId="303"/>
            <ac:grpSpMk id="427" creationId="{900B9610-FF80-4CC8-ADAE-8BAA21072E37}"/>
          </ac:grpSpMkLst>
        </pc:grpChg>
        <pc:grpChg chg="mod topLvl">
          <ac:chgData name="Filippo Acconcia" userId="844af49c-a8a0-47ac-a7dd-14a44b60cd18" providerId="ADAL" clId="{4E01D738-D0C1-4B9B-B836-CF053EEC4C53}" dt="2022-03-16T10:48:44.497" v="1245" actId="164"/>
          <ac:grpSpMkLst>
            <pc:docMk/>
            <pc:sldMk cId="2336920806" sldId="303"/>
            <ac:grpSpMk id="428" creationId="{380DE152-CA35-499F-A824-05425B6BA156}"/>
          </ac:grpSpMkLst>
        </pc:grpChg>
        <pc:grpChg chg="mod topLvl">
          <ac:chgData name="Filippo Acconcia" userId="844af49c-a8a0-47ac-a7dd-14a44b60cd18" providerId="ADAL" clId="{4E01D738-D0C1-4B9B-B836-CF053EEC4C53}" dt="2022-03-16T10:48:44.497" v="1245" actId="164"/>
          <ac:grpSpMkLst>
            <pc:docMk/>
            <pc:sldMk cId="2336920806" sldId="303"/>
            <ac:grpSpMk id="429" creationId="{DE6A3C93-28A1-4AFB-9A13-2230821C3A60}"/>
          </ac:grpSpMkLst>
        </pc:grpChg>
        <pc:grpChg chg="add mod">
          <ac:chgData name="Filippo Acconcia" userId="844af49c-a8a0-47ac-a7dd-14a44b60cd18" providerId="ADAL" clId="{4E01D738-D0C1-4B9B-B836-CF053EEC4C53}" dt="2022-03-16T11:01:29.835" v="1592" actId="1038"/>
          <ac:grpSpMkLst>
            <pc:docMk/>
            <pc:sldMk cId="2336920806" sldId="303"/>
            <ac:grpSpMk id="460" creationId="{57E43942-19F4-4E34-AD4D-9B0CDDFF5BF2}"/>
          </ac:grpSpMkLst>
        </pc:grpChg>
        <pc:grpChg chg="add mod">
          <ac:chgData name="Filippo Acconcia" userId="844af49c-a8a0-47ac-a7dd-14a44b60cd18" providerId="ADAL" clId="{4E01D738-D0C1-4B9B-B836-CF053EEC4C53}" dt="2022-03-16T11:01:23.557" v="1588" actId="1038"/>
          <ac:grpSpMkLst>
            <pc:docMk/>
            <pc:sldMk cId="2336920806" sldId="303"/>
            <ac:grpSpMk id="461" creationId="{285F1E1E-DCB8-45D5-8AC3-A496EA28909A}"/>
          </ac:grpSpMkLst>
        </pc:grpChg>
        <pc:grpChg chg="add del mod">
          <ac:chgData name="Filippo Acconcia" userId="844af49c-a8a0-47ac-a7dd-14a44b60cd18" providerId="ADAL" clId="{4E01D738-D0C1-4B9B-B836-CF053EEC4C53}" dt="2022-03-16T10:51:11.698" v="1276" actId="165"/>
          <ac:grpSpMkLst>
            <pc:docMk/>
            <pc:sldMk cId="2336920806" sldId="303"/>
            <ac:grpSpMk id="462" creationId="{895C46BA-8CA7-48F6-A73B-1C600EA3C785}"/>
          </ac:grpSpMkLst>
        </pc:grpChg>
        <pc:grpChg chg="mod topLvl">
          <ac:chgData name="Filippo Acconcia" userId="844af49c-a8a0-47ac-a7dd-14a44b60cd18" providerId="ADAL" clId="{4E01D738-D0C1-4B9B-B836-CF053EEC4C53}" dt="2022-03-16T10:53:09.412" v="1328" actId="164"/>
          <ac:grpSpMkLst>
            <pc:docMk/>
            <pc:sldMk cId="2336920806" sldId="303"/>
            <ac:grpSpMk id="466" creationId="{D691206F-873D-488E-89E3-304300E3AF5D}"/>
          </ac:grpSpMkLst>
        </pc:grpChg>
        <pc:grpChg chg="mod topLvl">
          <ac:chgData name="Filippo Acconcia" userId="844af49c-a8a0-47ac-a7dd-14a44b60cd18" providerId="ADAL" clId="{4E01D738-D0C1-4B9B-B836-CF053EEC4C53}" dt="2022-03-16T10:53:09.412" v="1328" actId="164"/>
          <ac:grpSpMkLst>
            <pc:docMk/>
            <pc:sldMk cId="2336920806" sldId="303"/>
            <ac:grpSpMk id="470" creationId="{5D5FED1B-5D22-4454-8D2B-B936EE9F1081}"/>
          </ac:grpSpMkLst>
        </pc:grpChg>
        <pc:grpChg chg="mod topLvl">
          <ac:chgData name="Filippo Acconcia" userId="844af49c-a8a0-47ac-a7dd-14a44b60cd18" providerId="ADAL" clId="{4E01D738-D0C1-4B9B-B836-CF053EEC4C53}" dt="2022-03-16T10:53:09.412" v="1328" actId="164"/>
          <ac:grpSpMkLst>
            <pc:docMk/>
            <pc:sldMk cId="2336920806" sldId="303"/>
            <ac:grpSpMk id="473" creationId="{B34D5077-D515-4C72-896E-2DF723459649}"/>
          </ac:grpSpMkLst>
        </pc:grpChg>
        <pc:grpChg chg="mod topLvl">
          <ac:chgData name="Filippo Acconcia" userId="844af49c-a8a0-47ac-a7dd-14a44b60cd18" providerId="ADAL" clId="{4E01D738-D0C1-4B9B-B836-CF053EEC4C53}" dt="2022-03-16T10:53:09.412" v="1328" actId="164"/>
          <ac:grpSpMkLst>
            <pc:docMk/>
            <pc:sldMk cId="2336920806" sldId="303"/>
            <ac:grpSpMk id="474" creationId="{B3F1FE2A-25F3-4F7B-B392-B8575284E817}"/>
          </ac:grpSpMkLst>
        </pc:grpChg>
        <pc:grpChg chg="mod topLvl">
          <ac:chgData name="Filippo Acconcia" userId="844af49c-a8a0-47ac-a7dd-14a44b60cd18" providerId="ADAL" clId="{4E01D738-D0C1-4B9B-B836-CF053EEC4C53}" dt="2022-03-16T10:53:09.412" v="1328" actId="164"/>
          <ac:grpSpMkLst>
            <pc:docMk/>
            <pc:sldMk cId="2336920806" sldId="303"/>
            <ac:grpSpMk id="475" creationId="{1486E046-81CA-40CB-8E5F-A7D1F11AB59A}"/>
          </ac:grpSpMkLst>
        </pc:grpChg>
        <pc:grpChg chg="add del mod">
          <ac:chgData name="Filippo Acconcia" userId="844af49c-a8a0-47ac-a7dd-14a44b60cd18" providerId="ADAL" clId="{4E01D738-D0C1-4B9B-B836-CF053EEC4C53}" dt="2022-03-16T10:49:57.069" v="1261" actId="478"/>
          <ac:grpSpMkLst>
            <pc:docMk/>
            <pc:sldMk cId="2336920806" sldId="303"/>
            <ac:grpSpMk id="504" creationId="{2E858E2F-19D4-4C31-86D1-76B890A323C5}"/>
          </ac:grpSpMkLst>
        </pc:grpChg>
        <pc:grpChg chg="mod">
          <ac:chgData name="Filippo Acconcia" userId="844af49c-a8a0-47ac-a7dd-14a44b60cd18" providerId="ADAL" clId="{4E01D738-D0C1-4B9B-B836-CF053EEC4C53}" dt="2022-03-16T10:49:02.913" v="1247"/>
          <ac:grpSpMkLst>
            <pc:docMk/>
            <pc:sldMk cId="2336920806" sldId="303"/>
            <ac:grpSpMk id="508" creationId="{D9EBE4B5-8399-4F09-8993-09B073F05497}"/>
          </ac:grpSpMkLst>
        </pc:grpChg>
        <pc:grpChg chg="mod">
          <ac:chgData name="Filippo Acconcia" userId="844af49c-a8a0-47ac-a7dd-14a44b60cd18" providerId="ADAL" clId="{4E01D738-D0C1-4B9B-B836-CF053EEC4C53}" dt="2022-03-16T10:49:02.913" v="1247"/>
          <ac:grpSpMkLst>
            <pc:docMk/>
            <pc:sldMk cId="2336920806" sldId="303"/>
            <ac:grpSpMk id="512" creationId="{83C36D3B-255A-49D9-9628-9DCBF4C75ADA}"/>
          </ac:grpSpMkLst>
        </pc:grpChg>
        <pc:grpChg chg="mod">
          <ac:chgData name="Filippo Acconcia" userId="844af49c-a8a0-47ac-a7dd-14a44b60cd18" providerId="ADAL" clId="{4E01D738-D0C1-4B9B-B836-CF053EEC4C53}" dt="2022-03-16T10:49:02.913" v="1247"/>
          <ac:grpSpMkLst>
            <pc:docMk/>
            <pc:sldMk cId="2336920806" sldId="303"/>
            <ac:grpSpMk id="515" creationId="{9D0FF3B9-55C2-4687-A0F8-06D7807A0B77}"/>
          </ac:grpSpMkLst>
        </pc:grpChg>
        <pc:grpChg chg="mod">
          <ac:chgData name="Filippo Acconcia" userId="844af49c-a8a0-47ac-a7dd-14a44b60cd18" providerId="ADAL" clId="{4E01D738-D0C1-4B9B-B836-CF053EEC4C53}" dt="2022-03-16T10:49:02.913" v="1247"/>
          <ac:grpSpMkLst>
            <pc:docMk/>
            <pc:sldMk cId="2336920806" sldId="303"/>
            <ac:grpSpMk id="516" creationId="{8D44929E-1484-40AF-ACC2-03D7C1F5394A}"/>
          </ac:grpSpMkLst>
        </pc:grpChg>
        <pc:grpChg chg="mod">
          <ac:chgData name="Filippo Acconcia" userId="844af49c-a8a0-47ac-a7dd-14a44b60cd18" providerId="ADAL" clId="{4E01D738-D0C1-4B9B-B836-CF053EEC4C53}" dt="2022-03-16T10:49:02.913" v="1247"/>
          <ac:grpSpMkLst>
            <pc:docMk/>
            <pc:sldMk cId="2336920806" sldId="303"/>
            <ac:grpSpMk id="517" creationId="{24080265-7EF0-492F-8A25-AA69F8D5CDDB}"/>
          </ac:grpSpMkLst>
        </pc:grpChg>
        <pc:grpChg chg="add del mod">
          <ac:chgData name="Filippo Acconcia" userId="844af49c-a8a0-47ac-a7dd-14a44b60cd18" providerId="ADAL" clId="{4E01D738-D0C1-4B9B-B836-CF053EEC4C53}" dt="2022-03-16T10:52:00.737" v="1311" actId="478"/>
          <ac:grpSpMkLst>
            <pc:docMk/>
            <pc:sldMk cId="2336920806" sldId="303"/>
            <ac:grpSpMk id="546" creationId="{3437C3CA-C66D-4CF3-843A-D9D80DFEF85D}"/>
          </ac:grpSpMkLst>
        </pc:grpChg>
        <pc:grpChg chg="mod">
          <ac:chgData name="Filippo Acconcia" userId="844af49c-a8a0-47ac-a7dd-14a44b60cd18" providerId="ADAL" clId="{4E01D738-D0C1-4B9B-B836-CF053EEC4C53}" dt="2022-03-16T10:49:59.150" v="1262"/>
          <ac:grpSpMkLst>
            <pc:docMk/>
            <pc:sldMk cId="2336920806" sldId="303"/>
            <ac:grpSpMk id="550" creationId="{67EF3338-BC3D-4C06-988B-E7072A66EC87}"/>
          </ac:grpSpMkLst>
        </pc:grpChg>
        <pc:grpChg chg="mod">
          <ac:chgData name="Filippo Acconcia" userId="844af49c-a8a0-47ac-a7dd-14a44b60cd18" providerId="ADAL" clId="{4E01D738-D0C1-4B9B-B836-CF053EEC4C53}" dt="2022-03-16T10:49:59.150" v="1262"/>
          <ac:grpSpMkLst>
            <pc:docMk/>
            <pc:sldMk cId="2336920806" sldId="303"/>
            <ac:grpSpMk id="554" creationId="{C6FB23BA-1FA5-4B2E-8910-CD939E18F9FB}"/>
          </ac:grpSpMkLst>
        </pc:grpChg>
        <pc:grpChg chg="mod">
          <ac:chgData name="Filippo Acconcia" userId="844af49c-a8a0-47ac-a7dd-14a44b60cd18" providerId="ADAL" clId="{4E01D738-D0C1-4B9B-B836-CF053EEC4C53}" dt="2022-03-16T10:49:59.150" v="1262"/>
          <ac:grpSpMkLst>
            <pc:docMk/>
            <pc:sldMk cId="2336920806" sldId="303"/>
            <ac:grpSpMk id="557" creationId="{3C67B41F-18EF-4B6D-B263-03C929180FB3}"/>
          </ac:grpSpMkLst>
        </pc:grpChg>
        <pc:grpChg chg="mod">
          <ac:chgData name="Filippo Acconcia" userId="844af49c-a8a0-47ac-a7dd-14a44b60cd18" providerId="ADAL" clId="{4E01D738-D0C1-4B9B-B836-CF053EEC4C53}" dt="2022-03-16T10:49:59.150" v="1262"/>
          <ac:grpSpMkLst>
            <pc:docMk/>
            <pc:sldMk cId="2336920806" sldId="303"/>
            <ac:grpSpMk id="558" creationId="{A11BD66F-3DBB-4C3E-8618-47A986883F26}"/>
          </ac:grpSpMkLst>
        </pc:grpChg>
        <pc:grpChg chg="mod">
          <ac:chgData name="Filippo Acconcia" userId="844af49c-a8a0-47ac-a7dd-14a44b60cd18" providerId="ADAL" clId="{4E01D738-D0C1-4B9B-B836-CF053EEC4C53}" dt="2022-03-16T10:49:59.150" v="1262"/>
          <ac:grpSpMkLst>
            <pc:docMk/>
            <pc:sldMk cId="2336920806" sldId="303"/>
            <ac:grpSpMk id="559" creationId="{FBC9B04B-FDFE-4E66-A80A-21DFD0C27B7A}"/>
          </ac:grpSpMkLst>
        </pc:grpChg>
        <pc:grpChg chg="add mod">
          <ac:chgData name="Filippo Acconcia" userId="844af49c-a8a0-47ac-a7dd-14a44b60cd18" providerId="ADAL" clId="{4E01D738-D0C1-4B9B-B836-CF053EEC4C53}" dt="2022-03-16T10:53:05.724" v="1327" actId="164"/>
          <ac:grpSpMkLst>
            <pc:docMk/>
            <pc:sldMk cId="2336920806" sldId="303"/>
            <ac:grpSpMk id="592" creationId="{FCA95FBE-A4DC-4E10-A4D9-9D251141BEC3}"/>
          </ac:grpSpMkLst>
        </pc:grpChg>
        <pc:grpChg chg="add mod">
          <ac:chgData name="Filippo Acconcia" userId="844af49c-a8a0-47ac-a7dd-14a44b60cd18" providerId="ADAL" clId="{4E01D738-D0C1-4B9B-B836-CF053EEC4C53}" dt="2022-03-16T10:53:05.724" v="1327" actId="164"/>
          <ac:grpSpMkLst>
            <pc:docMk/>
            <pc:sldMk cId="2336920806" sldId="303"/>
            <ac:grpSpMk id="600" creationId="{23754F77-A586-41DC-B4CA-142EA3626DF8}"/>
          </ac:grpSpMkLst>
        </pc:grpChg>
        <pc:grpChg chg="add mod">
          <ac:chgData name="Filippo Acconcia" userId="844af49c-a8a0-47ac-a7dd-14a44b60cd18" providerId="ADAL" clId="{4E01D738-D0C1-4B9B-B836-CF053EEC4C53}" dt="2022-03-16T10:53:05.724" v="1327" actId="164"/>
          <ac:grpSpMkLst>
            <pc:docMk/>
            <pc:sldMk cId="2336920806" sldId="303"/>
            <ac:grpSpMk id="607" creationId="{66522A90-C438-4C22-944F-343CC3886527}"/>
          </ac:grpSpMkLst>
        </pc:grpChg>
        <pc:grpChg chg="add mod">
          <ac:chgData name="Filippo Acconcia" userId="844af49c-a8a0-47ac-a7dd-14a44b60cd18" providerId="ADAL" clId="{4E01D738-D0C1-4B9B-B836-CF053EEC4C53}" dt="2022-03-16T10:53:05.724" v="1327" actId="164"/>
          <ac:grpSpMkLst>
            <pc:docMk/>
            <pc:sldMk cId="2336920806" sldId="303"/>
            <ac:grpSpMk id="612" creationId="{9D28C0CB-2A29-48CA-AE07-8A2341187B6F}"/>
          </ac:grpSpMkLst>
        </pc:grpChg>
        <pc:grpChg chg="add mod">
          <ac:chgData name="Filippo Acconcia" userId="844af49c-a8a0-47ac-a7dd-14a44b60cd18" providerId="ADAL" clId="{4E01D738-D0C1-4B9B-B836-CF053EEC4C53}" dt="2022-03-16T10:53:05.724" v="1327" actId="164"/>
          <ac:grpSpMkLst>
            <pc:docMk/>
            <pc:sldMk cId="2336920806" sldId="303"/>
            <ac:grpSpMk id="617" creationId="{A69E6815-F866-4D29-B785-E3BA09942193}"/>
          </ac:grpSpMkLst>
        </pc:grpChg>
        <pc:grpChg chg="add mod">
          <ac:chgData name="Filippo Acconcia" userId="844af49c-a8a0-47ac-a7dd-14a44b60cd18" providerId="ADAL" clId="{4E01D738-D0C1-4B9B-B836-CF053EEC4C53}" dt="2022-03-16T11:01:29.835" v="1592" actId="1038"/>
          <ac:grpSpMkLst>
            <pc:docMk/>
            <pc:sldMk cId="2336920806" sldId="303"/>
            <ac:grpSpMk id="631" creationId="{089AF3C7-993A-4507-BE2D-4BB7B7EB08B6}"/>
          </ac:grpSpMkLst>
        </pc:grpChg>
        <pc:grpChg chg="add mod">
          <ac:chgData name="Filippo Acconcia" userId="844af49c-a8a0-47ac-a7dd-14a44b60cd18" providerId="ADAL" clId="{4E01D738-D0C1-4B9B-B836-CF053EEC4C53}" dt="2022-03-16T11:01:23.557" v="1588" actId="1038"/>
          <ac:grpSpMkLst>
            <pc:docMk/>
            <pc:sldMk cId="2336920806" sldId="303"/>
            <ac:grpSpMk id="632" creationId="{201447BE-4ABF-4285-9F72-81C6B4A7A579}"/>
          </ac:grpSpMkLst>
        </pc:grpChg>
        <pc:grpChg chg="add mod">
          <ac:chgData name="Filippo Acconcia" userId="844af49c-a8a0-47ac-a7dd-14a44b60cd18" providerId="ADAL" clId="{4E01D738-D0C1-4B9B-B836-CF053EEC4C53}" dt="2022-03-16T11:01:29.835" v="1592" actId="1038"/>
          <ac:grpSpMkLst>
            <pc:docMk/>
            <pc:sldMk cId="2336920806" sldId="303"/>
            <ac:grpSpMk id="663" creationId="{E47DEF8B-B12E-430E-A4FA-C710F51472ED}"/>
          </ac:grpSpMkLst>
        </pc:grpChg>
        <pc:grpChg chg="add mod">
          <ac:chgData name="Filippo Acconcia" userId="844af49c-a8a0-47ac-a7dd-14a44b60cd18" providerId="ADAL" clId="{4E01D738-D0C1-4B9B-B836-CF053EEC4C53}" dt="2022-03-16T11:01:23.557" v="1588" actId="1038"/>
          <ac:grpSpMkLst>
            <pc:docMk/>
            <pc:sldMk cId="2336920806" sldId="303"/>
            <ac:grpSpMk id="664" creationId="{6801F6E5-6095-4117-897C-7D3665B81C7B}"/>
          </ac:grpSpMkLst>
        </pc:grpChg>
        <pc:picChg chg="del mod topLvl">
          <ac:chgData name="Filippo Acconcia" userId="844af49c-a8a0-47ac-a7dd-14a44b60cd18" providerId="ADAL" clId="{4E01D738-D0C1-4B9B-B836-CF053EEC4C53}" dt="2022-03-16T10:11:03.930" v="956" actId="478"/>
          <ac:picMkLst>
            <pc:docMk/>
            <pc:sldMk cId="2336920806" sldId="303"/>
            <ac:picMk id="4" creationId="{12FC60F9-D815-4205-A014-8B1A4020B3CE}"/>
          </ac:picMkLst>
        </pc:picChg>
        <pc:picChg chg="mod">
          <ac:chgData name="Filippo Acconcia" userId="844af49c-a8a0-47ac-a7dd-14a44b60cd18" providerId="ADAL" clId="{4E01D738-D0C1-4B9B-B836-CF053EEC4C53}" dt="2022-03-16T10:10:56.038" v="954" actId="165"/>
          <ac:picMkLst>
            <pc:docMk/>
            <pc:sldMk cId="2336920806" sldId="303"/>
            <ac:picMk id="42" creationId="{1935A872-61CE-44BC-88C2-1F7750017D55}"/>
          </ac:picMkLst>
        </pc:picChg>
        <pc:picChg chg="mod">
          <ac:chgData name="Filippo Acconcia" userId="844af49c-a8a0-47ac-a7dd-14a44b60cd18" providerId="ADAL" clId="{4E01D738-D0C1-4B9B-B836-CF053EEC4C53}" dt="2022-03-16T10:08:21.535" v="944"/>
          <ac:picMkLst>
            <pc:docMk/>
            <pc:sldMk cId="2336920806" sldId="303"/>
            <ac:picMk id="47" creationId="{28347450-E928-4253-98A6-3AA6EBB5C574}"/>
          </ac:picMkLst>
        </pc:picChg>
        <pc:picChg chg="mod">
          <ac:chgData name="Filippo Acconcia" userId="844af49c-a8a0-47ac-a7dd-14a44b60cd18" providerId="ADAL" clId="{4E01D738-D0C1-4B9B-B836-CF053EEC4C53}" dt="2022-03-16T10:08:21.535" v="944"/>
          <ac:picMkLst>
            <pc:docMk/>
            <pc:sldMk cId="2336920806" sldId="303"/>
            <ac:picMk id="85" creationId="{F29D4C6C-AEE8-4479-A82E-F53E2D053818}"/>
          </ac:picMkLst>
        </pc:picChg>
        <pc:picChg chg="mod">
          <ac:chgData name="Filippo Acconcia" userId="844af49c-a8a0-47ac-a7dd-14a44b60cd18" providerId="ADAL" clId="{4E01D738-D0C1-4B9B-B836-CF053EEC4C53}" dt="2022-03-16T10:08:33.114" v="946"/>
          <ac:picMkLst>
            <pc:docMk/>
            <pc:sldMk cId="2336920806" sldId="303"/>
            <ac:picMk id="92" creationId="{03E09459-60AB-4875-82ED-99D4C73A3EAE}"/>
          </ac:picMkLst>
        </pc:picChg>
        <pc:picChg chg="mod">
          <ac:chgData name="Filippo Acconcia" userId="844af49c-a8a0-47ac-a7dd-14a44b60cd18" providerId="ADAL" clId="{4E01D738-D0C1-4B9B-B836-CF053EEC4C53}" dt="2022-03-16T10:08:33.114" v="946"/>
          <ac:picMkLst>
            <pc:docMk/>
            <pc:sldMk cId="2336920806" sldId="303"/>
            <ac:picMk id="104" creationId="{609988CD-B1FE-4FB6-B9B5-CDDF4466FAA1}"/>
          </ac:picMkLst>
        </pc:picChg>
        <pc:picChg chg="del mod topLvl">
          <ac:chgData name="Filippo Acconcia" userId="844af49c-a8a0-47ac-a7dd-14a44b60cd18" providerId="ADAL" clId="{4E01D738-D0C1-4B9B-B836-CF053EEC4C53}" dt="2022-03-16T10:59:28.551" v="1555" actId="478"/>
          <ac:picMkLst>
            <pc:docMk/>
            <pc:sldMk cId="2336920806" sldId="303"/>
            <ac:picMk id="111" creationId="{904E18BB-20A0-4EA3-8D85-F51567C79AC1}"/>
          </ac:picMkLst>
        </pc:picChg>
        <pc:picChg chg="del mod topLvl">
          <ac:chgData name="Filippo Acconcia" userId="844af49c-a8a0-47ac-a7dd-14a44b60cd18" providerId="ADAL" clId="{4E01D738-D0C1-4B9B-B836-CF053EEC4C53}" dt="2022-03-16T10:59:28.551" v="1555" actId="478"/>
          <ac:picMkLst>
            <pc:docMk/>
            <pc:sldMk cId="2336920806" sldId="303"/>
            <ac:picMk id="123" creationId="{A73E3D7E-C5E9-41DD-A5CA-213C94F9A749}"/>
          </ac:picMkLst>
        </pc:picChg>
        <pc:picChg chg="mod ord">
          <ac:chgData name="Filippo Acconcia" userId="844af49c-a8a0-47ac-a7dd-14a44b60cd18" providerId="ADAL" clId="{4E01D738-D0C1-4B9B-B836-CF053EEC4C53}" dt="2022-03-16T10:17:10.919" v="1161" actId="164"/>
          <ac:picMkLst>
            <pc:docMk/>
            <pc:sldMk cId="2336920806" sldId="303"/>
            <ac:picMk id="127" creationId="{35B25ABA-186E-49EF-ABE2-17DC0852D371}"/>
          </ac:picMkLst>
        </pc:picChg>
        <pc:picChg chg="mod">
          <ac:chgData name="Filippo Acconcia" userId="844af49c-a8a0-47ac-a7dd-14a44b60cd18" providerId="ADAL" clId="{4E01D738-D0C1-4B9B-B836-CF053EEC4C53}" dt="2022-03-16T10:10:29.648" v="951" actId="165"/>
          <ac:picMkLst>
            <pc:docMk/>
            <pc:sldMk cId="2336920806" sldId="303"/>
            <ac:picMk id="132" creationId="{879A902B-7866-44AC-815C-4EC32A35F6C5}"/>
          </ac:picMkLst>
        </pc:picChg>
        <pc:picChg chg="del mod topLvl">
          <ac:chgData name="Filippo Acconcia" userId="844af49c-a8a0-47ac-a7dd-14a44b60cd18" providerId="ADAL" clId="{4E01D738-D0C1-4B9B-B836-CF053EEC4C53}" dt="2022-03-16T10:18:55.463" v="1178" actId="478"/>
          <ac:picMkLst>
            <pc:docMk/>
            <pc:sldMk cId="2336920806" sldId="303"/>
            <ac:picMk id="203" creationId="{AB83FCCB-1BCC-4147-AC7A-5A1522678BA2}"/>
          </ac:picMkLst>
        </pc:picChg>
        <pc:picChg chg="mod ord">
          <ac:chgData name="Filippo Acconcia" userId="844af49c-a8a0-47ac-a7dd-14a44b60cd18" providerId="ADAL" clId="{4E01D738-D0C1-4B9B-B836-CF053EEC4C53}" dt="2022-03-16T10:18:59.718" v="1179" actId="164"/>
          <ac:picMkLst>
            <pc:docMk/>
            <pc:sldMk cId="2336920806" sldId="303"/>
            <ac:picMk id="244" creationId="{C284D60D-CA31-4A11-8971-F50F26567EA0}"/>
          </ac:picMkLst>
        </pc:picChg>
        <pc:picChg chg="mod">
          <ac:chgData name="Filippo Acconcia" userId="844af49c-a8a0-47ac-a7dd-14a44b60cd18" providerId="ADAL" clId="{4E01D738-D0C1-4B9B-B836-CF053EEC4C53}" dt="2022-03-16T10:19:30.265" v="1183"/>
          <ac:picMkLst>
            <pc:docMk/>
            <pc:sldMk cId="2336920806" sldId="303"/>
            <ac:picMk id="247" creationId="{0E4BB690-710C-486A-9ADA-7D8957A213E2}"/>
          </ac:picMkLst>
        </pc:picChg>
        <pc:picChg chg="mod">
          <ac:chgData name="Filippo Acconcia" userId="844af49c-a8a0-47ac-a7dd-14a44b60cd18" providerId="ADAL" clId="{4E01D738-D0C1-4B9B-B836-CF053EEC4C53}" dt="2022-03-16T10:19:30.265" v="1183"/>
          <ac:picMkLst>
            <pc:docMk/>
            <pc:sldMk cId="2336920806" sldId="303"/>
            <ac:picMk id="285" creationId="{86B7B660-8FFD-477A-885A-C48B084722C2}"/>
          </ac:picMkLst>
        </pc:picChg>
        <pc:picChg chg="mod">
          <ac:chgData name="Filippo Acconcia" userId="844af49c-a8a0-47ac-a7dd-14a44b60cd18" providerId="ADAL" clId="{4E01D738-D0C1-4B9B-B836-CF053EEC4C53}" dt="2022-03-16T10:44:41.752" v="1189"/>
          <ac:picMkLst>
            <pc:docMk/>
            <pc:sldMk cId="2336920806" sldId="303"/>
            <ac:picMk id="290" creationId="{0B9A52B8-B3E1-4001-809C-60F7CF1B448C}"/>
          </ac:picMkLst>
        </pc:picChg>
        <pc:picChg chg="mod">
          <ac:chgData name="Filippo Acconcia" userId="844af49c-a8a0-47ac-a7dd-14a44b60cd18" providerId="ADAL" clId="{4E01D738-D0C1-4B9B-B836-CF053EEC4C53}" dt="2022-03-16T10:44:41.752" v="1189"/>
          <ac:picMkLst>
            <pc:docMk/>
            <pc:sldMk cId="2336920806" sldId="303"/>
            <ac:picMk id="327" creationId="{2553F049-0259-47F0-B93F-E001FFCB3F10}"/>
          </ac:picMkLst>
        </pc:picChg>
        <pc:picChg chg="mod">
          <ac:chgData name="Filippo Acconcia" userId="844af49c-a8a0-47ac-a7dd-14a44b60cd18" providerId="ADAL" clId="{4E01D738-D0C1-4B9B-B836-CF053EEC4C53}" dt="2022-03-16T10:44:41.752" v="1189"/>
          <ac:picMkLst>
            <pc:docMk/>
            <pc:sldMk cId="2336920806" sldId="303"/>
            <ac:picMk id="332" creationId="{C3DD5E6F-F8A2-425D-A808-DF36977F2906}"/>
          </ac:picMkLst>
        </pc:picChg>
        <pc:picChg chg="mod">
          <ac:chgData name="Filippo Acconcia" userId="844af49c-a8a0-47ac-a7dd-14a44b60cd18" providerId="ADAL" clId="{4E01D738-D0C1-4B9B-B836-CF053EEC4C53}" dt="2022-03-16T10:44:41.752" v="1189"/>
          <ac:picMkLst>
            <pc:docMk/>
            <pc:sldMk cId="2336920806" sldId="303"/>
            <ac:picMk id="370" creationId="{B3BFCF7F-EB10-42C0-987B-AD6038754EF8}"/>
          </ac:picMkLst>
        </pc:picChg>
        <pc:picChg chg="del mod topLvl">
          <ac:chgData name="Filippo Acconcia" userId="844af49c-a8a0-47ac-a7dd-14a44b60cd18" providerId="ADAL" clId="{4E01D738-D0C1-4B9B-B836-CF053EEC4C53}" dt="2022-03-16T10:46:08.729" v="1204" actId="478"/>
          <ac:picMkLst>
            <pc:docMk/>
            <pc:sldMk cId="2336920806" sldId="303"/>
            <ac:picMk id="375" creationId="{063A0DDD-F4C8-4AB4-8355-3BC872942953}"/>
          </ac:picMkLst>
        </pc:picChg>
        <pc:picChg chg="del mod topLvl">
          <ac:chgData name="Filippo Acconcia" userId="844af49c-a8a0-47ac-a7dd-14a44b60cd18" providerId="ADAL" clId="{4E01D738-D0C1-4B9B-B836-CF053EEC4C53}" dt="2022-03-16T10:48:14.446" v="1232" actId="478"/>
          <ac:picMkLst>
            <pc:docMk/>
            <pc:sldMk cId="2336920806" sldId="303"/>
            <ac:picMk id="417" creationId="{B8CBE3CB-F815-4B81-809A-BD2EAF253FD9}"/>
          </ac:picMkLst>
        </pc:picChg>
        <pc:picChg chg="mod ord">
          <ac:chgData name="Filippo Acconcia" userId="844af49c-a8a0-47ac-a7dd-14a44b60cd18" providerId="ADAL" clId="{4E01D738-D0C1-4B9B-B836-CF053EEC4C53}" dt="2022-03-16T10:48:48.519" v="1246" actId="164"/>
          <ac:picMkLst>
            <pc:docMk/>
            <pc:sldMk cId="2336920806" sldId="303"/>
            <ac:picMk id="458" creationId="{C7F14180-F08D-4833-A029-4FE3674A5345}"/>
          </ac:picMkLst>
        </pc:picChg>
        <pc:picChg chg="mod ord">
          <ac:chgData name="Filippo Acconcia" userId="844af49c-a8a0-47ac-a7dd-14a44b60cd18" providerId="ADAL" clId="{4E01D738-D0C1-4B9B-B836-CF053EEC4C53}" dt="2022-03-16T10:48:44.497" v="1245" actId="164"/>
          <ac:picMkLst>
            <pc:docMk/>
            <pc:sldMk cId="2336920806" sldId="303"/>
            <ac:picMk id="459" creationId="{5B0A417C-33A7-44B4-B6F2-C0026405D4A1}"/>
          </ac:picMkLst>
        </pc:picChg>
        <pc:picChg chg="del mod topLvl">
          <ac:chgData name="Filippo Acconcia" userId="844af49c-a8a0-47ac-a7dd-14a44b60cd18" providerId="ADAL" clId="{4E01D738-D0C1-4B9B-B836-CF053EEC4C53}" dt="2022-03-16T10:51:22.321" v="1280" actId="478"/>
          <ac:picMkLst>
            <pc:docMk/>
            <pc:sldMk cId="2336920806" sldId="303"/>
            <ac:picMk id="463" creationId="{7CD5BAEB-882E-4C2B-ADEC-3A83F5E4E294}"/>
          </ac:picMkLst>
        </pc:picChg>
        <pc:picChg chg="mod">
          <ac:chgData name="Filippo Acconcia" userId="844af49c-a8a0-47ac-a7dd-14a44b60cd18" providerId="ADAL" clId="{4E01D738-D0C1-4B9B-B836-CF053EEC4C53}" dt="2022-03-16T10:49:02.913" v="1247"/>
          <ac:picMkLst>
            <pc:docMk/>
            <pc:sldMk cId="2336920806" sldId="303"/>
            <ac:picMk id="505" creationId="{AB54E581-2195-4F7F-BCEA-715D8F9FFBDD}"/>
          </ac:picMkLst>
        </pc:picChg>
        <pc:picChg chg="mod">
          <ac:chgData name="Filippo Acconcia" userId="844af49c-a8a0-47ac-a7dd-14a44b60cd18" providerId="ADAL" clId="{4E01D738-D0C1-4B9B-B836-CF053EEC4C53}" dt="2022-03-16T10:49:59.150" v="1262"/>
          <ac:picMkLst>
            <pc:docMk/>
            <pc:sldMk cId="2336920806" sldId="303"/>
            <ac:picMk id="547" creationId="{AD911BB3-BE73-439F-B46F-4252C1D08D3E}"/>
          </ac:picMkLst>
        </pc:picChg>
        <pc:picChg chg="mod ord">
          <ac:chgData name="Filippo Acconcia" userId="844af49c-a8a0-47ac-a7dd-14a44b60cd18" providerId="ADAL" clId="{4E01D738-D0C1-4B9B-B836-CF053EEC4C53}" dt="2022-03-16T10:53:09.412" v="1328" actId="164"/>
          <ac:picMkLst>
            <pc:docMk/>
            <pc:sldMk cId="2336920806" sldId="303"/>
            <ac:picMk id="588" creationId="{3464A1BB-EC83-4692-8934-01681A32B28E}"/>
          </ac:picMkLst>
        </pc:picChg>
        <pc:picChg chg="add del mod">
          <ac:chgData name="Filippo Acconcia" userId="844af49c-a8a0-47ac-a7dd-14a44b60cd18" providerId="ADAL" clId="{4E01D738-D0C1-4B9B-B836-CF053EEC4C53}" dt="2022-03-16T10:52:53.053" v="1324" actId="478"/>
          <ac:picMkLst>
            <pc:docMk/>
            <pc:sldMk cId="2336920806" sldId="303"/>
            <ac:picMk id="589" creationId="{52329238-794A-4E8F-9AD1-B5D9B07C7928}"/>
          </ac:picMkLst>
        </pc:picChg>
        <pc:picChg chg="mod ord">
          <ac:chgData name="Filippo Acconcia" userId="844af49c-a8a0-47ac-a7dd-14a44b60cd18" providerId="ADAL" clId="{4E01D738-D0C1-4B9B-B836-CF053EEC4C53}" dt="2022-03-16T10:53:05.724" v="1327" actId="164"/>
          <ac:picMkLst>
            <pc:docMk/>
            <pc:sldMk cId="2336920806" sldId="303"/>
            <ac:picMk id="630" creationId="{7A663C1C-ABE7-45F0-920D-DE2C23546CA9}"/>
          </ac:picMkLst>
        </pc:picChg>
        <pc:picChg chg="mod">
          <ac:chgData name="Filippo Acconcia" userId="844af49c-a8a0-47ac-a7dd-14a44b60cd18" providerId="ADAL" clId="{4E01D738-D0C1-4B9B-B836-CF053EEC4C53}" dt="2022-03-16T11:00:52.825" v="1570" actId="164"/>
          <ac:picMkLst>
            <pc:docMk/>
            <pc:sldMk cId="2336920806" sldId="303"/>
            <ac:picMk id="633" creationId="{E2AFECE9-243E-43AF-84C0-711F788086AA}"/>
          </ac:picMkLst>
        </pc:picChg>
        <pc:picChg chg="mod">
          <ac:chgData name="Filippo Acconcia" userId="844af49c-a8a0-47ac-a7dd-14a44b60cd18" providerId="ADAL" clId="{4E01D738-D0C1-4B9B-B836-CF053EEC4C53}" dt="2022-03-16T11:00:52.825" v="1570" actId="164"/>
          <ac:picMkLst>
            <pc:docMk/>
            <pc:sldMk cId="2336920806" sldId="303"/>
            <ac:picMk id="634" creationId="{A410E42B-9E0D-4FAA-8A28-E00F3EDFAC37}"/>
          </ac:picMkLst>
        </pc:picChg>
        <pc:picChg chg="add del mod">
          <ac:chgData name="Filippo Acconcia" userId="844af49c-a8a0-47ac-a7dd-14a44b60cd18" providerId="ADAL" clId="{4E01D738-D0C1-4B9B-B836-CF053EEC4C53}" dt="2022-03-16T11:00:37.767" v="1563" actId="478"/>
          <ac:picMkLst>
            <pc:docMk/>
            <pc:sldMk cId="2336920806" sldId="303"/>
            <ac:picMk id="649" creationId="{FBD84EBB-F3B6-4E2A-ABAF-D6C0B9B7826E}"/>
          </ac:picMkLst>
        </pc:picChg>
        <pc:picChg chg="add mod">
          <ac:chgData name="Filippo Acconcia" userId="844af49c-a8a0-47ac-a7dd-14a44b60cd18" providerId="ADAL" clId="{4E01D738-D0C1-4B9B-B836-CF053EEC4C53}" dt="2022-03-16T11:00:49.170" v="1569" actId="164"/>
          <ac:picMkLst>
            <pc:docMk/>
            <pc:sldMk cId="2336920806" sldId="303"/>
            <ac:picMk id="650" creationId="{BA46438E-9426-42F0-941B-B8CB92BFD16D}"/>
          </ac:picMkLst>
        </pc:picChg>
        <pc:picChg chg="mod ord">
          <ac:chgData name="Filippo Acconcia" userId="844af49c-a8a0-47ac-a7dd-14a44b60cd18" providerId="ADAL" clId="{4E01D738-D0C1-4B9B-B836-CF053EEC4C53}" dt="2022-03-16T11:00:49.170" v="1569" actId="164"/>
          <ac:picMkLst>
            <pc:docMk/>
            <pc:sldMk cId="2336920806" sldId="303"/>
            <ac:picMk id="662" creationId="{B3E28D3D-F602-4051-9FB4-C90429033242}"/>
          </ac:picMkLst>
        </pc:picChg>
        <pc:cxnChg chg="del mod topLvl">
          <ac:chgData name="Filippo Acconcia" userId="844af49c-a8a0-47ac-a7dd-14a44b60cd18" providerId="ADAL" clId="{4E01D738-D0C1-4B9B-B836-CF053EEC4C53}" dt="2022-03-16T10:11:06.185" v="957" actId="478"/>
          <ac:cxnSpMkLst>
            <pc:docMk/>
            <pc:sldMk cId="2336920806" sldId="303"/>
            <ac:cxnSpMk id="10" creationId="{9A56F337-2A7E-4C7F-868F-8AA1683EA523}"/>
          </ac:cxnSpMkLst>
        </pc:cxnChg>
        <pc:cxnChg chg="del mod topLvl">
          <ac:chgData name="Filippo Acconcia" userId="844af49c-a8a0-47ac-a7dd-14a44b60cd18" providerId="ADAL" clId="{4E01D738-D0C1-4B9B-B836-CF053EEC4C53}" dt="2022-03-16T10:13:36.388" v="1060" actId="478"/>
          <ac:cxnSpMkLst>
            <pc:docMk/>
            <pc:sldMk cId="2336920806" sldId="303"/>
            <ac:cxnSpMk id="16" creationId="{2BCC75B9-76DE-4344-9943-AECE6CE3E606}"/>
          </ac:cxnSpMkLst>
        </pc:cxnChg>
        <pc:cxnChg chg="del mod topLvl">
          <ac:chgData name="Filippo Acconcia" userId="844af49c-a8a0-47ac-a7dd-14a44b60cd18" providerId="ADAL" clId="{4E01D738-D0C1-4B9B-B836-CF053EEC4C53}" dt="2022-03-16T10:13:38.774" v="1061" actId="478"/>
          <ac:cxnSpMkLst>
            <pc:docMk/>
            <pc:sldMk cId="2336920806" sldId="303"/>
            <ac:cxnSpMk id="22" creationId="{13413E83-1B3D-4097-9CEE-7E94F5895016}"/>
          </ac:cxnSpMkLst>
        </pc:cxnChg>
        <pc:cxnChg chg="del mod topLvl">
          <ac:chgData name="Filippo Acconcia" userId="844af49c-a8a0-47ac-a7dd-14a44b60cd18" providerId="ADAL" clId="{4E01D738-D0C1-4B9B-B836-CF053EEC4C53}" dt="2022-03-16T10:13:36.388" v="1060" actId="478"/>
          <ac:cxnSpMkLst>
            <pc:docMk/>
            <pc:sldMk cId="2336920806" sldId="303"/>
            <ac:cxnSpMk id="28" creationId="{89946189-3336-49E9-9BF4-3BC174EBC8C7}"/>
          </ac:cxnSpMkLst>
        </pc:cxnChg>
        <pc:cxnChg chg="del mod topLvl">
          <ac:chgData name="Filippo Acconcia" userId="844af49c-a8a0-47ac-a7dd-14a44b60cd18" providerId="ADAL" clId="{4E01D738-D0C1-4B9B-B836-CF053EEC4C53}" dt="2022-03-16T10:13:36.388" v="1060" actId="478"/>
          <ac:cxnSpMkLst>
            <pc:docMk/>
            <pc:sldMk cId="2336920806" sldId="303"/>
            <ac:cxnSpMk id="34" creationId="{67B56B49-4290-4ECF-9B31-D1C701D5DBEF}"/>
          </ac:cxnSpMkLst>
        </pc:cxnChg>
        <pc:cxnChg chg="del mod topLvl">
          <ac:chgData name="Filippo Acconcia" userId="844af49c-a8a0-47ac-a7dd-14a44b60cd18" providerId="ADAL" clId="{4E01D738-D0C1-4B9B-B836-CF053EEC4C53}" dt="2022-03-16T10:13:40.730" v="1062" actId="478"/>
          <ac:cxnSpMkLst>
            <pc:docMk/>
            <pc:sldMk cId="2336920806" sldId="303"/>
            <ac:cxnSpMk id="40" creationId="{750BC89A-A301-4BDB-AE32-FB59F9BD0C56}"/>
          </ac:cxnSpMkLst>
        </pc:cxnChg>
        <pc:cxnChg chg="mod">
          <ac:chgData name="Filippo Acconcia" userId="844af49c-a8a0-47ac-a7dd-14a44b60cd18" providerId="ADAL" clId="{4E01D738-D0C1-4B9B-B836-CF053EEC4C53}" dt="2022-03-16T10:08:21.535" v="944"/>
          <ac:cxnSpMkLst>
            <pc:docMk/>
            <pc:sldMk cId="2336920806" sldId="303"/>
            <ac:cxnSpMk id="53" creationId="{7317F75E-C347-4ED4-8195-84C20A1F3368}"/>
          </ac:cxnSpMkLst>
        </pc:cxnChg>
        <pc:cxnChg chg="mod">
          <ac:chgData name="Filippo Acconcia" userId="844af49c-a8a0-47ac-a7dd-14a44b60cd18" providerId="ADAL" clId="{4E01D738-D0C1-4B9B-B836-CF053EEC4C53}" dt="2022-03-16T10:08:21.535" v="944"/>
          <ac:cxnSpMkLst>
            <pc:docMk/>
            <pc:sldMk cId="2336920806" sldId="303"/>
            <ac:cxnSpMk id="59" creationId="{58E4DA4E-C0E8-44D9-B4AD-73AF5FF7C0B1}"/>
          </ac:cxnSpMkLst>
        </pc:cxnChg>
        <pc:cxnChg chg="mod">
          <ac:chgData name="Filippo Acconcia" userId="844af49c-a8a0-47ac-a7dd-14a44b60cd18" providerId="ADAL" clId="{4E01D738-D0C1-4B9B-B836-CF053EEC4C53}" dt="2022-03-16T10:08:21.535" v="944"/>
          <ac:cxnSpMkLst>
            <pc:docMk/>
            <pc:sldMk cId="2336920806" sldId="303"/>
            <ac:cxnSpMk id="65" creationId="{A51C91FD-B7E7-47CE-9AE9-FB8E6CD8C010}"/>
          </ac:cxnSpMkLst>
        </pc:cxnChg>
        <pc:cxnChg chg="mod">
          <ac:chgData name="Filippo Acconcia" userId="844af49c-a8a0-47ac-a7dd-14a44b60cd18" providerId="ADAL" clId="{4E01D738-D0C1-4B9B-B836-CF053EEC4C53}" dt="2022-03-16T10:08:21.535" v="944"/>
          <ac:cxnSpMkLst>
            <pc:docMk/>
            <pc:sldMk cId="2336920806" sldId="303"/>
            <ac:cxnSpMk id="71" creationId="{3C83EFAD-4E6C-43F8-B90D-1CE5B32035D3}"/>
          </ac:cxnSpMkLst>
        </pc:cxnChg>
        <pc:cxnChg chg="mod">
          <ac:chgData name="Filippo Acconcia" userId="844af49c-a8a0-47ac-a7dd-14a44b60cd18" providerId="ADAL" clId="{4E01D738-D0C1-4B9B-B836-CF053EEC4C53}" dt="2022-03-16T10:08:21.535" v="944"/>
          <ac:cxnSpMkLst>
            <pc:docMk/>
            <pc:sldMk cId="2336920806" sldId="303"/>
            <ac:cxnSpMk id="77" creationId="{2F3318B7-129F-4941-9D9B-A168F10CA201}"/>
          </ac:cxnSpMkLst>
        </pc:cxnChg>
        <pc:cxnChg chg="mod">
          <ac:chgData name="Filippo Acconcia" userId="844af49c-a8a0-47ac-a7dd-14a44b60cd18" providerId="ADAL" clId="{4E01D738-D0C1-4B9B-B836-CF053EEC4C53}" dt="2022-03-16T10:08:21.535" v="944"/>
          <ac:cxnSpMkLst>
            <pc:docMk/>
            <pc:sldMk cId="2336920806" sldId="303"/>
            <ac:cxnSpMk id="83" creationId="{60CFA369-B7E5-4E15-A02A-B42F01E1FEB1}"/>
          </ac:cxnSpMkLst>
        </pc:cxnChg>
        <pc:cxnChg chg="mod">
          <ac:chgData name="Filippo Acconcia" userId="844af49c-a8a0-47ac-a7dd-14a44b60cd18" providerId="ADAL" clId="{4E01D738-D0C1-4B9B-B836-CF053EEC4C53}" dt="2022-03-16T10:08:33.114" v="946"/>
          <ac:cxnSpMkLst>
            <pc:docMk/>
            <pc:sldMk cId="2336920806" sldId="303"/>
            <ac:cxnSpMk id="97" creationId="{DCBF4AEB-6B28-407F-9912-05392DDFC6E0}"/>
          </ac:cxnSpMkLst>
        </pc:cxnChg>
        <pc:cxnChg chg="del mod topLvl">
          <ac:chgData name="Filippo Acconcia" userId="844af49c-a8a0-47ac-a7dd-14a44b60cd18" providerId="ADAL" clId="{4E01D738-D0C1-4B9B-B836-CF053EEC4C53}" dt="2022-03-16T10:59:28.551" v="1555" actId="478"/>
          <ac:cxnSpMkLst>
            <pc:docMk/>
            <pc:sldMk cId="2336920806" sldId="303"/>
            <ac:cxnSpMk id="116" creationId="{9A14B1B7-F6C2-48C2-90D9-6A9927C0AB74}"/>
          </ac:cxnSpMkLst>
        </pc:cxnChg>
        <pc:cxnChg chg="mod">
          <ac:chgData name="Filippo Acconcia" userId="844af49c-a8a0-47ac-a7dd-14a44b60cd18" providerId="ADAL" clId="{4E01D738-D0C1-4B9B-B836-CF053EEC4C53}" dt="2022-03-16T10:10:29.648" v="951" actId="165"/>
          <ac:cxnSpMkLst>
            <pc:docMk/>
            <pc:sldMk cId="2336920806" sldId="303"/>
            <ac:cxnSpMk id="148" creationId="{195EE966-1097-4BF6-BF92-975D9AB205D5}"/>
          </ac:cxnSpMkLst>
        </pc:cxnChg>
        <pc:cxnChg chg="mod">
          <ac:chgData name="Filippo Acconcia" userId="844af49c-a8a0-47ac-a7dd-14a44b60cd18" providerId="ADAL" clId="{4E01D738-D0C1-4B9B-B836-CF053EEC4C53}" dt="2022-03-16T10:10:29.648" v="951" actId="165"/>
          <ac:cxnSpMkLst>
            <pc:docMk/>
            <pc:sldMk cId="2336920806" sldId="303"/>
            <ac:cxnSpMk id="149" creationId="{4108D852-5737-453C-91B2-784DA8EBA935}"/>
          </ac:cxnSpMkLst>
        </pc:cxnChg>
        <pc:cxnChg chg="mod">
          <ac:chgData name="Filippo Acconcia" userId="844af49c-a8a0-47ac-a7dd-14a44b60cd18" providerId="ADAL" clId="{4E01D738-D0C1-4B9B-B836-CF053EEC4C53}" dt="2022-03-16T10:10:29.648" v="951" actId="165"/>
          <ac:cxnSpMkLst>
            <pc:docMk/>
            <pc:sldMk cId="2336920806" sldId="303"/>
            <ac:cxnSpMk id="150" creationId="{4A36E916-894A-49E2-8C26-A90CB139F55B}"/>
          </ac:cxnSpMkLst>
        </pc:cxnChg>
        <pc:cxnChg chg="mod">
          <ac:chgData name="Filippo Acconcia" userId="844af49c-a8a0-47ac-a7dd-14a44b60cd18" providerId="ADAL" clId="{4E01D738-D0C1-4B9B-B836-CF053EEC4C53}" dt="2022-03-16T10:10:29.648" v="951" actId="165"/>
          <ac:cxnSpMkLst>
            <pc:docMk/>
            <pc:sldMk cId="2336920806" sldId="303"/>
            <ac:cxnSpMk id="151" creationId="{37DDDE9B-C9CA-4C0F-A4F2-C43DAF987771}"/>
          </ac:cxnSpMkLst>
        </pc:cxnChg>
        <pc:cxnChg chg="add mod">
          <ac:chgData name="Filippo Acconcia" userId="844af49c-a8a0-47ac-a7dd-14a44b60cd18" providerId="ADAL" clId="{4E01D738-D0C1-4B9B-B836-CF053EEC4C53}" dt="2022-03-16T10:17:10.919" v="1161" actId="164"/>
          <ac:cxnSpMkLst>
            <pc:docMk/>
            <pc:sldMk cId="2336920806" sldId="303"/>
            <ac:cxnSpMk id="193" creationId="{DF9024DE-20D0-43AF-B2BC-4547BBC7674C}"/>
          </ac:cxnSpMkLst>
        </pc:cxnChg>
        <pc:cxnChg chg="add mod">
          <ac:chgData name="Filippo Acconcia" userId="844af49c-a8a0-47ac-a7dd-14a44b60cd18" providerId="ADAL" clId="{4E01D738-D0C1-4B9B-B836-CF053EEC4C53}" dt="2022-03-16T10:17:10.919" v="1161" actId="164"/>
          <ac:cxnSpMkLst>
            <pc:docMk/>
            <pc:sldMk cId="2336920806" sldId="303"/>
            <ac:cxnSpMk id="194" creationId="{5C686A03-8B1D-42D2-A6C2-B4F830ABACD8}"/>
          </ac:cxnSpMkLst>
        </pc:cxnChg>
        <pc:cxnChg chg="add mod">
          <ac:chgData name="Filippo Acconcia" userId="844af49c-a8a0-47ac-a7dd-14a44b60cd18" providerId="ADAL" clId="{4E01D738-D0C1-4B9B-B836-CF053EEC4C53}" dt="2022-03-16T10:17:10.919" v="1161" actId="164"/>
          <ac:cxnSpMkLst>
            <pc:docMk/>
            <pc:sldMk cId="2336920806" sldId="303"/>
            <ac:cxnSpMk id="195" creationId="{C50AC52C-B993-4601-ADFC-1501216B3401}"/>
          </ac:cxnSpMkLst>
        </pc:cxnChg>
        <pc:cxnChg chg="add mod">
          <ac:chgData name="Filippo Acconcia" userId="844af49c-a8a0-47ac-a7dd-14a44b60cd18" providerId="ADAL" clId="{4E01D738-D0C1-4B9B-B836-CF053EEC4C53}" dt="2022-03-16T10:17:10.919" v="1161" actId="164"/>
          <ac:cxnSpMkLst>
            <pc:docMk/>
            <pc:sldMk cId="2336920806" sldId="303"/>
            <ac:cxnSpMk id="196" creationId="{42EC6D8B-DBB0-42A4-8412-E5E2EC98093B}"/>
          </ac:cxnSpMkLst>
        </pc:cxnChg>
        <pc:cxnChg chg="add mod">
          <ac:chgData name="Filippo Acconcia" userId="844af49c-a8a0-47ac-a7dd-14a44b60cd18" providerId="ADAL" clId="{4E01D738-D0C1-4B9B-B836-CF053EEC4C53}" dt="2022-03-16T10:17:10.919" v="1161" actId="164"/>
          <ac:cxnSpMkLst>
            <pc:docMk/>
            <pc:sldMk cId="2336920806" sldId="303"/>
            <ac:cxnSpMk id="197" creationId="{EEF0205A-D8E0-4391-8DA2-92D4A321CD5C}"/>
          </ac:cxnSpMkLst>
        </pc:cxnChg>
        <pc:cxnChg chg="mod topLvl">
          <ac:chgData name="Filippo Acconcia" userId="844af49c-a8a0-47ac-a7dd-14a44b60cd18" providerId="ADAL" clId="{4E01D738-D0C1-4B9B-B836-CF053EEC4C53}" dt="2022-03-16T10:18:59.718" v="1179" actId="164"/>
          <ac:cxnSpMkLst>
            <pc:docMk/>
            <pc:sldMk cId="2336920806" sldId="303"/>
            <ac:cxnSpMk id="216" creationId="{EFDF0B88-7533-4B70-8629-59C65AB93464}"/>
          </ac:cxnSpMkLst>
        </pc:cxnChg>
        <pc:cxnChg chg="mod topLvl">
          <ac:chgData name="Filippo Acconcia" userId="844af49c-a8a0-47ac-a7dd-14a44b60cd18" providerId="ADAL" clId="{4E01D738-D0C1-4B9B-B836-CF053EEC4C53}" dt="2022-03-16T10:18:59.718" v="1179" actId="164"/>
          <ac:cxnSpMkLst>
            <pc:docMk/>
            <pc:sldMk cId="2336920806" sldId="303"/>
            <ac:cxnSpMk id="217" creationId="{1A8EF527-1059-4991-A6DD-7FAAA0000B5D}"/>
          </ac:cxnSpMkLst>
        </pc:cxnChg>
        <pc:cxnChg chg="mod topLvl">
          <ac:chgData name="Filippo Acconcia" userId="844af49c-a8a0-47ac-a7dd-14a44b60cd18" providerId="ADAL" clId="{4E01D738-D0C1-4B9B-B836-CF053EEC4C53}" dt="2022-03-16T10:18:59.718" v="1179" actId="164"/>
          <ac:cxnSpMkLst>
            <pc:docMk/>
            <pc:sldMk cId="2336920806" sldId="303"/>
            <ac:cxnSpMk id="218" creationId="{1D30BC45-C119-4F16-B039-D5F3E4B31BE5}"/>
          </ac:cxnSpMkLst>
        </pc:cxnChg>
        <pc:cxnChg chg="mod topLvl">
          <ac:chgData name="Filippo Acconcia" userId="844af49c-a8a0-47ac-a7dd-14a44b60cd18" providerId="ADAL" clId="{4E01D738-D0C1-4B9B-B836-CF053EEC4C53}" dt="2022-03-16T10:18:59.718" v="1179" actId="164"/>
          <ac:cxnSpMkLst>
            <pc:docMk/>
            <pc:sldMk cId="2336920806" sldId="303"/>
            <ac:cxnSpMk id="219" creationId="{906D5873-3AC2-44DE-A154-BB8BC823F9A7}"/>
          </ac:cxnSpMkLst>
        </pc:cxnChg>
        <pc:cxnChg chg="mod topLvl">
          <ac:chgData name="Filippo Acconcia" userId="844af49c-a8a0-47ac-a7dd-14a44b60cd18" providerId="ADAL" clId="{4E01D738-D0C1-4B9B-B836-CF053EEC4C53}" dt="2022-03-16T10:18:59.718" v="1179" actId="164"/>
          <ac:cxnSpMkLst>
            <pc:docMk/>
            <pc:sldMk cId="2336920806" sldId="303"/>
            <ac:cxnSpMk id="220" creationId="{87EB1925-38EE-4C7E-87CF-C179C3E05DD8}"/>
          </ac:cxnSpMkLst>
        </pc:cxnChg>
        <pc:cxnChg chg="mod">
          <ac:chgData name="Filippo Acconcia" userId="844af49c-a8a0-47ac-a7dd-14a44b60cd18" providerId="ADAL" clId="{4E01D738-D0C1-4B9B-B836-CF053EEC4C53}" dt="2022-03-16T10:19:30.265" v="1183"/>
          <ac:cxnSpMkLst>
            <pc:docMk/>
            <pc:sldMk cId="2336920806" sldId="303"/>
            <ac:cxnSpMk id="253" creationId="{2B9D84B4-F9F1-42A9-9DC4-7208EA10036F}"/>
          </ac:cxnSpMkLst>
        </pc:cxnChg>
        <pc:cxnChg chg="mod">
          <ac:chgData name="Filippo Acconcia" userId="844af49c-a8a0-47ac-a7dd-14a44b60cd18" providerId="ADAL" clId="{4E01D738-D0C1-4B9B-B836-CF053EEC4C53}" dt="2022-03-16T10:19:30.265" v="1183"/>
          <ac:cxnSpMkLst>
            <pc:docMk/>
            <pc:sldMk cId="2336920806" sldId="303"/>
            <ac:cxnSpMk id="259" creationId="{E6CC0ABF-E89C-464B-867F-503715C98011}"/>
          </ac:cxnSpMkLst>
        </pc:cxnChg>
        <pc:cxnChg chg="mod">
          <ac:chgData name="Filippo Acconcia" userId="844af49c-a8a0-47ac-a7dd-14a44b60cd18" providerId="ADAL" clId="{4E01D738-D0C1-4B9B-B836-CF053EEC4C53}" dt="2022-03-16T10:19:30.265" v="1183"/>
          <ac:cxnSpMkLst>
            <pc:docMk/>
            <pc:sldMk cId="2336920806" sldId="303"/>
            <ac:cxnSpMk id="265" creationId="{567A973E-A44A-4F10-843F-03AC6A450DCB}"/>
          </ac:cxnSpMkLst>
        </pc:cxnChg>
        <pc:cxnChg chg="mod">
          <ac:chgData name="Filippo Acconcia" userId="844af49c-a8a0-47ac-a7dd-14a44b60cd18" providerId="ADAL" clId="{4E01D738-D0C1-4B9B-B836-CF053EEC4C53}" dt="2022-03-16T10:19:30.265" v="1183"/>
          <ac:cxnSpMkLst>
            <pc:docMk/>
            <pc:sldMk cId="2336920806" sldId="303"/>
            <ac:cxnSpMk id="271" creationId="{9AB97A20-2E5D-4043-B45B-B38A9CC75032}"/>
          </ac:cxnSpMkLst>
        </pc:cxnChg>
        <pc:cxnChg chg="mod">
          <ac:chgData name="Filippo Acconcia" userId="844af49c-a8a0-47ac-a7dd-14a44b60cd18" providerId="ADAL" clId="{4E01D738-D0C1-4B9B-B836-CF053EEC4C53}" dt="2022-03-16T10:19:30.265" v="1183"/>
          <ac:cxnSpMkLst>
            <pc:docMk/>
            <pc:sldMk cId="2336920806" sldId="303"/>
            <ac:cxnSpMk id="277" creationId="{A6E5E906-FA87-4BB9-9AF0-88BFF43FBCE0}"/>
          </ac:cxnSpMkLst>
        </pc:cxnChg>
        <pc:cxnChg chg="mod">
          <ac:chgData name="Filippo Acconcia" userId="844af49c-a8a0-47ac-a7dd-14a44b60cd18" providerId="ADAL" clId="{4E01D738-D0C1-4B9B-B836-CF053EEC4C53}" dt="2022-03-16T10:19:30.265" v="1183"/>
          <ac:cxnSpMkLst>
            <pc:docMk/>
            <pc:sldMk cId="2336920806" sldId="303"/>
            <ac:cxnSpMk id="283" creationId="{284A97DA-B1EF-409A-ACAB-17437FEA54EA}"/>
          </ac:cxnSpMkLst>
        </pc:cxnChg>
        <pc:cxnChg chg="mod">
          <ac:chgData name="Filippo Acconcia" userId="844af49c-a8a0-47ac-a7dd-14a44b60cd18" providerId="ADAL" clId="{4E01D738-D0C1-4B9B-B836-CF053EEC4C53}" dt="2022-03-16T10:44:41.752" v="1189"/>
          <ac:cxnSpMkLst>
            <pc:docMk/>
            <pc:sldMk cId="2336920806" sldId="303"/>
            <ac:cxnSpMk id="295" creationId="{CA363B6D-55EC-4027-97FC-DD929E4DB92B}"/>
          </ac:cxnSpMkLst>
        </pc:cxnChg>
        <pc:cxnChg chg="mod">
          <ac:chgData name="Filippo Acconcia" userId="844af49c-a8a0-47ac-a7dd-14a44b60cd18" providerId="ADAL" clId="{4E01D738-D0C1-4B9B-B836-CF053EEC4C53}" dt="2022-03-16T10:44:41.752" v="1189"/>
          <ac:cxnSpMkLst>
            <pc:docMk/>
            <pc:sldMk cId="2336920806" sldId="303"/>
            <ac:cxnSpMk id="301" creationId="{62FB0997-BECC-444E-A259-C480A83F2093}"/>
          </ac:cxnSpMkLst>
        </pc:cxnChg>
        <pc:cxnChg chg="mod">
          <ac:chgData name="Filippo Acconcia" userId="844af49c-a8a0-47ac-a7dd-14a44b60cd18" providerId="ADAL" clId="{4E01D738-D0C1-4B9B-B836-CF053EEC4C53}" dt="2022-03-16T10:44:41.752" v="1189"/>
          <ac:cxnSpMkLst>
            <pc:docMk/>
            <pc:sldMk cId="2336920806" sldId="303"/>
            <ac:cxnSpMk id="307" creationId="{F7BD04E6-ED98-409D-A67A-11A24FA19A52}"/>
          </ac:cxnSpMkLst>
        </pc:cxnChg>
        <pc:cxnChg chg="mod">
          <ac:chgData name="Filippo Acconcia" userId="844af49c-a8a0-47ac-a7dd-14a44b60cd18" providerId="ADAL" clId="{4E01D738-D0C1-4B9B-B836-CF053EEC4C53}" dt="2022-03-16T10:44:41.752" v="1189"/>
          <ac:cxnSpMkLst>
            <pc:docMk/>
            <pc:sldMk cId="2336920806" sldId="303"/>
            <ac:cxnSpMk id="313" creationId="{0A3B161B-9E01-418A-9E08-5BDD2439210D}"/>
          </ac:cxnSpMkLst>
        </pc:cxnChg>
        <pc:cxnChg chg="mod">
          <ac:chgData name="Filippo Acconcia" userId="844af49c-a8a0-47ac-a7dd-14a44b60cd18" providerId="ADAL" clId="{4E01D738-D0C1-4B9B-B836-CF053EEC4C53}" dt="2022-03-16T10:44:41.752" v="1189"/>
          <ac:cxnSpMkLst>
            <pc:docMk/>
            <pc:sldMk cId="2336920806" sldId="303"/>
            <ac:cxnSpMk id="319" creationId="{4BA6111B-9520-4465-B0CD-A622380843D5}"/>
          </ac:cxnSpMkLst>
        </pc:cxnChg>
        <pc:cxnChg chg="mod">
          <ac:chgData name="Filippo Acconcia" userId="844af49c-a8a0-47ac-a7dd-14a44b60cd18" providerId="ADAL" clId="{4E01D738-D0C1-4B9B-B836-CF053EEC4C53}" dt="2022-03-16T10:44:41.752" v="1189"/>
          <ac:cxnSpMkLst>
            <pc:docMk/>
            <pc:sldMk cId="2336920806" sldId="303"/>
            <ac:cxnSpMk id="325" creationId="{0D460857-FD5B-444E-8A8F-877DB400E7E5}"/>
          </ac:cxnSpMkLst>
        </pc:cxnChg>
        <pc:cxnChg chg="mod">
          <ac:chgData name="Filippo Acconcia" userId="844af49c-a8a0-47ac-a7dd-14a44b60cd18" providerId="ADAL" clId="{4E01D738-D0C1-4B9B-B836-CF053EEC4C53}" dt="2022-03-16T10:44:41.752" v="1189"/>
          <ac:cxnSpMkLst>
            <pc:docMk/>
            <pc:sldMk cId="2336920806" sldId="303"/>
            <ac:cxnSpMk id="338" creationId="{12A444EF-0BD6-4C19-82D4-2FB3E2EBFFA8}"/>
          </ac:cxnSpMkLst>
        </pc:cxnChg>
        <pc:cxnChg chg="mod">
          <ac:chgData name="Filippo Acconcia" userId="844af49c-a8a0-47ac-a7dd-14a44b60cd18" providerId="ADAL" clId="{4E01D738-D0C1-4B9B-B836-CF053EEC4C53}" dt="2022-03-16T10:44:41.752" v="1189"/>
          <ac:cxnSpMkLst>
            <pc:docMk/>
            <pc:sldMk cId="2336920806" sldId="303"/>
            <ac:cxnSpMk id="344" creationId="{DC3B0465-527E-4BDB-A95F-8E7815271D6B}"/>
          </ac:cxnSpMkLst>
        </pc:cxnChg>
        <pc:cxnChg chg="mod">
          <ac:chgData name="Filippo Acconcia" userId="844af49c-a8a0-47ac-a7dd-14a44b60cd18" providerId="ADAL" clId="{4E01D738-D0C1-4B9B-B836-CF053EEC4C53}" dt="2022-03-16T10:44:41.752" v="1189"/>
          <ac:cxnSpMkLst>
            <pc:docMk/>
            <pc:sldMk cId="2336920806" sldId="303"/>
            <ac:cxnSpMk id="350" creationId="{8CD512FD-F33A-45EC-B162-E22F726A2377}"/>
          </ac:cxnSpMkLst>
        </pc:cxnChg>
        <pc:cxnChg chg="mod">
          <ac:chgData name="Filippo Acconcia" userId="844af49c-a8a0-47ac-a7dd-14a44b60cd18" providerId="ADAL" clId="{4E01D738-D0C1-4B9B-B836-CF053EEC4C53}" dt="2022-03-16T10:44:41.752" v="1189"/>
          <ac:cxnSpMkLst>
            <pc:docMk/>
            <pc:sldMk cId="2336920806" sldId="303"/>
            <ac:cxnSpMk id="356" creationId="{3210B51A-8480-4AF0-945A-EA7E95253BED}"/>
          </ac:cxnSpMkLst>
        </pc:cxnChg>
        <pc:cxnChg chg="mod">
          <ac:chgData name="Filippo Acconcia" userId="844af49c-a8a0-47ac-a7dd-14a44b60cd18" providerId="ADAL" clId="{4E01D738-D0C1-4B9B-B836-CF053EEC4C53}" dt="2022-03-16T10:44:41.752" v="1189"/>
          <ac:cxnSpMkLst>
            <pc:docMk/>
            <pc:sldMk cId="2336920806" sldId="303"/>
            <ac:cxnSpMk id="362" creationId="{DAF6A1A0-ABA8-455A-B4A9-50467F99DEF0}"/>
          </ac:cxnSpMkLst>
        </pc:cxnChg>
        <pc:cxnChg chg="mod">
          <ac:chgData name="Filippo Acconcia" userId="844af49c-a8a0-47ac-a7dd-14a44b60cd18" providerId="ADAL" clId="{4E01D738-D0C1-4B9B-B836-CF053EEC4C53}" dt="2022-03-16T10:44:41.752" v="1189"/>
          <ac:cxnSpMkLst>
            <pc:docMk/>
            <pc:sldMk cId="2336920806" sldId="303"/>
            <ac:cxnSpMk id="368" creationId="{AA2ECAB4-9AE8-43E8-98B8-BE6355030B00}"/>
          </ac:cxnSpMkLst>
        </pc:cxnChg>
        <pc:cxnChg chg="mod topLvl">
          <ac:chgData name="Filippo Acconcia" userId="844af49c-a8a0-47ac-a7dd-14a44b60cd18" providerId="ADAL" clId="{4E01D738-D0C1-4B9B-B836-CF053EEC4C53}" dt="2022-03-16T10:48:48.519" v="1246" actId="164"/>
          <ac:cxnSpMkLst>
            <pc:docMk/>
            <pc:sldMk cId="2336920806" sldId="303"/>
            <ac:cxnSpMk id="388" creationId="{B9F8DBB9-3159-436A-B615-7447AC1E03F2}"/>
          </ac:cxnSpMkLst>
        </pc:cxnChg>
        <pc:cxnChg chg="mod topLvl">
          <ac:chgData name="Filippo Acconcia" userId="844af49c-a8a0-47ac-a7dd-14a44b60cd18" providerId="ADAL" clId="{4E01D738-D0C1-4B9B-B836-CF053EEC4C53}" dt="2022-03-16T10:48:48.519" v="1246" actId="164"/>
          <ac:cxnSpMkLst>
            <pc:docMk/>
            <pc:sldMk cId="2336920806" sldId="303"/>
            <ac:cxnSpMk id="389" creationId="{B8B25AA3-2AE6-483F-B0FA-A8B8CF26D0D4}"/>
          </ac:cxnSpMkLst>
        </pc:cxnChg>
        <pc:cxnChg chg="mod topLvl">
          <ac:chgData name="Filippo Acconcia" userId="844af49c-a8a0-47ac-a7dd-14a44b60cd18" providerId="ADAL" clId="{4E01D738-D0C1-4B9B-B836-CF053EEC4C53}" dt="2022-03-16T10:48:48.519" v="1246" actId="164"/>
          <ac:cxnSpMkLst>
            <pc:docMk/>
            <pc:sldMk cId="2336920806" sldId="303"/>
            <ac:cxnSpMk id="390" creationId="{C7D4D7EB-A9B0-4FCF-B532-E5FDA2E01E31}"/>
          </ac:cxnSpMkLst>
        </pc:cxnChg>
        <pc:cxnChg chg="mod topLvl">
          <ac:chgData name="Filippo Acconcia" userId="844af49c-a8a0-47ac-a7dd-14a44b60cd18" providerId="ADAL" clId="{4E01D738-D0C1-4B9B-B836-CF053EEC4C53}" dt="2022-03-16T10:48:48.519" v="1246" actId="164"/>
          <ac:cxnSpMkLst>
            <pc:docMk/>
            <pc:sldMk cId="2336920806" sldId="303"/>
            <ac:cxnSpMk id="391" creationId="{702C9B1D-F48F-4807-B10D-902AC60CF86B}"/>
          </ac:cxnSpMkLst>
        </pc:cxnChg>
        <pc:cxnChg chg="mod topLvl">
          <ac:chgData name="Filippo Acconcia" userId="844af49c-a8a0-47ac-a7dd-14a44b60cd18" providerId="ADAL" clId="{4E01D738-D0C1-4B9B-B836-CF053EEC4C53}" dt="2022-03-16T10:48:48.519" v="1246" actId="164"/>
          <ac:cxnSpMkLst>
            <pc:docMk/>
            <pc:sldMk cId="2336920806" sldId="303"/>
            <ac:cxnSpMk id="392" creationId="{1A3759DB-0423-4EC9-AA08-C4FCB201D2E8}"/>
          </ac:cxnSpMkLst>
        </pc:cxnChg>
        <pc:cxnChg chg="mod topLvl">
          <ac:chgData name="Filippo Acconcia" userId="844af49c-a8a0-47ac-a7dd-14a44b60cd18" providerId="ADAL" clId="{4E01D738-D0C1-4B9B-B836-CF053EEC4C53}" dt="2022-03-16T10:48:44.497" v="1245" actId="164"/>
          <ac:cxnSpMkLst>
            <pc:docMk/>
            <pc:sldMk cId="2336920806" sldId="303"/>
            <ac:cxnSpMk id="430" creationId="{EE7BF5F5-393C-4EC0-824C-ED9FC3E6CC0B}"/>
          </ac:cxnSpMkLst>
        </pc:cxnChg>
        <pc:cxnChg chg="mod topLvl">
          <ac:chgData name="Filippo Acconcia" userId="844af49c-a8a0-47ac-a7dd-14a44b60cd18" providerId="ADAL" clId="{4E01D738-D0C1-4B9B-B836-CF053EEC4C53}" dt="2022-03-16T10:48:44.497" v="1245" actId="164"/>
          <ac:cxnSpMkLst>
            <pc:docMk/>
            <pc:sldMk cId="2336920806" sldId="303"/>
            <ac:cxnSpMk id="431" creationId="{53CAC964-B356-415F-A97A-A6F3D094B3AA}"/>
          </ac:cxnSpMkLst>
        </pc:cxnChg>
        <pc:cxnChg chg="mod topLvl">
          <ac:chgData name="Filippo Acconcia" userId="844af49c-a8a0-47ac-a7dd-14a44b60cd18" providerId="ADAL" clId="{4E01D738-D0C1-4B9B-B836-CF053EEC4C53}" dt="2022-03-16T10:48:44.497" v="1245" actId="164"/>
          <ac:cxnSpMkLst>
            <pc:docMk/>
            <pc:sldMk cId="2336920806" sldId="303"/>
            <ac:cxnSpMk id="432" creationId="{61C5E6D5-A1C1-478B-B230-CC0F28926142}"/>
          </ac:cxnSpMkLst>
        </pc:cxnChg>
        <pc:cxnChg chg="mod topLvl">
          <ac:chgData name="Filippo Acconcia" userId="844af49c-a8a0-47ac-a7dd-14a44b60cd18" providerId="ADAL" clId="{4E01D738-D0C1-4B9B-B836-CF053EEC4C53}" dt="2022-03-16T10:48:44.497" v="1245" actId="164"/>
          <ac:cxnSpMkLst>
            <pc:docMk/>
            <pc:sldMk cId="2336920806" sldId="303"/>
            <ac:cxnSpMk id="433" creationId="{8A2526DB-5DBC-44A5-B01D-46A397B85DAE}"/>
          </ac:cxnSpMkLst>
        </pc:cxnChg>
        <pc:cxnChg chg="mod topLvl">
          <ac:chgData name="Filippo Acconcia" userId="844af49c-a8a0-47ac-a7dd-14a44b60cd18" providerId="ADAL" clId="{4E01D738-D0C1-4B9B-B836-CF053EEC4C53}" dt="2022-03-16T10:48:44.497" v="1245" actId="164"/>
          <ac:cxnSpMkLst>
            <pc:docMk/>
            <pc:sldMk cId="2336920806" sldId="303"/>
            <ac:cxnSpMk id="434" creationId="{AE60F383-D25D-4B75-B71D-6987ACC73ED0}"/>
          </ac:cxnSpMkLst>
        </pc:cxnChg>
        <pc:cxnChg chg="mod topLvl">
          <ac:chgData name="Filippo Acconcia" userId="844af49c-a8a0-47ac-a7dd-14a44b60cd18" providerId="ADAL" clId="{4E01D738-D0C1-4B9B-B836-CF053EEC4C53}" dt="2022-03-16T10:53:09.412" v="1328" actId="164"/>
          <ac:cxnSpMkLst>
            <pc:docMk/>
            <pc:sldMk cId="2336920806" sldId="303"/>
            <ac:cxnSpMk id="476" creationId="{50BA3E54-FFA3-4F7B-BCE4-6383914CEEE6}"/>
          </ac:cxnSpMkLst>
        </pc:cxnChg>
        <pc:cxnChg chg="mod topLvl">
          <ac:chgData name="Filippo Acconcia" userId="844af49c-a8a0-47ac-a7dd-14a44b60cd18" providerId="ADAL" clId="{4E01D738-D0C1-4B9B-B836-CF053EEC4C53}" dt="2022-03-16T10:53:09.412" v="1328" actId="164"/>
          <ac:cxnSpMkLst>
            <pc:docMk/>
            <pc:sldMk cId="2336920806" sldId="303"/>
            <ac:cxnSpMk id="477" creationId="{AF352FAB-16A2-4F6C-9560-C5B63B8D0EEC}"/>
          </ac:cxnSpMkLst>
        </pc:cxnChg>
        <pc:cxnChg chg="mod topLvl">
          <ac:chgData name="Filippo Acconcia" userId="844af49c-a8a0-47ac-a7dd-14a44b60cd18" providerId="ADAL" clId="{4E01D738-D0C1-4B9B-B836-CF053EEC4C53}" dt="2022-03-16T10:53:09.412" v="1328" actId="164"/>
          <ac:cxnSpMkLst>
            <pc:docMk/>
            <pc:sldMk cId="2336920806" sldId="303"/>
            <ac:cxnSpMk id="478" creationId="{4B3EF7DA-BA81-4535-A6FF-671D787646AB}"/>
          </ac:cxnSpMkLst>
        </pc:cxnChg>
        <pc:cxnChg chg="mod topLvl">
          <ac:chgData name="Filippo Acconcia" userId="844af49c-a8a0-47ac-a7dd-14a44b60cd18" providerId="ADAL" clId="{4E01D738-D0C1-4B9B-B836-CF053EEC4C53}" dt="2022-03-16T10:53:09.412" v="1328" actId="164"/>
          <ac:cxnSpMkLst>
            <pc:docMk/>
            <pc:sldMk cId="2336920806" sldId="303"/>
            <ac:cxnSpMk id="479" creationId="{9E078874-DEA2-4DA8-A24E-CE1862B24A99}"/>
          </ac:cxnSpMkLst>
        </pc:cxnChg>
        <pc:cxnChg chg="mod topLvl">
          <ac:chgData name="Filippo Acconcia" userId="844af49c-a8a0-47ac-a7dd-14a44b60cd18" providerId="ADAL" clId="{4E01D738-D0C1-4B9B-B836-CF053EEC4C53}" dt="2022-03-16T10:53:09.412" v="1328" actId="164"/>
          <ac:cxnSpMkLst>
            <pc:docMk/>
            <pc:sldMk cId="2336920806" sldId="303"/>
            <ac:cxnSpMk id="480" creationId="{51F70B45-89F5-406C-9758-CEDBD3161E4E}"/>
          </ac:cxnSpMkLst>
        </pc:cxnChg>
        <pc:cxnChg chg="mod">
          <ac:chgData name="Filippo Acconcia" userId="844af49c-a8a0-47ac-a7dd-14a44b60cd18" providerId="ADAL" clId="{4E01D738-D0C1-4B9B-B836-CF053EEC4C53}" dt="2022-03-16T10:49:02.913" v="1247"/>
          <ac:cxnSpMkLst>
            <pc:docMk/>
            <pc:sldMk cId="2336920806" sldId="303"/>
            <ac:cxnSpMk id="518" creationId="{7AAC815C-0791-4C19-A4F8-1123BB83FDEC}"/>
          </ac:cxnSpMkLst>
        </pc:cxnChg>
        <pc:cxnChg chg="mod">
          <ac:chgData name="Filippo Acconcia" userId="844af49c-a8a0-47ac-a7dd-14a44b60cd18" providerId="ADAL" clId="{4E01D738-D0C1-4B9B-B836-CF053EEC4C53}" dt="2022-03-16T10:49:02.913" v="1247"/>
          <ac:cxnSpMkLst>
            <pc:docMk/>
            <pc:sldMk cId="2336920806" sldId="303"/>
            <ac:cxnSpMk id="519" creationId="{F952CDFD-176A-42E6-A297-00D50E86D3E4}"/>
          </ac:cxnSpMkLst>
        </pc:cxnChg>
        <pc:cxnChg chg="mod">
          <ac:chgData name="Filippo Acconcia" userId="844af49c-a8a0-47ac-a7dd-14a44b60cd18" providerId="ADAL" clId="{4E01D738-D0C1-4B9B-B836-CF053EEC4C53}" dt="2022-03-16T10:49:02.913" v="1247"/>
          <ac:cxnSpMkLst>
            <pc:docMk/>
            <pc:sldMk cId="2336920806" sldId="303"/>
            <ac:cxnSpMk id="520" creationId="{A164EE91-A474-4AA2-A884-BE1BE8DE565E}"/>
          </ac:cxnSpMkLst>
        </pc:cxnChg>
        <pc:cxnChg chg="mod">
          <ac:chgData name="Filippo Acconcia" userId="844af49c-a8a0-47ac-a7dd-14a44b60cd18" providerId="ADAL" clId="{4E01D738-D0C1-4B9B-B836-CF053EEC4C53}" dt="2022-03-16T10:49:02.913" v="1247"/>
          <ac:cxnSpMkLst>
            <pc:docMk/>
            <pc:sldMk cId="2336920806" sldId="303"/>
            <ac:cxnSpMk id="521" creationId="{C2DB6CE3-DEEC-4A13-9FBF-6AF1B67C4A25}"/>
          </ac:cxnSpMkLst>
        </pc:cxnChg>
        <pc:cxnChg chg="mod">
          <ac:chgData name="Filippo Acconcia" userId="844af49c-a8a0-47ac-a7dd-14a44b60cd18" providerId="ADAL" clId="{4E01D738-D0C1-4B9B-B836-CF053EEC4C53}" dt="2022-03-16T10:49:02.913" v="1247"/>
          <ac:cxnSpMkLst>
            <pc:docMk/>
            <pc:sldMk cId="2336920806" sldId="303"/>
            <ac:cxnSpMk id="522" creationId="{923234BB-B326-48E0-A895-B75F72788C74}"/>
          </ac:cxnSpMkLst>
        </pc:cxnChg>
        <pc:cxnChg chg="mod">
          <ac:chgData name="Filippo Acconcia" userId="844af49c-a8a0-47ac-a7dd-14a44b60cd18" providerId="ADAL" clId="{4E01D738-D0C1-4B9B-B836-CF053EEC4C53}" dt="2022-03-16T10:49:59.150" v="1262"/>
          <ac:cxnSpMkLst>
            <pc:docMk/>
            <pc:sldMk cId="2336920806" sldId="303"/>
            <ac:cxnSpMk id="560" creationId="{695CBC19-3758-40E4-88A9-564FB27715B3}"/>
          </ac:cxnSpMkLst>
        </pc:cxnChg>
        <pc:cxnChg chg="mod">
          <ac:chgData name="Filippo Acconcia" userId="844af49c-a8a0-47ac-a7dd-14a44b60cd18" providerId="ADAL" clId="{4E01D738-D0C1-4B9B-B836-CF053EEC4C53}" dt="2022-03-16T10:49:59.150" v="1262"/>
          <ac:cxnSpMkLst>
            <pc:docMk/>
            <pc:sldMk cId="2336920806" sldId="303"/>
            <ac:cxnSpMk id="561" creationId="{13EDDE6F-6D49-4B80-A36E-D86AE4433E29}"/>
          </ac:cxnSpMkLst>
        </pc:cxnChg>
        <pc:cxnChg chg="mod">
          <ac:chgData name="Filippo Acconcia" userId="844af49c-a8a0-47ac-a7dd-14a44b60cd18" providerId="ADAL" clId="{4E01D738-D0C1-4B9B-B836-CF053EEC4C53}" dt="2022-03-16T10:49:59.150" v="1262"/>
          <ac:cxnSpMkLst>
            <pc:docMk/>
            <pc:sldMk cId="2336920806" sldId="303"/>
            <ac:cxnSpMk id="562" creationId="{46A9F44E-F48D-4E30-A06F-A4370E73890B}"/>
          </ac:cxnSpMkLst>
        </pc:cxnChg>
        <pc:cxnChg chg="mod">
          <ac:chgData name="Filippo Acconcia" userId="844af49c-a8a0-47ac-a7dd-14a44b60cd18" providerId="ADAL" clId="{4E01D738-D0C1-4B9B-B836-CF053EEC4C53}" dt="2022-03-16T10:49:59.150" v="1262"/>
          <ac:cxnSpMkLst>
            <pc:docMk/>
            <pc:sldMk cId="2336920806" sldId="303"/>
            <ac:cxnSpMk id="563" creationId="{4C6C5311-4A4F-4114-9D92-28B1A33C3B98}"/>
          </ac:cxnSpMkLst>
        </pc:cxnChg>
        <pc:cxnChg chg="mod">
          <ac:chgData name="Filippo Acconcia" userId="844af49c-a8a0-47ac-a7dd-14a44b60cd18" providerId="ADAL" clId="{4E01D738-D0C1-4B9B-B836-CF053EEC4C53}" dt="2022-03-16T10:49:59.150" v="1262"/>
          <ac:cxnSpMkLst>
            <pc:docMk/>
            <pc:sldMk cId="2336920806" sldId="303"/>
            <ac:cxnSpMk id="564" creationId="{8AE819F3-87B2-49DD-B0AF-870683B83FDC}"/>
          </ac:cxnSpMkLst>
        </pc:cxnChg>
        <pc:cxnChg chg="add mod">
          <ac:chgData name="Filippo Acconcia" userId="844af49c-a8a0-47ac-a7dd-14a44b60cd18" providerId="ADAL" clId="{4E01D738-D0C1-4B9B-B836-CF053EEC4C53}" dt="2022-03-16T10:53:05.724" v="1327" actId="164"/>
          <ac:cxnSpMkLst>
            <pc:docMk/>
            <pc:sldMk cId="2336920806" sldId="303"/>
            <ac:cxnSpMk id="622" creationId="{123C3D2B-C884-4616-A938-FE42AD9CA9DA}"/>
          </ac:cxnSpMkLst>
        </pc:cxnChg>
        <pc:cxnChg chg="add mod">
          <ac:chgData name="Filippo Acconcia" userId="844af49c-a8a0-47ac-a7dd-14a44b60cd18" providerId="ADAL" clId="{4E01D738-D0C1-4B9B-B836-CF053EEC4C53}" dt="2022-03-16T10:53:05.724" v="1327" actId="164"/>
          <ac:cxnSpMkLst>
            <pc:docMk/>
            <pc:sldMk cId="2336920806" sldId="303"/>
            <ac:cxnSpMk id="623" creationId="{82D29C80-328F-46B5-9293-A8972F2C9590}"/>
          </ac:cxnSpMkLst>
        </pc:cxnChg>
        <pc:cxnChg chg="add mod">
          <ac:chgData name="Filippo Acconcia" userId="844af49c-a8a0-47ac-a7dd-14a44b60cd18" providerId="ADAL" clId="{4E01D738-D0C1-4B9B-B836-CF053EEC4C53}" dt="2022-03-16T10:53:05.724" v="1327" actId="164"/>
          <ac:cxnSpMkLst>
            <pc:docMk/>
            <pc:sldMk cId="2336920806" sldId="303"/>
            <ac:cxnSpMk id="624" creationId="{CC583077-452A-4EC3-90E2-5CBCE4E20905}"/>
          </ac:cxnSpMkLst>
        </pc:cxnChg>
        <pc:cxnChg chg="add mod">
          <ac:chgData name="Filippo Acconcia" userId="844af49c-a8a0-47ac-a7dd-14a44b60cd18" providerId="ADAL" clId="{4E01D738-D0C1-4B9B-B836-CF053EEC4C53}" dt="2022-03-16T10:53:05.724" v="1327" actId="164"/>
          <ac:cxnSpMkLst>
            <pc:docMk/>
            <pc:sldMk cId="2336920806" sldId="303"/>
            <ac:cxnSpMk id="625" creationId="{BBA2B35C-561D-4AAF-96C1-DC8EE3732761}"/>
          </ac:cxnSpMkLst>
        </pc:cxnChg>
        <pc:cxnChg chg="add mod">
          <ac:chgData name="Filippo Acconcia" userId="844af49c-a8a0-47ac-a7dd-14a44b60cd18" providerId="ADAL" clId="{4E01D738-D0C1-4B9B-B836-CF053EEC4C53}" dt="2022-03-16T10:53:05.724" v="1327" actId="164"/>
          <ac:cxnSpMkLst>
            <pc:docMk/>
            <pc:sldMk cId="2336920806" sldId="303"/>
            <ac:cxnSpMk id="626" creationId="{44FC66C1-DD1B-47B2-8B2E-831FA2A0BC9B}"/>
          </ac:cxnSpMkLst>
        </pc:cxnChg>
      </pc:sldChg>
    </pc:docChg>
  </pc:docChgLst>
  <pc:docChgLst>
    <pc:chgData name="Filippo Acconcia" userId="844af49c-a8a0-47ac-a7dd-14a44b60cd18" providerId="ADAL" clId="{150EEF2B-F101-4710-9E96-E006CC520A49}"/>
    <pc:docChg chg="custSel modSld">
      <pc:chgData name="Filippo Acconcia" userId="844af49c-a8a0-47ac-a7dd-14a44b60cd18" providerId="ADAL" clId="{150EEF2B-F101-4710-9E96-E006CC520A49}" dt="2022-03-25T14:34:54.808" v="53" actId="164"/>
      <pc:docMkLst>
        <pc:docMk/>
      </pc:docMkLst>
      <pc:sldChg chg="addSp delSp modSp mod">
        <pc:chgData name="Filippo Acconcia" userId="844af49c-a8a0-47ac-a7dd-14a44b60cd18" providerId="ADAL" clId="{150EEF2B-F101-4710-9E96-E006CC520A49}" dt="2022-03-25T14:34:54.808" v="53" actId="164"/>
        <pc:sldMkLst>
          <pc:docMk/>
          <pc:sldMk cId="3001700615" sldId="298"/>
        </pc:sldMkLst>
        <pc:spChg chg="add mod">
          <ac:chgData name="Filippo Acconcia" userId="844af49c-a8a0-47ac-a7dd-14a44b60cd18" providerId="ADAL" clId="{150EEF2B-F101-4710-9E96-E006CC520A49}" dt="2022-03-25T14:32:31.641" v="4" actId="552"/>
          <ac:spMkLst>
            <pc:docMk/>
            <pc:sldMk cId="3001700615" sldId="298"/>
            <ac:spMk id="46" creationId="{3239AF68-BABB-4804-8FAB-4F3CFD20645D}"/>
          </ac:spMkLst>
        </pc:spChg>
        <pc:spChg chg="add mod">
          <ac:chgData name="Filippo Acconcia" userId="844af49c-a8a0-47ac-a7dd-14a44b60cd18" providerId="ADAL" clId="{150EEF2B-F101-4710-9E96-E006CC520A49}" dt="2022-03-25T14:32:34.854" v="5" actId="20577"/>
          <ac:spMkLst>
            <pc:docMk/>
            <pc:sldMk cId="3001700615" sldId="298"/>
            <ac:spMk id="47" creationId="{84C56A7A-234D-4670-9995-6891F80F57E4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50" creationId="{0D9123A6-2604-4E78-80F9-33318D64F0DF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51" creationId="{E6D10DA9-E555-4D00-AC51-C418639FBD73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52" creationId="{ED222277-AC07-4FB6-938A-F8D357BBBD36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53" creationId="{D497125B-9EE0-4606-88EB-609D9C877697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54" creationId="{A149D3B5-9700-45A6-91E8-D1E2321BDB96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55" creationId="{75AB659F-8B81-4354-9FAC-080101F73202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56" creationId="{FA5774F4-54FC-4198-AC67-0C73BF8176E6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57" creationId="{9DBFB691-7021-4586-8B14-646EA6A143D6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58" creationId="{270BC580-3D4F-4B2A-80B8-F5BBADEE946E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59" creationId="{CB67D566-FBE0-401B-8C99-57E06F9AFA5B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60" creationId="{8CAB06D6-3B21-4AB2-AAC0-107176F489D8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61" creationId="{5205EFAE-E9E1-4C1A-9B58-C07D7A51DB8A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62" creationId="{2562ACCA-5B7A-4072-89D7-39C595075DE7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63" creationId="{5D62DE79-66AD-468E-82CF-11674D1A785B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64" creationId="{525F43D1-9830-4D26-A848-A4CEE8A334DF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65" creationId="{D0B3E319-4CE1-481A-8B30-C6BE3D50267B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66" creationId="{6AC80800-346A-4F36-B149-00C204A5D1C0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67" creationId="{1B134E7E-BFAB-4E8C-8FBD-EF2EAAAC5013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68" creationId="{D7C01DF0-A465-4EF3-A916-B9C642144625}"/>
          </ac:spMkLst>
        </pc:spChg>
        <pc:spChg chg="mod">
          <ac:chgData name="Filippo Acconcia" userId="844af49c-a8a0-47ac-a7dd-14a44b60cd18" providerId="ADAL" clId="{150EEF2B-F101-4710-9E96-E006CC520A49}" dt="2022-03-25T14:32:41.168" v="6"/>
          <ac:spMkLst>
            <pc:docMk/>
            <pc:sldMk cId="3001700615" sldId="298"/>
            <ac:spMk id="71" creationId="{CB474ACB-2FC3-4E60-8415-E9514DD114AF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74" creationId="{66E5EA75-789F-44DA-A606-F48A8DF3B618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75" creationId="{58DEEFD9-9638-4B86-9A3C-54E3AAFEF289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76" creationId="{73407D47-DD19-4F6B-94DE-D4FE511769D8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77" creationId="{E6CF104B-8514-4A5A-9CD1-44D2A0FDE6C4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78" creationId="{0CE749DD-B3FF-4017-B87C-D60BF4794C78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79" creationId="{0C140D7B-6A17-4902-AD1F-C357E85AEBDD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80" creationId="{80D56B8D-0944-474B-8452-9CFBE9C600D0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81" creationId="{C2642F9F-AAC8-48B6-A8E4-A4421B147BBB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82" creationId="{A9B01F9A-2620-4343-9482-32E1990C2A53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83" creationId="{76F84FBB-F0AC-40EA-A5E0-22BD4F8E414E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84" creationId="{A06E8819-677A-4FE1-8091-089D6D3CCC47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85" creationId="{8CBACDB8-4CE2-4B0F-B678-B39B896F1ADA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86" creationId="{5976CA0E-8EA0-42C1-8396-C84D1A91B0FA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87" creationId="{DF09C1CA-79BD-4C86-AA2A-92D98B6CD704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88" creationId="{C5F5303C-6387-4D0D-9D8C-C75047D56428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89" creationId="{EA0A3166-59C2-45D3-BE2E-9E607CC63CBD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90" creationId="{9636923C-08F8-48E4-A3BA-DCCC34984681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91" creationId="{A89EAD94-EA3E-4310-9929-E93659FEE77B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97" creationId="{4DCA52F1-8929-43F4-9DBF-F642991E7AC7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98" creationId="{906A75C1-A3A5-4529-A246-4750123D92CD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99" creationId="{C5817DE7-36A5-4C2F-A988-640F0EDE2984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100" creationId="{C627B271-F6AD-4BBC-BB2D-735B022DB8EF}"/>
          </ac:spMkLst>
        </pc:spChg>
        <pc:spChg chg="mod topLvl">
          <ac:chgData name="Filippo Acconcia" userId="844af49c-a8a0-47ac-a7dd-14a44b60cd18" providerId="ADAL" clId="{150EEF2B-F101-4710-9E96-E006CC520A49}" dt="2022-03-25T14:34:54.808" v="53" actId="164"/>
          <ac:spMkLst>
            <pc:docMk/>
            <pc:sldMk cId="3001700615" sldId="298"/>
            <ac:spMk id="102" creationId="{E7C23C89-4993-4960-9A0B-AD8A120AC538}"/>
          </ac:spMkLst>
        </pc:spChg>
        <pc:spChg chg="del mod topLvl">
          <ac:chgData name="Filippo Acconcia" userId="844af49c-a8a0-47ac-a7dd-14a44b60cd18" providerId="ADAL" clId="{150EEF2B-F101-4710-9E96-E006CC520A49}" dt="2022-03-25T14:33:58.323" v="18" actId="478"/>
          <ac:spMkLst>
            <pc:docMk/>
            <pc:sldMk cId="3001700615" sldId="298"/>
            <ac:spMk id="103" creationId="{741FBC0B-FE58-491E-856E-C3C5C14040F1}"/>
          </ac:spMkLst>
        </pc:spChg>
        <pc:spChg chg="del mod topLvl">
          <ac:chgData name="Filippo Acconcia" userId="844af49c-a8a0-47ac-a7dd-14a44b60cd18" providerId="ADAL" clId="{150EEF2B-F101-4710-9E96-E006CC520A49}" dt="2022-03-25T14:33:58.323" v="18" actId="478"/>
          <ac:spMkLst>
            <pc:docMk/>
            <pc:sldMk cId="3001700615" sldId="298"/>
            <ac:spMk id="104" creationId="{4AF48A45-60BD-4657-8308-5B01B92D0D24}"/>
          </ac:spMkLst>
        </pc:spChg>
        <pc:spChg chg="del mod topLvl">
          <ac:chgData name="Filippo Acconcia" userId="844af49c-a8a0-47ac-a7dd-14a44b60cd18" providerId="ADAL" clId="{150EEF2B-F101-4710-9E96-E006CC520A49}" dt="2022-03-25T14:33:58.323" v="18" actId="478"/>
          <ac:spMkLst>
            <pc:docMk/>
            <pc:sldMk cId="3001700615" sldId="298"/>
            <ac:spMk id="105" creationId="{B9E39F10-8992-4026-A09C-FBAEB53E99C9}"/>
          </ac:spMkLst>
        </pc:spChg>
        <pc:spChg chg="del mod topLvl">
          <ac:chgData name="Filippo Acconcia" userId="844af49c-a8a0-47ac-a7dd-14a44b60cd18" providerId="ADAL" clId="{150EEF2B-F101-4710-9E96-E006CC520A49}" dt="2022-03-25T14:33:58.323" v="18" actId="478"/>
          <ac:spMkLst>
            <pc:docMk/>
            <pc:sldMk cId="3001700615" sldId="298"/>
            <ac:spMk id="106" creationId="{6DC62776-3A67-4E52-AB22-AFABDD625E90}"/>
          </ac:spMkLst>
        </pc:spChg>
        <pc:spChg chg="del mod topLvl">
          <ac:chgData name="Filippo Acconcia" userId="844af49c-a8a0-47ac-a7dd-14a44b60cd18" providerId="ADAL" clId="{150EEF2B-F101-4710-9E96-E006CC520A49}" dt="2022-03-25T14:33:58.323" v="18" actId="478"/>
          <ac:spMkLst>
            <pc:docMk/>
            <pc:sldMk cId="3001700615" sldId="298"/>
            <ac:spMk id="107" creationId="{65001B4C-E990-4B67-AC87-B0344ECE49BE}"/>
          </ac:spMkLst>
        </pc:spChg>
        <pc:spChg chg="del mod topLvl">
          <ac:chgData name="Filippo Acconcia" userId="844af49c-a8a0-47ac-a7dd-14a44b60cd18" providerId="ADAL" clId="{150EEF2B-F101-4710-9E96-E006CC520A49}" dt="2022-03-25T14:33:58.323" v="18" actId="478"/>
          <ac:spMkLst>
            <pc:docMk/>
            <pc:sldMk cId="3001700615" sldId="298"/>
            <ac:spMk id="108" creationId="{0CA9D9F8-6C51-4E8C-AC8C-2C5B6DF64C71}"/>
          </ac:spMkLst>
        </pc:spChg>
        <pc:grpChg chg="add del mod">
          <ac:chgData name="Filippo Acconcia" userId="844af49c-a8a0-47ac-a7dd-14a44b60cd18" providerId="ADAL" clId="{150EEF2B-F101-4710-9E96-E006CC520A49}" dt="2022-03-25T14:32:52.923" v="8" actId="478"/>
          <ac:grpSpMkLst>
            <pc:docMk/>
            <pc:sldMk cId="3001700615" sldId="298"/>
            <ac:grpSpMk id="48" creationId="{4124C106-BE23-458A-AB01-4D3D456A13EB}"/>
          </ac:grpSpMkLst>
        </pc:grpChg>
        <pc:grpChg chg="add del mod">
          <ac:chgData name="Filippo Acconcia" userId="844af49c-a8a0-47ac-a7dd-14a44b60cd18" providerId="ADAL" clId="{150EEF2B-F101-4710-9E96-E006CC520A49}" dt="2022-03-25T14:33:32.105" v="12" actId="165"/>
          <ac:grpSpMkLst>
            <pc:docMk/>
            <pc:sldMk cId="3001700615" sldId="298"/>
            <ac:grpSpMk id="72" creationId="{870A6ED4-D73C-4FA3-A185-6CAF2F8790C1}"/>
          </ac:grpSpMkLst>
        </pc:grpChg>
        <pc:grpChg chg="add mod">
          <ac:chgData name="Filippo Acconcia" userId="844af49c-a8a0-47ac-a7dd-14a44b60cd18" providerId="ADAL" clId="{150EEF2B-F101-4710-9E96-E006CC520A49}" dt="2022-03-25T14:34:54.808" v="53" actId="164"/>
          <ac:grpSpMkLst>
            <pc:docMk/>
            <pc:sldMk cId="3001700615" sldId="298"/>
            <ac:grpSpMk id="110" creationId="{52F64382-DAB4-4411-B0B8-132B66C1D63C}"/>
          </ac:grpSpMkLst>
        </pc:grpChg>
        <pc:picChg chg="mod">
          <ac:chgData name="Filippo Acconcia" userId="844af49c-a8a0-47ac-a7dd-14a44b60cd18" providerId="ADAL" clId="{150EEF2B-F101-4710-9E96-E006CC520A49}" dt="2022-03-25T14:32:41.168" v="6"/>
          <ac:picMkLst>
            <pc:docMk/>
            <pc:sldMk cId="3001700615" sldId="298"/>
            <ac:picMk id="49" creationId="{32492AA1-4A78-402F-9CD0-59C054641A54}"/>
          </ac:picMkLst>
        </pc:picChg>
        <pc:picChg chg="del mod topLvl">
          <ac:chgData name="Filippo Acconcia" userId="844af49c-a8a0-47ac-a7dd-14a44b60cd18" providerId="ADAL" clId="{150EEF2B-F101-4710-9E96-E006CC520A49}" dt="2022-03-25T14:33:55.074" v="17" actId="478"/>
          <ac:picMkLst>
            <pc:docMk/>
            <pc:sldMk cId="3001700615" sldId="298"/>
            <ac:picMk id="73" creationId="{30EDCA9B-C19E-462F-A92A-643A08CBA527}"/>
          </ac:picMkLst>
        </pc:picChg>
        <pc:picChg chg="mod ord">
          <ac:chgData name="Filippo Acconcia" userId="844af49c-a8a0-47ac-a7dd-14a44b60cd18" providerId="ADAL" clId="{150EEF2B-F101-4710-9E96-E006CC520A49}" dt="2022-03-25T14:34:54.808" v="53" actId="164"/>
          <ac:picMkLst>
            <pc:docMk/>
            <pc:sldMk cId="3001700615" sldId="298"/>
            <ac:picMk id="109" creationId="{1CE12982-2905-4F31-B32C-6905352D4A1C}"/>
          </ac:picMkLst>
        </pc:picChg>
        <pc:cxnChg chg="mod">
          <ac:chgData name="Filippo Acconcia" userId="844af49c-a8a0-47ac-a7dd-14a44b60cd18" providerId="ADAL" clId="{150EEF2B-F101-4710-9E96-E006CC520A49}" dt="2022-03-25T14:32:41.168" v="6"/>
          <ac:cxnSpMkLst>
            <pc:docMk/>
            <pc:sldMk cId="3001700615" sldId="298"/>
            <ac:cxnSpMk id="69" creationId="{450B773A-090A-4D66-833A-EEED958D976D}"/>
          </ac:cxnSpMkLst>
        </pc:cxnChg>
        <pc:cxnChg chg="mod">
          <ac:chgData name="Filippo Acconcia" userId="844af49c-a8a0-47ac-a7dd-14a44b60cd18" providerId="ADAL" clId="{150EEF2B-F101-4710-9E96-E006CC520A49}" dt="2022-03-25T14:32:41.168" v="6"/>
          <ac:cxnSpMkLst>
            <pc:docMk/>
            <pc:sldMk cId="3001700615" sldId="298"/>
            <ac:cxnSpMk id="70" creationId="{0F29A3D8-4D82-44C9-B72A-5A9A19453DAA}"/>
          </ac:cxnSpMkLst>
        </pc:cxnChg>
        <pc:cxnChg chg="mod topLvl">
          <ac:chgData name="Filippo Acconcia" userId="844af49c-a8a0-47ac-a7dd-14a44b60cd18" providerId="ADAL" clId="{150EEF2B-F101-4710-9E96-E006CC520A49}" dt="2022-03-25T14:34:54.808" v="53" actId="164"/>
          <ac:cxnSpMkLst>
            <pc:docMk/>
            <pc:sldMk cId="3001700615" sldId="298"/>
            <ac:cxnSpMk id="92" creationId="{347A344C-08A7-493F-A3E5-7B12D1BB1863}"/>
          </ac:cxnSpMkLst>
        </pc:cxnChg>
        <pc:cxnChg chg="mod topLvl">
          <ac:chgData name="Filippo Acconcia" userId="844af49c-a8a0-47ac-a7dd-14a44b60cd18" providerId="ADAL" clId="{150EEF2B-F101-4710-9E96-E006CC520A49}" dt="2022-03-25T14:34:54.808" v="53" actId="164"/>
          <ac:cxnSpMkLst>
            <pc:docMk/>
            <pc:sldMk cId="3001700615" sldId="298"/>
            <ac:cxnSpMk id="93" creationId="{3C7E4B96-BBAB-4B48-9C66-DFF89688F1E3}"/>
          </ac:cxnSpMkLst>
        </pc:cxnChg>
        <pc:cxnChg chg="mod topLvl">
          <ac:chgData name="Filippo Acconcia" userId="844af49c-a8a0-47ac-a7dd-14a44b60cd18" providerId="ADAL" clId="{150EEF2B-F101-4710-9E96-E006CC520A49}" dt="2022-03-25T14:34:54.808" v="53" actId="164"/>
          <ac:cxnSpMkLst>
            <pc:docMk/>
            <pc:sldMk cId="3001700615" sldId="298"/>
            <ac:cxnSpMk id="94" creationId="{A276E73B-0469-49E4-BDFF-9DEA1492D74B}"/>
          </ac:cxnSpMkLst>
        </pc:cxnChg>
        <pc:cxnChg chg="mod topLvl">
          <ac:chgData name="Filippo Acconcia" userId="844af49c-a8a0-47ac-a7dd-14a44b60cd18" providerId="ADAL" clId="{150EEF2B-F101-4710-9E96-E006CC520A49}" dt="2022-03-25T14:34:54.808" v="53" actId="164"/>
          <ac:cxnSpMkLst>
            <pc:docMk/>
            <pc:sldMk cId="3001700615" sldId="298"/>
            <ac:cxnSpMk id="95" creationId="{835C1C3A-AE6A-48C9-B908-605A5EE83C44}"/>
          </ac:cxnSpMkLst>
        </pc:cxnChg>
        <pc:cxnChg chg="mod topLvl">
          <ac:chgData name="Filippo Acconcia" userId="844af49c-a8a0-47ac-a7dd-14a44b60cd18" providerId="ADAL" clId="{150EEF2B-F101-4710-9E96-E006CC520A49}" dt="2022-03-25T14:34:54.808" v="53" actId="164"/>
          <ac:cxnSpMkLst>
            <pc:docMk/>
            <pc:sldMk cId="3001700615" sldId="298"/>
            <ac:cxnSpMk id="96" creationId="{50EED91E-9483-41E3-BA3E-1CAF4B15268F}"/>
          </ac:cxnSpMkLst>
        </pc:cxnChg>
        <pc:cxnChg chg="mod topLvl">
          <ac:chgData name="Filippo Acconcia" userId="844af49c-a8a0-47ac-a7dd-14a44b60cd18" providerId="ADAL" clId="{150EEF2B-F101-4710-9E96-E006CC520A49}" dt="2022-03-25T14:34:54.808" v="53" actId="164"/>
          <ac:cxnSpMkLst>
            <pc:docMk/>
            <pc:sldMk cId="3001700615" sldId="298"/>
            <ac:cxnSpMk id="101" creationId="{D53E7E9B-58AC-410B-8277-561AD715F385}"/>
          </ac:cxnSpMkLst>
        </pc:cxnChg>
      </pc:sldChg>
    </pc:docChg>
  </pc:docChgLst>
  <pc:docChgLst>
    <pc:chgData name="Filippo Acconcia" userId="844af49c-a8a0-47ac-a7dd-14a44b60cd18" providerId="ADAL" clId="{7949F0C2-5A3C-4007-AB02-8E5EC7EE0ACB}"/>
    <pc:docChg chg="delSld modSld">
      <pc:chgData name="Filippo Acconcia" userId="844af49c-a8a0-47ac-a7dd-14a44b60cd18" providerId="ADAL" clId="{7949F0C2-5A3C-4007-AB02-8E5EC7EE0ACB}" dt="2022-01-11T10:58:41.591" v="2" actId="20577"/>
      <pc:docMkLst>
        <pc:docMk/>
      </pc:docMkLst>
      <pc:sldChg chg="del">
        <pc:chgData name="Filippo Acconcia" userId="844af49c-a8a0-47ac-a7dd-14a44b60cd18" providerId="ADAL" clId="{7949F0C2-5A3C-4007-AB02-8E5EC7EE0ACB}" dt="2022-01-11T10:58:33.783" v="0" actId="47"/>
        <pc:sldMkLst>
          <pc:docMk/>
          <pc:sldMk cId="1130090998" sldId="297"/>
        </pc:sldMkLst>
      </pc:sldChg>
      <pc:sldChg chg="modSp mod">
        <pc:chgData name="Filippo Acconcia" userId="844af49c-a8a0-47ac-a7dd-14a44b60cd18" providerId="ADAL" clId="{7949F0C2-5A3C-4007-AB02-8E5EC7EE0ACB}" dt="2022-01-11T10:58:37.456" v="1" actId="20577"/>
        <pc:sldMkLst>
          <pc:docMk/>
          <pc:sldMk cId="3001700615" sldId="298"/>
        </pc:sldMkLst>
        <pc:spChg chg="mod">
          <ac:chgData name="Filippo Acconcia" userId="844af49c-a8a0-47ac-a7dd-14a44b60cd18" providerId="ADAL" clId="{7949F0C2-5A3C-4007-AB02-8E5EC7EE0ACB}" dt="2022-01-11T10:58:37.456" v="1" actId="20577"/>
          <ac:spMkLst>
            <pc:docMk/>
            <pc:sldMk cId="3001700615" sldId="298"/>
            <ac:spMk id="45" creationId="{B7CA2A80-F075-4F0D-8B71-5B771835F488}"/>
          </ac:spMkLst>
        </pc:spChg>
      </pc:sldChg>
      <pc:sldChg chg="modSp mod">
        <pc:chgData name="Filippo Acconcia" userId="844af49c-a8a0-47ac-a7dd-14a44b60cd18" providerId="ADAL" clId="{7949F0C2-5A3C-4007-AB02-8E5EC7EE0ACB}" dt="2022-01-11T10:58:41.591" v="2" actId="20577"/>
        <pc:sldMkLst>
          <pc:docMk/>
          <pc:sldMk cId="2323114696" sldId="300"/>
        </pc:sldMkLst>
        <pc:spChg chg="mod">
          <ac:chgData name="Filippo Acconcia" userId="844af49c-a8a0-47ac-a7dd-14a44b60cd18" providerId="ADAL" clId="{7949F0C2-5A3C-4007-AB02-8E5EC7EE0ACB}" dt="2022-01-11T10:58:41.591" v="2" actId="20577"/>
          <ac:spMkLst>
            <pc:docMk/>
            <pc:sldMk cId="2323114696" sldId="300"/>
            <ac:spMk id="2" creationId="{2620E1D6-1454-4D26-AB5B-F9DAAD59DD8D}"/>
          </ac:spMkLst>
        </pc:spChg>
      </pc:sldChg>
    </pc:docChg>
  </pc:docChgLst>
  <pc:docChgLst>
    <pc:chgData name="Filippo Acconcia" userId="844af49c-a8a0-47ac-a7dd-14a44b60cd18" providerId="ADAL" clId="{06E26EB0-D0F3-495F-BCB0-A1C9FB9B622C}"/>
    <pc:docChg chg="custSel addSld delSld modSld sldOrd">
      <pc:chgData name="Filippo Acconcia" userId="844af49c-a8a0-47ac-a7dd-14a44b60cd18" providerId="ADAL" clId="{06E26EB0-D0F3-495F-BCB0-A1C9FB9B622C}" dt="2022-03-15T10:46:17.712" v="36" actId="20577"/>
      <pc:docMkLst>
        <pc:docMk/>
      </pc:docMkLst>
      <pc:sldChg chg="modSp mod ord">
        <pc:chgData name="Filippo Acconcia" userId="844af49c-a8a0-47ac-a7dd-14a44b60cd18" providerId="ADAL" clId="{06E26EB0-D0F3-495F-BCB0-A1C9FB9B622C}" dt="2022-03-15T10:46:07.106" v="33" actId="20577"/>
        <pc:sldMkLst>
          <pc:docMk/>
          <pc:sldMk cId="714323932" sldId="289"/>
        </pc:sldMkLst>
        <pc:spChg chg="mod">
          <ac:chgData name="Filippo Acconcia" userId="844af49c-a8a0-47ac-a7dd-14a44b60cd18" providerId="ADAL" clId="{06E26EB0-D0F3-495F-BCB0-A1C9FB9B622C}" dt="2022-03-15T10:46:07.106" v="33" actId="20577"/>
          <ac:spMkLst>
            <pc:docMk/>
            <pc:sldMk cId="714323932" sldId="289"/>
            <ac:spMk id="2" creationId="{679DF6DD-401B-4B6E-8DD9-2162C4739EFA}"/>
          </ac:spMkLst>
        </pc:spChg>
      </pc:sldChg>
      <pc:sldChg chg="modSp mod">
        <pc:chgData name="Filippo Acconcia" userId="844af49c-a8a0-47ac-a7dd-14a44b60cd18" providerId="ADAL" clId="{06E26EB0-D0F3-495F-BCB0-A1C9FB9B622C}" dt="2022-03-15T10:46:10.578" v="34" actId="20577"/>
        <pc:sldMkLst>
          <pc:docMk/>
          <pc:sldMk cId="908504430" sldId="293"/>
        </pc:sldMkLst>
        <pc:spChg chg="mod">
          <ac:chgData name="Filippo Acconcia" userId="844af49c-a8a0-47ac-a7dd-14a44b60cd18" providerId="ADAL" clId="{06E26EB0-D0F3-495F-BCB0-A1C9FB9B622C}" dt="2022-03-15T10:46:10.578" v="34" actId="20577"/>
          <ac:spMkLst>
            <pc:docMk/>
            <pc:sldMk cId="908504430" sldId="293"/>
            <ac:spMk id="2" creationId="{BDE97044-5372-40C5-B7AD-11D4719AAEB5}"/>
          </ac:spMkLst>
        </pc:spChg>
      </pc:sldChg>
      <pc:sldChg chg="modSp mod">
        <pc:chgData name="Filippo Acconcia" userId="844af49c-a8a0-47ac-a7dd-14a44b60cd18" providerId="ADAL" clId="{06E26EB0-D0F3-495F-BCB0-A1C9FB9B622C}" dt="2022-03-15T10:46:13.993" v="35" actId="20577"/>
        <pc:sldMkLst>
          <pc:docMk/>
          <pc:sldMk cId="3001700615" sldId="298"/>
        </pc:sldMkLst>
        <pc:spChg chg="mod">
          <ac:chgData name="Filippo Acconcia" userId="844af49c-a8a0-47ac-a7dd-14a44b60cd18" providerId="ADAL" clId="{06E26EB0-D0F3-495F-BCB0-A1C9FB9B622C}" dt="2022-03-15T10:46:13.993" v="35" actId="20577"/>
          <ac:spMkLst>
            <pc:docMk/>
            <pc:sldMk cId="3001700615" sldId="298"/>
            <ac:spMk id="45" creationId="{B7CA2A80-F075-4F0D-8B71-5B771835F488}"/>
          </ac:spMkLst>
        </pc:spChg>
      </pc:sldChg>
      <pc:sldChg chg="modSp mod">
        <pc:chgData name="Filippo Acconcia" userId="844af49c-a8a0-47ac-a7dd-14a44b60cd18" providerId="ADAL" clId="{06E26EB0-D0F3-495F-BCB0-A1C9FB9B622C}" dt="2022-03-15T10:46:17.712" v="36" actId="20577"/>
        <pc:sldMkLst>
          <pc:docMk/>
          <pc:sldMk cId="2323114696" sldId="300"/>
        </pc:sldMkLst>
        <pc:spChg chg="mod">
          <ac:chgData name="Filippo Acconcia" userId="844af49c-a8a0-47ac-a7dd-14a44b60cd18" providerId="ADAL" clId="{06E26EB0-D0F3-495F-BCB0-A1C9FB9B622C}" dt="2022-03-15T10:46:17.712" v="36" actId="20577"/>
          <ac:spMkLst>
            <pc:docMk/>
            <pc:sldMk cId="2323114696" sldId="300"/>
            <ac:spMk id="2" creationId="{2620E1D6-1454-4D26-AB5B-F9DAAD59DD8D}"/>
          </ac:spMkLst>
        </pc:spChg>
      </pc:sldChg>
      <pc:sldChg chg="addSp modSp new mod">
        <pc:chgData name="Filippo Acconcia" userId="844af49c-a8a0-47ac-a7dd-14a44b60cd18" providerId="ADAL" clId="{06E26EB0-D0F3-495F-BCB0-A1C9FB9B622C}" dt="2022-03-15T10:39:57.793" v="31" actId="1036"/>
        <pc:sldMkLst>
          <pc:docMk/>
          <pc:sldMk cId="2898367101" sldId="301"/>
        </pc:sldMkLst>
        <pc:spChg chg="add mod">
          <ac:chgData name="Filippo Acconcia" userId="844af49c-a8a0-47ac-a7dd-14a44b60cd18" providerId="ADAL" clId="{06E26EB0-D0F3-495F-BCB0-A1C9FB9B622C}" dt="2022-03-15T10:39:29.436" v="5"/>
          <ac:spMkLst>
            <pc:docMk/>
            <pc:sldMk cId="2898367101" sldId="301"/>
            <ac:spMk id="2" creationId="{DAB35C31-9602-411A-9DB7-3FA9A2FC4DA3}"/>
          </ac:spMkLst>
        </pc:spChg>
        <pc:spChg chg="add mod">
          <ac:chgData name="Filippo Acconcia" userId="844af49c-a8a0-47ac-a7dd-14a44b60cd18" providerId="ADAL" clId="{06E26EB0-D0F3-495F-BCB0-A1C9FB9B622C}" dt="2022-03-15T10:39:54.593" v="27" actId="554"/>
          <ac:spMkLst>
            <pc:docMk/>
            <pc:sldMk cId="2898367101" sldId="301"/>
            <ac:spMk id="3" creationId="{C87E7A78-E592-4730-A163-FBD8EE08EC99}"/>
          </ac:spMkLst>
        </pc:spChg>
        <pc:spChg chg="add mod">
          <ac:chgData name="Filippo Acconcia" userId="844af49c-a8a0-47ac-a7dd-14a44b60cd18" providerId="ADAL" clId="{06E26EB0-D0F3-495F-BCB0-A1C9FB9B622C}" dt="2022-03-15T10:39:54.593" v="27" actId="554"/>
          <ac:spMkLst>
            <pc:docMk/>
            <pc:sldMk cId="2898367101" sldId="301"/>
            <ac:spMk id="4" creationId="{6B669F2F-B6BB-4C1B-B4E9-2D96049267C9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7" creationId="{A6CFB1FB-CEA1-446F-8720-0ED65F5C01DB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8" creationId="{667CA5A5-8F46-4BE7-8E5C-9E4B12E1315B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9" creationId="{CF8213E8-AC24-4082-A195-B730BE476179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10" creationId="{61A97826-BF5C-41B3-AB5A-624C6D6ACD55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11" creationId="{711BA7E7-C148-45F6-B22A-505E34FC10F3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12" creationId="{C3E91E65-919E-4D76-B688-B29A3E82AC60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13" creationId="{6B16DE2B-2202-4D78-8926-917316068605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14" creationId="{A31ABAC8-7976-4D13-9C7C-5C5395C90379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15" creationId="{9CFE1552-07E5-470E-8EE9-729867A4D857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16" creationId="{D4818FDA-D96B-4896-B9A7-EDADF165D043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18" creationId="{D921EAD5-E3BA-4741-B728-5F79DA96D767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24" creationId="{8E1AE8B0-B44D-4740-8675-6C05D5BE6D6B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25" creationId="{29B3F150-3B67-41B2-AF28-5102129AE4E7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26" creationId="{8A9B2E0A-7802-4E14-86D9-47C5FF928DEB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27" creationId="{C2456C45-847D-4F89-8B8F-D7BA4CF0E286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28" creationId="{BCB925D4-B5EC-48BC-B109-8B91140B09AC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30" creationId="{AF3138E4-5C13-44E7-9DC1-B22B0BB906EA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33" creationId="{510A1B30-1DD8-4983-A787-004250A33F14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34" creationId="{6C627538-E8B5-4450-A5CE-51F8B62BCD15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35" creationId="{43C59D76-31D2-4A1C-9A7A-E4740AC1DF23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36" creationId="{CDC722C6-5466-4D8E-81F4-67A5E0C14CE1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37" creationId="{FF08A1A6-DC55-4626-8A6C-EC2B3BCCAC02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38" creationId="{721B1551-A194-4145-8B2F-2E5CECD2D4F2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39" creationId="{5D6F3B4F-3590-413F-B3A5-CA84E51AD1DD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40" creationId="{4A532B61-FFB3-41DE-8D54-E7F2F622C570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41" creationId="{5CD8059A-B870-440D-AB30-626FD90E6D3D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43" creationId="{3465F762-07CB-4082-B1A1-36927A8028C8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44" creationId="{51FE9AB2-1FD9-49D8-89AF-D5947D79FC5A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45" creationId="{77D0374E-8749-47DA-B4D5-5478C59B3832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46" creationId="{8A432CE0-6DC3-440C-A5B3-73B4273FFE84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47" creationId="{B69FBD55-79E4-48DF-A44E-6847D19E272B}"/>
          </ac:spMkLst>
        </pc:spChg>
        <pc:spChg chg="mod">
          <ac:chgData name="Filippo Acconcia" userId="844af49c-a8a0-47ac-a7dd-14a44b60cd18" providerId="ADAL" clId="{06E26EB0-D0F3-495F-BCB0-A1C9FB9B622C}" dt="2022-03-15T10:39:35.185" v="7"/>
          <ac:spMkLst>
            <pc:docMk/>
            <pc:sldMk cId="2898367101" sldId="301"/>
            <ac:spMk id="48" creationId="{174FAB72-E86C-4F7B-9F59-34E59EF1F9B2}"/>
          </ac:spMkLst>
        </pc:spChg>
        <pc:grpChg chg="add mod">
          <ac:chgData name="Filippo Acconcia" userId="844af49c-a8a0-47ac-a7dd-14a44b60cd18" providerId="ADAL" clId="{06E26EB0-D0F3-495F-BCB0-A1C9FB9B622C}" dt="2022-03-15T10:39:57.793" v="31" actId="1036"/>
          <ac:grpSpMkLst>
            <pc:docMk/>
            <pc:sldMk cId="2898367101" sldId="301"/>
            <ac:grpSpMk id="5" creationId="{F391EBCE-63E2-465B-B4A4-050910F9A744}"/>
          </ac:grpSpMkLst>
        </pc:grpChg>
        <pc:grpChg chg="mod">
          <ac:chgData name="Filippo Acconcia" userId="844af49c-a8a0-47ac-a7dd-14a44b60cd18" providerId="ADAL" clId="{06E26EB0-D0F3-495F-BCB0-A1C9FB9B622C}" dt="2022-03-15T10:39:35.185" v="7"/>
          <ac:grpSpMkLst>
            <pc:docMk/>
            <pc:sldMk cId="2898367101" sldId="301"/>
            <ac:grpSpMk id="6" creationId="{496BF7E1-96C0-4439-A81F-BA29EBF2C275}"/>
          </ac:grpSpMkLst>
        </pc:grpChg>
        <pc:grpChg chg="add mod">
          <ac:chgData name="Filippo Acconcia" userId="844af49c-a8a0-47ac-a7dd-14a44b60cd18" providerId="ADAL" clId="{06E26EB0-D0F3-495F-BCB0-A1C9FB9B622C}" dt="2022-03-15T10:39:57.793" v="31" actId="1036"/>
          <ac:grpSpMkLst>
            <pc:docMk/>
            <pc:sldMk cId="2898367101" sldId="301"/>
            <ac:grpSpMk id="29" creationId="{38D762EF-BC13-4003-B18A-1338D9885139}"/>
          </ac:grpSpMkLst>
        </pc:grpChg>
        <pc:grpChg chg="mod">
          <ac:chgData name="Filippo Acconcia" userId="844af49c-a8a0-47ac-a7dd-14a44b60cd18" providerId="ADAL" clId="{06E26EB0-D0F3-495F-BCB0-A1C9FB9B622C}" dt="2022-03-15T10:39:35.185" v="7"/>
          <ac:grpSpMkLst>
            <pc:docMk/>
            <pc:sldMk cId="2898367101" sldId="301"/>
            <ac:grpSpMk id="31" creationId="{310C19F4-CCFD-4EE1-A2FD-56A2BEBB3421}"/>
          </ac:grpSpMkLst>
        </pc:grpChg>
        <pc:picChg chg="mod">
          <ac:chgData name="Filippo Acconcia" userId="844af49c-a8a0-47ac-a7dd-14a44b60cd18" providerId="ADAL" clId="{06E26EB0-D0F3-495F-BCB0-A1C9FB9B622C}" dt="2022-03-15T10:39:35.185" v="7"/>
          <ac:picMkLst>
            <pc:docMk/>
            <pc:sldMk cId="2898367101" sldId="301"/>
            <ac:picMk id="19" creationId="{C98E9531-BC80-48E6-9E27-3ED569DA9511}"/>
          </ac:picMkLst>
        </pc:picChg>
        <pc:picChg chg="mod">
          <ac:chgData name="Filippo Acconcia" userId="844af49c-a8a0-47ac-a7dd-14a44b60cd18" providerId="ADAL" clId="{06E26EB0-D0F3-495F-BCB0-A1C9FB9B622C}" dt="2022-03-15T10:39:35.185" v="7"/>
          <ac:picMkLst>
            <pc:docMk/>
            <pc:sldMk cId="2898367101" sldId="301"/>
            <ac:picMk id="20" creationId="{C48509C1-B754-4373-AFC3-E9D6FB3C6C47}"/>
          </ac:picMkLst>
        </pc:picChg>
        <pc:picChg chg="mod">
          <ac:chgData name="Filippo Acconcia" userId="844af49c-a8a0-47ac-a7dd-14a44b60cd18" providerId="ADAL" clId="{06E26EB0-D0F3-495F-BCB0-A1C9FB9B622C}" dt="2022-03-15T10:39:35.185" v="7"/>
          <ac:picMkLst>
            <pc:docMk/>
            <pc:sldMk cId="2898367101" sldId="301"/>
            <ac:picMk id="21" creationId="{41C02666-9C15-4B6B-9F98-1F779AC8C451}"/>
          </ac:picMkLst>
        </pc:picChg>
        <pc:picChg chg="mod">
          <ac:chgData name="Filippo Acconcia" userId="844af49c-a8a0-47ac-a7dd-14a44b60cd18" providerId="ADAL" clId="{06E26EB0-D0F3-495F-BCB0-A1C9FB9B622C}" dt="2022-03-15T10:39:35.185" v="7"/>
          <ac:picMkLst>
            <pc:docMk/>
            <pc:sldMk cId="2898367101" sldId="301"/>
            <ac:picMk id="22" creationId="{684B9493-A379-45AC-946B-448073C0F22A}"/>
          </ac:picMkLst>
        </pc:picChg>
        <pc:picChg chg="mod">
          <ac:chgData name="Filippo Acconcia" userId="844af49c-a8a0-47ac-a7dd-14a44b60cd18" providerId="ADAL" clId="{06E26EB0-D0F3-495F-BCB0-A1C9FB9B622C}" dt="2022-03-15T10:39:35.185" v="7"/>
          <ac:picMkLst>
            <pc:docMk/>
            <pc:sldMk cId="2898367101" sldId="301"/>
            <ac:picMk id="23" creationId="{498E552A-220B-4B74-9E32-4CA1D1533BD1}"/>
          </ac:picMkLst>
        </pc:picChg>
        <pc:picChg chg="mod">
          <ac:chgData name="Filippo Acconcia" userId="844af49c-a8a0-47ac-a7dd-14a44b60cd18" providerId="ADAL" clId="{06E26EB0-D0F3-495F-BCB0-A1C9FB9B622C}" dt="2022-03-15T10:39:35.185" v="7"/>
          <ac:picMkLst>
            <pc:docMk/>
            <pc:sldMk cId="2898367101" sldId="301"/>
            <ac:picMk id="32" creationId="{E5D888AB-9BE9-499B-B43F-62A501F5C906}"/>
          </ac:picMkLst>
        </pc:picChg>
        <pc:picChg chg="mod">
          <ac:chgData name="Filippo Acconcia" userId="844af49c-a8a0-47ac-a7dd-14a44b60cd18" providerId="ADAL" clId="{06E26EB0-D0F3-495F-BCB0-A1C9FB9B622C}" dt="2022-03-15T10:39:35.185" v="7"/>
          <ac:picMkLst>
            <pc:docMk/>
            <pc:sldMk cId="2898367101" sldId="301"/>
            <ac:picMk id="49" creationId="{C09BC711-2BB5-45CD-B99A-6CE823EB3A0C}"/>
          </ac:picMkLst>
        </pc:picChg>
        <pc:picChg chg="mod">
          <ac:chgData name="Filippo Acconcia" userId="844af49c-a8a0-47ac-a7dd-14a44b60cd18" providerId="ADAL" clId="{06E26EB0-D0F3-495F-BCB0-A1C9FB9B622C}" dt="2022-03-15T10:39:35.185" v="7"/>
          <ac:picMkLst>
            <pc:docMk/>
            <pc:sldMk cId="2898367101" sldId="301"/>
            <ac:picMk id="50" creationId="{F6057446-2A62-41BB-8042-7E183F6C5CCB}"/>
          </ac:picMkLst>
        </pc:picChg>
        <pc:picChg chg="mod">
          <ac:chgData name="Filippo Acconcia" userId="844af49c-a8a0-47ac-a7dd-14a44b60cd18" providerId="ADAL" clId="{06E26EB0-D0F3-495F-BCB0-A1C9FB9B622C}" dt="2022-03-15T10:39:35.185" v="7"/>
          <ac:picMkLst>
            <pc:docMk/>
            <pc:sldMk cId="2898367101" sldId="301"/>
            <ac:picMk id="51" creationId="{9D4D3D04-4033-4E20-8424-1392AE10D438}"/>
          </ac:picMkLst>
        </pc:picChg>
        <pc:picChg chg="mod">
          <ac:chgData name="Filippo Acconcia" userId="844af49c-a8a0-47ac-a7dd-14a44b60cd18" providerId="ADAL" clId="{06E26EB0-D0F3-495F-BCB0-A1C9FB9B622C}" dt="2022-03-15T10:39:35.185" v="7"/>
          <ac:picMkLst>
            <pc:docMk/>
            <pc:sldMk cId="2898367101" sldId="301"/>
            <ac:picMk id="52" creationId="{E3052510-D8FB-41EE-82AF-A843C257DD28}"/>
          </ac:picMkLst>
        </pc:picChg>
        <pc:cxnChg chg="mod">
          <ac:chgData name="Filippo Acconcia" userId="844af49c-a8a0-47ac-a7dd-14a44b60cd18" providerId="ADAL" clId="{06E26EB0-D0F3-495F-BCB0-A1C9FB9B622C}" dt="2022-03-15T10:39:35.185" v="7"/>
          <ac:cxnSpMkLst>
            <pc:docMk/>
            <pc:sldMk cId="2898367101" sldId="301"/>
            <ac:cxnSpMk id="17" creationId="{3CB7FF21-2E30-4CBE-8382-6D649996640C}"/>
          </ac:cxnSpMkLst>
        </pc:cxnChg>
        <pc:cxnChg chg="mod">
          <ac:chgData name="Filippo Acconcia" userId="844af49c-a8a0-47ac-a7dd-14a44b60cd18" providerId="ADAL" clId="{06E26EB0-D0F3-495F-BCB0-A1C9FB9B622C}" dt="2022-03-15T10:39:35.185" v="7"/>
          <ac:cxnSpMkLst>
            <pc:docMk/>
            <pc:sldMk cId="2898367101" sldId="301"/>
            <ac:cxnSpMk id="42" creationId="{A14814C8-DDC2-42C7-8A4E-0FBAAFD8F9CA}"/>
          </ac:cxnSpMkLst>
        </pc:cxnChg>
      </pc:sldChg>
      <pc:sldChg chg="addSp delSp modSp new del mod">
        <pc:chgData name="Filippo Acconcia" userId="844af49c-a8a0-47ac-a7dd-14a44b60cd18" providerId="ADAL" clId="{06E26EB0-D0F3-495F-BCB0-A1C9FB9B622C}" dt="2022-03-15T10:46:04.439" v="32" actId="47"/>
        <pc:sldMkLst>
          <pc:docMk/>
          <pc:sldMk cId="856563846" sldId="302"/>
        </pc:sldMkLst>
        <pc:spChg chg="add del mod">
          <ac:chgData name="Filippo Acconcia" userId="844af49c-a8a0-47ac-a7dd-14a44b60cd18" providerId="ADAL" clId="{06E26EB0-D0F3-495F-BCB0-A1C9FB9B622C}" dt="2022-03-15T10:39:33.700" v="6" actId="21"/>
          <ac:spMkLst>
            <pc:docMk/>
            <pc:sldMk cId="856563846" sldId="302"/>
            <ac:spMk id="2" creationId="{3B756260-2A66-4FD0-8982-18442FCF2239}"/>
          </ac:spMkLst>
        </pc:spChg>
        <pc:spChg chg="add del mod">
          <ac:chgData name="Filippo Acconcia" userId="844af49c-a8a0-47ac-a7dd-14a44b60cd18" providerId="ADAL" clId="{06E26EB0-D0F3-495F-BCB0-A1C9FB9B622C}" dt="2022-03-15T10:39:33.700" v="6" actId="21"/>
          <ac:spMkLst>
            <pc:docMk/>
            <pc:sldMk cId="856563846" sldId="302"/>
            <ac:spMk id="3" creationId="{77B777B9-82B8-4159-A803-C7426695F6B6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6" creationId="{42C8F8CA-1CB3-400D-A93F-5A1EC8DF66E2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7" creationId="{BF1AF9D8-A867-4BC9-BED1-0AF110D6AE48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8" creationId="{A1C3D200-EA86-46A4-BD8D-79FF27C52E4F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9" creationId="{18298BE9-6712-4368-89D9-CDFA11057816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10" creationId="{9E100AB0-150B-465E-935D-321E48AB7F6A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11" creationId="{EFB60DCC-4970-4FE3-9408-61A5FCC6FF96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12" creationId="{690F7E50-9DC2-4BD9-AEE3-465E1A0D874B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13" creationId="{66C7F62D-5277-4B9C-9EBC-DF8812DFC5DE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14" creationId="{1CF9FB4B-5A8C-4312-80D0-12B80747797A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15" creationId="{00F2953D-62B1-46C8-A04B-C73F346EA6AD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17" creationId="{6D272553-FBA5-4679-A119-C7D9D69561F9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23" creationId="{0F64F5B4-FFAB-4F47-8671-93771C2C9F4E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24" creationId="{55B40D01-67D9-4E38-808B-A305DEF04E07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25" creationId="{270E3586-D9B0-473C-9474-771CC9334F28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26" creationId="{50073A30-BE23-455C-9050-757DB9F0D0A1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27" creationId="{EE3057E8-99AE-4D59-BAFA-E99AF7B35390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29" creationId="{99212CD0-5026-4636-9DFE-2FA89D7D251C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32" creationId="{8981246A-5EDE-473C-BBB7-3340C8117498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33" creationId="{D9603112-62B3-493E-B679-B5DEE03BD5D3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34" creationId="{DEE17246-B0DC-4720-916E-9BF41D6C11CC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35" creationId="{E5D23434-642B-42E2-89D3-0CAAA640A8AF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36" creationId="{7BCE3516-4A63-4E5F-BBBF-80103CB70939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37" creationId="{91504C2D-0F59-48EF-9827-A1911D8843BC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38" creationId="{56BDF6E6-E69B-4ED2-835A-514371106C0C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39" creationId="{D510CE18-3C50-4B4E-A02F-7C8EFE6063ED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40" creationId="{C4D301BA-5C20-42C6-A69A-DAC1C5D4AF82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42" creationId="{32B5B857-1426-404D-BF99-16212C0F6F8D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43" creationId="{3BCABE57-4F1A-4145-88AA-7F9A8355D305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44" creationId="{9EAE94B6-14BE-4D2E-BABC-26EC51149605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45" creationId="{EF963673-2DBD-42FF-BB55-1572CB86B7F3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46" creationId="{0ABAB904-7980-4142-BA4E-B84AFA733CC9}"/>
          </ac:spMkLst>
        </pc:spChg>
        <pc:spChg chg="mod">
          <ac:chgData name="Filippo Acconcia" userId="844af49c-a8a0-47ac-a7dd-14a44b60cd18" providerId="ADAL" clId="{06E26EB0-D0F3-495F-BCB0-A1C9FB9B622C}" dt="2022-03-14T19:57:20.504" v="4"/>
          <ac:spMkLst>
            <pc:docMk/>
            <pc:sldMk cId="856563846" sldId="302"/>
            <ac:spMk id="47" creationId="{37346E09-2298-4B2A-AF45-8077F1BB76D5}"/>
          </ac:spMkLst>
        </pc:spChg>
        <pc:grpChg chg="add del mod">
          <ac:chgData name="Filippo Acconcia" userId="844af49c-a8a0-47ac-a7dd-14a44b60cd18" providerId="ADAL" clId="{06E26EB0-D0F3-495F-BCB0-A1C9FB9B622C}" dt="2022-03-15T10:39:33.700" v="6" actId="21"/>
          <ac:grpSpMkLst>
            <pc:docMk/>
            <pc:sldMk cId="856563846" sldId="302"/>
            <ac:grpSpMk id="4" creationId="{C9397252-8F2D-4668-ADE4-381F7516B06A}"/>
          </ac:grpSpMkLst>
        </pc:grpChg>
        <pc:grpChg chg="mod">
          <ac:chgData name="Filippo Acconcia" userId="844af49c-a8a0-47ac-a7dd-14a44b60cd18" providerId="ADAL" clId="{06E26EB0-D0F3-495F-BCB0-A1C9FB9B622C}" dt="2022-03-14T19:57:20.504" v="4"/>
          <ac:grpSpMkLst>
            <pc:docMk/>
            <pc:sldMk cId="856563846" sldId="302"/>
            <ac:grpSpMk id="5" creationId="{1F3B916E-C38E-4D60-9E41-CB0DC8FB7AB3}"/>
          </ac:grpSpMkLst>
        </pc:grpChg>
        <pc:grpChg chg="add del mod">
          <ac:chgData name="Filippo Acconcia" userId="844af49c-a8a0-47ac-a7dd-14a44b60cd18" providerId="ADAL" clId="{06E26EB0-D0F3-495F-BCB0-A1C9FB9B622C}" dt="2022-03-15T10:39:33.700" v="6" actId="21"/>
          <ac:grpSpMkLst>
            <pc:docMk/>
            <pc:sldMk cId="856563846" sldId="302"/>
            <ac:grpSpMk id="28" creationId="{AD3526C5-4181-459E-B468-E536C74FC764}"/>
          </ac:grpSpMkLst>
        </pc:grpChg>
        <pc:grpChg chg="mod">
          <ac:chgData name="Filippo Acconcia" userId="844af49c-a8a0-47ac-a7dd-14a44b60cd18" providerId="ADAL" clId="{06E26EB0-D0F3-495F-BCB0-A1C9FB9B622C}" dt="2022-03-14T19:57:20.504" v="4"/>
          <ac:grpSpMkLst>
            <pc:docMk/>
            <pc:sldMk cId="856563846" sldId="302"/>
            <ac:grpSpMk id="30" creationId="{37328E19-33BF-4525-B996-64C32EF06329}"/>
          </ac:grpSpMkLst>
        </pc:grpChg>
        <pc:picChg chg="mod">
          <ac:chgData name="Filippo Acconcia" userId="844af49c-a8a0-47ac-a7dd-14a44b60cd18" providerId="ADAL" clId="{06E26EB0-D0F3-495F-BCB0-A1C9FB9B622C}" dt="2022-03-14T19:57:20.504" v="4"/>
          <ac:picMkLst>
            <pc:docMk/>
            <pc:sldMk cId="856563846" sldId="302"/>
            <ac:picMk id="18" creationId="{4886A647-1293-43E3-B582-C2338AE11F96}"/>
          </ac:picMkLst>
        </pc:picChg>
        <pc:picChg chg="mod">
          <ac:chgData name="Filippo Acconcia" userId="844af49c-a8a0-47ac-a7dd-14a44b60cd18" providerId="ADAL" clId="{06E26EB0-D0F3-495F-BCB0-A1C9FB9B622C}" dt="2022-03-14T19:57:20.504" v="4"/>
          <ac:picMkLst>
            <pc:docMk/>
            <pc:sldMk cId="856563846" sldId="302"/>
            <ac:picMk id="19" creationId="{8CE8A0B4-CC41-44D6-9114-47F3FE93FC04}"/>
          </ac:picMkLst>
        </pc:picChg>
        <pc:picChg chg="mod">
          <ac:chgData name="Filippo Acconcia" userId="844af49c-a8a0-47ac-a7dd-14a44b60cd18" providerId="ADAL" clId="{06E26EB0-D0F3-495F-BCB0-A1C9FB9B622C}" dt="2022-03-14T19:57:20.504" v="4"/>
          <ac:picMkLst>
            <pc:docMk/>
            <pc:sldMk cId="856563846" sldId="302"/>
            <ac:picMk id="20" creationId="{5266B208-8D36-4F59-A47E-91EDC9F643E6}"/>
          </ac:picMkLst>
        </pc:picChg>
        <pc:picChg chg="mod">
          <ac:chgData name="Filippo Acconcia" userId="844af49c-a8a0-47ac-a7dd-14a44b60cd18" providerId="ADAL" clId="{06E26EB0-D0F3-495F-BCB0-A1C9FB9B622C}" dt="2022-03-14T19:57:20.504" v="4"/>
          <ac:picMkLst>
            <pc:docMk/>
            <pc:sldMk cId="856563846" sldId="302"/>
            <ac:picMk id="21" creationId="{2C66413B-DBDD-409C-8F09-D864C872D5D7}"/>
          </ac:picMkLst>
        </pc:picChg>
        <pc:picChg chg="mod">
          <ac:chgData name="Filippo Acconcia" userId="844af49c-a8a0-47ac-a7dd-14a44b60cd18" providerId="ADAL" clId="{06E26EB0-D0F3-495F-BCB0-A1C9FB9B622C}" dt="2022-03-14T19:57:20.504" v="4"/>
          <ac:picMkLst>
            <pc:docMk/>
            <pc:sldMk cId="856563846" sldId="302"/>
            <ac:picMk id="22" creationId="{CA979328-B0A5-4048-A19A-5A9791D4FFEA}"/>
          </ac:picMkLst>
        </pc:picChg>
        <pc:picChg chg="mod">
          <ac:chgData name="Filippo Acconcia" userId="844af49c-a8a0-47ac-a7dd-14a44b60cd18" providerId="ADAL" clId="{06E26EB0-D0F3-495F-BCB0-A1C9FB9B622C}" dt="2022-03-14T19:57:20.504" v="4"/>
          <ac:picMkLst>
            <pc:docMk/>
            <pc:sldMk cId="856563846" sldId="302"/>
            <ac:picMk id="31" creationId="{88E0BC2D-C486-4A1D-98C0-BAECA25F92C5}"/>
          </ac:picMkLst>
        </pc:picChg>
        <pc:picChg chg="mod">
          <ac:chgData name="Filippo Acconcia" userId="844af49c-a8a0-47ac-a7dd-14a44b60cd18" providerId="ADAL" clId="{06E26EB0-D0F3-495F-BCB0-A1C9FB9B622C}" dt="2022-03-14T19:57:20.504" v="4"/>
          <ac:picMkLst>
            <pc:docMk/>
            <pc:sldMk cId="856563846" sldId="302"/>
            <ac:picMk id="48" creationId="{39D24561-B11B-4F29-B792-3D44C466FA72}"/>
          </ac:picMkLst>
        </pc:picChg>
        <pc:picChg chg="mod">
          <ac:chgData name="Filippo Acconcia" userId="844af49c-a8a0-47ac-a7dd-14a44b60cd18" providerId="ADAL" clId="{06E26EB0-D0F3-495F-BCB0-A1C9FB9B622C}" dt="2022-03-14T19:57:20.504" v="4"/>
          <ac:picMkLst>
            <pc:docMk/>
            <pc:sldMk cId="856563846" sldId="302"/>
            <ac:picMk id="49" creationId="{86240006-521C-4BE4-9E2C-1F0F8EF806B1}"/>
          </ac:picMkLst>
        </pc:picChg>
        <pc:picChg chg="mod">
          <ac:chgData name="Filippo Acconcia" userId="844af49c-a8a0-47ac-a7dd-14a44b60cd18" providerId="ADAL" clId="{06E26EB0-D0F3-495F-BCB0-A1C9FB9B622C}" dt="2022-03-14T19:57:20.504" v="4"/>
          <ac:picMkLst>
            <pc:docMk/>
            <pc:sldMk cId="856563846" sldId="302"/>
            <ac:picMk id="50" creationId="{9F4FE23A-08E8-4ADF-BA2D-E7760DF0B38E}"/>
          </ac:picMkLst>
        </pc:picChg>
        <pc:picChg chg="mod">
          <ac:chgData name="Filippo Acconcia" userId="844af49c-a8a0-47ac-a7dd-14a44b60cd18" providerId="ADAL" clId="{06E26EB0-D0F3-495F-BCB0-A1C9FB9B622C}" dt="2022-03-14T19:57:20.504" v="4"/>
          <ac:picMkLst>
            <pc:docMk/>
            <pc:sldMk cId="856563846" sldId="302"/>
            <ac:picMk id="51" creationId="{0A411BA8-3371-46D9-879E-FE100681D3F0}"/>
          </ac:picMkLst>
        </pc:picChg>
        <pc:cxnChg chg="mod">
          <ac:chgData name="Filippo Acconcia" userId="844af49c-a8a0-47ac-a7dd-14a44b60cd18" providerId="ADAL" clId="{06E26EB0-D0F3-495F-BCB0-A1C9FB9B622C}" dt="2022-03-14T19:57:20.504" v="4"/>
          <ac:cxnSpMkLst>
            <pc:docMk/>
            <pc:sldMk cId="856563846" sldId="302"/>
            <ac:cxnSpMk id="16" creationId="{73C5CB06-107D-4A82-9041-B6CC7E013E60}"/>
          </ac:cxnSpMkLst>
        </pc:cxnChg>
        <pc:cxnChg chg="mod">
          <ac:chgData name="Filippo Acconcia" userId="844af49c-a8a0-47ac-a7dd-14a44b60cd18" providerId="ADAL" clId="{06E26EB0-D0F3-495F-BCB0-A1C9FB9B622C}" dt="2022-03-14T19:57:20.504" v="4"/>
          <ac:cxnSpMkLst>
            <pc:docMk/>
            <pc:sldMk cId="856563846" sldId="302"/>
            <ac:cxnSpMk id="41" creationId="{EE689577-7CA2-4614-A774-8B434B9F98BE}"/>
          </ac:cxnSpMkLst>
        </pc:cxnChg>
      </pc:sldChg>
    </pc:docChg>
  </pc:docChgLst>
  <pc:docChgLst>
    <pc:chgData name="Filippo Acconcia" userId="844af49c-a8a0-47ac-a7dd-14a44b60cd18" providerId="ADAL" clId="{6BB624ED-BD79-4859-8E52-6CCB1B2B12D4}"/>
    <pc:docChg chg="delSld modSld">
      <pc:chgData name="Filippo Acconcia" userId="844af49c-a8a0-47ac-a7dd-14a44b60cd18" providerId="ADAL" clId="{6BB624ED-BD79-4859-8E52-6CCB1B2B12D4}" dt="2022-02-04T16:08:59.884" v="13"/>
      <pc:docMkLst>
        <pc:docMk/>
      </pc:docMkLst>
      <pc:sldChg chg="del">
        <pc:chgData name="Filippo Acconcia" userId="844af49c-a8a0-47ac-a7dd-14a44b60cd18" providerId="ADAL" clId="{6BB624ED-BD79-4859-8E52-6CCB1B2B12D4}" dt="2022-01-03T14:16:11.391" v="0" actId="47"/>
        <pc:sldMkLst>
          <pc:docMk/>
          <pc:sldMk cId="0" sldId="274"/>
        </pc:sldMkLst>
      </pc:sldChg>
      <pc:sldChg chg="del">
        <pc:chgData name="Filippo Acconcia" userId="844af49c-a8a0-47ac-a7dd-14a44b60cd18" providerId="ADAL" clId="{6BB624ED-BD79-4859-8E52-6CCB1B2B12D4}" dt="2022-01-03T14:16:12.435" v="2" actId="47"/>
        <pc:sldMkLst>
          <pc:docMk/>
          <pc:sldMk cId="2761330523" sldId="275"/>
        </pc:sldMkLst>
      </pc:sldChg>
      <pc:sldChg chg="del">
        <pc:chgData name="Filippo Acconcia" userId="844af49c-a8a0-47ac-a7dd-14a44b60cd18" providerId="ADAL" clId="{6BB624ED-BD79-4859-8E52-6CCB1B2B12D4}" dt="2022-01-03T14:16:14.735" v="7" actId="47"/>
        <pc:sldMkLst>
          <pc:docMk/>
          <pc:sldMk cId="1836345376" sldId="279"/>
        </pc:sldMkLst>
      </pc:sldChg>
      <pc:sldChg chg="del">
        <pc:chgData name="Filippo Acconcia" userId="844af49c-a8a0-47ac-a7dd-14a44b60cd18" providerId="ADAL" clId="{6BB624ED-BD79-4859-8E52-6CCB1B2B12D4}" dt="2022-01-03T14:16:12.857" v="3" actId="47"/>
        <pc:sldMkLst>
          <pc:docMk/>
          <pc:sldMk cId="3809944351" sldId="282"/>
        </pc:sldMkLst>
      </pc:sldChg>
      <pc:sldChg chg="del">
        <pc:chgData name="Filippo Acconcia" userId="844af49c-a8a0-47ac-a7dd-14a44b60cd18" providerId="ADAL" clId="{6BB624ED-BD79-4859-8E52-6CCB1B2B12D4}" dt="2022-01-03T14:16:15.173" v="8" actId="47"/>
        <pc:sldMkLst>
          <pc:docMk/>
          <pc:sldMk cId="261704195" sldId="284"/>
        </pc:sldMkLst>
      </pc:sldChg>
      <pc:sldChg chg="del">
        <pc:chgData name="Filippo Acconcia" userId="844af49c-a8a0-47ac-a7dd-14a44b60cd18" providerId="ADAL" clId="{6BB624ED-BD79-4859-8E52-6CCB1B2B12D4}" dt="2022-01-03T14:16:15.641" v="9" actId="47"/>
        <pc:sldMkLst>
          <pc:docMk/>
          <pc:sldMk cId="3966312925" sldId="286"/>
        </pc:sldMkLst>
      </pc:sldChg>
      <pc:sldChg chg="del">
        <pc:chgData name="Filippo Acconcia" userId="844af49c-a8a0-47ac-a7dd-14a44b60cd18" providerId="ADAL" clId="{6BB624ED-BD79-4859-8E52-6CCB1B2B12D4}" dt="2022-01-03T14:16:13.279" v="4" actId="47"/>
        <pc:sldMkLst>
          <pc:docMk/>
          <pc:sldMk cId="794076375" sldId="287"/>
        </pc:sldMkLst>
      </pc:sldChg>
      <pc:sldChg chg="modSp">
        <pc:chgData name="Filippo Acconcia" userId="844af49c-a8a0-47ac-a7dd-14a44b60cd18" providerId="ADAL" clId="{6BB624ED-BD79-4859-8E52-6CCB1B2B12D4}" dt="2022-02-04T16:08:59.884" v="13"/>
        <pc:sldMkLst>
          <pc:docMk/>
          <pc:sldMk cId="714323932" sldId="289"/>
        </pc:sldMkLst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4" creationId="{DD4AE994-34DF-4618-83A8-7F5C61010741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5" creationId="{45677536-ED94-4E00-8C8D-3E8D82AA14EA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6" creationId="{57ACA4CC-4D99-4BE4-87C8-82BF4380DAF3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7" creationId="{C60A4AAC-4E98-4446-B900-7701411FAD73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8" creationId="{E3BD895B-200E-42E4-9E2B-C58543404A7B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9" creationId="{F85E4FD6-AA33-4691-8B52-160ED81C651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0" creationId="{1E620BFA-D18A-45C6-B606-74DE8B0A0E9A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1" creationId="{0E16D420-55E3-4929-9C7F-5403647622ED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2" creationId="{8CC800DB-BF3E-40D5-876C-88CEC2335B0F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3" creationId="{8D509502-B9DF-47EB-B0E7-B735740C2569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4" creationId="{93DA862E-80A6-40E0-8E7D-151B64C8E2B6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5" creationId="{01BAE838-9CD3-40AA-842D-6E547E9B0733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9" creationId="{F1872441-4DE0-4818-B199-5D8A1B18FD58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6" creationId="{BC550B6F-C5DD-4437-9473-EB6C595AC624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7" creationId="{4D60977B-F4D7-478F-A210-90AC73AA62B5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8" creationId="{6738F2DF-710B-4640-B8A8-BC62A51CB4CC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31" creationId="{3E028E28-6271-4406-B870-980B04378B87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32" creationId="{7132A1DD-9554-4DC1-B324-CF943BBCB59A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35" creationId="{3E72D95B-AC29-4A97-BAED-1AAB537C06A1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36" creationId="{02996BAD-A3D2-4AFA-8EE7-08E950282EEC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37" creationId="{B54BEE0D-15E1-41F6-8807-F51E5815D9C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39" creationId="{31727A4E-4C11-494A-B16D-1AB7D60F8B33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40" creationId="{8CD24A4E-F3F0-434A-8BA5-63C1C3437FB4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41" creationId="{546A534B-98E5-4B24-AB52-4D7B6FEB23EB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42" creationId="{067B6167-CC2F-4A1C-B5FA-460DC729238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43" creationId="{C862A38A-B1B0-4F39-BB3B-6FE18B00BD4B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47" creationId="{106A4957-5FEF-443D-8B08-C46F8FD3E2F5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53" creationId="{C7AF3C7B-E606-4794-805A-60C8350D1961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54" creationId="{D0D463E3-4827-4592-B1F1-67EE850F0C76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55" creationId="{BE3E9930-026F-4680-AF0E-731B7C138D8C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56" creationId="{6124BD3F-48CF-4560-BB05-D2188F368CDD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57" creationId="{60F060A4-3974-41C9-AC6D-30FC6878EB35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60" creationId="{DD5EB549-D546-4D67-A4CA-C5996C3785CF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61" creationId="{FE39828F-02EB-430E-A9B0-2F841EABDE81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62" creationId="{FEA5B997-93D1-4912-93E7-9D2D87839B19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63" creationId="{8B518DC3-6EDC-4692-85CA-75A68C666892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66" creationId="{A79610FA-F803-4294-BE77-2D0F340C2AD2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67" creationId="{1BEE7CEC-4DD6-4EBF-8B2C-510745731DBB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68" creationId="{47B3EB5D-B926-4606-A313-34D57D5351F6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70" creationId="{2F040673-7879-46A7-BAEE-9C1037672D96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71" creationId="{16A3CEA9-321D-40EC-AB5E-FF06010EAD19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72" creationId="{A4400333-8E30-40C8-B476-F4424E130F1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73" creationId="{6D36FD12-AB2E-408D-BF2C-098736849537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74" creationId="{A53034A5-6FAE-4A8D-845F-076889CCDC25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78" creationId="{015646B5-8547-4045-8A1A-DBDA590F70DB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82" creationId="{FF23A694-748E-4D5F-8568-3028854125A8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83" creationId="{6963FE9D-2138-4C10-93F8-971DAEC5DB30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84" creationId="{56D1343E-F540-48DE-B6C8-17BF5F68875B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87" creationId="{4E20B6DD-6DBF-4506-8A3F-D55D5F40A169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88" creationId="{8C84A4FD-2A31-42B3-B131-4B8FF8F7D205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89" creationId="{67D59985-F9B4-4C00-B730-00F4D9139AA0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93" creationId="{90AE1590-8A17-4058-B063-EA21C0D86F59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94" creationId="{2F9C1393-76D3-46E9-A441-29A03AC79F3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95" creationId="{05E40DCB-4275-494A-B7CE-B70D6BD0520B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96" creationId="{9AA88D92-4DDE-4A1A-8E15-72C11DB31714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98" creationId="{C62AD4DD-6B61-4E05-918B-7A372433B435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99" creationId="{2FED1925-ECA4-47C2-A350-473754664277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00" creationId="{2551A0CE-E656-4A5F-B3AC-781890445D07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02" creationId="{907C84DB-2F4E-4B9B-AF7E-2C1B02D185A6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03" creationId="{811880B3-B45A-4B11-A8FF-A1D8E3C9C3C6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04" creationId="{553FCF68-DD68-4988-B65C-C6A5A8F70FBC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05" creationId="{FA621728-5AD8-4BA3-99DA-E4F39BB5970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06" creationId="{A760DEBE-88C7-46E0-B7AA-163D43C50BDC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10" creationId="{F621E132-C712-4A97-B342-A224C33DD109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11" creationId="{CC8EBFC3-9B10-4499-A5B4-7A4DF737AA56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12" creationId="{F3EF2A0C-78D0-4459-83BD-6579247D5502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13" creationId="{58AC79F8-7E0B-47B5-BF76-3174C3B8E7C0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17" creationId="{FBF6E7AE-3827-46FA-8089-2723F0599805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18" creationId="{2D195CC4-730F-4335-8644-CC81BF044BF3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19" creationId="{75AB72DF-12B5-48CB-8475-50C3AECB2AD7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23" creationId="{9F948E81-D1A5-4488-885E-F2120AE298E6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24" creationId="{1211BFBA-AA06-4758-BEA0-1594F77F2343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25" creationId="{6B8A9C44-0864-4072-9C28-037F8A195C2B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26" creationId="{7EB9203A-76E4-4262-86FE-00D63BC902A6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32" creationId="{26D1D3D7-A8EE-4E43-9828-0A20A548EF74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33" creationId="{C81AEE4D-16C4-4FDC-ABA5-BBCA5A1519E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34" creationId="{60C289A4-EA68-4743-84F9-7C0653D8E8E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36" creationId="{452945F4-CEB9-4D5E-BBF8-B08A4AB98ADB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37" creationId="{0444D086-59BF-4723-BDA2-5BA7DCF8B9DB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38" creationId="{8DED2BA7-814B-4BEA-976E-60786A8C576F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39" creationId="{9B76BE90-7B47-4758-BB1B-27BE315E4D54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40" creationId="{50217A27-E8B1-4480-9DE0-6A6EA30F5A60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44" creationId="{90C87BD5-444D-402F-8253-14B6092F1A08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45" creationId="{49EA8E13-5C5F-4825-A2CC-22F299944419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46" creationId="{51EFB15C-0B7D-41F9-9018-59C13B31F304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47" creationId="{E095591B-9490-42C0-8E32-C3E5029C4D81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51" creationId="{1223A3F0-9806-4CA8-8500-04E43B5A04B6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52" creationId="{F6B528C6-3ECC-4715-915A-22911762299C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53" creationId="{47BAC21E-5E36-4B9C-BC11-4790A769BE81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54" creationId="{80F2AD27-FC09-4E4B-B2B8-BD0AA795959C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56" creationId="{21EF11A9-8AE2-4286-A4E2-D2EC69D30951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57" creationId="{14BF676E-3CA0-4B34-9E9D-48A6FD0FF58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58" creationId="{9FD9D539-DA1C-4864-86AB-B7C602D2B723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60" creationId="{76EE4CB6-B195-4068-ACB1-0EB91A8DE931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61" creationId="{EED37F84-CD0A-438B-8780-79EA3D6CF2D3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62" creationId="{62FC9038-280B-4929-8191-53F997FD18E3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63" creationId="{FEFD5CC5-7E9C-4B33-9DA5-93B34F7E6B98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64" creationId="{E8F1EC44-4D89-40D6-BBAF-6FA6973CF4F7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68" creationId="{8BBB1785-4346-404C-B4C5-D0AB109F88F2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78" creationId="{887240F7-89D5-4B04-8B7E-4C48FE5F8853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79" creationId="{7CAE4C6B-B839-4A01-B8DC-ACFCEF436327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80" creationId="{441616F2-0268-4649-8638-B1EFAAD9F2DB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81" creationId="{8EDE604F-5B51-4BDD-9635-DA9AAD415C31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82" creationId="{98E54B85-1E8E-4441-8646-E97D9CE83433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83" creationId="{3ADD40EE-483C-4827-B46A-FA30473BFCC8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84" creationId="{41E4D069-720F-40C7-96A2-077EC69CBBC8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87" creationId="{A02BD6F4-4251-4F05-B14A-CBFDA88CE7B2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88" creationId="{DC2BDCBF-8178-434D-98AD-E3126BEBE912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89" creationId="{72616B77-6DEE-45B0-876A-38172A62D68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91" creationId="{E908CFBE-7488-4E75-8998-CC5031198DC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92" creationId="{7ADBA68E-7A02-4DCB-AC66-721CBAA1CA67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93" creationId="{2E93FB11-7211-474B-BD97-119E51F99106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94" creationId="{D7137FCF-6CA1-4C33-B53C-343CBF9D2C17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95" creationId="{0104EA83-D27D-4E77-942A-FF0A9A2A086D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199" creationId="{28EBC9E3-00B5-446C-A132-DA345118F94C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08" creationId="{27FB366A-B046-4CCC-AA57-49F403156547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09" creationId="{133803D4-1FED-4A6B-84A5-87C8BC844DF5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10" creationId="{12F8E87F-493A-4B27-AEF5-CD7534C30013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11" creationId="{FC6FB568-38D3-48FE-ADB1-A7EDF4FB8ED5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12" creationId="{9E5D84A3-BF7E-4806-96D8-78DA488A839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13" creationId="{CF2C83FE-B6E8-4034-8688-144BD77A3DAF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14" creationId="{F7FCFE5A-5B0E-40D7-B3C8-AC33D269764F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17" creationId="{98524A09-F223-439F-9D89-11E4368CDFFD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18" creationId="{54741D36-5547-4BFA-9DB3-6A5523FE253F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19" creationId="{270707B4-48A9-41ED-A900-766A46EB961B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21" creationId="{6F0C8B9C-091A-4350-82CA-4BCD386C6D6B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22" creationId="{70733B21-7CF5-469B-B404-65F0F418E3BD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23" creationId="{83B06673-3645-4DBE-B487-FB84F9F16A1A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24" creationId="{277BCD7E-A58E-4F69-96C7-E9ACEEB8D546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25" creationId="{FF6740A7-3C66-4869-B3A2-546E6B19E307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29" creationId="{7C477811-2308-4AF2-9D2F-BDF1E2C93D64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38" creationId="{EB899B81-B427-4787-93B0-1FF420D1F53C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39" creationId="{ABA290A7-2710-4FC7-A958-8975709E33A5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40" creationId="{862E46CB-4CD5-467B-A23F-53AD734CDA6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41" creationId="{FAB02A69-7F11-43A8-B0DF-91A9BD07BFD0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42" creationId="{F3DA2A2D-2833-4E95-BF5A-5C04D57DE2CC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43" creationId="{0A09C752-88E9-4B04-BA63-57ED45889B4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44" creationId="{E51C1FCF-4188-4880-BB1B-1BA95BF33ACF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50" creationId="{792FFBA4-EAAB-4C7A-8C86-45999B07F1D1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51" creationId="{673A1909-ADCD-42A9-B40D-5B91CB09E999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52" creationId="{5E60B042-7584-4680-840F-A2B794484C3F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53" creationId="{32739797-11A1-45FC-828F-D18834BEFCB3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58" creationId="{90C7810D-84C2-4CAC-84CF-7711423E293E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59" creationId="{6DECAA21-94F0-44F2-984F-C566F3F4EDB7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60" creationId="{9519ECF2-D9B9-4590-8BD6-C9DAF593D459}"/>
          </ac:spMkLst>
        </pc:spChg>
        <pc:spChg chg="mod">
          <ac:chgData name="Filippo Acconcia" userId="844af49c-a8a0-47ac-a7dd-14a44b60cd18" providerId="ADAL" clId="{6BB624ED-BD79-4859-8E52-6CCB1B2B12D4}" dt="2022-02-04T16:08:59.884" v="13"/>
          <ac:spMkLst>
            <pc:docMk/>
            <pc:sldMk cId="714323932" sldId="289"/>
            <ac:spMk id="261" creationId="{D8B34ED6-60D5-4087-B8EF-68955D7A1244}"/>
          </ac:spMkLst>
        </pc:s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3" creationId="{019D84FB-04F2-4C4A-9856-34D4A05155A9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33" creationId="{46E91EAC-4BF0-4E8A-9471-3365990B352C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38" creationId="{263EF7FA-FCC2-4EA0-9809-2323921E392D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64" creationId="{BBDFDBEB-3F78-4831-A7FF-9ACF2B975DE0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69" creationId="{E4CEB413-30F6-45FC-BE37-AB4ED7C6A00D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97" creationId="{735CD4E2-3862-4BF2-BC1F-7528C68C10C3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101" creationId="{11F370C6-BCFF-4466-B067-1F000F12901B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131" creationId="{2BD607C8-DAA9-45E0-8DEA-54581CCE3005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135" creationId="{FE1F19DA-6175-4AF0-A105-4CCB7CC41DF8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155" creationId="{BEF68596-F3B3-4BA7-ADAA-E500DEBB3959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159" creationId="{6CA7A98F-81F7-4C9F-9971-58AFA8861EA8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185" creationId="{BE3097F8-7A0E-4D89-ACD1-7AC6AC604967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190" creationId="{310EE57D-D4CF-4177-9A75-C6FC08F9B691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215" creationId="{E5FFF784-216C-449B-B31C-17592073B869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220" creationId="{272AB5B3-AE62-459D-8412-5E551AC162D0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254" creationId="{0D9CD8E3-905F-4014-A7F1-518337D5ECE4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255" creationId="{9F7B1BDB-F9F9-4899-8A06-A48060595BFF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256" creationId="{8D053269-16F8-4DEA-86B5-D58D4A9419FA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257" creationId="{010C69CE-667B-4EED-A25B-B9A20E8510F2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262" creationId="{E438CAA8-0F78-44CE-B39E-592BECAAD570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263" creationId="{376333AF-7306-4D03-B5CE-9A79A1AF9ED2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264" creationId="{2AF9CE8F-EAB7-4037-A019-CBB5C3558333}"/>
          </ac:grpSpMkLst>
        </pc:grpChg>
        <pc:grpChg chg="mod">
          <ac:chgData name="Filippo Acconcia" userId="844af49c-a8a0-47ac-a7dd-14a44b60cd18" providerId="ADAL" clId="{6BB624ED-BD79-4859-8E52-6CCB1B2B12D4}" dt="2022-02-04T16:08:59.884" v="13"/>
          <ac:grpSpMkLst>
            <pc:docMk/>
            <pc:sldMk cId="714323932" sldId="289"/>
            <ac:grpSpMk id="265" creationId="{BFF3340E-D145-450B-B05F-072BBC466F43}"/>
          </ac:grpSpMkLst>
        </pc:grp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20" creationId="{856246F6-6151-45A3-9213-BCC330BF8522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21" creationId="{2E8CCF4E-8ED8-4E43-AFBC-ED025C63EBE4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22" creationId="{52EC0EB5-3A05-4B40-A23D-91A6113B418C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29" creationId="{7C9B31F1-7785-47D9-A361-0B515893F432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30" creationId="{B1470CBB-E784-489F-AC53-763C45CB75C9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34" creationId="{C3DFD675-CD64-4D2A-A720-E7F7ED8EC16A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48" creationId="{F52D1986-4732-47E5-8432-88578571C30E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49" creationId="{4EF03BC3-00FA-4498-B954-F5084E8BFF37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58" creationId="{975C8827-8B59-4589-858D-D8E1D26406C7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59" creationId="{E33C7FED-E43E-4C3B-9DB6-14E0A430327D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65" creationId="{7FB566A3-8EAF-4779-83F9-3459FF54CC37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85" creationId="{C3993995-BA75-4222-8547-D37FD7B00DF1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86" creationId="{07DEDFE1-B1A8-451F-BA62-BBFF090198B2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90" creationId="{5077B973-F1B8-43A5-9CAF-F0AF30BBD96B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91" creationId="{E6026777-CC8E-4415-801F-CD84769F9BE5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92" creationId="{C64C3A0D-8FAD-48F7-AC93-CD22F9A2574D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114" creationId="{4B99E1DD-D2A3-4B22-9601-E97BD685EA41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115" creationId="{0124B9AE-B7DD-4C5D-845C-67622363D1C3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116" creationId="{9E273372-9A7F-4913-B788-FF67093D82ED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120" creationId="{96DC4678-A8C7-4666-8CD1-6A9C629E750E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121" creationId="{75E81A51-5854-4FEE-8443-3308AC1F033B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122" creationId="{A42940AE-3611-4B74-81A6-9B5C4FAFC7F9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148" creationId="{F6BC1C5F-8524-454F-B8D2-67132F4EE665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149" creationId="{69A29EAA-9477-433D-83B6-DD8D774F3141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150" creationId="{F666ABEE-2AEC-4E78-88DD-230C81DAB68F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169" creationId="{AB224D1E-0FDF-4900-8F96-5EC5A7FC4D9A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170" creationId="{1EBB2048-E6B0-44B0-9427-E780CCED6C66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171" creationId="{E3587D5D-249B-407E-AE71-0B3A3FA8103A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186" creationId="{F070FDA8-74AB-4776-9A38-089AC6DBBBED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200" creationId="{94C2F8C7-FCEE-43B6-82D7-4F7C07FE281D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201" creationId="{D67AAE0A-AFB1-4BD6-879F-A9281252A6E8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216" creationId="{281C5B54-86B6-467C-883D-07718DB2BF40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230" creationId="{CAC91B89-F6B8-4754-B92E-49A84D80B399}"/>
          </ac:picMkLst>
        </pc:picChg>
        <pc:picChg chg="mod">
          <ac:chgData name="Filippo Acconcia" userId="844af49c-a8a0-47ac-a7dd-14a44b60cd18" providerId="ADAL" clId="{6BB624ED-BD79-4859-8E52-6CCB1B2B12D4}" dt="2022-02-04T16:08:59.884" v="13"/>
          <ac:picMkLst>
            <pc:docMk/>
            <pc:sldMk cId="714323932" sldId="289"/>
            <ac:picMk id="231" creationId="{EF73046A-8947-4DA0-9EAF-A2398D468211}"/>
          </ac:picMkLst>
        </pc:pic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6" creationId="{0B6B9BF0-C93C-4DED-8C36-7B3C51894FE0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7" creationId="{B90B2BC3-3A2F-4FF6-B14C-2CCF96EAEDE3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8" creationId="{49CB6CD9-7E1A-43A9-9405-318F35ADE149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3" creationId="{EFDB29D5-CA8E-48DC-AE55-A53D66E3F363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4" creationId="{2A95853E-957A-4DBA-82B2-FE0FCDA7762A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5" creationId="{C5FAE627-33D3-4170-846F-8422492B0E9A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44" creationId="{73852BDD-00F5-4BEE-A539-9114DF516E0B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45" creationId="{86C2A042-753A-4C68-8FF0-CB62BD6FF3B8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46" creationId="{BA6A172A-D856-48FC-9E28-978C9728A241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50" creationId="{0ADD73D7-103B-4D25-82F9-BE16AD0C73C0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51" creationId="{2209403F-A42C-428F-80B3-A158C271CB85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52" creationId="{63E80D7D-5C01-4C65-87FF-3C1A6A3EFDB6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75" creationId="{0B6FB90C-F0B3-4CCB-B4AB-A0635F3FCBD2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76" creationId="{A2D7C74F-6FCB-499A-BD07-271945156C09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77" creationId="{50D9D317-9516-4ACB-A822-1156572B98B9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79" creationId="{44F1C586-1FD3-4A6D-9C6C-7978993E4F5A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80" creationId="{3B24D9EC-16A6-4D4D-96E3-DE7A5EEA6285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81" creationId="{7699B18A-025D-4C59-9297-F8E6567DD436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07" creationId="{F13FC9E4-C245-4454-BDD8-DB8DAD8F4754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08" creationId="{4B6BB10B-2C6A-432F-A6F8-C7EB7B2162B4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09" creationId="{3DF0B768-64DF-49A6-A5D8-063E2DC3187B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41" creationId="{7F6B6D8A-DAAB-45D0-9DD1-8F58044A9BEE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42" creationId="{AC70052E-A5D5-4E12-B325-2EAEED9903FD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43" creationId="{BC22FED5-E31C-4970-BE85-F9757A9B6020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65" creationId="{89477AF5-AA91-497F-98DD-2823147E2ED4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66" creationId="{6052993A-3E92-49DD-975B-9759C71E6198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67" creationId="{0D74F3BC-3940-405A-9D77-E31955364760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72" creationId="{B0CBDE0A-F582-46DA-87A1-3E0E9B3B231B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73" creationId="{E5673CC2-7BCC-48E5-B6B6-45DB801976E8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74" creationId="{DE61E024-91B2-47D7-A617-DC0225CD931F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75" creationId="{2853C233-1249-42B4-8720-D79A588E8967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76" creationId="{E28D480C-0A29-4021-8A7C-41A6879213D3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77" creationId="{C79FDA3B-C507-4372-8D02-04530A5B6B31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96" creationId="{1C3E8EA2-83CE-42AF-AAEC-72CA120895DB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97" creationId="{7CFDA7B5-7913-40C2-B736-9277BAF496D9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198" creationId="{6A1336D4-FE7A-4416-BB29-CB34EA33ED4B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02" creationId="{349B6CDF-93F5-482E-A520-304DA42E5695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03" creationId="{F4B2BFAF-0486-48E4-803B-0CF8E26E5C02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04" creationId="{8C3D888B-6053-4EDC-AFC5-D9479D13D4B1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05" creationId="{FE61E209-2B17-485F-818A-728384080EA9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06" creationId="{8338D557-0DA8-49A8-BCE6-871145292828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07" creationId="{8E0A2075-45AB-4A6B-BD2C-A576CC28D4AB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26" creationId="{55744559-7C44-48F2-9225-419167E9DAA6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27" creationId="{2AA1E599-4EE0-46A8-A4C0-34F434194111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28" creationId="{E477F1AE-4640-4E2F-B290-5E3D4410C3F4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32" creationId="{84FB0F13-9404-4374-8585-4ABA8606DF62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33" creationId="{B3C0E0F6-13FE-432A-9213-92919468788D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34" creationId="{A844C86F-19EA-4C2F-B9D1-ED08C965160A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35" creationId="{B2582B41-D23B-4D12-B0D7-50B9A773CC6C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36" creationId="{2F782E9F-7D41-4C51-BEA4-BDC086D9406E}"/>
          </ac:cxnSpMkLst>
        </pc:cxnChg>
        <pc:cxnChg chg="mod">
          <ac:chgData name="Filippo Acconcia" userId="844af49c-a8a0-47ac-a7dd-14a44b60cd18" providerId="ADAL" clId="{6BB624ED-BD79-4859-8E52-6CCB1B2B12D4}" dt="2022-02-04T16:08:59.884" v="13"/>
          <ac:cxnSpMkLst>
            <pc:docMk/>
            <pc:sldMk cId="714323932" sldId="289"/>
            <ac:cxnSpMk id="237" creationId="{EBC4F527-0C9B-4B9B-A2FC-E8BECDA77980}"/>
          </ac:cxnSpMkLst>
        </pc:cxnChg>
      </pc:sldChg>
      <pc:sldChg chg="del">
        <pc:chgData name="Filippo Acconcia" userId="844af49c-a8a0-47ac-a7dd-14a44b60cd18" providerId="ADAL" clId="{6BB624ED-BD79-4859-8E52-6CCB1B2B12D4}" dt="2022-01-03T14:16:13.779" v="5" actId="47"/>
        <pc:sldMkLst>
          <pc:docMk/>
          <pc:sldMk cId="3012970129" sldId="291"/>
        </pc:sldMkLst>
      </pc:sldChg>
      <pc:sldChg chg="del">
        <pc:chgData name="Filippo Acconcia" userId="844af49c-a8a0-47ac-a7dd-14a44b60cd18" providerId="ADAL" clId="{6BB624ED-BD79-4859-8E52-6CCB1B2B12D4}" dt="2022-01-03T14:16:14.185" v="6" actId="47"/>
        <pc:sldMkLst>
          <pc:docMk/>
          <pc:sldMk cId="2941471277" sldId="292"/>
        </pc:sldMkLst>
      </pc:sldChg>
      <pc:sldChg chg="del">
        <pc:chgData name="Filippo Acconcia" userId="844af49c-a8a0-47ac-a7dd-14a44b60cd18" providerId="ADAL" clId="{6BB624ED-BD79-4859-8E52-6CCB1B2B12D4}" dt="2022-01-03T14:16:11.935" v="1" actId="47"/>
        <pc:sldMkLst>
          <pc:docMk/>
          <pc:sldMk cId="2231232633" sldId="294"/>
        </pc:sldMkLst>
      </pc:sldChg>
      <pc:sldChg chg="del">
        <pc:chgData name="Filippo Acconcia" userId="844af49c-a8a0-47ac-a7dd-14a44b60cd18" providerId="ADAL" clId="{6BB624ED-BD79-4859-8E52-6CCB1B2B12D4}" dt="2022-01-03T14:16:16.453" v="10" actId="47"/>
        <pc:sldMkLst>
          <pc:docMk/>
          <pc:sldMk cId="119360460" sldId="296"/>
        </pc:sldMkLst>
      </pc:sldChg>
      <pc:sldChg chg="del">
        <pc:chgData name="Filippo Acconcia" userId="844af49c-a8a0-47ac-a7dd-14a44b60cd18" providerId="ADAL" clId="{6BB624ED-BD79-4859-8E52-6CCB1B2B12D4}" dt="2022-01-03T14:16:21.829" v="11" actId="47"/>
        <pc:sldMkLst>
          <pc:docMk/>
          <pc:sldMk cId="633165484" sldId="29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>
            <a:extLst>
              <a:ext uri="{FF2B5EF4-FFF2-40B4-BE49-F238E27FC236}">
                <a16:creationId xmlns:a16="http://schemas.microsoft.com/office/drawing/2014/main" id="{3021E025-0A0C-48B1-8E0F-284826AC1F7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AD1D041-419B-4C71-976A-1EB4D9DD3D2E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D616DD4C-8BBB-49EC-A3AB-1185B6705009}" type="datetimeFigureOut">
              <a:rPr lang="it-IT"/>
              <a:pPr>
                <a:defRPr/>
              </a:pPr>
              <a:t>25/03/2022</a:t>
            </a:fld>
            <a:endParaRPr lang="it-IT"/>
          </a:p>
        </p:txBody>
      </p:sp>
      <p:sp>
        <p:nvSpPr>
          <p:cNvPr id="4" name="Segnaposto immagine diapositiva 3">
            <a:extLst>
              <a:ext uri="{FF2B5EF4-FFF2-40B4-BE49-F238E27FC236}">
                <a16:creationId xmlns:a16="http://schemas.microsoft.com/office/drawing/2014/main" id="{181F25FA-92D7-42AA-9C47-5338B3E177A6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it-IT" noProof="0"/>
          </a:p>
        </p:txBody>
      </p:sp>
      <p:sp>
        <p:nvSpPr>
          <p:cNvPr id="5" name="Segnaposto note 4">
            <a:extLst>
              <a:ext uri="{FF2B5EF4-FFF2-40B4-BE49-F238E27FC236}">
                <a16:creationId xmlns:a16="http://schemas.microsoft.com/office/drawing/2014/main" id="{D253DCF8-DC00-4CCA-9F21-635E20B52A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noProof="0"/>
              <a:t>Fare clic per modificare stili del testo dello schema</a:t>
            </a:r>
          </a:p>
          <a:p>
            <a:pPr lvl="1"/>
            <a:r>
              <a:rPr lang="it-IT" noProof="0"/>
              <a:t>Secondo livello</a:t>
            </a:r>
          </a:p>
          <a:p>
            <a:pPr lvl="2"/>
            <a:r>
              <a:rPr lang="it-IT" noProof="0"/>
              <a:t>Terzo livello</a:t>
            </a:r>
          </a:p>
          <a:p>
            <a:pPr lvl="3"/>
            <a:r>
              <a:rPr lang="it-IT" noProof="0"/>
              <a:t>Quarto livello</a:t>
            </a:r>
          </a:p>
          <a:p>
            <a:pPr lvl="4"/>
            <a:r>
              <a:rPr lang="it-IT" noProof="0"/>
              <a:t>Quinto livello</a:t>
            </a:r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C663B98-C022-4041-A89C-ADAC415DE94B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3C8DE6C-8A0F-4705-92AC-76234166F35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847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9FE68639-4BBA-40F2-9C3B-4084CA34D622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D9514660-86CD-45DB-AE8B-5936BAE4F4D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1561FFAD-9379-43FC-8B78-5BE4691C3106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E65D37CF-48F9-4387-BE7B-8D8E8E51578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905632C-C3F3-40E4-891C-4DC6F92A814C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349588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6946567F-0E2E-4B5C-958A-3D53B583358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D3E5FFC9-0B25-4466-9999-63B214776542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2EF991A3-A697-4C39-A6E6-8354B3B3FE82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94CCE1-A803-48EA-BFEE-3D7A5711F6E5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693924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AE9F3A0E-DFA2-414F-AACC-C757146D015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59F83E6D-FD47-4333-9BB4-C2B2D047A1E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59936280-C49D-4499-9FFE-C0454B0286BA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FE9A32-FE2A-4B66-8D75-A677DFC6383A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2715064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2A29C7EE-9B73-4F54-BBF8-C0FCDADCAC29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CA952E95-410A-48E8-896C-C93ADE225EF7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2FF7DBB3-CC8C-4E74-B25F-23BEC850F3E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8227B1C-6EA9-4CD5-B734-4F445F381245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2848185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3E0F3FD4-97DC-4B24-868F-4403FB4296D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03B1F413-F51B-456A-9C65-206961954B58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EA4CF9C0-DB95-4226-BB0B-D9E351636CF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A725DB-3DF0-4651-B7BB-BBA5C8B96229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1175608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2CD04F2-D219-4F1C-80F6-C60A38DE0A5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E2A8EBF-9C18-45C9-898C-BB9C6F4980CA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41DDE6E-7044-4DEF-B417-ED24CFE1E51A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3D94E8F-0893-4B89-A039-83D6207FA328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3548474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1D52F4CB-6E78-4124-A8BC-4B727BA671E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E93D6CB8-A271-4419-99EF-111E8414FE16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0365CF9C-13E7-4EF5-993B-DDEE96F4D66B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B7DC509-43C6-42C8-8B00-7FC1D3BBAAF1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2070500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B549663A-ED8E-47D3-9994-4EEFB2A162B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DD9171D5-9A3F-4700-B673-A340A1ED03D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69091EDA-4D73-4D4F-8B8A-73230ADDA966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21F5FC-7CD5-4C74-B005-AC914435E9B5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1870331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DA164BC1-5526-41A8-9B70-6F5D8D27314C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40EE2281-3A74-4E0E-8AD9-6CBA9BB6158E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64654261-B3DA-4AC5-8612-2C8A45C3BA2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8DBB4F-6C17-46DF-AC1F-34A58AE0D79A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509790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017F993-B2FD-4B42-976B-BB9A6B7814D9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490F29C-94BE-4CA0-BADF-B3FB5A11C56B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D7BD6B2-B19A-4C8A-AEDF-75A67352B30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2D5634-6A9B-4AD9-9E89-39A494A56E90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1716180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4507C6C-8193-43E9-B046-32D9A06F730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D9996A1-173E-42B1-9422-1D0A6CE95D5F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CB81C91-7131-46FE-B01D-F4B79EE15A18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EA1B89-A8B4-44B5-B159-1D3CD701084F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646633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6A8808E6-C826-4A67-94F4-C5574BC7716A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en-US"/>
              <a:t>Click to edit Master title style</a:t>
            </a:r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E73F13FC-927E-4931-9B85-E5FB1205E75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en-US"/>
              <a:t>Click to edit Master text styles</a:t>
            </a:r>
          </a:p>
          <a:p>
            <a:pPr lvl="1"/>
            <a:r>
              <a:rPr lang="it-IT" altLang="en-US"/>
              <a:t>Second level</a:t>
            </a:r>
          </a:p>
          <a:p>
            <a:pPr lvl="2"/>
            <a:r>
              <a:rPr lang="it-IT" altLang="en-US"/>
              <a:t>Third level</a:t>
            </a:r>
          </a:p>
          <a:p>
            <a:pPr lvl="3"/>
            <a:r>
              <a:rPr lang="it-IT" altLang="en-US"/>
              <a:t>Fourth level</a:t>
            </a:r>
          </a:p>
          <a:p>
            <a:pPr lvl="4"/>
            <a:r>
              <a:rPr lang="it-IT" altLang="en-US"/>
              <a:t>Fifth level</a:t>
            </a: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C5DCBBBD-636D-4787-976F-47E1021DA95E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9B981123-E30F-4283-BC00-9D52238C8899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613F572F-7760-4F0B-A0FC-0581F94A2778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9FE7A969-CF52-4352-B69C-73B19C67AF77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7.png"/><Relationship Id="rId18" Type="http://schemas.openxmlformats.org/officeDocument/2006/relationships/image" Target="../media/image10.png"/><Relationship Id="rId26" Type="http://schemas.openxmlformats.org/officeDocument/2006/relationships/image" Target="../media/image16.png"/><Relationship Id="rId3" Type="http://schemas.microsoft.com/office/2007/relationships/hdphoto" Target="../media/hdphoto1.wdp"/><Relationship Id="rId21" Type="http://schemas.openxmlformats.org/officeDocument/2006/relationships/image" Target="../media/image13.png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7.wdp"/><Relationship Id="rId25" Type="http://schemas.microsoft.com/office/2007/relationships/hdphoto" Target="../media/hdphoto9.wdp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0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5.png"/><Relationship Id="rId5" Type="http://schemas.microsoft.com/office/2007/relationships/hdphoto" Target="../media/hdphoto2.wdp"/><Relationship Id="rId15" Type="http://schemas.microsoft.com/office/2007/relationships/hdphoto" Target="../media/hdphoto6.wdp"/><Relationship Id="rId23" Type="http://schemas.microsoft.com/office/2007/relationships/hdphoto" Target="../media/hdphoto8.wdp"/><Relationship Id="rId10" Type="http://schemas.openxmlformats.org/officeDocument/2006/relationships/image" Target="../media/image5.png"/><Relationship Id="rId19" Type="http://schemas.openxmlformats.org/officeDocument/2006/relationships/image" Target="../media/image11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8.png"/><Relationship Id="rId22" Type="http://schemas.openxmlformats.org/officeDocument/2006/relationships/image" Target="../media/image14.png"/><Relationship Id="rId27" Type="http://schemas.microsoft.com/office/2007/relationships/hdphoto" Target="../media/hdphoto10.wdp"/></Relationships>
</file>

<file path=ppt/slides/_rels/slide2.xml.rels><?xml version="1.0" encoding="UTF-8" standalone="yes"?>
<Relationships xmlns="http://schemas.openxmlformats.org/package/2006/relationships"><Relationship Id="rId13" Type="http://schemas.microsoft.com/office/2007/relationships/hdphoto" Target="../media/hdphoto16.wdp"/><Relationship Id="rId18" Type="http://schemas.microsoft.com/office/2007/relationships/hdphoto" Target="../media/hdphoto18.wdp"/><Relationship Id="rId26" Type="http://schemas.openxmlformats.org/officeDocument/2006/relationships/image" Target="../media/image30.png"/><Relationship Id="rId39" Type="http://schemas.openxmlformats.org/officeDocument/2006/relationships/image" Target="../media/image37.png"/><Relationship Id="rId21" Type="http://schemas.openxmlformats.org/officeDocument/2006/relationships/image" Target="../media/image27.png"/><Relationship Id="rId34" Type="http://schemas.microsoft.com/office/2007/relationships/hdphoto" Target="../media/hdphoto25.wdp"/><Relationship Id="rId42" Type="http://schemas.microsoft.com/office/2007/relationships/hdphoto" Target="../media/hdphoto29.wdp"/><Relationship Id="rId47" Type="http://schemas.microsoft.com/office/2007/relationships/hdphoto" Target="../media/hdphoto31.wdp"/><Relationship Id="rId50" Type="http://schemas.openxmlformats.org/officeDocument/2006/relationships/image" Target="../media/image43.png"/><Relationship Id="rId55" Type="http://schemas.microsoft.com/office/2007/relationships/hdphoto" Target="../media/hdphoto35.wdp"/><Relationship Id="rId63" Type="http://schemas.microsoft.com/office/2007/relationships/hdphoto" Target="../media/hdphoto39.wdp"/><Relationship Id="rId7" Type="http://schemas.microsoft.com/office/2007/relationships/hdphoto" Target="../media/hdphoto13.wdp"/><Relationship Id="rId2" Type="http://schemas.openxmlformats.org/officeDocument/2006/relationships/image" Target="../media/image17.png"/><Relationship Id="rId16" Type="http://schemas.microsoft.com/office/2007/relationships/hdphoto" Target="../media/hdphoto17.wdp"/><Relationship Id="rId20" Type="http://schemas.microsoft.com/office/2007/relationships/hdphoto" Target="../media/hdphoto19.wdp"/><Relationship Id="rId29" Type="http://schemas.openxmlformats.org/officeDocument/2006/relationships/image" Target="../media/image32.png"/><Relationship Id="rId41" Type="http://schemas.openxmlformats.org/officeDocument/2006/relationships/image" Target="../media/image38.png"/><Relationship Id="rId54" Type="http://schemas.openxmlformats.org/officeDocument/2006/relationships/image" Target="../media/image45.png"/><Relationship Id="rId62" Type="http://schemas.openxmlformats.org/officeDocument/2006/relationships/image" Target="../media/image4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11" Type="http://schemas.microsoft.com/office/2007/relationships/hdphoto" Target="../media/hdphoto15.wdp"/><Relationship Id="rId24" Type="http://schemas.microsoft.com/office/2007/relationships/hdphoto" Target="../media/hdphoto21.wdp"/><Relationship Id="rId32" Type="http://schemas.microsoft.com/office/2007/relationships/hdphoto" Target="../media/hdphoto24.wdp"/><Relationship Id="rId37" Type="http://schemas.openxmlformats.org/officeDocument/2006/relationships/image" Target="../media/image36.png"/><Relationship Id="rId40" Type="http://schemas.microsoft.com/office/2007/relationships/hdphoto" Target="../media/hdphoto28.wdp"/><Relationship Id="rId45" Type="http://schemas.microsoft.com/office/2007/relationships/hdphoto" Target="../media/hdphoto30.wdp"/><Relationship Id="rId53" Type="http://schemas.microsoft.com/office/2007/relationships/hdphoto" Target="../media/hdphoto34.wdp"/><Relationship Id="rId58" Type="http://schemas.openxmlformats.org/officeDocument/2006/relationships/image" Target="../media/image47.png"/><Relationship Id="rId5" Type="http://schemas.microsoft.com/office/2007/relationships/hdphoto" Target="../media/hdphoto12.wdp"/><Relationship Id="rId15" Type="http://schemas.openxmlformats.org/officeDocument/2006/relationships/image" Target="../media/image24.png"/><Relationship Id="rId23" Type="http://schemas.openxmlformats.org/officeDocument/2006/relationships/image" Target="../media/image28.png"/><Relationship Id="rId28" Type="http://schemas.microsoft.com/office/2007/relationships/hdphoto" Target="../media/hdphoto22.wdp"/><Relationship Id="rId36" Type="http://schemas.microsoft.com/office/2007/relationships/hdphoto" Target="../media/hdphoto26.wdp"/><Relationship Id="rId49" Type="http://schemas.microsoft.com/office/2007/relationships/hdphoto" Target="../media/hdphoto32.wdp"/><Relationship Id="rId57" Type="http://schemas.microsoft.com/office/2007/relationships/hdphoto" Target="../media/hdphoto36.wdp"/><Relationship Id="rId61" Type="http://schemas.microsoft.com/office/2007/relationships/hdphoto" Target="../media/hdphoto38.wdp"/><Relationship Id="rId10" Type="http://schemas.openxmlformats.org/officeDocument/2006/relationships/image" Target="../media/image21.png"/><Relationship Id="rId19" Type="http://schemas.openxmlformats.org/officeDocument/2006/relationships/image" Target="../media/image26.png"/><Relationship Id="rId31" Type="http://schemas.openxmlformats.org/officeDocument/2006/relationships/image" Target="../media/image33.png"/><Relationship Id="rId44" Type="http://schemas.openxmlformats.org/officeDocument/2006/relationships/image" Target="../media/image40.png"/><Relationship Id="rId52" Type="http://schemas.openxmlformats.org/officeDocument/2006/relationships/image" Target="../media/image44.png"/><Relationship Id="rId60" Type="http://schemas.openxmlformats.org/officeDocument/2006/relationships/image" Target="../media/image48.png"/><Relationship Id="rId65" Type="http://schemas.microsoft.com/office/2007/relationships/hdphoto" Target="../media/hdphoto40.wdp"/><Relationship Id="rId4" Type="http://schemas.openxmlformats.org/officeDocument/2006/relationships/image" Target="../media/image18.png"/><Relationship Id="rId9" Type="http://schemas.microsoft.com/office/2007/relationships/hdphoto" Target="../media/hdphoto14.wdp"/><Relationship Id="rId14" Type="http://schemas.openxmlformats.org/officeDocument/2006/relationships/image" Target="../media/image23.png"/><Relationship Id="rId22" Type="http://schemas.microsoft.com/office/2007/relationships/hdphoto" Target="../media/hdphoto20.wdp"/><Relationship Id="rId27" Type="http://schemas.openxmlformats.org/officeDocument/2006/relationships/image" Target="../media/image31.png"/><Relationship Id="rId30" Type="http://schemas.microsoft.com/office/2007/relationships/hdphoto" Target="../media/hdphoto23.wdp"/><Relationship Id="rId35" Type="http://schemas.openxmlformats.org/officeDocument/2006/relationships/image" Target="../media/image35.png"/><Relationship Id="rId43" Type="http://schemas.openxmlformats.org/officeDocument/2006/relationships/image" Target="../media/image39.png"/><Relationship Id="rId48" Type="http://schemas.openxmlformats.org/officeDocument/2006/relationships/image" Target="../media/image42.png"/><Relationship Id="rId56" Type="http://schemas.openxmlformats.org/officeDocument/2006/relationships/image" Target="../media/image46.png"/><Relationship Id="rId64" Type="http://schemas.openxmlformats.org/officeDocument/2006/relationships/image" Target="../media/image50.png"/><Relationship Id="rId8" Type="http://schemas.openxmlformats.org/officeDocument/2006/relationships/image" Target="../media/image20.png"/><Relationship Id="rId51" Type="http://schemas.microsoft.com/office/2007/relationships/hdphoto" Target="../media/hdphoto33.wdp"/><Relationship Id="rId3" Type="http://schemas.microsoft.com/office/2007/relationships/hdphoto" Target="../media/hdphoto11.wdp"/><Relationship Id="rId12" Type="http://schemas.openxmlformats.org/officeDocument/2006/relationships/image" Target="../media/image22.png"/><Relationship Id="rId17" Type="http://schemas.openxmlformats.org/officeDocument/2006/relationships/image" Target="../media/image25.png"/><Relationship Id="rId25" Type="http://schemas.openxmlformats.org/officeDocument/2006/relationships/image" Target="../media/image29.png"/><Relationship Id="rId33" Type="http://schemas.openxmlformats.org/officeDocument/2006/relationships/image" Target="../media/image34.png"/><Relationship Id="rId38" Type="http://schemas.microsoft.com/office/2007/relationships/hdphoto" Target="../media/hdphoto27.wdp"/><Relationship Id="rId46" Type="http://schemas.openxmlformats.org/officeDocument/2006/relationships/image" Target="../media/image41.png"/><Relationship Id="rId59" Type="http://schemas.microsoft.com/office/2007/relationships/hdphoto" Target="../media/hdphoto37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3" Type="http://schemas.microsoft.com/office/2007/relationships/hdphoto" Target="../media/hdphoto41.wdp"/><Relationship Id="rId7" Type="http://schemas.microsoft.com/office/2007/relationships/hdphoto" Target="../media/hdphoto43.wdp"/><Relationship Id="rId12" Type="http://schemas.openxmlformats.org/officeDocument/2006/relationships/image" Target="../media/image57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11" Type="http://schemas.openxmlformats.org/officeDocument/2006/relationships/image" Target="../media/image56.png"/><Relationship Id="rId5" Type="http://schemas.microsoft.com/office/2007/relationships/hdphoto" Target="../media/hdphoto42.wdp"/><Relationship Id="rId10" Type="http://schemas.openxmlformats.org/officeDocument/2006/relationships/image" Target="../media/image55.png"/><Relationship Id="rId4" Type="http://schemas.openxmlformats.org/officeDocument/2006/relationships/image" Target="../media/image52.png"/><Relationship Id="rId9" Type="http://schemas.microsoft.com/office/2007/relationships/hdphoto" Target="../media/hdphoto44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png"/><Relationship Id="rId3" Type="http://schemas.openxmlformats.org/officeDocument/2006/relationships/image" Target="../media/image61.png"/><Relationship Id="rId7" Type="http://schemas.openxmlformats.org/officeDocument/2006/relationships/image" Target="../media/image65.png"/><Relationship Id="rId2" Type="http://schemas.openxmlformats.org/officeDocument/2006/relationships/image" Target="../media/image60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4.png"/><Relationship Id="rId5" Type="http://schemas.openxmlformats.org/officeDocument/2006/relationships/image" Target="../media/image63.png"/><Relationship Id="rId4" Type="http://schemas.openxmlformats.org/officeDocument/2006/relationships/image" Target="../media/image62.png"/><Relationship Id="rId9" Type="http://schemas.openxmlformats.org/officeDocument/2006/relationships/image" Target="../media/image6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png"/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0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7.png"/><Relationship Id="rId3" Type="http://schemas.openxmlformats.org/officeDocument/2006/relationships/image" Target="../media/image72.png"/><Relationship Id="rId7" Type="http://schemas.openxmlformats.org/officeDocument/2006/relationships/image" Target="../media/image76.png"/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5.png"/><Relationship Id="rId5" Type="http://schemas.openxmlformats.org/officeDocument/2006/relationships/image" Target="../media/image74.png"/><Relationship Id="rId10" Type="http://schemas.openxmlformats.org/officeDocument/2006/relationships/image" Target="../media/image79.png"/><Relationship Id="rId4" Type="http://schemas.openxmlformats.org/officeDocument/2006/relationships/image" Target="../media/image73.png"/><Relationship Id="rId9" Type="http://schemas.openxmlformats.org/officeDocument/2006/relationships/image" Target="../media/image7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DAB35C31-9602-411A-9DB7-3FA9A2FC4DA3}"/>
              </a:ext>
            </a:extLst>
          </p:cNvPr>
          <p:cNvSpPr txBox="1"/>
          <p:nvPr/>
        </p:nvSpPr>
        <p:spPr>
          <a:xfrm>
            <a:off x="2022205" y="142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ure 1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C87E7A78-E592-4730-A163-FBD8EE08EC99}"/>
              </a:ext>
            </a:extLst>
          </p:cNvPr>
          <p:cNvSpPr txBox="1"/>
          <p:nvPr/>
        </p:nvSpPr>
        <p:spPr>
          <a:xfrm>
            <a:off x="66063" y="82344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A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6B669F2F-B6BB-4C1B-B4E9-2D96049267C9}"/>
              </a:ext>
            </a:extLst>
          </p:cNvPr>
          <p:cNvSpPr txBox="1"/>
          <p:nvPr/>
        </p:nvSpPr>
        <p:spPr>
          <a:xfrm>
            <a:off x="3435942" y="823449"/>
            <a:ext cx="304801" cy="279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B</a:t>
            </a:r>
          </a:p>
        </p:txBody>
      </p:sp>
      <p:grpSp>
        <p:nvGrpSpPr>
          <p:cNvPr id="5" name="Gruppo 4">
            <a:extLst>
              <a:ext uri="{FF2B5EF4-FFF2-40B4-BE49-F238E27FC236}">
                <a16:creationId xmlns:a16="http://schemas.microsoft.com/office/drawing/2014/main" id="{F391EBCE-63E2-465B-B4A4-050910F9A744}"/>
              </a:ext>
            </a:extLst>
          </p:cNvPr>
          <p:cNvGrpSpPr/>
          <p:nvPr/>
        </p:nvGrpSpPr>
        <p:grpSpPr>
          <a:xfrm>
            <a:off x="764888" y="1059335"/>
            <a:ext cx="1958529" cy="1568449"/>
            <a:chOff x="318350" y="346087"/>
            <a:chExt cx="1958529" cy="1568449"/>
          </a:xfrm>
        </p:grpSpPr>
        <p:grpSp>
          <p:nvGrpSpPr>
            <p:cNvPr id="6" name="Gruppo 5">
              <a:extLst>
                <a:ext uri="{FF2B5EF4-FFF2-40B4-BE49-F238E27FC236}">
                  <a16:creationId xmlns:a16="http://schemas.microsoft.com/office/drawing/2014/main" id="{496BF7E1-96C0-4439-A81F-BA29EBF2C275}"/>
                </a:ext>
              </a:extLst>
            </p:cNvPr>
            <p:cNvGrpSpPr/>
            <p:nvPr/>
          </p:nvGrpSpPr>
          <p:grpSpPr>
            <a:xfrm>
              <a:off x="318350" y="346087"/>
              <a:ext cx="1958529" cy="1344260"/>
              <a:chOff x="277755" y="736035"/>
              <a:chExt cx="1958529" cy="1344260"/>
            </a:xfrm>
          </p:grpSpPr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667CA5A5-8F46-4BE7-8E5C-9E4B12E1315B}"/>
                  </a:ext>
                </a:extLst>
              </p:cNvPr>
              <p:cNvSpPr txBox="1"/>
              <p:nvPr/>
            </p:nvSpPr>
            <p:spPr>
              <a:xfrm>
                <a:off x="1149127" y="1262452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1</a:t>
                </a:r>
              </a:p>
            </p:txBody>
          </p:sp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CF8213E8-AC24-4082-A195-B730BE476179}"/>
                  </a:ext>
                </a:extLst>
              </p:cNvPr>
              <p:cNvSpPr txBox="1"/>
              <p:nvPr/>
            </p:nvSpPr>
            <p:spPr>
              <a:xfrm>
                <a:off x="1149127" y="1775596"/>
                <a:ext cx="652102" cy="3046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Vinculin</a:t>
                </a:r>
                <a:endParaRPr lang="it-IT" sz="1200" dirty="0"/>
              </a:p>
            </p:txBody>
          </p:sp>
          <p:sp>
            <p:nvSpPr>
              <p:cNvPr id="10" name="CasellaDiTesto 9">
                <a:extLst>
                  <a:ext uri="{FF2B5EF4-FFF2-40B4-BE49-F238E27FC236}">
                    <a16:creationId xmlns:a16="http://schemas.microsoft.com/office/drawing/2014/main" id="{61A97826-BF5C-41B3-AB5A-624C6D6ACD55}"/>
                  </a:ext>
                </a:extLst>
              </p:cNvPr>
              <p:cNvSpPr txBox="1"/>
              <p:nvPr/>
            </p:nvSpPr>
            <p:spPr>
              <a:xfrm>
                <a:off x="1149127" y="1091646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296-CHK1</a:t>
                </a:r>
              </a:p>
            </p:txBody>
          </p:sp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711BA7E7-C148-45F6-B22A-505E34FC10F3}"/>
                  </a:ext>
                </a:extLst>
              </p:cNvPr>
              <p:cNvSpPr txBox="1"/>
              <p:nvPr/>
            </p:nvSpPr>
            <p:spPr>
              <a:xfrm>
                <a:off x="277755" y="922674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C3E91E65-919E-4D76-B688-B29A3E82AC60}"/>
                  </a:ext>
                </a:extLst>
              </p:cNvPr>
              <p:cNvSpPr txBox="1"/>
              <p:nvPr/>
            </p:nvSpPr>
            <p:spPr>
              <a:xfrm>
                <a:off x="507554" y="922674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6B16DE2B-2202-4D78-8926-917316068605}"/>
                  </a:ext>
                </a:extLst>
              </p:cNvPr>
              <p:cNvSpPr txBox="1"/>
              <p:nvPr/>
            </p:nvSpPr>
            <p:spPr>
              <a:xfrm>
                <a:off x="771512" y="922674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A31ABAC8-7976-4D13-9C7C-5C5395C90379}"/>
                  </a:ext>
                </a:extLst>
              </p:cNvPr>
              <p:cNvSpPr txBox="1"/>
              <p:nvPr/>
            </p:nvSpPr>
            <p:spPr>
              <a:xfrm>
                <a:off x="952561" y="922674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9CFE1552-07E5-470E-8EE9-729867A4D857}"/>
                  </a:ext>
                </a:extLst>
              </p:cNvPr>
              <p:cNvSpPr txBox="1"/>
              <p:nvPr/>
            </p:nvSpPr>
            <p:spPr>
              <a:xfrm>
                <a:off x="952561" y="736035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id="{D4818FDA-D96B-4896-B9A7-EDADF165D043}"/>
                  </a:ext>
                </a:extLst>
              </p:cNvPr>
              <p:cNvSpPr txBox="1"/>
              <p:nvPr/>
            </p:nvSpPr>
            <p:spPr>
              <a:xfrm>
                <a:off x="1149127" y="922674"/>
                <a:ext cx="49930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ETO</a:t>
                </a:r>
              </a:p>
            </p:txBody>
          </p:sp>
          <p:cxnSp>
            <p:nvCxnSpPr>
              <p:cNvPr id="17" name="Connettore diritto 16">
                <a:extLst>
                  <a:ext uri="{FF2B5EF4-FFF2-40B4-BE49-F238E27FC236}">
                    <a16:creationId xmlns:a16="http://schemas.microsoft.com/office/drawing/2014/main" id="{3CB7FF21-2E30-4CBE-8382-6D64999664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88382" y="874534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D921EAD5-E3BA-4741-B728-5F79DA96D767}"/>
                  </a:ext>
                </a:extLst>
              </p:cNvPr>
              <p:cNvSpPr txBox="1"/>
              <p:nvPr/>
            </p:nvSpPr>
            <p:spPr>
              <a:xfrm>
                <a:off x="1149127" y="736035"/>
                <a:ext cx="101601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it-IT" sz="1200" dirty="0"/>
                  <a:t>AZD</a:t>
                </a:r>
              </a:p>
            </p:txBody>
          </p:sp>
          <p:pic>
            <p:nvPicPr>
              <p:cNvPr id="19" name="Immagine 18">
                <a:extLst>
                  <a:ext uri="{FF2B5EF4-FFF2-40B4-BE49-F238E27FC236}">
                    <a16:creationId xmlns:a16="http://schemas.microsoft.com/office/drawing/2014/main" id="{C98E9531-BC80-48E6-9E27-3ED569DA951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87227" y="1164069"/>
                <a:ext cx="900000" cy="13215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0" name="Immagine 19">
                <a:extLst>
                  <a:ext uri="{FF2B5EF4-FFF2-40B4-BE49-F238E27FC236}">
                    <a16:creationId xmlns:a16="http://schemas.microsoft.com/office/drawing/2014/main" id="{C48509C1-B754-4373-AFC3-E9D6FB3C6C4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87227" y="1334875"/>
                <a:ext cx="900000" cy="13215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1" name="Immagine 20">
                <a:extLst>
                  <a:ext uri="{FF2B5EF4-FFF2-40B4-BE49-F238E27FC236}">
                    <a16:creationId xmlns:a16="http://schemas.microsoft.com/office/drawing/2014/main" id="{41C02666-9C15-4B6B-9F98-1F779AC8C45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87227" y="1514635"/>
                <a:ext cx="900000" cy="13215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2" name="Immagine 21">
                <a:extLst>
                  <a:ext uri="{FF2B5EF4-FFF2-40B4-BE49-F238E27FC236}">
                    <a16:creationId xmlns:a16="http://schemas.microsoft.com/office/drawing/2014/main" id="{684B9493-A379-45AC-946B-448073C0F22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87227" y="1688361"/>
                <a:ext cx="900000" cy="13215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3" name="Immagine 22">
                <a:extLst>
                  <a:ext uri="{FF2B5EF4-FFF2-40B4-BE49-F238E27FC236}">
                    <a16:creationId xmlns:a16="http://schemas.microsoft.com/office/drawing/2014/main" id="{498E552A-220B-4B74-9E32-4CA1D1533B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87227" y="1861869"/>
                <a:ext cx="900000" cy="13215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4" name="CasellaDiTesto 23">
                <a:extLst>
                  <a:ext uri="{FF2B5EF4-FFF2-40B4-BE49-F238E27FC236}">
                    <a16:creationId xmlns:a16="http://schemas.microsoft.com/office/drawing/2014/main" id="{8E1AE8B0-B44D-4740-8675-6C05D5BE6D6B}"/>
                  </a:ext>
                </a:extLst>
              </p:cNvPr>
              <p:cNvSpPr txBox="1"/>
              <p:nvPr/>
            </p:nvSpPr>
            <p:spPr>
              <a:xfrm>
                <a:off x="1149127" y="1615938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2</a:t>
                </a:r>
              </a:p>
            </p:txBody>
          </p:sp>
          <p:sp>
            <p:nvSpPr>
              <p:cNvPr id="25" name="CasellaDiTesto 24">
                <a:extLst>
                  <a:ext uri="{FF2B5EF4-FFF2-40B4-BE49-F238E27FC236}">
                    <a16:creationId xmlns:a16="http://schemas.microsoft.com/office/drawing/2014/main" id="{29B3F150-3B67-41B2-AF28-5102129AE4E7}"/>
                  </a:ext>
                </a:extLst>
              </p:cNvPr>
              <p:cNvSpPr txBox="1"/>
              <p:nvPr/>
            </p:nvSpPr>
            <p:spPr>
              <a:xfrm>
                <a:off x="1149127" y="1442212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516-CHK2</a:t>
                </a:r>
              </a:p>
            </p:txBody>
          </p:sp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8A9B2E0A-7802-4E14-86D9-47C5FF928DEB}"/>
                  </a:ext>
                </a:extLst>
              </p:cNvPr>
              <p:cNvSpPr txBox="1"/>
              <p:nvPr/>
            </p:nvSpPr>
            <p:spPr>
              <a:xfrm>
                <a:off x="752276" y="736035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C2456C45-847D-4F89-8B8F-D7BA4CF0E286}"/>
                  </a:ext>
                </a:extLst>
              </p:cNvPr>
              <p:cNvSpPr txBox="1"/>
              <p:nvPr/>
            </p:nvSpPr>
            <p:spPr>
              <a:xfrm>
                <a:off x="277755" y="736035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28" name="CasellaDiTesto 27">
                <a:extLst>
                  <a:ext uri="{FF2B5EF4-FFF2-40B4-BE49-F238E27FC236}">
                    <a16:creationId xmlns:a16="http://schemas.microsoft.com/office/drawing/2014/main" id="{BCB925D4-B5EC-48BC-B109-8B91140B09AC}"/>
                  </a:ext>
                </a:extLst>
              </p:cNvPr>
              <p:cNvSpPr txBox="1"/>
              <p:nvPr/>
            </p:nvSpPr>
            <p:spPr>
              <a:xfrm>
                <a:off x="526790" y="736035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</p:grp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A6CFB1FB-CEA1-446F-8720-0ED65F5C01DB}"/>
                </a:ext>
              </a:extLst>
            </p:cNvPr>
            <p:cNvSpPr txBox="1"/>
            <p:nvPr/>
          </p:nvSpPr>
          <p:spPr>
            <a:xfrm>
              <a:off x="468048" y="1637537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/>
                <a:t>MCF-7</a:t>
              </a:r>
              <a:endParaRPr lang="it-IT" sz="1200" dirty="0"/>
            </a:p>
          </p:txBody>
        </p:sp>
      </p:grpSp>
      <p:grpSp>
        <p:nvGrpSpPr>
          <p:cNvPr id="29" name="Gruppo 28">
            <a:extLst>
              <a:ext uri="{FF2B5EF4-FFF2-40B4-BE49-F238E27FC236}">
                <a16:creationId xmlns:a16="http://schemas.microsoft.com/office/drawing/2014/main" id="{38D762EF-BC13-4003-B18A-1338D9885139}"/>
              </a:ext>
            </a:extLst>
          </p:cNvPr>
          <p:cNvGrpSpPr/>
          <p:nvPr/>
        </p:nvGrpSpPr>
        <p:grpSpPr>
          <a:xfrm>
            <a:off x="4413181" y="1068595"/>
            <a:ext cx="1958529" cy="1559189"/>
            <a:chOff x="4047627" y="286270"/>
            <a:chExt cx="1958529" cy="1559189"/>
          </a:xfrm>
        </p:grpSpPr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AF3138E4-5C13-44E7-9DC1-B22B0BB906EA}"/>
                </a:ext>
              </a:extLst>
            </p:cNvPr>
            <p:cNvSpPr txBox="1"/>
            <p:nvPr/>
          </p:nvSpPr>
          <p:spPr>
            <a:xfrm>
              <a:off x="4173556" y="1568460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Y537S</a:t>
              </a:r>
            </a:p>
          </p:txBody>
        </p:sp>
        <p:grpSp>
          <p:nvGrpSpPr>
            <p:cNvPr id="31" name="Gruppo 30">
              <a:extLst>
                <a:ext uri="{FF2B5EF4-FFF2-40B4-BE49-F238E27FC236}">
                  <a16:creationId xmlns:a16="http://schemas.microsoft.com/office/drawing/2014/main" id="{310C19F4-CCFD-4EE1-A2FD-56A2BEBB3421}"/>
                </a:ext>
              </a:extLst>
            </p:cNvPr>
            <p:cNvGrpSpPr/>
            <p:nvPr/>
          </p:nvGrpSpPr>
          <p:grpSpPr>
            <a:xfrm>
              <a:off x="4047627" y="286270"/>
              <a:ext cx="1958529" cy="1344260"/>
              <a:chOff x="318350" y="346087"/>
              <a:chExt cx="1958529" cy="1344260"/>
            </a:xfrm>
          </p:grpSpPr>
          <p:pic>
            <p:nvPicPr>
              <p:cNvPr id="32" name="Immagine 31">
                <a:extLst>
                  <a:ext uri="{FF2B5EF4-FFF2-40B4-BE49-F238E27FC236}">
                    <a16:creationId xmlns:a16="http://schemas.microsoft.com/office/drawing/2014/main" id="{E5D888AB-9BE9-499B-B43F-62A501F5C9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327822" y="774122"/>
                <a:ext cx="900000" cy="13215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3" name="CasellaDiTesto 32">
                <a:extLst>
                  <a:ext uri="{FF2B5EF4-FFF2-40B4-BE49-F238E27FC236}">
                    <a16:creationId xmlns:a16="http://schemas.microsoft.com/office/drawing/2014/main" id="{510A1B30-1DD8-4983-A787-004250A33F14}"/>
                  </a:ext>
                </a:extLst>
              </p:cNvPr>
              <p:cNvSpPr txBox="1"/>
              <p:nvPr/>
            </p:nvSpPr>
            <p:spPr>
              <a:xfrm>
                <a:off x="1189722" y="872504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1</a:t>
                </a:r>
              </a:p>
            </p:txBody>
          </p:sp>
          <p:sp>
            <p:nvSpPr>
              <p:cNvPr id="34" name="CasellaDiTesto 33">
                <a:extLst>
                  <a:ext uri="{FF2B5EF4-FFF2-40B4-BE49-F238E27FC236}">
                    <a16:creationId xmlns:a16="http://schemas.microsoft.com/office/drawing/2014/main" id="{6C627538-E8B5-4450-A5CE-51F8B62BCD15}"/>
                  </a:ext>
                </a:extLst>
              </p:cNvPr>
              <p:cNvSpPr txBox="1"/>
              <p:nvPr/>
            </p:nvSpPr>
            <p:spPr>
              <a:xfrm>
                <a:off x="1189722" y="1385648"/>
                <a:ext cx="652102" cy="3046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Vinculin</a:t>
                </a:r>
                <a:endParaRPr lang="it-IT" sz="1200" dirty="0"/>
              </a:p>
            </p:txBody>
          </p:sp>
          <p:sp>
            <p:nvSpPr>
              <p:cNvPr id="35" name="CasellaDiTesto 34">
                <a:extLst>
                  <a:ext uri="{FF2B5EF4-FFF2-40B4-BE49-F238E27FC236}">
                    <a16:creationId xmlns:a16="http://schemas.microsoft.com/office/drawing/2014/main" id="{43C59D76-31D2-4A1C-9A7A-E4740AC1DF23}"/>
                  </a:ext>
                </a:extLst>
              </p:cNvPr>
              <p:cNvSpPr txBox="1"/>
              <p:nvPr/>
            </p:nvSpPr>
            <p:spPr>
              <a:xfrm>
                <a:off x="1189722" y="701698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296-CHK1</a:t>
                </a:r>
              </a:p>
            </p:txBody>
          </p:sp>
          <p:sp>
            <p:nvSpPr>
              <p:cNvPr id="36" name="CasellaDiTesto 35">
                <a:extLst>
                  <a:ext uri="{FF2B5EF4-FFF2-40B4-BE49-F238E27FC236}">
                    <a16:creationId xmlns:a16="http://schemas.microsoft.com/office/drawing/2014/main" id="{CDC722C6-5466-4D8E-81F4-67A5E0C14CE1}"/>
                  </a:ext>
                </a:extLst>
              </p:cNvPr>
              <p:cNvSpPr txBox="1"/>
              <p:nvPr/>
            </p:nvSpPr>
            <p:spPr>
              <a:xfrm>
                <a:off x="318350" y="532726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37" name="CasellaDiTesto 36">
                <a:extLst>
                  <a:ext uri="{FF2B5EF4-FFF2-40B4-BE49-F238E27FC236}">
                    <a16:creationId xmlns:a16="http://schemas.microsoft.com/office/drawing/2014/main" id="{FF08A1A6-DC55-4626-8A6C-EC2B3BCCAC02}"/>
                  </a:ext>
                </a:extLst>
              </p:cNvPr>
              <p:cNvSpPr txBox="1"/>
              <p:nvPr/>
            </p:nvSpPr>
            <p:spPr>
              <a:xfrm>
                <a:off x="548149" y="532726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38" name="CasellaDiTesto 37">
                <a:extLst>
                  <a:ext uri="{FF2B5EF4-FFF2-40B4-BE49-F238E27FC236}">
                    <a16:creationId xmlns:a16="http://schemas.microsoft.com/office/drawing/2014/main" id="{721B1551-A194-4145-8B2F-2E5CECD2D4F2}"/>
                  </a:ext>
                </a:extLst>
              </p:cNvPr>
              <p:cNvSpPr txBox="1"/>
              <p:nvPr/>
            </p:nvSpPr>
            <p:spPr>
              <a:xfrm>
                <a:off x="812107" y="532726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39" name="CasellaDiTesto 38">
                <a:extLst>
                  <a:ext uri="{FF2B5EF4-FFF2-40B4-BE49-F238E27FC236}">
                    <a16:creationId xmlns:a16="http://schemas.microsoft.com/office/drawing/2014/main" id="{5D6F3B4F-3590-413F-B3A5-CA84E51AD1DD}"/>
                  </a:ext>
                </a:extLst>
              </p:cNvPr>
              <p:cNvSpPr txBox="1"/>
              <p:nvPr/>
            </p:nvSpPr>
            <p:spPr>
              <a:xfrm>
                <a:off x="993156" y="532726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40" name="CasellaDiTesto 39">
                <a:extLst>
                  <a:ext uri="{FF2B5EF4-FFF2-40B4-BE49-F238E27FC236}">
                    <a16:creationId xmlns:a16="http://schemas.microsoft.com/office/drawing/2014/main" id="{4A532B61-FFB3-41DE-8D54-E7F2F622C570}"/>
                  </a:ext>
                </a:extLst>
              </p:cNvPr>
              <p:cNvSpPr txBox="1"/>
              <p:nvPr/>
            </p:nvSpPr>
            <p:spPr>
              <a:xfrm>
                <a:off x="993156" y="346087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41" name="CasellaDiTesto 40">
                <a:extLst>
                  <a:ext uri="{FF2B5EF4-FFF2-40B4-BE49-F238E27FC236}">
                    <a16:creationId xmlns:a16="http://schemas.microsoft.com/office/drawing/2014/main" id="{5CD8059A-B870-440D-AB30-626FD90E6D3D}"/>
                  </a:ext>
                </a:extLst>
              </p:cNvPr>
              <p:cNvSpPr txBox="1"/>
              <p:nvPr/>
            </p:nvSpPr>
            <p:spPr>
              <a:xfrm>
                <a:off x="1189722" y="532726"/>
                <a:ext cx="49930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ETO</a:t>
                </a:r>
              </a:p>
            </p:txBody>
          </p:sp>
          <p:cxnSp>
            <p:nvCxnSpPr>
              <p:cNvPr id="42" name="Connettore diritto 41">
                <a:extLst>
                  <a:ext uri="{FF2B5EF4-FFF2-40B4-BE49-F238E27FC236}">
                    <a16:creationId xmlns:a16="http://schemas.microsoft.com/office/drawing/2014/main" id="{A14814C8-DDC2-42C7-8A4E-0FBAAFD8F9C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28977" y="484586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3" name="CasellaDiTesto 42">
                <a:extLst>
                  <a:ext uri="{FF2B5EF4-FFF2-40B4-BE49-F238E27FC236}">
                    <a16:creationId xmlns:a16="http://schemas.microsoft.com/office/drawing/2014/main" id="{3465F762-07CB-4082-B1A1-36927A8028C8}"/>
                  </a:ext>
                </a:extLst>
              </p:cNvPr>
              <p:cNvSpPr txBox="1"/>
              <p:nvPr/>
            </p:nvSpPr>
            <p:spPr>
              <a:xfrm>
                <a:off x="1189722" y="346087"/>
                <a:ext cx="101601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it-IT" sz="1200" dirty="0"/>
                  <a:t>AZD</a:t>
                </a:r>
              </a:p>
            </p:txBody>
          </p:sp>
          <p:sp>
            <p:nvSpPr>
              <p:cNvPr id="44" name="CasellaDiTesto 43">
                <a:extLst>
                  <a:ext uri="{FF2B5EF4-FFF2-40B4-BE49-F238E27FC236}">
                    <a16:creationId xmlns:a16="http://schemas.microsoft.com/office/drawing/2014/main" id="{51FE9AB2-1FD9-49D8-89AF-D5947D79FC5A}"/>
                  </a:ext>
                </a:extLst>
              </p:cNvPr>
              <p:cNvSpPr txBox="1"/>
              <p:nvPr/>
            </p:nvSpPr>
            <p:spPr>
              <a:xfrm>
                <a:off x="1189722" y="1225990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2</a:t>
                </a:r>
              </a:p>
            </p:txBody>
          </p:sp>
          <p:sp>
            <p:nvSpPr>
              <p:cNvPr id="45" name="CasellaDiTesto 44">
                <a:extLst>
                  <a:ext uri="{FF2B5EF4-FFF2-40B4-BE49-F238E27FC236}">
                    <a16:creationId xmlns:a16="http://schemas.microsoft.com/office/drawing/2014/main" id="{77D0374E-8749-47DA-B4D5-5478C59B3832}"/>
                  </a:ext>
                </a:extLst>
              </p:cNvPr>
              <p:cNvSpPr txBox="1"/>
              <p:nvPr/>
            </p:nvSpPr>
            <p:spPr>
              <a:xfrm>
                <a:off x="1189722" y="1052264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516-CHK2</a:t>
                </a:r>
              </a:p>
            </p:txBody>
          </p:sp>
          <p:sp>
            <p:nvSpPr>
              <p:cNvPr id="46" name="CasellaDiTesto 45">
                <a:extLst>
                  <a:ext uri="{FF2B5EF4-FFF2-40B4-BE49-F238E27FC236}">
                    <a16:creationId xmlns:a16="http://schemas.microsoft.com/office/drawing/2014/main" id="{8A432CE0-6DC3-440C-A5B3-73B4273FFE84}"/>
                  </a:ext>
                </a:extLst>
              </p:cNvPr>
              <p:cNvSpPr txBox="1"/>
              <p:nvPr/>
            </p:nvSpPr>
            <p:spPr>
              <a:xfrm>
                <a:off x="792871" y="346087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47" name="CasellaDiTesto 46">
                <a:extLst>
                  <a:ext uri="{FF2B5EF4-FFF2-40B4-BE49-F238E27FC236}">
                    <a16:creationId xmlns:a16="http://schemas.microsoft.com/office/drawing/2014/main" id="{B69FBD55-79E4-48DF-A44E-6847D19E272B}"/>
                  </a:ext>
                </a:extLst>
              </p:cNvPr>
              <p:cNvSpPr txBox="1"/>
              <p:nvPr/>
            </p:nvSpPr>
            <p:spPr>
              <a:xfrm>
                <a:off x="318350" y="346087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48" name="CasellaDiTesto 47">
                <a:extLst>
                  <a:ext uri="{FF2B5EF4-FFF2-40B4-BE49-F238E27FC236}">
                    <a16:creationId xmlns:a16="http://schemas.microsoft.com/office/drawing/2014/main" id="{174FAB72-E86C-4F7B-9F59-34E59EF1F9B2}"/>
                  </a:ext>
                </a:extLst>
              </p:cNvPr>
              <p:cNvSpPr txBox="1"/>
              <p:nvPr/>
            </p:nvSpPr>
            <p:spPr>
              <a:xfrm>
                <a:off x="567385" y="346087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pic>
            <p:nvPicPr>
              <p:cNvPr id="49" name="Immagine 48">
                <a:extLst>
                  <a:ext uri="{FF2B5EF4-FFF2-40B4-BE49-F238E27FC236}">
                    <a16:creationId xmlns:a16="http://schemas.microsoft.com/office/drawing/2014/main" id="{C09BC711-2BB5-45CD-B99A-6CE823EB3A0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327822" y="944927"/>
                <a:ext cx="900000" cy="13215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0" name="Immagine 49">
                <a:extLst>
                  <a:ext uri="{FF2B5EF4-FFF2-40B4-BE49-F238E27FC236}">
                    <a16:creationId xmlns:a16="http://schemas.microsoft.com/office/drawing/2014/main" id="{F6057446-2A62-41BB-8042-7E183F6C5C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27822" y="1471921"/>
                <a:ext cx="900000" cy="13215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1" name="Immagine 50">
                <a:extLst>
                  <a:ext uri="{FF2B5EF4-FFF2-40B4-BE49-F238E27FC236}">
                    <a16:creationId xmlns:a16="http://schemas.microsoft.com/office/drawing/2014/main" id="{9D4D3D04-4033-4E20-8424-1392AE10D4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27822" y="1130708"/>
                <a:ext cx="900000" cy="12613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2" name="Immagine 51">
                <a:extLst>
                  <a:ext uri="{FF2B5EF4-FFF2-40B4-BE49-F238E27FC236}">
                    <a16:creationId xmlns:a16="http://schemas.microsoft.com/office/drawing/2014/main" id="{E3052510-D8FB-41EE-82AF-A843C257DD2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327822" y="1298414"/>
                <a:ext cx="900000" cy="13215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</p:grpSp>
      <p:grpSp>
        <p:nvGrpSpPr>
          <p:cNvPr id="107" name="Gruppo 106">
            <a:extLst>
              <a:ext uri="{FF2B5EF4-FFF2-40B4-BE49-F238E27FC236}">
                <a16:creationId xmlns:a16="http://schemas.microsoft.com/office/drawing/2014/main" id="{6F14921F-B604-4C2F-AEDF-598971B3064F}"/>
              </a:ext>
            </a:extLst>
          </p:cNvPr>
          <p:cNvGrpSpPr/>
          <p:nvPr/>
        </p:nvGrpSpPr>
        <p:grpSpPr>
          <a:xfrm>
            <a:off x="608276" y="3119382"/>
            <a:ext cx="1812612" cy="1668642"/>
            <a:chOff x="759702" y="3150766"/>
            <a:chExt cx="1812612" cy="1668642"/>
          </a:xfrm>
        </p:grpSpPr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id="{3AE27A51-B173-4882-A079-6ED7957177BE}"/>
                </a:ext>
              </a:extLst>
            </p:cNvPr>
            <p:cNvSpPr txBox="1"/>
            <p:nvPr/>
          </p:nvSpPr>
          <p:spPr>
            <a:xfrm>
              <a:off x="759702" y="4542409"/>
              <a:ext cx="12089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200" dirty="0"/>
                <a:t>MCF-7</a:t>
              </a:r>
            </a:p>
          </p:txBody>
        </p:sp>
        <p:pic>
          <p:nvPicPr>
            <p:cNvPr id="69" name="Immagine 68">
              <a:extLst>
                <a:ext uri="{FF2B5EF4-FFF2-40B4-BE49-F238E27FC236}">
                  <a16:creationId xmlns:a16="http://schemas.microsoft.com/office/drawing/2014/main" id="{88F17B7A-3CA8-4166-914E-5E86317D2436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799833" y="3887804"/>
              <a:ext cx="1080000" cy="191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0" name="Immagine 69">
              <a:extLst>
                <a:ext uri="{FF2B5EF4-FFF2-40B4-BE49-F238E27FC236}">
                  <a16:creationId xmlns:a16="http://schemas.microsoft.com/office/drawing/2014/main" id="{DE610C82-3871-4844-8661-1D646FE0EFA5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799833" y="4132481"/>
              <a:ext cx="1080000" cy="191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1" name="Immagine 70">
              <a:extLst>
                <a:ext uri="{FF2B5EF4-FFF2-40B4-BE49-F238E27FC236}">
                  <a16:creationId xmlns:a16="http://schemas.microsoft.com/office/drawing/2014/main" id="{7AF5B02D-798C-4B1C-BB65-1BC4BE674882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799833" y="4375720"/>
              <a:ext cx="1080000" cy="191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2" name="CasellaDiTesto 71">
              <a:extLst>
                <a:ext uri="{FF2B5EF4-FFF2-40B4-BE49-F238E27FC236}">
                  <a16:creationId xmlns:a16="http://schemas.microsoft.com/office/drawing/2014/main" id="{1F966943-00D9-4A79-BA08-31C844E68008}"/>
                </a:ext>
              </a:extLst>
            </p:cNvPr>
            <p:cNvSpPr txBox="1"/>
            <p:nvPr/>
          </p:nvSpPr>
          <p:spPr>
            <a:xfrm rot="16200000">
              <a:off x="1075011" y="351763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HK1</a:t>
              </a:r>
            </a:p>
          </p:txBody>
        </p:sp>
        <p:sp>
          <p:nvSpPr>
            <p:cNvPr id="73" name="CasellaDiTesto 72">
              <a:extLst>
                <a:ext uri="{FF2B5EF4-FFF2-40B4-BE49-F238E27FC236}">
                  <a16:creationId xmlns:a16="http://schemas.microsoft.com/office/drawing/2014/main" id="{468E6A9A-8261-4C8F-AEF5-B35669F54A25}"/>
                </a:ext>
              </a:extLst>
            </p:cNvPr>
            <p:cNvSpPr txBox="1"/>
            <p:nvPr/>
          </p:nvSpPr>
          <p:spPr>
            <a:xfrm rot="16200000">
              <a:off x="1400083" y="351763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HK2</a:t>
              </a:r>
            </a:p>
          </p:txBody>
        </p:sp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0F218BBB-7C36-4145-9FE8-9C1EB8D19CEA}"/>
                </a:ext>
              </a:extLst>
            </p:cNvPr>
            <p:cNvSpPr txBox="1"/>
            <p:nvPr/>
          </p:nvSpPr>
          <p:spPr>
            <a:xfrm rot="16200000">
              <a:off x="766571" y="3564126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TR</a:t>
              </a:r>
            </a:p>
          </p:txBody>
        </p:sp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id="{3BBBA2E8-C340-49EB-9820-7EA19C7A93A4}"/>
                </a:ext>
              </a:extLst>
            </p:cNvPr>
            <p:cNvSpPr txBox="1"/>
            <p:nvPr/>
          </p:nvSpPr>
          <p:spPr>
            <a:xfrm>
              <a:off x="1855002" y="3844905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HK1</a:t>
              </a:r>
            </a:p>
          </p:txBody>
        </p:sp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id="{ACE57ACB-D13F-47A6-8065-F4EF462FA5EF}"/>
                </a:ext>
              </a:extLst>
            </p:cNvPr>
            <p:cNvSpPr txBox="1"/>
            <p:nvPr/>
          </p:nvSpPr>
          <p:spPr>
            <a:xfrm>
              <a:off x="1855002" y="4089582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HK2</a:t>
              </a:r>
            </a:p>
          </p:txBody>
        </p:sp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868912A5-4F58-4ED1-8541-734ED753F2A7}"/>
                </a:ext>
              </a:extLst>
            </p:cNvPr>
            <p:cNvSpPr txBox="1"/>
            <p:nvPr/>
          </p:nvSpPr>
          <p:spPr>
            <a:xfrm>
              <a:off x="1855002" y="4332821"/>
              <a:ext cx="7173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Vinculin</a:t>
              </a:r>
              <a:endParaRPr lang="it-IT" sz="1200" dirty="0"/>
            </a:p>
          </p:txBody>
        </p:sp>
        <p:cxnSp>
          <p:nvCxnSpPr>
            <p:cNvPr id="78" name="Connettore diritto 77">
              <a:extLst>
                <a:ext uri="{FF2B5EF4-FFF2-40B4-BE49-F238E27FC236}">
                  <a16:creationId xmlns:a16="http://schemas.microsoft.com/office/drawing/2014/main" id="{C8763473-0BD8-458F-8D8B-63643E78997C}"/>
                </a:ext>
              </a:extLst>
            </p:cNvPr>
            <p:cNvCxnSpPr>
              <a:cxnSpLocks/>
            </p:cNvCxnSpPr>
            <p:nvPr/>
          </p:nvCxnSpPr>
          <p:spPr>
            <a:xfrm>
              <a:off x="971203" y="3406517"/>
              <a:ext cx="79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9" name="CasellaDiTesto 78">
              <a:extLst>
                <a:ext uri="{FF2B5EF4-FFF2-40B4-BE49-F238E27FC236}">
                  <a16:creationId xmlns:a16="http://schemas.microsoft.com/office/drawing/2014/main" id="{4B66F6DB-F246-4B99-A766-2A5E01265D7C}"/>
                </a:ext>
              </a:extLst>
            </p:cNvPr>
            <p:cNvSpPr txBox="1"/>
            <p:nvPr/>
          </p:nvSpPr>
          <p:spPr>
            <a:xfrm>
              <a:off x="1057663" y="3150766"/>
              <a:ext cx="6190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siRNA</a:t>
              </a:r>
              <a:endParaRPr lang="it-IT" sz="1200" dirty="0"/>
            </a:p>
          </p:txBody>
        </p:sp>
      </p:grpSp>
      <p:grpSp>
        <p:nvGrpSpPr>
          <p:cNvPr id="106" name="Gruppo 105">
            <a:extLst>
              <a:ext uri="{FF2B5EF4-FFF2-40B4-BE49-F238E27FC236}">
                <a16:creationId xmlns:a16="http://schemas.microsoft.com/office/drawing/2014/main" id="{75F22434-CC31-449D-9D0F-0ABE5E91E8AE}"/>
              </a:ext>
            </a:extLst>
          </p:cNvPr>
          <p:cNvGrpSpPr/>
          <p:nvPr/>
        </p:nvGrpSpPr>
        <p:grpSpPr>
          <a:xfrm>
            <a:off x="4280684" y="3119382"/>
            <a:ext cx="1812612" cy="1668642"/>
            <a:chOff x="2750368" y="2446050"/>
            <a:chExt cx="1812612" cy="1668642"/>
          </a:xfrm>
        </p:grpSpPr>
        <p:pic>
          <p:nvPicPr>
            <p:cNvPr id="91" name="Immagine 90">
              <a:extLst>
                <a:ext uri="{FF2B5EF4-FFF2-40B4-BE49-F238E27FC236}">
                  <a16:creationId xmlns:a16="http://schemas.microsoft.com/office/drawing/2014/main" id="{A743E07C-756E-4434-8C37-3253AC0C67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790499" y="3183088"/>
              <a:ext cx="1080000" cy="17584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2" name="Immagine 91">
              <a:extLst>
                <a:ext uri="{FF2B5EF4-FFF2-40B4-BE49-F238E27FC236}">
                  <a16:creationId xmlns:a16="http://schemas.microsoft.com/office/drawing/2014/main" id="{905C8474-2052-4F5F-A833-2F6C460DB2C0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790499" y="3427765"/>
              <a:ext cx="1080000" cy="17584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3" name="Immagine 92">
              <a:extLst>
                <a:ext uri="{FF2B5EF4-FFF2-40B4-BE49-F238E27FC236}">
                  <a16:creationId xmlns:a16="http://schemas.microsoft.com/office/drawing/2014/main" id="{999F38A6-FB78-4EB0-891D-50DA26A903E6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790499" y="3671004"/>
              <a:ext cx="1080000" cy="1741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4" name="CasellaDiTesto 93">
              <a:extLst>
                <a:ext uri="{FF2B5EF4-FFF2-40B4-BE49-F238E27FC236}">
                  <a16:creationId xmlns:a16="http://schemas.microsoft.com/office/drawing/2014/main" id="{F38ACBCA-5C2D-4E24-862A-CBD81AAA5C21}"/>
                </a:ext>
              </a:extLst>
            </p:cNvPr>
            <p:cNvSpPr txBox="1"/>
            <p:nvPr/>
          </p:nvSpPr>
          <p:spPr>
            <a:xfrm>
              <a:off x="2750368" y="3837693"/>
              <a:ext cx="12089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200" dirty="0"/>
                <a:t>Y537S</a:t>
              </a:r>
            </a:p>
          </p:txBody>
        </p:sp>
        <p:sp>
          <p:nvSpPr>
            <p:cNvPr id="98" name="CasellaDiTesto 97">
              <a:extLst>
                <a:ext uri="{FF2B5EF4-FFF2-40B4-BE49-F238E27FC236}">
                  <a16:creationId xmlns:a16="http://schemas.microsoft.com/office/drawing/2014/main" id="{228A1D0F-8D90-48CA-8771-FD0F31024198}"/>
                </a:ext>
              </a:extLst>
            </p:cNvPr>
            <p:cNvSpPr txBox="1"/>
            <p:nvPr/>
          </p:nvSpPr>
          <p:spPr>
            <a:xfrm rot="16200000">
              <a:off x="3065677" y="2812923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HK1</a:t>
              </a:r>
            </a:p>
          </p:txBody>
        </p:sp>
        <p:sp>
          <p:nvSpPr>
            <p:cNvPr id="99" name="CasellaDiTesto 98">
              <a:extLst>
                <a:ext uri="{FF2B5EF4-FFF2-40B4-BE49-F238E27FC236}">
                  <a16:creationId xmlns:a16="http://schemas.microsoft.com/office/drawing/2014/main" id="{7DF61D0F-1C36-4913-A47A-59C81355FDB0}"/>
                </a:ext>
              </a:extLst>
            </p:cNvPr>
            <p:cNvSpPr txBox="1"/>
            <p:nvPr/>
          </p:nvSpPr>
          <p:spPr>
            <a:xfrm rot="16200000">
              <a:off x="3390749" y="2812923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HK2</a:t>
              </a:r>
            </a:p>
          </p:txBody>
        </p:sp>
        <p:sp>
          <p:nvSpPr>
            <p:cNvPr id="100" name="CasellaDiTesto 99">
              <a:extLst>
                <a:ext uri="{FF2B5EF4-FFF2-40B4-BE49-F238E27FC236}">
                  <a16:creationId xmlns:a16="http://schemas.microsoft.com/office/drawing/2014/main" id="{643BADCE-DAA0-4CF8-8977-1F54DE9C0732}"/>
                </a:ext>
              </a:extLst>
            </p:cNvPr>
            <p:cNvSpPr txBox="1"/>
            <p:nvPr/>
          </p:nvSpPr>
          <p:spPr>
            <a:xfrm rot="16200000">
              <a:off x="2757237" y="2859410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TR</a:t>
              </a:r>
            </a:p>
          </p:txBody>
        </p:sp>
        <p:sp>
          <p:nvSpPr>
            <p:cNvPr id="101" name="CasellaDiTesto 100">
              <a:extLst>
                <a:ext uri="{FF2B5EF4-FFF2-40B4-BE49-F238E27FC236}">
                  <a16:creationId xmlns:a16="http://schemas.microsoft.com/office/drawing/2014/main" id="{D61286CB-C585-4E83-BC18-6BE0563E77B4}"/>
                </a:ext>
              </a:extLst>
            </p:cNvPr>
            <p:cNvSpPr txBox="1"/>
            <p:nvPr/>
          </p:nvSpPr>
          <p:spPr>
            <a:xfrm>
              <a:off x="3845668" y="314018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HK1</a:t>
              </a:r>
            </a:p>
          </p:txBody>
        </p:sp>
        <p:sp>
          <p:nvSpPr>
            <p:cNvPr id="102" name="CasellaDiTesto 101">
              <a:extLst>
                <a:ext uri="{FF2B5EF4-FFF2-40B4-BE49-F238E27FC236}">
                  <a16:creationId xmlns:a16="http://schemas.microsoft.com/office/drawing/2014/main" id="{159C6311-9408-4DD9-A12E-EC2CAEE7650E}"/>
                </a:ext>
              </a:extLst>
            </p:cNvPr>
            <p:cNvSpPr txBox="1"/>
            <p:nvPr/>
          </p:nvSpPr>
          <p:spPr>
            <a:xfrm>
              <a:off x="3845668" y="3384866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HK2</a:t>
              </a:r>
            </a:p>
          </p:txBody>
        </p:sp>
        <p:sp>
          <p:nvSpPr>
            <p:cNvPr id="103" name="CasellaDiTesto 102">
              <a:extLst>
                <a:ext uri="{FF2B5EF4-FFF2-40B4-BE49-F238E27FC236}">
                  <a16:creationId xmlns:a16="http://schemas.microsoft.com/office/drawing/2014/main" id="{877E5133-4F57-41CB-AAB2-5DE8ACD6E5CD}"/>
                </a:ext>
              </a:extLst>
            </p:cNvPr>
            <p:cNvSpPr txBox="1"/>
            <p:nvPr/>
          </p:nvSpPr>
          <p:spPr>
            <a:xfrm>
              <a:off x="3845668" y="3628105"/>
              <a:ext cx="7173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Vinculin</a:t>
              </a:r>
              <a:endParaRPr lang="it-IT" sz="1200" dirty="0"/>
            </a:p>
          </p:txBody>
        </p:sp>
        <p:cxnSp>
          <p:nvCxnSpPr>
            <p:cNvPr id="104" name="Connettore diritto 103">
              <a:extLst>
                <a:ext uri="{FF2B5EF4-FFF2-40B4-BE49-F238E27FC236}">
                  <a16:creationId xmlns:a16="http://schemas.microsoft.com/office/drawing/2014/main" id="{339FE0BE-7D03-430B-A299-D3E9DB614E37}"/>
                </a:ext>
              </a:extLst>
            </p:cNvPr>
            <p:cNvCxnSpPr>
              <a:cxnSpLocks/>
            </p:cNvCxnSpPr>
            <p:nvPr/>
          </p:nvCxnSpPr>
          <p:spPr>
            <a:xfrm>
              <a:off x="2961869" y="2701801"/>
              <a:ext cx="79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5" name="CasellaDiTesto 104">
              <a:extLst>
                <a:ext uri="{FF2B5EF4-FFF2-40B4-BE49-F238E27FC236}">
                  <a16:creationId xmlns:a16="http://schemas.microsoft.com/office/drawing/2014/main" id="{2EFD1BA4-E258-4BEE-A25B-1A61F015FE8A}"/>
                </a:ext>
              </a:extLst>
            </p:cNvPr>
            <p:cNvSpPr txBox="1"/>
            <p:nvPr/>
          </p:nvSpPr>
          <p:spPr>
            <a:xfrm>
              <a:off x="3048329" y="2446050"/>
              <a:ext cx="6190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siRNA</a:t>
              </a:r>
              <a:endParaRPr lang="it-IT" sz="1200" dirty="0"/>
            </a:p>
          </p:txBody>
        </p:sp>
      </p:grpSp>
      <p:sp>
        <p:nvSpPr>
          <p:cNvPr id="108" name="CasellaDiTesto 107">
            <a:extLst>
              <a:ext uri="{FF2B5EF4-FFF2-40B4-BE49-F238E27FC236}">
                <a16:creationId xmlns:a16="http://schemas.microsoft.com/office/drawing/2014/main" id="{F78640A8-F501-4342-8743-960CDACC9017}"/>
              </a:ext>
            </a:extLst>
          </p:cNvPr>
          <p:cNvSpPr txBox="1"/>
          <p:nvPr/>
        </p:nvSpPr>
        <p:spPr>
          <a:xfrm>
            <a:off x="66063" y="292032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C</a:t>
            </a:r>
          </a:p>
        </p:txBody>
      </p:sp>
      <p:sp>
        <p:nvSpPr>
          <p:cNvPr id="109" name="CasellaDiTesto 108">
            <a:extLst>
              <a:ext uri="{FF2B5EF4-FFF2-40B4-BE49-F238E27FC236}">
                <a16:creationId xmlns:a16="http://schemas.microsoft.com/office/drawing/2014/main" id="{26753312-09A3-447F-AD66-7109FDC76B85}"/>
              </a:ext>
            </a:extLst>
          </p:cNvPr>
          <p:cNvSpPr txBox="1"/>
          <p:nvPr/>
        </p:nvSpPr>
        <p:spPr>
          <a:xfrm>
            <a:off x="3435942" y="2920323"/>
            <a:ext cx="304801" cy="279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8983671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679DF6DD-401B-4B6E-8DD9-2162C4739EFA}"/>
              </a:ext>
            </a:extLst>
          </p:cNvPr>
          <p:cNvSpPr txBox="1"/>
          <p:nvPr/>
        </p:nvSpPr>
        <p:spPr>
          <a:xfrm>
            <a:off x="2022205" y="142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ure 2</a:t>
            </a:r>
          </a:p>
        </p:txBody>
      </p:sp>
      <p:sp>
        <p:nvSpPr>
          <p:cNvPr id="127" name="CasellaDiTesto 126">
            <a:extLst>
              <a:ext uri="{FF2B5EF4-FFF2-40B4-BE49-F238E27FC236}">
                <a16:creationId xmlns:a16="http://schemas.microsoft.com/office/drawing/2014/main" id="{C1716853-7C20-4737-B3CF-BD3E961FACD2}"/>
              </a:ext>
            </a:extLst>
          </p:cNvPr>
          <p:cNvSpPr txBox="1"/>
          <p:nvPr/>
        </p:nvSpPr>
        <p:spPr>
          <a:xfrm>
            <a:off x="93588" y="46458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A</a:t>
            </a:r>
          </a:p>
        </p:txBody>
      </p:sp>
      <p:sp>
        <p:nvSpPr>
          <p:cNvPr id="128" name="CasellaDiTesto 127">
            <a:extLst>
              <a:ext uri="{FF2B5EF4-FFF2-40B4-BE49-F238E27FC236}">
                <a16:creationId xmlns:a16="http://schemas.microsoft.com/office/drawing/2014/main" id="{F53807D1-30FA-44A0-BD86-D100476C2641}"/>
              </a:ext>
            </a:extLst>
          </p:cNvPr>
          <p:cNvSpPr txBox="1"/>
          <p:nvPr/>
        </p:nvSpPr>
        <p:spPr>
          <a:xfrm>
            <a:off x="3463467" y="463222"/>
            <a:ext cx="304801" cy="279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B</a:t>
            </a:r>
          </a:p>
        </p:txBody>
      </p:sp>
      <p:sp>
        <p:nvSpPr>
          <p:cNvPr id="129" name="CasellaDiTesto 128">
            <a:extLst>
              <a:ext uri="{FF2B5EF4-FFF2-40B4-BE49-F238E27FC236}">
                <a16:creationId xmlns:a16="http://schemas.microsoft.com/office/drawing/2014/main" id="{3FFC30D5-FCFD-4C38-94E5-AB886928114E}"/>
              </a:ext>
            </a:extLst>
          </p:cNvPr>
          <p:cNvSpPr txBox="1"/>
          <p:nvPr/>
        </p:nvSpPr>
        <p:spPr>
          <a:xfrm>
            <a:off x="88825" y="2420071"/>
            <a:ext cx="304801" cy="279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C</a:t>
            </a:r>
          </a:p>
        </p:txBody>
      </p:sp>
      <p:sp>
        <p:nvSpPr>
          <p:cNvPr id="130" name="CasellaDiTesto 129">
            <a:extLst>
              <a:ext uri="{FF2B5EF4-FFF2-40B4-BE49-F238E27FC236}">
                <a16:creationId xmlns:a16="http://schemas.microsoft.com/office/drawing/2014/main" id="{634CE04D-1CC3-44E6-A96C-E00BD0874F2D}"/>
              </a:ext>
            </a:extLst>
          </p:cNvPr>
          <p:cNvSpPr txBox="1"/>
          <p:nvPr/>
        </p:nvSpPr>
        <p:spPr>
          <a:xfrm>
            <a:off x="3463467" y="2420071"/>
            <a:ext cx="304801" cy="279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D</a:t>
            </a:r>
          </a:p>
        </p:txBody>
      </p:sp>
      <p:sp>
        <p:nvSpPr>
          <p:cNvPr id="245" name="CasellaDiTesto 244">
            <a:extLst>
              <a:ext uri="{FF2B5EF4-FFF2-40B4-BE49-F238E27FC236}">
                <a16:creationId xmlns:a16="http://schemas.microsoft.com/office/drawing/2014/main" id="{16A1BC1E-C8CC-4281-8830-15C3B2383EF4}"/>
              </a:ext>
            </a:extLst>
          </p:cNvPr>
          <p:cNvSpPr txBox="1"/>
          <p:nvPr/>
        </p:nvSpPr>
        <p:spPr>
          <a:xfrm>
            <a:off x="88825" y="4518602"/>
            <a:ext cx="304801" cy="279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E</a:t>
            </a:r>
          </a:p>
        </p:txBody>
      </p:sp>
      <p:sp>
        <p:nvSpPr>
          <p:cNvPr id="246" name="CasellaDiTesto 245">
            <a:extLst>
              <a:ext uri="{FF2B5EF4-FFF2-40B4-BE49-F238E27FC236}">
                <a16:creationId xmlns:a16="http://schemas.microsoft.com/office/drawing/2014/main" id="{696A89DA-4126-40A4-A8BB-9C74F4C8D2AA}"/>
              </a:ext>
            </a:extLst>
          </p:cNvPr>
          <p:cNvSpPr txBox="1"/>
          <p:nvPr/>
        </p:nvSpPr>
        <p:spPr>
          <a:xfrm>
            <a:off x="3463467" y="4518602"/>
            <a:ext cx="304801" cy="279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F</a:t>
            </a:r>
          </a:p>
        </p:txBody>
      </p:sp>
      <p:sp>
        <p:nvSpPr>
          <p:cNvPr id="247" name="CasellaDiTesto 246">
            <a:extLst>
              <a:ext uri="{FF2B5EF4-FFF2-40B4-BE49-F238E27FC236}">
                <a16:creationId xmlns:a16="http://schemas.microsoft.com/office/drawing/2014/main" id="{BB8EB35A-6288-4AD3-9FDB-3E8AC4B58398}"/>
              </a:ext>
            </a:extLst>
          </p:cNvPr>
          <p:cNvSpPr txBox="1"/>
          <p:nvPr/>
        </p:nvSpPr>
        <p:spPr>
          <a:xfrm>
            <a:off x="88825" y="6084168"/>
            <a:ext cx="304801" cy="279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G</a:t>
            </a:r>
          </a:p>
        </p:txBody>
      </p:sp>
      <p:sp>
        <p:nvSpPr>
          <p:cNvPr id="248" name="CasellaDiTesto 247">
            <a:extLst>
              <a:ext uri="{FF2B5EF4-FFF2-40B4-BE49-F238E27FC236}">
                <a16:creationId xmlns:a16="http://schemas.microsoft.com/office/drawing/2014/main" id="{18791AE6-DD38-42C9-A087-46E89C31E90E}"/>
              </a:ext>
            </a:extLst>
          </p:cNvPr>
          <p:cNvSpPr txBox="1"/>
          <p:nvPr/>
        </p:nvSpPr>
        <p:spPr>
          <a:xfrm>
            <a:off x="3463467" y="6084168"/>
            <a:ext cx="304801" cy="279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H</a:t>
            </a:r>
          </a:p>
        </p:txBody>
      </p:sp>
      <p:grpSp>
        <p:nvGrpSpPr>
          <p:cNvPr id="256" name="Gruppo 255">
            <a:extLst>
              <a:ext uri="{FF2B5EF4-FFF2-40B4-BE49-F238E27FC236}">
                <a16:creationId xmlns:a16="http://schemas.microsoft.com/office/drawing/2014/main" id="{8D053269-16F8-4DEA-86B5-D58D4A9419FA}"/>
              </a:ext>
            </a:extLst>
          </p:cNvPr>
          <p:cNvGrpSpPr/>
          <p:nvPr/>
        </p:nvGrpSpPr>
        <p:grpSpPr>
          <a:xfrm>
            <a:off x="484312" y="4722194"/>
            <a:ext cx="2725834" cy="1276757"/>
            <a:chOff x="484312" y="4722194"/>
            <a:chExt cx="2725834" cy="1276757"/>
          </a:xfrm>
        </p:grpSpPr>
        <p:grpSp>
          <p:nvGrpSpPr>
            <p:cNvPr id="185" name="Gruppo 184">
              <a:extLst>
                <a:ext uri="{FF2B5EF4-FFF2-40B4-BE49-F238E27FC236}">
                  <a16:creationId xmlns:a16="http://schemas.microsoft.com/office/drawing/2014/main" id="{BE3097F8-7A0E-4D89-ACD1-7AC6AC604967}"/>
                </a:ext>
              </a:extLst>
            </p:cNvPr>
            <p:cNvGrpSpPr/>
            <p:nvPr/>
          </p:nvGrpSpPr>
          <p:grpSpPr>
            <a:xfrm>
              <a:off x="484312" y="4722194"/>
              <a:ext cx="2725834" cy="1044757"/>
              <a:chOff x="182611" y="2636534"/>
              <a:chExt cx="2725834" cy="1044757"/>
            </a:xfrm>
          </p:grpSpPr>
          <p:pic>
            <p:nvPicPr>
              <p:cNvPr id="186" name="Immagine 185">
                <a:extLst>
                  <a:ext uri="{FF2B5EF4-FFF2-40B4-BE49-F238E27FC236}">
                    <a16:creationId xmlns:a16="http://schemas.microsoft.com/office/drawing/2014/main" id="{F070FDA8-74AB-4776-9A38-089AC6DBBB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2611" y="3449667"/>
                <a:ext cx="1800000" cy="15854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87" name="CasellaDiTesto 186">
                <a:extLst>
                  <a:ext uri="{FF2B5EF4-FFF2-40B4-BE49-F238E27FC236}">
                    <a16:creationId xmlns:a16="http://schemas.microsoft.com/office/drawing/2014/main" id="{A02BD6F4-4251-4F05-B14A-CBFDA88CE7B2}"/>
                  </a:ext>
                </a:extLst>
              </p:cNvPr>
              <p:cNvSpPr txBox="1"/>
              <p:nvPr/>
            </p:nvSpPr>
            <p:spPr>
              <a:xfrm>
                <a:off x="1914262" y="3197834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2</a:t>
                </a:r>
              </a:p>
            </p:txBody>
          </p:sp>
          <p:sp>
            <p:nvSpPr>
              <p:cNvPr id="188" name="CasellaDiTesto 187">
                <a:extLst>
                  <a:ext uri="{FF2B5EF4-FFF2-40B4-BE49-F238E27FC236}">
                    <a16:creationId xmlns:a16="http://schemas.microsoft.com/office/drawing/2014/main" id="{DC2BDCBF-8178-434D-98AD-E3126BEBE912}"/>
                  </a:ext>
                </a:extLst>
              </p:cNvPr>
              <p:cNvSpPr txBox="1"/>
              <p:nvPr/>
            </p:nvSpPr>
            <p:spPr>
              <a:xfrm>
                <a:off x="1914262" y="3376592"/>
                <a:ext cx="652102" cy="3046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Vinculin</a:t>
                </a:r>
                <a:endParaRPr lang="it-IT" sz="1200" dirty="0"/>
              </a:p>
            </p:txBody>
          </p:sp>
          <p:sp>
            <p:nvSpPr>
              <p:cNvPr id="189" name="CasellaDiTesto 188">
                <a:extLst>
                  <a:ext uri="{FF2B5EF4-FFF2-40B4-BE49-F238E27FC236}">
                    <a16:creationId xmlns:a16="http://schemas.microsoft.com/office/drawing/2014/main" id="{72616B77-6DEE-45B0-876A-38172A62D68E}"/>
                  </a:ext>
                </a:extLst>
              </p:cNvPr>
              <p:cNvSpPr txBox="1"/>
              <p:nvPr/>
            </p:nvSpPr>
            <p:spPr>
              <a:xfrm>
                <a:off x="1914262" y="3005058"/>
                <a:ext cx="99418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T68-CHK2</a:t>
                </a:r>
              </a:p>
            </p:txBody>
          </p:sp>
          <p:grpSp>
            <p:nvGrpSpPr>
              <p:cNvPr id="190" name="Gruppo 189">
                <a:extLst>
                  <a:ext uri="{FF2B5EF4-FFF2-40B4-BE49-F238E27FC236}">
                    <a16:creationId xmlns:a16="http://schemas.microsoft.com/office/drawing/2014/main" id="{310EE57D-D4CF-4177-9A75-C6FC08F9B691}"/>
                  </a:ext>
                </a:extLst>
              </p:cNvPr>
              <p:cNvGrpSpPr/>
              <p:nvPr/>
            </p:nvGrpSpPr>
            <p:grpSpPr>
              <a:xfrm>
                <a:off x="182611" y="2836086"/>
                <a:ext cx="943034" cy="276999"/>
                <a:chOff x="3894249" y="2576928"/>
                <a:chExt cx="943034" cy="276999"/>
              </a:xfrm>
            </p:grpSpPr>
            <p:sp>
              <p:nvSpPr>
                <p:cNvPr id="211" name="CasellaDiTesto 210">
                  <a:extLst>
                    <a:ext uri="{FF2B5EF4-FFF2-40B4-BE49-F238E27FC236}">
                      <a16:creationId xmlns:a16="http://schemas.microsoft.com/office/drawing/2014/main" id="{FC6FB568-38D3-48FE-ADB1-A7EDF4FB8ED5}"/>
                    </a:ext>
                  </a:extLst>
                </p:cNvPr>
                <p:cNvSpPr txBox="1"/>
                <p:nvPr/>
              </p:nvSpPr>
              <p:spPr>
                <a:xfrm>
                  <a:off x="3894249" y="2576928"/>
                  <a:ext cx="235962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212" name="CasellaDiTesto 211">
                  <a:extLst>
                    <a:ext uri="{FF2B5EF4-FFF2-40B4-BE49-F238E27FC236}">
                      <a16:creationId xmlns:a16="http://schemas.microsoft.com/office/drawing/2014/main" id="{9E5D84A3-BF7E-4806-96D8-78DA488A839E}"/>
                    </a:ext>
                  </a:extLst>
                </p:cNvPr>
                <p:cNvSpPr txBox="1"/>
                <p:nvPr/>
              </p:nvSpPr>
              <p:spPr>
                <a:xfrm>
                  <a:off x="4130211" y="2576928"/>
                  <a:ext cx="274434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  <p:sp>
              <p:nvSpPr>
                <p:cNvPr id="213" name="CasellaDiTesto 212">
                  <a:extLst>
                    <a:ext uri="{FF2B5EF4-FFF2-40B4-BE49-F238E27FC236}">
                      <a16:creationId xmlns:a16="http://schemas.microsoft.com/office/drawing/2014/main" id="{CF2C83FE-B6E8-4034-8688-144BD77A3DAF}"/>
                    </a:ext>
                  </a:extLst>
                </p:cNvPr>
                <p:cNvSpPr txBox="1"/>
                <p:nvPr/>
              </p:nvSpPr>
              <p:spPr>
                <a:xfrm>
                  <a:off x="4386895" y="2576928"/>
                  <a:ext cx="235962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214" name="CasellaDiTesto 213">
                  <a:extLst>
                    <a:ext uri="{FF2B5EF4-FFF2-40B4-BE49-F238E27FC236}">
                      <a16:creationId xmlns:a16="http://schemas.microsoft.com/office/drawing/2014/main" id="{F7FCFE5A-5B0E-40D7-B3C8-AC33D269764F}"/>
                    </a:ext>
                  </a:extLst>
                </p:cNvPr>
                <p:cNvSpPr txBox="1"/>
                <p:nvPr/>
              </p:nvSpPr>
              <p:spPr>
                <a:xfrm>
                  <a:off x="4562849" y="2576928"/>
                  <a:ext cx="274434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</p:grpSp>
          <p:sp>
            <p:nvSpPr>
              <p:cNvPr id="191" name="CasellaDiTesto 190">
                <a:extLst>
                  <a:ext uri="{FF2B5EF4-FFF2-40B4-BE49-F238E27FC236}">
                    <a16:creationId xmlns:a16="http://schemas.microsoft.com/office/drawing/2014/main" id="{E908CFBE-7488-4E75-8998-CC5031198DCE}"/>
                  </a:ext>
                </a:extLst>
              </p:cNvPr>
              <p:cNvSpPr txBox="1"/>
              <p:nvPr/>
            </p:nvSpPr>
            <p:spPr>
              <a:xfrm>
                <a:off x="1099238" y="2836086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92" name="CasellaDiTesto 191">
                <a:extLst>
                  <a:ext uri="{FF2B5EF4-FFF2-40B4-BE49-F238E27FC236}">
                    <a16:creationId xmlns:a16="http://schemas.microsoft.com/office/drawing/2014/main" id="{7ADBA68E-7A02-4DCB-AC66-721CBAA1CA67}"/>
                  </a:ext>
                </a:extLst>
              </p:cNvPr>
              <p:cNvSpPr txBox="1"/>
              <p:nvPr/>
            </p:nvSpPr>
            <p:spPr>
              <a:xfrm>
                <a:off x="1301859" y="2836086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93" name="CasellaDiTesto 192">
                <a:extLst>
                  <a:ext uri="{FF2B5EF4-FFF2-40B4-BE49-F238E27FC236}">
                    <a16:creationId xmlns:a16="http://schemas.microsoft.com/office/drawing/2014/main" id="{2E93FB11-7211-474B-BD97-119E51F99106}"/>
                  </a:ext>
                </a:extLst>
              </p:cNvPr>
              <p:cNvSpPr txBox="1"/>
              <p:nvPr/>
            </p:nvSpPr>
            <p:spPr>
              <a:xfrm>
                <a:off x="1539491" y="2836086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94" name="CasellaDiTesto 193">
                <a:extLst>
                  <a:ext uri="{FF2B5EF4-FFF2-40B4-BE49-F238E27FC236}">
                    <a16:creationId xmlns:a16="http://schemas.microsoft.com/office/drawing/2014/main" id="{D7137FCF-6CA1-4C33-B53C-343CBF9D2C17}"/>
                  </a:ext>
                </a:extLst>
              </p:cNvPr>
              <p:cNvSpPr txBox="1"/>
              <p:nvPr/>
            </p:nvSpPr>
            <p:spPr>
              <a:xfrm>
                <a:off x="1739260" y="2836086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95" name="CasellaDiTesto 194">
                <a:extLst>
                  <a:ext uri="{FF2B5EF4-FFF2-40B4-BE49-F238E27FC236}">
                    <a16:creationId xmlns:a16="http://schemas.microsoft.com/office/drawing/2014/main" id="{0104EA83-D27D-4E77-942A-FF0A9A2A086D}"/>
                  </a:ext>
                </a:extLst>
              </p:cNvPr>
              <p:cNvSpPr txBox="1"/>
              <p:nvPr/>
            </p:nvSpPr>
            <p:spPr>
              <a:xfrm>
                <a:off x="1927234" y="2836086"/>
                <a:ext cx="58586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ETO  </a:t>
                </a:r>
              </a:p>
            </p:txBody>
          </p:sp>
          <p:cxnSp>
            <p:nvCxnSpPr>
              <p:cNvPr id="196" name="Connettore diritto 195">
                <a:extLst>
                  <a:ext uri="{FF2B5EF4-FFF2-40B4-BE49-F238E27FC236}">
                    <a16:creationId xmlns:a16="http://schemas.microsoft.com/office/drawing/2014/main" id="{1C3E8EA2-83CE-42AF-AAEC-72CA120895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3238" y="2886942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7" name="Connettore diritto 196">
                <a:extLst>
                  <a:ext uri="{FF2B5EF4-FFF2-40B4-BE49-F238E27FC236}">
                    <a16:creationId xmlns:a16="http://schemas.microsoft.com/office/drawing/2014/main" id="{7CFDA7B5-7913-40C2-B736-9277BAF496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21786" y="2886942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8" name="Connettore diritto 197">
                <a:extLst>
                  <a:ext uri="{FF2B5EF4-FFF2-40B4-BE49-F238E27FC236}">
                    <a16:creationId xmlns:a16="http://schemas.microsoft.com/office/drawing/2014/main" id="{6A1336D4-FE7A-4416-BB29-CB34EA33ED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2886" y="2886942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9" name="CasellaDiTesto 198">
                <a:extLst>
                  <a:ext uri="{FF2B5EF4-FFF2-40B4-BE49-F238E27FC236}">
                    <a16:creationId xmlns:a16="http://schemas.microsoft.com/office/drawing/2014/main" id="{28EBC9E3-00B5-446C-A132-DA345118F94C}"/>
                  </a:ext>
                </a:extLst>
              </p:cNvPr>
              <p:cNvSpPr txBox="1"/>
              <p:nvPr/>
            </p:nvSpPr>
            <p:spPr>
              <a:xfrm>
                <a:off x="1927234" y="2652135"/>
                <a:ext cx="821535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it-IT" sz="1200" dirty="0"/>
                  <a:t>KU (µM)</a:t>
                </a:r>
              </a:p>
            </p:txBody>
          </p:sp>
          <p:pic>
            <p:nvPicPr>
              <p:cNvPr id="200" name="Immagine 199">
                <a:extLst>
                  <a:ext uri="{FF2B5EF4-FFF2-40B4-BE49-F238E27FC236}">
                    <a16:creationId xmlns:a16="http://schemas.microsoft.com/office/drawing/2014/main" id="{94C2F8C7-FCEE-43B6-82D7-4F7C07FE281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2611" y="3064283"/>
                <a:ext cx="1800000" cy="15854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01" name="Immagine 200">
                <a:extLst>
                  <a:ext uri="{FF2B5EF4-FFF2-40B4-BE49-F238E27FC236}">
                    <a16:creationId xmlns:a16="http://schemas.microsoft.com/office/drawing/2014/main" id="{D67AAE0A-AFB1-4BD6-879F-A9281252A6E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2611" y="3257059"/>
                <a:ext cx="1800000" cy="15854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202" name="Connettore diritto 201">
                <a:extLst>
                  <a:ext uri="{FF2B5EF4-FFF2-40B4-BE49-F238E27FC236}">
                    <a16:creationId xmlns:a16="http://schemas.microsoft.com/office/drawing/2014/main" id="{349B6CDF-93F5-482E-A520-304DA42E56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1006" y="2874747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3" name="Connettore diritto 202">
                <a:extLst>
                  <a:ext uri="{FF2B5EF4-FFF2-40B4-BE49-F238E27FC236}">
                    <a16:creationId xmlns:a16="http://schemas.microsoft.com/office/drawing/2014/main" id="{F4B2BFAF-0486-48E4-803B-0CF8E26E5C0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19554" y="2874747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4" name="Connettore diritto 203">
                <a:extLst>
                  <a:ext uri="{FF2B5EF4-FFF2-40B4-BE49-F238E27FC236}">
                    <a16:creationId xmlns:a16="http://schemas.microsoft.com/office/drawing/2014/main" id="{8C3D888B-6053-4EDC-AFC5-D9479D13D4B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0654" y="2874747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5" name="Connettore diritto 204">
                <a:extLst>
                  <a:ext uri="{FF2B5EF4-FFF2-40B4-BE49-F238E27FC236}">
                    <a16:creationId xmlns:a16="http://schemas.microsoft.com/office/drawing/2014/main" id="{FE61E209-2B17-485F-818A-728384080E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1006" y="2871341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6" name="Connettore diritto 205">
                <a:extLst>
                  <a:ext uri="{FF2B5EF4-FFF2-40B4-BE49-F238E27FC236}">
                    <a16:creationId xmlns:a16="http://schemas.microsoft.com/office/drawing/2014/main" id="{8338D557-0DA8-49A8-BCE6-8711452928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19554" y="2871341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7" name="Connettore diritto 206">
                <a:extLst>
                  <a:ext uri="{FF2B5EF4-FFF2-40B4-BE49-F238E27FC236}">
                    <a16:creationId xmlns:a16="http://schemas.microsoft.com/office/drawing/2014/main" id="{8E0A2075-45AB-4A6B-BD2C-A576CC28D4A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0654" y="2871341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8" name="CasellaDiTesto 207">
                <a:extLst>
                  <a:ext uri="{FF2B5EF4-FFF2-40B4-BE49-F238E27FC236}">
                    <a16:creationId xmlns:a16="http://schemas.microsoft.com/office/drawing/2014/main" id="{27FB366A-B046-4CCC-AA57-49F403156547}"/>
                  </a:ext>
                </a:extLst>
              </p:cNvPr>
              <p:cNvSpPr txBox="1"/>
              <p:nvPr/>
            </p:nvSpPr>
            <p:spPr>
              <a:xfrm>
                <a:off x="684049" y="2636534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1</a:t>
                </a:r>
              </a:p>
            </p:txBody>
          </p:sp>
          <p:sp>
            <p:nvSpPr>
              <p:cNvPr id="209" name="CasellaDiTesto 208">
                <a:extLst>
                  <a:ext uri="{FF2B5EF4-FFF2-40B4-BE49-F238E27FC236}">
                    <a16:creationId xmlns:a16="http://schemas.microsoft.com/office/drawing/2014/main" id="{133803D4-1FED-4A6B-84A5-87C8BC844DF5}"/>
                  </a:ext>
                </a:extLst>
              </p:cNvPr>
              <p:cNvSpPr txBox="1"/>
              <p:nvPr/>
            </p:nvSpPr>
            <p:spPr>
              <a:xfrm>
                <a:off x="1116901" y="2636534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5</a:t>
                </a:r>
              </a:p>
            </p:txBody>
          </p:sp>
          <p:sp>
            <p:nvSpPr>
              <p:cNvPr id="210" name="CasellaDiTesto 209">
                <a:extLst>
                  <a:ext uri="{FF2B5EF4-FFF2-40B4-BE49-F238E27FC236}">
                    <a16:creationId xmlns:a16="http://schemas.microsoft.com/office/drawing/2014/main" id="{12F8E87F-493A-4B27-AEF5-CD7534C30013}"/>
                  </a:ext>
                </a:extLst>
              </p:cNvPr>
              <p:cNvSpPr txBox="1"/>
              <p:nvPr/>
            </p:nvSpPr>
            <p:spPr>
              <a:xfrm>
                <a:off x="1624796" y="2636534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</a:t>
                </a:r>
              </a:p>
            </p:txBody>
          </p:sp>
        </p:grpSp>
        <p:sp>
          <p:nvSpPr>
            <p:cNvPr id="250" name="CasellaDiTesto 249">
              <a:extLst>
                <a:ext uri="{FF2B5EF4-FFF2-40B4-BE49-F238E27FC236}">
                  <a16:creationId xmlns:a16="http://schemas.microsoft.com/office/drawing/2014/main" id="{792FFBA4-EAAB-4C7A-8C86-45999B07F1D1}"/>
                </a:ext>
              </a:extLst>
            </p:cNvPr>
            <p:cNvSpPr txBox="1"/>
            <p:nvPr/>
          </p:nvSpPr>
          <p:spPr>
            <a:xfrm>
              <a:off x="1034194" y="5721952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Y537S</a:t>
              </a:r>
            </a:p>
          </p:txBody>
        </p:sp>
      </p:grpSp>
      <p:grpSp>
        <p:nvGrpSpPr>
          <p:cNvPr id="255" name="Gruppo 254">
            <a:extLst>
              <a:ext uri="{FF2B5EF4-FFF2-40B4-BE49-F238E27FC236}">
                <a16:creationId xmlns:a16="http://schemas.microsoft.com/office/drawing/2014/main" id="{9F7B1BDB-F9F9-4899-8A06-A48060595BFF}"/>
              </a:ext>
            </a:extLst>
          </p:cNvPr>
          <p:cNvGrpSpPr/>
          <p:nvPr/>
        </p:nvGrpSpPr>
        <p:grpSpPr>
          <a:xfrm>
            <a:off x="3896449" y="4737795"/>
            <a:ext cx="2818808" cy="1250699"/>
            <a:chOff x="3896449" y="4737795"/>
            <a:chExt cx="2818808" cy="1250699"/>
          </a:xfrm>
        </p:grpSpPr>
        <p:grpSp>
          <p:nvGrpSpPr>
            <p:cNvPr id="131" name="Gruppo 130">
              <a:extLst>
                <a:ext uri="{FF2B5EF4-FFF2-40B4-BE49-F238E27FC236}">
                  <a16:creationId xmlns:a16="http://schemas.microsoft.com/office/drawing/2014/main" id="{2BD607C8-DAA9-45E0-8DEA-54581CCE3005}"/>
                </a:ext>
              </a:extLst>
            </p:cNvPr>
            <p:cNvGrpSpPr/>
            <p:nvPr/>
          </p:nvGrpSpPr>
          <p:grpSpPr>
            <a:xfrm>
              <a:off x="3896449" y="4737795"/>
              <a:ext cx="2818808" cy="1012006"/>
              <a:chOff x="3861684" y="2652135"/>
              <a:chExt cx="2818808" cy="1012006"/>
            </a:xfrm>
          </p:grpSpPr>
          <p:sp>
            <p:nvSpPr>
              <p:cNvPr id="132" name="CasellaDiTesto 131">
                <a:extLst>
                  <a:ext uri="{FF2B5EF4-FFF2-40B4-BE49-F238E27FC236}">
                    <a16:creationId xmlns:a16="http://schemas.microsoft.com/office/drawing/2014/main" id="{26D1D3D7-A8EE-4E43-9828-0A20A548EF74}"/>
                  </a:ext>
                </a:extLst>
              </p:cNvPr>
              <p:cNvSpPr txBox="1"/>
              <p:nvPr/>
            </p:nvSpPr>
            <p:spPr>
              <a:xfrm>
                <a:off x="5593335" y="3183545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1</a:t>
                </a:r>
              </a:p>
            </p:txBody>
          </p:sp>
          <p:sp>
            <p:nvSpPr>
              <p:cNvPr id="133" name="CasellaDiTesto 132">
                <a:extLst>
                  <a:ext uri="{FF2B5EF4-FFF2-40B4-BE49-F238E27FC236}">
                    <a16:creationId xmlns:a16="http://schemas.microsoft.com/office/drawing/2014/main" id="{C81AEE4D-16C4-4FDC-ABA5-BBCA5A1519EE}"/>
                  </a:ext>
                </a:extLst>
              </p:cNvPr>
              <p:cNvSpPr txBox="1"/>
              <p:nvPr/>
            </p:nvSpPr>
            <p:spPr>
              <a:xfrm>
                <a:off x="5593335" y="3359442"/>
                <a:ext cx="652102" cy="3046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Vinculin</a:t>
                </a:r>
                <a:endParaRPr lang="it-IT" sz="1200" dirty="0"/>
              </a:p>
            </p:txBody>
          </p:sp>
          <p:sp>
            <p:nvSpPr>
              <p:cNvPr id="134" name="CasellaDiTesto 133">
                <a:extLst>
                  <a:ext uri="{FF2B5EF4-FFF2-40B4-BE49-F238E27FC236}">
                    <a16:creationId xmlns:a16="http://schemas.microsoft.com/office/drawing/2014/main" id="{60C289A4-EA68-4743-84F9-7C0653D8E8EE}"/>
                  </a:ext>
                </a:extLst>
              </p:cNvPr>
              <p:cNvSpPr txBox="1"/>
              <p:nvPr/>
            </p:nvSpPr>
            <p:spPr>
              <a:xfrm>
                <a:off x="5593335" y="3005058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345-CHK1</a:t>
                </a:r>
              </a:p>
            </p:txBody>
          </p:sp>
          <p:grpSp>
            <p:nvGrpSpPr>
              <p:cNvPr id="135" name="Gruppo 134">
                <a:extLst>
                  <a:ext uri="{FF2B5EF4-FFF2-40B4-BE49-F238E27FC236}">
                    <a16:creationId xmlns:a16="http://schemas.microsoft.com/office/drawing/2014/main" id="{FE1F19DA-6175-4AF0-A105-4CCB7CC41DF8}"/>
                  </a:ext>
                </a:extLst>
              </p:cNvPr>
              <p:cNvGrpSpPr/>
              <p:nvPr/>
            </p:nvGrpSpPr>
            <p:grpSpPr>
              <a:xfrm>
                <a:off x="3861684" y="2836086"/>
                <a:ext cx="943034" cy="276999"/>
                <a:chOff x="3894249" y="2576928"/>
                <a:chExt cx="943034" cy="276999"/>
              </a:xfrm>
            </p:grpSpPr>
            <p:sp>
              <p:nvSpPr>
                <p:cNvPr id="151" name="CasellaDiTesto 150">
                  <a:extLst>
                    <a:ext uri="{FF2B5EF4-FFF2-40B4-BE49-F238E27FC236}">
                      <a16:creationId xmlns:a16="http://schemas.microsoft.com/office/drawing/2014/main" id="{1223A3F0-9806-4CA8-8500-04E43B5A04B6}"/>
                    </a:ext>
                  </a:extLst>
                </p:cNvPr>
                <p:cNvSpPr txBox="1"/>
                <p:nvPr/>
              </p:nvSpPr>
              <p:spPr>
                <a:xfrm>
                  <a:off x="3894249" y="2576928"/>
                  <a:ext cx="23596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152" name="CasellaDiTesto 151">
                  <a:extLst>
                    <a:ext uri="{FF2B5EF4-FFF2-40B4-BE49-F238E27FC236}">
                      <a16:creationId xmlns:a16="http://schemas.microsoft.com/office/drawing/2014/main" id="{F6B528C6-3ECC-4715-915A-22911762299C}"/>
                    </a:ext>
                  </a:extLst>
                </p:cNvPr>
                <p:cNvSpPr txBox="1"/>
                <p:nvPr/>
              </p:nvSpPr>
              <p:spPr>
                <a:xfrm>
                  <a:off x="4130211" y="2576928"/>
                  <a:ext cx="27443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  <p:sp>
              <p:nvSpPr>
                <p:cNvPr id="153" name="CasellaDiTesto 152">
                  <a:extLst>
                    <a:ext uri="{FF2B5EF4-FFF2-40B4-BE49-F238E27FC236}">
                      <a16:creationId xmlns:a16="http://schemas.microsoft.com/office/drawing/2014/main" id="{47BAC21E-5E36-4B9C-BC11-4790A769BE81}"/>
                    </a:ext>
                  </a:extLst>
                </p:cNvPr>
                <p:cNvSpPr txBox="1"/>
                <p:nvPr/>
              </p:nvSpPr>
              <p:spPr>
                <a:xfrm>
                  <a:off x="4386895" y="2576928"/>
                  <a:ext cx="23596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154" name="CasellaDiTesto 153">
                  <a:extLst>
                    <a:ext uri="{FF2B5EF4-FFF2-40B4-BE49-F238E27FC236}">
                      <a16:creationId xmlns:a16="http://schemas.microsoft.com/office/drawing/2014/main" id="{80F2AD27-FC09-4E4B-B2B8-BD0AA795959C}"/>
                    </a:ext>
                  </a:extLst>
                </p:cNvPr>
                <p:cNvSpPr txBox="1"/>
                <p:nvPr/>
              </p:nvSpPr>
              <p:spPr>
                <a:xfrm>
                  <a:off x="4562849" y="2576928"/>
                  <a:ext cx="27443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</p:grpSp>
          <p:sp>
            <p:nvSpPr>
              <p:cNvPr id="136" name="CasellaDiTesto 135">
                <a:extLst>
                  <a:ext uri="{FF2B5EF4-FFF2-40B4-BE49-F238E27FC236}">
                    <a16:creationId xmlns:a16="http://schemas.microsoft.com/office/drawing/2014/main" id="{452945F4-CEB9-4D5E-BBF8-B08A4AB98ADB}"/>
                  </a:ext>
                </a:extLst>
              </p:cNvPr>
              <p:cNvSpPr txBox="1"/>
              <p:nvPr/>
            </p:nvSpPr>
            <p:spPr>
              <a:xfrm>
                <a:off x="4778311" y="2836086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37" name="CasellaDiTesto 136">
                <a:extLst>
                  <a:ext uri="{FF2B5EF4-FFF2-40B4-BE49-F238E27FC236}">
                    <a16:creationId xmlns:a16="http://schemas.microsoft.com/office/drawing/2014/main" id="{0444D086-59BF-4723-BDA2-5BA7DCF8B9DB}"/>
                  </a:ext>
                </a:extLst>
              </p:cNvPr>
              <p:cNvSpPr txBox="1"/>
              <p:nvPr/>
            </p:nvSpPr>
            <p:spPr>
              <a:xfrm>
                <a:off x="4980932" y="2836086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38" name="CasellaDiTesto 137">
                <a:extLst>
                  <a:ext uri="{FF2B5EF4-FFF2-40B4-BE49-F238E27FC236}">
                    <a16:creationId xmlns:a16="http://schemas.microsoft.com/office/drawing/2014/main" id="{8DED2BA7-814B-4BEA-976E-60786A8C576F}"/>
                  </a:ext>
                </a:extLst>
              </p:cNvPr>
              <p:cNvSpPr txBox="1"/>
              <p:nvPr/>
            </p:nvSpPr>
            <p:spPr>
              <a:xfrm>
                <a:off x="5218564" y="2836086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39" name="CasellaDiTesto 138">
                <a:extLst>
                  <a:ext uri="{FF2B5EF4-FFF2-40B4-BE49-F238E27FC236}">
                    <a16:creationId xmlns:a16="http://schemas.microsoft.com/office/drawing/2014/main" id="{9B76BE90-7B47-4758-BB1B-27BE315E4D54}"/>
                  </a:ext>
                </a:extLst>
              </p:cNvPr>
              <p:cNvSpPr txBox="1"/>
              <p:nvPr/>
            </p:nvSpPr>
            <p:spPr>
              <a:xfrm>
                <a:off x="5418333" y="2836086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40" name="CasellaDiTesto 139">
                <a:extLst>
                  <a:ext uri="{FF2B5EF4-FFF2-40B4-BE49-F238E27FC236}">
                    <a16:creationId xmlns:a16="http://schemas.microsoft.com/office/drawing/2014/main" id="{50217A27-E8B1-4480-9DE0-6A6EA30F5A60}"/>
                  </a:ext>
                </a:extLst>
              </p:cNvPr>
              <p:cNvSpPr txBox="1"/>
              <p:nvPr/>
            </p:nvSpPr>
            <p:spPr>
              <a:xfrm>
                <a:off x="5606307" y="2836086"/>
                <a:ext cx="585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ETO  </a:t>
                </a:r>
              </a:p>
            </p:txBody>
          </p:sp>
          <p:cxnSp>
            <p:nvCxnSpPr>
              <p:cNvPr id="141" name="Connettore diritto 140">
                <a:extLst>
                  <a:ext uri="{FF2B5EF4-FFF2-40B4-BE49-F238E27FC236}">
                    <a16:creationId xmlns:a16="http://schemas.microsoft.com/office/drawing/2014/main" id="{7F6B6D8A-DAAB-45D0-9DD1-8F58044A9B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72311" y="2886942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2" name="Connettore diritto 141">
                <a:extLst>
                  <a:ext uri="{FF2B5EF4-FFF2-40B4-BE49-F238E27FC236}">
                    <a16:creationId xmlns:a16="http://schemas.microsoft.com/office/drawing/2014/main" id="{AC70052E-A5D5-4E12-B325-2EAEED9903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00859" y="2886942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3" name="Connettore diritto 142">
                <a:extLst>
                  <a:ext uri="{FF2B5EF4-FFF2-40B4-BE49-F238E27FC236}">
                    <a16:creationId xmlns:a16="http://schemas.microsoft.com/office/drawing/2014/main" id="{BC22FED5-E31C-4970-BE85-F9757A9B60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51959" y="2886942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4" name="CasellaDiTesto 143">
                <a:extLst>
                  <a:ext uri="{FF2B5EF4-FFF2-40B4-BE49-F238E27FC236}">
                    <a16:creationId xmlns:a16="http://schemas.microsoft.com/office/drawing/2014/main" id="{90C87BD5-444D-402F-8253-14B6092F1A08}"/>
                  </a:ext>
                </a:extLst>
              </p:cNvPr>
              <p:cNvSpPr txBox="1"/>
              <p:nvPr/>
            </p:nvSpPr>
            <p:spPr>
              <a:xfrm>
                <a:off x="4365354" y="2652135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1</a:t>
                </a:r>
              </a:p>
            </p:txBody>
          </p:sp>
          <p:sp>
            <p:nvSpPr>
              <p:cNvPr id="145" name="CasellaDiTesto 144">
                <a:extLst>
                  <a:ext uri="{FF2B5EF4-FFF2-40B4-BE49-F238E27FC236}">
                    <a16:creationId xmlns:a16="http://schemas.microsoft.com/office/drawing/2014/main" id="{49EA8E13-5C5F-4825-A2CC-22F299944419}"/>
                  </a:ext>
                </a:extLst>
              </p:cNvPr>
              <p:cNvSpPr txBox="1"/>
              <p:nvPr/>
            </p:nvSpPr>
            <p:spPr>
              <a:xfrm>
                <a:off x="4798206" y="2652135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5</a:t>
                </a:r>
              </a:p>
            </p:txBody>
          </p:sp>
          <p:sp>
            <p:nvSpPr>
              <p:cNvPr id="146" name="CasellaDiTesto 145">
                <a:extLst>
                  <a:ext uri="{FF2B5EF4-FFF2-40B4-BE49-F238E27FC236}">
                    <a16:creationId xmlns:a16="http://schemas.microsoft.com/office/drawing/2014/main" id="{51EFB15C-0B7D-41F9-9018-59C13B31F304}"/>
                  </a:ext>
                </a:extLst>
              </p:cNvPr>
              <p:cNvSpPr txBox="1"/>
              <p:nvPr/>
            </p:nvSpPr>
            <p:spPr>
              <a:xfrm>
                <a:off x="5306101" y="2652135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</a:t>
                </a:r>
              </a:p>
            </p:txBody>
          </p:sp>
          <p:sp>
            <p:nvSpPr>
              <p:cNvPr id="147" name="CasellaDiTesto 146">
                <a:extLst>
                  <a:ext uri="{FF2B5EF4-FFF2-40B4-BE49-F238E27FC236}">
                    <a16:creationId xmlns:a16="http://schemas.microsoft.com/office/drawing/2014/main" id="{E095591B-9490-42C0-8E32-C3E5029C4D81}"/>
                  </a:ext>
                </a:extLst>
              </p:cNvPr>
              <p:cNvSpPr txBox="1"/>
              <p:nvPr/>
            </p:nvSpPr>
            <p:spPr>
              <a:xfrm>
                <a:off x="5606307" y="2652135"/>
                <a:ext cx="821535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it-IT" sz="1200" dirty="0"/>
                  <a:t>VE (µM)</a:t>
                </a:r>
              </a:p>
            </p:txBody>
          </p:sp>
          <p:pic>
            <p:nvPicPr>
              <p:cNvPr id="148" name="Immagine 147">
                <a:extLst>
                  <a:ext uri="{FF2B5EF4-FFF2-40B4-BE49-F238E27FC236}">
                    <a16:creationId xmlns:a16="http://schemas.microsoft.com/office/drawing/2014/main" id="{F6BC1C5F-8524-454F-B8D2-67132F4EE6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861684" y="3081526"/>
                <a:ext cx="1800000" cy="12406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49" name="Immagine 148">
                <a:extLst>
                  <a:ext uri="{FF2B5EF4-FFF2-40B4-BE49-F238E27FC236}">
                    <a16:creationId xmlns:a16="http://schemas.microsoft.com/office/drawing/2014/main" id="{69A29EAA-9477-433D-83B6-DD8D774F314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861684" y="3260013"/>
                <a:ext cx="1800000" cy="12406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0" name="Immagine 149">
                <a:extLst>
                  <a:ext uri="{FF2B5EF4-FFF2-40B4-BE49-F238E27FC236}">
                    <a16:creationId xmlns:a16="http://schemas.microsoft.com/office/drawing/2014/main" id="{F666ABEE-2AEC-4E78-88DD-230C81DAB68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861684" y="3449760"/>
                <a:ext cx="1800000" cy="12406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251" name="CasellaDiTesto 250">
              <a:extLst>
                <a:ext uri="{FF2B5EF4-FFF2-40B4-BE49-F238E27FC236}">
                  <a16:creationId xmlns:a16="http://schemas.microsoft.com/office/drawing/2014/main" id="{673A1909-ADCD-42A9-B40D-5B91CB09E999}"/>
                </a:ext>
              </a:extLst>
            </p:cNvPr>
            <p:cNvSpPr txBox="1"/>
            <p:nvPr/>
          </p:nvSpPr>
          <p:spPr>
            <a:xfrm>
              <a:off x="4460862" y="5711495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Y537S</a:t>
              </a:r>
            </a:p>
          </p:txBody>
        </p:sp>
      </p:grpSp>
      <p:grpSp>
        <p:nvGrpSpPr>
          <p:cNvPr id="257" name="Gruppo 256">
            <a:extLst>
              <a:ext uri="{FF2B5EF4-FFF2-40B4-BE49-F238E27FC236}">
                <a16:creationId xmlns:a16="http://schemas.microsoft.com/office/drawing/2014/main" id="{010C69CE-667B-4EED-A25B-B9A20E8510F2}"/>
              </a:ext>
            </a:extLst>
          </p:cNvPr>
          <p:cNvGrpSpPr/>
          <p:nvPr/>
        </p:nvGrpSpPr>
        <p:grpSpPr>
          <a:xfrm>
            <a:off x="461367" y="6597755"/>
            <a:ext cx="2818808" cy="1309787"/>
            <a:chOff x="461367" y="6597755"/>
            <a:chExt cx="2818808" cy="1309787"/>
          </a:xfrm>
        </p:grpSpPr>
        <p:grpSp>
          <p:nvGrpSpPr>
            <p:cNvPr id="155" name="Gruppo 154">
              <a:extLst>
                <a:ext uri="{FF2B5EF4-FFF2-40B4-BE49-F238E27FC236}">
                  <a16:creationId xmlns:a16="http://schemas.microsoft.com/office/drawing/2014/main" id="{BEF68596-F3B3-4BA7-ADAA-E500DEBB3959}"/>
                </a:ext>
              </a:extLst>
            </p:cNvPr>
            <p:cNvGrpSpPr/>
            <p:nvPr/>
          </p:nvGrpSpPr>
          <p:grpSpPr>
            <a:xfrm>
              <a:off x="461367" y="6597755"/>
              <a:ext cx="2818808" cy="1067993"/>
              <a:chOff x="171152" y="3771474"/>
              <a:chExt cx="2818808" cy="1067993"/>
            </a:xfrm>
          </p:grpSpPr>
          <p:sp>
            <p:nvSpPr>
              <p:cNvPr id="156" name="CasellaDiTesto 155">
                <a:extLst>
                  <a:ext uri="{FF2B5EF4-FFF2-40B4-BE49-F238E27FC236}">
                    <a16:creationId xmlns:a16="http://schemas.microsoft.com/office/drawing/2014/main" id="{21EF11A9-8AE2-4286-A4E2-D2EC69D30951}"/>
                  </a:ext>
                </a:extLst>
              </p:cNvPr>
              <p:cNvSpPr txBox="1"/>
              <p:nvPr/>
            </p:nvSpPr>
            <p:spPr>
              <a:xfrm>
                <a:off x="1902803" y="4325530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2</a:t>
                </a:r>
              </a:p>
            </p:txBody>
          </p:sp>
          <p:sp>
            <p:nvSpPr>
              <p:cNvPr id="157" name="CasellaDiTesto 156">
                <a:extLst>
                  <a:ext uri="{FF2B5EF4-FFF2-40B4-BE49-F238E27FC236}">
                    <a16:creationId xmlns:a16="http://schemas.microsoft.com/office/drawing/2014/main" id="{14BF676E-3CA0-4B34-9E9D-48A6FD0FF58E}"/>
                  </a:ext>
                </a:extLst>
              </p:cNvPr>
              <p:cNvSpPr txBox="1"/>
              <p:nvPr/>
            </p:nvSpPr>
            <p:spPr>
              <a:xfrm>
                <a:off x="1902803" y="4534768"/>
                <a:ext cx="652102" cy="3046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Vinculin</a:t>
                </a:r>
                <a:endParaRPr lang="it-IT" sz="1200" dirty="0"/>
              </a:p>
            </p:txBody>
          </p:sp>
          <p:sp>
            <p:nvSpPr>
              <p:cNvPr id="158" name="CasellaDiTesto 157">
                <a:extLst>
                  <a:ext uri="{FF2B5EF4-FFF2-40B4-BE49-F238E27FC236}">
                    <a16:creationId xmlns:a16="http://schemas.microsoft.com/office/drawing/2014/main" id="{9FD9D539-DA1C-4864-86AB-B7C602D2B723}"/>
                  </a:ext>
                </a:extLst>
              </p:cNvPr>
              <p:cNvSpPr txBox="1"/>
              <p:nvPr/>
            </p:nvSpPr>
            <p:spPr>
              <a:xfrm>
                <a:off x="1902803" y="4132754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516-CHK2</a:t>
                </a:r>
              </a:p>
            </p:txBody>
          </p:sp>
          <p:grpSp>
            <p:nvGrpSpPr>
              <p:cNvPr id="159" name="Gruppo 158">
                <a:extLst>
                  <a:ext uri="{FF2B5EF4-FFF2-40B4-BE49-F238E27FC236}">
                    <a16:creationId xmlns:a16="http://schemas.microsoft.com/office/drawing/2014/main" id="{6CA7A98F-81F7-4C9F-9971-58AFA8861EA8}"/>
                  </a:ext>
                </a:extLst>
              </p:cNvPr>
              <p:cNvGrpSpPr/>
              <p:nvPr/>
            </p:nvGrpSpPr>
            <p:grpSpPr>
              <a:xfrm>
                <a:off x="171152" y="3963782"/>
                <a:ext cx="943034" cy="276999"/>
                <a:chOff x="3894249" y="2576928"/>
                <a:chExt cx="943034" cy="276999"/>
              </a:xfrm>
            </p:grpSpPr>
            <p:sp>
              <p:nvSpPr>
                <p:cNvPr id="181" name="CasellaDiTesto 180">
                  <a:extLst>
                    <a:ext uri="{FF2B5EF4-FFF2-40B4-BE49-F238E27FC236}">
                      <a16:creationId xmlns:a16="http://schemas.microsoft.com/office/drawing/2014/main" id="{8EDE604F-5B51-4BDD-9635-DA9AAD415C31}"/>
                    </a:ext>
                  </a:extLst>
                </p:cNvPr>
                <p:cNvSpPr txBox="1"/>
                <p:nvPr/>
              </p:nvSpPr>
              <p:spPr>
                <a:xfrm>
                  <a:off x="3894249" y="2576928"/>
                  <a:ext cx="235962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182" name="CasellaDiTesto 181">
                  <a:extLst>
                    <a:ext uri="{FF2B5EF4-FFF2-40B4-BE49-F238E27FC236}">
                      <a16:creationId xmlns:a16="http://schemas.microsoft.com/office/drawing/2014/main" id="{98E54B85-1E8E-4441-8646-E97D9CE83433}"/>
                    </a:ext>
                  </a:extLst>
                </p:cNvPr>
                <p:cNvSpPr txBox="1"/>
                <p:nvPr/>
              </p:nvSpPr>
              <p:spPr>
                <a:xfrm>
                  <a:off x="4130211" y="2576928"/>
                  <a:ext cx="274434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  <p:sp>
              <p:nvSpPr>
                <p:cNvPr id="183" name="CasellaDiTesto 182">
                  <a:extLst>
                    <a:ext uri="{FF2B5EF4-FFF2-40B4-BE49-F238E27FC236}">
                      <a16:creationId xmlns:a16="http://schemas.microsoft.com/office/drawing/2014/main" id="{3ADD40EE-483C-4827-B46A-FA30473BFCC8}"/>
                    </a:ext>
                  </a:extLst>
                </p:cNvPr>
                <p:cNvSpPr txBox="1"/>
                <p:nvPr/>
              </p:nvSpPr>
              <p:spPr>
                <a:xfrm>
                  <a:off x="4386895" y="2576928"/>
                  <a:ext cx="235962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184" name="CasellaDiTesto 183">
                  <a:extLst>
                    <a:ext uri="{FF2B5EF4-FFF2-40B4-BE49-F238E27FC236}">
                      <a16:creationId xmlns:a16="http://schemas.microsoft.com/office/drawing/2014/main" id="{41E4D069-720F-40C7-96A2-077EC69CBBC8}"/>
                    </a:ext>
                  </a:extLst>
                </p:cNvPr>
                <p:cNvSpPr txBox="1"/>
                <p:nvPr/>
              </p:nvSpPr>
              <p:spPr>
                <a:xfrm>
                  <a:off x="4562849" y="2576928"/>
                  <a:ext cx="274434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</p:grpSp>
          <p:sp>
            <p:nvSpPr>
              <p:cNvPr id="160" name="CasellaDiTesto 159">
                <a:extLst>
                  <a:ext uri="{FF2B5EF4-FFF2-40B4-BE49-F238E27FC236}">
                    <a16:creationId xmlns:a16="http://schemas.microsoft.com/office/drawing/2014/main" id="{76EE4CB6-B195-4068-ACB1-0EB91A8DE931}"/>
                  </a:ext>
                </a:extLst>
              </p:cNvPr>
              <p:cNvSpPr txBox="1"/>
              <p:nvPr/>
            </p:nvSpPr>
            <p:spPr>
              <a:xfrm>
                <a:off x="1087779" y="3963782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61" name="CasellaDiTesto 160">
                <a:extLst>
                  <a:ext uri="{FF2B5EF4-FFF2-40B4-BE49-F238E27FC236}">
                    <a16:creationId xmlns:a16="http://schemas.microsoft.com/office/drawing/2014/main" id="{EED37F84-CD0A-438B-8780-79EA3D6CF2D3}"/>
                  </a:ext>
                </a:extLst>
              </p:cNvPr>
              <p:cNvSpPr txBox="1"/>
              <p:nvPr/>
            </p:nvSpPr>
            <p:spPr>
              <a:xfrm>
                <a:off x="1290400" y="3963782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62" name="CasellaDiTesto 161">
                <a:extLst>
                  <a:ext uri="{FF2B5EF4-FFF2-40B4-BE49-F238E27FC236}">
                    <a16:creationId xmlns:a16="http://schemas.microsoft.com/office/drawing/2014/main" id="{62FC9038-280B-4929-8191-53F997FD18E3}"/>
                  </a:ext>
                </a:extLst>
              </p:cNvPr>
              <p:cNvSpPr txBox="1"/>
              <p:nvPr/>
            </p:nvSpPr>
            <p:spPr>
              <a:xfrm>
                <a:off x="1528032" y="3963782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63" name="CasellaDiTesto 162">
                <a:extLst>
                  <a:ext uri="{FF2B5EF4-FFF2-40B4-BE49-F238E27FC236}">
                    <a16:creationId xmlns:a16="http://schemas.microsoft.com/office/drawing/2014/main" id="{FEFD5CC5-7E9C-4B33-9DA5-93B34F7E6B98}"/>
                  </a:ext>
                </a:extLst>
              </p:cNvPr>
              <p:cNvSpPr txBox="1"/>
              <p:nvPr/>
            </p:nvSpPr>
            <p:spPr>
              <a:xfrm>
                <a:off x="1727801" y="3963782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64" name="CasellaDiTesto 163">
                <a:extLst>
                  <a:ext uri="{FF2B5EF4-FFF2-40B4-BE49-F238E27FC236}">
                    <a16:creationId xmlns:a16="http://schemas.microsoft.com/office/drawing/2014/main" id="{E8F1EC44-4D89-40D6-BBAF-6FA6973CF4F7}"/>
                  </a:ext>
                </a:extLst>
              </p:cNvPr>
              <p:cNvSpPr txBox="1"/>
              <p:nvPr/>
            </p:nvSpPr>
            <p:spPr>
              <a:xfrm>
                <a:off x="1915775" y="3963782"/>
                <a:ext cx="58586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ETO  </a:t>
                </a:r>
              </a:p>
            </p:txBody>
          </p:sp>
          <p:cxnSp>
            <p:nvCxnSpPr>
              <p:cNvPr id="165" name="Connettore diritto 164">
                <a:extLst>
                  <a:ext uri="{FF2B5EF4-FFF2-40B4-BE49-F238E27FC236}">
                    <a16:creationId xmlns:a16="http://schemas.microsoft.com/office/drawing/2014/main" id="{89477AF5-AA91-497F-98DD-2823147E2ED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1779" y="4014638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6" name="Connettore diritto 165">
                <a:extLst>
                  <a:ext uri="{FF2B5EF4-FFF2-40B4-BE49-F238E27FC236}">
                    <a16:creationId xmlns:a16="http://schemas.microsoft.com/office/drawing/2014/main" id="{6052993A-3E92-49DD-975B-9759C71E619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10327" y="4014638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7" name="Connettore diritto 166">
                <a:extLst>
                  <a:ext uri="{FF2B5EF4-FFF2-40B4-BE49-F238E27FC236}">
                    <a16:creationId xmlns:a16="http://schemas.microsoft.com/office/drawing/2014/main" id="{0D74F3BC-3940-405A-9D77-E319553647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61427" y="4014638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8" name="CasellaDiTesto 167">
                <a:extLst>
                  <a:ext uri="{FF2B5EF4-FFF2-40B4-BE49-F238E27FC236}">
                    <a16:creationId xmlns:a16="http://schemas.microsoft.com/office/drawing/2014/main" id="{8BBB1785-4346-404C-B4C5-D0AB109F88F2}"/>
                  </a:ext>
                </a:extLst>
              </p:cNvPr>
              <p:cNvSpPr txBox="1"/>
              <p:nvPr/>
            </p:nvSpPr>
            <p:spPr>
              <a:xfrm>
                <a:off x="1915775" y="3779831"/>
                <a:ext cx="91564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it-IT" sz="1200" dirty="0"/>
                  <a:t>CCT (µM)</a:t>
                </a:r>
              </a:p>
            </p:txBody>
          </p:sp>
          <p:pic>
            <p:nvPicPr>
              <p:cNvPr id="169" name="Immagine 168">
                <a:extLst>
                  <a:ext uri="{FF2B5EF4-FFF2-40B4-BE49-F238E27FC236}">
                    <a16:creationId xmlns:a16="http://schemas.microsoft.com/office/drawing/2014/main" id="{AB224D1E-0FDF-4900-8F96-5EC5A7FC4D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71152" y="4176800"/>
                <a:ext cx="1800000" cy="17097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70" name="Immagine 169">
                <a:extLst>
                  <a:ext uri="{FF2B5EF4-FFF2-40B4-BE49-F238E27FC236}">
                    <a16:creationId xmlns:a16="http://schemas.microsoft.com/office/drawing/2014/main" id="{1EBB2048-E6B0-44B0-9427-E780CCED6C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71152" y="4375852"/>
                <a:ext cx="1800000" cy="17097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71" name="Immagine 170">
                <a:extLst>
                  <a:ext uri="{FF2B5EF4-FFF2-40B4-BE49-F238E27FC236}">
                    <a16:creationId xmlns:a16="http://schemas.microsoft.com/office/drawing/2014/main" id="{E3587D5D-249B-407E-AE71-0B3A3FA810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71152" y="4595723"/>
                <a:ext cx="1800000" cy="17097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172" name="Connettore diritto 171">
                <a:extLst>
                  <a:ext uri="{FF2B5EF4-FFF2-40B4-BE49-F238E27FC236}">
                    <a16:creationId xmlns:a16="http://schemas.microsoft.com/office/drawing/2014/main" id="{B0CBDE0A-F582-46DA-87A1-3E0E9B3B23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6846" y="4009687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3" name="Connettore diritto 172">
                <a:extLst>
                  <a:ext uri="{FF2B5EF4-FFF2-40B4-BE49-F238E27FC236}">
                    <a16:creationId xmlns:a16="http://schemas.microsoft.com/office/drawing/2014/main" id="{E5673CC2-7BCC-48E5-B6B6-45DB801976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15394" y="4009687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4" name="Connettore diritto 173">
                <a:extLst>
                  <a:ext uri="{FF2B5EF4-FFF2-40B4-BE49-F238E27FC236}">
                    <a16:creationId xmlns:a16="http://schemas.microsoft.com/office/drawing/2014/main" id="{DE61E024-91B2-47D7-A617-DC0225CD93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66494" y="4009687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5" name="Connettore diritto 174">
                <a:extLst>
                  <a:ext uri="{FF2B5EF4-FFF2-40B4-BE49-F238E27FC236}">
                    <a16:creationId xmlns:a16="http://schemas.microsoft.com/office/drawing/2014/main" id="{2853C233-1249-42B4-8720-D79A588E89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6846" y="4006281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6" name="Connettore diritto 175">
                <a:extLst>
                  <a:ext uri="{FF2B5EF4-FFF2-40B4-BE49-F238E27FC236}">
                    <a16:creationId xmlns:a16="http://schemas.microsoft.com/office/drawing/2014/main" id="{E28D480C-0A29-4021-8A7C-41A6879213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15394" y="4006281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7" name="Connettore diritto 176">
                <a:extLst>
                  <a:ext uri="{FF2B5EF4-FFF2-40B4-BE49-F238E27FC236}">
                    <a16:creationId xmlns:a16="http://schemas.microsoft.com/office/drawing/2014/main" id="{C79FDA3B-C507-4372-8D02-04530A5B6B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66494" y="4006281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8" name="CasellaDiTesto 177">
                <a:extLst>
                  <a:ext uri="{FF2B5EF4-FFF2-40B4-BE49-F238E27FC236}">
                    <a16:creationId xmlns:a16="http://schemas.microsoft.com/office/drawing/2014/main" id="{887240F7-89D5-4B04-8B7E-4C48FE5F8853}"/>
                  </a:ext>
                </a:extLst>
              </p:cNvPr>
              <p:cNvSpPr txBox="1"/>
              <p:nvPr/>
            </p:nvSpPr>
            <p:spPr>
              <a:xfrm>
                <a:off x="679889" y="3771474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1</a:t>
                </a:r>
              </a:p>
            </p:txBody>
          </p:sp>
          <p:sp>
            <p:nvSpPr>
              <p:cNvPr id="179" name="CasellaDiTesto 178">
                <a:extLst>
                  <a:ext uri="{FF2B5EF4-FFF2-40B4-BE49-F238E27FC236}">
                    <a16:creationId xmlns:a16="http://schemas.microsoft.com/office/drawing/2014/main" id="{7CAE4C6B-B839-4A01-B8DC-ACFCEF436327}"/>
                  </a:ext>
                </a:extLst>
              </p:cNvPr>
              <p:cNvSpPr txBox="1"/>
              <p:nvPr/>
            </p:nvSpPr>
            <p:spPr>
              <a:xfrm>
                <a:off x="1112741" y="3771474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5</a:t>
                </a:r>
              </a:p>
            </p:txBody>
          </p:sp>
          <p:sp>
            <p:nvSpPr>
              <p:cNvPr id="180" name="CasellaDiTesto 179">
                <a:extLst>
                  <a:ext uri="{FF2B5EF4-FFF2-40B4-BE49-F238E27FC236}">
                    <a16:creationId xmlns:a16="http://schemas.microsoft.com/office/drawing/2014/main" id="{441616F2-0268-4649-8638-B1EFAAD9F2DB}"/>
                  </a:ext>
                </a:extLst>
              </p:cNvPr>
              <p:cNvSpPr txBox="1"/>
              <p:nvPr/>
            </p:nvSpPr>
            <p:spPr>
              <a:xfrm>
                <a:off x="1620636" y="3771474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</a:t>
                </a:r>
              </a:p>
            </p:txBody>
          </p:sp>
        </p:grpSp>
        <p:sp>
          <p:nvSpPr>
            <p:cNvPr id="252" name="CasellaDiTesto 251">
              <a:extLst>
                <a:ext uri="{FF2B5EF4-FFF2-40B4-BE49-F238E27FC236}">
                  <a16:creationId xmlns:a16="http://schemas.microsoft.com/office/drawing/2014/main" id="{5E60B042-7584-4680-840F-A2B794484C3F}"/>
                </a:ext>
              </a:extLst>
            </p:cNvPr>
            <p:cNvSpPr txBox="1"/>
            <p:nvPr/>
          </p:nvSpPr>
          <p:spPr>
            <a:xfrm>
              <a:off x="1049413" y="7630543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Y537S</a:t>
              </a:r>
            </a:p>
          </p:txBody>
        </p:sp>
      </p:grpSp>
      <p:grpSp>
        <p:nvGrpSpPr>
          <p:cNvPr id="254" name="Gruppo 253">
            <a:extLst>
              <a:ext uri="{FF2B5EF4-FFF2-40B4-BE49-F238E27FC236}">
                <a16:creationId xmlns:a16="http://schemas.microsoft.com/office/drawing/2014/main" id="{0D9CD8E3-905F-4014-A7F1-518337D5ECE4}"/>
              </a:ext>
            </a:extLst>
          </p:cNvPr>
          <p:cNvGrpSpPr/>
          <p:nvPr/>
        </p:nvGrpSpPr>
        <p:grpSpPr>
          <a:xfrm>
            <a:off x="3891640" y="6588224"/>
            <a:ext cx="2818808" cy="1308861"/>
            <a:chOff x="3891640" y="6588224"/>
            <a:chExt cx="2818808" cy="1308861"/>
          </a:xfrm>
        </p:grpSpPr>
        <p:grpSp>
          <p:nvGrpSpPr>
            <p:cNvPr id="215" name="Gruppo 214">
              <a:extLst>
                <a:ext uri="{FF2B5EF4-FFF2-40B4-BE49-F238E27FC236}">
                  <a16:creationId xmlns:a16="http://schemas.microsoft.com/office/drawing/2014/main" id="{E5FFF784-216C-449B-B31C-17592073B869}"/>
                </a:ext>
              </a:extLst>
            </p:cNvPr>
            <p:cNvGrpSpPr/>
            <p:nvPr/>
          </p:nvGrpSpPr>
          <p:grpSpPr>
            <a:xfrm>
              <a:off x="3891640" y="6588224"/>
              <a:ext cx="2818808" cy="1001324"/>
              <a:chOff x="3850225" y="3761943"/>
              <a:chExt cx="2818808" cy="1001324"/>
            </a:xfrm>
          </p:grpSpPr>
          <p:pic>
            <p:nvPicPr>
              <p:cNvPr id="216" name="Immagine 215">
                <a:extLst>
                  <a:ext uri="{FF2B5EF4-FFF2-40B4-BE49-F238E27FC236}">
                    <a16:creationId xmlns:a16="http://schemas.microsoft.com/office/drawing/2014/main" id="{281C5B54-86B6-467C-883D-07718DB2BF4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850225" y="4549042"/>
                <a:ext cx="1800000" cy="14040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17" name="CasellaDiTesto 216">
                <a:extLst>
                  <a:ext uri="{FF2B5EF4-FFF2-40B4-BE49-F238E27FC236}">
                    <a16:creationId xmlns:a16="http://schemas.microsoft.com/office/drawing/2014/main" id="{98524A09-F223-439F-9D89-11E4368CDFFD}"/>
                  </a:ext>
                </a:extLst>
              </p:cNvPr>
              <p:cNvSpPr txBox="1"/>
              <p:nvPr/>
            </p:nvSpPr>
            <p:spPr>
              <a:xfrm>
                <a:off x="5581876" y="4303560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1</a:t>
                </a:r>
              </a:p>
            </p:txBody>
          </p:sp>
          <p:sp>
            <p:nvSpPr>
              <p:cNvPr id="218" name="CasellaDiTesto 217">
                <a:extLst>
                  <a:ext uri="{FF2B5EF4-FFF2-40B4-BE49-F238E27FC236}">
                    <a16:creationId xmlns:a16="http://schemas.microsoft.com/office/drawing/2014/main" id="{54741D36-5547-4BFA-9DB3-6A5523FE253F}"/>
                  </a:ext>
                </a:extLst>
              </p:cNvPr>
              <p:cNvSpPr txBox="1"/>
              <p:nvPr/>
            </p:nvSpPr>
            <p:spPr>
              <a:xfrm>
                <a:off x="5581876" y="4458568"/>
                <a:ext cx="652102" cy="3046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Vinculin</a:t>
                </a:r>
                <a:endParaRPr lang="it-IT" sz="1200" dirty="0"/>
              </a:p>
            </p:txBody>
          </p:sp>
          <p:sp>
            <p:nvSpPr>
              <p:cNvPr id="219" name="CasellaDiTesto 218">
                <a:extLst>
                  <a:ext uri="{FF2B5EF4-FFF2-40B4-BE49-F238E27FC236}">
                    <a16:creationId xmlns:a16="http://schemas.microsoft.com/office/drawing/2014/main" id="{270707B4-48A9-41ED-A900-766A46EB961B}"/>
                  </a:ext>
                </a:extLst>
              </p:cNvPr>
              <p:cNvSpPr txBox="1"/>
              <p:nvPr/>
            </p:nvSpPr>
            <p:spPr>
              <a:xfrm>
                <a:off x="5581876" y="4132754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296-CHK1</a:t>
                </a:r>
              </a:p>
            </p:txBody>
          </p:sp>
          <p:grpSp>
            <p:nvGrpSpPr>
              <p:cNvPr id="220" name="Gruppo 219">
                <a:extLst>
                  <a:ext uri="{FF2B5EF4-FFF2-40B4-BE49-F238E27FC236}">
                    <a16:creationId xmlns:a16="http://schemas.microsoft.com/office/drawing/2014/main" id="{272AB5B3-AE62-459D-8412-5E551AC162D0}"/>
                  </a:ext>
                </a:extLst>
              </p:cNvPr>
              <p:cNvGrpSpPr/>
              <p:nvPr/>
            </p:nvGrpSpPr>
            <p:grpSpPr>
              <a:xfrm>
                <a:off x="3850225" y="3963782"/>
                <a:ext cx="943034" cy="276999"/>
                <a:chOff x="3894249" y="2576928"/>
                <a:chExt cx="943034" cy="276999"/>
              </a:xfrm>
            </p:grpSpPr>
            <p:sp>
              <p:nvSpPr>
                <p:cNvPr id="241" name="CasellaDiTesto 240">
                  <a:extLst>
                    <a:ext uri="{FF2B5EF4-FFF2-40B4-BE49-F238E27FC236}">
                      <a16:creationId xmlns:a16="http://schemas.microsoft.com/office/drawing/2014/main" id="{FAB02A69-7F11-43A8-B0DF-91A9BD07BFD0}"/>
                    </a:ext>
                  </a:extLst>
                </p:cNvPr>
                <p:cNvSpPr txBox="1"/>
                <p:nvPr/>
              </p:nvSpPr>
              <p:spPr>
                <a:xfrm>
                  <a:off x="3894249" y="2576928"/>
                  <a:ext cx="235962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242" name="CasellaDiTesto 241">
                  <a:extLst>
                    <a:ext uri="{FF2B5EF4-FFF2-40B4-BE49-F238E27FC236}">
                      <a16:creationId xmlns:a16="http://schemas.microsoft.com/office/drawing/2014/main" id="{F3DA2A2D-2833-4E95-BF5A-5C04D57DE2CC}"/>
                    </a:ext>
                  </a:extLst>
                </p:cNvPr>
                <p:cNvSpPr txBox="1"/>
                <p:nvPr/>
              </p:nvSpPr>
              <p:spPr>
                <a:xfrm>
                  <a:off x="4130211" y="2576928"/>
                  <a:ext cx="274434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  <p:sp>
              <p:nvSpPr>
                <p:cNvPr id="243" name="CasellaDiTesto 242">
                  <a:extLst>
                    <a:ext uri="{FF2B5EF4-FFF2-40B4-BE49-F238E27FC236}">
                      <a16:creationId xmlns:a16="http://schemas.microsoft.com/office/drawing/2014/main" id="{0A09C752-88E9-4B04-BA63-57ED45889B4E}"/>
                    </a:ext>
                  </a:extLst>
                </p:cNvPr>
                <p:cNvSpPr txBox="1"/>
                <p:nvPr/>
              </p:nvSpPr>
              <p:spPr>
                <a:xfrm>
                  <a:off x="4386895" y="2576928"/>
                  <a:ext cx="235962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244" name="CasellaDiTesto 243">
                  <a:extLst>
                    <a:ext uri="{FF2B5EF4-FFF2-40B4-BE49-F238E27FC236}">
                      <a16:creationId xmlns:a16="http://schemas.microsoft.com/office/drawing/2014/main" id="{E51C1FCF-4188-4880-BB1B-1BA95BF33ACF}"/>
                    </a:ext>
                  </a:extLst>
                </p:cNvPr>
                <p:cNvSpPr txBox="1"/>
                <p:nvPr/>
              </p:nvSpPr>
              <p:spPr>
                <a:xfrm>
                  <a:off x="4562849" y="2576928"/>
                  <a:ext cx="274434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</p:grpSp>
          <p:sp>
            <p:nvSpPr>
              <p:cNvPr id="221" name="CasellaDiTesto 220">
                <a:extLst>
                  <a:ext uri="{FF2B5EF4-FFF2-40B4-BE49-F238E27FC236}">
                    <a16:creationId xmlns:a16="http://schemas.microsoft.com/office/drawing/2014/main" id="{6F0C8B9C-091A-4350-82CA-4BCD386C6D6B}"/>
                  </a:ext>
                </a:extLst>
              </p:cNvPr>
              <p:cNvSpPr txBox="1"/>
              <p:nvPr/>
            </p:nvSpPr>
            <p:spPr>
              <a:xfrm>
                <a:off x="4766852" y="3963782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222" name="CasellaDiTesto 221">
                <a:extLst>
                  <a:ext uri="{FF2B5EF4-FFF2-40B4-BE49-F238E27FC236}">
                    <a16:creationId xmlns:a16="http://schemas.microsoft.com/office/drawing/2014/main" id="{70733B21-7CF5-469B-B404-65F0F418E3BD}"/>
                  </a:ext>
                </a:extLst>
              </p:cNvPr>
              <p:cNvSpPr txBox="1"/>
              <p:nvPr/>
            </p:nvSpPr>
            <p:spPr>
              <a:xfrm>
                <a:off x="4969473" y="3963782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223" name="CasellaDiTesto 222">
                <a:extLst>
                  <a:ext uri="{FF2B5EF4-FFF2-40B4-BE49-F238E27FC236}">
                    <a16:creationId xmlns:a16="http://schemas.microsoft.com/office/drawing/2014/main" id="{83B06673-3645-4DBE-B487-FB84F9F16A1A}"/>
                  </a:ext>
                </a:extLst>
              </p:cNvPr>
              <p:cNvSpPr txBox="1"/>
              <p:nvPr/>
            </p:nvSpPr>
            <p:spPr>
              <a:xfrm>
                <a:off x="5207105" y="3963782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224" name="CasellaDiTesto 223">
                <a:extLst>
                  <a:ext uri="{FF2B5EF4-FFF2-40B4-BE49-F238E27FC236}">
                    <a16:creationId xmlns:a16="http://schemas.microsoft.com/office/drawing/2014/main" id="{277BCD7E-A58E-4F69-96C7-E9ACEEB8D546}"/>
                  </a:ext>
                </a:extLst>
              </p:cNvPr>
              <p:cNvSpPr txBox="1"/>
              <p:nvPr/>
            </p:nvSpPr>
            <p:spPr>
              <a:xfrm>
                <a:off x="5406874" y="3963782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225" name="CasellaDiTesto 224">
                <a:extLst>
                  <a:ext uri="{FF2B5EF4-FFF2-40B4-BE49-F238E27FC236}">
                    <a16:creationId xmlns:a16="http://schemas.microsoft.com/office/drawing/2014/main" id="{FF6740A7-3C66-4869-B3A2-546E6B19E307}"/>
                  </a:ext>
                </a:extLst>
              </p:cNvPr>
              <p:cNvSpPr txBox="1"/>
              <p:nvPr/>
            </p:nvSpPr>
            <p:spPr>
              <a:xfrm>
                <a:off x="5594848" y="3963782"/>
                <a:ext cx="58586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ETO  </a:t>
                </a:r>
              </a:p>
            </p:txBody>
          </p:sp>
          <p:cxnSp>
            <p:nvCxnSpPr>
              <p:cNvPr id="226" name="Connettore diritto 225">
                <a:extLst>
                  <a:ext uri="{FF2B5EF4-FFF2-40B4-BE49-F238E27FC236}">
                    <a16:creationId xmlns:a16="http://schemas.microsoft.com/office/drawing/2014/main" id="{55744559-7C44-48F2-9225-419167E9DAA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60852" y="4014638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7" name="Connettore diritto 226">
                <a:extLst>
                  <a:ext uri="{FF2B5EF4-FFF2-40B4-BE49-F238E27FC236}">
                    <a16:creationId xmlns:a16="http://schemas.microsoft.com/office/drawing/2014/main" id="{2AA1E599-4EE0-46A8-A4C0-34F4341941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89400" y="4014638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8" name="Connettore diritto 227">
                <a:extLst>
                  <a:ext uri="{FF2B5EF4-FFF2-40B4-BE49-F238E27FC236}">
                    <a16:creationId xmlns:a16="http://schemas.microsoft.com/office/drawing/2014/main" id="{E477F1AE-4640-4E2F-B290-5E3D4410C3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40500" y="4014638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9" name="CasellaDiTesto 228">
                <a:extLst>
                  <a:ext uri="{FF2B5EF4-FFF2-40B4-BE49-F238E27FC236}">
                    <a16:creationId xmlns:a16="http://schemas.microsoft.com/office/drawing/2014/main" id="{7C477811-2308-4AF2-9D2F-BDF1E2C93D64}"/>
                  </a:ext>
                </a:extLst>
              </p:cNvPr>
              <p:cNvSpPr txBox="1"/>
              <p:nvPr/>
            </p:nvSpPr>
            <p:spPr>
              <a:xfrm>
                <a:off x="5594848" y="3779831"/>
                <a:ext cx="821535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it-IT" sz="1200" dirty="0"/>
                  <a:t>MK (µM)</a:t>
                </a:r>
              </a:p>
            </p:txBody>
          </p:sp>
          <p:pic>
            <p:nvPicPr>
              <p:cNvPr id="230" name="Immagine 229">
                <a:extLst>
                  <a:ext uri="{FF2B5EF4-FFF2-40B4-BE49-F238E27FC236}">
                    <a16:creationId xmlns:a16="http://schemas.microsoft.com/office/drawing/2014/main" id="{CAC91B89-F6B8-4754-B92E-49A84D80B3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850225" y="4380184"/>
                <a:ext cx="1800000" cy="14040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31" name="Immagine 230">
                <a:extLst>
                  <a:ext uri="{FF2B5EF4-FFF2-40B4-BE49-F238E27FC236}">
                    <a16:creationId xmlns:a16="http://schemas.microsoft.com/office/drawing/2014/main" id="{EF73046A-8947-4DA0-9EAF-A2398D46821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850225" y="4209378"/>
                <a:ext cx="1800000" cy="14040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232" name="Connettore diritto 231">
                <a:extLst>
                  <a:ext uri="{FF2B5EF4-FFF2-40B4-BE49-F238E27FC236}">
                    <a16:creationId xmlns:a16="http://schemas.microsoft.com/office/drawing/2014/main" id="{84FB0F13-9404-4374-8585-4ABA8606DF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48424" y="4000156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3" name="Connettore diritto 232">
                <a:extLst>
                  <a:ext uri="{FF2B5EF4-FFF2-40B4-BE49-F238E27FC236}">
                    <a16:creationId xmlns:a16="http://schemas.microsoft.com/office/drawing/2014/main" id="{B3C0E0F6-13FE-432A-9213-92919468788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76972" y="4000156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4" name="Connettore diritto 233">
                <a:extLst>
                  <a:ext uri="{FF2B5EF4-FFF2-40B4-BE49-F238E27FC236}">
                    <a16:creationId xmlns:a16="http://schemas.microsoft.com/office/drawing/2014/main" id="{A844C86F-19EA-4C2F-B9D1-ED08C965160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28072" y="4000156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5" name="Connettore diritto 234">
                <a:extLst>
                  <a:ext uri="{FF2B5EF4-FFF2-40B4-BE49-F238E27FC236}">
                    <a16:creationId xmlns:a16="http://schemas.microsoft.com/office/drawing/2014/main" id="{B2582B41-D23B-4D12-B0D7-50B9A773CC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48424" y="3996750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6" name="Connettore diritto 235">
                <a:extLst>
                  <a:ext uri="{FF2B5EF4-FFF2-40B4-BE49-F238E27FC236}">
                    <a16:creationId xmlns:a16="http://schemas.microsoft.com/office/drawing/2014/main" id="{2F782E9F-7D41-4C51-BEA4-BDC086D9406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76972" y="3996750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7" name="Connettore diritto 236">
                <a:extLst>
                  <a:ext uri="{FF2B5EF4-FFF2-40B4-BE49-F238E27FC236}">
                    <a16:creationId xmlns:a16="http://schemas.microsoft.com/office/drawing/2014/main" id="{EBC4F527-0C9B-4B9B-A2FC-E8BECDA7798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28072" y="3996750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8" name="CasellaDiTesto 237">
                <a:extLst>
                  <a:ext uri="{FF2B5EF4-FFF2-40B4-BE49-F238E27FC236}">
                    <a16:creationId xmlns:a16="http://schemas.microsoft.com/office/drawing/2014/main" id="{EB899B81-B427-4787-93B0-1FF420D1F53C}"/>
                  </a:ext>
                </a:extLst>
              </p:cNvPr>
              <p:cNvSpPr txBox="1"/>
              <p:nvPr/>
            </p:nvSpPr>
            <p:spPr>
              <a:xfrm>
                <a:off x="4341467" y="3761943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1</a:t>
                </a:r>
              </a:p>
            </p:txBody>
          </p:sp>
          <p:sp>
            <p:nvSpPr>
              <p:cNvPr id="239" name="CasellaDiTesto 238">
                <a:extLst>
                  <a:ext uri="{FF2B5EF4-FFF2-40B4-BE49-F238E27FC236}">
                    <a16:creationId xmlns:a16="http://schemas.microsoft.com/office/drawing/2014/main" id="{ABA290A7-2710-4FC7-A958-8975709E33A5}"/>
                  </a:ext>
                </a:extLst>
              </p:cNvPr>
              <p:cNvSpPr txBox="1"/>
              <p:nvPr/>
            </p:nvSpPr>
            <p:spPr>
              <a:xfrm>
                <a:off x="4774319" y="3761943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5</a:t>
                </a:r>
              </a:p>
            </p:txBody>
          </p:sp>
          <p:sp>
            <p:nvSpPr>
              <p:cNvPr id="240" name="CasellaDiTesto 239">
                <a:extLst>
                  <a:ext uri="{FF2B5EF4-FFF2-40B4-BE49-F238E27FC236}">
                    <a16:creationId xmlns:a16="http://schemas.microsoft.com/office/drawing/2014/main" id="{862E46CB-4CD5-467B-A23F-53AD734CDA6E}"/>
                  </a:ext>
                </a:extLst>
              </p:cNvPr>
              <p:cNvSpPr txBox="1"/>
              <p:nvPr/>
            </p:nvSpPr>
            <p:spPr>
              <a:xfrm>
                <a:off x="5282214" y="3761943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</a:t>
                </a:r>
              </a:p>
            </p:txBody>
          </p:sp>
        </p:grpSp>
        <p:sp>
          <p:nvSpPr>
            <p:cNvPr id="253" name="CasellaDiTesto 252">
              <a:extLst>
                <a:ext uri="{FF2B5EF4-FFF2-40B4-BE49-F238E27FC236}">
                  <a16:creationId xmlns:a16="http://schemas.microsoft.com/office/drawing/2014/main" id="{32739797-11A1-45FC-828F-D18834BEFCB3}"/>
                </a:ext>
              </a:extLst>
            </p:cNvPr>
            <p:cNvSpPr txBox="1"/>
            <p:nvPr/>
          </p:nvSpPr>
          <p:spPr>
            <a:xfrm>
              <a:off x="4476081" y="7620086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Y537S</a:t>
              </a:r>
            </a:p>
          </p:txBody>
        </p:sp>
      </p:grpSp>
      <p:grpSp>
        <p:nvGrpSpPr>
          <p:cNvPr id="265" name="Gruppo 264">
            <a:extLst>
              <a:ext uri="{FF2B5EF4-FFF2-40B4-BE49-F238E27FC236}">
                <a16:creationId xmlns:a16="http://schemas.microsoft.com/office/drawing/2014/main" id="{BFF3340E-D145-450B-B05F-072BBC466F43}"/>
              </a:ext>
            </a:extLst>
          </p:cNvPr>
          <p:cNvGrpSpPr/>
          <p:nvPr/>
        </p:nvGrpSpPr>
        <p:grpSpPr>
          <a:xfrm>
            <a:off x="456558" y="663110"/>
            <a:ext cx="2818808" cy="1750037"/>
            <a:chOff x="456558" y="663110"/>
            <a:chExt cx="2818808" cy="1750037"/>
          </a:xfrm>
        </p:grpSpPr>
        <p:grpSp>
          <p:nvGrpSpPr>
            <p:cNvPr id="64" name="Gruppo 63">
              <a:extLst>
                <a:ext uri="{FF2B5EF4-FFF2-40B4-BE49-F238E27FC236}">
                  <a16:creationId xmlns:a16="http://schemas.microsoft.com/office/drawing/2014/main" id="{BBDFDBEB-3F78-4831-A7FF-9ACF2B975DE0}"/>
                </a:ext>
              </a:extLst>
            </p:cNvPr>
            <p:cNvGrpSpPr/>
            <p:nvPr/>
          </p:nvGrpSpPr>
          <p:grpSpPr>
            <a:xfrm>
              <a:off x="456558" y="663110"/>
              <a:ext cx="2818808" cy="1579587"/>
              <a:chOff x="243965" y="5226724"/>
              <a:chExt cx="2818808" cy="1579587"/>
            </a:xfrm>
          </p:grpSpPr>
          <p:pic>
            <p:nvPicPr>
              <p:cNvPr id="65" name="Immagine 64">
                <a:extLst>
                  <a:ext uri="{FF2B5EF4-FFF2-40B4-BE49-F238E27FC236}">
                    <a16:creationId xmlns:a16="http://schemas.microsoft.com/office/drawing/2014/main" id="{7FB566A3-8EAF-4779-83F9-3459FF54CC3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243965" y="5657634"/>
                <a:ext cx="1800000" cy="14307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6" name="CasellaDiTesto 65">
                <a:extLst>
                  <a:ext uri="{FF2B5EF4-FFF2-40B4-BE49-F238E27FC236}">
                    <a16:creationId xmlns:a16="http://schemas.microsoft.com/office/drawing/2014/main" id="{A79610FA-F803-4294-BE77-2D0F340C2AD2}"/>
                  </a:ext>
                </a:extLst>
              </p:cNvPr>
              <p:cNvSpPr txBox="1"/>
              <p:nvPr/>
            </p:nvSpPr>
            <p:spPr>
              <a:xfrm>
                <a:off x="1975616" y="5950841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2</a:t>
                </a:r>
              </a:p>
            </p:txBody>
          </p:sp>
          <p:sp>
            <p:nvSpPr>
              <p:cNvPr id="67" name="CasellaDiTesto 66">
                <a:extLst>
                  <a:ext uri="{FF2B5EF4-FFF2-40B4-BE49-F238E27FC236}">
                    <a16:creationId xmlns:a16="http://schemas.microsoft.com/office/drawing/2014/main" id="{1BEE7CEC-4DD6-4EBF-8B2C-510745731DBB}"/>
                  </a:ext>
                </a:extLst>
              </p:cNvPr>
              <p:cNvSpPr txBox="1"/>
              <p:nvPr/>
            </p:nvSpPr>
            <p:spPr>
              <a:xfrm>
                <a:off x="1975616" y="6501612"/>
                <a:ext cx="652102" cy="3046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Vinculin</a:t>
                </a:r>
                <a:endParaRPr lang="it-IT" sz="1200" dirty="0"/>
              </a:p>
            </p:txBody>
          </p:sp>
          <p:sp>
            <p:nvSpPr>
              <p:cNvPr id="68" name="CasellaDiTesto 67">
                <a:extLst>
                  <a:ext uri="{FF2B5EF4-FFF2-40B4-BE49-F238E27FC236}">
                    <a16:creationId xmlns:a16="http://schemas.microsoft.com/office/drawing/2014/main" id="{47B3EB5D-B926-4606-A313-34D57D5351F6}"/>
                  </a:ext>
                </a:extLst>
              </p:cNvPr>
              <p:cNvSpPr txBox="1"/>
              <p:nvPr/>
            </p:nvSpPr>
            <p:spPr>
              <a:xfrm>
                <a:off x="1975616" y="5590673"/>
                <a:ext cx="99418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T68-CHK2</a:t>
                </a:r>
              </a:p>
            </p:txBody>
          </p:sp>
          <p:grpSp>
            <p:nvGrpSpPr>
              <p:cNvPr id="69" name="Gruppo 68">
                <a:extLst>
                  <a:ext uri="{FF2B5EF4-FFF2-40B4-BE49-F238E27FC236}">
                    <a16:creationId xmlns:a16="http://schemas.microsoft.com/office/drawing/2014/main" id="{E4CEB413-30F6-45FC-BE37-AB4ED7C6A00D}"/>
                  </a:ext>
                </a:extLst>
              </p:cNvPr>
              <p:cNvGrpSpPr/>
              <p:nvPr/>
            </p:nvGrpSpPr>
            <p:grpSpPr>
              <a:xfrm>
                <a:off x="243965" y="5414081"/>
                <a:ext cx="943034" cy="276999"/>
                <a:chOff x="3894249" y="2576928"/>
                <a:chExt cx="943034" cy="276999"/>
              </a:xfrm>
            </p:grpSpPr>
            <p:sp>
              <p:nvSpPr>
                <p:cNvPr id="93" name="CasellaDiTesto 92">
                  <a:extLst>
                    <a:ext uri="{FF2B5EF4-FFF2-40B4-BE49-F238E27FC236}">
                      <a16:creationId xmlns:a16="http://schemas.microsoft.com/office/drawing/2014/main" id="{90AE1590-8A17-4058-B063-EA21C0D86F59}"/>
                    </a:ext>
                  </a:extLst>
                </p:cNvPr>
                <p:cNvSpPr txBox="1"/>
                <p:nvPr/>
              </p:nvSpPr>
              <p:spPr>
                <a:xfrm>
                  <a:off x="3894249" y="2576928"/>
                  <a:ext cx="235962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94" name="CasellaDiTesto 93">
                  <a:extLst>
                    <a:ext uri="{FF2B5EF4-FFF2-40B4-BE49-F238E27FC236}">
                      <a16:creationId xmlns:a16="http://schemas.microsoft.com/office/drawing/2014/main" id="{2F9C1393-76D3-46E9-A441-29A03AC79F3E}"/>
                    </a:ext>
                  </a:extLst>
                </p:cNvPr>
                <p:cNvSpPr txBox="1"/>
                <p:nvPr/>
              </p:nvSpPr>
              <p:spPr>
                <a:xfrm>
                  <a:off x="4130211" y="2576928"/>
                  <a:ext cx="274434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  <p:sp>
              <p:nvSpPr>
                <p:cNvPr id="95" name="CasellaDiTesto 94">
                  <a:extLst>
                    <a:ext uri="{FF2B5EF4-FFF2-40B4-BE49-F238E27FC236}">
                      <a16:creationId xmlns:a16="http://schemas.microsoft.com/office/drawing/2014/main" id="{05E40DCB-4275-494A-B7CE-B70D6BD0520B}"/>
                    </a:ext>
                  </a:extLst>
                </p:cNvPr>
                <p:cNvSpPr txBox="1"/>
                <p:nvPr/>
              </p:nvSpPr>
              <p:spPr>
                <a:xfrm>
                  <a:off x="4386895" y="2576928"/>
                  <a:ext cx="235962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96" name="CasellaDiTesto 95">
                  <a:extLst>
                    <a:ext uri="{FF2B5EF4-FFF2-40B4-BE49-F238E27FC236}">
                      <a16:creationId xmlns:a16="http://schemas.microsoft.com/office/drawing/2014/main" id="{9AA88D92-4DDE-4A1A-8E15-72C11DB31714}"/>
                    </a:ext>
                  </a:extLst>
                </p:cNvPr>
                <p:cNvSpPr txBox="1"/>
                <p:nvPr/>
              </p:nvSpPr>
              <p:spPr>
                <a:xfrm>
                  <a:off x="4562849" y="2576928"/>
                  <a:ext cx="274434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</p:grpSp>
          <p:sp>
            <p:nvSpPr>
              <p:cNvPr id="70" name="CasellaDiTesto 69">
                <a:extLst>
                  <a:ext uri="{FF2B5EF4-FFF2-40B4-BE49-F238E27FC236}">
                    <a16:creationId xmlns:a16="http://schemas.microsoft.com/office/drawing/2014/main" id="{2F040673-7879-46A7-BAEE-9C1037672D96}"/>
                  </a:ext>
                </a:extLst>
              </p:cNvPr>
              <p:cNvSpPr txBox="1"/>
              <p:nvPr/>
            </p:nvSpPr>
            <p:spPr>
              <a:xfrm>
                <a:off x="1160592" y="5414081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71" name="CasellaDiTesto 70">
                <a:extLst>
                  <a:ext uri="{FF2B5EF4-FFF2-40B4-BE49-F238E27FC236}">
                    <a16:creationId xmlns:a16="http://schemas.microsoft.com/office/drawing/2014/main" id="{16A3CEA9-321D-40EC-AB5E-FF06010EAD19}"/>
                  </a:ext>
                </a:extLst>
              </p:cNvPr>
              <p:cNvSpPr txBox="1"/>
              <p:nvPr/>
            </p:nvSpPr>
            <p:spPr>
              <a:xfrm>
                <a:off x="1363213" y="5414081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72" name="CasellaDiTesto 71">
                <a:extLst>
                  <a:ext uri="{FF2B5EF4-FFF2-40B4-BE49-F238E27FC236}">
                    <a16:creationId xmlns:a16="http://schemas.microsoft.com/office/drawing/2014/main" id="{A4400333-8E30-40C8-B476-F4424E130F1E}"/>
                  </a:ext>
                </a:extLst>
              </p:cNvPr>
              <p:cNvSpPr txBox="1"/>
              <p:nvPr/>
            </p:nvSpPr>
            <p:spPr>
              <a:xfrm>
                <a:off x="1600845" y="5414081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73" name="CasellaDiTesto 72">
                <a:extLst>
                  <a:ext uri="{FF2B5EF4-FFF2-40B4-BE49-F238E27FC236}">
                    <a16:creationId xmlns:a16="http://schemas.microsoft.com/office/drawing/2014/main" id="{6D36FD12-AB2E-408D-BF2C-098736849537}"/>
                  </a:ext>
                </a:extLst>
              </p:cNvPr>
              <p:cNvSpPr txBox="1"/>
              <p:nvPr/>
            </p:nvSpPr>
            <p:spPr>
              <a:xfrm>
                <a:off x="1800614" y="5414081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74" name="CasellaDiTesto 73">
                <a:extLst>
                  <a:ext uri="{FF2B5EF4-FFF2-40B4-BE49-F238E27FC236}">
                    <a16:creationId xmlns:a16="http://schemas.microsoft.com/office/drawing/2014/main" id="{A53034A5-6FAE-4A8D-845F-076889CCDC25}"/>
                  </a:ext>
                </a:extLst>
              </p:cNvPr>
              <p:cNvSpPr txBox="1"/>
              <p:nvPr/>
            </p:nvSpPr>
            <p:spPr>
              <a:xfrm>
                <a:off x="1988588" y="5414081"/>
                <a:ext cx="58586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ETO  </a:t>
                </a:r>
              </a:p>
            </p:txBody>
          </p:sp>
          <p:cxnSp>
            <p:nvCxnSpPr>
              <p:cNvPr id="75" name="Connettore diritto 74">
                <a:extLst>
                  <a:ext uri="{FF2B5EF4-FFF2-40B4-BE49-F238E27FC236}">
                    <a16:creationId xmlns:a16="http://schemas.microsoft.com/office/drawing/2014/main" id="{0B6FB90C-F0B3-4CCB-B4AB-A0635F3FCB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4592" y="5464937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Connettore diritto 75">
                <a:extLst>
                  <a:ext uri="{FF2B5EF4-FFF2-40B4-BE49-F238E27FC236}">
                    <a16:creationId xmlns:a16="http://schemas.microsoft.com/office/drawing/2014/main" id="{A2D7C74F-6FCB-499A-BD07-271945156C0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3140" y="5464937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Connettore diritto 76">
                <a:extLst>
                  <a:ext uri="{FF2B5EF4-FFF2-40B4-BE49-F238E27FC236}">
                    <a16:creationId xmlns:a16="http://schemas.microsoft.com/office/drawing/2014/main" id="{50D9D317-9516-4ACB-A822-1156572B98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34240" y="5464937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8" name="CasellaDiTesto 77">
                <a:extLst>
                  <a:ext uri="{FF2B5EF4-FFF2-40B4-BE49-F238E27FC236}">
                    <a16:creationId xmlns:a16="http://schemas.microsoft.com/office/drawing/2014/main" id="{015646B5-8547-4045-8A1A-DBDA590F70DB}"/>
                  </a:ext>
                </a:extLst>
              </p:cNvPr>
              <p:cNvSpPr txBox="1"/>
              <p:nvPr/>
            </p:nvSpPr>
            <p:spPr>
              <a:xfrm>
                <a:off x="1988588" y="5230130"/>
                <a:ext cx="821535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it-IT" sz="1200" dirty="0"/>
                  <a:t>KU (µM)</a:t>
                </a:r>
              </a:p>
            </p:txBody>
          </p:sp>
          <p:cxnSp>
            <p:nvCxnSpPr>
              <p:cNvPr id="79" name="Connettore diritto 78">
                <a:extLst>
                  <a:ext uri="{FF2B5EF4-FFF2-40B4-BE49-F238E27FC236}">
                    <a16:creationId xmlns:a16="http://schemas.microsoft.com/office/drawing/2014/main" id="{44F1C586-1FD3-4A6D-9C6C-7978993E4F5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4592" y="5461531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Connettore diritto 79">
                <a:extLst>
                  <a:ext uri="{FF2B5EF4-FFF2-40B4-BE49-F238E27FC236}">
                    <a16:creationId xmlns:a16="http://schemas.microsoft.com/office/drawing/2014/main" id="{3B24D9EC-16A6-4D4D-96E3-DE7A5EEA62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3140" y="5461531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Connettore diritto 80">
                <a:extLst>
                  <a:ext uri="{FF2B5EF4-FFF2-40B4-BE49-F238E27FC236}">
                    <a16:creationId xmlns:a16="http://schemas.microsoft.com/office/drawing/2014/main" id="{7699B18A-025D-4C59-9297-F8E6567DD43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34240" y="5461531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2" name="CasellaDiTesto 81">
                <a:extLst>
                  <a:ext uri="{FF2B5EF4-FFF2-40B4-BE49-F238E27FC236}">
                    <a16:creationId xmlns:a16="http://schemas.microsoft.com/office/drawing/2014/main" id="{FF23A694-748E-4D5F-8568-3028854125A8}"/>
                  </a:ext>
                </a:extLst>
              </p:cNvPr>
              <p:cNvSpPr txBox="1"/>
              <p:nvPr/>
            </p:nvSpPr>
            <p:spPr>
              <a:xfrm>
                <a:off x="747635" y="5226724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1</a:t>
                </a:r>
              </a:p>
            </p:txBody>
          </p:sp>
          <p:sp>
            <p:nvSpPr>
              <p:cNvPr id="83" name="CasellaDiTesto 82">
                <a:extLst>
                  <a:ext uri="{FF2B5EF4-FFF2-40B4-BE49-F238E27FC236}">
                    <a16:creationId xmlns:a16="http://schemas.microsoft.com/office/drawing/2014/main" id="{6963FE9D-2138-4C10-93F8-971DAEC5DB30}"/>
                  </a:ext>
                </a:extLst>
              </p:cNvPr>
              <p:cNvSpPr txBox="1"/>
              <p:nvPr/>
            </p:nvSpPr>
            <p:spPr>
              <a:xfrm>
                <a:off x="1180487" y="5226724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5</a:t>
                </a:r>
              </a:p>
            </p:txBody>
          </p:sp>
          <p:sp>
            <p:nvSpPr>
              <p:cNvPr id="84" name="CasellaDiTesto 83">
                <a:extLst>
                  <a:ext uri="{FF2B5EF4-FFF2-40B4-BE49-F238E27FC236}">
                    <a16:creationId xmlns:a16="http://schemas.microsoft.com/office/drawing/2014/main" id="{56D1343E-F540-48DE-B6C8-17BF5F68875B}"/>
                  </a:ext>
                </a:extLst>
              </p:cNvPr>
              <p:cNvSpPr txBox="1"/>
              <p:nvPr/>
            </p:nvSpPr>
            <p:spPr>
              <a:xfrm>
                <a:off x="1688382" y="5226724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</a:t>
                </a:r>
              </a:p>
            </p:txBody>
          </p:sp>
          <p:pic>
            <p:nvPicPr>
              <p:cNvPr id="85" name="Immagine 84">
                <a:extLst>
                  <a:ext uri="{FF2B5EF4-FFF2-40B4-BE49-F238E27FC236}">
                    <a16:creationId xmlns:a16="http://schemas.microsoft.com/office/drawing/2014/main" id="{C3993995-BA75-4222-8547-D37FD7B00DF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/>
              <a:stretch>
                <a:fillRect/>
              </a:stretch>
            </p:blipFill>
            <p:spPr>
              <a:xfrm>
                <a:off x="243965" y="6017802"/>
                <a:ext cx="1800000" cy="14307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6" name="Immagine 85">
                <a:extLst>
                  <a:ext uri="{FF2B5EF4-FFF2-40B4-BE49-F238E27FC236}">
                    <a16:creationId xmlns:a16="http://schemas.microsoft.com/office/drawing/2014/main" id="{07DEDFE1-B1A8-451F-BA62-BBFF090198B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>
                <a:extLst>
                  <a:ext uri="{BEBA8EAE-BF5A-486C-A8C5-ECC9F3942E4B}">
                    <a14:imgProps xmlns:a14="http://schemas.microsoft.com/office/drawing/2010/main">
                      <a14:imgLayer r:embed="rId28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43965" y="6582423"/>
                <a:ext cx="1800000" cy="14307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87" name="CasellaDiTesto 86">
                <a:extLst>
                  <a:ext uri="{FF2B5EF4-FFF2-40B4-BE49-F238E27FC236}">
                    <a16:creationId xmlns:a16="http://schemas.microsoft.com/office/drawing/2014/main" id="{4E20B6DD-6DBF-4506-8A3F-D55D5F40A169}"/>
                  </a:ext>
                </a:extLst>
              </p:cNvPr>
              <p:cNvSpPr txBox="1"/>
              <p:nvPr/>
            </p:nvSpPr>
            <p:spPr>
              <a:xfrm>
                <a:off x="1975616" y="5772321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516-CHK2</a:t>
                </a:r>
              </a:p>
            </p:txBody>
          </p:sp>
          <p:sp>
            <p:nvSpPr>
              <p:cNvPr id="88" name="CasellaDiTesto 87">
                <a:extLst>
                  <a:ext uri="{FF2B5EF4-FFF2-40B4-BE49-F238E27FC236}">
                    <a16:creationId xmlns:a16="http://schemas.microsoft.com/office/drawing/2014/main" id="{8C84A4FD-2A31-42B3-B131-4B8FF8F7D205}"/>
                  </a:ext>
                </a:extLst>
              </p:cNvPr>
              <p:cNvSpPr txBox="1"/>
              <p:nvPr/>
            </p:nvSpPr>
            <p:spPr>
              <a:xfrm>
                <a:off x="1975616" y="6140448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296-CHK1</a:t>
                </a:r>
              </a:p>
            </p:txBody>
          </p:sp>
          <p:sp>
            <p:nvSpPr>
              <p:cNvPr id="89" name="CasellaDiTesto 88">
                <a:extLst>
                  <a:ext uri="{FF2B5EF4-FFF2-40B4-BE49-F238E27FC236}">
                    <a16:creationId xmlns:a16="http://schemas.microsoft.com/office/drawing/2014/main" id="{67D59985-F9B4-4C00-B730-00F4D9139AA0}"/>
                  </a:ext>
                </a:extLst>
              </p:cNvPr>
              <p:cNvSpPr txBox="1"/>
              <p:nvPr/>
            </p:nvSpPr>
            <p:spPr>
              <a:xfrm>
                <a:off x="1975616" y="6332526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1</a:t>
                </a:r>
              </a:p>
            </p:txBody>
          </p:sp>
          <p:pic>
            <p:nvPicPr>
              <p:cNvPr id="90" name="Immagine 89">
                <a:extLst>
                  <a:ext uri="{FF2B5EF4-FFF2-40B4-BE49-F238E27FC236}">
                    <a16:creationId xmlns:a16="http://schemas.microsoft.com/office/drawing/2014/main" id="{5077B973-F1B8-43A5-9CAF-F0AF30BBD9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9">
                <a:extLst>
                  <a:ext uri="{BEBA8EAE-BF5A-486C-A8C5-ECC9F3942E4B}">
                    <a14:imgProps xmlns:a14="http://schemas.microsoft.com/office/drawing/2010/main">
                      <a14:imgLayer r:embed="rId30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43965" y="6202518"/>
                <a:ext cx="1800000" cy="15285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1" name="Immagine 90">
                <a:extLst>
                  <a:ext uri="{FF2B5EF4-FFF2-40B4-BE49-F238E27FC236}">
                    <a16:creationId xmlns:a16="http://schemas.microsoft.com/office/drawing/2014/main" id="{E6026777-CC8E-4415-801F-CD84769F9BE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1">
                <a:extLst>
                  <a:ext uri="{BEBA8EAE-BF5A-486C-A8C5-ECC9F3942E4B}">
                    <a14:imgProps xmlns:a14="http://schemas.microsoft.com/office/drawing/2010/main">
                      <a14:imgLayer r:embed="rId32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43965" y="6399487"/>
                <a:ext cx="1800000" cy="14307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2" name="Immagine 91">
                <a:extLst>
                  <a:ext uri="{FF2B5EF4-FFF2-40B4-BE49-F238E27FC236}">
                    <a16:creationId xmlns:a16="http://schemas.microsoft.com/office/drawing/2014/main" id="{C64C3A0D-8FAD-48F7-AC93-CD22F9A257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3">
                <a:extLst>
                  <a:ext uri="{BEBA8EAE-BF5A-486C-A8C5-ECC9F3942E4B}">
                    <a14:imgProps xmlns:a14="http://schemas.microsoft.com/office/drawing/2010/main">
                      <a14:imgLayer r:embed="rId34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43965" y="5839282"/>
                <a:ext cx="1800000" cy="14307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258" name="CasellaDiTesto 257">
              <a:extLst>
                <a:ext uri="{FF2B5EF4-FFF2-40B4-BE49-F238E27FC236}">
                  <a16:creationId xmlns:a16="http://schemas.microsoft.com/office/drawing/2014/main" id="{90C7810D-84C2-4CAC-84CF-7711423E293E}"/>
                </a:ext>
              </a:extLst>
            </p:cNvPr>
            <p:cNvSpPr txBox="1"/>
            <p:nvPr/>
          </p:nvSpPr>
          <p:spPr>
            <a:xfrm>
              <a:off x="1066494" y="2136148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/>
                <a:t>MCF-7</a:t>
              </a:r>
              <a:endParaRPr lang="it-IT" sz="1200" dirty="0"/>
            </a:p>
          </p:txBody>
        </p:sp>
      </p:grpSp>
      <p:grpSp>
        <p:nvGrpSpPr>
          <p:cNvPr id="264" name="Gruppo 263">
            <a:extLst>
              <a:ext uri="{FF2B5EF4-FFF2-40B4-BE49-F238E27FC236}">
                <a16:creationId xmlns:a16="http://schemas.microsoft.com/office/drawing/2014/main" id="{2AF9CE8F-EAB7-4037-A019-CBB5C3558333}"/>
              </a:ext>
            </a:extLst>
          </p:cNvPr>
          <p:cNvGrpSpPr/>
          <p:nvPr/>
        </p:nvGrpSpPr>
        <p:grpSpPr>
          <a:xfrm>
            <a:off x="3891640" y="676670"/>
            <a:ext cx="2826971" cy="1726020"/>
            <a:chOff x="3891640" y="676670"/>
            <a:chExt cx="2826971" cy="1726020"/>
          </a:xfrm>
        </p:grpSpPr>
        <p:grpSp>
          <p:nvGrpSpPr>
            <p:cNvPr id="97" name="Gruppo 96">
              <a:extLst>
                <a:ext uri="{FF2B5EF4-FFF2-40B4-BE49-F238E27FC236}">
                  <a16:creationId xmlns:a16="http://schemas.microsoft.com/office/drawing/2014/main" id="{735CD4E2-3862-4BF2-BC1F-7528C68C10C3}"/>
                </a:ext>
              </a:extLst>
            </p:cNvPr>
            <p:cNvGrpSpPr/>
            <p:nvPr/>
          </p:nvGrpSpPr>
          <p:grpSpPr>
            <a:xfrm>
              <a:off x="3891640" y="676670"/>
              <a:ext cx="2826971" cy="1552467"/>
              <a:chOff x="3952133" y="5190327"/>
              <a:chExt cx="2826971" cy="1552467"/>
            </a:xfrm>
          </p:grpSpPr>
          <p:sp>
            <p:nvSpPr>
              <p:cNvPr id="98" name="CasellaDiTesto 97">
                <a:extLst>
                  <a:ext uri="{FF2B5EF4-FFF2-40B4-BE49-F238E27FC236}">
                    <a16:creationId xmlns:a16="http://schemas.microsoft.com/office/drawing/2014/main" id="{C62AD4DD-6B61-4E05-918B-7A372433B435}"/>
                  </a:ext>
                </a:extLst>
              </p:cNvPr>
              <p:cNvSpPr txBox="1"/>
              <p:nvPr/>
            </p:nvSpPr>
            <p:spPr>
              <a:xfrm>
                <a:off x="5683784" y="5887324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1</a:t>
                </a:r>
              </a:p>
            </p:txBody>
          </p:sp>
          <p:sp>
            <p:nvSpPr>
              <p:cNvPr id="99" name="CasellaDiTesto 98">
                <a:extLst>
                  <a:ext uri="{FF2B5EF4-FFF2-40B4-BE49-F238E27FC236}">
                    <a16:creationId xmlns:a16="http://schemas.microsoft.com/office/drawing/2014/main" id="{2FED1925-ECA4-47C2-A350-473754664277}"/>
                  </a:ext>
                </a:extLst>
              </p:cNvPr>
              <p:cNvSpPr txBox="1"/>
              <p:nvPr/>
            </p:nvSpPr>
            <p:spPr>
              <a:xfrm>
                <a:off x="5683784" y="6438095"/>
                <a:ext cx="652102" cy="3046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Vinculin</a:t>
                </a:r>
                <a:endParaRPr lang="it-IT" sz="1200" dirty="0"/>
              </a:p>
            </p:txBody>
          </p:sp>
          <p:sp>
            <p:nvSpPr>
              <p:cNvPr id="100" name="CasellaDiTesto 99">
                <a:extLst>
                  <a:ext uri="{FF2B5EF4-FFF2-40B4-BE49-F238E27FC236}">
                    <a16:creationId xmlns:a16="http://schemas.microsoft.com/office/drawing/2014/main" id="{2551A0CE-E656-4A5F-B3AC-781890445D07}"/>
                  </a:ext>
                </a:extLst>
              </p:cNvPr>
              <p:cNvSpPr txBox="1"/>
              <p:nvPr/>
            </p:nvSpPr>
            <p:spPr>
              <a:xfrm>
                <a:off x="5683784" y="5527156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345-CHK1</a:t>
                </a:r>
              </a:p>
            </p:txBody>
          </p:sp>
          <p:grpSp>
            <p:nvGrpSpPr>
              <p:cNvPr id="101" name="Gruppo 100">
                <a:extLst>
                  <a:ext uri="{FF2B5EF4-FFF2-40B4-BE49-F238E27FC236}">
                    <a16:creationId xmlns:a16="http://schemas.microsoft.com/office/drawing/2014/main" id="{11F370C6-BCFF-4466-B067-1F000F12901B}"/>
                  </a:ext>
                </a:extLst>
              </p:cNvPr>
              <p:cNvGrpSpPr/>
              <p:nvPr/>
            </p:nvGrpSpPr>
            <p:grpSpPr>
              <a:xfrm>
                <a:off x="3952133" y="5374278"/>
                <a:ext cx="943034" cy="276999"/>
                <a:chOff x="3894249" y="2576928"/>
                <a:chExt cx="943034" cy="276999"/>
              </a:xfrm>
            </p:grpSpPr>
            <p:sp>
              <p:nvSpPr>
                <p:cNvPr id="123" name="CasellaDiTesto 122">
                  <a:extLst>
                    <a:ext uri="{FF2B5EF4-FFF2-40B4-BE49-F238E27FC236}">
                      <a16:creationId xmlns:a16="http://schemas.microsoft.com/office/drawing/2014/main" id="{9F948E81-D1A5-4488-885E-F2120AE298E6}"/>
                    </a:ext>
                  </a:extLst>
                </p:cNvPr>
                <p:cNvSpPr txBox="1"/>
                <p:nvPr/>
              </p:nvSpPr>
              <p:spPr>
                <a:xfrm>
                  <a:off x="3894249" y="2576928"/>
                  <a:ext cx="23596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124" name="CasellaDiTesto 123">
                  <a:extLst>
                    <a:ext uri="{FF2B5EF4-FFF2-40B4-BE49-F238E27FC236}">
                      <a16:creationId xmlns:a16="http://schemas.microsoft.com/office/drawing/2014/main" id="{1211BFBA-AA06-4758-BEA0-1594F77F2343}"/>
                    </a:ext>
                  </a:extLst>
                </p:cNvPr>
                <p:cNvSpPr txBox="1"/>
                <p:nvPr/>
              </p:nvSpPr>
              <p:spPr>
                <a:xfrm>
                  <a:off x="4130211" y="2576928"/>
                  <a:ext cx="27443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  <p:sp>
              <p:nvSpPr>
                <p:cNvPr id="125" name="CasellaDiTesto 124">
                  <a:extLst>
                    <a:ext uri="{FF2B5EF4-FFF2-40B4-BE49-F238E27FC236}">
                      <a16:creationId xmlns:a16="http://schemas.microsoft.com/office/drawing/2014/main" id="{6B8A9C44-0864-4072-9C28-037F8A195C2B}"/>
                    </a:ext>
                  </a:extLst>
                </p:cNvPr>
                <p:cNvSpPr txBox="1"/>
                <p:nvPr/>
              </p:nvSpPr>
              <p:spPr>
                <a:xfrm>
                  <a:off x="4386895" y="2576928"/>
                  <a:ext cx="23596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126" name="CasellaDiTesto 125">
                  <a:extLst>
                    <a:ext uri="{FF2B5EF4-FFF2-40B4-BE49-F238E27FC236}">
                      <a16:creationId xmlns:a16="http://schemas.microsoft.com/office/drawing/2014/main" id="{7EB9203A-76E4-4262-86FE-00D63BC902A6}"/>
                    </a:ext>
                  </a:extLst>
                </p:cNvPr>
                <p:cNvSpPr txBox="1"/>
                <p:nvPr/>
              </p:nvSpPr>
              <p:spPr>
                <a:xfrm>
                  <a:off x="4562849" y="2576928"/>
                  <a:ext cx="27443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</p:grpSp>
          <p:sp>
            <p:nvSpPr>
              <p:cNvPr id="102" name="CasellaDiTesto 101">
                <a:extLst>
                  <a:ext uri="{FF2B5EF4-FFF2-40B4-BE49-F238E27FC236}">
                    <a16:creationId xmlns:a16="http://schemas.microsoft.com/office/drawing/2014/main" id="{907C84DB-2F4E-4B9B-AF7E-2C1B02D185A6}"/>
                  </a:ext>
                </a:extLst>
              </p:cNvPr>
              <p:cNvSpPr txBox="1"/>
              <p:nvPr/>
            </p:nvSpPr>
            <p:spPr>
              <a:xfrm>
                <a:off x="4868760" y="5374278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03" name="CasellaDiTesto 102">
                <a:extLst>
                  <a:ext uri="{FF2B5EF4-FFF2-40B4-BE49-F238E27FC236}">
                    <a16:creationId xmlns:a16="http://schemas.microsoft.com/office/drawing/2014/main" id="{811880B3-B45A-4B11-A8FF-A1D8E3C9C3C6}"/>
                  </a:ext>
                </a:extLst>
              </p:cNvPr>
              <p:cNvSpPr txBox="1"/>
              <p:nvPr/>
            </p:nvSpPr>
            <p:spPr>
              <a:xfrm>
                <a:off x="5071381" y="5374278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04" name="CasellaDiTesto 103">
                <a:extLst>
                  <a:ext uri="{FF2B5EF4-FFF2-40B4-BE49-F238E27FC236}">
                    <a16:creationId xmlns:a16="http://schemas.microsoft.com/office/drawing/2014/main" id="{553FCF68-DD68-4988-B65C-C6A5A8F70FBC}"/>
                  </a:ext>
                </a:extLst>
              </p:cNvPr>
              <p:cNvSpPr txBox="1"/>
              <p:nvPr/>
            </p:nvSpPr>
            <p:spPr>
              <a:xfrm>
                <a:off x="5309013" y="5374278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05" name="CasellaDiTesto 104">
                <a:extLst>
                  <a:ext uri="{FF2B5EF4-FFF2-40B4-BE49-F238E27FC236}">
                    <a16:creationId xmlns:a16="http://schemas.microsoft.com/office/drawing/2014/main" id="{FA621728-5AD8-4BA3-99DA-E4F39BB5970E}"/>
                  </a:ext>
                </a:extLst>
              </p:cNvPr>
              <p:cNvSpPr txBox="1"/>
              <p:nvPr/>
            </p:nvSpPr>
            <p:spPr>
              <a:xfrm>
                <a:off x="5508782" y="5374278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06" name="CasellaDiTesto 105">
                <a:extLst>
                  <a:ext uri="{FF2B5EF4-FFF2-40B4-BE49-F238E27FC236}">
                    <a16:creationId xmlns:a16="http://schemas.microsoft.com/office/drawing/2014/main" id="{A760DEBE-88C7-46E0-B7AA-163D43C50BDC}"/>
                  </a:ext>
                </a:extLst>
              </p:cNvPr>
              <p:cNvSpPr txBox="1"/>
              <p:nvPr/>
            </p:nvSpPr>
            <p:spPr>
              <a:xfrm>
                <a:off x="5696756" y="5374278"/>
                <a:ext cx="585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ETO  </a:t>
                </a:r>
              </a:p>
            </p:txBody>
          </p:sp>
          <p:cxnSp>
            <p:nvCxnSpPr>
              <p:cNvPr id="107" name="Connettore diritto 106">
                <a:extLst>
                  <a:ext uri="{FF2B5EF4-FFF2-40B4-BE49-F238E27FC236}">
                    <a16:creationId xmlns:a16="http://schemas.microsoft.com/office/drawing/2014/main" id="{F13FC9E4-C245-4454-BDD8-DB8DAD8F475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62760" y="5425134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Connettore diritto 107">
                <a:extLst>
                  <a:ext uri="{FF2B5EF4-FFF2-40B4-BE49-F238E27FC236}">
                    <a16:creationId xmlns:a16="http://schemas.microsoft.com/office/drawing/2014/main" id="{4B6BB10B-2C6A-432F-A6F8-C7EB7B2162B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1308" y="5425134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9" name="Connettore diritto 108">
                <a:extLst>
                  <a:ext uri="{FF2B5EF4-FFF2-40B4-BE49-F238E27FC236}">
                    <a16:creationId xmlns:a16="http://schemas.microsoft.com/office/drawing/2014/main" id="{3DF0B768-64DF-49A6-A5D8-063E2DC318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42408" y="5425134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0" name="CasellaDiTesto 109">
                <a:extLst>
                  <a:ext uri="{FF2B5EF4-FFF2-40B4-BE49-F238E27FC236}">
                    <a16:creationId xmlns:a16="http://schemas.microsoft.com/office/drawing/2014/main" id="{F621E132-C712-4A97-B342-A224C33DD109}"/>
                  </a:ext>
                </a:extLst>
              </p:cNvPr>
              <p:cNvSpPr txBox="1"/>
              <p:nvPr/>
            </p:nvSpPr>
            <p:spPr>
              <a:xfrm>
                <a:off x="4455803" y="5190327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1</a:t>
                </a:r>
              </a:p>
            </p:txBody>
          </p:sp>
          <p:sp>
            <p:nvSpPr>
              <p:cNvPr id="111" name="CasellaDiTesto 110">
                <a:extLst>
                  <a:ext uri="{FF2B5EF4-FFF2-40B4-BE49-F238E27FC236}">
                    <a16:creationId xmlns:a16="http://schemas.microsoft.com/office/drawing/2014/main" id="{CC8EBFC3-9B10-4499-A5B4-7A4DF737AA56}"/>
                  </a:ext>
                </a:extLst>
              </p:cNvPr>
              <p:cNvSpPr txBox="1"/>
              <p:nvPr/>
            </p:nvSpPr>
            <p:spPr>
              <a:xfrm>
                <a:off x="4888655" y="5190327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5</a:t>
                </a:r>
              </a:p>
            </p:txBody>
          </p:sp>
          <p:sp>
            <p:nvSpPr>
              <p:cNvPr id="112" name="CasellaDiTesto 111">
                <a:extLst>
                  <a:ext uri="{FF2B5EF4-FFF2-40B4-BE49-F238E27FC236}">
                    <a16:creationId xmlns:a16="http://schemas.microsoft.com/office/drawing/2014/main" id="{F3EF2A0C-78D0-4459-83BD-6579247D5502}"/>
                  </a:ext>
                </a:extLst>
              </p:cNvPr>
              <p:cNvSpPr txBox="1"/>
              <p:nvPr/>
            </p:nvSpPr>
            <p:spPr>
              <a:xfrm>
                <a:off x="5396550" y="5190327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</a:t>
                </a:r>
              </a:p>
            </p:txBody>
          </p:sp>
          <p:sp>
            <p:nvSpPr>
              <p:cNvPr id="113" name="CasellaDiTesto 112">
                <a:extLst>
                  <a:ext uri="{FF2B5EF4-FFF2-40B4-BE49-F238E27FC236}">
                    <a16:creationId xmlns:a16="http://schemas.microsoft.com/office/drawing/2014/main" id="{58AC79F8-7E0B-47B5-BF76-3174C3B8E7C0}"/>
                  </a:ext>
                </a:extLst>
              </p:cNvPr>
              <p:cNvSpPr txBox="1"/>
              <p:nvPr/>
            </p:nvSpPr>
            <p:spPr>
              <a:xfrm>
                <a:off x="5696756" y="5190327"/>
                <a:ext cx="821535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it-IT" sz="1200" dirty="0"/>
                  <a:t>VE (µM)</a:t>
                </a:r>
              </a:p>
            </p:txBody>
          </p:sp>
          <p:pic>
            <p:nvPicPr>
              <p:cNvPr id="114" name="Immagine 113">
                <a:extLst>
                  <a:ext uri="{FF2B5EF4-FFF2-40B4-BE49-F238E27FC236}">
                    <a16:creationId xmlns:a16="http://schemas.microsoft.com/office/drawing/2014/main" id="{4B99E1DD-D2A3-4B22-9601-E97BD685EA4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5">
                <a:extLst>
                  <a:ext uri="{BEBA8EAE-BF5A-486C-A8C5-ECC9F3942E4B}">
                    <a14:imgProps xmlns:a14="http://schemas.microsoft.com/office/drawing/2010/main">
                      <a14:imgLayer r:embed="rId36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952133" y="5600902"/>
                <a:ext cx="1800000" cy="13629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15" name="Immagine 114">
                <a:extLst>
                  <a:ext uri="{FF2B5EF4-FFF2-40B4-BE49-F238E27FC236}">
                    <a16:creationId xmlns:a16="http://schemas.microsoft.com/office/drawing/2014/main" id="{0124B9AE-B7DD-4C5D-845C-67622363D1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7">
                <a:extLst>
                  <a:ext uri="{BEBA8EAE-BF5A-486C-A8C5-ECC9F3942E4B}">
                    <a14:imgProps xmlns:a14="http://schemas.microsoft.com/office/drawing/2010/main">
                      <a14:imgLayer r:embed="rId38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952133" y="5961070"/>
                <a:ext cx="1800000" cy="13629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16" name="Immagine 115">
                <a:extLst>
                  <a:ext uri="{FF2B5EF4-FFF2-40B4-BE49-F238E27FC236}">
                    <a16:creationId xmlns:a16="http://schemas.microsoft.com/office/drawing/2014/main" id="{9E273372-9A7F-4913-B788-FF67093D82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9">
                <a:extLst>
                  <a:ext uri="{BEBA8EAE-BF5A-486C-A8C5-ECC9F3942E4B}">
                    <a14:imgProps xmlns:a14="http://schemas.microsoft.com/office/drawing/2010/main">
                      <a14:imgLayer r:embed="rId40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952133" y="6518906"/>
                <a:ext cx="1800000" cy="15304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17" name="CasellaDiTesto 116">
                <a:extLst>
                  <a:ext uri="{FF2B5EF4-FFF2-40B4-BE49-F238E27FC236}">
                    <a16:creationId xmlns:a16="http://schemas.microsoft.com/office/drawing/2014/main" id="{FBF6E7AE-3827-46FA-8089-2723F0599805}"/>
                  </a:ext>
                </a:extLst>
              </p:cNvPr>
              <p:cNvSpPr txBox="1"/>
              <p:nvPr/>
            </p:nvSpPr>
            <p:spPr>
              <a:xfrm>
                <a:off x="5683784" y="5708804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296-CHK1</a:t>
                </a:r>
              </a:p>
            </p:txBody>
          </p:sp>
          <p:sp>
            <p:nvSpPr>
              <p:cNvPr id="118" name="CasellaDiTesto 117">
                <a:extLst>
                  <a:ext uri="{FF2B5EF4-FFF2-40B4-BE49-F238E27FC236}">
                    <a16:creationId xmlns:a16="http://schemas.microsoft.com/office/drawing/2014/main" id="{2D195CC4-730F-4335-8644-CC81BF044BF3}"/>
                  </a:ext>
                </a:extLst>
              </p:cNvPr>
              <p:cNvSpPr txBox="1"/>
              <p:nvPr/>
            </p:nvSpPr>
            <p:spPr>
              <a:xfrm>
                <a:off x="5691947" y="6269009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2</a:t>
                </a:r>
              </a:p>
            </p:txBody>
          </p:sp>
          <p:sp>
            <p:nvSpPr>
              <p:cNvPr id="119" name="CasellaDiTesto 118">
                <a:extLst>
                  <a:ext uri="{FF2B5EF4-FFF2-40B4-BE49-F238E27FC236}">
                    <a16:creationId xmlns:a16="http://schemas.microsoft.com/office/drawing/2014/main" id="{75AB72DF-12B5-48CB-8475-50C3AECB2AD7}"/>
                  </a:ext>
                </a:extLst>
              </p:cNvPr>
              <p:cNvSpPr txBox="1"/>
              <p:nvPr/>
            </p:nvSpPr>
            <p:spPr>
              <a:xfrm>
                <a:off x="5691947" y="6076931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516-CHK2</a:t>
                </a:r>
              </a:p>
            </p:txBody>
          </p:sp>
          <p:pic>
            <p:nvPicPr>
              <p:cNvPr id="120" name="Immagine 119">
                <a:extLst>
                  <a:ext uri="{FF2B5EF4-FFF2-40B4-BE49-F238E27FC236}">
                    <a16:creationId xmlns:a16="http://schemas.microsoft.com/office/drawing/2014/main" id="{96DC4678-A8C7-4666-8CD1-6A9C629E75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1">
                <a:extLst>
                  <a:ext uri="{BEBA8EAE-BF5A-486C-A8C5-ECC9F3942E4B}">
                    <a14:imgProps xmlns:a14="http://schemas.microsoft.com/office/drawing/2010/main">
                      <a14:imgLayer r:embed="rId42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952133" y="5779015"/>
                <a:ext cx="1800000" cy="13982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21" name="Immagine 120">
                <a:extLst>
                  <a:ext uri="{FF2B5EF4-FFF2-40B4-BE49-F238E27FC236}">
                    <a16:creationId xmlns:a16="http://schemas.microsoft.com/office/drawing/2014/main" id="{75E81A51-5854-4FEE-8443-3308AC1F03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3"/>
              <a:stretch>
                <a:fillRect/>
              </a:stretch>
            </p:blipFill>
            <p:spPr>
              <a:xfrm>
                <a:off x="3952133" y="6139001"/>
                <a:ext cx="1800000" cy="15039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22" name="Immagine 121">
                <a:extLst>
                  <a:ext uri="{FF2B5EF4-FFF2-40B4-BE49-F238E27FC236}">
                    <a16:creationId xmlns:a16="http://schemas.microsoft.com/office/drawing/2014/main" id="{A42940AE-3611-4B74-81A6-9B5C4FAFC7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4">
                <a:extLst>
                  <a:ext uri="{BEBA8EAE-BF5A-486C-A8C5-ECC9F3942E4B}">
                    <a14:imgProps xmlns:a14="http://schemas.microsoft.com/office/drawing/2010/main">
                      <a14:imgLayer r:embed="rId4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952133" y="6335970"/>
                <a:ext cx="1800000" cy="15039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259" name="CasellaDiTesto 258">
              <a:extLst>
                <a:ext uri="{FF2B5EF4-FFF2-40B4-BE49-F238E27FC236}">
                  <a16:creationId xmlns:a16="http://schemas.microsoft.com/office/drawing/2014/main" id="{6DECAA21-94F0-44F2-984F-C566F3F4EDB7}"/>
                </a:ext>
              </a:extLst>
            </p:cNvPr>
            <p:cNvSpPr txBox="1"/>
            <p:nvPr/>
          </p:nvSpPr>
          <p:spPr>
            <a:xfrm>
              <a:off x="4505037" y="2125691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/>
                <a:t>MCF-7</a:t>
              </a:r>
              <a:endParaRPr lang="it-IT" sz="1200" dirty="0"/>
            </a:p>
          </p:txBody>
        </p:sp>
      </p:grpSp>
      <p:grpSp>
        <p:nvGrpSpPr>
          <p:cNvPr id="262" name="Gruppo 261">
            <a:extLst>
              <a:ext uri="{FF2B5EF4-FFF2-40B4-BE49-F238E27FC236}">
                <a16:creationId xmlns:a16="http://schemas.microsoft.com/office/drawing/2014/main" id="{E438CAA8-0F78-44CE-B39E-592BECAAD570}"/>
              </a:ext>
            </a:extLst>
          </p:cNvPr>
          <p:cNvGrpSpPr/>
          <p:nvPr/>
        </p:nvGrpSpPr>
        <p:grpSpPr>
          <a:xfrm>
            <a:off x="410340" y="2771390"/>
            <a:ext cx="2818808" cy="1634815"/>
            <a:chOff x="410340" y="2771390"/>
            <a:chExt cx="2818808" cy="1634815"/>
          </a:xfrm>
        </p:grpSpPr>
        <p:grpSp>
          <p:nvGrpSpPr>
            <p:cNvPr id="33" name="Gruppo 32">
              <a:extLst>
                <a:ext uri="{FF2B5EF4-FFF2-40B4-BE49-F238E27FC236}">
                  <a16:creationId xmlns:a16="http://schemas.microsoft.com/office/drawing/2014/main" id="{46E91EAC-4BF0-4E8A-9471-3365990B352C}"/>
                </a:ext>
              </a:extLst>
            </p:cNvPr>
            <p:cNvGrpSpPr/>
            <p:nvPr/>
          </p:nvGrpSpPr>
          <p:grpSpPr>
            <a:xfrm>
              <a:off x="410340" y="2771390"/>
              <a:ext cx="2818808" cy="1461470"/>
              <a:chOff x="248774" y="7431010"/>
              <a:chExt cx="2818808" cy="1461470"/>
            </a:xfrm>
          </p:grpSpPr>
          <p:pic>
            <p:nvPicPr>
              <p:cNvPr id="34" name="Immagine 33">
                <a:extLst>
                  <a:ext uri="{FF2B5EF4-FFF2-40B4-BE49-F238E27FC236}">
                    <a16:creationId xmlns:a16="http://schemas.microsoft.com/office/drawing/2014/main" id="{C3DFD675-CD64-4D2A-A720-E7F7ED8EC1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6">
                <a:extLst>
                  <a:ext uri="{BEBA8EAE-BF5A-486C-A8C5-ECC9F3942E4B}">
                    <a14:imgProps xmlns:a14="http://schemas.microsoft.com/office/drawing/2010/main">
                      <a14:imgLayer r:embed="rId4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48774" y="7853390"/>
                <a:ext cx="1800000" cy="15304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5" name="CasellaDiTesto 34">
                <a:extLst>
                  <a:ext uri="{FF2B5EF4-FFF2-40B4-BE49-F238E27FC236}">
                    <a16:creationId xmlns:a16="http://schemas.microsoft.com/office/drawing/2014/main" id="{3E72D95B-AC29-4A97-BAED-1AAB537C06A1}"/>
                  </a:ext>
                </a:extLst>
              </p:cNvPr>
              <p:cNvSpPr txBox="1"/>
              <p:nvPr/>
            </p:nvSpPr>
            <p:spPr>
              <a:xfrm>
                <a:off x="1980425" y="7984190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2</a:t>
                </a:r>
              </a:p>
            </p:txBody>
          </p:sp>
          <p:sp>
            <p:nvSpPr>
              <p:cNvPr id="36" name="CasellaDiTesto 35">
                <a:extLst>
                  <a:ext uri="{FF2B5EF4-FFF2-40B4-BE49-F238E27FC236}">
                    <a16:creationId xmlns:a16="http://schemas.microsoft.com/office/drawing/2014/main" id="{02996BAD-A3D2-4AFA-8EE7-08E950282EEC}"/>
                  </a:ext>
                </a:extLst>
              </p:cNvPr>
              <p:cNvSpPr txBox="1"/>
              <p:nvPr/>
            </p:nvSpPr>
            <p:spPr>
              <a:xfrm>
                <a:off x="1980425" y="8587781"/>
                <a:ext cx="652102" cy="3046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Vinculin</a:t>
                </a:r>
                <a:endParaRPr lang="it-IT" sz="1200" dirty="0"/>
              </a:p>
            </p:txBody>
          </p:sp>
          <p:sp>
            <p:nvSpPr>
              <p:cNvPr id="37" name="CasellaDiTesto 36">
                <a:extLst>
                  <a:ext uri="{FF2B5EF4-FFF2-40B4-BE49-F238E27FC236}">
                    <a16:creationId xmlns:a16="http://schemas.microsoft.com/office/drawing/2014/main" id="{B54BEE0D-15E1-41F6-8807-F51E5815D9CE}"/>
                  </a:ext>
                </a:extLst>
              </p:cNvPr>
              <p:cNvSpPr txBox="1"/>
              <p:nvPr/>
            </p:nvSpPr>
            <p:spPr>
              <a:xfrm>
                <a:off x="1980425" y="7791414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516-CHK2</a:t>
                </a:r>
              </a:p>
            </p:txBody>
          </p:sp>
          <p:grpSp>
            <p:nvGrpSpPr>
              <p:cNvPr id="38" name="Gruppo 37">
                <a:extLst>
                  <a:ext uri="{FF2B5EF4-FFF2-40B4-BE49-F238E27FC236}">
                    <a16:creationId xmlns:a16="http://schemas.microsoft.com/office/drawing/2014/main" id="{263EF7FA-FCC2-4EA0-9809-2323921E392D}"/>
                  </a:ext>
                </a:extLst>
              </p:cNvPr>
              <p:cNvGrpSpPr/>
              <p:nvPr/>
            </p:nvGrpSpPr>
            <p:grpSpPr>
              <a:xfrm>
                <a:off x="248774" y="7622442"/>
                <a:ext cx="943034" cy="276999"/>
                <a:chOff x="3894249" y="2576928"/>
                <a:chExt cx="943034" cy="276999"/>
              </a:xfrm>
            </p:grpSpPr>
            <p:sp>
              <p:nvSpPr>
                <p:cNvPr id="60" name="CasellaDiTesto 59">
                  <a:extLst>
                    <a:ext uri="{FF2B5EF4-FFF2-40B4-BE49-F238E27FC236}">
                      <a16:creationId xmlns:a16="http://schemas.microsoft.com/office/drawing/2014/main" id="{DD5EB549-D546-4D67-A4CA-C5996C3785CF}"/>
                    </a:ext>
                  </a:extLst>
                </p:cNvPr>
                <p:cNvSpPr txBox="1"/>
                <p:nvPr/>
              </p:nvSpPr>
              <p:spPr>
                <a:xfrm>
                  <a:off x="3894249" y="2576928"/>
                  <a:ext cx="235962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61" name="CasellaDiTesto 60">
                  <a:extLst>
                    <a:ext uri="{FF2B5EF4-FFF2-40B4-BE49-F238E27FC236}">
                      <a16:creationId xmlns:a16="http://schemas.microsoft.com/office/drawing/2014/main" id="{FE39828F-02EB-430E-A9B0-2F841EABDE81}"/>
                    </a:ext>
                  </a:extLst>
                </p:cNvPr>
                <p:cNvSpPr txBox="1"/>
                <p:nvPr/>
              </p:nvSpPr>
              <p:spPr>
                <a:xfrm>
                  <a:off x="4130211" y="2576928"/>
                  <a:ext cx="274434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  <p:sp>
              <p:nvSpPr>
                <p:cNvPr id="62" name="CasellaDiTesto 61">
                  <a:extLst>
                    <a:ext uri="{FF2B5EF4-FFF2-40B4-BE49-F238E27FC236}">
                      <a16:creationId xmlns:a16="http://schemas.microsoft.com/office/drawing/2014/main" id="{FEA5B997-93D1-4912-93E7-9D2D87839B19}"/>
                    </a:ext>
                  </a:extLst>
                </p:cNvPr>
                <p:cNvSpPr txBox="1"/>
                <p:nvPr/>
              </p:nvSpPr>
              <p:spPr>
                <a:xfrm>
                  <a:off x="4386895" y="2576928"/>
                  <a:ext cx="235962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-</a:t>
                  </a:r>
                </a:p>
              </p:txBody>
            </p:sp>
            <p:sp>
              <p:nvSpPr>
                <p:cNvPr id="63" name="CasellaDiTesto 62">
                  <a:extLst>
                    <a:ext uri="{FF2B5EF4-FFF2-40B4-BE49-F238E27FC236}">
                      <a16:creationId xmlns:a16="http://schemas.microsoft.com/office/drawing/2014/main" id="{8B518DC3-6EDC-4692-85CA-75A68C666892}"/>
                    </a:ext>
                  </a:extLst>
                </p:cNvPr>
                <p:cNvSpPr txBox="1"/>
                <p:nvPr/>
              </p:nvSpPr>
              <p:spPr>
                <a:xfrm>
                  <a:off x="4562849" y="2576928"/>
                  <a:ext cx="274434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+</a:t>
                  </a:r>
                </a:p>
              </p:txBody>
            </p:sp>
          </p:grpSp>
          <p:sp>
            <p:nvSpPr>
              <p:cNvPr id="39" name="CasellaDiTesto 38">
                <a:extLst>
                  <a:ext uri="{FF2B5EF4-FFF2-40B4-BE49-F238E27FC236}">
                    <a16:creationId xmlns:a16="http://schemas.microsoft.com/office/drawing/2014/main" id="{31727A4E-4C11-494A-B16D-1AB7D60F8B33}"/>
                  </a:ext>
                </a:extLst>
              </p:cNvPr>
              <p:cNvSpPr txBox="1"/>
              <p:nvPr/>
            </p:nvSpPr>
            <p:spPr>
              <a:xfrm>
                <a:off x="1165401" y="7622442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40" name="CasellaDiTesto 39">
                <a:extLst>
                  <a:ext uri="{FF2B5EF4-FFF2-40B4-BE49-F238E27FC236}">
                    <a16:creationId xmlns:a16="http://schemas.microsoft.com/office/drawing/2014/main" id="{8CD24A4E-F3F0-434A-8BA5-63C1C3437FB4}"/>
                  </a:ext>
                </a:extLst>
              </p:cNvPr>
              <p:cNvSpPr txBox="1"/>
              <p:nvPr/>
            </p:nvSpPr>
            <p:spPr>
              <a:xfrm>
                <a:off x="1368022" y="7622442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41" name="CasellaDiTesto 40">
                <a:extLst>
                  <a:ext uri="{FF2B5EF4-FFF2-40B4-BE49-F238E27FC236}">
                    <a16:creationId xmlns:a16="http://schemas.microsoft.com/office/drawing/2014/main" id="{546A534B-98E5-4B24-AB52-4D7B6FEB23EB}"/>
                  </a:ext>
                </a:extLst>
              </p:cNvPr>
              <p:cNvSpPr txBox="1"/>
              <p:nvPr/>
            </p:nvSpPr>
            <p:spPr>
              <a:xfrm>
                <a:off x="1605654" y="7622442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42" name="CasellaDiTesto 41">
                <a:extLst>
                  <a:ext uri="{FF2B5EF4-FFF2-40B4-BE49-F238E27FC236}">
                    <a16:creationId xmlns:a16="http://schemas.microsoft.com/office/drawing/2014/main" id="{067B6167-CC2F-4A1C-B5FA-460DC729238E}"/>
                  </a:ext>
                </a:extLst>
              </p:cNvPr>
              <p:cNvSpPr txBox="1"/>
              <p:nvPr/>
            </p:nvSpPr>
            <p:spPr>
              <a:xfrm>
                <a:off x="1805423" y="7622442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43" name="CasellaDiTesto 42">
                <a:extLst>
                  <a:ext uri="{FF2B5EF4-FFF2-40B4-BE49-F238E27FC236}">
                    <a16:creationId xmlns:a16="http://schemas.microsoft.com/office/drawing/2014/main" id="{C862A38A-B1B0-4F39-BB3B-6FE18B00BD4B}"/>
                  </a:ext>
                </a:extLst>
              </p:cNvPr>
              <p:cNvSpPr txBox="1"/>
              <p:nvPr/>
            </p:nvSpPr>
            <p:spPr>
              <a:xfrm>
                <a:off x="1980425" y="7622442"/>
                <a:ext cx="58586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ETO  </a:t>
                </a:r>
              </a:p>
            </p:txBody>
          </p:sp>
          <p:cxnSp>
            <p:nvCxnSpPr>
              <p:cNvPr id="44" name="Connettore diritto 43">
                <a:extLst>
                  <a:ext uri="{FF2B5EF4-FFF2-40B4-BE49-F238E27FC236}">
                    <a16:creationId xmlns:a16="http://schemas.microsoft.com/office/drawing/2014/main" id="{73852BDD-00F5-4BEE-A539-9114DF516E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9401" y="7673298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Connettore diritto 44">
                <a:extLst>
                  <a:ext uri="{FF2B5EF4-FFF2-40B4-BE49-F238E27FC236}">
                    <a16:creationId xmlns:a16="http://schemas.microsoft.com/office/drawing/2014/main" id="{86C2A042-753A-4C68-8FF0-CB62BD6FF3B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7949" y="7673298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Connettore diritto 45">
                <a:extLst>
                  <a:ext uri="{FF2B5EF4-FFF2-40B4-BE49-F238E27FC236}">
                    <a16:creationId xmlns:a16="http://schemas.microsoft.com/office/drawing/2014/main" id="{BA6A172A-D856-48FC-9E28-978C9728A2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39049" y="7673298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7" name="CasellaDiTesto 46">
                <a:extLst>
                  <a:ext uri="{FF2B5EF4-FFF2-40B4-BE49-F238E27FC236}">
                    <a16:creationId xmlns:a16="http://schemas.microsoft.com/office/drawing/2014/main" id="{106A4957-5FEF-443D-8B08-C46F8FD3E2F5}"/>
                  </a:ext>
                </a:extLst>
              </p:cNvPr>
              <p:cNvSpPr txBox="1"/>
              <p:nvPr/>
            </p:nvSpPr>
            <p:spPr>
              <a:xfrm>
                <a:off x="1980425" y="7438491"/>
                <a:ext cx="91564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it-IT" sz="1200" dirty="0"/>
                  <a:t>CCT (µM)</a:t>
                </a:r>
              </a:p>
            </p:txBody>
          </p:sp>
          <p:pic>
            <p:nvPicPr>
              <p:cNvPr id="48" name="Immagine 47">
                <a:extLst>
                  <a:ext uri="{FF2B5EF4-FFF2-40B4-BE49-F238E27FC236}">
                    <a16:creationId xmlns:a16="http://schemas.microsoft.com/office/drawing/2014/main" id="{F52D1986-4732-47E5-8432-88578571C3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8">
                <a:extLst>
                  <a:ext uri="{BEBA8EAE-BF5A-486C-A8C5-ECC9F3942E4B}">
                    <a14:imgProps xmlns:a14="http://schemas.microsoft.com/office/drawing/2010/main">
                      <a14:imgLayer r:embed="rId49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48774" y="8648959"/>
                <a:ext cx="1800000" cy="15304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9" name="Immagine 48">
                <a:extLst>
                  <a:ext uri="{FF2B5EF4-FFF2-40B4-BE49-F238E27FC236}">
                    <a16:creationId xmlns:a16="http://schemas.microsoft.com/office/drawing/2014/main" id="{4EF03BC3-00FA-4498-B954-F5084E8BFF3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0">
                <a:extLst>
                  <a:ext uri="{BEBA8EAE-BF5A-486C-A8C5-ECC9F3942E4B}">
                    <a14:imgProps xmlns:a14="http://schemas.microsoft.com/office/drawing/2010/main">
                      <a14:imgLayer r:embed="rId51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48774" y="8052442"/>
                <a:ext cx="1800000" cy="15304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50" name="Connettore diritto 49">
                <a:extLst>
                  <a:ext uri="{FF2B5EF4-FFF2-40B4-BE49-F238E27FC236}">
                    <a16:creationId xmlns:a16="http://schemas.microsoft.com/office/drawing/2014/main" id="{0ADD73D7-103B-4D25-82F9-BE16AD0C73C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6535" y="7665817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nettore diritto 50">
                <a:extLst>
                  <a:ext uri="{FF2B5EF4-FFF2-40B4-BE49-F238E27FC236}">
                    <a16:creationId xmlns:a16="http://schemas.microsoft.com/office/drawing/2014/main" id="{2209403F-A42C-428F-80B3-A158C271CB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05083" y="7665817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Connettore diritto 51">
                <a:extLst>
                  <a:ext uri="{FF2B5EF4-FFF2-40B4-BE49-F238E27FC236}">
                    <a16:creationId xmlns:a16="http://schemas.microsoft.com/office/drawing/2014/main" id="{63E80D7D-5C01-4C65-87FF-3C1A6A3EFD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56183" y="7665817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3" name="CasellaDiTesto 52">
                <a:extLst>
                  <a:ext uri="{FF2B5EF4-FFF2-40B4-BE49-F238E27FC236}">
                    <a16:creationId xmlns:a16="http://schemas.microsoft.com/office/drawing/2014/main" id="{C7AF3C7B-E606-4794-805A-60C8350D1961}"/>
                  </a:ext>
                </a:extLst>
              </p:cNvPr>
              <p:cNvSpPr txBox="1"/>
              <p:nvPr/>
            </p:nvSpPr>
            <p:spPr>
              <a:xfrm>
                <a:off x="769578" y="7431010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1</a:t>
                </a:r>
              </a:p>
            </p:txBody>
          </p:sp>
          <p:sp>
            <p:nvSpPr>
              <p:cNvPr id="54" name="CasellaDiTesto 53">
                <a:extLst>
                  <a:ext uri="{FF2B5EF4-FFF2-40B4-BE49-F238E27FC236}">
                    <a16:creationId xmlns:a16="http://schemas.microsoft.com/office/drawing/2014/main" id="{D0D463E3-4827-4592-B1F1-67EE850F0C76}"/>
                  </a:ext>
                </a:extLst>
              </p:cNvPr>
              <p:cNvSpPr txBox="1"/>
              <p:nvPr/>
            </p:nvSpPr>
            <p:spPr>
              <a:xfrm>
                <a:off x="1202430" y="7431010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5</a:t>
                </a:r>
              </a:p>
            </p:txBody>
          </p:sp>
          <p:sp>
            <p:nvSpPr>
              <p:cNvPr id="55" name="CasellaDiTesto 54">
                <a:extLst>
                  <a:ext uri="{FF2B5EF4-FFF2-40B4-BE49-F238E27FC236}">
                    <a16:creationId xmlns:a16="http://schemas.microsoft.com/office/drawing/2014/main" id="{BE3E9930-026F-4680-AF0E-731B7C138D8C}"/>
                  </a:ext>
                </a:extLst>
              </p:cNvPr>
              <p:cNvSpPr txBox="1"/>
              <p:nvPr/>
            </p:nvSpPr>
            <p:spPr>
              <a:xfrm>
                <a:off x="1710325" y="743101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</a:t>
                </a:r>
              </a:p>
            </p:txBody>
          </p:sp>
          <p:sp>
            <p:nvSpPr>
              <p:cNvPr id="56" name="CasellaDiTesto 55">
                <a:extLst>
                  <a:ext uri="{FF2B5EF4-FFF2-40B4-BE49-F238E27FC236}">
                    <a16:creationId xmlns:a16="http://schemas.microsoft.com/office/drawing/2014/main" id="{6124BD3F-48CF-4560-BB05-D2188F368CDD}"/>
                  </a:ext>
                </a:extLst>
              </p:cNvPr>
              <p:cNvSpPr txBox="1"/>
              <p:nvPr/>
            </p:nvSpPr>
            <p:spPr>
              <a:xfrm>
                <a:off x="1980425" y="8386846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1</a:t>
                </a:r>
              </a:p>
            </p:txBody>
          </p:sp>
          <p:sp>
            <p:nvSpPr>
              <p:cNvPr id="57" name="CasellaDiTesto 56">
                <a:extLst>
                  <a:ext uri="{FF2B5EF4-FFF2-40B4-BE49-F238E27FC236}">
                    <a16:creationId xmlns:a16="http://schemas.microsoft.com/office/drawing/2014/main" id="{60F060A4-3974-41C9-AC6D-30FC6878EB35}"/>
                  </a:ext>
                </a:extLst>
              </p:cNvPr>
              <p:cNvSpPr txBox="1"/>
              <p:nvPr/>
            </p:nvSpPr>
            <p:spPr>
              <a:xfrm>
                <a:off x="1980425" y="8177940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296-CHK1</a:t>
                </a:r>
              </a:p>
            </p:txBody>
          </p:sp>
          <p:pic>
            <p:nvPicPr>
              <p:cNvPr id="58" name="Immagine 57">
                <a:extLst>
                  <a:ext uri="{FF2B5EF4-FFF2-40B4-BE49-F238E27FC236}">
                    <a16:creationId xmlns:a16="http://schemas.microsoft.com/office/drawing/2014/main" id="{975C8827-8B59-4589-858D-D8E1D26406C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2">
                <a:extLst>
                  <a:ext uri="{BEBA8EAE-BF5A-486C-A8C5-ECC9F3942E4B}">
                    <a14:imgProps xmlns:a14="http://schemas.microsoft.com/office/drawing/2010/main">
                      <a14:imgLayer r:embed="rId5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48774" y="8233467"/>
                <a:ext cx="1800000" cy="165945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</p:pic>
          <p:pic>
            <p:nvPicPr>
              <p:cNvPr id="59" name="Immagine 58">
                <a:extLst>
                  <a:ext uri="{FF2B5EF4-FFF2-40B4-BE49-F238E27FC236}">
                    <a16:creationId xmlns:a16="http://schemas.microsoft.com/office/drawing/2014/main" id="{E33C7FED-E43E-4C3B-9DB6-14E0A430327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4">
                <a:extLst>
                  <a:ext uri="{BEBA8EAE-BF5A-486C-A8C5-ECC9F3942E4B}">
                    <a14:imgProps xmlns:a14="http://schemas.microsoft.com/office/drawing/2010/main">
                      <a14:imgLayer r:embed="rId5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48774" y="8445552"/>
                <a:ext cx="1800000" cy="159587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</p:pic>
        </p:grpSp>
        <p:sp>
          <p:nvSpPr>
            <p:cNvPr id="260" name="CasellaDiTesto 259">
              <a:extLst>
                <a:ext uri="{FF2B5EF4-FFF2-40B4-BE49-F238E27FC236}">
                  <a16:creationId xmlns:a16="http://schemas.microsoft.com/office/drawing/2014/main" id="{9519ECF2-D9B9-4590-8BD6-C9DAF593D459}"/>
                </a:ext>
              </a:extLst>
            </p:cNvPr>
            <p:cNvSpPr txBox="1"/>
            <p:nvPr/>
          </p:nvSpPr>
          <p:spPr>
            <a:xfrm>
              <a:off x="1027079" y="4129206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/>
                <a:t>MCF-7</a:t>
              </a:r>
              <a:endParaRPr lang="it-IT" sz="1200" dirty="0"/>
            </a:p>
          </p:txBody>
        </p:sp>
      </p:grpSp>
      <p:grpSp>
        <p:nvGrpSpPr>
          <p:cNvPr id="263" name="Gruppo 262">
            <a:extLst>
              <a:ext uri="{FF2B5EF4-FFF2-40B4-BE49-F238E27FC236}">
                <a16:creationId xmlns:a16="http://schemas.microsoft.com/office/drawing/2014/main" id="{376333AF-7306-4D03-B5CE-9A79A1AF9ED2}"/>
              </a:ext>
            </a:extLst>
          </p:cNvPr>
          <p:cNvGrpSpPr/>
          <p:nvPr/>
        </p:nvGrpSpPr>
        <p:grpSpPr>
          <a:xfrm>
            <a:off x="3891640" y="2858887"/>
            <a:ext cx="2818808" cy="1536861"/>
            <a:chOff x="3891640" y="2858887"/>
            <a:chExt cx="2818808" cy="1536861"/>
          </a:xfrm>
        </p:grpSpPr>
        <p:grpSp>
          <p:nvGrpSpPr>
            <p:cNvPr id="3" name="Gruppo 2">
              <a:extLst>
                <a:ext uri="{FF2B5EF4-FFF2-40B4-BE49-F238E27FC236}">
                  <a16:creationId xmlns:a16="http://schemas.microsoft.com/office/drawing/2014/main" id="{019D84FB-04F2-4C4A-9856-34D4A05155A9}"/>
                </a:ext>
              </a:extLst>
            </p:cNvPr>
            <p:cNvGrpSpPr/>
            <p:nvPr/>
          </p:nvGrpSpPr>
          <p:grpSpPr>
            <a:xfrm>
              <a:off x="3891640" y="2858887"/>
              <a:ext cx="2818808" cy="1287297"/>
              <a:chOff x="3947324" y="6846088"/>
              <a:chExt cx="2818808" cy="1287297"/>
            </a:xfrm>
          </p:grpSpPr>
          <p:sp>
            <p:nvSpPr>
              <p:cNvPr id="4" name="CasellaDiTesto 3">
                <a:extLst>
                  <a:ext uri="{FF2B5EF4-FFF2-40B4-BE49-F238E27FC236}">
                    <a16:creationId xmlns:a16="http://schemas.microsoft.com/office/drawing/2014/main" id="{DD4AE994-34DF-4618-83A8-7F5C61010741}"/>
                  </a:ext>
                </a:extLst>
              </p:cNvPr>
              <p:cNvSpPr txBox="1"/>
              <p:nvPr/>
            </p:nvSpPr>
            <p:spPr>
              <a:xfrm>
                <a:off x="5678975" y="7369817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1</a:t>
                </a:r>
              </a:p>
            </p:txBody>
          </p:sp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45677536-ED94-4E00-8C8D-3E8D82AA14EA}"/>
                  </a:ext>
                </a:extLst>
              </p:cNvPr>
              <p:cNvSpPr txBox="1"/>
              <p:nvPr/>
            </p:nvSpPr>
            <p:spPr>
              <a:xfrm>
                <a:off x="5678975" y="7828686"/>
                <a:ext cx="652102" cy="3046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Vinculin</a:t>
                </a:r>
                <a:endParaRPr lang="it-IT" sz="1200" dirty="0"/>
              </a:p>
            </p:txBody>
          </p:sp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57ACA4CC-4D99-4BE4-87C8-82BF4380DAF3}"/>
                  </a:ext>
                </a:extLst>
              </p:cNvPr>
              <p:cNvSpPr txBox="1"/>
              <p:nvPr/>
            </p:nvSpPr>
            <p:spPr>
              <a:xfrm>
                <a:off x="5678975" y="7199011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296-CHK1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C60A4AAC-4E98-4446-B900-7701411FAD73}"/>
                  </a:ext>
                </a:extLst>
              </p:cNvPr>
              <p:cNvSpPr txBox="1"/>
              <p:nvPr/>
            </p:nvSpPr>
            <p:spPr>
              <a:xfrm>
                <a:off x="3947324" y="7030039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E3BD895B-200E-42E4-9E2B-C58543404A7B}"/>
                  </a:ext>
                </a:extLst>
              </p:cNvPr>
              <p:cNvSpPr txBox="1"/>
              <p:nvPr/>
            </p:nvSpPr>
            <p:spPr>
              <a:xfrm>
                <a:off x="4183286" y="7030039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F85E4FD6-AA33-4691-8B52-160ED81C651E}"/>
                  </a:ext>
                </a:extLst>
              </p:cNvPr>
              <p:cNvSpPr txBox="1"/>
              <p:nvPr/>
            </p:nvSpPr>
            <p:spPr>
              <a:xfrm>
                <a:off x="4439970" y="7030039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0" name="CasellaDiTesto 9">
                <a:extLst>
                  <a:ext uri="{FF2B5EF4-FFF2-40B4-BE49-F238E27FC236}">
                    <a16:creationId xmlns:a16="http://schemas.microsoft.com/office/drawing/2014/main" id="{1E620BFA-D18A-45C6-B606-74DE8B0A0E9A}"/>
                  </a:ext>
                </a:extLst>
              </p:cNvPr>
              <p:cNvSpPr txBox="1"/>
              <p:nvPr/>
            </p:nvSpPr>
            <p:spPr>
              <a:xfrm>
                <a:off x="4615924" y="7030039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0E16D420-55E3-4929-9C7F-5403647622ED}"/>
                  </a:ext>
                </a:extLst>
              </p:cNvPr>
              <p:cNvSpPr txBox="1"/>
              <p:nvPr/>
            </p:nvSpPr>
            <p:spPr>
              <a:xfrm>
                <a:off x="4863951" y="7030039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8CC800DB-BF3E-40D5-876C-88CEC2335B0F}"/>
                  </a:ext>
                </a:extLst>
              </p:cNvPr>
              <p:cNvSpPr txBox="1"/>
              <p:nvPr/>
            </p:nvSpPr>
            <p:spPr>
              <a:xfrm>
                <a:off x="5066572" y="7030039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8D509502-B9DF-47EB-B0E7-B735740C2569}"/>
                  </a:ext>
                </a:extLst>
              </p:cNvPr>
              <p:cNvSpPr txBox="1"/>
              <p:nvPr/>
            </p:nvSpPr>
            <p:spPr>
              <a:xfrm>
                <a:off x="5304204" y="7030039"/>
                <a:ext cx="23596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93DA862E-80A6-40E0-8E7D-151B64C8E2B6}"/>
                  </a:ext>
                </a:extLst>
              </p:cNvPr>
              <p:cNvSpPr txBox="1"/>
              <p:nvPr/>
            </p:nvSpPr>
            <p:spPr>
              <a:xfrm>
                <a:off x="5503973" y="7030039"/>
                <a:ext cx="27443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01BAE838-9CD3-40AA-842D-6E547E9B0733}"/>
                  </a:ext>
                </a:extLst>
              </p:cNvPr>
              <p:cNvSpPr txBox="1"/>
              <p:nvPr/>
            </p:nvSpPr>
            <p:spPr>
              <a:xfrm>
                <a:off x="5691947" y="7030039"/>
                <a:ext cx="58586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ETO  </a:t>
                </a:r>
              </a:p>
            </p:txBody>
          </p:sp>
          <p:cxnSp>
            <p:nvCxnSpPr>
              <p:cNvPr id="16" name="Connettore diritto 15">
                <a:extLst>
                  <a:ext uri="{FF2B5EF4-FFF2-40B4-BE49-F238E27FC236}">
                    <a16:creationId xmlns:a16="http://schemas.microsoft.com/office/drawing/2014/main" id="{0B6B9BF0-C93C-4DED-8C36-7B3C51894F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57951" y="7263775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" name="Connettore diritto 16">
                <a:extLst>
                  <a:ext uri="{FF2B5EF4-FFF2-40B4-BE49-F238E27FC236}">
                    <a16:creationId xmlns:a16="http://schemas.microsoft.com/office/drawing/2014/main" id="{B90B2BC3-3A2F-4FF6-B14C-2CCF96EAEDE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86499" y="7263775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" name="Connettore diritto 17">
                <a:extLst>
                  <a:ext uri="{FF2B5EF4-FFF2-40B4-BE49-F238E27FC236}">
                    <a16:creationId xmlns:a16="http://schemas.microsoft.com/office/drawing/2014/main" id="{49CB6CD9-7E1A-43A9-9405-318F35ADE1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37599" y="7263775"/>
                <a:ext cx="195190" cy="0"/>
              </a:xfrm>
              <a:prstGeom prst="line">
                <a:avLst/>
              </a:prstGeom>
              <a:ln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F1872441-4DE0-4818-B199-5D8A1B18FD58}"/>
                  </a:ext>
                </a:extLst>
              </p:cNvPr>
              <p:cNvSpPr txBox="1"/>
              <p:nvPr/>
            </p:nvSpPr>
            <p:spPr>
              <a:xfrm>
                <a:off x="5691947" y="6846088"/>
                <a:ext cx="821535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it-IT" sz="1200" dirty="0"/>
                  <a:t>MK (µM)</a:t>
                </a:r>
              </a:p>
            </p:txBody>
          </p:sp>
          <p:pic>
            <p:nvPicPr>
              <p:cNvPr id="20" name="Immagine 19">
                <a:extLst>
                  <a:ext uri="{FF2B5EF4-FFF2-40B4-BE49-F238E27FC236}">
                    <a16:creationId xmlns:a16="http://schemas.microsoft.com/office/drawing/2014/main" id="{856246F6-6151-45A3-9213-BCC330BF852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6">
                <a:extLst>
                  <a:ext uri="{BEBA8EAE-BF5A-486C-A8C5-ECC9F3942E4B}">
                    <a14:imgProps xmlns:a14="http://schemas.microsoft.com/office/drawing/2010/main">
                      <a14:imgLayer r:embed="rId5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947324" y="7275635"/>
                <a:ext cx="1800000" cy="12375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1" name="Immagine 20">
                <a:extLst>
                  <a:ext uri="{FF2B5EF4-FFF2-40B4-BE49-F238E27FC236}">
                    <a16:creationId xmlns:a16="http://schemas.microsoft.com/office/drawing/2014/main" id="{2E8CCF4E-8ED8-4E43-AFBC-ED025C63EBE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8">
                <a:extLst>
                  <a:ext uri="{BEBA8EAE-BF5A-486C-A8C5-ECC9F3942E4B}">
                    <a14:imgProps xmlns:a14="http://schemas.microsoft.com/office/drawing/2010/main">
                      <a14:imgLayer r:embed="rId59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947324" y="7446441"/>
                <a:ext cx="1800000" cy="12375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2" name="Immagine 21">
                <a:extLst>
                  <a:ext uri="{FF2B5EF4-FFF2-40B4-BE49-F238E27FC236}">
                    <a16:creationId xmlns:a16="http://schemas.microsoft.com/office/drawing/2014/main" id="{52EC0EB5-3A05-4B40-A23D-91A6113B418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0">
                <a:extLst>
                  <a:ext uri="{BEBA8EAE-BF5A-486C-A8C5-ECC9F3942E4B}">
                    <a14:imgProps xmlns:a14="http://schemas.microsoft.com/office/drawing/2010/main">
                      <a14:imgLayer r:embed="rId61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947324" y="7919160"/>
                <a:ext cx="1800000" cy="12375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23" name="Connettore diritto 22">
                <a:extLst>
                  <a:ext uri="{FF2B5EF4-FFF2-40B4-BE49-F238E27FC236}">
                    <a16:creationId xmlns:a16="http://schemas.microsoft.com/office/drawing/2014/main" id="{EFDB29D5-CA8E-48DC-AE55-A53D66E3F3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54750" y="7082748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" name="Connettore diritto 23">
                <a:extLst>
                  <a:ext uri="{FF2B5EF4-FFF2-40B4-BE49-F238E27FC236}">
                    <a16:creationId xmlns:a16="http://schemas.microsoft.com/office/drawing/2014/main" id="{2A95853E-957A-4DBA-82B2-FE0FCDA776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83298" y="7082748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Connettore diritto 24">
                <a:extLst>
                  <a:ext uri="{FF2B5EF4-FFF2-40B4-BE49-F238E27FC236}">
                    <a16:creationId xmlns:a16="http://schemas.microsoft.com/office/drawing/2014/main" id="{C5FAE627-33D3-4170-846F-8422492B0E9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34398" y="7082748"/>
                <a:ext cx="19519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BC550B6F-C5DD-4437-9473-EB6C595AC624}"/>
                  </a:ext>
                </a:extLst>
              </p:cNvPr>
              <p:cNvSpPr txBox="1"/>
              <p:nvPr/>
            </p:nvSpPr>
            <p:spPr>
              <a:xfrm>
                <a:off x="4447793" y="6847941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1</a:t>
                </a:r>
              </a:p>
            </p:txBody>
          </p:sp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4D60977B-F4D7-478F-A210-90AC73AA62B5}"/>
                  </a:ext>
                </a:extLst>
              </p:cNvPr>
              <p:cNvSpPr txBox="1"/>
              <p:nvPr/>
            </p:nvSpPr>
            <p:spPr>
              <a:xfrm>
                <a:off x="4880645" y="6847941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5</a:t>
                </a:r>
              </a:p>
            </p:txBody>
          </p:sp>
          <p:sp>
            <p:nvSpPr>
              <p:cNvPr id="28" name="CasellaDiTesto 27">
                <a:extLst>
                  <a:ext uri="{FF2B5EF4-FFF2-40B4-BE49-F238E27FC236}">
                    <a16:creationId xmlns:a16="http://schemas.microsoft.com/office/drawing/2014/main" id="{6738F2DF-710B-4640-B8A8-BC62A51CB4CC}"/>
                  </a:ext>
                </a:extLst>
              </p:cNvPr>
              <p:cNvSpPr txBox="1"/>
              <p:nvPr/>
            </p:nvSpPr>
            <p:spPr>
              <a:xfrm>
                <a:off x="5388540" y="684794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</a:t>
                </a:r>
              </a:p>
            </p:txBody>
          </p:sp>
          <p:pic>
            <p:nvPicPr>
              <p:cNvPr id="29" name="Immagine 28">
                <a:extLst>
                  <a:ext uri="{FF2B5EF4-FFF2-40B4-BE49-F238E27FC236}">
                    <a16:creationId xmlns:a16="http://schemas.microsoft.com/office/drawing/2014/main" id="{7C9B31F1-7785-47D9-A361-0B515893F4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2">
                <a:extLst>
                  <a:ext uri="{BEBA8EAE-BF5A-486C-A8C5-ECC9F3942E4B}">
                    <a14:imgProps xmlns:a14="http://schemas.microsoft.com/office/drawing/2010/main">
                      <a14:imgLayer r:embed="rId63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947324" y="7611867"/>
                <a:ext cx="1800000" cy="12022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0" name="Immagine 29">
                <a:extLst>
                  <a:ext uri="{FF2B5EF4-FFF2-40B4-BE49-F238E27FC236}">
                    <a16:creationId xmlns:a16="http://schemas.microsoft.com/office/drawing/2014/main" id="{B1470CBB-E784-489F-AC53-763C45CB75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4">
                <a:extLst>
                  <a:ext uri="{BEBA8EAE-BF5A-486C-A8C5-ECC9F3942E4B}">
                    <a14:imgProps xmlns:a14="http://schemas.microsoft.com/office/drawing/2010/main">
                      <a14:imgLayer r:embed="rId6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947324" y="7768091"/>
                <a:ext cx="1800000" cy="12189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1" name="CasellaDiTesto 30">
                <a:extLst>
                  <a:ext uri="{FF2B5EF4-FFF2-40B4-BE49-F238E27FC236}">
                    <a16:creationId xmlns:a16="http://schemas.microsoft.com/office/drawing/2014/main" id="{3E028E28-6271-4406-B870-980B04378B87}"/>
                  </a:ext>
                </a:extLst>
              </p:cNvPr>
              <p:cNvSpPr txBox="1"/>
              <p:nvPr/>
            </p:nvSpPr>
            <p:spPr>
              <a:xfrm>
                <a:off x="5678975" y="7690539"/>
                <a:ext cx="5934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HK2</a:t>
                </a:r>
              </a:p>
            </p:txBody>
          </p:sp>
          <p:sp>
            <p:nvSpPr>
              <p:cNvPr id="32" name="CasellaDiTesto 31">
                <a:extLst>
                  <a:ext uri="{FF2B5EF4-FFF2-40B4-BE49-F238E27FC236}">
                    <a16:creationId xmlns:a16="http://schemas.microsoft.com/office/drawing/2014/main" id="{7132A1DD-9554-4DC1-B324-CF943BBCB59A}"/>
                  </a:ext>
                </a:extLst>
              </p:cNvPr>
              <p:cNvSpPr txBox="1"/>
              <p:nvPr/>
            </p:nvSpPr>
            <p:spPr>
              <a:xfrm>
                <a:off x="5678975" y="7533480"/>
                <a:ext cx="10871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pS516-CHK2</a:t>
                </a:r>
              </a:p>
            </p:txBody>
          </p:sp>
        </p:grpSp>
        <p:sp>
          <p:nvSpPr>
            <p:cNvPr id="261" name="CasellaDiTesto 260">
              <a:extLst>
                <a:ext uri="{FF2B5EF4-FFF2-40B4-BE49-F238E27FC236}">
                  <a16:creationId xmlns:a16="http://schemas.microsoft.com/office/drawing/2014/main" id="{D8B34ED6-60D5-4087-B8EF-68955D7A1244}"/>
                </a:ext>
              </a:extLst>
            </p:cNvPr>
            <p:cNvSpPr txBox="1"/>
            <p:nvPr/>
          </p:nvSpPr>
          <p:spPr>
            <a:xfrm>
              <a:off x="4465622" y="4118749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/>
                <a:t>MCF-7</a:t>
              </a:r>
              <a:endParaRPr lang="it-IT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7143239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BDE97044-5372-40C5-B7AD-11D4719AAEB5}"/>
              </a:ext>
            </a:extLst>
          </p:cNvPr>
          <p:cNvSpPr txBox="1"/>
          <p:nvPr/>
        </p:nvSpPr>
        <p:spPr>
          <a:xfrm>
            <a:off x="2022205" y="142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ure 3</a:t>
            </a:r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D28D9807-C44F-4F76-B4BE-E0222825C87B}"/>
              </a:ext>
            </a:extLst>
          </p:cNvPr>
          <p:cNvGrpSpPr/>
          <p:nvPr/>
        </p:nvGrpSpPr>
        <p:grpSpPr>
          <a:xfrm>
            <a:off x="945763" y="876613"/>
            <a:ext cx="1691149" cy="1199716"/>
            <a:chOff x="2217765" y="835968"/>
            <a:chExt cx="1691149" cy="1199716"/>
          </a:xfrm>
        </p:grpSpPr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9765AF81-DF08-4C43-8E8C-73B1FEB2D0AC}"/>
                </a:ext>
              </a:extLst>
            </p:cNvPr>
            <p:cNvSpPr txBox="1"/>
            <p:nvPr/>
          </p:nvSpPr>
          <p:spPr>
            <a:xfrm>
              <a:off x="3256812" y="1239198"/>
              <a:ext cx="440389" cy="3046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ER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it-IT" sz="1200" dirty="0"/>
            </a:p>
          </p:txBody>
        </p: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0A60C100-5F5F-478E-B0E2-59FBED849F62}"/>
                </a:ext>
              </a:extLst>
            </p:cNvPr>
            <p:cNvSpPr txBox="1"/>
            <p:nvPr/>
          </p:nvSpPr>
          <p:spPr>
            <a:xfrm>
              <a:off x="3256812" y="1480163"/>
              <a:ext cx="652102" cy="3046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Vinculin</a:t>
              </a:r>
              <a:endParaRPr lang="it-IT" sz="1200" dirty="0"/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06DCB194-56AB-4AB2-9999-2EAE0B846C73}"/>
                </a:ext>
              </a:extLst>
            </p:cNvPr>
            <p:cNvSpPr txBox="1"/>
            <p:nvPr/>
          </p:nvSpPr>
          <p:spPr>
            <a:xfrm>
              <a:off x="2217765" y="10686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</a:t>
              </a: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9D83196F-5257-4625-B72C-E6EEA553FBBE}"/>
                </a:ext>
              </a:extLst>
            </p:cNvPr>
            <p:cNvSpPr txBox="1"/>
            <p:nvPr/>
          </p:nvSpPr>
          <p:spPr>
            <a:xfrm>
              <a:off x="2378921" y="1068665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1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69EA7D3A-80D8-44DB-BA6D-94DACABCB2CF}"/>
                </a:ext>
              </a:extLst>
            </p:cNvPr>
            <p:cNvSpPr txBox="1"/>
            <p:nvPr/>
          </p:nvSpPr>
          <p:spPr>
            <a:xfrm>
              <a:off x="2725273" y="106866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1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170156DF-984A-413A-A98E-110035561C4C}"/>
                </a:ext>
              </a:extLst>
            </p:cNvPr>
            <p:cNvSpPr txBox="1"/>
            <p:nvPr/>
          </p:nvSpPr>
          <p:spPr>
            <a:xfrm>
              <a:off x="3042828" y="10686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</a:t>
              </a:r>
            </a:p>
          </p:txBody>
        </p:sp>
        <p:cxnSp>
          <p:nvCxnSpPr>
            <p:cNvPr id="10" name="Connettore diritto 9">
              <a:extLst>
                <a:ext uri="{FF2B5EF4-FFF2-40B4-BE49-F238E27FC236}">
                  <a16:creationId xmlns:a16="http://schemas.microsoft.com/office/drawing/2014/main" id="{43FFC361-4E64-4019-8425-4135C4116F96}"/>
                </a:ext>
              </a:extLst>
            </p:cNvPr>
            <p:cNvCxnSpPr>
              <a:cxnSpLocks/>
            </p:cNvCxnSpPr>
            <p:nvPr/>
          </p:nvCxnSpPr>
          <p:spPr>
            <a:xfrm>
              <a:off x="2507912" y="1079007"/>
              <a:ext cx="73011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A9158AFE-B6A4-44E4-A598-A11752410FF1}"/>
                </a:ext>
              </a:extLst>
            </p:cNvPr>
            <p:cNvSpPr txBox="1"/>
            <p:nvPr/>
          </p:nvSpPr>
          <p:spPr>
            <a:xfrm>
              <a:off x="2580260" y="835968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GDC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7FC1DE70-2414-4E9E-A320-A490681B4527}"/>
                </a:ext>
              </a:extLst>
            </p:cNvPr>
            <p:cNvSpPr txBox="1"/>
            <p:nvPr/>
          </p:nvSpPr>
          <p:spPr>
            <a:xfrm>
              <a:off x="3203472" y="1068665"/>
              <a:ext cx="63289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sz="1200" dirty="0"/>
                <a:t> (µM)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C9D34849-A4C2-4450-9330-2CF6422288FB}"/>
                </a:ext>
              </a:extLst>
            </p:cNvPr>
            <p:cNvSpPr txBox="1"/>
            <p:nvPr/>
          </p:nvSpPr>
          <p:spPr>
            <a:xfrm>
              <a:off x="2472503" y="1730985"/>
              <a:ext cx="594860" cy="3046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/>
                <a:t>MCF-7</a:t>
              </a:r>
              <a:endParaRPr lang="it-IT" sz="1200" dirty="0"/>
            </a:p>
          </p:txBody>
        </p:sp>
        <p:pic>
          <p:nvPicPr>
            <p:cNvPr id="14" name="Immagine 13">
              <a:extLst>
                <a:ext uri="{FF2B5EF4-FFF2-40B4-BE49-F238E27FC236}">
                  <a16:creationId xmlns:a16="http://schemas.microsoft.com/office/drawing/2014/main" id="{B175F52A-9E39-4759-870A-4394CB7556A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227612" y="1297779"/>
              <a:ext cx="1080000" cy="1660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" name="Immagine 14">
              <a:extLst>
                <a:ext uri="{FF2B5EF4-FFF2-40B4-BE49-F238E27FC236}">
                  <a16:creationId xmlns:a16="http://schemas.microsoft.com/office/drawing/2014/main" id="{9E74E5E3-FD6C-4AA3-96F6-CAA151F0B03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227612" y="1535689"/>
              <a:ext cx="1080000" cy="16703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66" name="Gruppo 65">
            <a:extLst>
              <a:ext uri="{FF2B5EF4-FFF2-40B4-BE49-F238E27FC236}">
                <a16:creationId xmlns:a16="http://schemas.microsoft.com/office/drawing/2014/main" id="{F13EF42E-B086-4A6C-97D4-2767D468F232}"/>
              </a:ext>
            </a:extLst>
          </p:cNvPr>
          <p:cNvGrpSpPr/>
          <p:nvPr/>
        </p:nvGrpSpPr>
        <p:grpSpPr>
          <a:xfrm>
            <a:off x="945763" y="2031832"/>
            <a:ext cx="1691149" cy="1172016"/>
            <a:chOff x="1916832" y="1991187"/>
            <a:chExt cx="1691149" cy="1172016"/>
          </a:xfrm>
        </p:grpSpPr>
        <p:sp>
          <p:nvSpPr>
            <p:cNvPr id="67" name="CasellaDiTesto 66">
              <a:extLst>
                <a:ext uri="{FF2B5EF4-FFF2-40B4-BE49-F238E27FC236}">
                  <a16:creationId xmlns:a16="http://schemas.microsoft.com/office/drawing/2014/main" id="{6E30A3B0-3AE4-4D49-A0AA-D29B890A584A}"/>
                </a:ext>
              </a:extLst>
            </p:cNvPr>
            <p:cNvSpPr txBox="1"/>
            <p:nvPr/>
          </p:nvSpPr>
          <p:spPr>
            <a:xfrm>
              <a:off x="2955879" y="2394417"/>
              <a:ext cx="440389" cy="3046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ER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it-IT" sz="1200" dirty="0"/>
            </a:p>
          </p:txBody>
        </p:sp>
        <p:sp>
          <p:nvSpPr>
            <p:cNvPr id="68" name="CasellaDiTesto 67">
              <a:extLst>
                <a:ext uri="{FF2B5EF4-FFF2-40B4-BE49-F238E27FC236}">
                  <a16:creationId xmlns:a16="http://schemas.microsoft.com/office/drawing/2014/main" id="{FF0578AD-EBBD-4B39-9EC8-E134202F4DBA}"/>
                </a:ext>
              </a:extLst>
            </p:cNvPr>
            <p:cNvSpPr txBox="1"/>
            <p:nvPr/>
          </p:nvSpPr>
          <p:spPr>
            <a:xfrm>
              <a:off x="2955879" y="2635382"/>
              <a:ext cx="652102" cy="3046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Vinculin</a:t>
              </a:r>
              <a:endParaRPr lang="it-IT" sz="1200" dirty="0"/>
            </a:p>
          </p:txBody>
        </p: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id="{CB7DC0A5-7D34-44D2-9D33-FD9E3D2E7572}"/>
                </a:ext>
              </a:extLst>
            </p:cNvPr>
            <p:cNvSpPr txBox="1"/>
            <p:nvPr/>
          </p:nvSpPr>
          <p:spPr>
            <a:xfrm>
              <a:off x="1916832" y="222388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</a:t>
              </a:r>
            </a:p>
          </p:txBody>
        </p:sp>
        <p:sp>
          <p:nvSpPr>
            <p:cNvPr id="70" name="CasellaDiTesto 69">
              <a:extLst>
                <a:ext uri="{FF2B5EF4-FFF2-40B4-BE49-F238E27FC236}">
                  <a16:creationId xmlns:a16="http://schemas.microsoft.com/office/drawing/2014/main" id="{89FEA5D2-E1F8-4FA3-A351-F0F5EA073D76}"/>
                </a:ext>
              </a:extLst>
            </p:cNvPr>
            <p:cNvSpPr txBox="1"/>
            <p:nvPr/>
          </p:nvSpPr>
          <p:spPr>
            <a:xfrm>
              <a:off x="2077988" y="2223884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1</a:t>
              </a:r>
            </a:p>
          </p:txBody>
        </p:sp>
        <p:sp>
          <p:nvSpPr>
            <p:cNvPr id="71" name="CasellaDiTesto 70">
              <a:extLst>
                <a:ext uri="{FF2B5EF4-FFF2-40B4-BE49-F238E27FC236}">
                  <a16:creationId xmlns:a16="http://schemas.microsoft.com/office/drawing/2014/main" id="{BCDBC512-B488-4E94-A3F2-09AEC5930BC0}"/>
                </a:ext>
              </a:extLst>
            </p:cNvPr>
            <p:cNvSpPr txBox="1"/>
            <p:nvPr/>
          </p:nvSpPr>
          <p:spPr>
            <a:xfrm>
              <a:off x="2424340" y="222388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1</a:t>
              </a:r>
            </a:p>
          </p:txBody>
        </p:sp>
        <p:sp>
          <p:nvSpPr>
            <p:cNvPr id="72" name="CasellaDiTesto 71">
              <a:extLst>
                <a:ext uri="{FF2B5EF4-FFF2-40B4-BE49-F238E27FC236}">
                  <a16:creationId xmlns:a16="http://schemas.microsoft.com/office/drawing/2014/main" id="{2277FE02-CFBB-4E12-AB4F-AF01DFAD6576}"/>
                </a:ext>
              </a:extLst>
            </p:cNvPr>
            <p:cNvSpPr txBox="1"/>
            <p:nvPr/>
          </p:nvSpPr>
          <p:spPr>
            <a:xfrm>
              <a:off x="2741895" y="222388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</a:t>
              </a:r>
            </a:p>
          </p:txBody>
        </p:sp>
        <p:cxnSp>
          <p:nvCxnSpPr>
            <p:cNvPr id="73" name="Connettore diritto 72">
              <a:extLst>
                <a:ext uri="{FF2B5EF4-FFF2-40B4-BE49-F238E27FC236}">
                  <a16:creationId xmlns:a16="http://schemas.microsoft.com/office/drawing/2014/main" id="{53DCC29D-F700-4541-8F99-0388D31448DE}"/>
                </a:ext>
              </a:extLst>
            </p:cNvPr>
            <p:cNvCxnSpPr>
              <a:cxnSpLocks/>
            </p:cNvCxnSpPr>
            <p:nvPr/>
          </p:nvCxnSpPr>
          <p:spPr>
            <a:xfrm>
              <a:off x="2206979" y="2234226"/>
              <a:ext cx="73011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209A3B5D-00C2-4B89-861E-C0B46EA59D88}"/>
                </a:ext>
              </a:extLst>
            </p:cNvPr>
            <p:cNvSpPr txBox="1"/>
            <p:nvPr/>
          </p:nvSpPr>
          <p:spPr>
            <a:xfrm>
              <a:off x="2279327" y="1991187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GDC</a:t>
              </a:r>
            </a:p>
          </p:txBody>
        </p:sp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id="{92DFAE8F-ED33-40F2-94A9-D62E1227195D}"/>
                </a:ext>
              </a:extLst>
            </p:cNvPr>
            <p:cNvSpPr txBox="1"/>
            <p:nvPr/>
          </p:nvSpPr>
          <p:spPr>
            <a:xfrm>
              <a:off x="2902539" y="2223884"/>
              <a:ext cx="63289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sz="1200" dirty="0"/>
                <a:t> (µM)</a:t>
              </a:r>
            </a:p>
          </p:txBody>
        </p:sp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id="{DF3561D6-2197-4941-A077-BAC5FD552F09}"/>
                </a:ext>
              </a:extLst>
            </p:cNvPr>
            <p:cNvSpPr txBox="1"/>
            <p:nvPr/>
          </p:nvSpPr>
          <p:spPr>
            <a:xfrm>
              <a:off x="2171570" y="2886204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Y537S</a:t>
              </a:r>
            </a:p>
          </p:txBody>
        </p:sp>
        <p:pic>
          <p:nvPicPr>
            <p:cNvPr id="77" name="Immagine 76">
              <a:extLst>
                <a:ext uri="{FF2B5EF4-FFF2-40B4-BE49-F238E27FC236}">
                  <a16:creationId xmlns:a16="http://schemas.microsoft.com/office/drawing/2014/main" id="{93A13172-3E6A-4145-9B56-A93C65BCD85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926679" y="2452999"/>
              <a:ext cx="1080000" cy="16764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8" name="Immagine 77">
              <a:extLst>
                <a:ext uri="{FF2B5EF4-FFF2-40B4-BE49-F238E27FC236}">
                  <a16:creationId xmlns:a16="http://schemas.microsoft.com/office/drawing/2014/main" id="{0F6F8FAF-AC09-4055-8B72-F8EAC7444B3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926679" y="2693990"/>
              <a:ext cx="1080000" cy="16764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79" name="Gruppo 78">
            <a:extLst>
              <a:ext uri="{FF2B5EF4-FFF2-40B4-BE49-F238E27FC236}">
                <a16:creationId xmlns:a16="http://schemas.microsoft.com/office/drawing/2014/main" id="{E7C9E66A-2388-4E2B-9294-290620A0F047}"/>
              </a:ext>
            </a:extLst>
          </p:cNvPr>
          <p:cNvGrpSpPr/>
          <p:nvPr/>
        </p:nvGrpSpPr>
        <p:grpSpPr>
          <a:xfrm>
            <a:off x="212467" y="3851920"/>
            <a:ext cx="3013063" cy="1683474"/>
            <a:chOff x="7375391" y="2385090"/>
            <a:chExt cx="3013063" cy="1683474"/>
          </a:xfrm>
        </p:grpSpPr>
        <p:pic>
          <p:nvPicPr>
            <p:cNvPr id="80" name="Immagine 79">
              <a:extLst>
                <a:ext uri="{FF2B5EF4-FFF2-40B4-BE49-F238E27FC236}">
                  <a16:creationId xmlns:a16="http://schemas.microsoft.com/office/drawing/2014/main" id="{6B4AC7C6-0DBF-43A9-88FF-2BEBF64AC58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8102774" y="2671729"/>
              <a:ext cx="1708986" cy="1134000"/>
            </a:xfrm>
            <a:prstGeom prst="rect">
              <a:avLst/>
            </a:prstGeom>
          </p:spPr>
        </p:pic>
        <p:sp>
          <p:nvSpPr>
            <p:cNvPr id="81" name="CasellaDiTesto 80">
              <a:extLst>
                <a:ext uri="{FF2B5EF4-FFF2-40B4-BE49-F238E27FC236}">
                  <a16:creationId xmlns:a16="http://schemas.microsoft.com/office/drawing/2014/main" id="{70237911-487C-4757-A49F-7DBC6735BEA6}"/>
                </a:ext>
              </a:extLst>
            </p:cNvPr>
            <p:cNvSpPr txBox="1"/>
            <p:nvPr/>
          </p:nvSpPr>
          <p:spPr>
            <a:xfrm rot="16200000">
              <a:off x="6764487" y="2995994"/>
              <a:ext cx="168347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Normalized</a:t>
              </a:r>
              <a:r>
                <a:rPr lang="it-IT" sz="1200" dirty="0"/>
                <a:t> Cell Index</a:t>
              </a:r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0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82" name="CasellaDiTesto 81">
              <a:extLst>
                <a:ext uri="{FF2B5EF4-FFF2-40B4-BE49-F238E27FC236}">
                  <a16:creationId xmlns:a16="http://schemas.microsoft.com/office/drawing/2014/main" id="{4100524E-754A-4C7C-9D11-379710363E88}"/>
                </a:ext>
              </a:extLst>
            </p:cNvPr>
            <p:cNvSpPr txBox="1"/>
            <p:nvPr/>
          </p:nvSpPr>
          <p:spPr>
            <a:xfrm>
              <a:off x="7749398" y="309793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0</a:t>
              </a:r>
            </a:p>
          </p:txBody>
        </p:sp>
        <p:sp>
          <p:nvSpPr>
            <p:cNvPr id="83" name="CasellaDiTesto 82">
              <a:extLst>
                <a:ext uri="{FF2B5EF4-FFF2-40B4-BE49-F238E27FC236}">
                  <a16:creationId xmlns:a16="http://schemas.microsoft.com/office/drawing/2014/main" id="{B26E908C-214E-4CE0-A12B-D4143D7F78EA}"/>
                </a:ext>
              </a:extLst>
            </p:cNvPr>
            <p:cNvSpPr txBox="1"/>
            <p:nvPr/>
          </p:nvSpPr>
          <p:spPr>
            <a:xfrm>
              <a:off x="7749398" y="2919229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5</a:t>
              </a:r>
            </a:p>
          </p:txBody>
        </p:sp>
        <p:sp>
          <p:nvSpPr>
            <p:cNvPr id="84" name="CasellaDiTesto 83">
              <a:extLst>
                <a:ext uri="{FF2B5EF4-FFF2-40B4-BE49-F238E27FC236}">
                  <a16:creationId xmlns:a16="http://schemas.microsoft.com/office/drawing/2014/main" id="{D8F1C9CF-E5C5-4B59-A79A-3066FEEEB19A}"/>
                </a:ext>
              </a:extLst>
            </p:cNvPr>
            <p:cNvSpPr txBox="1"/>
            <p:nvPr/>
          </p:nvSpPr>
          <p:spPr>
            <a:xfrm>
              <a:off x="7749398" y="3286889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5</a:t>
              </a:r>
            </a:p>
          </p:txBody>
        </p:sp>
        <p:sp>
          <p:nvSpPr>
            <p:cNvPr id="85" name="CasellaDiTesto 84">
              <a:extLst>
                <a:ext uri="{FF2B5EF4-FFF2-40B4-BE49-F238E27FC236}">
                  <a16:creationId xmlns:a16="http://schemas.microsoft.com/office/drawing/2014/main" id="{57977FB9-8694-4A1D-9D25-422E31463ADB}"/>
                </a:ext>
              </a:extLst>
            </p:cNvPr>
            <p:cNvSpPr txBox="1"/>
            <p:nvPr/>
          </p:nvSpPr>
          <p:spPr>
            <a:xfrm>
              <a:off x="7698102" y="3630639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0.5</a:t>
              </a:r>
            </a:p>
          </p:txBody>
        </p:sp>
        <p:sp>
          <p:nvSpPr>
            <p:cNvPr id="86" name="CasellaDiTesto 85">
              <a:extLst>
                <a:ext uri="{FF2B5EF4-FFF2-40B4-BE49-F238E27FC236}">
                  <a16:creationId xmlns:a16="http://schemas.microsoft.com/office/drawing/2014/main" id="{13018A7C-FD25-442A-BF3C-FB95FA6A4DA3}"/>
                </a:ext>
              </a:extLst>
            </p:cNvPr>
            <p:cNvSpPr txBox="1"/>
            <p:nvPr/>
          </p:nvSpPr>
          <p:spPr>
            <a:xfrm>
              <a:off x="7749398" y="345391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87" name="CasellaDiTesto 86">
              <a:extLst>
                <a:ext uri="{FF2B5EF4-FFF2-40B4-BE49-F238E27FC236}">
                  <a16:creationId xmlns:a16="http://schemas.microsoft.com/office/drawing/2014/main" id="{25ACC2EB-6853-4700-9F53-196A3DB123E0}"/>
                </a:ext>
              </a:extLst>
            </p:cNvPr>
            <p:cNvSpPr txBox="1"/>
            <p:nvPr/>
          </p:nvSpPr>
          <p:spPr>
            <a:xfrm>
              <a:off x="8416570" y="2488052"/>
              <a:ext cx="12089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200"/>
                <a:t>MCF-7</a:t>
              </a:r>
              <a:endParaRPr lang="it-IT" sz="1200" dirty="0"/>
            </a:p>
          </p:txBody>
        </p:sp>
        <p:sp>
          <p:nvSpPr>
            <p:cNvPr id="88" name="CasellaDiTesto 87">
              <a:extLst>
                <a:ext uri="{FF2B5EF4-FFF2-40B4-BE49-F238E27FC236}">
                  <a16:creationId xmlns:a16="http://schemas.microsoft.com/office/drawing/2014/main" id="{C66F4B9B-4ECF-4616-9750-544EA431154E}"/>
                </a:ext>
              </a:extLst>
            </p:cNvPr>
            <p:cNvSpPr txBox="1"/>
            <p:nvPr/>
          </p:nvSpPr>
          <p:spPr>
            <a:xfrm>
              <a:off x="9703947" y="2987824"/>
              <a:ext cx="52610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1</a:t>
              </a:r>
            </a:p>
            <a:p>
              <a:r>
                <a:rPr lang="it-IT" sz="1200" dirty="0"/>
                <a:t>1; 10</a:t>
              </a:r>
            </a:p>
          </p:txBody>
        </p:sp>
        <p:sp>
          <p:nvSpPr>
            <p:cNvPr id="89" name="CasellaDiTesto 88">
              <a:extLst>
                <a:ext uri="{FF2B5EF4-FFF2-40B4-BE49-F238E27FC236}">
                  <a16:creationId xmlns:a16="http://schemas.microsoft.com/office/drawing/2014/main" id="{065A118F-D5D9-4DE5-91A3-02F0789356E2}"/>
                </a:ext>
              </a:extLst>
            </p:cNvPr>
            <p:cNvSpPr txBox="1"/>
            <p:nvPr/>
          </p:nvSpPr>
          <p:spPr>
            <a:xfrm>
              <a:off x="9703947" y="334168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50</a:t>
              </a:r>
            </a:p>
          </p:txBody>
        </p:sp>
        <p:cxnSp>
          <p:nvCxnSpPr>
            <p:cNvPr id="90" name="Connettore diritto 89">
              <a:extLst>
                <a:ext uri="{FF2B5EF4-FFF2-40B4-BE49-F238E27FC236}">
                  <a16:creationId xmlns:a16="http://schemas.microsoft.com/office/drawing/2014/main" id="{57DF0695-D453-47CB-B555-8DDC90F41724}"/>
                </a:ext>
              </a:extLst>
            </p:cNvPr>
            <p:cNvCxnSpPr>
              <a:cxnSpLocks/>
            </p:cNvCxnSpPr>
            <p:nvPr/>
          </p:nvCxnSpPr>
          <p:spPr>
            <a:xfrm>
              <a:off x="10140033" y="3059832"/>
              <a:ext cx="0" cy="612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1" name="CasellaDiTesto 90">
              <a:extLst>
                <a:ext uri="{FF2B5EF4-FFF2-40B4-BE49-F238E27FC236}">
                  <a16:creationId xmlns:a16="http://schemas.microsoft.com/office/drawing/2014/main" id="{712DC873-F204-4A27-8788-7A3AA5EE38AD}"/>
                </a:ext>
              </a:extLst>
            </p:cNvPr>
            <p:cNvSpPr txBox="1"/>
            <p:nvPr/>
          </p:nvSpPr>
          <p:spPr>
            <a:xfrm rot="5400000">
              <a:off x="9815380" y="3188109"/>
              <a:ext cx="8691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[GDC] 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dirty="0"/>
                <a:t>M</a:t>
              </a:r>
            </a:p>
          </p:txBody>
        </p:sp>
        <p:sp>
          <p:nvSpPr>
            <p:cNvPr id="92" name="CasellaDiTesto 91">
              <a:extLst>
                <a:ext uri="{FF2B5EF4-FFF2-40B4-BE49-F238E27FC236}">
                  <a16:creationId xmlns:a16="http://schemas.microsoft.com/office/drawing/2014/main" id="{6C54760E-A28B-4899-8712-5EABCC6D082A}"/>
                </a:ext>
              </a:extLst>
            </p:cNvPr>
            <p:cNvSpPr txBox="1"/>
            <p:nvPr/>
          </p:nvSpPr>
          <p:spPr>
            <a:xfrm>
              <a:off x="9703947" y="283515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</a:t>
              </a:r>
            </a:p>
          </p:txBody>
        </p:sp>
        <p:grpSp>
          <p:nvGrpSpPr>
            <p:cNvPr id="93" name="Gruppo 92">
              <a:extLst>
                <a:ext uri="{FF2B5EF4-FFF2-40B4-BE49-F238E27FC236}">
                  <a16:creationId xmlns:a16="http://schemas.microsoft.com/office/drawing/2014/main" id="{3F4D0B4C-A4A3-4BFA-B6EF-ECE3721D5212}"/>
                </a:ext>
              </a:extLst>
            </p:cNvPr>
            <p:cNvGrpSpPr/>
            <p:nvPr/>
          </p:nvGrpSpPr>
          <p:grpSpPr>
            <a:xfrm>
              <a:off x="8321794" y="3577830"/>
              <a:ext cx="1573199" cy="448586"/>
              <a:chOff x="4470271" y="4882491"/>
              <a:chExt cx="1573199" cy="448586"/>
            </a:xfrm>
          </p:grpSpPr>
          <p:sp>
            <p:nvSpPr>
              <p:cNvPr id="97" name="CasellaDiTesto 96">
                <a:extLst>
                  <a:ext uri="{FF2B5EF4-FFF2-40B4-BE49-F238E27FC236}">
                    <a16:creationId xmlns:a16="http://schemas.microsoft.com/office/drawing/2014/main" id="{A6E1F8A4-C6D5-4CBA-9FCC-434CD2619065}"/>
                  </a:ext>
                </a:extLst>
              </p:cNvPr>
              <p:cNvSpPr txBox="1"/>
              <p:nvPr/>
            </p:nvSpPr>
            <p:spPr>
              <a:xfrm>
                <a:off x="4657590" y="5054078"/>
                <a:ext cx="1208959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it-IT" sz="1200" dirty="0"/>
                  <a:t> Time (Days)</a:t>
                </a:r>
              </a:p>
            </p:txBody>
          </p:sp>
          <p:sp>
            <p:nvSpPr>
              <p:cNvPr id="98" name="CasellaDiTesto 97">
                <a:extLst>
                  <a:ext uri="{FF2B5EF4-FFF2-40B4-BE49-F238E27FC236}">
                    <a16:creationId xmlns:a16="http://schemas.microsoft.com/office/drawing/2014/main" id="{A4C89F82-A633-48CB-A910-1D00DEE49388}"/>
                  </a:ext>
                </a:extLst>
              </p:cNvPr>
              <p:cNvSpPr txBox="1"/>
              <p:nvPr/>
            </p:nvSpPr>
            <p:spPr>
              <a:xfrm>
                <a:off x="4800702" y="488249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2</a:t>
                </a:r>
              </a:p>
            </p:txBody>
          </p:sp>
          <p:sp>
            <p:nvSpPr>
              <p:cNvPr id="99" name="CasellaDiTesto 98">
                <a:extLst>
                  <a:ext uri="{FF2B5EF4-FFF2-40B4-BE49-F238E27FC236}">
                    <a16:creationId xmlns:a16="http://schemas.microsoft.com/office/drawing/2014/main" id="{DDAB7F20-0074-49C1-BA14-AB1FA6D24B8F}"/>
                  </a:ext>
                </a:extLst>
              </p:cNvPr>
              <p:cNvSpPr txBox="1"/>
              <p:nvPr/>
            </p:nvSpPr>
            <p:spPr>
              <a:xfrm>
                <a:off x="5123851" y="488249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3</a:t>
                </a:r>
              </a:p>
            </p:txBody>
          </p:sp>
          <p:sp>
            <p:nvSpPr>
              <p:cNvPr id="100" name="CasellaDiTesto 99">
                <a:extLst>
                  <a:ext uri="{FF2B5EF4-FFF2-40B4-BE49-F238E27FC236}">
                    <a16:creationId xmlns:a16="http://schemas.microsoft.com/office/drawing/2014/main" id="{FA6C72E6-4499-43A2-A8CB-D23182BCC24A}"/>
                  </a:ext>
                </a:extLst>
              </p:cNvPr>
              <p:cNvSpPr txBox="1"/>
              <p:nvPr/>
            </p:nvSpPr>
            <p:spPr>
              <a:xfrm>
                <a:off x="5445224" y="488249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4</a:t>
                </a:r>
              </a:p>
            </p:txBody>
          </p:sp>
          <p:sp>
            <p:nvSpPr>
              <p:cNvPr id="101" name="CasellaDiTesto 100">
                <a:extLst>
                  <a:ext uri="{FF2B5EF4-FFF2-40B4-BE49-F238E27FC236}">
                    <a16:creationId xmlns:a16="http://schemas.microsoft.com/office/drawing/2014/main" id="{FF1D7BE2-CA7F-40E6-A945-B37ABBD85ADF}"/>
                  </a:ext>
                </a:extLst>
              </p:cNvPr>
              <p:cNvSpPr txBox="1"/>
              <p:nvPr/>
            </p:nvSpPr>
            <p:spPr>
              <a:xfrm>
                <a:off x="4470271" y="488249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</a:t>
                </a:r>
              </a:p>
            </p:txBody>
          </p:sp>
          <p:sp>
            <p:nvSpPr>
              <p:cNvPr id="102" name="CasellaDiTesto 101">
                <a:extLst>
                  <a:ext uri="{FF2B5EF4-FFF2-40B4-BE49-F238E27FC236}">
                    <a16:creationId xmlns:a16="http://schemas.microsoft.com/office/drawing/2014/main" id="{F322A4EC-E522-419C-8B3E-80C1831A91FC}"/>
                  </a:ext>
                </a:extLst>
              </p:cNvPr>
              <p:cNvSpPr txBox="1"/>
              <p:nvPr/>
            </p:nvSpPr>
            <p:spPr>
              <a:xfrm>
                <a:off x="5773844" y="488249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5</a:t>
                </a:r>
              </a:p>
            </p:txBody>
          </p:sp>
        </p:grpSp>
        <p:sp>
          <p:nvSpPr>
            <p:cNvPr id="94" name="CasellaDiTesto 93">
              <a:extLst>
                <a:ext uri="{FF2B5EF4-FFF2-40B4-BE49-F238E27FC236}">
                  <a16:creationId xmlns:a16="http://schemas.microsoft.com/office/drawing/2014/main" id="{55AF01BE-7768-404E-9673-F39C22CFF18D}"/>
                </a:ext>
              </a:extLst>
            </p:cNvPr>
            <p:cNvSpPr txBox="1"/>
            <p:nvPr/>
          </p:nvSpPr>
          <p:spPr>
            <a:xfrm>
              <a:off x="7749398" y="273027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.0</a:t>
              </a:r>
            </a:p>
          </p:txBody>
        </p:sp>
        <p:sp>
          <p:nvSpPr>
            <p:cNvPr id="95" name="CasellaDiTesto 94">
              <a:extLst>
                <a:ext uri="{FF2B5EF4-FFF2-40B4-BE49-F238E27FC236}">
                  <a16:creationId xmlns:a16="http://schemas.microsoft.com/office/drawing/2014/main" id="{B1ED9D9F-6F98-43A6-A475-442E8BCD56D3}"/>
                </a:ext>
              </a:extLst>
            </p:cNvPr>
            <p:cNvSpPr txBox="1"/>
            <p:nvPr/>
          </p:nvSpPr>
          <p:spPr>
            <a:xfrm>
              <a:off x="7749398" y="256250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.5</a:t>
              </a:r>
            </a:p>
          </p:txBody>
        </p:sp>
        <p:sp>
          <p:nvSpPr>
            <p:cNvPr id="96" name="CasellaDiTesto 95">
              <a:extLst>
                <a:ext uri="{FF2B5EF4-FFF2-40B4-BE49-F238E27FC236}">
                  <a16:creationId xmlns:a16="http://schemas.microsoft.com/office/drawing/2014/main" id="{77C5E2F5-8AFC-4FAF-956D-D8D13753F588}"/>
                </a:ext>
              </a:extLst>
            </p:cNvPr>
            <p:cNvSpPr txBox="1"/>
            <p:nvPr/>
          </p:nvSpPr>
          <p:spPr>
            <a:xfrm>
              <a:off x="9703947" y="349408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00</a:t>
              </a:r>
            </a:p>
          </p:txBody>
        </p:sp>
      </p:grpSp>
      <p:grpSp>
        <p:nvGrpSpPr>
          <p:cNvPr id="128" name="Gruppo 127">
            <a:extLst>
              <a:ext uri="{FF2B5EF4-FFF2-40B4-BE49-F238E27FC236}">
                <a16:creationId xmlns:a16="http://schemas.microsoft.com/office/drawing/2014/main" id="{20232D08-D89D-4F05-A0AA-1E248F7E138B}"/>
              </a:ext>
            </a:extLst>
          </p:cNvPr>
          <p:cNvGrpSpPr/>
          <p:nvPr/>
        </p:nvGrpSpPr>
        <p:grpSpPr>
          <a:xfrm>
            <a:off x="3620256" y="3851919"/>
            <a:ext cx="3030054" cy="1683474"/>
            <a:chOff x="3620256" y="3851919"/>
            <a:chExt cx="3030054" cy="1683474"/>
          </a:xfrm>
        </p:grpSpPr>
        <p:pic>
          <p:nvPicPr>
            <p:cNvPr id="127" name="Immagine 126">
              <a:extLst>
                <a:ext uri="{FF2B5EF4-FFF2-40B4-BE49-F238E27FC236}">
                  <a16:creationId xmlns:a16="http://schemas.microsoft.com/office/drawing/2014/main" id="{BB7243EB-E608-47D6-9C09-427CACE12FA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347639" y="4138558"/>
              <a:ext cx="1730842" cy="1134000"/>
            </a:xfrm>
            <a:prstGeom prst="rect">
              <a:avLst/>
            </a:prstGeom>
          </p:spPr>
        </p:pic>
        <p:sp>
          <p:nvSpPr>
            <p:cNvPr id="105" name="CasellaDiTesto 104">
              <a:extLst>
                <a:ext uri="{FF2B5EF4-FFF2-40B4-BE49-F238E27FC236}">
                  <a16:creationId xmlns:a16="http://schemas.microsoft.com/office/drawing/2014/main" id="{F880D4BB-BDE4-4DC2-980B-A741985B0A4C}"/>
                </a:ext>
              </a:extLst>
            </p:cNvPr>
            <p:cNvSpPr txBox="1"/>
            <p:nvPr/>
          </p:nvSpPr>
          <p:spPr>
            <a:xfrm rot="16200000">
              <a:off x="3009352" y="4462823"/>
              <a:ext cx="168347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Normalized</a:t>
              </a:r>
              <a:r>
                <a:rPr lang="it-IT" sz="1200" dirty="0"/>
                <a:t> Cell Index</a:t>
              </a:r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0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06" name="CasellaDiTesto 105">
              <a:extLst>
                <a:ext uri="{FF2B5EF4-FFF2-40B4-BE49-F238E27FC236}">
                  <a16:creationId xmlns:a16="http://schemas.microsoft.com/office/drawing/2014/main" id="{EC078D72-4D90-43A4-BBF4-DEA1B0AC0F38}"/>
                </a:ext>
              </a:extLst>
            </p:cNvPr>
            <p:cNvSpPr txBox="1"/>
            <p:nvPr/>
          </p:nvSpPr>
          <p:spPr>
            <a:xfrm>
              <a:off x="3994263" y="429666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0</a:t>
              </a:r>
            </a:p>
          </p:txBody>
        </p:sp>
        <p:sp>
          <p:nvSpPr>
            <p:cNvPr id="107" name="CasellaDiTesto 106">
              <a:extLst>
                <a:ext uri="{FF2B5EF4-FFF2-40B4-BE49-F238E27FC236}">
                  <a16:creationId xmlns:a16="http://schemas.microsoft.com/office/drawing/2014/main" id="{E0678942-2B4C-4DEF-B2E6-59F9D9E9CA02}"/>
                </a:ext>
              </a:extLst>
            </p:cNvPr>
            <p:cNvSpPr txBox="1"/>
            <p:nvPr/>
          </p:nvSpPr>
          <p:spPr>
            <a:xfrm>
              <a:off x="3994263" y="402349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5</a:t>
              </a:r>
            </a:p>
          </p:txBody>
        </p:sp>
        <p:sp>
          <p:nvSpPr>
            <p:cNvPr id="108" name="CasellaDiTesto 107">
              <a:extLst>
                <a:ext uri="{FF2B5EF4-FFF2-40B4-BE49-F238E27FC236}">
                  <a16:creationId xmlns:a16="http://schemas.microsoft.com/office/drawing/2014/main" id="{D28DB45B-3943-4EB3-8AE0-5BAAB8BFE50B}"/>
                </a:ext>
              </a:extLst>
            </p:cNvPr>
            <p:cNvSpPr txBox="1"/>
            <p:nvPr/>
          </p:nvSpPr>
          <p:spPr>
            <a:xfrm>
              <a:off x="3994263" y="456565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5</a:t>
              </a:r>
            </a:p>
          </p:txBody>
        </p:sp>
        <p:sp>
          <p:nvSpPr>
            <p:cNvPr id="109" name="CasellaDiTesto 108">
              <a:extLst>
                <a:ext uri="{FF2B5EF4-FFF2-40B4-BE49-F238E27FC236}">
                  <a16:creationId xmlns:a16="http://schemas.microsoft.com/office/drawing/2014/main" id="{681C1B49-DA61-41FA-8AAC-F6C65F3ADCAB}"/>
                </a:ext>
              </a:extLst>
            </p:cNvPr>
            <p:cNvSpPr txBox="1"/>
            <p:nvPr/>
          </p:nvSpPr>
          <p:spPr>
            <a:xfrm>
              <a:off x="3942967" y="5097468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0.5</a:t>
              </a:r>
            </a:p>
          </p:txBody>
        </p:sp>
        <p:sp>
          <p:nvSpPr>
            <p:cNvPr id="110" name="CasellaDiTesto 109">
              <a:extLst>
                <a:ext uri="{FF2B5EF4-FFF2-40B4-BE49-F238E27FC236}">
                  <a16:creationId xmlns:a16="http://schemas.microsoft.com/office/drawing/2014/main" id="{32A2C871-65C7-4E04-A0C8-BF3713EE4184}"/>
                </a:ext>
              </a:extLst>
            </p:cNvPr>
            <p:cNvSpPr txBox="1"/>
            <p:nvPr/>
          </p:nvSpPr>
          <p:spPr>
            <a:xfrm>
              <a:off x="3994263" y="484517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111" name="CasellaDiTesto 110">
              <a:extLst>
                <a:ext uri="{FF2B5EF4-FFF2-40B4-BE49-F238E27FC236}">
                  <a16:creationId xmlns:a16="http://schemas.microsoft.com/office/drawing/2014/main" id="{59D1E63F-DD15-4F47-98DD-F586C7D5CA94}"/>
                </a:ext>
              </a:extLst>
            </p:cNvPr>
            <p:cNvSpPr txBox="1"/>
            <p:nvPr/>
          </p:nvSpPr>
          <p:spPr>
            <a:xfrm>
              <a:off x="4661435" y="3954881"/>
              <a:ext cx="12089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200" dirty="0"/>
                <a:t>Y537S</a:t>
              </a:r>
            </a:p>
          </p:txBody>
        </p:sp>
        <p:sp>
          <p:nvSpPr>
            <p:cNvPr id="112" name="CasellaDiTesto 111">
              <a:extLst>
                <a:ext uri="{FF2B5EF4-FFF2-40B4-BE49-F238E27FC236}">
                  <a16:creationId xmlns:a16="http://schemas.microsoft.com/office/drawing/2014/main" id="{04C499CE-1285-4702-9D74-AABBF11FB4BC}"/>
                </a:ext>
              </a:extLst>
            </p:cNvPr>
            <p:cNvSpPr txBox="1"/>
            <p:nvPr/>
          </p:nvSpPr>
          <p:spPr>
            <a:xfrm>
              <a:off x="5948812" y="4355976"/>
              <a:ext cx="52610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1</a:t>
              </a:r>
            </a:p>
            <a:p>
              <a:r>
                <a:rPr lang="it-IT" sz="1200" dirty="0"/>
                <a:t>1; 10</a:t>
              </a:r>
            </a:p>
          </p:txBody>
        </p:sp>
        <p:sp>
          <p:nvSpPr>
            <p:cNvPr id="113" name="CasellaDiTesto 112">
              <a:extLst>
                <a:ext uri="{FF2B5EF4-FFF2-40B4-BE49-F238E27FC236}">
                  <a16:creationId xmlns:a16="http://schemas.microsoft.com/office/drawing/2014/main" id="{EE9EDAC6-6237-4B2C-8046-7D4DF1275CDB}"/>
                </a:ext>
              </a:extLst>
            </p:cNvPr>
            <p:cNvSpPr txBox="1"/>
            <p:nvPr/>
          </p:nvSpPr>
          <p:spPr>
            <a:xfrm>
              <a:off x="5948812" y="475771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50</a:t>
              </a:r>
            </a:p>
          </p:txBody>
        </p:sp>
        <p:cxnSp>
          <p:nvCxnSpPr>
            <p:cNvPr id="114" name="Connettore diritto 113">
              <a:extLst>
                <a:ext uri="{FF2B5EF4-FFF2-40B4-BE49-F238E27FC236}">
                  <a16:creationId xmlns:a16="http://schemas.microsoft.com/office/drawing/2014/main" id="{C0BC9514-8113-49D8-B2EA-7B13BDEBEA9C}"/>
                </a:ext>
              </a:extLst>
            </p:cNvPr>
            <p:cNvCxnSpPr>
              <a:cxnSpLocks/>
            </p:cNvCxnSpPr>
            <p:nvPr/>
          </p:nvCxnSpPr>
          <p:spPr>
            <a:xfrm>
              <a:off x="6401889" y="4475861"/>
              <a:ext cx="0" cy="612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5" name="CasellaDiTesto 114">
              <a:extLst>
                <a:ext uri="{FF2B5EF4-FFF2-40B4-BE49-F238E27FC236}">
                  <a16:creationId xmlns:a16="http://schemas.microsoft.com/office/drawing/2014/main" id="{18B0AF8B-FCAE-4DFB-9C7B-92E771AD3BDB}"/>
                </a:ext>
              </a:extLst>
            </p:cNvPr>
            <p:cNvSpPr txBox="1"/>
            <p:nvPr/>
          </p:nvSpPr>
          <p:spPr>
            <a:xfrm rot="5400000">
              <a:off x="6077236" y="4604138"/>
              <a:ext cx="8691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[GDC] 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dirty="0"/>
                <a:t>M</a:t>
              </a:r>
            </a:p>
          </p:txBody>
        </p:sp>
        <p:sp>
          <p:nvSpPr>
            <p:cNvPr id="116" name="CasellaDiTesto 115">
              <a:extLst>
                <a:ext uri="{FF2B5EF4-FFF2-40B4-BE49-F238E27FC236}">
                  <a16:creationId xmlns:a16="http://schemas.microsoft.com/office/drawing/2014/main" id="{9B7D7722-4B02-4110-9594-648FAB3E4F47}"/>
                </a:ext>
              </a:extLst>
            </p:cNvPr>
            <p:cNvSpPr txBox="1"/>
            <p:nvPr/>
          </p:nvSpPr>
          <p:spPr>
            <a:xfrm>
              <a:off x="5948812" y="421308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</a:t>
              </a:r>
            </a:p>
          </p:txBody>
        </p:sp>
        <p:grpSp>
          <p:nvGrpSpPr>
            <p:cNvPr id="117" name="Gruppo 116">
              <a:extLst>
                <a:ext uri="{FF2B5EF4-FFF2-40B4-BE49-F238E27FC236}">
                  <a16:creationId xmlns:a16="http://schemas.microsoft.com/office/drawing/2014/main" id="{CABADD0D-E475-42D1-880F-B454A984312D}"/>
                </a:ext>
              </a:extLst>
            </p:cNvPr>
            <p:cNvGrpSpPr/>
            <p:nvPr/>
          </p:nvGrpSpPr>
          <p:grpSpPr>
            <a:xfrm>
              <a:off x="4566659" y="5044659"/>
              <a:ext cx="1573199" cy="448586"/>
              <a:chOff x="4470271" y="4882491"/>
              <a:chExt cx="1573199" cy="448586"/>
            </a:xfrm>
          </p:grpSpPr>
          <p:sp>
            <p:nvSpPr>
              <p:cNvPr id="121" name="CasellaDiTesto 120">
                <a:extLst>
                  <a:ext uri="{FF2B5EF4-FFF2-40B4-BE49-F238E27FC236}">
                    <a16:creationId xmlns:a16="http://schemas.microsoft.com/office/drawing/2014/main" id="{A8E3A747-D52E-487B-904A-58D34634C89A}"/>
                  </a:ext>
                </a:extLst>
              </p:cNvPr>
              <p:cNvSpPr txBox="1"/>
              <p:nvPr/>
            </p:nvSpPr>
            <p:spPr>
              <a:xfrm>
                <a:off x="4657590" y="5054078"/>
                <a:ext cx="1208959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it-IT" sz="1200" dirty="0"/>
                  <a:t> Time (Days)</a:t>
                </a:r>
              </a:p>
            </p:txBody>
          </p:sp>
          <p:sp>
            <p:nvSpPr>
              <p:cNvPr id="122" name="CasellaDiTesto 121">
                <a:extLst>
                  <a:ext uri="{FF2B5EF4-FFF2-40B4-BE49-F238E27FC236}">
                    <a16:creationId xmlns:a16="http://schemas.microsoft.com/office/drawing/2014/main" id="{6300D3E5-A6A6-4B95-87A4-2714C31EB357}"/>
                  </a:ext>
                </a:extLst>
              </p:cNvPr>
              <p:cNvSpPr txBox="1"/>
              <p:nvPr/>
            </p:nvSpPr>
            <p:spPr>
              <a:xfrm>
                <a:off x="4800702" y="488249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2</a:t>
                </a:r>
              </a:p>
            </p:txBody>
          </p:sp>
          <p:sp>
            <p:nvSpPr>
              <p:cNvPr id="123" name="CasellaDiTesto 122">
                <a:extLst>
                  <a:ext uri="{FF2B5EF4-FFF2-40B4-BE49-F238E27FC236}">
                    <a16:creationId xmlns:a16="http://schemas.microsoft.com/office/drawing/2014/main" id="{868BF24B-A4EC-422F-91E3-058E31ED8CCF}"/>
                  </a:ext>
                </a:extLst>
              </p:cNvPr>
              <p:cNvSpPr txBox="1"/>
              <p:nvPr/>
            </p:nvSpPr>
            <p:spPr>
              <a:xfrm>
                <a:off x="5123851" y="488249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3</a:t>
                </a:r>
              </a:p>
            </p:txBody>
          </p:sp>
          <p:sp>
            <p:nvSpPr>
              <p:cNvPr id="124" name="CasellaDiTesto 123">
                <a:extLst>
                  <a:ext uri="{FF2B5EF4-FFF2-40B4-BE49-F238E27FC236}">
                    <a16:creationId xmlns:a16="http://schemas.microsoft.com/office/drawing/2014/main" id="{4C02CE65-C477-4F01-978B-255688E379D6}"/>
                  </a:ext>
                </a:extLst>
              </p:cNvPr>
              <p:cNvSpPr txBox="1"/>
              <p:nvPr/>
            </p:nvSpPr>
            <p:spPr>
              <a:xfrm>
                <a:off x="5445224" y="488249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4</a:t>
                </a:r>
              </a:p>
            </p:txBody>
          </p:sp>
          <p:sp>
            <p:nvSpPr>
              <p:cNvPr id="125" name="CasellaDiTesto 124">
                <a:extLst>
                  <a:ext uri="{FF2B5EF4-FFF2-40B4-BE49-F238E27FC236}">
                    <a16:creationId xmlns:a16="http://schemas.microsoft.com/office/drawing/2014/main" id="{8068CB55-6048-4EE9-9C0B-FD869B6C320A}"/>
                  </a:ext>
                </a:extLst>
              </p:cNvPr>
              <p:cNvSpPr txBox="1"/>
              <p:nvPr/>
            </p:nvSpPr>
            <p:spPr>
              <a:xfrm>
                <a:off x="4470271" y="488249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</a:t>
                </a:r>
              </a:p>
            </p:txBody>
          </p:sp>
          <p:sp>
            <p:nvSpPr>
              <p:cNvPr id="126" name="CasellaDiTesto 125">
                <a:extLst>
                  <a:ext uri="{FF2B5EF4-FFF2-40B4-BE49-F238E27FC236}">
                    <a16:creationId xmlns:a16="http://schemas.microsoft.com/office/drawing/2014/main" id="{EE6C862B-8560-4A0C-9905-52A9C14F64B2}"/>
                  </a:ext>
                </a:extLst>
              </p:cNvPr>
              <p:cNvSpPr txBox="1"/>
              <p:nvPr/>
            </p:nvSpPr>
            <p:spPr>
              <a:xfrm>
                <a:off x="5773844" y="4882491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5</a:t>
                </a:r>
              </a:p>
            </p:txBody>
          </p:sp>
        </p:grpSp>
        <p:sp>
          <p:nvSpPr>
            <p:cNvPr id="120" name="CasellaDiTesto 119">
              <a:extLst>
                <a:ext uri="{FF2B5EF4-FFF2-40B4-BE49-F238E27FC236}">
                  <a16:creationId xmlns:a16="http://schemas.microsoft.com/office/drawing/2014/main" id="{0D4EDAEE-550F-435F-A87A-8A043EB725A9}"/>
                </a:ext>
              </a:extLst>
            </p:cNvPr>
            <p:cNvSpPr txBox="1"/>
            <p:nvPr/>
          </p:nvSpPr>
          <p:spPr>
            <a:xfrm>
              <a:off x="5948812" y="491011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00</a:t>
              </a:r>
            </a:p>
          </p:txBody>
        </p:sp>
      </p:grpSp>
      <p:grpSp>
        <p:nvGrpSpPr>
          <p:cNvPr id="188" name="Gruppo 187">
            <a:extLst>
              <a:ext uri="{FF2B5EF4-FFF2-40B4-BE49-F238E27FC236}">
                <a16:creationId xmlns:a16="http://schemas.microsoft.com/office/drawing/2014/main" id="{4AEE213C-D63E-4110-B161-5696F2303B90}"/>
              </a:ext>
            </a:extLst>
          </p:cNvPr>
          <p:cNvGrpSpPr/>
          <p:nvPr/>
        </p:nvGrpSpPr>
        <p:grpSpPr>
          <a:xfrm>
            <a:off x="3152479" y="1320740"/>
            <a:ext cx="3588889" cy="1656051"/>
            <a:chOff x="2763865" y="1320740"/>
            <a:chExt cx="3588889" cy="1656051"/>
          </a:xfrm>
        </p:grpSpPr>
        <p:pic>
          <p:nvPicPr>
            <p:cNvPr id="129" name="Immagine 128">
              <a:extLst>
                <a:ext uri="{FF2B5EF4-FFF2-40B4-BE49-F238E27FC236}">
                  <a16:creationId xmlns:a16="http://schemas.microsoft.com/office/drawing/2014/main" id="{D5E59677-818C-45CD-8316-17E8B307760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435508" y="1420136"/>
              <a:ext cx="2190187" cy="1134000"/>
            </a:xfrm>
            <a:prstGeom prst="rect">
              <a:avLst/>
            </a:prstGeom>
          </p:spPr>
        </p:pic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C068F20C-310C-4FD7-ACF9-A5C742D1E69F}"/>
                </a:ext>
              </a:extLst>
            </p:cNvPr>
            <p:cNvSpPr txBox="1"/>
            <p:nvPr/>
          </p:nvSpPr>
          <p:spPr>
            <a:xfrm>
              <a:off x="5507680" y="2491828"/>
              <a:ext cx="84507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sz="1200" dirty="0"/>
                <a:t>GDC(µM)</a:t>
              </a: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408C9DEF-0EA8-4585-A0A3-2A8E1052BE81}"/>
                </a:ext>
              </a:extLst>
            </p:cNvPr>
            <p:cNvSpPr txBox="1"/>
            <p:nvPr/>
          </p:nvSpPr>
          <p:spPr>
            <a:xfrm rot="16200000">
              <a:off x="2519247" y="1736230"/>
              <a:ext cx="95090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ER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200" dirty="0" err="1">
                  <a:latin typeface="+mn-lt"/>
                  <a:cs typeface="Times New Roman" panose="02020603050405020304" pitchFamily="18" charset="0"/>
                </a:rPr>
                <a:t>levels</a:t>
              </a:r>
              <a:r>
                <a:rPr lang="it-IT" sz="1200" dirty="0">
                  <a:latin typeface="+mn-lt"/>
                  <a:cs typeface="Times New Roman" panose="02020603050405020304" pitchFamily="18" charset="0"/>
                </a:rPr>
                <a:t> </a:t>
              </a:r>
            </a:p>
            <a:p>
              <a:r>
                <a:rPr lang="it-IT" sz="1200" dirty="0">
                  <a:latin typeface="+mn-lt"/>
                  <a:cs typeface="Times New Roman" panose="02020603050405020304" pitchFamily="18" charset="0"/>
                </a:rPr>
                <a:t>(</a:t>
              </a:r>
              <a:r>
                <a:rPr lang="it-IT" sz="1200" dirty="0" err="1">
                  <a:latin typeface="+mn-lt"/>
                  <a:cs typeface="Times New Roman" panose="02020603050405020304" pitchFamily="18" charset="0"/>
                </a:rPr>
                <a:t>Fold</a:t>
              </a:r>
              <a:r>
                <a:rPr lang="it-IT" sz="1200" dirty="0">
                  <a:latin typeface="+mn-lt"/>
                  <a:cs typeface="Times New Roman" panose="02020603050405020304" pitchFamily="18" charset="0"/>
                </a:rPr>
                <a:t> on 0)</a:t>
              </a:r>
              <a:endParaRPr lang="it-IT" sz="1200" dirty="0">
                <a:latin typeface="+mn-lt"/>
              </a:endParaRP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6C8980B4-7BC0-4DEC-8D59-059E25672D4C}"/>
                </a:ext>
              </a:extLst>
            </p:cNvPr>
            <p:cNvSpPr txBox="1"/>
            <p:nvPr/>
          </p:nvSpPr>
          <p:spPr>
            <a:xfrm>
              <a:off x="3104682" y="237539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A54B941D-73D0-487E-B75D-CAAA7AFA9AD8}"/>
                </a:ext>
              </a:extLst>
            </p:cNvPr>
            <p:cNvSpPr txBox="1"/>
            <p:nvPr/>
          </p:nvSpPr>
          <p:spPr>
            <a:xfrm>
              <a:off x="3104682" y="183455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B86CBB2D-C61B-44D7-8BE1-65678F839133}"/>
                </a:ext>
              </a:extLst>
            </p:cNvPr>
            <p:cNvSpPr txBox="1"/>
            <p:nvPr/>
          </p:nvSpPr>
          <p:spPr>
            <a:xfrm>
              <a:off x="3104682" y="132074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7FE31004-E6C3-461A-9DA1-C4F73AA7B810}"/>
                </a:ext>
              </a:extLst>
            </p:cNvPr>
            <p:cNvSpPr txBox="1"/>
            <p:nvPr/>
          </p:nvSpPr>
          <p:spPr>
            <a:xfrm>
              <a:off x="4611834" y="249182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</a:t>
              </a:r>
            </a:p>
          </p:txBody>
        </p:sp>
        <p:sp>
          <p:nvSpPr>
            <p:cNvPr id="51" name="CasellaDiTesto 50">
              <a:extLst>
                <a:ext uri="{FF2B5EF4-FFF2-40B4-BE49-F238E27FC236}">
                  <a16:creationId xmlns:a16="http://schemas.microsoft.com/office/drawing/2014/main" id="{9AE83DBA-E75F-488F-AAEC-5F1178DEF178}"/>
                </a:ext>
              </a:extLst>
            </p:cNvPr>
            <p:cNvSpPr txBox="1"/>
            <p:nvPr/>
          </p:nvSpPr>
          <p:spPr>
            <a:xfrm>
              <a:off x="4729729" y="2491828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1</a:t>
              </a:r>
            </a:p>
          </p:txBody>
        </p:sp>
        <p:sp>
          <p:nvSpPr>
            <p:cNvPr id="52" name="CasellaDiTesto 51">
              <a:extLst>
                <a:ext uri="{FF2B5EF4-FFF2-40B4-BE49-F238E27FC236}">
                  <a16:creationId xmlns:a16="http://schemas.microsoft.com/office/drawing/2014/main" id="{EF8261F3-468D-45F2-B816-69E0F982059A}"/>
                </a:ext>
              </a:extLst>
            </p:cNvPr>
            <p:cNvSpPr txBox="1"/>
            <p:nvPr/>
          </p:nvSpPr>
          <p:spPr>
            <a:xfrm>
              <a:off x="5047358" y="249182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1</a:t>
              </a:r>
            </a:p>
          </p:txBody>
        </p:sp>
        <p:sp>
          <p:nvSpPr>
            <p:cNvPr id="53" name="CasellaDiTesto 52">
              <a:extLst>
                <a:ext uri="{FF2B5EF4-FFF2-40B4-BE49-F238E27FC236}">
                  <a16:creationId xmlns:a16="http://schemas.microsoft.com/office/drawing/2014/main" id="{426AF6D2-292D-4AF0-90EA-D1EB1CBBA31A}"/>
                </a:ext>
              </a:extLst>
            </p:cNvPr>
            <p:cNvSpPr txBox="1"/>
            <p:nvPr/>
          </p:nvSpPr>
          <p:spPr>
            <a:xfrm>
              <a:off x="5319614" y="249182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</a:t>
              </a:r>
            </a:p>
          </p:txBody>
        </p:sp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id="{FB0B382A-9C8F-4516-A5C0-C8CDF599AB05}"/>
                </a:ext>
              </a:extLst>
            </p:cNvPr>
            <p:cNvSpPr txBox="1"/>
            <p:nvPr/>
          </p:nvSpPr>
          <p:spPr>
            <a:xfrm>
              <a:off x="3702560" y="2699792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/>
                <a:t>MCF-7</a:t>
              </a:r>
              <a:endParaRPr lang="it-IT" sz="1200" dirty="0"/>
            </a:p>
          </p:txBody>
        </p:sp>
        <p:sp>
          <p:nvSpPr>
            <p:cNvPr id="47" name="CasellaDiTesto 46">
              <a:extLst>
                <a:ext uri="{FF2B5EF4-FFF2-40B4-BE49-F238E27FC236}">
                  <a16:creationId xmlns:a16="http://schemas.microsoft.com/office/drawing/2014/main" id="{600D95FB-B860-4CC1-B1F6-67EA2556C10A}"/>
                </a:ext>
              </a:extLst>
            </p:cNvPr>
            <p:cNvSpPr txBox="1"/>
            <p:nvPr/>
          </p:nvSpPr>
          <p:spPr>
            <a:xfrm>
              <a:off x="4752534" y="2699792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Y537S</a:t>
              </a:r>
            </a:p>
          </p:txBody>
        </p:sp>
        <p:sp>
          <p:nvSpPr>
            <p:cNvPr id="152" name="CasellaDiTesto 151">
              <a:extLst>
                <a:ext uri="{FF2B5EF4-FFF2-40B4-BE49-F238E27FC236}">
                  <a16:creationId xmlns:a16="http://schemas.microsoft.com/office/drawing/2014/main" id="{8E9274F2-C7F4-4D09-8D39-01463FCB9DE6}"/>
                </a:ext>
              </a:extLst>
            </p:cNvPr>
            <p:cNvSpPr txBox="1"/>
            <p:nvPr/>
          </p:nvSpPr>
          <p:spPr>
            <a:xfrm>
              <a:off x="3807403" y="1518978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*</a:t>
              </a:r>
            </a:p>
          </p:txBody>
        </p:sp>
        <p:sp>
          <p:nvSpPr>
            <p:cNvPr id="153" name="CasellaDiTesto 152">
              <a:extLst>
                <a:ext uri="{FF2B5EF4-FFF2-40B4-BE49-F238E27FC236}">
                  <a16:creationId xmlns:a16="http://schemas.microsoft.com/office/drawing/2014/main" id="{D121AE6B-43C0-445B-A74C-4ED5A928BE69}"/>
                </a:ext>
              </a:extLst>
            </p:cNvPr>
            <p:cNvSpPr txBox="1"/>
            <p:nvPr/>
          </p:nvSpPr>
          <p:spPr>
            <a:xfrm>
              <a:off x="4247358" y="1893178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**</a:t>
              </a:r>
            </a:p>
            <a:p>
              <a:r>
                <a:rPr lang="it-IT" sz="800" dirty="0"/>
                <a:t>**</a:t>
              </a:r>
            </a:p>
          </p:txBody>
        </p:sp>
        <p:sp>
          <p:nvSpPr>
            <p:cNvPr id="156" name="CasellaDiTesto 155">
              <a:extLst>
                <a:ext uri="{FF2B5EF4-FFF2-40B4-BE49-F238E27FC236}">
                  <a16:creationId xmlns:a16="http://schemas.microsoft.com/office/drawing/2014/main" id="{3EE67DDA-A6A7-4829-B44B-E0239F99FC7F}"/>
                </a:ext>
              </a:extLst>
            </p:cNvPr>
            <p:cNvSpPr txBox="1"/>
            <p:nvPr/>
          </p:nvSpPr>
          <p:spPr>
            <a:xfrm>
              <a:off x="5094617" y="1473330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**</a:t>
              </a:r>
            </a:p>
            <a:p>
              <a:r>
                <a:rPr lang="it-IT" sz="800" dirty="0"/>
                <a:t>**</a:t>
              </a:r>
            </a:p>
          </p:txBody>
        </p:sp>
        <p:sp>
          <p:nvSpPr>
            <p:cNvPr id="157" name="CasellaDiTesto 156">
              <a:extLst>
                <a:ext uri="{FF2B5EF4-FFF2-40B4-BE49-F238E27FC236}">
                  <a16:creationId xmlns:a16="http://schemas.microsoft.com/office/drawing/2014/main" id="{863CDC66-FF55-4C47-ABC9-957913970E9C}"/>
                </a:ext>
              </a:extLst>
            </p:cNvPr>
            <p:cNvSpPr txBox="1"/>
            <p:nvPr/>
          </p:nvSpPr>
          <p:spPr>
            <a:xfrm>
              <a:off x="5335116" y="1994488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**</a:t>
              </a:r>
            </a:p>
            <a:p>
              <a:r>
                <a:rPr lang="it-IT" sz="800" dirty="0"/>
                <a:t>**</a:t>
              </a:r>
            </a:p>
          </p:txBody>
        </p:sp>
        <p:sp>
          <p:nvSpPr>
            <p:cNvPr id="180" name="CasellaDiTesto 179">
              <a:extLst>
                <a:ext uri="{FF2B5EF4-FFF2-40B4-BE49-F238E27FC236}">
                  <a16:creationId xmlns:a16="http://schemas.microsoft.com/office/drawing/2014/main" id="{7FDAEAE4-7A85-437C-98DE-78EDF7B0B435}"/>
                </a:ext>
              </a:extLst>
            </p:cNvPr>
            <p:cNvSpPr txBox="1"/>
            <p:nvPr/>
          </p:nvSpPr>
          <p:spPr>
            <a:xfrm>
              <a:off x="3539578" y="2491828"/>
              <a:ext cx="2696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0</a:t>
              </a:r>
            </a:p>
          </p:txBody>
        </p:sp>
        <p:sp>
          <p:nvSpPr>
            <p:cNvPr id="181" name="CasellaDiTesto 180">
              <a:extLst>
                <a:ext uri="{FF2B5EF4-FFF2-40B4-BE49-F238E27FC236}">
                  <a16:creationId xmlns:a16="http://schemas.microsoft.com/office/drawing/2014/main" id="{D16C4E22-A8D9-49A8-9EF9-AB97D8765252}"/>
                </a:ext>
              </a:extLst>
            </p:cNvPr>
            <p:cNvSpPr txBox="1"/>
            <p:nvPr/>
          </p:nvSpPr>
          <p:spPr>
            <a:xfrm>
              <a:off x="3657473" y="2491828"/>
              <a:ext cx="4828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0.01</a:t>
              </a:r>
            </a:p>
          </p:txBody>
        </p:sp>
        <p:sp>
          <p:nvSpPr>
            <p:cNvPr id="182" name="CasellaDiTesto 181">
              <a:extLst>
                <a:ext uri="{FF2B5EF4-FFF2-40B4-BE49-F238E27FC236}">
                  <a16:creationId xmlns:a16="http://schemas.microsoft.com/office/drawing/2014/main" id="{1F15A9E1-A6CE-477E-B203-987BB5EEB705}"/>
                </a:ext>
              </a:extLst>
            </p:cNvPr>
            <p:cNvSpPr txBox="1"/>
            <p:nvPr/>
          </p:nvSpPr>
          <p:spPr>
            <a:xfrm>
              <a:off x="3975102" y="2491828"/>
              <a:ext cx="3978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0.1</a:t>
              </a:r>
            </a:p>
          </p:txBody>
        </p:sp>
        <p:sp>
          <p:nvSpPr>
            <p:cNvPr id="183" name="CasellaDiTesto 182">
              <a:extLst>
                <a:ext uri="{FF2B5EF4-FFF2-40B4-BE49-F238E27FC236}">
                  <a16:creationId xmlns:a16="http://schemas.microsoft.com/office/drawing/2014/main" id="{CF0FB382-3F84-4256-BEBD-B94D2561A423}"/>
                </a:ext>
              </a:extLst>
            </p:cNvPr>
            <p:cNvSpPr txBox="1"/>
            <p:nvPr/>
          </p:nvSpPr>
          <p:spPr>
            <a:xfrm>
              <a:off x="4247358" y="2491828"/>
              <a:ext cx="2696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1</a:t>
              </a:r>
            </a:p>
          </p:txBody>
        </p:sp>
        <p:cxnSp>
          <p:nvCxnSpPr>
            <p:cNvPr id="185" name="Connettore diritto 184">
              <a:extLst>
                <a:ext uri="{FF2B5EF4-FFF2-40B4-BE49-F238E27FC236}">
                  <a16:creationId xmlns:a16="http://schemas.microsoft.com/office/drawing/2014/main" id="{62B07443-4A58-42FB-ACB5-54C8D0E7D1A2}"/>
                </a:ext>
              </a:extLst>
            </p:cNvPr>
            <p:cNvCxnSpPr>
              <a:cxnSpLocks/>
            </p:cNvCxnSpPr>
            <p:nvPr/>
          </p:nvCxnSpPr>
          <p:spPr>
            <a:xfrm>
              <a:off x="3674391" y="2738347"/>
              <a:ext cx="7077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6" name="Connettore diritto 185">
              <a:extLst>
                <a:ext uri="{FF2B5EF4-FFF2-40B4-BE49-F238E27FC236}">
                  <a16:creationId xmlns:a16="http://schemas.microsoft.com/office/drawing/2014/main" id="{BB9D4C15-FC25-4D79-9CF4-9C6BFE658F7E}"/>
                </a:ext>
              </a:extLst>
            </p:cNvPr>
            <p:cNvCxnSpPr>
              <a:cxnSpLocks/>
            </p:cNvCxnSpPr>
            <p:nvPr/>
          </p:nvCxnSpPr>
          <p:spPr>
            <a:xfrm>
              <a:off x="4721008" y="2738347"/>
              <a:ext cx="7077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7" name="CasellaDiTesto 186">
              <a:extLst>
                <a:ext uri="{FF2B5EF4-FFF2-40B4-BE49-F238E27FC236}">
                  <a16:creationId xmlns:a16="http://schemas.microsoft.com/office/drawing/2014/main" id="{31A0E269-A69E-4E00-85CE-D56887402AB8}"/>
                </a:ext>
              </a:extLst>
            </p:cNvPr>
            <p:cNvSpPr txBox="1"/>
            <p:nvPr/>
          </p:nvSpPr>
          <p:spPr>
            <a:xfrm>
              <a:off x="4006159" y="1732252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**</a:t>
              </a:r>
            </a:p>
            <a:p>
              <a:endParaRPr lang="it-IT" sz="800" dirty="0"/>
            </a:p>
          </p:txBody>
        </p:sp>
      </p:grpSp>
      <p:sp>
        <p:nvSpPr>
          <p:cNvPr id="189" name="CasellaDiTesto 188">
            <a:extLst>
              <a:ext uri="{FF2B5EF4-FFF2-40B4-BE49-F238E27FC236}">
                <a16:creationId xmlns:a16="http://schemas.microsoft.com/office/drawing/2014/main" id="{19DBC1F4-89B2-423F-8D69-B74DB5B68F14}"/>
              </a:ext>
            </a:extLst>
          </p:cNvPr>
          <p:cNvSpPr txBox="1"/>
          <p:nvPr/>
        </p:nvSpPr>
        <p:spPr>
          <a:xfrm>
            <a:off x="79209" y="69324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A</a:t>
            </a:r>
          </a:p>
        </p:txBody>
      </p:sp>
      <p:sp>
        <p:nvSpPr>
          <p:cNvPr id="190" name="CasellaDiTesto 189">
            <a:extLst>
              <a:ext uri="{FF2B5EF4-FFF2-40B4-BE49-F238E27FC236}">
                <a16:creationId xmlns:a16="http://schemas.microsoft.com/office/drawing/2014/main" id="{EE35FDEE-4D92-49C2-BCEE-7CECF0C89FDB}"/>
              </a:ext>
            </a:extLst>
          </p:cNvPr>
          <p:cNvSpPr txBox="1"/>
          <p:nvPr/>
        </p:nvSpPr>
        <p:spPr>
          <a:xfrm>
            <a:off x="3175150" y="691879"/>
            <a:ext cx="3978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A’</a:t>
            </a:r>
          </a:p>
        </p:txBody>
      </p:sp>
      <p:sp>
        <p:nvSpPr>
          <p:cNvPr id="191" name="CasellaDiTesto 190">
            <a:extLst>
              <a:ext uri="{FF2B5EF4-FFF2-40B4-BE49-F238E27FC236}">
                <a16:creationId xmlns:a16="http://schemas.microsoft.com/office/drawing/2014/main" id="{719785AA-0252-4FB7-A7AC-4EBE36B04B38}"/>
              </a:ext>
            </a:extLst>
          </p:cNvPr>
          <p:cNvSpPr txBox="1"/>
          <p:nvPr/>
        </p:nvSpPr>
        <p:spPr>
          <a:xfrm>
            <a:off x="79209" y="357491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B</a:t>
            </a:r>
          </a:p>
        </p:txBody>
      </p:sp>
      <p:sp>
        <p:nvSpPr>
          <p:cNvPr id="192" name="CasellaDiTesto 191">
            <a:extLst>
              <a:ext uri="{FF2B5EF4-FFF2-40B4-BE49-F238E27FC236}">
                <a16:creationId xmlns:a16="http://schemas.microsoft.com/office/drawing/2014/main" id="{394B07CF-6697-4172-87B3-EB176BAF252A}"/>
              </a:ext>
            </a:extLst>
          </p:cNvPr>
          <p:cNvSpPr txBox="1"/>
          <p:nvPr/>
        </p:nvSpPr>
        <p:spPr>
          <a:xfrm>
            <a:off x="3226446" y="357491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9085044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F1D7D5B2-A72D-4DE1-BD23-1EA572229B45}"/>
              </a:ext>
            </a:extLst>
          </p:cNvPr>
          <p:cNvGrpSpPr/>
          <p:nvPr/>
        </p:nvGrpSpPr>
        <p:grpSpPr>
          <a:xfrm>
            <a:off x="1484784" y="827584"/>
            <a:ext cx="3537554" cy="1986774"/>
            <a:chOff x="3391263" y="3115652"/>
            <a:chExt cx="3537554" cy="1986774"/>
          </a:xfrm>
        </p:grpSpPr>
        <p:grpSp>
          <p:nvGrpSpPr>
            <p:cNvPr id="3" name="Gruppo 2">
              <a:extLst>
                <a:ext uri="{FF2B5EF4-FFF2-40B4-BE49-F238E27FC236}">
                  <a16:creationId xmlns:a16="http://schemas.microsoft.com/office/drawing/2014/main" id="{4431F3F4-29FE-45C6-8A80-828290DAAA54}"/>
                </a:ext>
              </a:extLst>
            </p:cNvPr>
            <p:cNvGrpSpPr/>
            <p:nvPr/>
          </p:nvGrpSpPr>
          <p:grpSpPr>
            <a:xfrm>
              <a:off x="3391263" y="3115652"/>
              <a:ext cx="3537554" cy="1986774"/>
              <a:chOff x="3391263" y="3115652"/>
              <a:chExt cx="3537554" cy="1986774"/>
            </a:xfrm>
          </p:grpSpPr>
          <p:grpSp>
            <p:nvGrpSpPr>
              <p:cNvPr id="5" name="Gruppo 4">
                <a:extLst>
                  <a:ext uri="{FF2B5EF4-FFF2-40B4-BE49-F238E27FC236}">
                    <a16:creationId xmlns:a16="http://schemas.microsoft.com/office/drawing/2014/main" id="{A16E3704-7663-4E8B-AB20-EA987CB0B676}"/>
                  </a:ext>
                </a:extLst>
              </p:cNvPr>
              <p:cNvGrpSpPr/>
              <p:nvPr/>
            </p:nvGrpSpPr>
            <p:grpSpPr>
              <a:xfrm>
                <a:off x="3391263" y="3115652"/>
                <a:ext cx="3537554" cy="1986774"/>
                <a:chOff x="3329378" y="2953916"/>
                <a:chExt cx="3537554" cy="1986774"/>
              </a:xfrm>
            </p:grpSpPr>
            <p:pic>
              <p:nvPicPr>
                <p:cNvPr id="13" name="Immagine 12">
                  <a:extLst>
                    <a:ext uri="{FF2B5EF4-FFF2-40B4-BE49-F238E27FC236}">
                      <a16:creationId xmlns:a16="http://schemas.microsoft.com/office/drawing/2014/main" id="{01ABAB67-AC05-4AE0-842C-CFE3CC86809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3942582" y="3177487"/>
                  <a:ext cx="2590784" cy="1328400"/>
                </a:xfrm>
                <a:prstGeom prst="rect">
                  <a:avLst/>
                </a:prstGeom>
              </p:spPr>
            </p:pic>
            <p:sp>
              <p:nvSpPr>
                <p:cNvPr id="14" name="CasellaDiTesto 13">
                  <a:extLst>
                    <a:ext uri="{FF2B5EF4-FFF2-40B4-BE49-F238E27FC236}">
                      <a16:creationId xmlns:a16="http://schemas.microsoft.com/office/drawing/2014/main" id="{E7E60A8C-F6C6-4780-B386-4CF6AAEC2E17}"/>
                    </a:ext>
                  </a:extLst>
                </p:cNvPr>
                <p:cNvSpPr txBox="1"/>
                <p:nvPr/>
              </p:nvSpPr>
              <p:spPr>
                <a:xfrm>
                  <a:off x="4202161" y="4694469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AZD</a:t>
                  </a:r>
                </a:p>
              </p:txBody>
            </p:sp>
            <p:sp>
              <p:nvSpPr>
                <p:cNvPr id="15" name="CasellaDiTesto 14">
                  <a:extLst>
                    <a:ext uri="{FF2B5EF4-FFF2-40B4-BE49-F238E27FC236}">
                      <a16:creationId xmlns:a16="http://schemas.microsoft.com/office/drawing/2014/main" id="{77F5508F-91B6-4CE8-9089-3D164201AF8A}"/>
                    </a:ext>
                  </a:extLst>
                </p:cNvPr>
                <p:cNvSpPr txBox="1"/>
                <p:nvPr/>
              </p:nvSpPr>
              <p:spPr>
                <a:xfrm>
                  <a:off x="3682163" y="3676266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0.6</a:t>
                  </a:r>
                </a:p>
              </p:txBody>
            </p:sp>
            <p:sp>
              <p:nvSpPr>
                <p:cNvPr id="16" name="CasellaDiTesto 15">
                  <a:extLst>
                    <a:ext uri="{FF2B5EF4-FFF2-40B4-BE49-F238E27FC236}">
                      <a16:creationId xmlns:a16="http://schemas.microsoft.com/office/drawing/2014/main" id="{600D84F2-1770-4F54-A847-D23A71F3AA06}"/>
                    </a:ext>
                  </a:extLst>
                </p:cNvPr>
                <p:cNvSpPr txBox="1"/>
                <p:nvPr/>
              </p:nvSpPr>
              <p:spPr>
                <a:xfrm>
                  <a:off x="3682163" y="4305407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0.0</a:t>
                  </a:r>
                </a:p>
              </p:txBody>
            </p:sp>
            <p:sp>
              <p:nvSpPr>
                <p:cNvPr id="17" name="CasellaDiTesto 16">
                  <a:extLst>
                    <a:ext uri="{FF2B5EF4-FFF2-40B4-BE49-F238E27FC236}">
                      <a16:creationId xmlns:a16="http://schemas.microsoft.com/office/drawing/2014/main" id="{C9D3609F-85F9-4DD4-9A1C-B0D5606D4E53}"/>
                    </a:ext>
                  </a:extLst>
                </p:cNvPr>
                <p:cNvSpPr txBox="1"/>
                <p:nvPr/>
              </p:nvSpPr>
              <p:spPr>
                <a:xfrm>
                  <a:off x="6419374" y="4421963"/>
                  <a:ext cx="4475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(</a:t>
                  </a:r>
                  <a:r>
                    <a:rPr lang="el-GR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it-IT" sz="1000" dirty="0"/>
                    <a:t>M)</a:t>
                  </a:r>
                </a:p>
              </p:txBody>
            </p:sp>
            <p:sp>
              <p:nvSpPr>
                <p:cNvPr id="18" name="CasellaDiTesto 17">
                  <a:extLst>
                    <a:ext uri="{FF2B5EF4-FFF2-40B4-BE49-F238E27FC236}">
                      <a16:creationId xmlns:a16="http://schemas.microsoft.com/office/drawing/2014/main" id="{47A75597-1999-4527-A5D3-344DABD30F62}"/>
                    </a:ext>
                  </a:extLst>
                </p:cNvPr>
                <p:cNvSpPr txBox="1"/>
                <p:nvPr/>
              </p:nvSpPr>
              <p:spPr>
                <a:xfrm>
                  <a:off x="3682163" y="3064650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1.2</a:t>
                  </a:r>
                </a:p>
              </p:txBody>
            </p:sp>
            <p:sp>
              <p:nvSpPr>
                <p:cNvPr id="19" name="CasellaDiTesto 18">
                  <a:extLst>
                    <a:ext uri="{FF2B5EF4-FFF2-40B4-BE49-F238E27FC236}">
                      <a16:creationId xmlns:a16="http://schemas.microsoft.com/office/drawing/2014/main" id="{6FC9414C-F27D-45E8-9644-66B73BB1DCB6}"/>
                    </a:ext>
                  </a:extLst>
                </p:cNvPr>
                <p:cNvSpPr txBox="1"/>
                <p:nvPr/>
              </p:nvSpPr>
              <p:spPr>
                <a:xfrm rot="16200000">
                  <a:off x="2716069" y="3567225"/>
                  <a:ext cx="1688283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/>
                    <a:t>ERE Promoter activity</a:t>
                  </a:r>
                </a:p>
                <a:p>
                  <a:pPr algn="ctr"/>
                  <a:r>
                    <a:rPr lang="it-IT" sz="1200" dirty="0"/>
                    <a:t>(RLU; </a:t>
                  </a:r>
                  <a:r>
                    <a:rPr lang="it-IT" sz="1200" dirty="0" err="1"/>
                    <a:t>Fold</a:t>
                  </a:r>
                  <a:r>
                    <a:rPr lang="it-IT" sz="1200" dirty="0"/>
                    <a:t> on - CTR)</a:t>
                  </a:r>
                  <a:endParaRPr lang="it-IT" sz="1200" dirty="0">
                    <a:latin typeface="+mn-lt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CasellaDiTesto 19">
                  <a:extLst>
                    <a:ext uri="{FF2B5EF4-FFF2-40B4-BE49-F238E27FC236}">
                      <a16:creationId xmlns:a16="http://schemas.microsoft.com/office/drawing/2014/main" id="{EBCB97ED-535E-4A22-A140-466B98050502}"/>
                    </a:ext>
                  </a:extLst>
                </p:cNvPr>
                <p:cNvSpPr txBox="1"/>
                <p:nvPr/>
              </p:nvSpPr>
              <p:spPr>
                <a:xfrm>
                  <a:off x="4691663" y="4694469"/>
                  <a:ext cx="37702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MK</a:t>
                  </a:r>
                </a:p>
              </p:txBody>
            </p:sp>
            <p:sp>
              <p:nvSpPr>
                <p:cNvPr id="21" name="CasellaDiTesto 20">
                  <a:extLst>
                    <a:ext uri="{FF2B5EF4-FFF2-40B4-BE49-F238E27FC236}">
                      <a16:creationId xmlns:a16="http://schemas.microsoft.com/office/drawing/2014/main" id="{1E7FB669-ED1B-4620-8FF2-CB0EB84913D0}"/>
                    </a:ext>
                  </a:extLst>
                </p:cNvPr>
                <p:cNvSpPr txBox="1"/>
                <p:nvPr/>
              </p:nvSpPr>
              <p:spPr>
                <a:xfrm>
                  <a:off x="5100914" y="4694469"/>
                  <a:ext cx="4491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CCT</a:t>
                  </a:r>
                </a:p>
              </p:txBody>
            </p:sp>
            <p:sp>
              <p:nvSpPr>
                <p:cNvPr id="22" name="CasellaDiTesto 21">
                  <a:extLst>
                    <a:ext uri="{FF2B5EF4-FFF2-40B4-BE49-F238E27FC236}">
                      <a16:creationId xmlns:a16="http://schemas.microsoft.com/office/drawing/2014/main" id="{DA5692DA-1813-4353-BAC4-0C57FA3E5EAE}"/>
                    </a:ext>
                  </a:extLst>
                </p:cNvPr>
                <p:cNvSpPr txBox="1"/>
                <p:nvPr/>
              </p:nvSpPr>
              <p:spPr>
                <a:xfrm>
                  <a:off x="5609782" y="4694469"/>
                  <a:ext cx="35458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VE</a:t>
                  </a:r>
                </a:p>
              </p:txBody>
            </p:sp>
            <p:sp>
              <p:nvSpPr>
                <p:cNvPr id="23" name="CasellaDiTesto 22">
                  <a:extLst>
                    <a:ext uri="{FF2B5EF4-FFF2-40B4-BE49-F238E27FC236}">
                      <a16:creationId xmlns:a16="http://schemas.microsoft.com/office/drawing/2014/main" id="{E5689B03-B155-411F-986C-E004B86F694C}"/>
                    </a:ext>
                  </a:extLst>
                </p:cNvPr>
                <p:cNvSpPr txBox="1"/>
                <p:nvPr/>
              </p:nvSpPr>
              <p:spPr>
                <a:xfrm>
                  <a:off x="6065285" y="4694469"/>
                  <a:ext cx="36260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KU</a:t>
                  </a:r>
                </a:p>
              </p:txBody>
            </p:sp>
            <p:cxnSp>
              <p:nvCxnSpPr>
                <p:cNvPr id="24" name="Connettore diritto 23">
                  <a:extLst>
                    <a:ext uri="{FF2B5EF4-FFF2-40B4-BE49-F238E27FC236}">
                      <a16:creationId xmlns:a16="http://schemas.microsoft.com/office/drawing/2014/main" id="{23D4BE54-EB94-47B1-BD17-D4657FD781E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13536" y="4716016"/>
                  <a:ext cx="360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5" name="CasellaDiTesto 24">
                  <a:extLst>
                    <a:ext uri="{FF2B5EF4-FFF2-40B4-BE49-F238E27FC236}">
                      <a16:creationId xmlns:a16="http://schemas.microsoft.com/office/drawing/2014/main" id="{DFED7436-6341-4133-9195-7BED6D5A806F}"/>
                    </a:ext>
                  </a:extLst>
                </p:cNvPr>
                <p:cNvSpPr txBox="1"/>
                <p:nvPr/>
              </p:nvSpPr>
              <p:spPr>
                <a:xfrm rot="16200000">
                  <a:off x="3893846" y="4523434"/>
                  <a:ext cx="4491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CTR</a:t>
                  </a:r>
                </a:p>
              </p:txBody>
            </p:sp>
            <p:sp>
              <p:nvSpPr>
                <p:cNvPr id="26" name="CasellaDiTesto 25">
                  <a:extLst>
                    <a:ext uri="{FF2B5EF4-FFF2-40B4-BE49-F238E27FC236}">
                      <a16:creationId xmlns:a16="http://schemas.microsoft.com/office/drawing/2014/main" id="{5CB63C53-52C4-46DB-AF6F-31B3D0A790FD}"/>
                    </a:ext>
                  </a:extLst>
                </p:cNvPr>
                <p:cNvSpPr txBox="1"/>
                <p:nvPr/>
              </p:nvSpPr>
              <p:spPr>
                <a:xfrm rot="16200000">
                  <a:off x="4148336" y="4426452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1</a:t>
                  </a:r>
                </a:p>
              </p:txBody>
            </p:sp>
            <p:sp>
              <p:nvSpPr>
                <p:cNvPr id="27" name="CasellaDiTesto 26">
                  <a:extLst>
                    <a:ext uri="{FF2B5EF4-FFF2-40B4-BE49-F238E27FC236}">
                      <a16:creationId xmlns:a16="http://schemas.microsoft.com/office/drawing/2014/main" id="{462537BD-90AE-413F-9B1B-8FDFA83AC7A7}"/>
                    </a:ext>
                  </a:extLst>
                </p:cNvPr>
                <p:cNvSpPr txBox="1"/>
                <p:nvPr/>
              </p:nvSpPr>
              <p:spPr>
                <a:xfrm rot="16200000">
                  <a:off x="4280784" y="4426452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5</a:t>
                  </a:r>
                </a:p>
              </p:txBody>
            </p:sp>
            <p:sp>
              <p:nvSpPr>
                <p:cNvPr id="28" name="CasellaDiTesto 27">
                  <a:extLst>
                    <a:ext uri="{FF2B5EF4-FFF2-40B4-BE49-F238E27FC236}">
                      <a16:creationId xmlns:a16="http://schemas.microsoft.com/office/drawing/2014/main" id="{37D20C97-87E3-4EC3-8993-D7594D51C9FB}"/>
                    </a:ext>
                  </a:extLst>
                </p:cNvPr>
                <p:cNvSpPr txBox="1"/>
                <p:nvPr/>
              </p:nvSpPr>
              <p:spPr>
                <a:xfrm rot="16200000">
                  <a:off x="4395816" y="4461718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10</a:t>
                  </a:r>
                </a:p>
              </p:txBody>
            </p:sp>
            <p:sp>
              <p:nvSpPr>
                <p:cNvPr id="29" name="CasellaDiTesto 28">
                  <a:extLst>
                    <a:ext uri="{FF2B5EF4-FFF2-40B4-BE49-F238E27FC236}">
                      <a16:creationId xmlns:a16="http://schemas.microsoft.com/office/drawing/2014/main" id="{CF57C418-DE34-4EAF-8612-A1BAA2BCB0D6}"/>
                    </a:ext>
                  </a:extLst>
                </p:cNvPr>
                <p:cNvSpPr txBox="1"/>
                <p:nvPr/>
              </p:nvSpPr>
              <p:spPr>
                <a:xfrm rot="16200000">
                  <a:off x="4551128" y="4479351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0.1</a:t>
                  </a:r>
                </a:p>
              </p:txBody>
            </p:sp>
            <p:sp>
              <p:nvSpPr>
                <p:cNvPr id="30" name="CasellaDiTesto 29">
                  <a:extLst>
                    <a:ext uri="{FF2B5EF4-FFF2-40B4-BE49-F238E27FC236}">
                      <a16:creationId xmlns:a16="http://schemas.microsoft.com/office/drawing/2014/main" id="{0BD0377E-69E4-4902-B761-E4FF3C5ACB12}"/>
                    </a:ext>
                  </a:extLst>
                </p:cNvPr>
                <p:cNvSpPr txBox="1"/>
                <p:nvPr/>
              </p:nvSpPr>
              <p:spPr>
                <a:xfrm rot="16200000">
                  <a:off x="4702114" y="4479351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0.5</a:t>
                  </a:r>
                </a:p>
              </p:txBody>
            </p:sp>
            <p:sp>
              <p:nvSpPr>
                <p:cNvPr id="31" name="CasellaDiTesto 30">
                  <a:extLst>
                    <a:ext uri="{FF2B5EF4-FFF2-40B4-BE49-F238E27FC236}">
                      <a16:creationId xmlns:a16="http://schemas.microsoft.com/office/drawing/2014/main" id="{DEC8AD41-41E7-4018-AF21-43CE4E82DB3A}"/>
                    </a:ext>
                  </a:extLst>
                </p:cNvPr>
                <p:cNvSpPr txBox="1"/>
                <p:nvPr/>
              </p:nvSpPr>
              <p:spPr>
                <a:xfrm rot="16200000">
                  <a:off x="4906125" y="4426452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1</a:t>
                  </a:r>
                </a:p>
              </p:txBody>
            </p:sp>
            <p:sp>
              <p:nvSpPr>
                <p:cNvPr id="32" name="CasellaDiTesto 31">
                  <a:extLst>
                    <a:ext uri="{FF2B5EF4-FFF2-40B4-BE49-F238E27FC236}">
                      <a16:creationId xmlns:a16="http://schemas.microsoft.com/office/drawing/2014/main" id="{3A9D76A6-9A6E-4AC7-A69C-40BDA7052B28}"/>
                    </a:ext>
                  </a:extLst>
                </p:cNvPr>
                <p:cNvSpPr txBox="1"/>
                <p:nvPr/>
              </p:nvSpPr>
              <p:spPr>
                <a:xfrm rot="16200000">
                  <a:off x="4987372" y="4479351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0.1</a:t>
                  </a:r>
                </a:p>
              </p:txBody>
            </p:sp>
            <p:sp>
              <p:nvSpPr>
                <p:cNvPr id="33" name="CasellaDiTesto 32">
                  <a:extLst>
                    <a:ext uri="{FF2B5EF4-FFF2-40B4-BE49-F238E27FC236}">
                      <a16:creationId xmlns:a16="http://schemas.microsoft.com/office/drawing/2014/main" id="{DEA0DFB2-E079-47E0-8AA2-F469EA2954A5}"/>
                    </a:ext>
                  </a:extLst>
                </p:cNvPr>
                <p:cNvSpPr txBox="1"/>
                <p:nvPr/>
              </p:nvSpPr>
              <p:spPr>
                <a:xfrm rot="16200000">
                  <a:off x="5157410" y="4479351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0.5</a:t>
                  </a:r>
                </a:p>
              </p:txBody>
            </p:sp>
            <p:sp>
              <p:nvSpPr>
                <p:cNvPr id="34" name="CasellaDiTesto 33">
                  <a:extLst>
                    <a:ext uri="{FF2B5EF4-FFF2-40B4-BE49-F238E27FC236}">
                      <a16:creationId xmlns:a16="http://schemas.microsoft.com/office/drawing/2014/main" id="{2E1DD9AD-67E4-4089-B500-0B3ED12E8585}"/>
                    </a:ext>
                  </a:extLst>
                </p:cNvPr>
                <p:cNvSpPr txBox="1"/>
                <p:nvPr/>
              </p:nvSpPr>
              <p:spPr>
                <a:xfrm rot="16200000">
                  <a:off x="5361421" y="4426452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1</a:t>
                  </a:r>
                </a:p>
              </p:txBody>
            </p:sp>
            <p:sp>
              <p:nvSpPr>
                <p:cNvPr id="35" name="CasellaDiTesto 34">
                  <a:extLst>
                    <a:ext uri="{FF2B5EF4-FFF2-40B4-BE49-F238E27FC236}">
                      <a16:creationId xmlns:a16="http://schemas.microsoft.com/office/drawing/2014/main" id="{E65F5702-5E22-4400-B1B3-EC0C8C33F5D7}"/>
                    </a:ext>
                  </a:extLst>
                </p:cNvPr>
                <p:cNvSpPr txBox="1"/>
                <p:nvPr/>
              </p:nvSpPr>
              <p:spPr>
                <a:xfrm rot="16200000">
                  <a:off x="5453808" y="4479351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0.1</a:t>
                  </a:r>
                </a:p>
              </p:txBody>
            </p:sp>
            <p:sp>
              <p:nvSpPr>
                <p:cNvPr id="36" name="CasellaDiTesto 35">
                  <a:extLst>
                    <a:ext uri="{FF2B5EF4-FFF2-40B4-BE49-F238E27FC236}">
                      <a16:creationId xmlns:a16="http://schemas.microsoft.com/office/drawing/2014/main" id="{9DE2C377-7961-4A8A-840C-7B18CEA0D505}"/>
                    </a:ext>
                  </a:extLst>
                </p:cNvPr>
                <p:cNvSpPr txBox="1"/>
                <p:nvPr/>
              </p:nvSpPr>
              <p:spPr>
                <a:xfrm rot="16200000">
                  <a:off x="5623846" y="4479351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0.5</a:t>
                  </a:r>
                </a:p>
              </p:txBody>
            </p:sp>
            <p:sp>
              <p:nvSpPr>
                <p:cNvPr id="37" name="CasellaDiTesto 36">
                  <a:extLst>
                    <a:ext uri="{FF2B5EF4-FFF2-40B4-BE49-F238E27FC236}">
                      <a16:creationId xmlns:a16="http://schemas.microsoft.com/office/drawing/2014/main" id="{758DB507-7868-4861-AEC8-B572A420E48D}"/>
                    </a:ext>
                  </a:extLst>
                </p:cNvPr>
                <p:cNvSpPr txBox="1"/>
                <p:nvPr/>
              </p:nvSpPr>
              <p:spPr>
                <a:xfrm rot="16200000">
                  <a:off x="5813568" y="4426452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1</a:t>
                  </a:r>
                </a:p>
              </p:txBody>
            </p:sp>
            <p:sp>
              <p:nvSpPr>
                <p:cNvPr id="38" name="CasellaDiTesto 37">
                  <a:extLst>
                    <a:ext uri="{FF2B5EF4-FFF2-40B4-BE49-F238E27FC236}">
                      <a16:creationId xmlns:a16="http://schemas.microsoft.com/office/drawing/2014/main" id="{C28A530E-B99D-4673-849C-FDF133CC4E79}"/>
                    </a:ext>
                  </a:extLst>
                </p:cNvPr>
                <p:cNvSpPr txBox="1"/>
                <p:nvPr/>
              </p:nvSpPr>
              <p:spPr>
                <a:xfrm rot="16200000">
                  <a:off x="5935186" y="4479351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0.1</a:t>
                  </a:r>
                </a:p>
              </p:txBody>
            </p:sp>
            <p:sp>
              <p:nvSpPr>
                <p:cNvPr id="39" name="CasellaDiTesto 38">
                  <a:extLst>
                    <a:ext uri="{FF2B5EF4-FFF2-40B4-BE49-F238E27FC236}">
                      <a16:creationId xmlns:a16="http://schemas.microsoft.com/office/drawing/2014/main" id="{78C82142-A409-490D-A998-1DFA8BA19E4F}"/>
                    </a:ext>
                  </a:extLst>
                </p:cNvPr>
                <p:cNvSpPr txBox="1"/>
                <p:nvPr/>
              </p:nvSpPr>
              <p:spPr>
                <a:xfrm rot="16200000">
                  <a:off x="6105224" y="4479351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0.5</a:t>
                  </a:r>
                </a:p>
              </p:txBody>
            </p:sp>
            <p:sp>
              <p:nvSpPr>
                <p:cNvPr id="40" name="CasellaDiTesto 39">
                  <a:extLst>
                    <a:ext uri="{FF2B5EF4-FFF2-40B4-BE49-F238E27FC236}">
                      <a16:creationId xmlns:a16="http://schemas.microsoft.com/office/drawing/2014/main" id="{6C000529-DDA0-4B98-9682-8183C75D813B}"/>
                    </a:ext>
                  </a:extLst>
                </p:cNvPr>
                <p:cNvSpPr txBox="1"/>
                <p:nvPr/>
              </p:nvSpPr>
              <p:spPr>
                <a:xfrm rot="16200000">
                  <a:off x="6294946" y="4426452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/>
                    <a:t>1</a:t>
                  </a:r>
                </a:p>
              </p:txBody>
            </p:sp>
            <p:cxnSp>
              <p:nvCxnSpPr>
                <p:cNvPr id="41" name="Connettore diritto 40">
                  <a:extLst>
                    <a:ext uri="{FF2B5EF4-FFF2-40B4-BE49-F238E27FC236}">
                      <a16:creationId xmlns:a16="http://schemas.microsoft.com/office/drawing/2014/main" id="{145D64B8-3CB9-472C-BE42-4888C84D3E3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66449" y="4716016"/>
                  <a:ext cx="360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Connettore diritto 41">
                  <a:extLst>
                    <a:ext uri="{FF2B5EF4-FFF2-40B4-BE49-F238E27FC236}">
                      <a16:creationId xmlns:a16="http://schemas.microsoft.com/office/drawing/2014/main" id="{1F00267E-B9B7-41EA-B767-3924A5B62CF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07572" y="4716016"/>
                  <a:ext cx="360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Connettore diritto 42">
                  <a:extLst>
                    <a:ext uri="{FF2B5EF4-FFF2-40B4-BE49-F238E27FC236}">
                      <a16:creationId xmlns:a16="http://schemas.microsoft.com/office/drawing/2014/main" id="{0600FA80-494D-4620-9AAE-42EAA3AE44B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99263" y="4716016"/>
                  <a:ext cx="360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Connettore diritto 43">
                  <a:extLst>
                    <a:ext uri="{FF2B5EF4-FFF2-40B4-BE49-F238E27FC236}">
                      <a16:creationId xmlns:a16="http://schemas.microsoft.com/office/drawing/2014/main" id="{69B35F03-E136-40A8-AC26-C7053136C94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48833" y="4716016"/>
                  <a:ext cx="360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D8EAEB45-D9F3-4148-BBBE-15271BB0B267}"/>
                  </a:ext>
                </a:extLst>
              </p:cNvPr>
              <p:cNvSpPr txBox="1"/>
              <p:nvPr/>
            </p:nvSpPr>
            <p:spPr>
              <a:xfrm>
                <a:off x="4520081" y="3599602"/>
                <a:ext cx="26481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**</a:t>
                </a:r>
              </a:p>
              <a:p>
                <a:r>
                  <a:rPr lang="it-IT" sz="800" dirty="0"/>
                  <a:t>**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D9A9A77B-70F0-4C3E-B187-091DA8C637C1}"/>
                  </a:ext>
                </a:extLst>
              </p:cNvPr>
              <p:cNvSpPr txBox="1"/>
              <p:nvPr/>
            </p:nvSpPr>
            <p:spPr>
              <a:xfrm>
                <a:off x="4672481" y="3347864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**</a:t>
                </a:r>
              </a:p>
            </p:txBody>
          </p:sp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06D79108-E84E-4E7D-9C34-A14084705720}"/>
                  </a:ext>
                </a:extLst>
              </p:cNvPr>
              <p:cNvSpPr txBox="1"/>
              <p:nvPr/>
            </p:nvSpPr>
            <p:spPr>
              <a:xfrm>
                <a:off x="4824881" y="3500264"/>
                <a:ext cx="26481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**</a:t>
                </a:r>
              </a:p>
              <a:p>
                <a:r>
                  <a:rPr lang="it-IT" sz="800" dirty="0"/>
                  <a:t>**</a:t>
                </a:r>
              </a:p>
            </p:txBody>
          </p:sp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D18AA236-BDE8-4B77-A321-47F5C30DBC82}"/>
                  </a:ext>
                </a:extLst>
              </p:cNvPr>
              <p:cNvSpPr txBox="1"/>
              <p:nvPr/>
            </p:nvSpPr>
            <p:spPr>
              <a:xfrm>
                <a:off x="4977281" y="3652664"/>
                <a:ext cx="26481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**</a:t>
                </a:r>
              </a:p>
              <a:p>
                <a:r>
                  <a:rPr lang="it-IT" sz="800" dirty="0"/>
                  <a:t>**</a:t>
                </a:r>
              </a:p>
            </p:txBody>
          </p:sp>
          <p:sp>
            <p:nvSpPr>
              <p:cNvPr id="10" name="CasellaDiTesto 9">
                <a:extLst>
                  <a:ext uri="{FF2B5EF4-FFF2-40B4-BE49-F238E27FC236}">
                    <a16:creationId xmlns:a16="http://schemas.microsoft.com/office/drawing/2014/main" id="{53E5AF97-213F-432B-9A48-4523877B88E9}"/>
                  </a:ext>
                </a:extLst>
              </p:cNvPr>
              <p:cNvSpPr txBox="1"/>
              <p:nvPr/>
            </p:nvSpPr>
            <p:spPr>
              <a:xfrm>
                <a:off x="5576638" y="3366914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**</a:t>
                </a:r>
              </a:p>
            </p:txBody>
          </p:sp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B7E379A3-4C24-44B2-AB33-E716AE9F5D0E}"/>
                  </a:ext>
                </a:extLst>
              </p:cNvPr>
              <p:cNvSpPr txBox="1"/>
              <p:nvPr/>
            </p:nvSpPr>
            <p:spPr>
              <a:xfrm>
                <a:off x="5729038" y="3519314"/>
                <a:ext cx="26481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**</a:t>
                </a:r>
              </a:p>
              <a:p>
                <a:r>
                  <a:rPr lang="it-IT" sz="800" dirty="0"/>
                  <a:t>**</a:t>
                </a: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2DB5A465-A66C-48AD-A6BC-73B6FAB3262A}"/>
                  </a:ext>
                </a:extLst>
              </p:cNvPr>
              <p:cNvSpPr txBox="1"/>
              <p:nvPr/>
            </p:nvSpPr>
            <p:spPr>
              <a:xfrm>
                <a:off x="5881438" y="3671714"/>
                <a:ext cx="26481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/>
                  <a:t>**</a:t>
                </a:r>
              </a:p>
              <a:p>
                <a:r>
                  <a:rPr lang="it-IT" sz="800" dirty="0"/>
                  <a:t>**</a:t>
                </a:r>
              </a:p>
            </p:txBody>
          </p:sp>
        </p:grpSp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1DDE6411-3BA2-44E1-8220-CDC3812CA5DE}"/>
                </a:ext>
              </a:extLst>
            </p:cNvPr>
            <p:cNvSpPr txBox="1"/>
            <p:nvPr/>
          </p:nvSpPr>
          <p:spPr>
            <a:xfrm>
              <a:off x="4962926" y="3202464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Y537S</a:t>
              </a:r>
            </a:p>
          </p:txBody>
        </p:sp>
      </p:grp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B7CA2A80-F075-4F0D-8B71-5B771835F488}"/>
              </a:ext>
            </a:extLst>
          </p:cNvPr>
          <p:cNvSpPr txBox="1"/>
          <p:nvPr/>
        </p:nvSpPr>
        <p:spPr>
          <a:xfrm>
            <a:off x="1970792" y="30783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ure 4</a:t>
            </a: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3239AF68-BABB-4804-8FAB-4F3CFD20645D}"/>
              </a:ext>
            </a:extLst>
          </p:cNvPr>
          <p:cNvSpPr txBox="1"/>
          <p:nvPr/>
        </p:nvSpPr>
        <p:spPr>
          <a:xfrm>
            <a:off x="1037970" y="55058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A</a:t>
            </a: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84C56A7A-234D-4670-9995-6891F80F57E4}"/>
              </a:ext>
            </a:extLst>
          </p:cNvPr>
          <p:cNvSpPr txBox="1"/>
          <p:nvPr/>
        </p:nvSpPr>
        <p:spPr>
          <a:xfrm>
            <a:off x="1037970" y="334786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B</a:t>
            </a:r>
          </a:p>
        </p:txBody>
      </p:sp>
      <p:grpSp>
        <p:nvGrpSpPr>
          <p:cNvPr id="110" name="Gruppo 109">
            <a:extLst>
              <a:ext uri="{FF2B5EF4-FFF2-40B4-BE49-F238E27FC236}">
                <a16:creationId xmlns:a16="http://schemas.microsoft.com/office/drawing/2014/main" id="{52F64382-DAB4-4411-B0B8-132B66C1D63C}"/>
              </a:ext>
            </a:extLst>
          </p:cNvPr>
          <p:cNvGrpSpPr/>
          <p:nvPr/>
        </p:nvGrpSpPr>
        <p:grpSpPr>
          <a:xfrm>
            <a:off x="1527175" y="4079682"/>
            <a:ext cx="2863423" cy="1649804"/>
            <a:chOff x="1527175" y="4079682"/>
            <a:chExt cx="2863423" cy="1649804"/>
          </a:xfrm>
        </p:grpSpPr>
        <p:pic>
          <p:nvPicPr>
            <p:cNvPr id="109" name="Immagine 108">
              <a:extLst>
                <a:ext uri="{FF2B5EF4-FFF2-40B4-BE49-F238E27FC236}">
                  <a16:creationId xmlns:a16="http://schemas.microsoft.com/office/drawing/2014/main" id="{1CE12982-2905-4F31-B32C-6905352D4A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10566" y="4234169"/>
              <a:ext cx="1936733" cy="1328400"/>
            </a:xfrm>
            <a:prstGeom prst="rect">
              <a:avLst/>
            </a:prstGeom>
          </p:spPr>
        </p:pic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66E5EA75-789F-44DA-A606-F48A8DF3B618}"/>
                </a:ext>
              </a:extLst>
            </p:cNvPr>
            <p:cNvSpPr txBox="1"/>
            <p:nvPr/>
          </p:nvSpPr>
          <p:spPr>
            <a:xfrm>
              <a:off x="2510304" y="4079682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AZD</a:t>
              </a:r>
            </a:p>
          </p:txBody>
        </p:sp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id="{58DEEFD9-9638-4B86-9A3C-54E3AAFEF289}"/>
                </a:ext>
              </a:extLst>
            </p:cNvPr>
            <p:cNvSpPr txBox="1"/>
            <p:nvPr/>
          </p:nvSpPr>
          <p:spPr>
            <a:xfrm>
              <a:off x="1877779" y="4760309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10.0</a:t>
              </a:r>
            </a:p>
          </p:txBody>
        </p:sp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id="{73407D47-DD19-4F6B-94DE-D4FE511769D8}"/>
                </a:ext>
              </a:extLst>
            </p:cNvPr>
            <p:cNvSpPr txBox="1"/>
            <p:nvPr/>
          </p:nvSpPr>
          <p:spPr>
            <a:xfrm>
              <a:off x="1948311" y="5370400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0.0</a:t>
              </a:r>
            </a:p>
          </p:txBody>
        </p:sp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E6CF104B-8514-4A5A-9CD1-44D2A0FDE6C4}"/>
                </a:ext>
              </a:extLst>
            </p:cNvPr>
            <p:cNvSpPr txBox="1"/>
            <p:nvPr/>
          </p:nvSpPr>
          <p:spPr>
            <a:xfrm>
              <a:off x="2239129" y="5483265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78" name="CasellaDiTesto 77">
              <a:extLst>
                <a:ext uri="{FF2B5EF4-FFF2-40B4-BE49-F238E27FC236}">
                  <a16:creationId xmlns:a16="http://schemas.microsoft.com/office/drawing/2014/main" id="{0CE749DD-B3FF-4017-B87C-D60BF4794C78}"/>
                </a:ext>
              </a:extLst>
            </p:cNvPr>
            <p:cNvSpPr txBox="1"/>
            <p:nvPr/>
          </p:nvSpPr>
          <p:spPr>
            <a:xfrm>
              <a:off x="2550974" y="5483265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79" name="CasellaDiTesto 78">
              <a:extLst>
                <a:ext uri="{FF2B5EF4-FFF2-40B4-BE49-F238E27FC236}">
                  <a16:creationId xmlns:a16="http://schemas.microsoft.com/office/drawing/2014/main" id="{0C140D7B-6A17-4902-AD1F-C357E85AEBDD}"/>
                </a:ext>
              </a:extLst>
            </p:cNvPr>
            <p:cNvSpPr txBox="1"/>
            <p:nvPr/>
          </p:nvSpPr>
          <p:spPr>
            <a:xfrm>
              <a:off x="2340281" y="5483265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+</a:t>
              </a:r>
            </a:p>
          </p:txBody>
        </p:sp>
        <p:sp>
          <p:nvSpPr>
            <p:cNvPr id="80" name="CasellaDiTesto 79">
              <a:extLst>
                <a:ext uri="{FF2B5EF4-FFF2-40B4-BE49-F238E27FC236}">
                  <a16:creationId xmlns:a16="http://schemas.microsoft.com/office/drawing/2014/main" id="{80D56B8D-0944-474B-8452-9CFBE9C600D0}"/>
                </a:ext>
              </a:extLst>
            </p:cNvPr>
            <p:cNvSpPr txBox="1"/>
            <p:nvPr/>
          </p:nvSpPr>
          <p:spPr>
            <a:xfrm>
              <a:off x="2657237" y="5483265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+</a:t>
              </a:r>
            </a:p>
          </p:txBody>
        </p:sp>
        <p:sp>
          <p:nvSpPr>
            <p:cNvPr id="81" name="CasellaDiTesto 80">
              <a:extLst>
                <a:ext uri="{FF2B5EF4-FFF2-40B4-BE49-F238E27FC236}">
                  <a16:creationId xmlns:a16="http://schemas.microsoft.com/office/drawing/2014/main" id="{C2642F9F-AAC8-48B6-A8E4-A4421B147BBB}"/>
                </a:ext>
              </a:extLst>
            </p:cNvPr>
            <p:cNvSpPr txBox="1"/>
            <p:nvPr/>
          </p:nvSpPr>
          <p:spPr>
            <a:xfrm>
              <a:off x="4050440" y="5483265"/>
              <a:ext cx="3401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E2</a:t>
              </a:r>
            </a:p>
          </p:txBody>
        </p:sp>
        <p:sp>
          <p:nvSpPr>
            <p:cNvPr id="82" name="CasellaDiTesto 81">
              <a:extLst>
                <a:ext uri="{FF2B5EF4-FFF2-40B4-BE49-F238E27FC236}">
                  <a16:creationId xmlns:a16="http://schemas.microsoft.com/office/drawing/2014/main" id="{A9B01F9A-2620-4343-9482-32E1990C2A53}"/>
                </a:ext>
              </a:extLst>
            </p:cNvPr>
            <p:cNvSpPr txBox="1"/>
            <p:nvPr/>
          </p:nvSpPr>
          <p:spPr>
            <a:xfrm>
              <a:off x="1877779" y="4148693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0.0</a:t>
              </a:r>
            </a:p>
          </p:txBody>
        </p:sp>
        <p:sp>
          <p:nvSpPr>
            <p:cNvPr id="83" name="CasellaDiTesto 82">
              <a:extLst>
                <a:ext uri="{FF2B5EF4-FFF2-40B4-BE49-F238E27FC236}">
                  <a16:creationId xmlns:a16="http://schemas.microsoft.com/office/drawing/2014/main" id="{76F84FBB-F0AC-40EA-A5E0-22BD4F8E414E}"/>
                </a:ext>
              </a:extLst>
            </p:cNvPr>
            <p:cNvSpPr txBox="1"/>
            <p:nvPr/>
          </p:nvSpPr>
          <p:spPr>
            <a:xfrm rot="16200000">
              <a:off x="1264924" y="4650502"/>
              <a:ext cx="98616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pS2 </a:t>
              </a:r>
              <a:r>
                <a:rPr lang="it-IT" sz="1200" dirty="0" err="1"/>
                <a:t>Levels</a:t>
              </a:r>
              <a:r>
                <a:rPr lang="it-IT" sz="1200" dirty="0"/>
                <a:t> </a:t>
              </a:r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-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84" name="CasellaDiTesto 83">
              <a:extLst>
                <a:ext uri="{FF2B5EF4-FFF2-40B4-BE49-F238E27FC236}">
                  <a16:creationId xmlns:a16="http://schemas.microsoft.com/office/drawing/2014/main" id="{A06E8819-677A-4FE1-8091-089D6D3CCC47}"/>
                </a:ext>
              </a:extLst>
            </p:cNvPr>
            <p:cNvSpPr txBox="1"/>
            <p:nvPr/>
          </p:nvSpPr>
          <p:spPr>
            <a:xfrm>
              <a:off x="2865913" y="5483265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85" name="CasellaDiTesto 84">
              <a:extLst>
                <a:ext uri="{FF2B5EF4-FFF2-40B4-BE49-F238E27FC236}">
                  <a16:creationId xmlns:a16="http://schemas.microsoft.com/office/drawing/2014/main" id="{8CBACDB8-4CE2-4B0F-B678-B39B896F1ADA}"/>
                </a:ext>
              </a:extLst>
            </p:cNvPr>
            <p:cNvSpPr txBox="1"/>
            <p:nvPr/>
          </p:nvSpPr>
          <p:spPr>
            <a:xfrm>
              <a:off x="3184108" y="5483265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86" name="CasellaDiTesto 85">
              <a:extLst>
                <a:ext uri="{FF2B5EF4-FFF2-40B4-BE49-F238E27FC236}">
                  <a16:creationId xmlns:a16="http://schemas.microsoft.com/office/drawing/2014/main" id="{5976CA0E-8EA0-42C1-8396-C84D1A91B0FA}"/>
                </a:ext>
              </a:extLst>
            </p:cNvPr>
            <p:cNvSpPr txBox="1"/>
            <p:nvPr/>
          </p:nvSpPr>
          <p:spPr>
            <a:xfrm>
              <a:off x="2967065" y="5483265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+</a:t>
              </a:r>
            </a:p>
          </p:txBody>
        </p:sp>
        <p:sp>
          <p:nvSpPr>
            <p:cNvPr id="87" name="CasellaDiTesto 86">
              <a:extLst>
                <a:ext uri="{FF2B5EF4-FFF2-40B4-BE49-F238E27FC236}">
                  <a16:creationId xmlns:a16="http://schemas.microsoft.com/office/drawing/2014/main" id="{DF09C1CA-79BD-4C86-AA2A-92D98B6CD704}"/>
                </a:ext>
              </a:extLst>
            </p:cNvPr>
            <p:cNvSpPr txBox="1"/>
            <p:nvPr/>
          </p:nvSpPr>
          <p:spPr>
            <a:xfrm>
              <a:off x="3280499" y="5483265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+</a:t>
              </a:r>
            </a:p>
          </p:txBody>
        </p:sp>
        <p:sp>
          <p:nvSpPr>
            <p:cNvPr id="88" name="CasellaDiTesto 87">
              <a:extLst>
                <a:ext uri="{FF2B5EF4-FFF2-40B4-BE49-F238E27FC236}">
                  <a16:creationId xmlns:a16="http://schemas.microsoft.com/office/drawing/2014/main" id="{C5F5303C-6387-4D0D-9D8C-C75047D56428}"/>
                </a:ext>
              </a:extLst>
            </p:cNvPr>
            <p:cNvSpPr txBox="1"/>
            <p:nvPr/>
          </p:nvSpPr>
          <p:spPr>
            <a:xfrm>
              <a:off x="3492923" y="5483265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89" name="CasellaDiTesto 88">
              <a:extLst>
                <a:ext uri="{FF2B5EF4-FFF2-40B4-BE49-F238E27FC236}">
                  <a16:creationId xmlns:a16="http://schemas.microsoft.com/office/drawing/2014/main" id="{EA0A3166-59C2-45D3-BE2E-9E607CC63CBD}"/>
                </a:ext>
              </a:extLst>
            </p:cNvPr>
            <p:cNvSpPr txBox="1"/>
            <p:nvPr/>
          </p:nvSpPr>
          <p:spPr>
            <a:xfrm>
              <a:off x="3804768" y="5483265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90" name="CasellaDiTesto 89">
              <a:extLst>
                <a:ext uri="{FF2B5EF4-FFF2-40B4-BE49-F238E27FC236}">
                  <a16:creationId xmlns:a16="http://schemas.microsoft.com/office/drawing/2014/main" id="{9636923C-08F8-48E4-A3BA-DCCC34984681}"/>
                </a:ext>
              </a:extLst>
            </p:cNvPr>
            <p:cNvSpPr txBox="1"/>
            <p:nvPr/>
          </p:nvSpPr>
          <p:spPr>
            <a:xfrm>
              <a:off x="3594075" y="5483265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+</a:t>
              </a:r>
            </a:p>
          </p:txBody>
        </p:sp>
        <p:sp>
          <p:nvSpPr>
            <p:cNvPr id="91" name="CasellaDiTesto 90">
              <a:extLst>
                <a:ext uri="{FF2B5EF4-FFF2-40B4-BE49-F238E27FC236}">
                  <a16:creationId xmlns:a16="http://schemas.microsoft.com/office/drawing/2014/main" id="{A89EAD94-EA3E-4310-9929-E93659FEE77B}"/>
                </a:ext>
              </a:extLst>
            </p:cNvPr>
            <p:cNvSpPr txBox="1"/>
            <p:nvPr/>
          </p:nvSpPr>
          <p:spPr>
            <a:xfrm>
              <a:off x="3901159" y="5483265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+</a:t>
              </a:r>
            </a:p>
          </p:txBody>
        </p:sp>
        <p:cxnSp>
          <p:nvCxnSpPr>
            <p:cNvPr id="92" name="Connettore diritto 91">
              <a:extLst>
                <a:ext uri="{FF2B5EF4-FFF2-40B4-BE49-F238E27FC236}">
                  <a16:creationId xmlns:a16="http://schemas.microsoft.com/office/drawing/2014/main" id="{347A344C-08A7-493F-A3E5-7B12D1BB1863}"/>
                </a:ext>
              </a:extLst>
            </p:cNvPr>
            <p:cNvCxnSpPr>
              <a:cxnSpLocks/>
            </p:cNvCxnSpPr>
            <p:nvPr/>
          </p:nvCxnSpPr>
          <p:spPr>
            <a:xfrm>
              <a:off x="2619090" y="4289587"/>
              <a:ext cx="22357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" name="Connettore diritto 92">
              <a:extLst>
                <a:ext uri="{FF2B5EF4-FFF2-40B4-BE49-F238E27FC236}">
                  <a16:creationId xmlns:a16="http://schemas.microsoft.com/office/drawing/2014/main" id="{3C7E4B96-BBAB-4B48-9C66-DFF89688F1E3}"/>
                </a:ext>
              </a:extLst>
            </p:cNvPr>
            <p:cNvCxnSpPr>
              <a:cxnSpLocks/>
            </p:cNvCxnSpPr>
            <p:nvPr/>
          </p:nvCxnSpPr>
          <p:spPr>
            <a:xfrm>
              <a:off x="2938762" y="4289587"/>
              <a:ext cx="22357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Connettore diritto 93">
              <a:extLst>
                <a:ext uri="{FF2B5EF4-FFF2-40B4-BE49-F238E27FC236}">
                  <a16:creationId xmlns:a16="http://schemas.microsoft.com/office/drawing/2014/main" id="{A276E73B-0469-49E4-BDFF-9DEA1492D74B}"/>
                </a:ext>
              </a:extLst>
            </p:cNvPr>
            <p:cNvCxnSpPr>
              <a:cxnSpLocks/>
            </p:cNvCxnSpPr>
            <p:nvPr/>
          </p:nvCxnSpPr>
          <p:spPr>
            <a:xfrm>
              <a:off x="3240773" y="4289587"/>
              <a:ext cx="22357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Connettore diritto 94">
              <a:extLst>
                <a:ext uri="{FF2B5EF4-FFF2-40B4-BE49-F238E27FC236}">
                  <a16:creationId xmlns:a16="http://schemas.microsoft.com/office/drawing/2014/main" id="{835C1C3A-AE6A-48C9-B908-605A5EE83C44}"/>
                </a:ext>
              </a:extLst>
            </p:cNvPr>
            <p:cNvCxnSpPr>
              <a:cxnSpLocks/>
            </p:cNvCxnSpPr>
            <p:nvPr/>
          </p:nvCxnSpPr>
          <p:spPr>
            <a:xfrm>
              <a:off x="3533568" y="4289587"/>
              <a:ext cx="22357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" name="Connettore diritto 95">
              <a:extLst>
                <a:ext uri="{FF2B5EF4-FFF2-40B4-BE49-F238E27FC236}">
                  <a16:creationId xmlns:a16="http://schemas.microsoft.com/office/drawing/2014/main" id="{50EED91E-9483-41E3-BA3E-1CAF4B15268F}"/>
                </a:ext>
              </a:extLst>
            </p:cNvPr>
            <p:cNvCxnSpPr>
              <a:cxnSpLocks/>
            </p:cNvCxnSpPr>
            <p:nvPr/>
          </p:nvCxnSpPr>
          <p:spPr>
            <a:xfrm>
              <a:off x="3845259" y="4289587"/>
              <a:ext cx="22357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7" name="CasellaDiTesto 96">
              <a:extLst>
                <a:ext uri="{FF2B5EF4-FFF2-40B4-BE49-F238E27FC236}">
                  <a16:creationId xmlns:a16="http://schemas.microsoft.com/office/drawing/2014/main" id="{4DCA52F1-8929-43F4-9DBF-F642991E7AC7}"/>
                </a:ext>
              </a:extLst>
            </p:cNvPr>
            <p:cNvSpPr txBox="1"/>
            <p:nvPr/>
          </p:nvSpPr>
          <p:spPr>
            <a:xfrm>
              <a:off x="2856953" y="4079682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VE</a:t>
              </a:r>
            </a:p>
          </p:txBody>
        </p:sp>
        <p:sp>
          <p:nvSpPr>
            <p:cNvPr id="98" name="CasellaDiTesto 97">
              <a:extLst>
                <a:ext uri="{FF2B5EF4-FFF2-40B4-BE49-F238E27FC236}">
                  <a16:creationId xmlns:a16="http://schemas.microsoft.com/office/drawing/2014/main" id="{906A75C1-A3A5-4529-A246-4750123D92CD}"/>
                </a:ext>
              </a:extLst>
            </p:cNvPr>
            <p:cNvSpPr txBox="1"/>
            <p:nvPr/>
          </p:nvSpPr>
          <p:spPr>
            <a:xfrm>
              <a:off x="3165168" y="4079682"/>
              <a:ext cx="3626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KU</a:t>
              </a:r>
            </a:p>
          </p:txBody>
        </p:sp>
        <p:sp>
          <p:nvSpPr>
            <p:cNvPr id="99" name="CasellaDiTesto 98">
              <a:extLst>
                <a:ext uri="{FF2B5EF4-FFF2-40B4-BE49-F238E27FC236}">
                  <a16:creationId xmlns:a16="http://schemas.microsoft.com/office/drawing/2014/main" id="{C5817DE7-36A5-4C2F-A988-640F0EDE2984}"/>
                </a:ext>
              </a:extLst>
            </p:cNvPr>
            <p:cNvSpPr txBox="1"/>
            <p:nvPr/>
          </p:nvSpPr>
          <p:spPr>
            <a:xfrm>
              <a:off x="3466965" y="4079682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MK</a:t>
              </a:r>
            </a:p>
          </p:txBody>
        </p:sp>
        <p:sp>
          <p:nvSpPr>
            <p:cNvPr id="100" name="CasellaDiTesto 99">
              <a:extLst>
                <a:ext uri="{FF2B5EF4-FFF2-40B4-BE49-F238E27FC236}">
                  <a16:creationId xmlns:a16="http://schemas.microsoft.com/office/drawing/2014/main" id="{C627B271-F6AD-4BBC-BB2D-735B022DB8EF}"/>
                </a:ext>
              </a:extLst>
            </p:cNvPr>
            <p:cNvSpPr txBox="1"/>
            <p:nvPr/>
          </p:nvSpPr>
          <p:spPr>
            <a:xfrm>
              <a:off x="3731559" y="4079682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CCT</a:t>
              </a:r>
            </a:p>
          </p:txBody>
        </p:sp>
        <p:cxnSp>
          <p:nvCxnSpPr>
            <p:cNvPr id="101" name="Connettore diritto 100">
              <a:extLst>
                <a:ext uri="{FF2B5EF4-FFF2-40B4-BE49-F238E27FC236}">
                  <a16:creationId xmlns:a16="http://schemas.microsoft.com/office/drawing/2014/main" id="{D53E7E9B-58AC-410B-8277-561AD715F385}"/>
                </a:ext>
              </a:extLst>
            </p:cNvPr>
            <p:cNvCxnSpPr>
              <a:cxnSpLocks/>
            </p:cNvCxnSpPr>
            <p:nvPr/>
          </p:nvCxnSpPr>
          <p:spPr>
            <a:xfrm>
              <a:off x="2318786" y="4289587"/>
              <a:ext cx="22357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2" name="CasellaDiTesto 101">
              <a:extLst>
                <a:ext uri="{FF2B5EF4-FFF2-40B4-BE49-F238E27FC236}">
                  <a16:creationId xmlns:a16="http://schemas.microsoft.com/office/drawing/2014/main" id="{E7C23C89-4993-4960-9A0B-AD8A120AC538}"/>
                </a:ext>
              </a:extLst>
            </p:cNvPr>
            <p:cNvSpPr txBox="1"/>
            <p:nvPr/>
          </p:nvSpPr>
          <p:spPr>
            <a:xfrm>
              <a:off x="2196384" y="4079682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CT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017006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2620E1D6-1454-4D26-AB5B-F9DAAD59DD8D}"/>
              </a:ext>
            </a:extLst>
          </p:cNvPr>
          <p:cNvSpPr txBox="1"/>
          <p:nvPr/>
        </p:nvSpPr>
        <p:spPr>
          <a:xfrm>
            <a:off x="1970792" y="-6263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ure 5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CA1A5C8D-C184-42C9-B057-41BC9F75F5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80" y="611560"/>
            <a:ext cx="2226122" cy="18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40" name="Gruppo 39">
            <a:extLst>
              <a:ext uri="{FF2B5EF4-FFF2-40B4-BE49-F238E27FC236}">
                <a16:creationId xmlns:a16="http://schemas.microsoft.com/office/drawing/2014/main" id="{B3A815DF-90FD-4106-B7F7-B3E088192913}"/>
              </a:ext>
            </a:extLst>
          </p:cNvPr>
          <p:cNvGrpSpPr/>
          <p:nvPr/>
        </p:nvGrpSpPr>
        <p:grpSpPr>
          <a:xfrm>
            <a:off x="3919111" y="611560"/>
            <a:ext cx="2531019" cy="1744101"/>
            <a:chOff x="3919111" y="1043608"/>
            <a:chExt cx="2531019" cy="1744101"/>
          </a:xfrm>
        </p:grpSpPr>
        <p:pic>
          <p:nvPicPr>
            <p:cNvPr id="39" name="Immagine 38">
              <a:extLst>
                <a:ext uri="{FF2B5EF4-FFF2-40B4-BE49-F238E27FC236}">
                  <a16:creationId xmlns:a16="http://schemas.microsoft.com/office/drawing/2014/main" id="{1AE0E86B-534E-4663-B34A-282DB324287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01356" y="1296789"/>
              <a:ext cx="1150274" cy="1166400"/>
            </a:xfrm>
            <a:prstGeom prst="rect">
              <a:avLst/>
            </a:prstGeom>
          </p:spPr>
        </p:pic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AC32BF34-4A2B-4CAC-B508-AB881AB696A6}"/>
                </a:ext>
              </a:extLst>
            </p:cNvPr>
            <p:cNvSpPr txBox="1"/>
            <p:nvPr/>
          </p:nvSpPr>
          <p:spPr>
            <a:xfrm rot="16200000">
              <a:off x="3415948" y="1673203"/>
              <a:ext cx="140643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 err="1"/>
                <a:t>Number</a:t>
              </a:r>
              <a:r>
                <a:rPr lang="it-IT" sz="1000" dirty="0"/>
                <a:t> of </a:t>
              </a:r>
              <a:r>
                <a:rPr lang="it-IT" sz="1000" dirty="0" err="1"/>
                <a:t>cells</a:t>
              </a:r>
              <a:endParaRPr lang="it-IT" sz="1000" dirty="0"/>
            </a:p>
            <a:p>
              <a:pPr algn="ctr"/>
              <a:r>
                <a:rPr lang="it-IT" sz="1000" dirty="0"/>
                <a:t>(% on -)</a:t>
              </a:r>
              <a:endParaRPr lang="it-IT" sz="10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C2DFD476-1B04-4B0D-8604-309340F641BC}"/>
                </a:ext>
              </a:extLst>
            </p:cNvPr>
            <p:cNvSpPr txBox="1"/>
            <p:nvPr/>
          </p:nvSpPr>
          <p:spPr>
            <a:xfrm>
              <a:off x="4179849" y="173195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60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5E3AFFE8-8707-437D-A577-0C3C1A4BF48D}"/>
                </a:ext>
              </a:extLst>
            </p:cNvPr>
            <p:cNvSpPr txBox="1"/>
            <p:nvPr/>
          </p:nvSpPr>
          <p:spPr>
            <a:xfrm>
              <a:off x="4264807" y="226002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0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15FFB193-02DD-43F6-9E51-A83B80C75C27}"/>
                </a:ext>
              </a:extLst>
            </p:cNvPr>
            <p:cNvSpPr txBox="1"/>
            <p:nvPr/>
          </p:nvSpPr>
          <p:spPr>
            <a:xfrm>
              <a:off x="4094889" y="119002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120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6FB681EC-AFB4-4949-BC81-09691371C495}"/>
                </a:ext>
              </a:extLst>
            </p:cNvPr>
            <p:cNvSpPr txBox="1"/>
            <p:nvPr/>
          </p:nvSpPr>
          <p:spPr>
            <a:xfrm>
              <a:off x="4715618" y="1246566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**</a:t>
              </a:r>
            </a:p>
            <a:p>
              <a:r>
                <a:rPr lang="it-IT" sz="1000" dirty="0"/>
                <a:t>**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AF21877F-4AA4-4B97-96C3-BC941C500DD2}"/>
                </a:ext>
              </a:extLst>
            </p:cNvPr>
            <p:cNvSpPr txBox="1"/>
            <p:nvPr/>
          </p:nvSpPr>
          <p:spPr>
            <a:xfrm>
              <a:off x="4508964" y="2388476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E94C112D-20C1-4EF4-8F53-6FFD111584F5}"/>
                </a:ext>
              </a:extLst>
            </p:cNvPr>
            <p:cNvSpPr txBox="1"/>
            <p:nvPr/>
          </p:nvSpPr>
          <p:spPr>
            <a:xfrm>
              <a:off x="4735199" y="2388476"/>
              <a:ext cx="2504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+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2F691CB1-5519-4C88-9D1D-F73687E9AC17}"/>
                </a:ext>
              </a:extLst>
            </p:cNvPr>
            <p:cNvSpPr txBox="1"/>
            <p:nvPr/>
          </p:nvSpPr>
          <p:spPr>
            <a:xfrm>
              <a:off x="5468771" y="2388476"/>
              <a:ext cx="9813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GDC (100nM)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2841944A-49F4-4F1C-A10C-3694EE90AE03}"/>
                </a:ext>
              </a:extLst>
            </p:cNvPr>
            <p:cNvSpPr txBox="1"/>
            <p:nvPr/>
          </p:nvSpPr>
          <p:spPr>
            <a:xfrm>
              <a:off x="5007281" y="2388476"/>
              <a:ext cx="2504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E503D857-3F02-4078-AB50-AF6D8BEFE27D}"/>
                </a:ext>
              </a:extLst>
            </p:cNvPr>
            <p:cNvSpPr txBox="1"/>
            <p:nvPr/>
          </p:nvSpPr>
          <p:spPr>
            <a:xfrm>
              <a:off x="4509161" y="2541488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E580EFF8-78EA-4D0D-A07D-5D38191FB081}"/>
                </a:ext>
              </a:extLst>
            </p:cNvPr>
            <p:cNvSpPr txBox="1"/>
            <p:nvPr/>
          </p:nvSpPr>
          <p:spPr>
            <a:xfrm>
              <a:off x="4743615" y="2541488"/>
              <a:ext cx="2504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-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1EDAC9DD-BA99-460A-BAC8-05EE83531C45}"/>
                </a:ext>
              </a:extLst>
            </p:cNvPr>
            <p:cNvSpPr txBox="1"/>
            <p:nvPr/>
          </p:nvSpPr>
          <p:spPr>
            <a:xfrm>
              <a:off x="5244726" y="254148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+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6134BB26-F6BA-49DE-9485-8681EF4060E5}"/>
                </a:ext>
              </a:extLst>
            </p:cNvPr>
            <p:cNvSpPr txBox="1"/>
            <p:nvPr/>
          </p:nvSpPr>
          <p:spPr>
            <a:xfrm>
              <a:off x="5468771" y="2533705"/>
              <a:ext cx="7793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/>
                <a:t>Abe</a:t>
              </a:r>
              <a:r>
                <a:rPr lang="it-IT" sz="1000" dirty="0"/>
                <a:t> (1</a:t>
              </a:r>
              <a:r>
                <a:rPr lang="el-G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000" dirty="0"/>
                <a:t>M)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16F28CB5-68F6-4142-A3C0-640318D369B5}"/>
                </a:ext>
              </a:extLst>
            </p:cNvPr>
            <p:cNvSpPr txBox="1"/>
            <p:nvPr/>
          </p:nvSpPr>
          <p:spPr>
            <a:xfrm>
              <a:off x="4699520" y="1043608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Y537S</a:t>
              </a:r>
            </a:p>
          </p:txBody>
        </p:sp>
        <p:cxnSp>
          <p:nvCxnSpPr>
            <p:cNvPr id="22" name="Connettore diritto 21">
              <a:extLst>
                <a:ext uri="{FF2B5EF4-FFF2-40B4-BE49-F238E27FC236}">
                  <a16:creationId xmlns:a16="http://schemas.microsoft.com/office/drawing/2014/main" id="{718F1CAA-1BBC-4C5C-9D09-B0E3D20D225B}"/>
                </a:ext>
              </a:extLst>
            </p:cNvPr>
            <p:cNvCxnSpPr>
              <a:cxnSpLocks/>
            </p:cNvCxnSpPr>
            <p:nvPr/>
          </p:nvCxnSpPr>
          <p:spPr>
            <a:xfrm>
              <a:off x="4490898" y="1269158"/>
              <a:ext cx="98342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AD5BCE24-88A3-4C19-8AE8-EF012093483C}"/>
                </a:ext>
              </a:extLst>
            </p:cNvPr>
            <p:cNvSpPr txBox="1"/>
            <p:nvPr/>
          </p:nvSpPr>
          <p:spPr>
            <a:xfrm>
              <a:off x="4985571" y="2541488"/>
              <a:ext cx="227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+</a:t>
              </a: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E042FE6A-5DEC-44B9-BD9C-2C6EE47978BC}"/>
                </a:ext>
              </a:extLst>
            </p:cNvPr>
            <p:cNvSpPr txBox="1"/>
            <p:nvPr/>
          </p:nvSpPr>
          <p:spPr>
            <a:xfrm>
              <a:off x="5244156" y="2388476"/>
              <a:ext cx="2504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/>
                <a:t>+</a:t>
              </a: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DD191EFD-AE40-49D7-B3E9-C5081060AC27}"/>
                </a:ext>
              </a:extLst>
            </p:cNvPr>
            <p:cNvSpPr txBox="1"/>
            <p:nvPr/>
          </p:nvSpPr>
          <p:spPr>
            <a:xfrm>
              <a:off x="5219674" y="1246566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**</a:t>
              </a:r>
            </a:p>
            <a:p>
              <a:r>
                <a:rPr lang="it-IT" sz="1000" dirty="0"/>
                <a:t>**</a:t>
              </a: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FCF6AB08-AD95-497A-BE0B-F1CB61F3BA2F}"/>
                </a:ext>
              </a:extLst>
            </p:cNvPr>
            <p:cNvSpPr txBox="1"/>
            <p:nvPr/>
          </p:nvSpPr>
          <p:spPr>
            <a:xfrm>
              <a:off x="5238910" y="1692732"/>
              <a:ext cx="24558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°</a:t>
              </a:r>
            </a:p>
            <a:p>
              <a:r>
                <a:rPr lang="it-IT" sz="1000" dirty="0"/>
                <a:t>^</a:t>
              </a:r>
            </a:p>
          </p:txBody>
        </p:sp>
      </p:grp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E9740C14-700A-4A5E-AAC5-2F68D9BA59C5}"/>
              </a:ext>
            </a:extLst>
          </p:cNvPr>
          <p:cNvSpPr txBox="1"/>
          <p:nvPr/>
        </p:nvSpPr>
        <p:spPr>
          <a:xfrm>
            <a:off x="45479" y="26770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A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D60CA0BC-79E0-4AB9-BC7A-CDD96FE01E49}"/>
              </a:ext>
            </a:extLst>
          </p:cNvPr>
          <p:cNvSpPr txBox="1"/>
          <p:nvPr/>
        </p:nvSpPr>
        <p:spPr>
          <a:xfrm>
            <a:off x="3429000" y="251520"/>
            <a:ext cx="3321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A’</a:t>
            </a:r>
          </a:p>
        </p:txBody>
      </p:sp>
      <p:grpSp>
        <p:nvGrpSpPr>
          <p:cNvPr id="347" name="Gruppo 346">
            <a:extLst>
              <a:ext uri="{FF2B5EF4-FFF2-40B4-BE49-F238E27FC236}">
                <a16:creationId xmlns:a16="http://schemas.microsoft.com/office/drawing/2014/main" id="{DD634BF5-24BA-48AA-A0A8-FCE763180BE0}"/>
              </a:ext>
            </a:extLst>
          </p:cNvPr>
          <p:cNvGrpSpPr/>
          <p:nvPr/>
        </p:nvGrpSpPr>
        <p:grpSpPr>
          <a:xfrm>
            <a:off x="258958" y="2771800"/>
            <a:ext cx="2480910" cy="1818143"/>
            <a:chOff x="90344" y="2922251"/>
            <a:chExt cx="2480910" cy="1818143"/>
          </a:xfrm>
        </p:grpSpPr>
        <p:pic>
          <p:nvPicPr>
            <p:cNvPr id="348" name="Immagine 347">
              <a:extLst>
                <a:ext uri="{FF2B5EF4-FFF2-40B4-BE49-F238E27FC236}">
                  <a16:creationId xmlns:a16="http://schemas.microsoft.com/office/drawing/2014/main" id="{C980596B-8395-40A4-87AE-4408AED42C8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48048" y="3059832"/>
              <a:ext cx="2067523" cy="1440000"/>
            </a:xfrm>
            <a:prstGeom prst="rect">
              <a:avLst/>
            </a:prstGeom>
          </p:spPr>
        </p:pic>
        <p:sp>
          <p:nvSpPr>
            <p:cNvPr id="349" name="CasellaDiTesto 348">
              <a:extLst>
                <a:ext uri="{FF2B5EF4-FFF2-40B4-BE49-F238E27FC236}">
                  <a16:creationId xmlns:a16="http://schemas.microsoft.com/office/drawing/2014/main" id="{05456DD7-FF2E-40C1-B26D-2AD111FE79CF}"/>
                </a:ext>
              </a:extLst>
            </p:cNvPr>
            <p:cNvSpPr txBox="1"/>
            <p:nvPr/>
          </p:nvSpPr>
          <p:spPr>
            <a:xfrm rot="16200000">
              <a:off x="-474374" y="3631763"/>
              <a:ext cx="1406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600" dirty="0" err="1"/>
                <a:t>Number</a:t>
              </a:r>
              <a:r>
                <a:rPr lang="it-IT" sz="600" dirty="0"/>
                <a:t> of </a:t>
              </a:r>
              <a:r>
                <a:rPr lang="it-IT" sz="600" dirty="0" err="1"/>
                <a:t>cells</a:t>
              </a:r>
              <a:endParaRPr lang="it-IT" sz="600" dirty="0"/>
            </a:p>
            <a:p>
              <a:pPr algn="ctr"/>
              <a:r>
                <a:rPr lang="it-IT" sz="600" dirty="0"/>
                <a:t>(% on -)</a:t>
              </a:r>
              <a:endParaRPr lang="it-IT" sz="6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350" name="CasellaDiTesto 349">
              <a:extLst>
                <a:ext uri="{FF2B5EF4-FFF2-40B4-BE49-F238E27FC236}">
                  <a16:creationId xmlns:a16="http://schemas.microsoft.com/office/drawing/2014/main" id="{F3F24C0A-F54A-4D1E-8E50-1C1469FF763F}"/>
                </a:ext>
              </a:extLst>
            </p:cNvPr>
            <p:cNvSpPr txBox="1"/>
            <p:nvPr/>
          </p:nvSpPr>
          <p:spPr>
            <a:xfrm>
              <a:off x="230903" y="3664180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sp>
          <p:nvSpPr>
            <p:cNvPr id="351" name="CasellaDiTesto 350">
              <a:extLst>
                <a:ext uri="{FF2B5EF4-FFF2-40B4-BE49-F238E27FC236}">
                  <a16:creationId xmlns:a16="http://schemas.microsoft.com/office/drawing/2014/main" id="{42327D69-62B2-4400-A0B3-C68EB812B655}"/>
                </a:ext>
              </a:extLst>
            </p:cNvPr>
            <p:cNvSpPr txBox="1"/>
            <p:nvPr/>
          </p:nvSpPr>
          <p:spPr>
            <a:xfrm>
              <a:off x="317465" y="4328496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</a:t>
              </a:r>
            </a:p>
          </p:txBody>
        </p:sp>
        <p:sp>
          <p:nvSpPr>
            <p:cNvPr id="352" name="CasellaDiTesto 351">
              <a:extLst>
                <a:ext uri="{FF2B5EF4-FFF2-40B4-BE49-F238E27FC236}">
                  <a16:creationId xmlns:a16="http://schemas.microsoft.com/office/drawing/2014/main" id="{67964EC0-EBD9-404F-8203-49A04C1896C3}"/>
                </a:ext>
              </a:extLst>
            </p:cNvPr>
            <p:cNvSpPr txBox="1"/>
            <p:nvPr/>
          </p:nvSpPr>
          <p:spPr>
            <a:xfrm>
              <a:off x="230903" y="2998550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00</a:t>
              </a:r>
            </a:p>
          </p:txBody>
        </p:sp>
        <p:sp>
          <p:nvSpPr>
            <p:cNvPr id="353" name="CasellaDiTesto 352">
              <a:extLst>
                <a:ext uri="{FF2B5EF4-FFF2-40B4-BE49-F238E27FC236}">
                  <a16:creationId xmlns:a16="http://schemas.microsoft.com/office/drawing/2014/main" id="{377E2D4A-C10E-4110-8175-4368CD6BECB0}"/>
                </a:ext>
              </a:extLst>
            </p:cNvPr>
            <p:cNvSpPr txBox="1"/>
            <p:nvPr/>
          </p:nvSpPr>
          <p:spPr>
            <a:xfrm>
              <a:off x="453373" y="4427984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354" name="Gruppo 353">
              <a:extLst>
                <a:ext uri="{FF2B5EF4-FFF2-40B4-BE49-F238E27FC236}">
                  <a16:creationId xmlns:a16="http://schemas.microsoft.com/office/drawing/2014/main" id="{73D6D072-6ACE-494B-8782-0F1C1CC6BE38}"/>
                </a:ext>
              </a:extLst>
            </p:cNvPr>
            <p:cNvGrpSpPr/>
            <p:nvPr/>
          </p:nvGrpSpPr>
          <p:grpSpPr>
            <a:xfrm>
              <a:off x="504190" y="4427984"/>
              <a:ext cx="498353" cy="184666"/>
              <a:chOff x="504190" y="4467019"/>
              <a:chExt cx="498353" cy="184666"/>
            </a:xfrm>
          </p:grpSpPr>
          <p:sp>
            <p:nvSpPr>
              <p:cNvPr id="391" name="CasellaDiTesto 390">
                <a:extLst>
                  <a:ext uri="{FF2B5EF4-FFF2-40B4-BE49-F238E27FC236}">
                    <a16:creationId xmlns:a16="http://schemas.microsoft.com/office/drawing/2014/main" id="{E4265CB9-9900-405A-8208-C1059DAFA61B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392" name="CasellaDiTesto 391">
                <a:extLst>
                  <a:ext uri="{FF2B5EF4-FFF2-40B4-BE49-F238E27FC236}">
                    <a16:creationId xmlns:a16="http://schemas.microsoft.com/office/drawing/2014/main" id="{FE331C7E-E7C3-4D60-860E-D7BFE2335FB5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393" name="CasellaDiTesto 392">
                <a:extLst>
                  <a:ext uri="{FF2B5EF4-FFF2-40B4-BE49-F238E27FC236}">
                    <a16:creationId xmlns:a16="http://schemas.microsoft.com/office/drawing/2014/main" id="{0A943136-5BD3-4E2F-BE3E-D6510E407C35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394" name="CasellaDiTesto 393">
                <a:extLst>
                  <a:ext uri="{FF2B5EF4-FFF2-40B4-BE49-F238E27FC236}">
                    <a16:creationId xmlns:a16="http://schemas.microsoft.com/office/drawing/2014/main" id="{16CA4D0E-1E9B-435E-897D-BC908BE06FD7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355" name="CasellaDiTesto 354">
              <a:extLst>
                <a:ext uri="{FF2B5EF4-FFF2-40B4-BE49-F238E27FC236}">
                  <a16:creationId xmlns:a16="http://schemas.microsoft.com/office/drawing/2014/main" id="{67990255-F6F0-46E2-A99B-31FD84B2A916}"/>
                </a:ext>
              </a:extLst>
            </p:cNvPr>
            <p:cNvSpPr txBox="1"/>
            <p:nvPr/>
          </p:nvSpPr>
          <p:spPr>
            <a:xfrm>
              <a:off x="850906" y="4427984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356" name="Gruppo 355">
              <a:extLst>
                <a:ext uri="{FF2B5EF4-FFF2-40B4-BE49-F238E27FC236}">
                  <a16:creationId xmlns:a16="http://schemas.microsoft.com/office/drawing/2014/main" id="{9F93ABF3-EEB4-4D29-8E53-B50B66F3E00C}"/>
                </a:ext>
              </a:extLst>
            </p:cNvPr>
            <p:cNvGrpSpPr/>
            <p:nvPr/>
          </p:nvGrpSpPr>
          <p:grpSpPr>
            <a:xfrm>
              <a:off x="901723" y="4427984"/>
              <a:ext cx="498353" cy="184666"/>
              <a:chOff x="504190" y="4467019"/>
              <a:chExt cx="498353" cy="184666"/>
            </a:xfrm>
          </p:grpSpPr>
          <p:sp>
            <p:nvSpPr>
              <p:cNvPr id="387" name="CasellaDiTesto 386">
                <a:extLst>
                  <a:ext uri="{FF2B5EF4-FFF2-40B4-BE49-F238E27FC236}">
                    <a16:creationId xmlns:a16="http://schemas.microsoft.com/office/drawing/2014/main" id="{C042993D-C665-491C-B33F-935847197EBB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388" name="CasellaDiTesto 387">
                <a:extLst>
                  <a:ext uri="{FF2B5EF4-FFF2-40B4-BE49-F238E27FC236}">
                    <a16:creationId xmlns:a16="http://schemas.microsoft.com/office/drawing/2014/main" id="{CCEACE2E-F024-4D36-8581-9EF983241D9C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389" name="CasellaDiTesto 388">
                <a:extLst>
                  <a:ext uri="{FF2B5EF4-FFF2-40B4-BE49-F238E27FC236}">
                    <a16:creationId xmlns:a16="http://schemas.microsoft.com/office/drawing/2014/main" id="{FA5CB010-9BBA-489E-AE9E-2F83D692F4F9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390" name="CasellaDiTesto 389">
                <a:extLst>
                  <a:ext uri="{FF2B5EF4-FFF2-40B4-BE49-F238E27FC236}">
                    <a16:creationId xmlns:a16="http://schemas.microsoft.com/office/drawing/2014/main" id="{2DFCA5E5-13F0-4CBE-84CE-570D2CADB7AF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357" name="CasellaDiTesto 356">
              <a:extLst>
                <a:ext uri="{FF2B5EF4-FFF2-40B4-BE49-F238E27FC236}">
                  <a16:creationId xmlns:a16="http://schemas.microsoft.com/office/drawing/2014/main" id="{9CFD502C-816D-47C9-89E8-49299BB7FF32}"/>
                </a:ext>
              </a:extLst>
            </p:cNvPr>
            <p:cNvSpPr txBox="1"/>
            <p:nvPr/>
          </p:nvSpPr>
          <p:spPr>
            <a:xfrm>
              <a:off x="1242696" y="4427984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358" name="Gruppo 357">
              <a:extLst>
                <a:ext uri="{FF2B5EF4-FFF2-40B4-BE49-F238E27FC236}">
                  <a16:creationId xmlns:a16="http://schemas.microsoft.com/office/drawing/2014/main" id="{C41A578D-09C8-41EF-812D-3E2C05161813}"/>
                </a:ext>
              </a:extLst>
            </p:cNvPr>
            <p:cNvGrpSpPr/>
            <p:nvPr/>
          </p:nvGrpSpPr>
          <p:grpSpPr>
            <a:xfrm>
              <a:off x="1293513" y="4427984"/>
              <a:ext cx="498353" cy="184666"/>
              <a:chOff x="504190" y="4467019"/>
              <a:chExt cx="498353" cy="184666"/>
            </a:xfrm>
          </p:grpSpPr>
          <p:sp>
            <p:nvSpPr>
              <p:cNvPr id="383" name="CasellaDiTesto 382">
                <a:extLst>
                  <a:ext uri="{FF2B5EF4-FFF2-40B4-BE49-F238E27FC236}">
                    <a16:creationId xmlns:a16="http://schemas.microsoft.com/office/drawing/2014/main" id="{8426A3EB-F527-4BEC-9066-D554B410DC8E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384" name="CasellaDiTesto 383">
                <a:extLst>
                  <a:ext uri="{FF2B5EF4-FFF2-40B4-BE49-F238E27FC236}">
                    <a16:creationId xmlns:a16="http://schemas.microsoft.com/office/drawing/2014/main" id="{EC2E6E40-D346-4F63-A556-085C0C054E27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385" name="CasellaDiTesto 384">
                <a:extLst>
                  <a:ext uri="{FF2B5EF4-FFF2-40B4-BE49-F238E27FC236}">
                    <a16:creationId xmlns:a16="http://schemas.microsoft.com/office/drawing/2014/main" id="{6929F54C-0C32-4DF9-A39D-F896CC05CCB4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386" name="CasellaDiTesto 385">
                <a:extLst>
                  <a:ext uri="{FF2B5EF4-FFF2-40B4-BE49-F238E27FC236}">
                    <a16:creationId xmlns:a16="http://schemas.microsoft.com/office/drawing/2014/main" id="{9D2C446F-7C01-495C-A71C-E7AE6A9C921C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359" name="CasellaDiTesto 358">
              <a:extLst>
                <a:ext uri="{FF2B5EF4-FFF2-40B4-BE49-F238E27FC236}">
                  <a16:creationId xmlns:a16="http://schemas.microsoft.com/office/drawing/2014/main" id="{DF938601-0425-4A5C-9AB0-35FF6CC115C3}"/>
                </a:ext>
              </a:extLst>
            </p:cNvPr>
            <p:cNvSpPr txBox="1"/>
            <p:nvPr/>
          </p:nvSpPr>
          <p:spPr>
            <a:xfrm>
              <a:off x="1636644" y="4427984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360" name="Gruppo 359">
              <a:extLst>
                <a:ext uri="{FF2B5EF4-FFF2-40B4-BE49-F238E27FC236}">
                  <a16:creationId xmlns:a16="http://schemas.microsoft.com/office/drawing/2014/main" id="{08AE25C5-9AD8-40A5-83B1-064CE94463ED}"/>
                </a:ext>
              </a:extLst>
            </p:cNvPr>
            <p:cNvGrpSpPr/>
            <p:nvPr/>
          </p:nvGrpSpPr>
          <p:grpSpPr>
            <a:xfrm>
              <a:off x="1687461" y="4427984"/>
              <a:ext cx="498353" cy="184666"/>
              <a:chOff x="504190" y="4467019"/>
              <a:chExt cx="498353" cy="184666"/>
            </a:xfrm>
          </p:grpSpPr>
          <p:sp>
            <p:nvSpPr>
              <p:cNvPr id="379" name="CasellaDiTesto 378">
                <a:extLst>
                  <a:ext uri="{FF2B5EF4-FFF2-40B4-BE49-F238E27FC236}">
                    <a16:creationId xmlns:a16="http://schemas.microsoft.com/office/drawing/2014/main" id="{67884001-E9B1-4068-A1D6-99591AB500C6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380" name="CasellaDiTesto 379">
                <a:extLst>
                  <a:ext uri="{FF2B5EF4-FFF2-40B4-BE49-F238E27FC236}">
                    <a16:creationId xmlns:a16="http://schemas.microsoft.com/office/drawing/2014/main" id="{7DDACA2C-5D4E-4A77-9E0B-8FD99C7126A9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381" name="CasellaDiTesto 380">
                <a:extLst>
                  <a:ext uri="{FF2B5EF4-FFF2-40B4-BE49-F238E27FC236}">
                    <a16:creationId xmlns:a16="http://schemas.microsoft.com/office/drawing/2014/main" id="{3ABF8424-A677-4376-93D4-ED3D12B02B42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382" name="CasellaDiTesto 381">
                <a:extLst>
                  <a:ext uri="{FF2B5EF4-FFF2-40B4-BE49-F238E27FC236}">
                    <a16:creationId xmlns:a16="http://schemas.microsoft.com/office/drawing/2014/main" id="{255CCA5D-2D33-4CAF-A947-2C2FC00FEDD7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361" name="CasellaDiTesto 360">
              <a:extLst>
                <a:ext uri="{FF2B5EF4-FFF2-40B4-BE49-F238E27FC236}">
                  <a16:creationId xmlns:a16="http://schemas.microsoft.com/office/drawing/2014/main" id="{77714E3E-6FE7-40A1-8E5C-D7B802E07319}"/>
                </a:ext>
              </a:extLst>
            </p:cNvPr>
            <p:cNvSpPr txBox="1"/>
            <p:nvPr/>
          </p:nvSpPr>
          <p:spPr>
            <a:xfrm>
              <a:off x="2022084" y="4427984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362" name="CasellaDiTesto 361">
              <a:extLst>
                <a:ext uri="{FF2B5EF4-FFF2-40B4-BE49-F238E27FC236}">
                  <a16:creationId xmlns:a16="http://schemas.microsoft.com/office/drawing/2014/main" id="{A87B797C-750A-47AD-BC75-3C4BC919DAC1}"/>
                </a:ext>
              </a:extLst>
            </p:cNvPr>
            <p:cNvSpPr txBox="1"/>
            <p:nvPr/>
          </p:nvSpPr>
          <p:spPr>
            <a:xfrm>
              <a:off x="2072901" y="4427984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9</a:t>
              </a:r>
              <a:endParaRPr lang="it-IT" sz="600" dirty="0"/>
            </a:p>
          </p:txBody>
        </p:sp>
        <p:sp>
          <p:nvSpPr>
            <p:cNvPr id="363" name="CasellaDiTesto 362">
              <a:extLst>
                <a:ext uri="{FF2B5EF4-FFF2-40B4-BE49-F238E27FC236}">
                  <a16:creationId xmlns:a16="http://schemas.microsoft.com/office/drawing/2014/main" id="{96825A2A-5E60-4878-BA5E-77C2A5F45F02}"/>
                </a:ext>
              </a:extLst>
            </p:cNvPr>
            <p:cNvSpPr txBox="1"/>
            <p:nvPr/>
          </p:nvSpPr>
          <p:spPr>
            <a:xfrm>
              <a:off x="2159592" y="4427984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8</a:t>
              </a:r>
              <a:endParaRPr lang="it-IT" sz="600" dirty="0"/>
            </a:p>
          </p:txBody>
        </p:sp>
        <p:sp>
          <p:nvSpPr>
            <p:cNvPr id="364" name="CasellaDiTesto 363">
              <a:extLst>
                <a:ext uri="{FF2B5EF4-FFF2-40B4-BE49-F238E27FC236}">
                  <a16:creationId xmlns:a16="http://schemas.microsoft.com/office/drawing/2014/main" id="{B88F0745-1C81-4149-8DED-6A86727ACDB6}"/>
                </a:ext>
              </a:extLst>
            </p:cNvPr>
            <p:cNvSpPr txBox="1"/>
            <p:nvPr/>
          </p:nvSpPr>
          <p:spPr>
            <a:xfrm>
              <a:off x="2247791" y="4427984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7</a:t>
              </a:r>
              <a:endParaRPr lang="it-IT" sz="600" dirty="0"/>
            </a:p>
          </p:txBody>
        </p:sp>
        <p:sp>
          <p:nvSpPr>
            <p:cNvPr id="365" name="CasellaDiTesto 364">
              <a:extLst>
                <a:ext uri="{FF2B5EF4-FFF2-40B4-BE49-F238E27FC236}">
                  <a16:creationId xmlns:a16="http://schemas.microsoft.com/office/drawing/2014/main" id="{F14CBC46-BC99-406A-9D3C-91929552A739}"/>
                </a:ext>
              </a:extLst>
            </p:cNvPr>
            <p:cNvSpPr txBox="1"/>
            <p:nvPr/>
          </p:nvSpPr>
          <p:spPr>
            <a:xfrm>
              <a:off x="2317658" y="4427984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6</a:t>
              </a:r>
              <a:endParaRPr lang="it-IT" sz="600" dirty="0"/>
            </a:p>
          </p:txBody>
        </p:sp>
        <p:sp>
          <p:nvSpPr>
            <p:cNvPr id="366" name="CasellaDiTesto 365">
              <a:extLst>
                <a:ext uri="{FF2B5EF4-FFF2-40B4-BE49-F238E27FC236}">
                  <a16:creationId xmlns:a16="http://schemas.microsoft.com/office/drawing/2014/main" id="{C923BE19-60F7-4248-A3A8-846D86BB00D2}"/>
                </a:ext>
              </a:extLst>
            </p:cNvPr>
            <p:cNvSpPr txBox="1"/>
            <p:nvPr/>
          </p:nvSpPr>
          <p:spPr>
            <a:xfrm>
              <a:off x="1173846" y="4555728"/>
              <a:ext cx="6671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Log [Tam] (M)</a:t>
              </a:r>
            </a:p>
          </p:txBody>
        </p:sp>
        <p:cxnSp>
          <p:nvCxnSpPr>
            <p:cNvPr id="367" name="Connettore diritto 366">
              <a:extLst>
                <a:ext uri="{FF2B5EF4-FFF2-40B4-BE49-F238E27FC236}">
                  <a16:creationId xmlns:a16="http://schemas.microsoft.com/office/drawing/2014/main" id="{A3D4E4BA-C029-4B80-9209-410AA5FEF6A2}"/>
                </a:ext>
              </a:extLst>
            </p:cNvPr>
            <p:cNvCxnSpPr>
              <a:cxnSpLocks/>
            </p:cNvCxnSpPr>
            <p:nvPr/>
          </p:nvCxnSpPr>
          <p:spPr>
            <a:xfrm>
              <a:off x="510580" y="4591050"/>
              <a:ext cx="19527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8" name="Connettore diritto 367">
              <a:extLst>
                <a:ext uri="{FF2B5EF4-FFF2-40B4-BE49-F238E27FC236}">
                  <a16:creationId xmlns:a16="http://schemas.microsoft.com/office/drawing/2014/main" id="{D8667110-6B9F-42D4-A837-B7ECC5C03BF4}"/>
                </a:ext>
              </a:extLst>
            </p:cNvPr>
            <p:cNvCxnSpPr/>
            <p:nvPr/>
          </p:nvCxnSpPr>
          <p:spPr>
            <a:xfrm>
              <a:off x="926326" y="3275856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9" name="Connettore diritto 368">
              <a:extLst>
                <a:ext uri="{FF2B5EF4-FFF2-40B4-BE49-F238E27FC236}">
                  <a16:creationId xmlns:a16="http://schemas.microsoft.com/office/drawing/2014/main" id="{33B461B4-81B1-4383-8964-5FBD586CD9A4}"/>
                </a:ext>
              </a:extLst>
            </p:cNvPr>
            <p:cNvCxnSpPr/>
            <p:nvPr/>
          </p:nvCxnSpPr>
          <p:spPr>
            <a:xfrm>
              <a:off x="1324096" y="3275856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0" name="Connettore diritto 369">
              <a:extLst>
                <a:ext uri="{FF2B5EF4-FFF2-40B4-BE49-F238E27FC236}">
                  <a16:creationId xmlns:a16="http://schemas.microsoft.com/office/drawing/2014/main" id="{51F64FD9-B534-4CEF-9782-CEE781AA92B5}"/>
                </a:ext>
              </a:extLst>
            </p:cNvPr>
            <p:cNvCxnSpPr/>
            <p:nvPr/>
          </p:nvCxnSpPr>
          <p:spPr>
            <a:xfrm>
              <a:off x="1735733" y="3275856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1" name="Connettore diritto 370">
              <a:extLst>
                <a:ext uri="{FF2B5EF4-FFF2-40B4-BE49-F238E27FC236}">
                  <a16:creationId xmlns:a16="http://schemas.microsoft.com/office/drawing/2014/main" id="{96D09F37-E805-4B1D-9223-3B1EF23CCE2C}"/>
                </a:ext>
              </a:extLst>
            </p:cNvPr>
            <p:cNvCxnSpPr/>
            <p:nvPr/>
          </p:nvCxnSpPr>
          <p:spPr>
            <a:xfrm>
              <a:off x="2132059" y="3275856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72" name="CasellaDiTesto 371">
              <a:extLst>
                <a:ext uri="{FF2B5EF4-FFF2-40B4-BE49-F238E27FC236}">
                  <a16:creationId xmlns:a16="http://schemas.microsoft.com/office/drawing/2014/main" id="{8DD02093-64AD-45DA-82C4-32D2D8B529C1}"/>
                </a:ext>
              </a:extLst>
            </p:cNvPr>
            <p:cNvSpPr txBox="1"/>
            <p:nvPr/>
          </p:nvSpPr>
          <p:spPr>
            <a:xfrm>
              <a:off x="989346" y="3111201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</a:t>
              </a:r>
            </a:p>
          </p:txBody>
        </p:sp>
        <p:sp>
          <p:nvSpPr>
            <p:cNvPr id="373" name="CasellaDiTesto 372">
              <a:extLst>
                <a:ext uri="{FF2B5EF4-FFF2-40B4-BE49-F238E27FC236}">
                  <a16:creationId xmlns:a16="http://schemas.microsoft.com/office/drawing/2014/main" id="{0E925B84-4F8D-45BF-8B5C-F294F7E93425}"/>
                </a:ext>
              </a:extLst>
            </p:cNvPr>
            <p:cNvSpPr txBox="1"/>
            <p:nvPr/>
          </p:nvSpPr>
          <p:spPr>
            <a:xfrm>
              <a:off x="1328844" y="3111201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</a:t>
              </a:r>
            </a:p>
          </p:txBody>
        </p:sp>
        <p:sp>
          <p:nvSpPr>
            <p:cNvPr id="374" name="CasellaDiTesto 373">
              <a:extLst>
                <a:ext uri="{FF2B5EF4-FFF2-40B4-BE49-F238E27FC236}">
                  <a16:creationId xmlns:a16="http://schemas.microsoft.com/office/drawing/2014/main" id="{6F5744F3-B76B-4D1E-A770-3CEA27618FA5}"/>
                </a:ext>
              </a:extLst>
            </p:cNvPr>
            <p:cNvSpPr txBox="1"/>
            <p:nvPr/>
          </p:nvSpPr>
          <p:spPr>
            <a:xfrm>
              <a:off x="1761485" y="3111201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sp>
          <p:nvSpPr>
            <p:cNvPr id="375" name="CasellaDiTesto 374">
              <a:extLst>
                <a:ext uri="{FF2B5EF4-FFF2-40B4-BE49-F238E27FC236}">
                  <a16:creationId xmlns:a16="http://schemas.microsoft.com/office/drawing/2014/main" id="{7219AB95-FA25-415B-9AF8-A038CA098491}"/>
                </a:ext>
              </a:extLst>
            </p:cNvPr>
            <p:cNvSpPr txBox="1"/>
            <p:nvPr/>
          </p:nvSpPr>
          <p:spPr>
            <a:xfrm>
              <a:off x="2133582" y="3111201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0</a:t>
              </a:r>
            </a:p>
          </p:txBody>
        </p:sp>
        <p:cxnSp>
          <p:nvCxnSpPr>
            <p:cNvPr id="376" name="Connettore diritto 375">
              <a:extLst>
                <a:ext uri="{FF2B5EF4-FFF2-40B4-BE49-F238E27FC236}">
                  <a16:creationId xmlns:a16="http://schemas.microsoft.com/office/drawing/2014/main" id="{27260A3C-2D65-4A7F-8CA1-93B777791039}"/>
                </a:ext>
              </a:extLst>
            </p:cNvPr>
            <p:cNvCxnSpPr>
              <a:cxnSpLocks/>
            </p:cNvCxnSpPr>
            <p:nvPr/>
          </p:nvCxnSpPr>
          <p:spPr>
            <a:xfrm>
              <a:off x="1103320" y="3111201"/>
              <a:ext cx="120915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77" name="CasellaDiTesto 376">
              <a:extLst>
                <a:ext uri="{FF2B5EF4-FFF2-40B4-BE49-F238E27FC236}">
                  <a16:creationId xmlns:a16="http://schemas.microsoft.com/office/drawing/2014/main" id="{D8B99B10-3512-4358-A15E-26BD34C1F210}"/>
                </a:ext>
              </a:extLst>
            </p:cNvPr>
            <p:cNvSpPr txBox="1"/>
            <p:nvPr/>
          </p:nvSpPr>
          <p:spPr>
            <a:xfrm>
              <a:off x="1447250" y="2922251"/>
              <a:ext cx="52129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[MK] (</a:t>
              </a:r>
              <a:r>
                <a:rPr lang="it-IT" sz="600" dirty="0" err="1"/>
                <a:t>nM</a:t>
              </a:r>
              <a:r>
                <a:rPr lang="it-IT" sz="600" dirty="0"/>
                <a:t>)</a:t>
              </a:r>
            </a:p>
          </p:txBody>
        </p:sp>
        <p:sp>
          <p:nvSpPr>
            <p:cNvPr id="378" name="CasellaDiTesto 377">
              <a:extLst>
                <a:ext uri="{FF2B5EF4-FFF2-40B4-BE49-F238E27FC236}">
                  <a16:creationId xmlns:a16="http://schemas.microsoft.com/office/drawing/2014/main" id="{04382456-F3C0-4BD5-89D0-07536F9573AD}"/>
                </a:ext>
              </a:extLst>
            </p:cNvPr>
            <p:cNvSpPr txBox="1"/>
            <p:nvPr/>
          </p:nvSpPr>
          <p:spPr>
            <a:xfrm>
              <a:off x="474181" y="4227794"/>
              <a:ext cx="4203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/>
                <a:t>MCF-7</a:t>
              </a:r>
              <a:endParaRPr lang="it-IT" sz="600" b="1" dirty="0"/>
            </a:p>
          </p:txBody>
        </p:sp>
      </p:grpSp>
      <p:sp>
        <p:nvSpPr>
          <p:cNvPr id="397" name="CasellaDiTesto 396">
            <a:extLst>
              <a:ext uri="{FF2B5EF4-FFF2-40B4-BE49-F238E27FC236}">
                <a16:creationId xmlns:a16="http://schemas.microsoft.com/office/drawing/2014/main" id="{182C66D8-0E0D-4763-980E-888A9A933DBF}"/>
              </a:ext>
            </a:extLst>
          </p:cNvPr>
          <p:cNvSpPr txBox="1"/>
          <p:nvPr/>
        </p:nvSpPr>
        <p:spPr>
          <a:xfrm rot="16200000">
            <a:off x="3119676" y="3481312"/>
            <a:ext cx="14064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600" dirty="0" err="1"/>
              <a:t>Number</a:t>
            </a:r>
            <a:r>
              <a:rPr lang="it-IT" sz="600" dirty="0"/>
              <a:t> of </a:t>
            </a:r>
            <a:r>
              <a:rPr lang="it-IT" sz="600" dirty="0" err="1"/>
              <a:t>cells</a:t>
            </a:r>
            <a:endParaRPr lang="it-IT" sz="600" dirty="0"/>
          </a:p>
          <a:p>
            <a:pPr algn="ctr"/>
            <a:r>
              <a:rPr lang="it-IT" sz="600" dirty="0"/>
              <a:t>(% on -)</a:t>
            </a:r>
            <a:endParaRPr lang="it-IT" sz="600" dirty="0">
              <a:latin typeface="+mn-lt"/>
              <a:cs typeface="Times New Roman" panose="02020603050405020304" pitchFamily="18" charset="0"/>
            </a:endParaRPr>
          </a:p>
        </p:txBody>
      </p:sp>
      <p:grpSp>
        <p:nvGrpSpPr>
          <p:cNvPr id="643" name="Gruppo 642">
            <a:extLst>
              <a:ext uri="{FF2B5EF4-FFF2-40B4-BE49-F238E27FC236}">
                <a16:creationId xmlns:a16="http://schemas.microsoft.com/office/drawing/2014/main" id="{577AE676-C9F6-4523-AF10-F056AD35324F}"/>
              </a:ext>
            </a:extLst>
          </p:cNvPr>
          <p:cNvGrpSpPr/>
          <p:nvPr/>
        </p:nvGrpSpPr>
        <p:grpSpPr>
          <a:xfrm>
            <a:off x="3824953" y="2771800"/>
            <a:ext cx="2340351" cy="1818143"/>
            <a:chOff x="3824953" y="2771800"/>
            <a:chExt cx="2340351" cy="1818143"/>
          </a:xfrm>
        </p:grpSpPr>
        <p:pic>
          <p:nvPicPr>
            <p:cNvPr id="642" name="Immagine 641">
              <a:extLst>
                <a:ext uri="{FF2B5EF4-FFF2-40B4-BE49-F238E27FC236}">
                  <a16:creationId xmlns:a16="http://schemas.microsoft.com/office/drawing/2014/main" id="{18E420A0-498C-46A8-8C78-97AA3EE1DF5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42098" y="2909381"/>
              <a:ext cx="2103070" cy="1440000"/>
            </a:xfrm>
            <a:prstGeom prst="rect">
              <a:avLst/>
            </a:prstGeom>
          </p:spPr>
        </p:pic>
        <p:sp>
          <p:nvSpPr>
            <p:cNvPr id="398" name="CasellaDiTesto 397">
              <a:extLst>
                <a:ext uri="{FF2B5EF4-FFF2-40B4-BE49-F238E27FC236}">
                  <a16:creationId xmlns:a16="http://schemas.microsoft.com/office/drawing/2014/main" id="{67FBDF8A-1512-49A7-8DD1-37BADDFE8FB7}"/>
                </a:ext>
              </a:extLst>
            </p:cNvPr>
            <p:cNvSpPr txBox="1"/>
            <p:nvPr/>
          </p:nvSpPr>
          <p:spPr>
            <a:xfrm>
              <a:off x="3824953" y="3513729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sp>
          <p:nvSpPr>
            <p:cNvPr id="399" name="CasellaDiTesto 398">
              <a:extLst>
                <a:ext uri="{FF2B5EF4-FFF2-40B4-BE49-F238E27FC236}">
                  <a16:creationId xmlns:a16="http://schemas.microsoft.com/office/drawing/2014/main" id="{6EC1B413-FFFA-4FB6-B983-FA6E88DAEB7B}"/>
                </a:ext>
              </a:extLst>
            </p:cNvPr>
            <p:cNvSpPr txBox="1"/>
            <p:nvPr/>
          </p:nvSpPr>
          <p:spPr>
            <a:xfrm>
              <a:off x="3911515" y="4178045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</a:t>
              </a:r>
            </a:p>
          </p:txBody>
        </p:sp>
        <p:sp>
          <p:nvSpPr>
            <p:cNvPr id="400" name="CasellaDiTesto 399">
              <a:extLst>
                <a:ext uri="{FF2B5EF4-FFF2-40B4-BE49-F238E27FC236}">
                  <a16:creationId xmlns:a16="http://schemas.microsoft.com/office/drawing/2014/main" id="{FF1F8688-C1C1-4E7E-9EA3-41D92E3D3FE5}"/>
                </a:ext>
              </a:extLst>
            </p:cNvPr>
            <p:cNvSpPr txBox="1"/>
            <p:nvPr/>
          </p:nvSpPr>
          <p:spPr>
            <a:xfrm>
              <a:off x="3824953" y="2848099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00</a:t>
              </a:r>
            </a:p>
          </p:txBody>
        </p:sp>
        <p:sp>
          <p:nvSpPr>
            <p:cNvPr id="401" name="CasellaDiTesto 400">
              <a:extLst>
                <a:ext uri="{FF2B5EF4-FFF2-40B4-BE49-F238E27FC236}">
                  <a16:creationId xmlns:a16="http://schemas.microsoft.com/office/drawing/2014/main" id="{104AC23E-0E22-4F2B-BE93-1551E774ECCD}"/>
                </a:ext>
              </a:extLst>
            </p:cNvPr>
            <p:cNvSpPr txBox="1"/>
            <p:nvPr/>
          </p:nvSpPr>
          <p:spPr>
            <a:xfrm>
              <a:off x="4047423" y="4277533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439" name="CasellaDiTesto 438">
              <a:extLst>
                <a:ext uri="{FF2B5EF4-FFF2-40B4-BE49-F238E27FC236}">
                  <a16:creationId xmlns:a16="http://schemas.microsoft.com/office/drawing/2014/main" id="{70246226-B075-49E6-8781-383535AC0AFA}"/>
                </a:ext>
              </a:extLst>
            </p:cNvPr>
            <p:cNvSpPr txBox="1"/>
            <p:nvPr/>
          </p:nvSpPr>
          <p:spPr>
            <a:xfrm>
              <a:off x="4098240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9</a:t>
              </a:r>
              <a:endParaRPr lang="it-IT" sz="600" dirty="0"/>
            </a:p>
          </p:txBody>
        </p:sp>
        <p:sp>
          <p:nvSpPr>
            <p:cNvPr id="440" name="CasellaDiTesto 439">
              <a:extLst>
                <a:ext uri="{FF2B5EF4-FFF2-40B4-BE49-F238E27FC236}">
                  <a16:creationId xmlns:a16="http://schemas.microsoft.com/office/drawing/2014/main" id="{7337A797-2D82-4DEF-8877-203A6B563D92}"/>
                </a:ext>
              </a:extLst>
            </p:cNvPr>
            <p:cNvSpPr txBox="1"/>
            <p:nvPr/>
          </p:nvSpPr>
          <p:spPr>
            <a:xfrm>
              <a:off x="4184931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8</a:t>
              </a:r>
              <a:endParaRPr lang="it-IT" sz="600" dirty="0"/>
            </a:p>
          </p:txBody>
        </p:sp>
        <p:sp>
          <p:nvSpPr>
            <p:cNvPr id="441" name="CasellaDiTesto 440">
              <a:extLst>
                <a:ext uri="{FF2B5EF4-FFF2-40B4-BE49-F238E27FC236}">
                  <a16:creationId xmlns:a16="http://schemas.microsoft.com/office/drawing/2014/main" id="{689509D6-1635-4272-9CDD-AB6A7B975F85}"/>
                </a:ext>
              </a:extLst>
            </p:cNvPr>
            <p:cNvSpPr txBox="1"/>
            <p:nvPr/>
          </p:nvSpPr>
          <p:spPr>
            <a:xfrm>
              <a:off x="4273130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7</a:t>
              </a:r>
              <a:endParaRPr lang="it-IT" sz="600" dirty="0"/>
            </a:p>
          </p:txBody>
        </p:sp>
        <p:sp>
          <p:nvSpPr>
            <p:cNvPr id="442" name="CasellaDiTesto 441">
              <a:extLst>
                <a:ext uri="{FF2B5EF4-FFF2-40B4-BE49-F238E27FC236}">
                  <a16:creationId xmlns:a16="http://schemas.microsoft.com/office/drawing/2014/main" id="{4DA44F70-A41D-4A21-AFCD-18ADC1764141}"/>
                </a:ext>
              </a:extLst>
            </p:cNvPr>
            <p:cNvSpPr txBox="1"/>
            <p:nvPr/>
          </p:nvSpPr>
          <p:spPr>
            <a:xfrm>
              <a:off x="4342997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6</a:t>
              </a:r>
              <a:endParaRPr lang="it-IT" sz="600" dirty="0"/>
            </a:p>
          </p:txBody>
        </p:sp>
        <p:sp>
          <p:nvSpPr>
            <p:cNvPr id="403" name="CasellaDiTesto 402">
              <a:extLst>
                <a:ext uri="{FF2B5EF4-FFF2-40B4-BE49-F238E27FC236}">
                  <a16:creationId xmlns:a16="http://schemas.microsoft.com/office/drawing/2014/main" id="{F5183F30-BB7B-42A9-BC0D-23C04D065BFE}"/>
                </a:ext>
              </a:extLst>
            </p:cNvPr>
            <p:cNvSpPr txBox="1"/>
            <p:nvPr/>
          </p:nvSpPr>
          <p:spPr>
            <a:xfrm>
              <a:off x="4444956" y="4277533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435" name="CasellaDiTesto 434">
              <a:extLst>
                <a:ext uri="{FF2B5EF4-FFF2-40B4-BE49-F238E27FC236}">
                  <a16:creationId xmlns:a16="http://schemas.microsoft.com/office/drawing/2014/main" id="{5988EE16-1D23-452A-8AE7-1B6AEBCE79CD}"/>
                </a:ext>
              </a:extLst>
            </p:cNvPr>
            <p:cNvSpPr txBox="1"/>
            <p:nvPr/>
          </p:nvSpPr>
          <p:spPr>
            <a:xfrm>
              <a:off x="4495773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9</a:t>
              </a:r>
              <a:endParaRPr lang="it-IT" sz="600" dirty="0"/>
            </a:p>
          </p:txBody>
        </p:sp>
        <p:sp>
          <p:nvSpPr>
            <p:cNvPr id="436" name="CasellaDiTesto 435">
              <a:extLst>
                <a:ext uri="{FF2B5EF4-FFF2-40B4-BE49-F238E27FC236}">
                  <a16:creationId xmlns:a16="http://schemas.microsoft.com/office/drawing/2014/main" id="{065DF2B0-2154-4DD5-8EDA-959BA36C5993}"/>
                </a:ext>
              </a:extLst>
            </p:cNvPr>
            <p:cNvSpPr txBox="1"/>
            <p:nvPr/>
          </p:nvSpPr>
          <p:spPr>
            <a:xfrm>
              <a:off x="4582464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8</a:t>
              </a:r>
              <a:endParaRPr lang="it-IT" sz="600" dirty="0"/>
            </a:p>
          </p:txBody>
        </p:sp>
        <p:sp>
          <p:nvSpPr>
            <p:cNvPr id="437" name="CasellaDiTesto 436">
              <a:extLst>
                <a:ext uri="{FF2B5EF4-FFF2-40B4-BE49-F238E27FC236}">
                  <a16:creationId xmlns:a16="http://schemas.microsoft.com/office/drawing/2014/main" id="{D744B632-CF83-42E3-9699-F69A7C844358}"/>
                </a:ext>
              </a:extLst>
            </p:cNvPr>
            <p:cNvSpPr txBox="1"/>
            <p:nvPr/>
          </p:nvSpPr>
          <p:spPr>
            <a:xfrm>
              <a:off x="4670663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7</a:t>
              </a:r>
              <a:endParaRPr lang="it-IT" sz="600" dirty="0"/>
            </a:p>
          </p:txBody>
        </p:sp>
        <p:sp>
          <p:nvSpPr>
            <p:cNvPr id="438" name="CasellaDiTesto 437">
              <a:extLst>
                <a:ext uri="{FF2B5EF4-FFF2-40B4-BE49-F238E27FC236}">
                  <a16:creationId xmlns:a16="http://schemas.microsoft.com/office/drawing/2014/main" id="{150DB698-AFBC-45D2-83AF-419FF511FB3A}"/>
                </a:ext>
              </a:extLst>
            </p:cNvPr>
            <p:cNvSpPr txBox="1"/>
            <p:nvPr/>
          </p:nvSpPr>
          <p:spPr>
            <a:xfrm>
              <a:off x="4740530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6</a:t>
              </a:r>
              <a:endParaRPr lang="it-IT" sz="600" dirty="0"/>
            </a:p>
          </p:txBody>
        </p:sp>
        <p:sp>
          <p:nvSpPr>
            <p:cNvPr id="405" name="CasellaDiTesto 404">
              <a:extLst>
                <a:ext uri="{FF2B5EF4-FFF2-40B4-BE49-F238E27FC236}">
                  <a16:creationId xmlns:a16="http://schemas.microsoft.com/office/drawing/2014/main" id="{5DC07E36-A2DB-42C1-B89A-A2AC948C88E4}"/>
                </a:ext>
              </a:extLst>
            </p:cNvPr>
            <p:cNvSpPr txBox="1"/>
            <p:nvPr/>
          </p:nvSpPr>
          <p:spPr>
            <a:xfrm>
              <a:off x="4836746" y="4277533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431" name="CasellaDiTesto 430">
              <a:extLst>
                <a:ext uri="{FF2B5EF4-FFF2-40B4-BE49-F238E27FC236}">
                  <a16:creationId xmlns:a16="http://schemas.microsoft.com/office/drawing/2014/main" id="{7A8E7D8E-87D9-45DF-904B-0621A8E43FF6}"/>
                </a:ext>
              </a:extLst>
            </p:cNvPr>
            <p:cNvSpPr txBox="1"/>
            <p:nvPr/>
          </p:nvSpPr>
          <p:spPr>
            <a:xfrm>
              <a:off x="4887563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9</a:t>
              </a:r>
              <a:endParaRPr lang="it-IT" sz="600" dirty="0"/>
            </a:p>
          </p:txBody>
        </p:sp>
        <p:sp>
          <p:nvSpPr>
            <p:cNvPr id="432" name="CasellaDiTesto 431">
              <a:extLst>
                <a:ext uri="{FF2B5EF4-FFF2-40B4-BE49-F238E27FC236}">
                  <a16:creationId xmlns:a16="http://schemas.microsoft.com/office/drawing/2014/main" id="{D62CEEED-DAFE-48EA-A027-86623EE57698}"/>
                </a:ext>
              </a:extLst>
            </p:cNvPr>
            <p:cNvSpPr txBox="1"/>
            <p:nvPr/>
          </p:nvSpPr>
          <p:spPr>
            <a:xfrm>
              <a:off x="4974254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8</a:t>
              </a:r>
              <a:endParaRPr lang="it-IT" sz="600" dirty="0"/>
            </a:p>
          </p:txBody>
        </p:sp>
        <p:sp>
          <p:nvSpPr>
            <p:cNvPr id="433" name="CasellaDiTesto 432">
              <a:extLst>
                <a:ext uri="{FF2B5EF4-FFF2-40B4-BE49-F238E27FC236}">
                  <a16:creationId xmlns:a16="http://schemas.microsoft.com/office/drawing/2014/main" id="{D6F760CE-1E15-4E1A-BAB3-6545B2E73992}"/>
                </a:ext>
              </a:extLst>
            </p:cNvPr>
            <p:cNvSpPr txBox="1"/>
            <p:nvPr/>
          </p:nvSpPr>
          <p:spPr>
            <a:xfrm>
              <a:off x="5062453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7</a:t>
              </a:r>
              <a:endParaRPr lang="it-IT" sz="600" dirty="0"/>
            </a:p>
          </p:txBody>
        </p:sp>
        <p:sp>
          <p:nvSpPr>
            <p:cNvPr id="434" name="CasellaDiTesto 433">
              <a:extLst>
                <a:ext uri="{FF2B5EF4-FFF2-40B4-BE49-F238E27FC236}">
                  <a16:creationId xmlns:a16="http://schemas.microsoft.com/office/drawing/2014/main" id="{1EE76D02-5904-4218-A0DD-97141D0A42F8}"/>
                </a:ext>
              </a:extLst>
            </p:cNvPr>
            <p:cNvSpPr txBox="1"/>
            <p:nvPr/>
          </p:nvSpPr>
          <p:spPr>
            <a:xfrm>
              <a:off x="5132320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6</a:t>
              </a:r>
              <a:endParaRPr lang="it-IT" sz="600" dirty="0"/>
            </a:p>
          </p:txBody>
        </p:sp>
        <p:sp>
          <p:nvSpPr>
            <p:cNvPr id="407" name="CasellaDiTesto 406">
              <a:extLst>
                <a:ext uri="{FF2B5EF4-FFF2-40B4-BE49-F238E27FC236}">
                  <a16:creationId xmlns:a16="http://schemas.microsoft.com/office/drawing/2014/main" id="{53569202-1DFD-459E-AAC5-93886C2A628D}"/>
                </a:ext>
              </a:extLst>
            </p:cNvPr>
            <p:cNvSpPr txBox="1"/>
            <p:nvPr/>
          </p:nvSpPr>
          <p:spPr>
            <a:xfrm>
              <a:off x="5230694" y="4277533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427" name="CasellaDiTesto 426">
              <a:extLst>
                <a:ext uri="{FF2B5EF4-FFF2-40B4-BE49-F238E27FC236}">
                  <a16:creationId xmlns:a16="http://schemas.microsoft.com/office/drawing/2014/main" id="{6CF4ADE8-2973-4D48-89F5-ECAF968E2529}"/>
                </a:ext>
              </a:extLst>
            </p:cNvPr>
            <p:cNvSpPr txBox="1"/>
            <p:nvPr/>
          </p:nvSpPr>
          <p:spPr>
            <a:xfrm>
              <a:off x="5281511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9</a:t>
              </a:r>
              <a:endParaRPr lang="it-IT" sz="600" dirty="0"/>
            </a:p>
          </p:txBody>
        </p:sp>
        <p:sp>
          <p:nvSpPr>
            <p:cNvPr id="428" name="CasellaDiTesto 427">
              <a:extLst>
                <a:ext uri="{FF2B5EF4-FFF2-40B4-BE49-F238E27FC236}">
                  <a16:creationId xmlns:a16="http://schemas.microsoft.com/office/drawing/2014/main" id="{8B959984-3E26-465D-9182-004608B3AA19}"/>
                </a:ext>
              </a:extLst>
            </p:cNvPr>
            <p:cNvSpPr txBox="1"/>
            <p:nvPr/>
          </p:nvSpPr>
          <p:spPr>
            <a:xfrm>
              <a:off x="5368202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8</a:t>
              </a:r>
              <a:endParaRPr lang="it-IT" sz="600" dirty="0"/>
            </a:p>
          </p:txBody>
        </p:sp>
        <p:sp>
          <p:nvSpPr>
            <p:cNvPr id="429" name="CasellaDiTesto 428">
              <a:extLst>
                <a:ext uri="{FF2B5EF4-FFF2-40B4-BE49-F238E27FC236}">
                  <a16:creationId xmlns:a16="http://schemas.microsoft.com/office/drawing/2014/main" id="{6D810E69-D5DA-4A29-A2EF-D745A19ECB25}"/>
                </a:ext>
              </a:extLst>
            </p:cNvPr>
            <p:cNvSpPr txBox="1"/>
            <p:nvPr/>
          </p:nvSpPr>
          <p:spPr>
            <a:xfrm>
              <a:off x="5456401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7</a:t>
              </a:r>
              <a:endParaRPr lang="it-IT" sz="600" dirty="0"/>
            </a:p>
          </p:txBody>
        </p:sp>
        <p:sp>
          <p:nvSpPr>
            <p:cNvPr id="430" name="CasellaDiTesto 429">
              <a:extLst>
                <a:ext uri="{FF2B5EF4-FFF2-40B4-BE49-F238E27FC236}">
                  <a16:creationId xmlns:a16="http://schemas.microsoft.com/office/drawing/2014/main" id="{86745E1E-BF74-4D45-A3E9-AB34514BBC9E}"/>
                </a:ext>
              </a:extLst>
            </p:cNvPr>
            <p:cNvSpPr txBox="1"/>
            <p:nvPr/>
          </p:nvSpPr>
          <p:spPr>
            <a:xfrm>
              <a:off x="5526268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6</a:t>
              </a:r>
              <a:endParaRPr lang="it-IT" sz="600" dirty="0"/>
            </a:p>
          </p:txBody>
        </p:sp>
        <p:sp>
          <p:nvSpPr>
            <p:cNvPr id="409" name="CasellaDiTesto 408">
              <a:extLst>
                <a:ext uri="{FF2B5EF4-FFF2-40B4-BE49-F238E27FC236}">
                  <a16:creationId xmlns:a16="http://schemas.microsoft.com/office/drawing/2014/main" id="{1621492B-90EB-496F-9E3B-7B8EBFD15195}"/>
                </a:ext>
              </a:extLst>
            </p:cNvPr>
            <p:cNvSpPr txBox="1"/>
            <p:nvPr/>
          </p:nvSpPr>
          <p:spPr>
            <a:xfrm>
              <a:off x="5616134" y="4277533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410" name="CasellaDiTesto 409">
              <a:extLst>
                <a:ext uri="{FF2B5EF4-FFF2-40B4-BE49-F238E27FC236}">
                  <a16:creationId xmlns:a16="http://schemas.microsoft.com/office/drawing/2014/main" id="{33701A36-0EE0-45FB-939A-D4DE0BBE5A6C}"/>
                </a:ext>
              </a:extLst>
            </p:cNvPr>
            <p:cNvSpPr txBox="1"/>
            <p:nvPr/>
          </p:nvSpPr>
          <p:spPr>
            <a:xfrm>
              <a:off x="5666951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9</a:t>
              </a:r>
              <a:endParaRPr lang="it-IT" sz="600" dirty="0"/>
            </a:p>
          </p:txBody>
        </p:sp>
        <p:sp>
          <p:nvSpPr>
            <p:cNvPr id="411" name="CasellaDiTesto 410">
              <a:extLst>
                <a:ext uri="{FF2B5EF4-FFF2-40B4-BE49-F238E27FC236}">
                  <a16:creationId xmlns:a16="http://schemas.microsoft.com/office/drawing/2014/main" id="{C9DE4895-5AAF-4D9D-A588-C4D4BB8906CB}"/>
                </a:ext>
              </a:extLst>
            </p:cNvPr>
            <p:cNvSpPr txBox="1"/>
            <p:nvPr/>
          </p:nvSpPr>
          <p:spPr>
            <a:xfrm>
              <a:off x="5753642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8</a:t>
              </a:r>
              <a:endParaRPr lang="it-IT" sz="600" dirty="0"/>
            </a:p>
          </p:txBody>
        </p:sp>
        <p:sp>
          <p:nvSpPr>
            <p:cNvPr id="412" name="CasellaDiTesto 411">
              <a:extLst>
                <a:ext uri="{FF2B5EF4-FFF2-40B4-BE49-F238E27FC236}">
                  <a16:creationId xmlns:a16="http://schemas.microsoft.com/office/drawing/2014/main" id="{053FDB5D-C25E-49FC-8A69-3C149B170B4F}"/>
                </a:ext>
              </a:extLst>
            </p:cNvPr>
            <p:cNvSpPr txBox="1"/>
            <p:nvPr/>
          </p:nvSpPr>
          <p:spPr>
            <a:xfrm>
              <a:off x="5841841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7</a:t>
              </a:r>
              <a:endParaRPr lang="it-IT" sz="600" dirty="0"/>
            </a:p>
          </p:txBody>
        </p:sp>
        <p:sp>
          <p:nvSpPr>
            <p:cNvPr id="413" name="CasellaDiTesto 412">
              <a:extLst>
                <a:ext uri="{FF2B5EF4-FFF2-40B4-BE49-F238E27FC236}">
                  <a16:creationId xmlns:a16="http://schemas.microsoft.com/office/drawing/2014/main" id="{E5428D00-B144-4F44-BE2B-B7F32D22CBD5}"/>
                </a:ext>
              </a:extLst>
            </p:cNvPr>
            <p:cNvSpPr txBox="1"/>
            <p:nvPr/>
          </p:nvSpPr>
          <p:spPr>
            <a:xfrm>
              <a:off x="5911708" y="4277533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6</a:t>
              </a:r>
              <a:endParaRPr lang="it-IT" sz="600" dirty="0"/>
            </a:p>
          </p:txBody>
        </p:sp>
        <p:sp>
          <p:nvSpPr>
            <p:cNvPr id="414" name="CasellaDiTesto 413">
              <a:extLst>
                <a:ext uri="{FF2B5EF4-FFF2-40B4-BE49-F238E27FC236}">
                  <a16:creationId xmlns:a16="http://schemas.microsoft.com/office/drawing/2014/main" id="{A28DB261-4963-49A7-89E5-59C991BD2278}"/>
                </a:ext>
              </a:extLst>
            </p:cNvPr>
            <p:cNvSpPr txBox="1"/>
            <p:nvPr/>
          </p:nvSpPr>
          <p:spPr>
            <a:xfrm>
              <a:off x="4769806" y="4405277"/>
              <a:ext cx="6671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Log [Tam] (M)</a:t>
              </a:r>
            </a:p>
          </p:txBody>
        </p:sp>
        <p:cxnSp>
          <p:nvCxnSpPr>
            <p:cNvPr id="415" name="Connettore diritto 414">
              <a:extLst>
                <a:ext uri="{FF2B5EF4-FFF2-40B4-BE49-F238E27FC236}">
                  <a16:creationId xmlns:a16="http://schemas.microsoft.com/office/drawing/2014/main" id="{51643AA1-F1D3-4C0D-97F5-60FB8E334FAD}"/>
                </a:ext>
              </a:extLst>
            </p:cNvPr>
            <p:cNvCxnSpPr>
              <a:cxnSpLocks/>
            </p:cNvCxnSpPr>
            <p:nvPr/>
          </p:nvCxnSpPr>
          <p:spPr>
            <a:xfrm>
              <a:off x="4104630" y="4440599"/>
              <a:ext cx="19527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6" name="Connettore diritto 415">
              <a:extLst>
                <a:ext uri="{FF2B5EF4-FFF2-40B4-BE49-F238E27FC236}">
                  <a16:creationId xmlns:a16="http://schemas.microsoft.com/office/drawing/2014/main" id="{06EA5968-7AD4-48FD-9DE3-3D01D15B785B}"/>
                </a:ext>
              </a:extLst>
            </p:cNvPr>
            <p:cNvCxnSpPr/>
            <p:nvPr/>
          </p:nvCxnSpPr>
          <p:spPr>
            <a:xfrm>
              <a:off x="4520376" y="3125405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7" name="Connettore diritto 416">
              <a:extLst>
                <a:ext uri="{FF2B5EF4-FFF2-40B4-BE49-F238E27FC236}">
                  <a16:creationId xmlns:a16="http://schemas.microsoft.com/office/drawing/2014/main" id="{08F50063-E44A-4EE0-BE6D-5CBF39033C80}"/>
                </a:ext>
              </a:extLst>
            </p:cNvPr>
            <p:cNvCxnSpPr/>
            <p:nvPr/>
          </p:nvCxnSpPr>
          <p:spPr>
            <a:xfrm>
              <a:off x="4918146" y="3125405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8" name="Connettore diritto 417">
              <a:extLst>
                <a:ext uri="{FF2B5EF4-FFF2-40B4-BE49-F238E27FC236}">
                  <a16:creationId xmlns:a16="http://schemas.microsoft.com/office/drawing/2014/main" id="{AD644D38-893E-49BD-8FC0-59B4A85C184B}"/>
                </a:ext>
              </a:extLst>
            </p:cNvPr>
            <p:cNvCxnSpPr/>
            <p:nvPr/>
          </p:nvCxnSpPr>
          <p:spPr>
            <a:xfrm>
              <a:off x="5329783" y="3125405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9" name="Connettore diritto 418">
              <a:extLst>
                <a:ext uri="{FF2B5EF4-FFF2-40B4-BE49-F238E27FC236}">
                  <a16:creationId xmlns:a16="http://schemas.microsoft.com/office/drawing/2014/main" id="{4E7F61D2-4DF7-4DDB-BC15-C71C248B28C0}"/>
                </a:ext>
              </a:extLst>
            </p:cNvPr>
            <p:cNvCxnSpPr/>
            <p:nvPr/>
          </p:nvCxnSpPr>
          <p:spPr>
            <a:xfrm>
              <a:off x="5726109" y="3125405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0" name="CasellaDiTesto 419">
              <a:extLst>
                <a:ext uri="{FF2B5EF4-FFF2-40B4-BE49-F238E27FC236}">
                  <a16:creationId xmlns:a16="http://schemas.microsoft.com/office/drawing/2014/main" id="{14AEDCD0-7C5A-429C-A81C-89DA6794EB5F}"/>
                </a:ext>
              </a:extLst>
            </p:cNvPr>
            <p:cNvSpPr txBox="1"/>
            <p:nvPr/>
          </p:nvSpPr>
          <p:spPr>
            <a:xfrm>
              <a:off x="4583396" y="2960750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</a:t>
              </a:r>
            </a:p>
          </p:txBody>
        </p:sp>
        <p:sp>
          <p:nvSpPr>
            <p:cNvPr id="421" name="CasellaDiTesto 420">
              <a:extLst>
                <a:ext uri="{FF2B5EF4-FFF2-40B4-BE49-F238E27FC236}">
                  <a16:creationId xmlns:a16="http://schemas.microsoft.com/office/drawing/2014/main" id="{21A40BAD-FA0C-4E88-939B-E881CDB46C28}"/>
                </a:ext>
              </a:extLst>
            </p:cNvPr>
            <p:cNvSpPr txBox="1"/>
            <p:nvPr/>
          </p:nvSpPr>
          <p:spPr>
            <a:xfrm>
              <a:off x="4922894" y="2960750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</a:t>
              </a:r>
            </a:p>
          </p:txBody>
        </p:sp>
        <p:sp>
          <p:nvSpPr>
            <p:cNvPr id="422" name="CasellaDiTesto 421">
              <a:extLst>
                <a:ext uri="{FF2B5EF4-FFF2-40B4-BE49-F238E27FC236}">
                  <a16:creationId xmlns:a16="http://schemas.microsoft.com/office/drawing/2014/main" id="{1688C910-F420-4B86-AEB8-C40B803ECFFF}"/>
                </a:ext>
              </a:extLst>
            </p:cNvPr>
            <p:cNvSpPr txBox="1"/>
            <p:nvPr/>
          </p:nvSpPr>
          <p:spPr>
            <a:xfrm>
              <a:off x="5355535" y="2960750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sp>
          <p:nvSpPr>
            <p:cNvPr id="423" name="CasellaDiTesto 422">
              <a:extLst>
                <a:ext uri="{FF2B5EF4-FFF2-40B4-BE49-F238E27FC236}">
                  <a16:creationId xmlns:a16="http://schemas.microsoft.com/office/drawing/2014/main" id="{39CF7A3B-E979-4E12-9B73-59BCD9E203D1}"/>
                </a:ext>
              </a:extLst>
            </p:cNvPr>
            <p:cNvSpPr txBox="1"/>
            <p:nvPr/>
          </p:nvSpPr>
          <p:spPr>
            <a:xfrm>
              <a:off x="5727632" y="2960750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0</a:t>
              </a:r>
            </a:p>
          </p:txBody>
        </p:sp>
        <p:cxnSp>
          <p:nvCxnSpPr>
            <p:cNvPr id="424" name="Connettore diritto 423">
              <a:extLst>
                <a:ext uri="{FF2B5EF4-FFF2-40B4-BE49-F238E27FC236}">
                  <a16:creationId xmlns:a16="http://schemas.microsoft.com/office/drawing/2014/main" id="{BF89F917-31A5-4E85-AACB-800C781B8869}"/>
                </a:ext>
              </a:extLst>
            </p:cNvPr>
            <p:cNvCxnSpPr>
              <a:cxnSpLocks/>
            </p:cNvCxnSpPr>
            <p:nvPr/>
          </p:nvCxnSpPr>
          <p:spPr>
            <a:xfrm>
              <a:off x="4697370" y="2960750"/>
              <a:ext cx="120915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5" name="CasellaDiTesto 424">
              <a:extLst>
                <a:ext uri="{FF2B5EF4-FFF2-40B4-BE49-F238E27FC236}">
                  <a16:creationId xmlns:a16="http://schemas.microsoft.com/office/drawing/2014/main" id="{477CD04F-6D42-4A78-8EC6-1BD043924F36}"/>
                </a:ext>
              </a:extLst>
            </p:cNvPr>
            <p:cNvSpPr txBox="1"/>
            <p:nvPr/>
          </p:nvSpPr>
          <p:spPr>
            <a:xfrm>
              <a:off x="5041300" y="2771800"/>
              <a:ext cx="5774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[GDC] (</a:t>
              </a:r>
              <a:r>
                <a:rPr lang="it-IT" sz="600" dirty="0" err="1"/>
                <a:t>nM</a:t>
              </a:r>
              <a:r>
                <a:rPr lang="it-IT" sz="600" dirty="0"/>
                <a:t>)</a:t>
              </a:r>
            </a:p>
          </p:txBody>
        </p:sp>
        <p:sp>
          <p:nvSpPr>
            <p:cNvPr id="426" name="CasellaDiTesto 425">
              <a:extLst>
                <a:ext uri="{FF2B5EF4-FFF2-40B4-BE49-F238E27FC236}">
                  <a16:creationId xmlns:a16="http://schemas.microsoft.com/office/drawing/2014/main" id="{1159010B-6A26-4942-B381-4202EFA70CB5}"/>
                </a:ext>
              </a:extLst>
            </p:cNvPr>
            <p:cNvSpPr txBox="1"/>
            <p:nvPr/>
          </p:nvSpPr>
          <p:spPr>
            <a:xfrm>
              <a:off x="4068231" y="4077343"/>
              <a:ext cx="4203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/>
                <a:t>MCF-7</a:t>
              </a:r>
              <a:endParaRPr lang="it-IT" sz="600" b="1" dirty="0"/>
            </a:p>
          </p:txBody>
        </p:sp>
      </p:grpSp>
      <p:grpSp>
        <p:nvGrpSpPr>
          <p:cNvPr id="645" name="Gruppo 644">
            <a:extLst>
              <a:ext uri="{FF2B5EF4-FFF2-40B4-BE49-F238E27FC236}">
                <a16:creationId xmlns:a16="http://schemas.microsoft.com/office/drawing/2014/main" id="{612AF593-28AA-4846-9B1A-FF80E8AF4289}"/>
              </a:ext>
            </a:extLst>
          </p:cNvPr>
          <p:cNvGrpSpPr/>
          <p:nvPr/>
        </p:nvGrpSpPr>
        <p:grpSpPr>
          <a:xfrm>
            <a:off x="258958" y="4909522"/>
            <a:ext cx="2480910" cy="1818143"/>
            <a:chOff x="258958" y="4909522"/>
            <a:chExt cx="2480910" cy="1818143"/>
          </a:xfrm>
        </p:grpSpPr>
        <p:pic>
          <p:nvPicPr>
            <p:cNvPr id="644" name="Immagine 643">
              <a:extLst>
                <a:ext uri="{FF2B5EF4-FFF2-40B4-BE49-F238E27FC236}">
                  <a16:creationId xmlns:a16="http://schemas.microsoft.com/office/drawing/2014/main" id="{BDBC5ECA-37F6-4C56-A990-9ADE528033B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16662" y="5047103"/>
              <a:ext cx="2077050" cy="1440000"/>
            </a:xfrm>
            <a:prstGeom prst="rect">
              <a:avLst/>
            </a:prstGeom>
          </p:spPr>
        </p:pic>
        <p:sp>
          <p:nvSpPr>
            <p:cNvPr id="445" name="CasellaDiTesto 444">
              <a:extLst>
                <a:ext uri="{FF2B5EF4-FFF2-40B4-BE49-F238E27FC236}">
                  <a16:creationId xmlns:a16="http://schemas.microsoft.com/office/drawing/2014/main" id="{0AE77E7D-A2E2-402D-AC36-4678B7013B0E}"/>
                </a:ext>
              </a:extLst>
            </p:cNvPr>
            <p:cNvSpPr txBox="1"/>
            <p:nvPr/>
          </p:nvSpPr>
          <p:spPr>
            <a:xfrm rot="16200000">
              <a:off x="-305760" y="5619034"/>
              <a:ext cx="1406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600" dirty="0" err="1"/>
                <a:t>Number</a:t>
              </a:r>
              <a:r>
                <a:rPr lang="it-IT" sz="600" dirty="0"/>
                <a:t> of </a:t>
              </a:r>
              <a:r>
                <a:rPr lang="it-IT" sz="600" dirty="0" err="1"/>
                <a:t>cells</a:t>
              </a:r>
              <a:endParaRPr lang="it-IT" sz="600" dirty="0"/>
            </a:p>
            <a:p>
              <a:pPr algn="ctr"/>
              <a:r>
                <a:rPr lang="it-IT" sz="600" dirty="0"/>
                <a:t>(% on -)</a:t>
              </a:r>
              <a:endParaRPr lang="it-IT" sz="6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446" name="CasellaDiTesto 445">
              <a:extLst>
                <a:ext uri="{FF2B5EF4-FFF2-40B4-BE49-F238E27FC236}">
                  <a16:creationId xmlns:a16="http://schemas.microsoft.com/office/drawing/2014/main" id="{A15CDCD6-4A3F-437B-A691-656C3A77CDCC}"/>
                </a:ext>
              </a:extLst>
            </p:cNvPr>
            <p:cNvSpPr txBox="1"/>
            <p:nvPr/>
          </p:nvSpPr>
          <p:spPr>
            <a:xfrm>
              <a:off x="399517" y="5651451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sp>
          <p:nvSpPr>
            <p:cNvPr id="447" name="CasellaDiTesto 446">
              <a:extLst>
                <a:ext uri="{FF2B5EF4-FFF2-40B4-BE49-F238E27FC236}">
                  <a16:creationId xmlns:a16="http://schemas.microsoft.com/office/drawing/2014/main" id="{25A96A51-528B-4923-B33B-A358708A9B1D}"/>
                </a:ext>
              </a:extLst>
            </p:cNvPr>
            <p:cNvSpPr txBox="1"/>
            <p:nvPr/>
          </p:nvSpPr>
          <p:spPr>
            <a:xfrm>
              <a:off x="486079" y="631576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</a:t>
              </a:r>
            </a:p>
          </p:txBody>
        </p:sp>
        <p:sp>
          <p:nvSpPr>
            <p:cNvPr id="448" name="CasellaDiTesto 447">
              <a:extLst>
                <a:ext uri="{FF2B5EF4-FFF2-40B4-BE49-F238E27FC236}">
                  <a16:creationId xmlns:a16="http://schemas.microsoft.com/office/drawing/2014/main" id="{F5AE53BB-2722-4E37-BDAD-9F6E3CFA38ED}"/>
                </a:ext>
              </a:extLst>
            </p:cNvPr>
            <p:cNvSpPr txBox="1"/>
            <p:nvPr/>
          </p:nvSpPr>
          <p:spPr>
            <a:xfrm>
              <a:off x="399517" y="4985821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00</a:t>
              </a:r>
            </a:p>
          </p:txBody>
        </p:sp>
        <p:sp>
          <p:nvSpPr>
            <p:cNvPr id="449" name="CasellaDiTesto 448">
              <a:extLst>
                <a:ext uri="{FF2B5EF4-FFF2-40B4-BE49-F238E27FC236}">
                  <a16:creationId xmlns:a16="http://schemas.microsoft.com/office/drawing/2014/main" id="{BE86C972-940A-4FD8-804D-E037277203FD}"/>
                </a:ext>
              </a:extLst>
            </p:cNvPr>
            <p:cNvSpPr txBox="1"/>
            <p:nvPr/>
          </p:nvSpPr>
          <p:spPr>
            <a:xfrm>
              <a:off x="621987" y="6415255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450" name="Gruppo 449">
              <a:extLst>
                <a:ext uri="{FF2B5EF4-FFF2-40B4-BE49-F238E27FC236}">
                  <a16:creationId xmlns:a16="http://schemas.microsoft.com/office/drawing/2014/main" id="{2888366A-2C7E-4E15-BD57-B0B380EC2DB5}"/>
                </a:ext>
              </a:extLst>
            </p:cNvPr>
            <p:cNvGrpSpPr/>
            <p:nvPr/>
          </p:nvGrpSpPr>
          <p:grpSpPr>
            <a:xfrm>
              <a:off x="672804" y="6415255"/>
              <a:ext cx="498353" cy="184666"/>
              <a:chOff x="504190" y="4467019"/>
              <a:chExt cx="498353" cy="184666"/>
            </a:xfrm>
          </p:grpSpPr>
          <p:sp>
            <p:nvSpPr>
              <p:cNvPr id="487" name="CasellaDiTesto 486">
                <a:extLst>
                  <a:ext uri="{FF2B5EF4-FFF2-40B4-BE49-F238E27FC236}">
                    <a16:creationId xmlns:a16="http://schemas.microsoft.com/office/drawing/2014/main" id="{DC21D9CD-F082-4413-A70F-17CB6980E65D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488" name="CasellaDiTesto 487">
                <a:extLst>
                  <a:ext uri="{FF2B5EF4-FFF2-40B4-BE49-F238E27FC236}">
                    <a16:creationId xmlns:a16="http://schemas.microsoft.com/office/drawing/2014/main" id="{AAE156AB-850F-417D-894C-0B44D2302764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489" name="CasellaDiTesto 488">
                <a:extLst>
                  <a:ext uri="{FF2B5EF4-FFF2-40B4-BE49-F238E27FC236}">
                    <a16:creationId xmlns:a16="http://schemas.microsoft.com/office/drawing/2014/main" id="{AEBE5EBD-8463-4257-B850-1AF3FDF69682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490" name="CasellaDiTesto 489">
                <a:extLst>
                  <a:ext uri="{FF2B5EF4-FFF2-40B4-BE49-F238E27FC236}">
                    <a16:creationId xmlns:a16="http://schemas.microsoft.com/office/drawing/2014/main" id="{35873420-8B49-46B6-8645-90EF09D1746E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451" name="CasellaDiTesto 450">
              <a:extLst>
                <a:ext uri="{FF2B5EF4-FFF2-40B4-BE49-F238E27FC236}">
                  <a16:creationId xmlns:a16="http://schemas.microsoft.com/office/drawing/2014/main" id="{A09D2338-524C-4744-9DB5-AE5F3EF8587E}"/>
                </a:ext>
              </a:extLst>
            </p:cNvPr>
            <p:cNvSpPr txBox="1"/>
            <p:nvPr/>
          </p:nvSpPr>
          <p:spPr>
            <a:xfrm>
              <a:off x="1019520" y="6415255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452" name="Gruppo 451">
              <a:extLst>
                <a:ext uri="{FF2B5EF4-FFF2-40B4-BE49-F238E27FC236}">
                  <a16:creationId xmlns:a16="http://schemas.microsoft.com/office/drawing/2014/main" id="{8351CFCB-3E84-427A-947C-A744214809E7}"/>
                </a:ext>
              </a:extLst>
            </p:cNvPr>
            <p:cNvGrpSpPr/>
            <p:nvPr/>
          </p:nvGrpSpPr>
          <p:grpSpPr>
            <a:xfrm>
              <a:off x="1070337" y="6415255"/>
              <a:ext cx="498353" cy="184666"/>
              <a:chOff x="504190" y="4467019"/>
              <a:chExt cx="498353" cy="184666"/>
            </a:xfrm>
          </p:grpSpPr>
          <p:sp>
            <p:nvSpPr>
              <p:cNvPr id="483" name="CasellaDiTesto 482">
                <a:extLst>
                  <a:ext uri="{FF2B5EF4-FFF2-40B4-BE49-F238E27FC236}">
                    <a16:creationId xmlns:a16="http://schemas.microsoft.com/office/drawing/2014/main" id="{D66BC254-16B7-4D38-836B-E2056D972C2E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484" name="CasellaDiTesto 483">
                <a:extLst>
                  <a:ext uri="{FF2B5EF4-FFF2-40B4-BE49-F238E27FC236}">
                    <a16:creationId xmlns:a16="http://schemas.microsoft.com/office/drawing/2014/main" id="{406E0AEC-C828-4102-B0D1-5D71E6BEB590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485" name="CasellaDiTesto 484">
                <a:extLst>
                  <a:ext uri="{FF2B5EF4-FFF2-40B4-BE49-F238E27FC236}">
                    <a16:creationId xmlns:a16="http://schemas.microsoft.com/office/drawing/2014/main" id="{8ED713D5-2090-470E-9D4F-3E198FE64927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486" name="CasellaDiTesto 485">
                <a:extLst>
                  <a:ext uri="{FF2B5EF4-FFF2-40B4-BE49-F238E27FC236}">
                    <a16:creationId xmlns:a16="http://schemas.microsoft.com/office/drawing/2014/main" id="{2644428E-EF1F-4402-BE80-3161979BF888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453" name="CasellaDiTesto 452">
              <a:extLst>
                <a:ext uri="{FF2B5EF4-FFF2-40B4-BE49-F238E27FC236}">
                  <a16:creationId xmlns:a16="http://schemas.microsoft.com/office/drawing/2014/main" id="{255E304E-683E-4E29-ADDC-4354FCBFD9FD}"/>
                </a:ext>
              </a:extLst>
            </p:cNvPr>
            <p:cNvSpPr txBox="1"/>
            <p:nvPr/>
          </p:nvSpPr>
          <p:spPr>
            <a:xfrm>
              <a:off x="1411310" y="6415255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454" name="Gruppo 453">
              <a:extLst>
                <a:ext uri="{FF2B5EF4-FFF2-40B4-BE49-F238E27FC236}">
                  <a16:creationId xmlns:a16="http://schemas.microsoft.com/office/drawing/2014/main" id="{12AD2840-4819-46E3-B4AC-AB0052DD1154}"/>
                </a:ext>
              </a:extLst>
            </p:cNvPr>
            <p:cNvGrpSpPr/>
            <p:nvPr/>
          </p:nvGrpSpPr>
          <p:grpSpPr>
            <a:xfrm>
              <a:off x="1462127" y="6415255"/>
              <a:ext cx="498353" cy="184666"/>
              <a:chOff x="504190" y="4467019"/>
              <a:chExt cx="498353" cy="184666"/>
            </a:xfrm>
          </p:grpSpPr>
          <p:sp>
            <p:nvSpPr>
              <p:cNvPr id="479" name="CasellaDiTesto 478">
                <a:extLst>
                  <a:ext uri="{FF2B5EF4-FFF2-40B4-BE49-F238E27FC236}">
                    <a16:creationId xmlns:a16="http://schemas.microsoft.com/office/drawing/2014/main" id="{7CBD2AEB-5EFC-431C-87B1-B6C96412CA07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480" name="CasellaDiTesto 479">
                <a:extLst>
                  <a:ext uri="{FF2B5EF4-FFF2-40B4-BE49-F238E27FC236}">
                    <a16:creationId xmlns:a16="http://schemas.microsoft.com/office/drawing/2014/main" id="{B9472588-B926-45D3-8F0F-4C188AF1DCC1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481" name="CasellaDiTesto 480">
                <a:extLst>
                  <a:ext uri="{FF2B5EF4-FFF2-40B4-BE49-F238E27FC236}">
                    <a16:creationId xmlns:a16="http://schemas.microsoft.com/office/drawing/2014/main" id="{D30A8F72-8572-4E08-B3F5-7DC20A8BE541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482" name="CasellaDiTesto 481">
                <a:extLst>
                  <a:ext uri="{FF2B5EF4-FFF2-40B4-BE49-F238E27FC236}">
                    <a16:creationId xmlns:a16="http://schemas.microsoft.com/office/drawing/2014/main" id="{B974925B-F4A1-43D1-90DE-5EB7BF44679A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455" name="CasellaDiTesto 454">
              <a:extLst>
                <a:ext uri="{FF2B5EF4-FFF2-40B4-BE49-F238E27FC236}">
                  <a16:creationId xmlns:a16="http://schemas.microsoft.com/office/drawing/2014/main" id="{E4A4AE21-98B2-4072-93EC-9787687D4B35}"/>
                </a:ext>
              </a:extLst>
            </p:cNvPr>
            <p:cNvSpPr txBox="1"/>
            <p:nvPr/>
          </p:nvSpPr>
          <p:spPr>
            <a:xfrm>
              <a:off x="1805258" y="6415255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456" name="Gruppo 455">
              <a:extLst>
                <a:ext uri="{FF2B5EF4-FFF2-40B4-BE49-F238E27FC236}">
                  <a16:creationId xmlns:a16="http://schemas.microsoft.com/office/drawing/2014/main" id="{D773E3BA-AAAC-49BF-9688-8726E987A516}"/>
                </a:ext>
              </a:extLst>
            </p:cNvPr>
            <p:cNvGrpSpPr/>
            <p:nvPr/>
          </p:nvGrpSpPr>
          <p:grpSpPr>
            <a:xfrm>
              <a:off x="1856075" y="6415255"/>
              <a:ext cx="498353" cy="184666"/>
              <a:chOff x="504190" y="4467019"/>
              <a:chExt cx="498353" cy="184666"/>
            </a:xfrm>
          </p:grpSpPr>
          <p:sp>
            <p:nvSpPr>
              <p:cNvPr id="475" name="CasellaDiTesto 474">
                <a:extLst>
                  <a:ext uri="{FF2B5EF4-FFF2-40B4-BE49-F238E27FC236}">
                    <a16:creationId xmlns:a16="http://schemas.microsoft.com/office/drawing/2014/main" id="{07F229A6-9E4D-4C20-A299-BD3E7B2A2837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476" name="CasellaDiTesto 475">
                <a:extLst>
                  <a:ext uri="{FF2B5EF4-FFF2-40B4-BE49-F238E27FC236}">
                    <a16:creationId xmlns:a16="http://schemas.microsoft.com/office/drawing/2014/main" id="{B78E6408-8198-470F-82AA-B6389EF4FEA2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477" name="CasellaDiTesto 476">
                <a:extLst>
                  <a:ext uri="{FF2B5EF4-FFF2-40B4-BE49-F238E27FC236}">
                    <a16:creationId xmlns:a16="http://schemas.microsoft.com/office/drawing/2014/main" id="{AFE1D37D-B0D5-4A2A-B967-2D218E3CFBCC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478" name="CasellaDiTesto 477">
                <a:extLst>
                  <a:ext uri="{FF2B5EF4-FFF2-40B4-BE49-F238E27FC236}">
                    <a16:creationId xmlns:a16="http://schemas.microsoft.com/office/drawing/2014/main" id="{43CE1CF4-164A-47DA-91F8-11E7E895F066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457" name="CasellaDiTesto 456">
              <a:extLst>
                <a:ext uri="{FF2B5EF4-FFF2-40B4-BE49-F238E27FC236}">
                  <a16:creationId xmlns:a16="http://schemas.microsoft.com/office/drawing/2014/main" id="{F8B7500A-7ED2-47B6-8333-E57EF5E9F2D7}"/>
                </a:ext>
              </a:extLst>
            </p:cNvPr>
            <p:cNvSpPr txBox="1"/>
            <p:nvPr/>
          </p:nvSpPr>
          <p:spPr>
            <a:xfrm>
              <a:off x="2190698" y="6415255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458" name="CasellaDiTesto 457">
              <a:extLst>
                <a:ext uri="{FF2B5EF4-FFF2-40B4-BE49-F238E27FC236}">
                  <a16:creationId xmlns:a16="http://schemas.microsoft.com/office/drawing/2014/main" id="{B2AE8484-D877-456A-95F3-185A07C21BB6}"/>
                </a:ext>
              </a:extLst>
            </p:cNvPr>
            <p:cNvSpPr txBox="1"/>
            <p:nvPr/>
          </p:nvSpPr>
          <p:spPr>
            <a:xfrm>
              <a:off x="2241515" y="6415255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9</a:t>
              </a:r>
              <a:endParaRPr lang="it-IT" sz="600" dirty="0"/>
            </a:p>
          </p:txBody>
        </p:sp>
        <p:sp>
          <p:nvSpPr>
            <p:cNvPr id="459" name="CasellaDiTesto 458">
              <a:extLst>
                <a:ext uri="{FF2B5EF4-FFF2-40B4-BE49-F238E27FC236}">
                  <a16:creationId xmlns:a16="http://schemas.microsoft.com/office/drawing/2014/main" id="{6D699543-A515-402A-AB13-C8AA2BACA402}"/>
                </a:ext>
              </a:extLst>
            </p:cNvPr>
            <p:cNvSpPr txBox="1"/>
            <p:nvPr/>
          </p:nvSpPr>
          <p:spPr>
            <a:xfrm>
              <a:off x="2328206" y="6415255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8</a:t>
              </a:r>
              <a:endParaRPr lang="it-IT" sz="600" dirty="0"/>
            </a:p>
          </p:txBody>
        </p:sp>
        <p:sp>
          <p:nvSpPr>
            <p:cNvPr id="460" name="CasellaDiTesto 459">
              <a:extLst>
                <a:ext uri="{FF2B5EF4-FFF2-40B4-BE49-F238E27FC236}">
                  <a16:creationId xmlns:a16="http://schemas.microsoft.com/office/drawing/2014/main" id="{EB7EF885-FBB4-4794-BF2E-DEDEA5349E1E}"/>
                </a:ext>
              </a:extLst>
            </p:cNvPr>
            <p:cNvSpPr txBox="1"/>
            <p:nvPr/>
          </p:nvSpPr>
          <p:spPr>
            <a:xfrm>
              <a:off x="2416405" y="6415255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7</a:t>
              </a:r>
              <a:endParaRPr lang="it-IT" sz="600" dirty="0"/>
            </a:p>
          </p:txBody>
        </p:sp>
        <p:sp>
          <p:nvSpPr>
            <p:cNvPr id="461" name="CasellaDiTesto 460">
              <a:extLst>
                <a:ext uri="{FF2B5EF4-FFF2-40B4-BE49-F238E27FC236}">
                  <a16:creationId xmlns:a16="http://schemas.microsoft.com/office/drawing/2014/main" id="{D5C30E10-E91F-4A70-8BED-286538D41F8D}"/>
                </a:ext>
              </a:extLst>
            </p:cNvPr>
            <p:cNvSpPr txBox="1"/>
            <p:nvPr/>
          </p:nvSpPr>
          <p:spPr>
            <a:xfrm>
              <a:off x="2486272" y="6415255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6</a:t>
              </a:r>
              <a:endParaRPr lang="it-IT" sz="600" dirty="0"/>
            </a:p>
          </p:txBody>
        </p:sp>
        <p:sp>
          <p:nvSpPr>
            <p:cNvPr id="462" name="CasellaDiTesto 461">
              <a:extLst>
                <a:ext uri="{FF2B5EF4-FFF2-40B4-BE49-F238E27FC236}">
                  <a16:creationId xmlns:a16="http://schemas.microsoft.com/office/drawing/2014/main" id="{B7C480C7-A5B3-4B7F-8A1D-358B41BD9351}"/>
                </a:ext>
              </a:extLst>
            </p:cNvPr>
            <p:cNvSpPr txBox="1"/>
            <p:nvPr/>
          </p:nvSpPr>
          <p:spPr>
            <a:xfrm>
              <a:off x="1344370" y="6542999"/>
              <a:ext cx="6671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Log [Tam] (M)</a:t>
              </a:r>
            </a:p>
          </p:txBody>
        </p:sp>
        <p:cxnSp>
          <p:nvCxnSpPr>
            <p:cNvPr id="463" name="Connettore diritto 462">
              <a:extLst>
                <a:ext uri="{FF2B5EF4-FFF2-40B4-BE49-F238E27FC236}">
                  <a16:creationId xmlns:a16="http://schemas.microsoft.com/office/drawing/2014/main" id="{E21672B7-C4EA-4633-95B0-4978220DA534}"/>
                </a:ext>
              </a:extLst>
            </p:cNvPr>
            <p:cNvCxnSpPr>
              <a:cxnSpLocks/>
            </p:cNvCxnSpPr>
            <p:nvPr/>
          </p:nvCxnSpPr>
          <p:spPr>
            <a:xfrm>
              <a:off x="679194" y="6578321"/>
              <a:ext cx="19527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4" name="Connettore diritto 463">
              <a:extLst>
                <a:ext uri="{FF2B5EF4-FFF2-40B4-BE49-F238E27FC236}">
                  <a16:creationId xmlns:a16="http://schemas.microsoft.com/office/drawing/2014/main" id="{0FD4ECAA-B422-432A-B511-89C7AAE2DE31}"/>
                </a:ext>
              </a:extLst>
            </p:cNvPr>
            <p:cNvCxnSpPr/>
            <p:nvPr/>
          </p:nvCxnSpPr>
          <p:spPr>
            <a:xfrm>
              <a:off x="1094940" y="5263127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5" name="Connettore diritto 464">
              <a:extLst>
                <a:ext uri="{FF2B5EF4-FFF2-40B4-BE49-F238E27FC236}">
                  <a16:creationId xmlns:a16="http://schemas.microsoft.com/office/drawing/2014/main" id="{068A4C13-7B5E-4D18-B6CE-8CBF57B1A6FE}"/>
                </a:ext>
              </a:extLst>
            </p:cNvPr>
            <p:cNvCxnSpPr/>
            <p:nvPr/>
          </p:nvCxnSpPr>
          <p:spPr>
            <a:xfrm>
              <a:off x="1492710" y="5263127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6" name="Connettore diritto 465">
              <a:extLst>
                <a:ext uri="{FF2B5EF4-FFF2-40B4-BE49-F238E27FC236}">
                  <a16:creationId xmlns:a16="http://schemas.microsoft.com/office/drawing/2014/main" id="{4A551048-81F4-4565-8E01-4F2226C40007}"/>
                </a:ext>
              </a:extLst>
            </p:cNvPr>
            <p:cNvCxnSpPr/>
            <p:nvPr/>
          </p:nvCxnSpPr>
          <p:spPr>
            <a:xfrm>
              <a:off x="1904347" y="5263127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7" name="Connettore diritto 466">
              <a:extLst>
                <a:ext uri="{FF2B5EF4-FFF2-40B4-BE49-F238E27FC236}">
                  <a16:creationId xmlns:a16="http://schemas.microsoft.com/office/drawing/2014/main" id="{3B506123-5E01-43A8-914F-10F4F0CF1B39}"/>
                </a:ext>
              </a:extLst>
            </p:cNvPr>
            <p:cNvCxnSpPr/>
            <p:nvPr/>
          </p:nvCxnSpPr>
          <p:spPr>
            <a:xfrm>
              <a:off x="2300673" y="5263127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8" name="CasellaDiTesto 467">
              <a:extLst>
                <a:ext uri="{FF2B5EF4-FFF2-40B4-BE49-F238E27FC236}">
                  <a16:creationId xmlns:a16="http://schemas.microsoft.com/office/drawing/2014/main" id="{149C2D6E-9141-4042-9136-7141471AE69B}"/>
                </a:ext>
              </a:extLst>
            </p:cNvPr>
            <p:cNvSpPr txBox="1"/>
            <p:nvPr/>
          </p:nvSpPr>
          <p:spPr>
            <a:xfrm>
              <a:off x="1124744" y="5098472"/>
              <a:ext cx="3353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.01</a:t>
              </a:r>
            </a:p>
          </p:txBody>
        </p:sp>
        <p:sp>
          <p:nvSpPr>
            <p:cNvPr id="469" name="CasellaDiTesto 468">
              <a:extLst>
                <a:ext uri="{FF2B5EF4-FFF2-40B4-BE49-F238E27FC236}">
                  <a16:creationId xmlns:a16="http://schemas.microsoft.com/office/drawing/2014/main" id="{5FCE0756-4274-4E8E-ACB6-0E8B3B9DBC2A}"/>
                </a:ext>
              </a:extLst>
            </p:cNvPr>
            <p:cNvSpPr txBox="1"/>
            <p:nvPr/>
          </p:nvSpPr>
          <p:spPr>
            <a:xfrm>
              <a:off x="1521273" y="5098472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.1</a:t>
              </a:r>
            </a:p>
          </p:txBody>
        </p:sp>
        <p:sp>
          <p:nvSpPr>
            <p:cNvPr id="470" name="CasellaDiTesto 469">
              <a:extLst>
                <a:ext uri="{FF2B5EF4-FFF2-40B4-BE49-F238E27FC236}">
                  <a16:creationId xmlns:a16="http://schemas.microsoft.com/office/drawing/2014/main" id="{36052F19-6CC9-48CE-A767-553ECB875D1B}"/>
                </a:ext>
              </a:extLst>
            </p:cNvPr>
            <p:cNvSpPr txBox="1"/>
            <p:nvPr/>
          </p:nvSpPr>
          <p:spPr>
            <a:xfrm>
              <a:off x="1976916" y="509847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</a:t>
              </a:r>
            </a:p>
          </p:txBody>
        </p:sp>
        <p:sp>
          <p:nvSpPr>
            <p:cNvPr id="471" name="CasellaDiTesto 470">
              <a:extLst>
                <a:ext uri="{FF2B5EF4-FFF2-40B4-BE49-F238E27FC236}">
                  <a16:creationId xmlns:a16="http://schemas.microsoft.com/office/drawing/2014/main" id="{EA287B41-28CC-4730-9DE6-2114F301E4CE}"/>
                </a:ext>
              </a:extLst>
            </p:cNvPr>
            <p:cNvSpPr txBox="1"/>
            <p:nvPr/>
          </p:nvSpPr>
          <p:spPr>
            <a:xfrm>
              <a:off x="2330774" y="509847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</a:t>
              </a:r>
            </a:p>
          </p:txBody>
        </p:sp>
        <p:cxnSp>
          <p:nvCxnSpPr>
            <p:cNvPr id="472" name="Connettore diritto 471">
              <a:extLst>
                <a:ext uri="{FF2B5EF4-FFF2-40B4-BE49-F238E27FC236}">
                  <a16:creationId xmlns:a16="http://schemas.microsoft.com/office/drawing/2014/main" id="{0D0A9239-5DFD-48AF-9AE4-7285CB9C0AC0}"/>
                </a:ext>
              </a:extLst>
            </p:cNvPr>
            <p:cNvCxnSpPr>
              <a:cxnSpLocks/>
            </p:cNvCxnSpPr>
            <p:nvPr/>
          </p:nvCxnSpPr>
          <p:spPr>
            <a:xfrm>
              <a:off x="1271934" y="5098472"/>
              <a:ext cx="120915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3" name="CasellaDiTesto 472">
              <a:extLst>
                <a:ext uri="{FF2B5EF4-FFF2-40B4-BE49-F238E27FC236}">
                  <a16:creationId xmlns:a16="http://schemas.microsoft.com/office/drawing/2014/main" id="{D964FAE6-18EA-4A2F-8F42-9CD4EBF2D571}"/>
                </a:ext>
              </a:extLst>
            </p:cNvPr>
            <p:cNvSpPr txBox="1"/>
            <p:nvPr/>
          </p:nvSpPr>
          <p:spPr>
            <a:xfrm>
              <a:off x="1615864" y="4909522"/>
              <a:ext cx="55976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[AZD] (µM)</a:t>
              </a:r>
            </a:p>
          </p:txBody>
        </p:sp>
        <p:sp>
          <p:nvSpPr>
            <p:cNvPr id="474" name="CasellaDiTesto 473">
              <a:extLst>
                <a:ext uri="{FF2B5EF4-FFF2-40B4-BE49-F238E27FC236}">
                  <a16:creationId xmlns:a16="http://schemas.microsoft.com/office/drawing/2014/main" id="{CDE75734-949C-483A-BAB3-B5EFB6A694E0}"/>
                </a:ext>
              </a:extLst>
            </p:cNvPr>
            <p:cNvSpPr txBox="1"/>
            <p:nvPr/>
          </p:nvSpPr>
          <p:spPr>
            <a:xfrm>
              <a:off x="642795" y="6215065"/>
              <a:ext cx="4427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 dirty="0"/>
                <a:t>BT-474</a:t>
              </a:r>
            </a:p>
          </p:txBody>
        </p:sp>
      </p:grpSp>
      <p:grpSp>
        <p:nvGrpSpPr>
          <p:cNvPr id="647" name="Gruppo 646">
            <a:extLst>
              <a:ext uri="{FF2B5EF4-FFF2-40B4-BE49-F238E27FC236}">
                <a16:creationId xmlns:a16="http://schemas.microsoft.com/office/drawing/2014/main" id="{FCDCDFDE-9988-4D6D-A70B-EB7615DBADE9}"/>
              </a:ext>
            </a:extLst>
          </p:cNvPr>
          <p:cNvGrpSpPr/>
          <p:nvPr/>
        </p:nvGrpSpPr>
        <p:grpSpPr>
          <a:xfrm>
            <a:off x="3684394" y="4909522"/>
            <a:ext cx="2480910" cy="1818143"/>
            <a:chOff x="3684394" y="4909522"/>
            <a:chExt cx="2480910" cy="1818143"/>
          </a:xfrm>
        </p:grpSpPr>
        <p:pic>
          <p:nvPicPr>
            <p:cNvPr id="646" name="Immagine 645">
              <a:extLst>
                <a:ext uri="{FF2B5EF4-FFF2-40B4-BE49-F238E27FC236}">
                  <a16:creationId xmlns:a16="http://schemas.microsoft.com/office/drawing/2014/main" id="{C2EEB9F1-78E6-456A-8DA3-99D3C2C7163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042098" y="5047103"/>
              <a:ext cx="2092711" cy="1440000"/>
            </a:xfrm>
            <a:prstGeom prst="rect">
              <a:avLst/>
            </a:prstGeom>
          </p:spPr>
        </p:pic>
        <p:sp>
          <p:nvSpPr>
            <p:cNvPr id="493" name="CasellaDiTesto 492">
              <a:extLst>
                <a:ext uri="{FF2B5EF4-FFF2-40B4-BE49-F238E27FC236}">
                  <a16:creationId xmlns:a16="http://schemas.microsoft.com/office/drawing/2014/main" id="{8F8A3395-4C01-4B63-8711-DB051D5364D8}"/>
                </a:ext>
              </a:extLst>
            </p:cNvPr>
            <p:cNvSpPr txBox="1"/>
            <p:nvPr/>
          </p:nvSpPr>
          <p:spPr>
            <a:xfrm rot="16200000">
              <a:off x="3119676" y="5619034"/>
              <a:ext cx="1406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600" dirty="0" err="1"/>
                <a:t>Number</a:t>
              </a:r>
              <a:r>
                <a:rPr lang="it-IT" sz="600" dirty="0"/>
                <a:t> of </a:t>
              </a:r>
              <a:r>
                <a:rPr lang="it-IT" sz="600" dirty="0" err="1"/>
                <a:t>cells</a:t>
              </a:r>
              <a:endParaRPr lang="it-IT" sz="600" dirty="0"/>
            </a:p>
            <a:p>
              <a:pPr algn="ctr"/>
              <a:r>
                <a:rPr lang="it-IT" sz="600" dirty="0"/>
                <a:t>(% on -)</a:t>
              </a:r>
              <a:endParaRPr lang="it-IT" sz="6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494" name="CasellaDiTesto 493">
              <a:extLst>
                <a:ext uri="{FF2B5EF4-FFF2-40B4-BE49-F238E27FC236}">
                  <a16:creationId xmlns:a16="http://schemas.microsoft.com/office/drawing/2014/main" id="{EB66A413-665A-48BF-BBFD-B2E1719644F0}"/>
                </a:ext>
              </a:extLst>
            </p:cNvPr>
            <p:cNvSpPr txBox="1"/>
            <p:nvPr/>
          </p:nvSpPr>
          <p:spPr>
            <a:xfrm>
              <a:off x="3824953" y="5651451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sp>
          <p:nvSpPr>
            <p:cNvPr id="495" name="CasellaDiTesto 494">
              <a:extLst>
                <a:ext uri="{FF2B5EF4-FFF2-40B4-BE49-F238E27FC236}">
                  <a16:creationId xmlns:a16="http://schemas.microsoft.com/office/drawing/2014/main" id="{9EC5C6A7-FF7E-46DA-927A-D49607370C5B}"/>
                </a:ext>
              </a:extLst>
            </p:cNvPr>
            <p:cNvSpPr txBox="1"/>
            <p:nvPr/>
          </p:nvSpPr>
          <p:spPr>
            <a:xfrm>
              <a:off x="3911515" y="631576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</a:t>
              </a:r>
            </a:p>
          </p:txBody>
        </p:sp>
        <p:sp>
          <p:nvSpPr>
            <p:cNvPr id="496" name="CasellaDiTesto 495">
              <a:extLst>
                <a:ext uri="{FF2B5EF4-FFF2-40B4-BE49-F238E27FC236}">
                  <a16:creationId xmlns:a16="http://schemas.microsoft.com/office/drawing/2014/main" id="{9592C4A5-946A-45BA-9D3A-C03D0CACFE80}"/>
                </a:ext>
              </a:extLst>
            </p:cNvPr>
            <p:cNvSpPr txBox="1"/>
            <p:nvPr/>
          </p:nvSpPr>
          <p:spPr>
            <a:xfrm>
              <a:off x="3824953" y="4985821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00</a:t>
              </a:r>
            </a:p>
          </p:txBody>
        </p:sp>
        <p:sp>
          <p:nvSpPr>
            <p:cNvPr id="497" name="CasellaDiTesto 496">
              <a:extLst>
                <a:ext uri="{FF2B5EF4-FFF2-40B4-BE49-F238E27FC236}">
                  <a16:creationId xmlns:a16="http://schemas.microsoft.com/office/drawing/2014/main" id="{B1750DC6-FACB-46F0-A483-391A24639ACB}"/>
                </a:ext>
              </a:extLst>
            </p:cNvPr>
            <p:cNvSpPr txBox="1"/>
            <p:nvPr/>
          </p:nvSpPr>
          <p:spPr>
            <a:xfrm>
              <a:off x="4047423" y="6415255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498" name="Gruppo 497">
              <a:extLst>
                <a:ext uri="{FF2B5EF4-FFF2-40B4-BE49-F238E27FC236}">
                  <a16:creationId xmlns:a16="http://schemas.microsoft.com/office/drawing/2014/main" id="{9924296E-293E-43B9-8AB8-1B629E170C9F}"/>
                </a:ext>
              </a:extLst>
            </p:cNvPr>
            <p:cNvGrpSpPr/>
            <p:nvPr/>
          </p:nvGrpSpPr>
          <p:grpSpPr>
            <a:xfrm>
              <a:off x="4098240" y="6415255"/>
              <a:ext cx="498353" cy="184666"/>
              <a:chOff x="504190" y="4467019"/>
              <a:chExt cx="498353" cy="184666"/>
            </a:xfrm>
          </p:grpSpPr>
          <p:sp>
            <p:nvSpPr>
              <p:cNvPr id="535" name="CasellaDiTesto 534">
                <a:extLst>
                  <a:ext uri="{FF2B5EF4-FFF2-40B4-BE49-F238E27FC236}">
                    <a16:creationId xmlns:a16="http://schemas.microsoft.com/office/drawing/2014/main" id="{C1D3408A-A059-42DB-99A2-7AFAA26B05F6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536" name="CasellaDiTesto 535">
                <a:extLst>
                  <a:ext uri="{FF2B5EF4-FFF2-40B4-BE49-F238E27FC236}">
                    <a16:creationId xmlns:a16="http://schemas.microsoft.com/office/drawing/2014/main" id="{6B36DDE8-3CE6-4153-B394-15931710389F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537" name="CasellaDiTesto 536">
                <a:extLst>
                  <a:ext uri="{FF2B5EF4-FFF2-40B4-BE49-F238E27FC236}">
                    <a16:creationId xmlns:a16="http://schemas.microsoft.com/office/drawing/2014/main" id="{2B214EC8-118B-424C-986D-AEE89582DA3E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538" name="CasellaDiTesto 537">
                <a:extLst>
                  <a:ext uri="{FF2B5EF4-FFF2-40B4-BE49-F238E27FC236}">
                    <a16:creationId xmlns:a16="http://schemas.microsoft.com/office/drawing/2014/main" id="{6FB9FEF1-BCD9-4E4C-9820-D064C5449F65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499" name="CasellaDiTesto 498">
              <a:extLst>
                <a:ext uri="{FF2B5EF4-FFF2-40B4-BE49-F238E27FC236}">
                  <a16:creationId xmlns:a16="http://schemas.microsoft.com/office/drawing/2014/main" id="{AB8654BD-EC8E-475A-A42B-EDDBA4E0F7C0}"/>
                </a:ext>
              </a:extLst>
            </p:cNvPr>
            <p:cNvSpPr txBox="1"/>
            <p:nvPr/>
          </p:nvSpPr>
          <p:spPr>
            <a:xfrm>
              <a:off x="4444956" y="6415255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500" name="Gruppo 499">
              <a:extLst>
                <a:ext uri="{FF2B5EF4-FFF2-40B4-BE49-F238E27FC236}">
                  <a16:creationId xmlns:a16="http://schemas.microsoft.com/office/drawing/2014/main" id="{F803A680-EFF6-4053-80DF-3BC0934F87A7}"/>
                </a:ext>
              </a:extLst>
            </p:cNvPr>
            <p:cNvGrpSpPr/>
            <p:nvPr/>
          </p:nvGrpSpPr>
          <p:grpSpPr>
            <a:xfrm>
              <a:off x="4495773" y="6415255"/>
              <a:ext cx="498353" cy="184666"/>
              <a:chOff x="504190" y="4467019"/>
              <a:chExt cx="498353" cy="184666"/>
            </a:xfrm>
          </p:grpSpPr>
          <p:sp>
            <p:nvSpPr>
              <p:cNvPr id="531" name="CasellaDiTesto 530">
                <a:extLst>
                  <a:ext uri="{FF2B5EF4-FFF2-40B4-BE49-F238E27FC236}">
                    <a16:creationId xmlns:a16="http://schemas.microsoft.com/office/drawing/2014/main" id="{C4700DAF-E0D3-4D88-B6E2-BFE3650C8D58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532" name="CasellaDiTesto 531">
                <a:extLst>
                  <a:ext uri="{FF2B5EF4-FFF2-40B4-BE49-F238E27FC236}">
                    <a16:creationId xmlns:a16="http://schemas.microsoft.com/office/drawing/2014/main" id="{D88DB357-4B22-47B7-BBED-6B68BE021CAE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533" name="CasellaDiTesto 532">
                <a:extLst>
                  <a:ext uri="{FF2B5EF4-FFF2-40B4-BE49-F238E27FC236}">
                    <a16:creationId xmlns:a16="http://schemas.microsoft.com/office/drawing/2014/main" id="{4BED0A48-ABC9-46D9-9824-206D4E6454E5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534" name="CasellaDiTesto 533">
                <a:extLst>
                  <a:ext uri="{FF2B5EF4-FFF2-40B4-BE49-F238E27FC236}">
                    <a16:creationId xmlns:a16="http://schemas.microsoft.com/office/drawing/2014/main" id="{D809C376-8E20-4F18-836A-7939B8A56B78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501" name="CasellaDiTesto 500">
              <a:extLst>
                <a:ext uri="{FF2B5EF4-FFF2-40B4-BE49-F238E27FC236}">
                  <a16:creationId xmlns:a16="http://schemas.microsoft.com/office/drawing/2014/main" id="{506214B3-322D-4DA9-9E93-406AC9EC9057}"/>
                </a:ext>
              </a:extLst>
            </p:cNvPr>
            <p:cNvSpPr txBox="1"/>
            <p:nvPr/>
          </p:nvSpPr>
          <p:spPr>
            <a:xfrm>
              <a:off x="4836746" y="6415255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502" name="Gruppo 501">
              <a:extLst>
                <a:ext uri="{FF2B5EF4-FFF2-40B4-BE49-F238E27FC236}">
                  <a16:creationId xmlns:a16="http://schemas.microsoft.com/office/drawing/2014/main" id="{5B83387E-8483-49AE-BCC0-6D7B6FE9EAF6}"/>
                </a:ext>
              </a:extLst>
            </p:cNvPr>
            <p:cNvGrpSpPr/>
            <p:nvPr/>
          </p:nvGrpSpPr>
          <p:grpSpPr>
            <a:xfrm>
              <a:off x="4887563" y="6415255"/>
              <a:ext cx="498353" cy="184666"/>
              <a:chOff x="504190" y="4467019"/>
              <a:chExt cx="498353" cy="184666"/>
            </a:xfrm>
          </p:grpSpPr>
          <p:sp>
            <p:nvSpPr>
              <p:cNvPr id="527" name="CasellaDiTesto 526">
                <a:extLst>
                  <a:ext uri="{FF2B5EF4-FFF2-40B4-BE49-F238E27FC236}">
                    <a16:creationId xmlns:a16="http://schemas.microsoft.com/office/drawing/2014/main" id="{A60B9EFA-BCF4-4FDD-B5AC-1E39C2B236D8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528" name="CasellaDiTesto 527">
                <a:extLst>
                  <a:ext uri="{FF2B5EF4-FFF2-40B4-BE49-F238E27FC236}">
                    <a16:creationId xmlns:a16="http://schemas.microsoft.com/office/drawing/2014/main" id="{80742805-0828-4469-9382-B6F29E7B4953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529" name="CasellaDiTesto 528">
                <a:extLst>
                  <a:ext uri="{FF2B5EF4-FFF2-40B4-BE49-F238E27FC236}">
                    <a16:creationId xmlns:a16="http://schemas.microsoft.com/office/drawing/2014/main" id="{590DF2F5-5D47-4395-99D3-E0A6E081E3DD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530" name="CasellaDiTesto 529">
                <a:extLst>
                  <a:ext uri="{FF2B5EF4-FFF2-40B4-BE49-F238E27FC236}">
                    <a16:creationId xmlns:a16="http://schemas.microsoft.com/office/drawing/2014/main" id="{E0457763-A4FD-496C-B612-7D65374BD52C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503" name="CasellaDiTesto 502">
              <a:extLst>
                <a:ext uri="{FF2B5EF4-FFF2-40B4-BE49-F238E27FC236}">
                  <a16:creationId xmlns:a16="http://schemas.microsoft.com/office/drawing/2014/main" id="{FE0797AF-0F1D-4F84-A6A7-32F4EAC13E85}"/>
                </a:ext>
              </a:extLst>
            </p:cNvPr>
            <p:cNvSpPr txBox="1"/>
            <p:nvPr/>
          </p:nvSpPr>
          <p:spPr>
            <a:xfrm>
              <a:off x="5230694" y="6415255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504" name="Gruppo 503">
              <a:extLst>
                <a:ext uri="{FF2B5EF4-FFF2-40B4-BE49-F238E27FC236}">
                  <a16:creationId xmlns:a16="http://schemas.microsoft.com/office/drawing/2014/main" id="{FCD7A0B3-AA41-4DB3-B321-11BB27E3232C}"/>
                </a:ext>
              </a:extLst>
            </p:cNvPr>
            <p:cNvGrpSpPr/>
            <p:nvPr/>
          </p:nvGrpSpPr>
          <p:grpSpPr>
            <a:xfrm>
              <a:off x="5281511" y="6415255"/>
              <a:ext cx="498353" cy="184666"/>
              <a:chOff x="504190" y="4467019"/>
              <a:chExt cx="498353" cy="184666"/>
            </a:xfrm>
          </p:grpSpPr>
          <p:sp>
            <p:nvSpPr>
              <p:cNvPr id="523" name="CasellaDiTesto 522">
                <a:extLst>
                  <a:ext uri="{FF2B5EF4-FFF2-40B4-BE49-F238E27FC236}">
                    <a16:creationId xmlns:a16="http://schemas.microsoft.com/office/drawing/2014/main" id="{7224DAD6-A41B-4213-829A-958D7E965DE4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524" name="CasellaDiTesto 523">
                <a:extLst>
                  <a:ext uri="{FF2B5EF4-FFF2-40B4-BE49-F238E27FC236}">
                    <a16:creationId xmlns:a16="http://schemas.microsoft.com/office/drawing/2014/main" id="{C0426700-26E7-4590-8119-C5EEE479EC4F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525" name="CasellaDiTesto 524">
                <a:extLst>
                  <a:ext uri="{FF2B5EF4-FFF2-40B4-BE49-F238E27FC236}">
                    <a16:creationId xmlns:a16="http://schemas.microsoft.com/office/drawing/2014/main" id="{E08CE6B5-AB40-477A-8E12-40332D3D9C6D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526" name="CasellaDiTesto 525">
                <a:extLst>
                  <a:ext uri="{FF2B5EF4-FFF2-40B4-BE49-F238E27FC236}">
                    <a16:creationId xmlns:a16="http://schemas.microsoft.com/office/drawing/2014/main" id="{1A2A92E9-903F-4A93-B4DE-E8EED16073F9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505" name="CasellaDiTesto 504">
              <a:extLst>
                <a:ext uri="{FF2B5EF4-FFF2-40B4-BE49-F238E27FC236}">
                  <a16:creationId xmlns:a16="http://schemas.microsoft.com/office/drawing/2014/main" id="{7A6F89C5-8046-41A1-8FF7-2E8D62F16423}"/>
                </a:ext>
              </a:extLst>
            </p:cNvPr>
            <p:cNvSpPr txBox="1"/>
            <p:nvPr/>
          </p:nvSpPr>
          <p:spPr>
            <a:xfrm>
              <a:off x="5616134" y="6415255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506" name="CasellaDiTesto 505">
              <a:extLst>
                <a:ext uri="{FF2B5EF4-FFF2-40B4-BE49-F238E27FC236}">
                  <a16:creationId xmlns:a16="http://schemas.microsoft.com/office/drawing/2014/main" id="{FC02F7F0-0C82-4B13-8EEE-F9A6F2B45C7B}"/>
                </a:ext>
              </a:extLst>
            </p:cNvPr>
            <p:cNvSpPr txBox="1"/>
            <p:nvPr/>
          </p:nvSpPr>
          <p:spPr>
            <a:xfrm>
              <a:off x="5666951" y="6415255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9</a:t>
              </a:r>
              <a:endParaRPr lang="it-IT" sz="600" dirty="0"/>
            </a:p>
          </p:txBody>
        </p:sp>
        <p:sp>
          <p:nvSpPr>
            <p:cNvPr id="507" name="CasellaDiTesto 506">
              <a:extLst>
                <a:ext uri="{FF2B5EF4-FFF2-40B4-BE49-F238E27FC236}">
                  <a16:creationId xmlns:a16="http://schemas.microsoft.com/office/drawing/2014/main" id="{741A846B-BF6C-4D73-A1C4-CF02315DAB78}"/>
                </a:ext>
              </a:extLst>
            </p:cNvPr>
            <p:cNvSpPr txBox="1"/>
            <p:nvPr/>
          </p:nvSpPr>
          <p:spPr>
            <a:xfrm>
              <a:off x="5753642" y="6415255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8</a:t>
              </a:r>
              <a:endParaRPr lang="it-IT" sz="600" dirty="0"/>
            </a:p>
          </p:txBody>
        </p:sp>
        <p:sp>
          <p:nvSpPr>
            <p:cNvPr id="508" name="CasellaDiTesto 507">
              <a:extLst>
                <a:ext uri="{FF2B5EF4-FFF2-40B4-BE49-F238E27FC236}">
                  <a16:creationId xmlns:a16="http://schemas.microsoft.com/office/drawing/2014/main" id="{AEEBBD4C-AB32-4A3D-87BE-2534D8CAB2E4}"/>
                </a:ext>
              </a:extLst>
            </p:cNvPr>
            <p:cNvSpPr txBox="1"/>
            <p:nvPr/>
          </p:nvSpPr>
          <p:spPr>
            <a:xfrm>
              <a:off x="5841841" y="6415255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7</a:t>
              </a:r>
              <a:endParaRPr lang="it-IT" sz="600" dirty="0"/>
            </a:p>
          </p:txBody>
        </p:sp>
        <p:sp>
          <p:nvSpPr>
            <p:cNvPr id="509" name="CasellaDiTesto 508">
              <a:extLst>
                <a:ext uri="{FF2B5EF4-FFF2-40B4-BE49-F238E27FC236}">
                  <a16:creationId xmlns:a16="http://schemas.microsoft.com/office/drawing/2014/main" id="{9F8AA899-8505-4374-B6B4-D2044DF6EAB2}"/>
                </a:ext>
              </a:extLst>
            </p:cNvPr>
            <p:cNvSpPr txBox="1"/>
            <p:nvPr/>
          </p:nvSpPr>
          <p:spPr>
            <a:xfrm>
              <a:off x="5911708" y="6415255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6</a:t>
              </a:r>
              <a:endParaRPr lang="it-IT" sz="600" dirty="0"/>
            </a:p>
          </p:txBody>
        </p:sp>
        <p:sp>
          <p:nvSpPr>
            <p:cNvPr id="510" name="CasellaDiTesto 509">
              <a:extLst>
                <a:ext uri="{FF2B5EF4-FFF2-40B4-BE49-F238E27FC236}">
                  <a16:creationId xmlns:a16="http://schemas.microsoft.com/office/drawing/2014/main" id="{E75488A4-607D-4799-99BB-658DBD983CA0}"/>
                </a:ext>
              </a:extLst>
            </p:cNvPr>
            <p:cNvSpPr txBox="1"/>
            <p:nvPr/>
          </p:nvSpPr>
          <p:spPr>
            <a:xfrm>
              <a:off x="4762186" y="6542999"/>
              <a:ext cx="6671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Log [Tam] (M)</a:t>
              </a:r>
            </a:p>
          </p:txBody>
        </p:sp>
        <p:cxnSp>
          <p:nvCxnSpPr>
            <p:cNvPr id="511" name="Connettore diritto 510">
              <a:extLst>
                <a:ext uri="{FF2B5EF4-FFF2-40B4-BE49-F238E27FC236}">
                  <a16:creationId xmlns:a16="http://schemas.microsoft.com/office/drawing/2014/main" id="{28985A15-5A7B-429D-A8F3-E5355A40F787}"/>
                </a:ext>
              </a:extLst>
            </p:cNvPr>
            <p:cNvCxnSpPr>
              <a:cxnSpLocks/>
            </p:cNvCxnSpPr>
            <p:nvPr/>
          </p:nvCxnSpPr>
          <p:spPr>
            <a:xfrm>
              <a:off x="4104630" y="6578321"/>
              <a:ext cx="19527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2" name="Connettore diritto 511">
              <a:extLst>
                <a:ext uri="{FF2B5EF4-FFF2-40B4-BE49-F238E27FC236}">
                  <a16:creationId xmlns:a16="http://schemas.microsoft.com/office/drawing/2014/main" id="{ACCBEF80-7992-4B64-B54C-E4D30A8F2296}"/>
                </a:ext>
              </a:extLst>
            </p:cNvPr>
            <p:cNvCxnSpPr/>
            <p:nvPr/>
          </p:nvCxnSpPr>
          <p:spPr>
            <a:xfrm>
              <a:off x="4520376" y="5263127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3" name="Connettore diritto 512">
              <a:extLst>
                <a:ext uri="{FF2B5EF4-FFF2-40B4-BE49-F238E27FC236}">
                  <a16:creationId xmlns:a16="http://schemas.microsoft.com/office/drawing/2014/main" id="{2BF5D0D2-52B9-4F80-A895-4D6892D8E6D9}"/>
                </a:ext>
              </a:extLst>
            </p:cNvPr>
            <p:cNvCxnSpPr/>
            <p:nvPr/>
          </p:nvCxnSpPr>
          <p:spPr>
            <a:xfrm>
              <a:off x="4918146" y="5263127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4" name="Connettore diritto 513">
              <a:extLst>
                <a:ext uri="{FF2B5EF4-FFF2-40B4-BE49-F238E27FC236}">
                  <a16:creationId xmlns:a16="http://schemas.microsoft.com/office/drawing/2014/main" id="{1CC1669D-226F-4999-9F21-F13BB3CC1729}"/>
                </a:ext>
              </a:extLst>
            </p:cNvPr>
            <p:cNvCxnSpPr/>
            <p:nvPr/>
          </p:nvCxnSpPr>
          <p:spPr>
            <a:xfrm>
              <a:off x="5329783" y="5263127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5" name="Connettore diritto 514">
              <a:extLst>
                <a:ext uri="{FF2B5EF4-FFF2-40B4-BE49-F238E27FC236}">
                  <a16:creationId xmlns:a16="http://schemas.microsoft.com/office/drawing/2014/main" id="{9695440E-48B3-4099-B5A6-45319191F190}"/>
                </a:ext>
              </a:extLst>
            </p:cNvPr>
            <p:cNvCxnSpPr/>
            <p:nvPr/>
          </p:nvCxnSpPr>
          <p:spPr>
            <a:xfrm>
              <a:off x="5726109" y="5263127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6" name="CasellaDiTesto 515">
              <a:extLst>
                <a:ext uri="{FF2B5EF4-FFF2-40B4-BE49-F238E27FC236}">
                  <a16:creationId xmlns:a16="http://schemas.microsoft.com/office/drawing/2014/main" id="{E5D0DFB1-0115-4CF0-8D9C-65F521285CE4}"/>
                </a:ext>
              </a:extLst>
            </p:cNvPr>
            <p:cNvSpPr txBox="1"/>
            <p:nvPr/>
          </p:nvSpPr>
          <p:spPr>
            <a:xfrm>
              <a:off x="4583396" y="509847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</a:t>
              </a:r>
            </a:p>
          </p:txBody>
        </p:sp>
        <p:sp>
          <p:nvSpPr>
            <p:cNvPr id="517" name="CasellaDiTesto 516">
              <a:extLst>
                <a:ext uri="{FF2B5EF4-FFF2-40B4-BE49-F238E27FC236}">
                  <a16:creationId xmlns:a16="http://schemas.microsoft.com/office/drawing/2014/main" id="{3EB52F5C-871E-4473-886E-65098533A660}"/>
                </a:ext>
              </a:extLst>
            </p:cNvPr>
            <p:cNvSpPr txBox="1"/>
            <p:nvPr/>
          </p:nvSpPr>
          <p:spPr>
            <a:xfrm>
              <a:off x="4922894" y="509847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</a:t>
              </a:r>
            </a:p>
          </p:txBody>
        </p:sp>
        <p:sp>
          <p:nvSpPr>
            <p:cNvPr id="518" name="CasellaDiTesto 517">
              <a:extLst>
                <a:ext uri="{FF2B5EF4-FFF2-40B4-BE49-F238E27FC236}">
                  <a16:creationId xmlns:a16="http://schemas.microsoft.com/office/drawing/2014/main" id="{413D9821-24F8-4FA9-ADBA-6879A87E710C}"/>
                </a:ext>
              </a:extLst>
            </p:cNvPr>
            <p:cNvSpPr txBox="1"/>
            <p:nvPr/>
          </p:nvSpPr>
          <p:spPr>
            <a:xfrm>
              <a:off x="5378395" y="509847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50</a:t>
              </a:r>
            </a:p>
          </p:txBody>
        </p:sp>
        <p:sp>
          <p:nvSpPr>
            <p:cNvPr id="519" name="CasellaDiTesto 518">
              <a:extLst>
                <a:ext uri="{FF2B5EF4-FFF2-40B4-BE49-F238E27FC236}">
                  <a16:creationId xmlns:a16="http://schemas.microsoft.com/office/drawing/2014/main" id="{485ACBC2-3145-4789-A310-4131F77D804A}"/>
                </a:ext>
              </a:extLst>
            </p:cNvPr>
            <p:cNvSpPr txBox="1"/>
            <p:nvPr/>
          </p:nvSpPr>
          <p:spPr>
            <a:xfrm>
              <a:off x="5727632" y="5098472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cxnSp>
          <p:nvCxnSpPr>
            <p:cNvPr id="520" name="Connettore diritto 519">
              <a:extLst>
                <a:ext uri="{FF2B5EF4-FFF2-40B4-BE49-F238E27FC236}">
                  <a16:creationId xmlns:a16="http://schemas.microsoft.com/office/drawing/2014/main" id="{8A2895EA-3DF6-4FC9-BB2E-E4B30B765F8F}"/>
                </a:ext>
              </a:extLst>
            </p:cNvPr>
            <p:cNvCxnSpPr>
              <a:cxnSpLocks/>
            </p:cNvCxnSpPr>
            <p:nvPr/>
          </p:nvCxnSpPr>
          <p:spPr>
            <a:xfrm>
              <a:off x="4697370" y="5098472"/>
              <a:ext cx="120915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1" name="CasellaDiTesto 520">
              <a:extLst>
                <a:ext uri="{FF2B5EF4-FFF2-40B4-BE49-F238E27FC236}">
                  <a16:creationId xmlns:a16="http://schemas.microsoft.com/office/drawing/2014/main" id="{E72D8EA0-E475-42CE-9DBF-2CF94A70D7C1}"/>
                </a:ext>
              </a:extLst>
            </p:cNvPr>
            <p:cNvSpPr txBox="1"/>
            <p:nvPr/>
          </p:nvSpPr>
          <p:spPr>
            <a:xfrm>
              <a:off x="5041300" y="4909522"/>
              <a:ext cx="6078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[</a:t>
              </a:r>
              <a:r>
                <a:rPr lang="it-IT" sz="600" dirty="0" err="1"/>
                <a:t>Prexa</a:t>
              </a:r>
              <a:r>
                <a:rPr lang="it-IT" sz="600" dirty="0"/>
                <a:t>] (</a:t>
              </a:r>
              <a:r>
                <a:rPr lang="it-IT" sz="600" dirty="0" err="1"/>
                <a:t>nM</a:t>
              </a:r>
              <a:r>
                <a:rPr lang="it-IT" sz="600" dirty="0"/>
                <a:t>)</a:t>
              </a:r>
            </a:p>
          </p:txBody>
        </p:sp>
        <p:sp>
          <p:nvSpPr>
            <p:cNvPr id="522" name="CasellaDiTesto 521">
              <a:extLst>
                <a:ext uri="{FF2B5EF4-FFF2-40B4-BE49-F238E27FC236}">
                  <a16:creationId xmlns:a16="http://schemas.microsoft.com/office/drawing/2014/main" id="{D0E01DA4-8CD2-4297-B038-05C61AA07F41}"/>
                </a:ext>
              </a:extLst>
            </p:cNvPr>
            <p:cNvSpPr txBox="1"/>
            <p:nvPr/>
          </p:nvSpPr>
          <p:spPr>
            <a:xfrm>
              <a:off x="4068231" y="6215065"/>
              <a:ext cx="4427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 dirty="0"/>
                <a:t>BT-474</a:t>
              </a:r>
            </a:p>
          </p:txBody>
        </p:sp>
      </p:grpSp>
      <p:grpSp>
        <p:nvGrpSpPr>
          <p:cNvPr id="700" name="Gruppo 699">
            <a:extLst>
              <a:ext uri="{FF2B5EF4-FFF2-40B4-BE49-F238E27FC236}">
                <a16:creationId xmlns:a16="http://schemas.microsoft.com/office/drawing/2014/main" id="{18473F21-C422-40C6-8B4B-06579E10DC59}"/>
              </a:ext>
            </a:extLst>
          </p:cNvPr>
          <p:cNvGrpSpPr/>
          <p:nvPr/>
        </p:nvGrpSpPr>
        <p:grpSpPr>
          <a:xfrm>
            <a:off x="3684394" y="7074337"/>
            <a:ext cx="2480910" cy="1818143"/>
            <a:chOff x="3684394" y="7074337"/>
            <a:chExt cx="2480910" cy="1818143"/>
          </a:xfrm>
        </p:grpSpPr>
        <p:pic>
          <p:nvPicPr>
            <p:cNvPr id="699" name="Immagine 698">
              <a:extLst>
                <a:ext uri="{FF2B5EF4-FFF2-40B4-BE49-F238E27FC236}">
                  <a16:creationId xmlns:a16="http://schemas.microsoft.com/office/drawing/2014/main" id="{4F7021EE-0FA7-47C8-9F38-60C8B83560E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042098" y="7211918"/>
              <a:ext cx="2083686" cy="1440000"/>
            </a:xfrm>
            <a:prstGeom prst="rect">
              <a:avLst/>
            </a:prstGeom>
          </p:spPr>
        </p:pic>
        <p:sp>
          <p:nvSpPr>
            <p:cNvPr id="589" name="CasellaDiTesto 588">
              <a:extLst>
                <a:ext uri="{FF2B5EF4-FFF2-40B4-BE49-F238E27FC236}">
                  <a16:creationId xmlns:a16="http://schemas.microsoft.com/office/drawing/2014/main" id="{6E0DF1F5-637A-49A8-AC51-61AB0A94C533}"/>
                </a:ext>
              </a:extLst>
            </p:cNvPr>
            <p:cNvSpPr txBox="1"/>
            <p:nvPr/>
          </p:nvSpPr>
          <p:spPr>
            <a:xfrm rot="16200000">
              <a:off x="3119676" y="7783849"/>
              <a:ext cx="1406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600" dirty="0" err="1"/>
                <a:t>Number</a:t>
              </a:r>
              <a:r>
                <a:rPr lang="it-IT" sz="600" dirty="0"/>
                <a:t> of </a:t>
              </a:r>
              <a:r>
                <a:rPr lang="it-IT" sz="600" dirty="0" err="1"/>
                <a:t>cells</a:t>
              </a:r>
              <a:endParaRPr lang="it-IT" sz="600" dirty="0"/>
            </a:p>
            <a:p>
              <a:pPr algn="ctr"/>
              <a:r>
                <a:rPr lang="it-IT" sz="600" dirty="0"/>
                <a:t>(% on -)</a:t>
              </a:r>
              <a:endParaRPr lang="it-IT" sz="6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590" name="CasellaDiTesto 589">
              <a:extLst>
                <a:ext uri="{FF2B5EF4-FFF2-40B4-BE49-F238E27FC236}">
                  <a16:creationId xmlns:a16="http://schemas.microsoft.com/office/drawing/2014/main" id="{BFC5C06F-90BE-4E34-89EA-836A8ACFACD0}"/>
                </a:ext>
              </a:extLst>
            </p:cNvPr>
            <p:cNvSpPr txBox="1"/>
            <p:nvPr/>
          </p:nvSpPr>
          <p:spPr>
            <a:xfrm>
              <a:off x="3824953" y="7816266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sp>
          <p:nvSpPr>
            <p:cNvPr id="591" name="CasellaDiTesto 590">
              <a:extLst>
                <a:ext uri="{FF2B5EF4-FFF2-40B4-BE49-F238E27FC236}">
                  <a16:creationId xmlns:a16="http://schemas.microsoft.com/office/drawing/2014/main" id="{02C54E61-EB21-4752-BB1B-47B3219A0AF6}"/>
                </a:ext>
              </a:extLst>
            </p:cNvPr>
            <p:cNvSpPr txBox="1"/>
            <p:nvPr/>
          </p:nvSpPr>
          <p:spPr>
            <a:xfrm>
              <a:off x="3911515" y="848058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</a:t>
              </a:r>
            </a:p>
          </p:txBody>
        </p:sp>
        <p:sp>
          <p:nvSpPr>
            <p:cNvPr id="592" name="CasellaDiTesto 591">
              <a:extLst>
                <a:ext uri="{FF2B5EF4-FFF2-40B4-BE49-F238E27FC236}">
                  <a16:creationId xmlns:a16="http://schemas.microsoft.com/office/drawing/2014/main" id="{B7831C9C-8EB9-4E8B-831F-A01434CB4FB3}"/>
                </a:ext>
              </a:extLst>
            </p:cNvPr>
            <p:cNvSpPr txBox="1"/>
            <p:nvPr/>
          </p:nvSpPr>
          <p:spPr>
            <a:xfrm>
              <a:off x="3824953" y="7150636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00</a:t>
              </a:r>
            </a:p>
          </p:txBody>
        </p:sp>
        <p:sp>
          <p:nvSpPr>
            <p:cNvPr id="593" name="CasellaDiTesto 592">
              <a:extLst>
                <a:ext uri="{FF2B5EF4-FFF2-40B4-BE49-F238E27FC236}">
                  <a16:creationId xmlns:a16="http://schemas.microsoft.com/office/drawing/2014/main" id="{53FDF580-07B7-4A39-B26E-593580AD202E}"/>
                </a:ext>
              </a:extLst>
            </p:cNvPr>
            <p:cNvSpPr txBox="1"/>
            <p:nvPr/>
          </p:nvSpPr>
          <p:spPr>
            <a:xfrm>
              <a:off x="4047423" y="858007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594" name="Gruppo 593">
              <a:extLst>
                <a:ext uri="{FF2B5EF4-FFF2-40B4-BE49-F238E27FC236}">
                  <a16:creationId xmlns:a16="http://schemas.microsoft.com/office/drawing/2014/main" id="{61BEA5F9-F8CC-45E0-B4D1-AAFCCE37BE3E}"/>
                </a:ext>
              </a:extLst>
            </p:cNvPr>
            <p:cNvGrpSpPr/>
            <p:nvPr/>
          </p:nvGrpSpPr>
          <p:grpSpPr>
            <a:xfrm>
              <a:off x="4098240" y="8580070"/>
              <a:ext cx="498353" cy="184666"/>
              <a:chOff x="504190" y="4467019"/>
              <a:chExt cx="498353" cy="184666"/>
            </a:xfrm>
          </p:grpSpPr>
          <p:sp>
            <p:nvSpPr>
              <p:cNvPr id="631" name="CasellaDiTesto 630">
                <a:extLst>
                  <a:ext uri="{FF2B5EF4-FFF2-40B4-BE49-F238E27FC236}">
                    <a16:creationId xmlns:a16="http://schemas.microsoft.com/office/drawing/2014/main" id="{A3E779B6-F8BE-4BC1-873C-00FE18E7687F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632" name="CasellaDiTesto 631">
                <a:extLst>
                  <a:ext uri="{FF2B5EF4-FFF2-40B4-BE49-F238E27FC236}">
                    <a16:creationId xmlns:a16="http://schemas.microsoft.com/office/drawing/2014/main" id="{139548C7-F647-48D1-A22F-9D2C8A831114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633" name="CasellaDiTesto 632">
                <a:extLst>
                  <a:ext uri="{FF2B5EF4-FFF2-40B4-BE49-F238E27FC236}">
                    <a16:creationId xmlns:a16="http://schemas.microsoft.com/office/drawing/2014/main" id="{4DD86099-E655-43A7-B959-696B2E1A5444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634" name="CasellaDiTesto 633">
                <a:extLst>
                  <a:ext uri="{FF2B5EF4-FFF2-40B4-BE49-F238E27FC236}">
                    <a16:creationId xmlns:a16="http://schemas.microsoft.com/office/drawing/2014/main" id="{7FD5B549-B3E6-4943-B587-6AF1CCB31865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595" name="CasellaDiTesto 594">
              <a:extLst>
                <a:ext uri="{FF2B5EF4-FFF2-40B4-BE49-F238E27FC236}">
                  <a16:creationId xmlns:a16="http://schemas.microsoft.com/office/drawing/2014/main" id="{77EC5409-D934-4CF8-9A6F-85EC6E590EDF}"/>
                </a:ext>
              </a:extLst>
            </p:cNvPr>
            <p:cNvSpPr txBox="1"/>
            <p:nvPr/>
          </p:nvSpPr>
          <p:spPr>
            <a:xfrm>
              <a:off x="4444956" y="858007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596" name="Gruppo 595">
              <a:extLst>
                <a:ext uri="{FF2B5EF4-FFF2-40B4-BE49-F238E27FC236}">
                  <a16:creationId xmlns:a16="http://schemas.microsoft.com/office/drawing/2014/main" id="{BD443815-970A-49F3-93F6-57A08B231337}"/>
                </a:ext>
              </a:extLst>
            </p:cNvPr>
            <p:cNvGrpSpPr/>
            <p:nvPr/>
          </p:nvGrpSpPr>
          <p:grpSpPr>
            <a:xfrm>
              <a:off x="4495773" y="8580070"/>
              <a:ext cx="498353" cy="184666"/>
              <a:chOff x="504190" y="4467019"/>
              <a:chExt cx="498353" cy="184666"/>
            </a:xfrm>
          </p:grpSpPr>
          <p:sp>
            <p:nvSpPr>
              <p:cNvPr id="627" name="CasellaDiTesto 626">
                <a:extLst>
                  <a:ext uri="{FF2B5EF4-FFF2-40B4-BE49-F238E27FC236}">
                    <a16:creationId xmlns:a16="http://schemas.microsoft.com/office/drawing/2014/main" id="{F4675958-9F06-436D-A289-B6FF7D9A1408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628" name="CasellaDiTesto 627">
                <a:extLst>
                  <a:ext uri="{FF2B5EF4-FFF2-40B4-BE49-F238E27FC236}">
                    <a16:creationId xmlns:a16="http://schemas.microsoft.com/office/drawing/2014/main" id="{B931B173-AF83-47A2-8A0D-349F42D348C1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629" name="CasellaDiTesto 628">
                <a:extLst>
                  <a:ext uri="{FF2B5EF4-FFF2-40B4-BE49-F238E27FC236}">
                    <a16:creationId xmlns:a16="http://schemas.microsoft.com/office/drawing/2014/main" id="{F28E01FC-5D13-4B80-8229-828E999EB840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630" name="CasellaDiTesto 629">
                <a:extLst>
                  <a:ext uri="{FF2B5EF4-FFF2-40B4-BE49-F238E27FC236}">
                    <a16:creationId xmlns:a16="http://schemas.microsoft.com/office/drawing/2014/main" id="{49D5B616-BF61-4AE5-81D4-DFD17A0E26C4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597" name="CasellaDiTesto 596">
              <a:extLst>
                <a:ext uri="{FF2B5EF4-FFF2-40B4-BE49-F238E27FC236}">
                  <a16:creationId xmlns:a16="http://schemas.microsoft.com/office/drawing/2014/main" id="{ADDEA70B-86F6-44E5-A7F2-E6FD60988DD7}"/>
                </a:ext>
              </a:extLst>
            </p:cNvPr>
            <p:cNvSpPr txBox="1"/>
            <p:nvPr/>
          </p:nvSpPr>
          <p:spPr>
            <a:xfrm>
              <a:off x="4836746" y="858007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598" name="Gruppo 597">
              <a:extLst>
                <a:ext uri="{FF2B5EF4-FFF2-40B4-BE49-F238E27FC236}">
                  <a16:creationId xmlns:a16="http://schemas.microsoft.com/office/drawing/2014/main" id="{B7AC5287-1246-4BD1-8293-3C8C6A33F841}"/>
                </a:ext>
              </a:extLst>
            </p:cNvPr>
            <p:cNvGrpSpPr/>
            <p:nvPr/>
          </p:nvGrpSpPr>
          <p:grpSpPr>
            <a:xfrm>
              <a:off x="4887563" y="8580070"/>
              <a:ext cx="498353" cy="184666"/>
              <a:chOff x="504190" y="4467019"/>
              <a:chExt cx="498353" cy="184666"/>
            </a:xfrm>
          </p:grpSpPr>
          <p:sp>
            <p:nvSpPr>
              <p:cNvPr id="623" name="CasellaDiTesto 622">
                <a:extLst>
                  <a:ext uri="{FF2B5EF4-FFF2-40B4-BE49-F238E27FC236}">
                    <a16:creationId xmlns:a16="http://schemas.microsoft.com/office/drawing/2014/main" id="{C4EF245E-8271-4FEC-A1D6-01081162F3CF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624" name="CasellaDiTesto 623">
                <a:extLst>
                  <a:ext uri="{FF2B5EF4-FFF2-40B4-BE49-F238E27FC236}">
                    <a16:creationId xmlns:a16="http://schemas.microsoft.com/office/drawing/2014/main" id="{9D1C002B-12E0-4B98-A1D2-4A433F678E9F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625" name="CasellaDiTesto 624">
                <a:extLst>
                  <a:ext uri="{FF2B5EF4-FFF2-40B4-BE49-F238E27FC236}">
                    <a16:creationId xmlns:a16="http://schemas.microsoft.com/office/drawing/2014/main" id="{628AE210-4265-4244-A9E4-ABC8337DB857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626" name="CasellaDiTesto 625">
                <a:extLst>
                  <a:ext uri="{FF2B5EF4-FFF2-40B4-BE49-F238E27FC236}">
                    <a16:creationId xmlns:a16="http://schemas.microsoft.com/office/drawing/2014/main" id="{11886847-0A3B-4285-B692-C21059AED659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599" name="CasellaDiTesto 598">
              <a:extLst>
                <a:ext uri="{FF2B5EF4-FFF2-40B4-BE49-F238E27FC236}">
                  <a16:creationId xmlns:a16="http://schemas.microsoft.com/office/drawing/2014/main" id="{8E1C77B2-4B09-46D9-961E-6AF37BA0E732}"/>
                </a:ext>
              </a:extLst>
            </p:cNvPr>
            <p:cNvSpPr txBox="1"/>
            <p:nvPr/>
          </p:nvSpPr>
          <p:spPr>
            <a:xfrm>
              <a:off x="5230694" y="858007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600" name="Gruppo 599">
              <a:extLst>
                <a:ext uri="{FF2B5EF4-FFF2-40B4-BE49-F238E27FC236}">
                  <a16:creationId xmlns:a16="http://schemas.microsoft.com/office/drawing/2014/main" id="{584ED147-ADF2-495D-8665-E1C68F67C041}"/>
                </a:ext>
              </a:extLst>
            </p:cNvPr>
            <p:cNvGrpSpPr/>
            <p:nvPr/>
          </p:nvGrpSpPr>
          <p:grpSpPr>
            <a:xfrm>
              <a:off x="5281511" y="8580070"/>
              <a:ext cx="498353" cy="184666"/>
              <a:chOff x="504190" y="4467019"/>
              <a:chExt cx="498353" cy="184666"/>
            </a:xfrm>
          </p:grpSpPr>
          <p:sp>
            <p:nvSpPr>
              <p:cNvPr id="619" name="CasellaDiTesto 618">
                <a:extLst>
                  <a:ext uri="{FF2B5EF4-FFF2-40B4-BE49-F238E27FC236}">
                    <a16:creationId xmlns:a16="http://schemas.microsoft.com/office/drawing/2014/main" id="{816F01DE-FEE2-46AF-8B1D-50F2E3DA68C5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620" name="CasellaDiTesto 619">
                <a:extLst>
                  <a:ext uri="{FF2B5EF4-FFF2-40B4-BE49-F238E27FC236}">
                    <a16:creationId xmlns:a16="http://schemas.microsoft.com/office/drawing/2014/main" id="{12BC550C-91E9-421E-ADF1-798BA61B7FA9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621" name="CasellaDiTesto 620">
                <a:extLst>
                  <a:ext uri="{FF2B5EF4-FFF2-40B4-BE49-F238E27FC236}">
                    <a16:creationId xmlns:a16="http://schemas.microsoft.com/office/drawing/2014/main" id="{EF84994E-9AC4-4FBB-B9DA-07A8EFD53E96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622" name="CasellaDiTesto 621">
                <a:extLst>
                  <a:ext uri="{FF2B5EF4-FFF2-40B4-BE49-F238E27FC236}">
                    <a16:creationId xmlns:a16="http://schemas.microsoft.com/office/drawing/2014/main" id="{558FE6D6-FFC5-4835-984F-048DC337B742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601" name="CasellaDiTesto 600">
              <a:extLst>
                <a:ext uri="{FF2B5EF4-FFF2-40B4-BE49-F238E27FC236}">
                  <a16:creationId xmlns:a16="http://schemas.microsoft.com/office/drawing/2014/main" id="{0E277147-641A-4A30-8C58-F47226FE4043}"/>
                </a:ext>
              </a:extLst>
            </p:cNvPr>
            <p:cNvSpPr txBox="1"/>
            <p:nvPr/>
          </p:nvSpPr>
          <p:spPr>
            <a:xfrm>
              <a:off x="5616134" y="858007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602" name="CasellaDiTesto 601">
              <a:extLst>
                <a:ext uri="{FF2B5EF4-FFF2-40B4-BE49-F238E27FC236}">
                  <a16:creationId xmlns:a16="http://schemas.microsoft.com/office/drawing/2014/main" id="{D04A359A-B36E-4606-857F-AD73E1CAD30C}"/>
                </a:ext>
              </a:extLst>
            </p:cNvPr>
            <p:cNvSpPr txBox="1"/>
            <p:nvPr/>
          </p:nvSpPr>
          <p:spPr>
            <a:xfrm>
              <a:off x="5666951" y="858007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9</a:t>
              </a:r>
              <a:endParaRPr lang="it-IT" sz="600" dirty="0"/>
            </a:p>
          </p:txBody>
        </p:sp>
        <p:sp>
          <p:nvSpPr>
            <p:cNvPr id="603" name="CasellaDiTesto 602">
              <a:extLst>
                <a:ext uri="{FF2B5EF4-FFF2-40B4-BE49-F238E27FC236}">
                  <a16:creationId xmlns:a16="http://schemas.microsoft.com/office/drawing/2014/main" id="{257EF9A7-FAF4-4670-A6C5-0A948AC6CF0B}"/>
                </a:ext>
              </a:extLst>
            </p:cNvPr>
            <p:cNvSpPr txBox="1"/>
            <p:nvPr/>
          </p:nvSpPr>
          <p:spPr>
            <a:xfrm>
              <a:off x="5753642" y="858007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8</a:t>
              </a:r>
              <a:endParaRPr lang="it-IT" sz="600" dirty="0"/>
            </a:p>
          </p:txBody>
        </p:sp>
        <p:sp>
          <p:nvSpPr>
            <p:cNvPr id="604" name="CasellaDiTesto 603">
              <a:extLst>
                <a:ext uri="{FF2B5EF4-FFF2-40B4-BE49-F238E27FC236}">
                  <a16:creationId xmlns:a16="http://schemas.microsoft.com/office/drawing/2014/main" id="{E7B15C83-CC04-463C-83A7-04DB96B1BA94}"/>
                </a:ext>
              </a:extLst>
            </p:cNvPr>
            <p:cNvSpPr txBox="1"/>
            <p:nvPr/>
          </p:nvSpPr>
          <p:spPr>
            <a:xfrm>
              <a:off x="5841841" y="858007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7</a:t>
              </a:r>
              <a:endParaRPr lang="it-IT" sz="600" dirty="0"/>
            </a:p>
          </p:txBody>
        </p:sp>
        <p:sp>
          <p:nvSpPr>
            <p:cNvPr id="605" name="CasellaDiTesto 604">
              <a:extLst>
                <a:ext uri="{FF2B5EF4-FFF2-40B4-BE49-F238E27FC236}">
                  <a16:creationId xmlns:a16="http://schemas.microsoft.com/office/drawing/2014/main" id="{8BBBF029-6C5A-4B80-B4D4-4A856A31A1A5}"/>
                </a:ext>
              </a:extLst>
            </p:cNvPr>
            <p:cNvSpPr txBox="1"/>
            <p:nvPr/>
          </p:nvSpPr>
          <p:spPr>
            <a:xfrm>
              <a:off x="5911708" y="858007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6</a:t>
              </a:r>
              <a:endParaRPr lang="it-IT" sz="600" dirty="0"/>
            </a:p>
          </p:txBody>
        </p:sp>
        <p:sp>
          <p:nvSpPr>
            <p:cNvPr id="606" name="CasellaDiTesto 605">
              <a:extLst>
                <a:ext uri="{FF2B5EF4-FFF2-40B4-BE49-F238E27FC236}">
                  <a16:creationId xmlns:a16="http://schemas.microsoft.com/office/drawing/2014/main" id="{CCF58735-059F-4197-B075-69777F6E57B1}"/>
                </a:ext>
              </a:extLst>
            </p:cNvPr>
            <p:cNvSpPr txBox="1"/>
            <p:nvPr/>
          </p:nvSpPr>
          <p:spPr>
            <a:xfrm>
              <a:off x="4762186" y="8707814"/>
              <a:ext cx="6671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Log [Tam] (M)</a:t>
              </a:r>
            </a:p>
          </p:txBody>
        </p:sp>
        <p:cxnSp>
          <p:nvCxnSpPr>
            <p:cNvPr id="607" name="Connettore diritto 606">
              <a:extLst>
                <a:ext uri="{FF2B5EF4-FFF2-40B4-BE49-F238E27FC236}">
                  <a16:creationId xmlns:a16="http://schemas.microsoft.com/office/drawing/2014/main" id="{C1B93300-BA25-4BCA-AB8E-446812609807}"/>
                </a:ext>
              </a:extLst>
            </p:cNvPr>
            <p:cNvCxnSpPr>
              <a:cxnSpLocks/>
            </p:cNvCxnSpPr>
            <p:nvPr/>
          </p:nvCxnSpPr>
          <p:spPr>
            <a:xfrm>
              <a:off x="4104630" y="8743136"/>
              <a:ext cx="19527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8" name="Connettore diritto 607">
              <a:extLst>
                <a:ext uri="{FF2B5EF4-FFF2-40B4-BE49-F238E27FC236}">
                  <a16:creationId xmlns:a16="http://schemas.microsoft.com/office/drawing/2014/main" id="{7D801328-C6FB-462C-9B6E-B144CE3DB605}"/>
                </a:ext>
              </a:extLst>
            </p:cNvPr>
            <p:cNvCxnSpPr/>
            <p:nvPr/>
          </p:nvCxnSpPr>
          <p:spPr>
            <a:xfrm>
              <a:off x="4520376" y="742794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9" name="Connettore diritto 608">
              <a:extLst>
                <a:ext uri="{FF2B5EF4-FFF2-40B4-BE49-F238E27FC236}">
                  <a16:creationId xmlns:a16="http://schemas.microsoft.com/office/drawing/2014/main" id="{FB8FD791-F69B-40EA-99BD-4BD84F15E368}"/>
                </a:ext>
              </a:extLst>
            </p:cNvPr>
            <p:cNvCxnSpPr/>
            <p:nvPr/>
          </p:nvCxnSpPr>
          <p:spPr>
            <a:xfrm>
              <a:off x="4918146" y="742794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0" name="Connettore diritto 609">
              <a:extLst>
                <a:ext uri="{FF2B5EF4-FFF2-40B4-BE49-F238E27FC236}">
                  <a16:creationId xmlns:a16="http://schemas.microsoft.com/office/drawing/2014/main" id="{311F021D-38D8-4CD8-A03B-1B4704350332}"/>
                </a:ext>
              </a:extLst>
            </p:cNvPr>
            <p:cNvCxnSpPr/>
            <p:nvPr/>
          </p:nvCxnSpPr>
          <p:spPr>
            <a:xfrm>
              <a:off x="5329783" y="742794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1" name="Connettore diritto 610">
              <a:extLst>
                <a:ext uri="{FF2B5EF4-FFF2-40B4-BE49-F238E27FC236}">
                  <a16:creationId xmlns:a16="http://schemas.microsoft.com/office/drawing/2014/main" id="{F6EA1893-5D35-4DE8-9410-DF51FCBD92B7}"/>
                </a:ext>
              </a:extLst>
            </p:cNvPr>
            <p:cNvCxnSpPr/>
            <p:nvPr/>
          </p:nvCxnSpPr>
          <p:spPr>
            <a:xfrm>
              <a:off x="5726109" y="742794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2" name="CasellaDiTesto 611">
              <a:extLst>
                <a:ext uri="{FF2B5EF4-FFF2-40B4-BE49-F238E27FC236}">
                  <a16:creationId xmlns:a16="http://schemas.microsoft.com/office/drawing/2014/main" id="{6E8AA96D-CE8B-48D7-A8B3-F7E6FAE88D40}"/>
                </a:ext>
              </a:extLst>
            </p:cNvPr>
            <p:cNvSpPr txBox="1"/>
            <p:nvPr/>
          </p:nvSpPr>
          <p:spPr>
            <a:xfrm>
              <a:off x="4583396" y="726328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</a:t>
              </a:r>
            </a:p>
          </p:txBody>
        </p:sp>
        <p:sp>
          <p:nvSpPr>
            <p:cNvPr id="613" name="CasellaDiTesto 612">
              <a:extLst>
                <a:ext uri="{FF2B5EF4-FFF2-40B4-BE49-F238E27FC236}">
                  <a16:creationId xmlns:a16="http://schemas.microsoft.com/office/drawing/2014/main" id="{9239537C-15BC-4F42-A26E-7A6A2E33E6C7}"/>
                </a:ext>
              </a:extLst>
            </p:cNvPr>
            <p:cNvSpPr txBox="1"/>
            <p:nvPr/>
          </p:nvSpPr>
          <p:spPr>
            <a:xfrm>
              <a:off x="4922894" y="726328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</a:t>
              </a:r>
            </a:p>
          </p:txBody>
        </p:sp>
        <p:sp>
          <p:nvSpPr>
            <p:cNvPr id="614" name="CasellaDiTesto 613">
              <a:extLst>
                <a:ext uri="{FF2B5EF4-FFF2-40B4-BE49-F238E27FC236}">
                  <a16:creationId xmlns:a16="http://schemas.microsoft.com/office/drawing/2014/main" id="{23D7BFDF-477C-43DC-B057-85CCC63E8F31}"/>
                </a:ext>
              </a:extLst>
            </p:cNvPr>
            <p:cNvSpPr txBox="1"/>
            <p:nvPr/>
          </p:nvSpPr>
          <p:spPr>
            <a:xfrm>
              <a:off x="5355535" y="7263287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sp>
          <p:nvSpPr>
            <p:cNvPr id="615" name="CasellaDiTesto 614">
              <a:extLst>
                <a:ext uri="{FF2B5EF4-FFF2-40B4-BE49-F238E27FC236}">
                  <a16:creationId xmlns:a16="http://schemas.microsoft.com/office/drawing/2014/main" id="{08AE8B3A-A97D-4BFB-B7DF-E7527CC9FB8E}"/>
                </a:ext>
              </a:extLst>
            </p:cNvPr>
            <p:cNvSpPr txBox="1"/>
            <p:nvPr/>
          </p:nvSpPr>
          <p:spPr>
            <a:xfrm>
              <a:off x="5727632" y="7263287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0</a:t>
              </a:r>
            </a:p>
          </p:txBody>
        </p:sp>
        <p:cxnSp>
          <p:nvCxnSpPr>
            <p:cNvPr id="616" name="Connettore diritto 615">
              <a:extLst>
                <a:ext uri="{FF2B5EF4-FFF2-40B4-BE49-F238E27FC236}">
                  <a16:creationId xmlns:a16="http://schemas.microsoft.com/office/drawing/2014/main" id="{C0EC531F-887D-47EB-B4FC-3A27DE3FEBF6}"/>
                </a:ext>
              </a:extLst>
            </p:cNvPr>
            <p:cNvCxnSpPr>
              <a:cxnSpLocks/>
            </p:cNvCxnSpPr>
            <p:nvPr/>
          </p:nvCxnSpPr>
          <p:spPr>
            <a:xfrm>
              <a:off x="4697370" y="7263287"/>
              <a:ext cx="120915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7" name="CasellaDiTesto 616">
              <a:extLst>
                <a:ext uri="{FF2B5EF4-FFF2-40B4-BE49-F238E27FC236}">
                  <a16:creationId xmlns:a16="http://schemas.microsoft.com/office/drawing/2014/main" id="{DEC06A02-4AB9-4C1B-8E48-6EA66EB24B4C}"/>
                </a:ext>
              </a:extLst>
            </p:cNvPr>
            <p:cNvSpPr txBox="1"/>
            <p:nvPr/>
          </p:nvSpPr>
          <p:spPr>
            <a:xfrm>
              <a:off x="5010820" y="7074337"/>
              <a:ext cx="6078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[</a:t>
              </a:r>
              <a:r>
                <a:rPr lang="it-IT" sz="600" dirty="0" err="1"/>
                <a:t>Prexa</a:t>
              </a:r>
              <a:r>
                <a:rPr lang="it-IT" sz="600" dirty="0"/>
                <a:t>] (</a:t>
              </a:r>
              <a:r>
                <a:rPr lang="it-IT" sz="600" dirty="0" err="1"/>
                <a:t>nM</a:t>
              </a:r>
              <a:r>
                <a:rPr lang="it-IT" sz="600" dirty="0"/>
                <a:t>)</a:t>
              </a:r>
            </a:p>
          </p:txBody>
        </p:sp>
        <p:sp>
          <p:nvSpPr>
            <p:cNvPr id="618" name="CasellaDiTesto 617">
              <a:extLst>
                <a:ext uri="{FF2B5EF4-FFF2-40B4-BE49-F238E27FC236}">
                  <a16:creationId xmlns:a16="http://schemas.microsoft.com/office/drawing/2014/main" id="{F19D73C7-8C4A-4DD4-BDD1-A15AD0D3348F}"/>
                </a:ext>
              </a:extLst>
            </p:cNvPr>
            <p:cNvSpPr txBox="1"/>
            <p:nvPr/>
          </p:nvSpPr>
          <p:spPr>
            <a:xfrm>
              <a:off x="4068231" y="8379880"/>
              <a:ext cx="66236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 dirty="0"/>
                <a:t>MDA-MB-361</a:t>
              </a:r>
            </a:p>
          </p:txBody>
        </p:sp>
      </p:grpSp>
      <p:sp>
        <p:nvSpPr>
          <p:cNvPr id="636" name="CasellaDiTesto 635">
            <a:extLst>
              <a:ext uri="{FF2B5EF4-FFF2-40B4-BE49-F238E27FC236}">
                <a16:creationId xmlns:a16="http://schemas.microsoft.com/office/drawing/2014/main" id="{06D7066F-C875-4483-86BD-F58DFEBB5B24}"/>
              </a:ext>
            </a:extLst>
          </p:cNvPr>
          <p:cNvSpPr txBox="1"/>
          <p:nvPr/>
        </p:nvSpPr>
        <p:spPr>
          <a:xfrm>
            <a:off x="45479" y="249995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B</a:t>
            </a:r>
          </a:p>
        </p:txBody>
      </p:sp>
      <p:sp>
        <p:nvSpPr>
          <p:cNvPr id="637" name="CasellaDiTesto 636">
            <a:extLst>
              <a:ext uri="{FF2B5EF4-FFF2-40B4-BE49-F238E27FC236}">
                <a16:creationId xmlns:a16="http://schemas.microsoft.com/office/drawing/2014/main" id="{377D7FCF-4A7B-48BF-A522-7235807EA575}"/>
              </a:ext>
            </a:extLst>
          </p:cNvPr>
          <p:cNvSpPr txBox="1"/>
          <p:nvPr/>
        </p:nvSpPr>
        <p:spPr>
          <a:xfrm>
            <a:off x="3429000" y="248376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B’</a:t>
            </a:r>
          </a:p>
        </p:txBody>
      </p:sp>
      <p:sp>
        <p:nvSpPr>
          <p:cNvPr id="638" name="CasellaDiTesto 637">
            <a:extLst>
              <a:ext uri="{FF2B5EF4-FFF2-40B4-BE49-F238E27FC236}">
                <a16:creationId xmlns:a16="http://schemas.microsoft.com/office/drawing/2014/main" id="{E589C829-C5D0-44B8-9530-FD8118A7E2F8}"/>
              </a:ext>
            </a:extLst>
          </p:cNvPr>
          <p:cNvSpPr txBox="1"/>
          <p:nvPr/>
        </p:nvSpPr>
        <p:spPr>
          <a:xfrm>
            <a:off x="45479" y="456539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C</a:t>
            </a:r>
          </a:p>
        </p:txBody>
      </p:sp>
      <p:sp>
        <p:nvSpPr>
          <p:cNvPr id="639" name="CasellaDiTesto 638">
            <a:extLst>
              <a:ext uri="{FF2B5EF4-FFF2-40B4-BE49-F238E27FC236}">
                <a16:creationId xmlns:a16="http://schemas.microsoft.com/office/drawing/2014/main" id="{03508E2D-80C0-448B-8DCE-EC1B4EEBE05A}"/>
              </a:ext>
            </a:extLst>
          </p:cNvPr>
          <p:cNvSpPr txBox="1"/>
          <p:nvPr/>
        </p:nvSpPr>
        <p:spPr>
          <a:xfrm>
            <a:off x="3429000" y="454920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C’</a:t>
            </a:r>
          </a:p>
        </p:txBody>
      </p:sp>
      <p:sp>
        <p:nvSpPr>
          <p:cNvPr id="640" name="CasellaDiTesto 639">
            <a:extLst>
              <a:ext uri="{FF2B5EF4-FFF2-40B4-BE49-F238E27FC236}">
                <a16:creationId xmlns:a16="http://schemas.microsoft.com/office/drawing/2014/main" id="{08181E49-649B-425F-B989-A165F57AC591}"/>
              </a:ext>
            </a:extLst>
          </p:cNvPr>
          <p:cNvSpPr txBox="1"/>
          <p:nvPr/>
        </p:nvSpPr>
        <p:spPr>
          <a:xfrm>
            <a:off x="45479" y="69365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D</a:t>
            </a:r>
          </a:p>
        </p:txBody>
      </p:sp>
      <p:sp>
        <p:nvSpPr>
          <p:cNvPr id="641" name="CasellaDiTesto 640">
            <a:extLst>
              <a:ext uri="{FF2B5EF4-FFF2-40B4-BE49-F238E27FC236}">
                <a16:creationId xmlns:a16="http://schemas.microsoft.com/office/drawing/2014/main" id="{A6E651EF-9FD9-4D32-ADAB-3E89EDAF7C09}"/>
              </a:ext>
            </a:extLst>
          </p:cNvPr>
          <p:cNvSpPr txBox="1"/>
          <p:nvPr/>
        </p:nvSpPr>
        <p:spPr>
          <a:xfrm>
            <a:off x="3429000" y="692031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D’</a:t>
            </a:r>
          </a:p>
        </p:txBody>
      </p:sp>
      <p:grpSp>
        <p:nvGrpSpPr>
          <p:cNvPr id="698" name="Gruppo 697">
            <a:extLst>
              <a:ext uri="{FF2B5EF4-FFF2-40B4-BE49-F238E27FC236}">
                <a16:creationId xmlns:a16="http://schemas.microsoft.com/office/drawing/2014/main" id="{7D28CDCB-6F49-4A1B-8D8C-95AEAE83E860}"/>
              </a:ext>
            </a:extLst>
          </p:cNvPr>
          <p:cNvGrpSpPr/>
          <p:nvPr/>
        </p:nvGrpSpPr>
        <p:grpSpPr>
          <a:xfrm>
            <a:off x="258958" y="7074337"/>
            <a:ext cx="2480910" cy="1818143"/>
            <a:chOff x="258958" y="7074337"/>
            <a:chExt cx="2480910" cy="1818143"/>
          </a:xfrm>
        </p:grpSpPr>
        <p:pic>
          <p:nvPicPr>
            <p:cNvPr id="648" name="Immagine 647">
              <a:extLst>
                <a:ext uri="{FF2B5EF4-FFF2-40B4-BE49-F238E27FC236}">
                  <a16:creationId xmlns:a16="http://schemas.microsoft.com/office/drawing/2014/main" id="{877CCD5D-2865-4767-9BB1-BE76FF2B331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16662" y="7211918"/>
              <a:ext cx="2073333" cy="1440000"/>
            </a:xfrm>
            <a:prstGeom prst="rect">
              <a:avLst/>
            </a:prstGeom>
          </p:spPr>
        </p:pic>
        <p:sp>
          <p:nvSpPr>
            <p:cNvPr id="651" name="CasellaDiTesto 650">
              <a:extLst>
                <a:ext uri="{FF2B5EF4-FFF2-40B4-BE49-F238E27FC236}">
                  <a16:creationId xmlns:a16="http://schemas.microsoft.com/office/drawing/2014/main" id="{72486AAA-FB32-4629-BFB5-7D928C8A4F9A}"/>
                </a:ext>
              </a:extLst>
            </p:cNvPr>
            <p:cNvSpPr txBox="1"/>
            <p:nvPr/>
          </p:nvSpPr>
          <p:spPr>
            <a:xfrm rot="16200000">
              <a:off x="-305760" y="7783849"/>
              <a:ext cx="1406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600" dirty="0" err="1"/>
                <a:t>Number</a:t>
              </a:r>
              <a:r>
                <a:rPr lang="it-IT" sz="600" dirty="0"/>
                <a:t> of </a:t>
              </a:r>
              <a:r>
                <a:rPr lang="it-IT" sz="600" dirty="0" err="1"/>
                <a:t>cells</a:t>
              </a:r>
              <a:endParaRPr lang="it-IT" sz="600" dirty="0"/>
            </a:p>
            <a:p>
              <a:pPr algn="ctr"/>
              <a:r>
                <a:rPr lang="it-IT" sz="600" dirty="0"/>
                <a:t>(% on -)</a:t>
              </a:r>
              <a:endParaRPr lang="it-IT" sz="6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652" name="CasellaDiTesto 651">
              <a:extLst>
                <a:ext uri="{FF2B5EF4-FFF2-40B4-BE49-F238E27FC236}">
                  <a16:creationId xmlns:a16="http://schemas.microsoft.com/office/drawing/2014/main" id="{0A1D9A71-C4D8-45CE-B249-C1BE6B3B9993}"/>
                </a:ext>
              </a:extLst>
            </p:cNvPr>
            <p:cNvSpPr txBox="1"/>
            <p:nvPr/>
          </p:nvSpPr>
          <p:spPr>
            <a:xfrm>
              <a:off x="399517" y="7816266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sp>
          <p:nvSpPr>
            <p:cNvPr id="653" name="CasellaDiTesto 652">
              <a:extLst>
                <a:ext uri="{FF2B5EF4-FFF2-40B4-BE49-F238E27FC236}">
                  <a16:creationId xmlns:a16="http://schemas.microsoft.com/office/drawing/2014/main" id="{627D44F5-280C-4327-9651-B8D5EC5E784F}"/>
                </a:ext>
              </a:extLst>
            </p:cNvPr>
            <p:cNvSpPr txBox="1"/>
            <p:nvPr/>
          </p:nvSpPr>
          <p:spPr>
            <a:xfrm>
              <a:off x="486079" y="848058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</a:t>
              </a:r>
            </a:p>
          </p:txBody>
        </p:sp>
        <p:sp>
          <p:nvSpPr>
            <p:cNvPr id="654" name="CasellaDiTesto 653">
              <a:extLst>
                <a:ext uri="{FF2B5EF4-FFF2-40B4-BE49-F238E27FC236}">
                  <a16:creationId xmlns:a16="http://schemas.microsoft.com/office/drawing/2014/main" id="{76F804FE-02AB-4A9B-942F-02740A0A76BD}"/>
                </a:ext>
              </a:extLst>
            </p:cNvPr>
            <p:cNvSpPr txBox="1"/>
            <p:nvPr/>
          </p:nvSpPr>
          <p:spPr>
            <a:xfrm>
              <a:off x="399517" y="7150636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00</a:t>
              </a:r>
            </a:p>
          </p:txBody>
        </p:sp>
        <p:sp>
          <p:nvSpPr>
            <p:cNvPr id="655" name="CasellaDiTesto 654">
              <a:extLst>
                <a:ext uri="{FF2B5EF4-FFF2-40B4-BE49-F238E27FC236}">
                  <a16:creationId xmlns:a16="http://schemas.microsoft.com/office/drawing/2014/main" id="{A1553BC2-3D72-4920-AA47-60E30E3FFDE0}"/>
                </a:ext>
              </a:extLst>
            </p:cNvPr>
            <p:cNvSpPr txBox="1"/>
            <p:nvPr/>
          </p:nvSpPr>
          <p:spPr>
            <a:xfrm>
              <a:off x="621987" y="858007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656" name="Gruppo 655">
              <a:extLst>
                <a:ext uri="{FF2B5EF4-FFF2-40B4-BE49-F238E27FC236}">
                  <a16:creationId xmlns:a16="http://schemas.microsoft.com/office/drawing/2014/main" id="{2B242927-F3C4-4BB5-9EBE-E2C7FF3CB00F}"/>
                </a:ext>
              </a:extLst>
            </p:cNvPr>
            <p:cNvGrpSpPr/>
            <p:nvPr/>
          </p:nvGrpSpPr>
          <p:grpSpPr>
            <a:xfrm>
              <a:off x="672804" y="8580070"/>
              <a:ext cx="498353" cy="184666"/>
              <a:chOff x="504190" y="4467019"/>
              <a:chExt cx="498353" cy="184666"/>
            </a:xfrm>
          </p:grpSpPr>
          <p:sp>
            <p:nvSpPr>
              <p:cNvPr id="693" name="CasellaDiTesto 692">
                <a:extLst>
                  <a:ext uri="{FF2B5EF4-FFF2-40B4-BE49-F238E27FC236}">
                    <a16:creationId xmlns:a16="http://schemas.microsoft.com/office/drawing/2014/main" id="{DCED0DB7-C41C-45F9-AABB-4F7D0FB7E0A8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694" name="CasellaDiTesto 693">
                <a:extLst>
                  <a:ext uri="{FF2B5EF4-FFF2-40B4-BE49-F238E27FC236}">
                    <a16:creationId xmlns:a16="http://schemas.microsoft.com/office/drawing/2014/main" id="{A89737EF-0729-4B8E-A764-52B35949019B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695" name="CasellaDiTesto 694">
                <a:extLst>
                  <a:ext uri="{FF2B5EF4-FFF2-40B4-BE49-F238E27FC236}">
                    <a16:creationId xmlns:a16="http://schemas.microsoft.com/office/drawing/2014/main" id="{EC87B18E-1AE1-4D23-8AC2-C928B5E82CD2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696" name="CasellaDiTesto 695">
                <a:extLst>
                  <a:ext uri="{FF2B5EF4-FFF2-40B4-BE49-F238E27FC236}">
                    <a16:creationId xmlns:a16="http://schemas.microsoft.com/office/drawing/2014/main" id="{1D89C829-DBE0-47EB-9F91-265C596571D7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657" name="CasellaDiTesto 656">
              <a:extLst>
                <a:ext uri="{FF2B5EF4-FFF2-40B4-BE49-F238E27FC236}">
                  <a16:creationId xmlns:a16="http://schemas.microsoft.com/office/drawing/2014/main" id="{B64A40E2-3CC4-4308-AE55-0FC15CB939DC}"/>
                </a:ext>
              </a:extLst>
            </p:cNvPr>
            <p:cNvSpPr txBox="1"/>
            <p:nvPr/>
          </p:nvSpPr>
          <p:spPr>
            <a:xfrm>
              <a:off x="1019520" y="858007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658" name="Gruppo 657">
              <a:extLst>
                <a:ext uri="{FF2B5EF4-FFF2-40B4-BE49-F238E27FC236}">
                  <a16:creationId xmlns:a16="http://schemas.microsoft.com/office/drawing/2014/main" id="{C4F0FD67-3E64-43D7-9DA4-753D056DAB45}"/>
                </a:ext>
              </a:extLst>
            </p:cNvPr>
            <p:cNvGrpSpPr/>
            <p:nvPr/>
          </p:nvGrpSpPr>
          <p:grpSpPr>
            <a:xfrm>
              <a:off x="1070337" y="8580070"/>
              <a:ext cx="498353" cy="184666"/>
              <a:chOff x="504190" y="4467019"/>
              <a:chExt cx="498353" cy="184666"/>
            </a:xfrm>
          </p:grpSpPr>
          <p:sp>
            <p:nvSpPr>
              <p:cNvPr id="689" name="CasellaDiTesto 688">
                <a:extLst>
                  <a:ext uri="{FF2B5EF4-FFF2-40B4-BE49-F238E27FC236}">
                    <a16:creationId xmlns:a16="http://schemas.microsoft.com/office/drawing/2014/main" id="{8DA6F694-8787-49D9-BF05-6DC54B18EFC8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690" name="CasellaDiTesto 689">
                <a:extLst>
                  <a:ext uri="{FF2B5EF4-FFF2-40B4-BE49-F238E27FC236}">
                    <a16:creationId xmlns:a16="http://schemas.microsoft.com/office/drawing/2014/main" id="{7335A2D5-A75D-48F5-B3F8-480BACD4B825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691" name="CasellaDiTesto 690">
                <a:extLst>
                  <a:ext uri="{FF2B5EF4-FFF2-40B4-BE49-F238E27FC236}">
                    <a16:creationId xmlns:a16="http://schemas.microsoft.com/office/drawing/2014/main" id="{0C97A9AF-1738-40EA-AA5F-7FB0D8CF75CE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692" name="CasellaDiTesto 691">
                <a:extLst>
                  <a:ext uri="{FF2B5EF4-FFF2-40B4-BE49-F238E27FC236}">
                    <a16:creationId xmlns:a16="http://schemas.microsoft.com/office/drawing/2014/main" id="{5FD12E02-83A7-441E-BC56-FCAD7DFAC416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659" name="CasellaDiTesto 658">
              <a:extLst>
                <a:ext uri="{FF2B5EF4-FFF2-40B4-BE49-F238E27FC236}">
                  <a16:creationId xmlns:a16="http://schemas.microsoft.com/office/drawing/2014/main" id="{A521BF26-7FCC-4217-AFC7-DF2F04904511}"/>
                </a:ext>
              </a:extLst>
            </p:cNvPr>
            <p:cNvSpPr txBox="1"/>
            <p:nvPr/>
          </p:nvSpPr>
          <p:spPr>
            <a:xfrm>
              <a:off x="1411310" y="858007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660" name="Gruppo 659">
              <a:extLst>
                <a:ext uri="{FF2B5EF4-FFF2-40B4-BE49-F238E27FC236}">
                  <a16:creationId xmlns:a16="http://schemas.microsoft.com/office/drawing/2014/main" id="{9CD500B6-4F83-41F0-8DD3-22D1008864E3}"/>
                </a:ext>
              </a:extLst>
            </p:cNvPr>
            <p:cNvGrpSpPr/>
            <p:nvPr/>
          </p:nvGrpSpPr>
          <p:grpSpPr>
            <a:xfrm>
              <a:off x="1462127" y="8580070"/>
              <a:ext cx="498353" cy="184666"/>
              <a:chOff x="504190" y="4467019"/>
              <a:chExt cx="498353" cy="184666"/>
            </a:xfrm>
          </p:grpSpPr>
          <p:sp>
            <p:nvSpPr>
              <p:cNvPr id="685" name="CasellaDiTesto 684">
                <a:extLst>
                  <a:ext uri="{FF2B5EF4-FFF2-40B4-BE49-F238E27FC236}">
                    <a16:creationId xmlns:a16="http://schemas.microsoft.com/office/drawing/2014/main" id="{464496E9-59C9-4CB7-8E07-C80D4FD00D64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686" name="CasellaDiTesto 685">
                <a:extLst>
                  <a:ext uri="{FF2B5EF4-FFF2-40B4-BE49-F238E27FC236}">
                    <a16:creationId xmlns:a16="http://schemas.microsoft.com/office/drawing/2014/main" id="{9167C7A0-B068-486D-B85D-A62207CE620C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687" name="CasellaDiTesto 686">
                <a:extLst>
                  <a:ext uri="{FF2B5EF4-FFF2-40B4-BE49-F238E27FC236}">
                    <a16:creationId xmlns:a16="http://schemas.microsoft.com/office/drawing/2014/main" id="{2A71B22E-6E1A-43DF-B29E-44B3AA15C736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688" name="CasellaDiTesto 687">
                <a:extLst>
                  <a:ext uri="{FF2B5EF4-FFF2-40B4-BE49-F238E27FC236}">
                    <a16:creationId xmlns:a16="http://schemas.microsoft.com/office/drawing/2014/main" id="{73F7949D-83A2-4C42-B9BB-D34301E96D94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661" name="CasellaDiTesto 660">
              <a:extLst>
                <a:ext uri="{FF2B5EF4-FFF2-40B4-BE49-F238E27FC236}">
                  <a16:creationId xmlns:a16="http://schemas.microsoft.com/office/drawing/2014/main" id="{0FD165A5-EE84-4408-AEA6-E265D9F43D2A}"/>
                </a:ext>
              </a:extLst>
            </p:cNvPr>
            <p:cNvSpPr txBox="1"/>
            <p:nvPr/>
          </p:nvSpPr>
          <p:spPr>
            <a:xfrm>
              <a:off x="1805258" y="858007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grpSp>
          <p:nvGrpSpPr>
            <p:cNvPr id="662" name="Gruppo 661">
              <a:extLst>
                <a:ext uri="{FF2B5EF4-FFF2-40B4-BE49-F238E27FC236}">
                  <a16:creationId xmlns:a16="http://schemas.microsoft.com/office/drawing/2014/main" id="{CBF9B478-9BA6-4277-8F1C-D9744BBB33A3}"/>
                </a:ext>
              </a:extLst>
            </p:cNvPr>
            <p:cNvGrpSpPr/>
            <p:nvPr/>
          </p:nvGrpSpPr>
          <p:grpSpPr>
            <a:xfrm>
              <a:off x="1856075" y="8580070"/>
              <a:ext cx="498353" cy="184666"/>
              <a:chOff x="504190" y="4467019"/>
              <a:chExt cx="498353" cy="184666"/>
            </a:xfrm>
          </p:grpSpPr>
          <p:sp>
            <p:nvSpPr>
              <p:cNvPr id="681" name="CasellaDiTesto 680">
                <a:extLst>
                  <a:ext uri="{FF2B5EF4-FFF2-40B4-BE49-F238E27FC236}">
                    <a16:creationId xmlns:a16="http://schemas.microsoft.com/office/drawing/2014/main" id="{2DB2D750-363C-45C8-9F60-F3308E025614}"/>
                  </a:ext>
                </a:extLst>
              </p:cNvPr>
              <p:cNvSpPr txBox="1"/>
              <p:nvPr/>
            </p:nvSpPr>
            <p:spPr>
              <a:xfrm>
                <a:off x="50419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9</a:t>
                </a:r>
                <a:endParaRPr lang="it-IT" sz="600" dirty="0"/>
              </a:p>
            </p:txBody>
          </p:sp>
          <p:sp>
            <p:nvSpPr>
              <p:cNvPr id="682" name="CasellaDiTesto 681">
                <a:extLst>
                  <a:ext uri="{FF2B5EF4-FFF2-40B4-BE49-F238E27FC236}">
                    <a16:creationId xmlns:a16="http://schemas.microsoft.com/office/drawing/2014/main" id="{2CD4ECDB-D27A-48B0-89E6-78A953FE004B}"/>
                  </a:ext>
                </a:extLst>
              </p:cNvPr>
              <p:cNvSpPr txBox="1"/>
              <p:nvPr/>
            </p:nvSpPr>
            <p:spPr>
              <a:xfrm>
                <a:off x="590881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8</a:t>
                </a:r>
                <a:endParaRPr lang="it-IT" sz="600" dirty="0"/>
              </a:p>
            </p:txBody>
          </p:sp>
          <p:sp>
            <p:nvSpPr>
              <p:cNvPr id="683" name="CasellaDiTesto 682">
                <a:extLst>
                  <a:ext uri="{FF2B5EF4-FFF2-40B4-BE49-F238E27FC236}">
                    <a16:creationId xmlns:a16="http://schemas.microsoft.com/office/drawing/2014/main" id="{D85B523E-9F58-47FF-A556-08F0156DAAFB}"/>
                  </a:ext>
                </a:extLst>
              </p:cNvPr>
              <p:cNvSpPr txBox="1"/>
              <p:nvPr/>
            </p:nvSpPr>
            <p:spPr>
              <a:xfrm>
                <a:off x="679080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7</a:t>
                </a:r>
                <a:endParaRPr lang="it-IT" sz="600" dirty="0"/>
              </a:p>
            </p:txBody>
          </p:sp>
          <p:sp>
            <p:nvSpPr>
              <p:cNvPr id="684" name="CasellaDiTesto 683">
                <a:extLst>
                  <a:ext uri="{FF2B5EF4-FFF2-40B4-BE49-F238E27FC236}">
                    <a16:creationId xmlns:a16="http://schemas.microsoft.com/office/drawing/2014/main" id="{45963B42-19A6-432C-8A77-659CF5462CC6}"/>
                  </a:ext>
                </a:extLst>
              </p:cNvPr>
              <p:cNvSpPr txBox="1"/>
              <p:nvPr/>
            </p:nvSpPr>
            <p:spPr>
              <a:xfrm>
                <a:off x="748947" y="4467019"/>
                <a:ext cx="2535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/>
                  <a:t>-6</a:t>
                </a:r>
                <a:endParaRPr lang="it-IT" sz="600" dirty="0"/>
              </a:p>
            </p:txBody>
          </p:sp>
        </p:grpSp>
        <p:sp>
          <p:nvSpPr>
            <p:cNvPr id="663" name="CasellaDiTesto 662">
              <a:extLst>
                <a:ext uri="{FF2B5EF4-FFF2-40B4-BE49-F238E27FC236}">
                  <a16:creationId xmlns:a16="http://schemas.microsoft.com/office/drawing/2014/main" id="{48843BDA-23C0-45BE-B236-D5519DB375CA}"/>
                </a:ext>
              </a:extLst>
            </p:cNvPr>
            <p:cNvSpPr txBox="1"/>
            <p:nvPr/>
          </p:nvSpPr>
          <p:spPr>
            <a:xfrm>
              <a:off x="2190698" y="858007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664" name="CasellaDiTesto 663">
              <a:extLst>
                <a:ext uri="{FF2B5EF4-FFF2-40B4-BE49-F238E27FC236}">
                  <a16:creationId xmlns:a16="http://schemas.microsoft.com/office/drawing/2014/main" id="{4D79EBBC-39EF-4D14-9A6D-0C5DE1F09D51}"/>
                </a:ext>
              </a:extLst>
            </p:cNvPr>
            <p:cNvSpPr txBox="1"/>
            <p:nvPr/>
          </p:nvSpPr>
          <p:spPr>
            <a:xfrm>
              <a:off x="2241515" y="858007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9</a:t>
              </a:r>
              <a:endParaRPr lang="it-IT" sz="600" dirty="0"/>
            </a:p>
          </p:txBody>
        </p:sp>
        <p:sp>
          <p:nvSpPr>
            <p:cNvPr id="665" name="CasellaDiTesto 664">
              <a:extLst>
                <a:ext uri="{FF2B5EF4-FFF2-40B4-BE49-F238E27FC236}">
                  <a16:creationId xmlns:a16="http://schemas.microsoft.com/office/drawing/2014/main" id="{4A8B83FB-7683-40C4-B22C-66BEFAE7A291}"/>
                </a:ext>
              </a:extLst>
            </p:cNvPr>
            <p:cNvSpPr txBox="1"/>
            <p:nvPr/>
          </p:nvSpPr>
          <p:spPr>
            <a:xfrm>
              <a:off x="2328206" y="858007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8</a:t>
              </a:r>
              <a:endParaRPr lang="it-IT" sz="600" dirty="0"/>
            </a:p>
          </p:txBody>
        </p:sp>
        <p:sp>
          <p:nvSpPr>
            <p:cNvPr id="666" name="CasellaDiTesto 665">
              <a:extLst>
                <a:ext uri="{FF2B5EF4-FFF2-40B4-BE49-F238E27FC236}">
                  <a16:creationId xmlns:a16="http://schemas.microsoft.com/office/drawing/2014/main" id="{AD84E5A6-C3E4-4E10-8672-1DB5DDC0BE05}"/>
                </a:ext>
              </a:extLst>
            </p:cNvPr>
            <p:cNvSpPr txBox="1"/>
            <p:nvPr/>
          </p:nvSpPr>
          <p:spPr>
            <a:xfrm>
              <a:off x="2416405" y="858007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7</a:t>
              </a:r>
              <a:endParaRPr lang="it-IT" sz="600" dirty="0"/>
            </a:p>
          </p:txBody>
        </p:sp>
        <p:sp>
          <p:nvSpPr>
            <p:cNvPr id="667" name="CasellaDiTesto 666">
              <a:extLst>
                <a:ext uri="{FF2B5EF4-FFF2-40B4-BE49-F238E27FC236}">
                  <a16:creationId xmlns:a16="http://schemas.microsoft.com/office/drawing/2014/main" id="{6CE01B75-A13C-4727-908D-9FF910329541}"/>
                </a:ext>
              </a:extLst>
            </p:cNvPr>
            <p:cNvSpPr txBox="1"/>
            <p:nvPr/>
          </p:nvSpPr>
          <p:spPr>
            <a:xfrm>
              <a:off x="2486272" y="858007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/>
                <a:t>-6</a:t>
              </a:r>
              <a:endParaRPr lang="it-IT" sz="600" dirty="0"/>
            </a:p>
          </p:txBody>
        </p:sp>
        <p:sp>
          <p:nvSpPr>
            <p:cNvPr id="668" name="CasellaDiTesto 667">
              <a:extLst>
                <a:ext uri="{FF2B5EF4-FFF2-40B4-BE49-F238E27FC236}">
                  <a16:creationId xmlns:a16="http://schemas.microsoft.com/office/drawing/2014/main" id="{9C520C53-B661-4008-BA7E-A8975FF6C8DE}"/>
                </a:ext>
              </a:extLst>
            </p:cNvPr>
            <p:cNvSpPr txBox="1"/>
            <p:nvPr/>
          </p:nvSpPr>
          <p:spPr>
            <a:xfrm>
              <a:off x="1344370" y="8707814"/>
              <a:ext cx="6671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Log [Tam] (M)</a:t>
              </a:r>
            </a:p>
          </p:txBody>
        </p:sp>
        <p:cxnSp>
          <p:nvCxnSpPr>
            <p:cNvPr id="669" name="Connettore diritto 668">
              <a:extLst>
                <a:ext uri="{FF2B5EF4-FFF2-40B4-BE49-F238E27FC236}">
                  <a16:creationId xmlns:a16="http://schemas.microsoft.com/office/drawing/2014/main" id="{910B2DF2-2F6C-4E3B-8401-450A027540F6}"/>
                </a:ext>
              </a:extLst>
            </p:cNvPr>
            <p:cNvCxnSpPr>
              <a:cxnSpLocks/>
            </p:cNvCxnSpPr>
            <p:nvPr/>
          </p:nvCxnSpPr>
          <p:spPr>
            <a:xfrm>
              <a:off x="679194" y="8743136"/>
              <a:ext cx="19527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0" name="Connettore diritto 669">
              <a:extLst>
                <a:ext uri="{FF2B5EF4-FFF2-40B4-BE49-F238E27FC236}">
                  <a16:creationId xmlns:a16="http://schemas.microsoft.com/office/drawing/2014/main" id="{D00E41E2-6E10-4390-A0AF-1C639CCAD89A}"/>
                </a:ext>
              </a:extLst>
            </p:cNvPr>
            <p:cNvCxnSpPr/>
            <p:nvPr/>
          </p:nvCxnSpPr>
          <p:spPr>
            <a:xfrm>
              <a:off x="1094940" y="742794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1" name="Connettore diritto 670">
              <a:extLst>
                <a:ext uri="{FF2B5EF4-FFF2-40B4-BE49-F238E27FC236}">
                  <a16:creationId xmlns:a16="http://schemas.microsoft.com/office/drawing/2014/main" id="{B424E7AA-78C4-462C-BCD1-054C3EE14629}"/>
                </a:ext>
              </a:extLst>
            </p:cNvPr>
            <p:cNvCxnSpPr/>
            <p:nvPr/>
          </p:nvCxnSpPr>
          <p:spPr>
            <a:xfrm>
              <a:off x="1492710" y="742794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2" name="Connettore diritto 671">
              <a:extLst>
                <a:ext uri="{FF2B5EF4-FFF2-40B4-BE49-F238E27FC236}">
                  <a16:creationId xmlns:a16="http://schemas.microsoft.com/office/drawing/2014/main" id="{A044A848-773E-40AC-B8A4-268957B5BC8F}"/>
                </a:ext>
              </a:extLst>
            </p:cNvPr>
            <p:cNvCxnSpPr/>
            <p:nvPr/>
          </p:nvCxnSpPr>
          <p:spPr>
            <a:xfrm>
              <a:off x="1904347" y="742794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3" name="Connettore diritto 672">
              <a:extLst>
                <a:ext uri="{FF2B5EF4-FFF2-40B4-BE49-F238E27FC236}">
                  <a16:creationId xmlns:a16="http://schemas.microsoft.com/office/drawing/2014/main" id="{E15F4F53-4730-4E39-97E4-DB85771E5CE6}"/>
                </a:ext>
              </a:extLst>
            </p:cNvPr>
            <p:cNvCxnSpPr/>
            <p:nvPr/>
          </p:nvCxnSpPr>
          <p:spPr>
            <a:xfrm>
              <a:off x="2300673" y="742794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74" name="CasellaDiTesto 673">
              <a:extLst>
                <a:ext uri="{FF2B5EF4-FFF2-40B4-BE49-F238E27FC236}">
                  <a16:creationId xmlns:a16="http://schemas.microsoft.com/office/drawing/2014/main" id="{AF150BFE-0665-420C-86FF-8E616B31FA0D}"/>
                </a:ext>
              </a:extLst>
            </p:cNvPr>
            <p:cNvSpPr txBox="1"/>
            <p:nvPr/>
          </p:nvSpPr>
          <p:spPr>
            <a:xfrm>
              <a:off x="1124744" y="7263287"/>
              <a:ext cx="3353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.01</a:t>
              </a:r>
            </a:p>
          </p:txBody>
        </p:sp>
        <p:sp>
          <p:nvSpPr>
            <p:cNvPr id="675" name="CasellaDiTesto 674">
              <a:extLst>
                <a:ext uri="{FF2B5EF4-FFF2-40B4-BE49-F238E27FC236}">
                  <a16:creationId xmlns:a16="http://schemas.microsoft.com/office/drawing/2014/main" id="{17DB7FF3-6E7D-4DCC-A89E-F27009A2D6B0}"/>
                </a:ext>
              </a:extLst>
            </p:cNvPr>
            <p:cNvSpPr txBox="1"/>
            <p:nvPr/>
          </p:nvSpPr>
          <p:spPr>
            <a:xfrm>
              <a:off x="1521273" y="7263287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.1</a:t>
              </a:r>
            </a:p>
          </p:txBody>
        </p:sp>
        <p:sp>
          <p:nvSpPr>
            <p:cNvPr id="676" name="CasellaDiTesto 675">
              <a:extLst>
                <a:ext uri="{FF2B5EF4-FFF2-40B4-BE49-F238E27FC236}">
                  <a16:creationId xmlns:a16="http://schemas.microsoft.com/office/drawing/2014/main" id="{47E6F595-C05E-473F-8C19-767DF52E407C}"/>
                </a:ext>
              </a:extLst>
            </p:cNvPr>
            <p:cNvSpPr txBox="1"/>
            <p:nvPr/>
          </p:nvSpPr>
          <p:spPr>
            <a:xfrm>
              <a:off x="1976916" y="726328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</a:t>
              </a:r>
            </a:p>
          </p:txBody>
        </p:sp>
        <p:sp>
          <p:nvSpPr>
            <p:cNvPr id="677" name="CasellaDiTesto 676">
              <a:extLst>
                <a:ext uri="{FF2B5EF4-FFF2-40B4-BE49-F238E27FC236}">
                  <a16:creationId xmlns:a16="http://schemas.microsoft.com/office/drawing/2014/main" id="{1FD0A77B-CCBF-4160-B3C7-FE797478D7CD}"/>
                </a:ext>
              </a:extLst>
            </p:cNvPr>
            <p:cNvSpPr txBox="1"/>
            <p:nvPr/>
          </p:nvSpPr>
          <p:spPr>
            <a:xfrm>
              <a:off x="2330774" y="726328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</a:t>
              </a:r>
            </a:p>
          </p:txBody>
        </p:sp>
        <p:cxnSp>
          <p:nvCxnSpPr>
            <p:cNvPr id="678" name="Connettore diritto 677">
              <a:extLst>
                <a:ext uri="{FF2B5EF4-FFF2-40B4-BE49-F238E27FC236}">
                  <a16:creationId xmlns:a16="http://schemas.microsoft.com/office/drawing/2014/main" id="{D7A76228-28AB-4E7D-A0E0-2B26F685992B}"/>
                </a:ext>
              </a:extLst>
            </p:cNvPr>
            <p:cNvCxnSpPr>
              <a:cxnSpLocks/>
            </p:cNvCxnSpPr>
            <p:nvPr/>
          </p:nvCxnSpPr>
          <p:spPr>
            <a:xfrm>
              <a:off x="1271934" y="7263287"/>
              <a:ext cx="120915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79" name="CasellaDiTesto 678">
              <a:extLst>
                <a:ext uri="{FF2B5EF4-FFF2-40B4-BE49-F238E27FC236}">
                  <a16:creationId xmlns:a16="http://schemas.microsoft.com/office/drawing/2014/main" id="{225CA7B7-FC9B-4465-B9CF-3689BBB76927}"/>
                </a:ext>
              </a:extLst>
            </p:cNvPr>
            <p:cNvSpPr txBox="1"/>
            <p:nvPr/>
          </p:nvSpPr>
          <p:spPr>
            <a:xfrm>
              <a:off x="1615864" y="7074337"/>
              <a:ext cx="55976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[AZD] (µM)</a:t>
              </a:r>
            </a:p>
          </p:txBody>
        </p:sp>
        <p:sp>
          <p:nvSpPr>
            <p:cNvPr id="680" name="CasellaDiTesto 679">
              <a:extLst>
                <a:ext uri="{FF2B5EF4-FFF2-40B4-BE49-F238E27FC236}">
                  <a16:creationId xmlns:a16="http://schemas.microsoft.com/office/drawing/2014/main" id="{2017158C-C55E-483F-90CB-F77B431FDC6A}"/>
                </a:ext>
              </a:extLst>
            </p:cNvPr>
            <p:cNvSpPr txBox="1"/>
            <p:nvPr/>
          </p:nvSpPr>
          <p:spPr>
            <a:xfrm>
              <a:off x="642795" y="8379880"/>
              <a:ext cx="66236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 dirty="0"/>
                <a:t>MDA-MB-36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231146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6E29DCE7-AB1E-4E29-A6CB-A53944649AC9}"/>
              </a:ext>
            </a:extLst>
          </p:cNvPr>
          <p:cNvSpPr txBox="1"/>
          <p:nvPr/>
        </p:nvSpPr>
        <p:spPr>
          <a:xfrm>
            <a:off x="1970792" y="30783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ure 6</a:t>
            </a:r>
          </a:p>
        </p:txBody>
      </p:sp>
      <p:grpSp>
        <p:nvGrpSpPr>
          <p:cNvPr id="532" name="Gruppo 531">
            <a:extLst>
              <a:ext uri="{FF2B5EF4-FFF2-40B4-BE49-F238E27FC236}">
                <a16:creationId xmlns:a16="http://schemas.microsoft.com/office/drawing/2014/main" id="{6D688B7D-D2D1-4CE8-9394-E3AB16CE60D2}"/>
              </a:ext>
            </a:extLst>
          </p:cNvPr>
          <p:cNvGrpSpPr/>
          <p:nvPr/>
        </p:nvGrpSpPr>
        <p:grpSpPr>
          <a:xfrm>
            <a:off x="2041120" y="1097673"/>
            <a:ext cx="2480910" cy="1818143"/>
            <a:chOff x="3060418" y="1860375"/>
            <a:chExt cx="2480910" cy="1818143"/>
          </a:xfrm>
        </p:grpSpPr>
        <p:pic>
          <p:nvPicPr>
            <p:cNvPr id="533" name="Immagine 532">
              <a:extLst>
                <a:ext uri="{FF2B5EF4-FFF2-40B4-BE49-F238E27FC236}">
                  <a16:creationId xmlns:a16="http://schemas.microsoft.com/office/drawing/2014/main" id="{BEC8CE7D-2755-499E-9C6A-7C36A42A6B8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18122" y="1997956"/>
              <a:ext cx="2052489" cy="1440000"/>
            </a:xfrm>
            <a:prstGeom prst="rect">
              <a:avLst/>
            </a:prstGeom>
          </p:spPr>
        </p:pic>
        <p:sp>
          <p:nvSpPr>
            <p:cNvPr id="534" name="CasellaDiTesto 533">
              <a:extLst>
                <a:ext uri="{FF2B5EF4-FFF2-40B4-BE49-F238E27FC236}">
                  <a16:creationId xmlns:a16="http://schemas.microsoft.com/office/drawing/2014/main" id="{CA836182-8E4C-4322-BB13-DE0509F74950}"/>
                </a:ext>
              </a:extLst>
            </p:cNvPr>
            <p:cNvSpPr txBox="1"/>
            <p:nvPr/>
          </p:nvSpPr>
          <p:spPr>
            <a:xfrm rot="16200000">
              <a:off x="2495700" y="2569887"/>
              <a:ext cx="1406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600" dirty="0" err="1"/>
                <a:t>Number</a:t>
              </a:r>
              <a:r>
                <a:rPr lang="it-IT" sz="600" dirty="0"/>
                <a:t> of </a:t>
              </a:r>
              <a:r>
                <a:rPr lang="it-IT" sz="600" dirty="0" err="1"/>
                <a:t>cells</a:t>
              </a:r>
              <a:endParaRPr lang="it-IT" sz="600" dirty="0"/>
            </a:p>
            <a:p>
              <a:pPr algn="ctr"/>
              <a:r>
                <a:rPr lang="it-IT" sz="600" dirty="0"/>
                <a:t>(% on -)</a:t>
              </a:r>
              <a:endParaRPr lang="it-IT" sz="6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535" name="CasellaDiTesto 534">
              <a:extLst>
                <a:ext uri="{FF2B5EF4-FFF2-40B4-BE49-F238E27FC236}">
                  <a16:creationId xmlns:a16="http://schemas.microsoft.com/office/drawing/2014/main" id="{85C85E81-E475-4E6F-B746-196FA8177178}"/>
                </a:ext>
              </a:extLst>
            </p:cNvPr>
            <p:cNvSpPr txBox="1"/>
            <p:nvPr/>
          </p:nvSpPr>
          <p:spPr>
            <a:xfrm>
              <a:off x="3200977" y="2602304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sp>
          <p:nvSpPr>
            <p:cNvPr id="536" name="CasellaDiTesto 535">
              <a:extLst>
                <a:ext uri="{FF2B5EF4-FFF2-40B4-BE49-F238E27FC236}">
                  <a16:creationId xmlns:a16="http://schemas.microsoft.com/office/drawing/2014/main" id="{646055CD-52C5-4212-90B6-239FA020D886}"/>
                </a:ext>
              </a:extLst>
            </p:cNvPr>
            <p:cNvSpPr txBox="1"/>
            <p:nvPr/>
          </p:nvSpPr>
          <p:spPr>
            <a:xfrm>
              <a:off x="3287539" y="3266620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</a:t>
              </a:r>
            </a:p>
          </p:txBody>
        </p:sp>
        <p:sp>
          <p:nvSpPr>
            <p:cNvPr id="537" name="CasellaDiTesto 536">
              <a:extLst>
                <a:ext uri="{FF2B5EF4-FFF2-40B4-BE49-F238E27FC236}">
                  <a16:creationId xmlns:a16="http://schemas.microsoft.com/office/drawing/2014/main" id="{7E10F50C-9285-446B-AEE7-6F03EA46FD10}"/>
                </a:ext>
              </a:extLst>
            </p:cNvPr>
            <p:cNvSpPr txBox="1"/>
            <p:nvPr/>
          </p:nvSpPr>
          <p:spPr>
            <a:xfrm>
              <a:off x="3200977" y="1936674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00</a:t>
              </a:r>
            </a:p>
          </p:txBody>
        </p:sp>
        <p:sp>
          <p:nvSpPr>
            <p:cNvPr id="538" name="CasellaDiTesto 537">
              <a:extLst>
                <a:ext uri="{FF2B5EF4-FFF2-40B4-BE49-F238E27FC236}">
                  <a16:creationId xmlns:a16="http://schemas.microsoft.com/office/drawing/2014/main" id="{40E2D885-ACB8-442E-9FFB-93DDB49F783B}"/>
                </a:ext>
              </a:extLst>
            </p:cNvPr>
            <p:cNvSpPr txBox="1"/>
            <p:nvPr/>
          </p:nvSpPr>
          <p:spPr>
            <a:xfrm>
              <a:off x="3423447" y="3366108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539" name="CasellaDiTesto 538">
              <a:extLst>
                <a:ext uri="{FF2B5EF4-FFF2-40B4-BE49-F238E27FC236}">
                  <a16:creationId xmlns:a16="http://schemas.microsoft.com/office/drawing/2014/main" id="{3AB89551-E8D4-4502-964A-3F68DA96C1D1}"/>
                </a:ext>
              </a:extLst>
            </p:cNvPr>
            <p:cNvSpPr txBox="1"/>
            <p:nvPr/>
          </p:nvSpPr>
          <p:spPr>
            <a:xfrm>
              <a:off x="3474264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8</a:t>
              </a:r>
            </a:p>
          </p:txBody>
        </p:sp>
        <p:sp>
          <p:nvSpPr>
            <p:cNvPr id="540" name="CasellaDiTesto 539">
              <a:extLst>
                <a:ext uri="{FF2B5EF4-FFF2-40B4-BE49-F238E27FC236}">
                  <a16:creationId xmlns:a16="http://schemas.microsoft.com/office/drawing/2014/main" id="{8F707A4A-7C61-47E1-8A2B-5A7003B7FCE7}"/>
                </a:ext>
              </a:extLst>
            </p:cNvPr>
            <p:cNvSpPr txBox="1"/>
            <p:nvPr/>
          </p:nvSpPr>
          <p:spPr>
            <a:xfrm>
              <a:off x="3560955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7</a:t>
              </a:r>
            </a:p>
          </p:txBody>
        </p:sp>
        <p:sp>
          <p:nvSpPr>
            <p:cNvPr id="541" name="CasellaDiTesto 540">
              <a:extLst>
                <a:ext uri="{FF2B5EF4-FFF2-40B4-BE49-F238E27FC236}">
                  <a16:creationId xmlns:a16="http://schemas.microsoft.com/office/drawing/2014/main" id="{DAAF4BEF-1A8A-4230-BE63-51137A4BA7BF}"/>
                </a:ext>
              </a:extLst>
            </p:cNvPr>
            <p:cNvSpPr txBox="1"/>
            <p:nvPr/>
          </p:nvSpPr>
          <p:spPr>
            <a:xfrm>
              <a:off x="3649154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6</a:t>
              </a:r>
            </a:p>
          </p:txBody>
        </p:sp>
        <p:sp>
          <p:nvSpPr>
            <p:cNvPr id="542" name="CasellaDiTesto 541">
              <a:extLst>
                <a:ext uri="{FF2B5EF4-FFF2-40B4-BE49-F238E27FC236}">
                  <a16:creationId xmlns:a16="http://schemas.microsoft.com/office/drawing/2014/main" id="{5537EFA8-22E1-4F5C-9DB0-C8E9C8FA4F0F}"/>
                </a:ext>
              </a:extLst>
            </p:cNvPr>
            <p:cNvSpPr txBox="1"/>
            <p:nvPr/>
          </p:nvSpPr>
          <p:spPr>
            <a:xfrm>
              <a:off x="3719021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5</a:t>
              </a:r>
            </a:p>
          </p:txBody>
        </p:sp>
        <p:sp>
          <p:nvSpPr>
            <p:cNvPr id="543" name="CasellaDiTesto 542">
              <a:extLst>
                <a:ext uri="{FF2B5EF4-FFF2-40B4-BE49-F238E27FC236}">
                  <a16:creationId xmlns:a16="http://schemas.microsoft.com/office/drawing/2014/main" id="{4B07BB2E-CA81-4FF3-9AD6-CCA2620EDA6C}"/>
                </a:ext>
              </a:extLst>
            </p:cNvPr>
            <p:cNvSpPr txBox="1"/>
            <p:nvPr/>
          </p:nvSpPr>
          <p:spPr>
            <a:xfrm>
              <a:off x="3820980" y="3366108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544" name="CasellaDiTesto 543">
              <a:extLst>
                <a:ext uri="{FF2B5EF4-FFF2-40B4-BE49-F238E27FC236}">
                  <a16:creationId xmlns:a16="http://schemas.microsoft.com/office/drawing/2014/main" id="{7BDA8293-3346-4B02-984C-B5F56208F9A2}"/>
                </a:ext>
              </a:extLst>
            </p:cNvPr>
            <p:cNvSpPr txBox="1"/>
            <p:nvPr/>
          </p:nvSpPr>
          <p:spPr>
            <a:xfrm>
              <a:off x="3871797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8</a:t>
              </a:r>
            </a:p>
          </p:txBody>
        </p:sp>
        <p:sp>
          <p:nvSpPr>
            <p:cNvPr id="545" name="CasellaDiTesto 544">
              <a:extLst>
                <a:ext uri="{FF2B5EF4-FFF2-40B4-BE49-F238E27FC236}">
                  <a16:creationId xmlns:a16="http://schemas.microsoft.com/office/drawing/2014/main" id="{D795A4EF-CE43-4C8A-B162-964027CAAFC8}"/>
                </a:ext>
              </a:extLst>
            </p:cNvPr>
            <p:cNvSpPr txBox="1"/>
            <p:nvPr/>
          </p:nvSpPr>
          <p:spPr>
            <a:xfrm>
              <a:off x="3958488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7</a:t>
              </a:r>
            </a:p>
          </p:txBody>
        </p:sp>
        <p:sp>
          <p:nvSpPr>
            <p:cNvPr id="546" name="CasellaDiTesto 545">
              <a:extLst>
                <a:ext uri="{FF2B5EF4-FFF2-40B4-BE49-F238E27FC236}">
                  <a16:creationId xmlns:a16="http://schemas.microsoft.com/office/drawing/2014/main" id="{03E12725-B193-4422-AF83-8C955FDA8E03}"/>
                </a:ext>
              </a:extLst>
            </p:cNvPr>
            <p:cNvSpPr txBox="1"/>
            <p:nvPr/>
          </p:nvSpPr>
          <p:spPr>
            <a:xfrm>
              <a:off x="4046687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6</a:t>
              </a:r>
            </a:p>
          </p:txBody>
        </p:sp>
        <p:sp>
          <p:nvSpPr>
            <p:cNvPr id="547" name="CasellaDiTesto 546">
              <a:extLst>
                <a:ext uri="{FF2B5EF4-FFF2-40B4-BE49-F238E27FC236}">
                  <a16:creationId xmlns:a16="http://schemas.microsoft.com/office/drawing/2014/main" id="{A007CC5A-4ACB-4251-A35A-0FFEC9006C92}"/>
                </a:ext>
              </a:extLst>
            </p:cNvPr>
            <p:cNvSpPr txBox="1"/>
            <p:nvPr/>
          </p:nvSpPr>
          <p:spPr>
            <a:xfrm>
              <a:off x="4116554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5</a:t>
              </a:r>
            </a:p>
          </p:txBody>
        </p:sp>
        <p:sp>
          <p:nvSpPr>
            <p:cNvPr id="548" name="CasellaDiTesto 547">
              <a:extLst>
                <a:ext uri="{FF2B5EF4-FFF2-40B4-BE49-F238E27FC236}">
                  <a16:creationId xmlns:a16="http://schemas.microsoft.com/office/drawing/2014/main" id="{906E6E06-423F-4358-B972-6072E4DA4174}"/>
                </a:ext>
              </a:extLst>
            </p:cNvPr>
            <p:cNvSpPr txBox="1"/>
            <p:nvPr/>
          </p:nvSpPr>
          <p:spPr>
            <a:xfrm>
              <a:off x="4212770" y="3366108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549" name="CasellaDiTesto 548">
              <a:extLst>
                <a:ext uri="{FF2B5EF4-FFF2-40B4-BE49-F238E27FC236}">
                  <a16:creationId xmlns:a16="http://schemas.microsoft.com/office/drawing/2014/main" id="{D3DB3FA2-1455-4396-9FBB-901BAECA1AAC}"/>
                </a:ext>
              </a:extLst>
            </p:cNvPr>
            <p:cNvSpPr txBox="1"/>
            <p:nvPr/>
          </p:nvSpPr>
          <p:spPr>
            <a:xfrm>
              <a:off x="4263587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8</a:t>
              </a:r>
            </a:p>
          </p:txBody>
        </p:sp>
        <p:sp>
          <p:nvSpPr>
            <p:cNvPr id="550" name="CasellaDiTesto 549">
              <a:extLst>
                <a:ext uri="{FF2B5EF4-FFF2-40B4-BE49-F238E27FC236}">
                  <a16:creationId xmlns:a16="http://schemas.microsoft.com/office/drawing/2014/main" id="{F2026D6A-4954-43B9-AE4A-E67C2B8107A2}"/>
                </a:ext>
              </a:extLst>
            </p:cNvPr>
            <p:cNvSpPr txBox="1"/>
            <p:nvPr/>
          </p:nvSpPr>
          <p:spPr>
            <a:xfrm>
              <a:off x="4350278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7</a:t>
              </a:r>
            </a:p>
          </p:txBody>
        </p:sp>
        <p:sp>
          <p:nvSpPr>
            <p:cNvPr id="551" name="CasellaDiTesto 550">
              <a:extLst>
                <a:ext uri="{FF2B5EF4-FFF2-40B4-BE49-F238E27FC236}">
                  <a16:creationId xmlns:a16="http://schemas.microsoft.com/office/drawing/2014/main" id="{AAC2D11E-32AB-48F3-A5E0-1F22D54041A6}"/>
                </a:ext>
              </a:extLst>
            </p:cNvPr>
            <p:cNvSpPr txBox="1"/>
            <p:nvPr/>
          </p:nvSpPr>
          <p:spPr>
            <a:xfrm>
              <a:off x="4438477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6</a:t>
              </a:r>
            </a:p>
          </p:txBody>
        </p:sp>
        <p:sp>
          <p:nvSpPr>
            <p:cNvPr id="552" name="CasellaDiTesto 551">
              <a:extLst>
                <a:ext uri="{FF2B5EF4-FFF2-40B4-BE49-F238E27FC236}">
                  <a16:creationId xmlns:a16="http://schemas.microsoft.com/office/drawing/2014/main" id="{47DD5080-2F9D-4459-BC3B-6698E6409CC6}"/>
                </a:ext>
              </a:extLst>
            </p:cNvPr>
            <p:cNvSpPr txBox="1"/>
            <p:nvPr/>
          </p:nvSpPr>
          <p:spPr>
            <a:xfrm>
              <a:off x="4508344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5</a:t>
              </a:r>
            </a:p>
          </p:txBody>
        </p:sp>
        <p:sp>
          <p:nvSpPr>
            <p:cNvPr id="553" name="CasellaDiTesto 552">
              <a:extLst>
                <a:ext uri="{FF2B5EF4-FFF2-40B4-BE49-F238E27FC236}">
                  <a16:creationId xmlns:a16="http://schemas.microsoft.com/office/drawing/2014/main" id="{93A79475-B35B-48F2-9EC9-5C26986A66F5}"/>
                </a:ext>
              </a:extLst>
            </p:cNvPr>
            <p:cNvSpPr txBox="1"/>
            <p:nvPr/>
          </p:nvSpPr>
          <p:spPr>
            <a:xfrm>
              <a:off x="4606718" y="3366108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554" name="CasellaDiTesto 553">
              <a:extLst>
                <a:ext uri="{FF2B5EF4-FFF2-40B4-BE49-F238E27FC236}">
                  <a16:creationId xmlns:a16="http://schemas.microsoft.com/office/drawing/2014/main" id="{796833AE-CC9A-4918-B478-1E15FE39A820}"/>
                </a:ext>
              </a:extLst>
            </p:cNvPr>
            <p:cNvSpPr txBox="1"/>
            <p:nvPr/>
          </p:nvSpPr>
          <p:spPr>
            <a:xfrm>
              <a:off x="4657535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8</a:t>
              </a:r>
            </a:p>
          </p:txBody>
        </p:sp>
        <p:sp>
          <p:nvSpPr>
            <p:cNvPr id="555" name="CasellaDiTesto 554">
              <a:extLst>
                <a:ext uri="{FF2B5EF4-FFF2-40B4-BE49-F238E27FC236}">
                  <a16:creationId xmlns:a16="http://schemas.microsoft.com/office/drawing/2014/main" id="{FF80CF12-390A-4604-94BD-D445CD584D1E}"/>
                </a:ext>
              </a:extLst>
            </p:cNvPr>
            <p:cNvSpPr txBox="1"/>
            <p:nvPr/>
          </p:nvSpPr>
          <p:spPr>
            <a:xfrm>
              <a:off x="4744226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7</a:t>
              </a:r>
            </a:p>
          </p:txBody>
        </p:sp>
        <p:sp>
          <p:nvSpPr>
            <p:cNvPr id="556" name="CasellaDiTesto 555">
              <a:extLst>
                <a:ext uri="{FF2B5EF4-FFF2-40B4-BE49-F238E27FC236}">
                  <a16:creationId xmlns:a16="http://schemas.microsoft.com/office/drawing/2014/main" id="{0A391A7C-57B4-4BCF-9350-81B57D4C27A1}"/>
                </a:ext>
              </a:extLst>
            </p:cNvPr>
            <p:cNvSpPr txBox="1"/>
            <p:nvPr/>
          </p:nvSpPr>
          <p:spPr>
            <a:xfrm>
              <a:off x="4832425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6</a:t>
              </a:r>
            </a:p>
          </p:txBody>
        </p:sp>
        <p:sp>
          <p:nvSpPr>
            <p:cNvPr id="557" name="CasellaDiTesto 556">
              <a:extLst>
                <a:ext uri="{FF2B5EF4-FFF2-40B4-BE49-F238E27FC236}">
                  <a16:creationId xmlns:a16="http://schemas.microsoft.com/office/drawing/2014/main" id="{5E56B103-613B-4ACB-9DC0-05B379EF73B2}"/>
                </a:ext>
              </a:extLst>
            </p:cNvPr>
            <p:cNvSpPr txBox="1"/>
            <p:nvPr/>
          </p:nvSpPr>
          <p:spPr>
            <a:xfrm>
              <a:off x="4902292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5</a:t>
              </a:r>
            </a:p>
          </p:txBody>
        </p:sp>
        <p:sp>
          <p:nvSpPr>
            <p:cNvPr id="558" name="CasellaDiTesto 557">
              <a:extLst>
                <a:ext uri="{FF2B5EF4-FFF2-40B4-BE49-F238E27FC236}">
                  <a16:creationId xmlns:a16="http://schemas.microsoft.com/office/drawing/2014/main" id="{E701F582-5C45-4F49-B62B-3BB3363E7E68}"/>
                </a:ext>
              </a:extLst>
            </p:cNvPr>
            <p:cNvSpPr txBox="1"/>
            <p:nvPr/>
          </p:nvSpPr>
          <p:spPr>
            <a:xfrm>
              <a:off x="4992158" y="3366108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559" name="CasellaDiTesto 558">
              <a:extLst>
                <a:ext uri="{FF2B5EF4-FFF2-40B4-BE49-F238E27FC236}">
                  <a16:creationId xmlns:a16="http://schemas.microsoft.com/office/drawing/2014/main" id="{ED637667-19E6-458F-AC4B-0D5C8CDA6835}"/>
                </a:ext>
              </a:extLst>
            </p:cNvPr>
            <p:cNvSpPr txBox="1"/>
            <p:nvPr/>
          </p:nvSpPr>
          <p:spPr>
            <a:xfrm>
              <a:off x="5042975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8</a:t>
              </a:r>
            </a:p>
          </p:txBody>
        </p:sp>
        <p:sp>
          <p:nvSpPr>
            <p:cNvPr id="560" name="CasellaDiTesto 559">
              <a:extLst>
                <a:ext uri="{FF2B5EF4-FFF2-40B4-BE49-F238E27FC236}">
                  <a16:creationId xmlns:a16="http://schemas.microsoft.com/office/drawing/2014/main" id="{F924D9C3-BD53-480B-ADF5-04C71B4D7076}"/>
                </a:ext>
              </a:extLst>
            </p:cNvPr>
            <p:cNvSpPr txBox="1"/>
            <p:nvPr/>
          </p:nvSpPr>
          <p:spPr>
            <a:xfrm>
              <a:off x="5129666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7</a:t>
              </a:r>
            </a:p>
          </p:txBody>
        </p:sp>
        <p:sp>
          <p:nvSpPr>
            <p:cNvPr id="561" name="CasellaDiTesto 560">
              <a:extLst>
                <a:ext uri="{FF2B5EF4-FFF2-40B4-BE49-F238E27FC236}">
                  <a16:creationId xmlns:a16="http://schemas.microsoft.com/office/drawing/2014/main" id="{9BEFC0AB-C4F5-4D44-A54C-32FBB859A077}"/>
                </a:ext>
              </a:extLst>
            </p:cNvPr>
            <p:cNvSpPr txBox="1"/>
            <p:nvPr/>
          </p:nvSpPr>
          <p:spPr>
            <a:xfrm>
              <a:off x="5217865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6</a:t>
              </a:r>
            </a:p>
          </p:txBody>
        </p:sp>
        <p:sp>
          <p:nvSpPr>
            <p:cNvPr id="562" name="CasellaDiTesto 561">
              <a:extLst>
                <a:ext uri="{FF2B5EF4-FFF2-40B4-BE49-F238E27FC236}">
                  <a16:creationId xmlns:a16="http://schemas.microsoft.com/office/drawing/2014/main" id="{A661DF9B-D063-4D3F-A50B-ACDB178AC973}"/>
                </a:ext>
              </a:extLst>
            </p:cNvPr>
            <p:cNvSpPr txBox="1"/>
            <p:nvPr/>
          </p:nvSpPr>
          <p:spPr>
            <a:xfrm>
              <a:off x="5287732" y="3366108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5</a:t>
              </a:r>
            </a:p>
          </p:txBody>
        </p:sp>
        <p:sp>
          <p:nvSpPr>
            <p:cNvPr id="563" name="CasellaDiTesto 562">
              <a:extLst>
                <a:ext uri="{FF2B5EF4-FFF2-40B4-BE49-F238E27FC236}">
                  <a16:creationId xmlns:a16="http://schemas.microsoft.com/office/drawing/2014/main" id="{3A9656F0-0BA9-430B-885F-57C7D68C8038}"/>
                </a:ext>
              </a:extLst>
            </p:cNvPr>
            <p:cNvSpPr txBox="1"/>
            <p:nvPr/>
          </p:nvSpPr>
          <p:spPr>
            <a:xfrm>
              <a:off x="4191550" y="3493852"/>
              <a:ext cx="6671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Log [AZD] (M)</a:t>
              </a:r>
            </a:p>
          </p:txBody>
        </p:sp>
        <p:cxnSp>
          <p:nvCxnSpPr>
            <p:cNvPr id="564" name="Connettore diritto 563">
              <a:extLst>
                <a:ext uri="{FF2B5EF4-FFF2-40B4-BE49-F238E27FC236}">
                  <a16:creationId xmlns:a16="http://schemas.microsoft.com/office/drawing/2014/main" id="{3E5A0A9B-A2EB-4ACA-A42E-8014F6A600F0}"/>
                </a:ext>
              </a:extLst>
            </p:cNvPr>
            <p:cNvCxnSpPr>
              <a:cxnSpLocks/>
            </p:cNvCxnSpPr>
            <p:nvPr/>
          </p:nvCxnSpPr>
          <p:spPr>
            <a:xfrm>
              <a:off x="3480654" y="3529174"/>
              <a:ext cx="19527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5" name="Connettore diritto 564">
              <a:extLst>
                <a:ext uri="{FF2B5EF4-FFF2-40B4-BE49-F238E27FC236}">
                  <a16:creationId xmlns:a16="http://schemas.microsoft.com/office/drawing/2014/main" id="{2687C28F-84A3-465A-9977-0B362F62D1EC}"/>
                </a:ext>
              </a:extLst>
            </p:cNvPr>
            <p:cNvCxnSpPr/>
            <p:nvPr/>
          </p:nvCxnSpPr>
          <p:spPr>
            <a:xfrm>
              <a:off x="3896400" y="2213980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6" name="Connettore diritto 565">
              <a:extLst>
                <a:ext uri="{FF2B5EF4-FFF2-40B4-BE49-F238E27FC236}">
                  <a16:creationId xmlns:a16="http://schemas.microsoft.com/office/drawing/2014/main" id="{0D056DAF-4CF1-40FA-B200-3E202335E028}"/>
                </a:ext>
              </a:extLst>
            </p:cNvPr>
            <p:cNvCxnSpPr/>
            <p:nvPr/>
          </p:nvCxnSpPr>
          <p:spPr>
            <a:xfrm>
              <a:off x="4294170" y="2213980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7" name="Connettore diritto 566">
              <a:extLst>
                <a:ext uri="{FF2B5EF4-FFF2-40B4-BE49-F238E27FC236}">
                  <a16:creationId xmlns:a16="http://schemas.microsoft.com/office/drawing/2014/main" id="{32B69136-63EA-4BB0-B268-61CD14FFAC0B}"/>
                </a:ext>
              </a:extLst>
            </p:cNvPr>
            <p:cNvCxnSpPr/>
            <p:nvPr/>
          </p:nvCxnSpPr>
          <p:spPr>
            <a:xfrm>
              <a:off x="4705807" y="2213980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8" name="Connettore diritto 567">
              <a:extLst>
                <a:ext uri="{FF2B5EF4-FFF2-40B4-BE49-F238E27FC236}">
                  <a16:creationId xmlns:a16="http://schemas.microsoft.com/office/drawing/2014/main" id="{3DFD4DE8-93E0-4493-A579-BFDBAF683359}"/>
                </a:ext>
              </a:extLst>
            </p:cNvPr>
            <p:cNvCxnSpPr/>
            <p:nvPr/>
          </p:nvCxnSpPr>
          <p:spPr>
            <a:xfrm>
              <a:off x="5102133" y="2213980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9" name="CasellaDiTesto 568">
              <a:extLst>
                <a:ext uri="{FF2B5EF4-FFF2-40B4-BE49-F238E27FC236}">
                  <a16:creationId xmlns:a16="http://schemas.microsoft.com/office/drawing/2014/main" id="{D4DC2AD2-FE4A-475A-BCFA-09B37D015E4C}"/>
                </a:ext>
              </a:extLst>
            </p:cNvPr>
            <p:cNvSpPr txBox="1"/>
            <p:nvPr/>
          </p:nvSpPr>
          <p:spPr>
            <a:xfrm>
              <a:off x="3935605" y="2049325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sp>
          <p:nvSpPr>
            <p:cNvPr id="570" name="CasellaDiTesto 569">
              <a:extLst>
                <a:ext uri="{FF2B5EF4-FFF2-40B4-BE49-F238E27FC236}">
                  <a16:creationId xmlns:a16="http://schemas.microsoft.com/office/drawing/2014/main" id="{51F73A60-7493-4561-9E16-C5C05BEEEA23}"/>
                </a:ext>
              </a:extLst>
            </p:cNvPr>
            <p:cNvSpPr txBox="1"/>
            <p:nvPr/>
          </p:nvSpPr>
          <p:spPr>
            <a:xfrm>
              <a:off x="4322733" y="2049325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50</a:t>
              </a:r>
            </a:p>
          </p:txBody>
        </p:sp>
        <p:sp>
          <p:nvSpPr>
            <p:cNvPr id="571" name="CasellaDiTesto 570">
              <a:extLst>
                <a:ext uri="{FF2B5EF4-FFF2-40B4-BE49-F238E27FC236}">
                  <a16:creationId xmlns:a16="http://schemas.microsoft.com/office/drawing/2014/main" id="{1B3278AE-011F-47B4-AF47-8E3D16A8AF7D}"/>
                </a:ext>
              </a:extLst>
            </p:cNvPr>
            <p:cNvSpPr txBox="1"/>
            <p:nvPr/>
          </p:nvSpPr>
          <p:spPr>
            <a:xfrm>
              <a:off x="4731559" y="2049325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500</a:t>
              </a:r>
            </a:p>
          </p:txBody>
        </p:sp>
        <p:sp>
          <p:nvSpPr>
            <p:cNvPr id="572" name="CasellaDiTesto 571">
              <a:extLst>
                <a:ext uri="{FF2B5EF4-FFF2-40B4-BE49-F238E27FC236}">
                  <a16:creationId xmlns:a16="http://schemas.microsoft.com/office/drawing/2014/main" id="{3853A2E1-790E-4093-80B5-AF1FF44A9162}"/>
                </a:ext>
              </a:extLst>
            </p:cNvPr>
            <p:cNvSpPr txBox="1"/>
            <p:nvPr/>
          </p:nvSpPr>
          <p:spPr>
            <a:xfrm>
              <a:off x="5103656" y="2049325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0</a:t>
              </a:r>
            </a:p>
          </p:txBody>
        </p:sp>
        <p:cxnSp>
          <p:nvCxnSpPr>
            <p:cNvPr id="573" name="Connettore diritto 572">
              <a:extLst>
                <a:ext uri="{FF2B5EF4-FFF2-40B4-BE49-F238E27FC236}">
                  <a16:creationId xmlns:a16="http://schemas.microsoft.com/office/drawing/2014/main" id="{93E915FA-1CA2-4366-A9B2-1D6A0C9B0A41}"/>
                </a:ext>
              </a:extLst>
            </p:cNvPr>
            <p:cNvCxnSpPr>
              <a:cxnSpLocks/>
            </p:cNvCxnSpPr>
            <p:nvPr/>
          </p:nvCxnSpPr>
          <p:spPr>
            <a:xfrm>
              <a:off x="4073394" y="2049325"/>
              <a:ext cx="120915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4" name="CasellaDiTesto 573">
              <a:extLst>
                <a:ext uri="{FF2B5EF4-FFF2-40B4-BE49-F238E27FC236}">
                  <a16:creationId xmlns:a16="http://schemas.microsoft.com/office/drawing/2014/main" id="{B375F4B2-3821-4488-B967-7A9FF47CCE84}"/>
                </a:ext>
              </a:extLst>
            </p:cNvPr>
            <p:cNvSpPr txBox="1"/>
            <p:nvPr/>
          </p:nvSpPr>
          <p:spPr>
            <a:xfrm>
              <a:off x="4417324" y="1860375"/>
              <a:ext cx="52770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[</a:t>
              </a:r>
              <a:r>
                <a:rPr lang="it-IT" sz="600" dirty="0" err="1"/>
                <a:t>Abe</a:t>
              </a:r>
              <a:r>
                <a:rPr lang="it-IT" sz="600" dirty="0"/>
                <a:t>] (</a:t>
              </a:r>
              <a:r>
                <a:rPr lang="it-IT" sz="600" dirty="0" err="1"/>
                <a:t>nM</a:t>
              </a:r>
              <a:r>
                <a:rPr lang="it-IT" sz="600" dirty="0"/>
                <a:t>)</a:t>
              </a:r>
            </a:p>
          </p:txBody>
        </p:sp>
        <p:sp>
          <p:nvSpPr>
            <p:cNvPr id="575" name="CasellaDiTesto 574">
              <a:extLst>
                <a:ext uri="{FF2B5EF4-FFF2-40B4-BE49-F238E27FC236}">
                  <a16:creationId xmlns:a16="http://schemas.microsoft.com/office/drawing/2014/main" id="{9A64B2E8-A524-4D01-9510-E936BE777123}"/>
                </a:ext>
              </a:extLst>
            </p:cNvPr>
            <p:cNvSpPr txBox="1"/>
            <p:nvPr/>
          </p:nvSpPr>
          <p:spPr>
            <a:xfrm>
              <a:off x="3425205" y="3191318"/>
              <a:ext cx="4171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 dirty="0"/>
                <a:t>Y537S</a:t>
              </a:r>
            </a:p>
          </p:txBody>
        </p:sp>
      </p:grpSp>
      <p:grpSp>
        <p:nvGrpSpPr>
          <p:cNvPr id="621" name="Gruppo 620">
            <a:extLst>
              <a:ext uri="{FF2B5EF4-FFF2-40B4-BE49-F238E27FC236}">
                <a16:creationId xmlns:a16="http://schemas.microsoft.com/office/drawing/2014/main" id="{8292B586-EA83-4F53-9AEA-3B7EFBC6B831}"/>
              </a:ext>
            </a:extLst>
          </p:cNvPr>
          <p:cNvGrpSpPr/>
          <p:nvPr/>
        </p:nvGrpSpPr>
        <p:grpSpPr>
          <a:xfrm>
            <a:off x="2041120" y="3545945"/>
            <a:ext cx="2480910" cy="1818143"/>
            <a:chOff x="1952190" y="2872507"/>
            <a:chExt cx="2480910" cy="1818143"/>
          </a:xfrm>
        </p:grpSpPr>
        <p:pic>
          <p:nvPicPr>
            <p:cNvPr id="620" name="Immagine 619">
              <a:extLst>
                <a:ext uri="{FF2B5EF4-FFF2-40B4-BE49-F238E27FC236}">
                  <a16:creationId xmlns:a16="http://schemas.microsoft.com/office/drawing/2014/main" id="{491CA75E-FC1C-4A9C-8F88-EA38DD44851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09894" y="3010088"/>
              <a:ext cx="2083686" cy="1440000"/>
            </a:xfrm>
            <a:prstGeom prst="rect">
              <a:avLst/>
            </a:prstGeom>
          </p:spPr>
        </p:pic>
        <p:sp>
          <p:nvSpPr>
            <p:cNvPr id="578" name="CasellaDiTesto 577">
              <a:extLst>
                <a:ext uri="{FF2B5EF4-FFF2-40B4-BE49-F238E27FC236}">
                  <a16:creationId xmlns:a16="http://schemas.microsoft.com/office/drawing/2014/main" id="{A3F74C7B-49EA-48B3-9BD9-00722578AFA3}"/>
                </a:ext>
              </a:extLst>
            </p:cNvPr>
            <p:cNvSpPr txBox="1"/>
            <p:nvPr/>
          </p:nvSpPr>
          <p:spPr>
            <a:xfrm rot="16200000">
              <a:off x="1387472" y="3582019"/>
              <a:ext cx="1406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600" dirty="0" err="1"/>
                <a:t>Number</a:t>
              </a:r>
              <a:r>
                <a:rPr lang="it-IT" sz="600" dirty="0"/>
                <a:t> of </a:t>
              </a:r>
              <a:r>
                <a:rPr lang="it-IT" sz="600" dirty="0" err="1"/>
                <a:t>cells</a:t>
              </a:r>
              <a:endParaRPr lang="it-IT" sz="600" dirty="0"/>
            </a:p>
            <a:p>
              <a:pPr algn="ctr"/>
              <a:r>
                <a:rPr lang="it-IT" sz="600" dirty="0"/>
                <a:t>(% on -)</a:t>
              </a:r>
              <a:endParaRPr lang="it-IT" sz="6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579" name="CasellaDiTesto 578">
              <a:extLst>
                <a:ext uri="{FF2B5EF4-FFF2-40B4-BE49-F238E27FC236}">
                  <a16:creationId xmlns:a16="http://schemas.microsoft.com/office/drawing/2014/main" id="{1F03AFA5-5FA6-4BB3-B5D0-7FBF7FFAA007}"/>
                </a:ext>
              </a:extLst>
            </p:cNvPr>
            <p:cNvSpPr txBox="1"/>
            <p:nvPr/>
          </p:nvSpPr>
          <p:spPr>
            <a:xfrm>
              <a:off x="2092749" y="3614436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sp>
          <p:nvSpPr>
            <p:cNvPr id="580" name="CasellaDiTesto 579">
              <a:extLst>
                <a:ext uri="{FF2B5EF4-FFF2-40B4-BE49-F238E27FC236}">
                  <a16:creationId xmlns:a16="http://schemas.microsoft.com/office/drawing/2014/main" id="{6A1B7071-35C7-4FF1-A2E1-A2E43BD9F53F}"/>
                </a:ext>
              </a:extLst>
            </p:cNvPr>
            <p:cNvSpPr txBox="1"/>
            <p:nvPr/>
          </p:nvSpPr>
          <p:spPr>
            <a:xfrm>
              <a:off x="2179311" y="427875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</a:t>
              </a:r>
            </a:p>
          </p:txBody>
        </p:sp>
        <p:sp>
          <p:nvSpPr>
            <p:cNvPr id="581" name="CasellaDiTesto 580">
              <a:extLst>
                <a:ext uri="{FF2B5EF4-FFF2-40B4-BE49-F238E27FC236}">
                  <a16:creationId xmlns:a16="http://schemas.microsoft.com/office/drawing/2014/main" id="{B603EC2C-5752-4BC0-9C48-1F5737D3B721}"/>
                </a:ext>
              </a:extLst>
            </p:cNvPr>
            <p:cNvSpPr txBox="1"/>
            <p:nvPr/>
          </p:nvSpPr>
          <p:spPr>
            <a:xfrm>
              <a:off x="2092749" y="2948806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00</a:t>
              </a:r>
            </a:p>
          </p:txBody>
        </p:sp>
        <p:sp>
          <p:nvSpPr>
            <p:cNvPr id="582" name="CasellaDiTesto 581">
              <a:extLst>
                <a:ext uri="{FF2B5EF4-FFF2-40B4-BE49-F238E27FC236}">
                  <a16:creationId xmlns:a16="http://schemas.microsoft.com/office/drawing/2014/main" id="{103615C6-33E5-4A01-8F8D-789C0C244CB5}"/>
                </a:ext>
              </a:extLst>
            </p:cNvPr>
            <p:cNvSpPr txBox="1"/>
            <p:nvPr/>
          </p:nvSpPr>
          <p:spPr>
            <a:xfrm>
              <a:off x="2315219" y="437824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583" name="CasellaDiTesto 582">
              <a:extLst>
                <a:ext uri="{FF2B5EF4-FFF2-40B4-BE49-F238E27FC236}">
                  <a16:creationId xmlns:a16="http://schemas.microsoft.com/office/drawing/2014/main" id="{F5723645-033A-4215-ABA6-A8CF8AC8AC89}"/>
                </a:ext>
              </a:extLst>
            </p:cNvPr>
            <p:cNvSpPr txBox="1"/>
            <p:nvPr/>
          </p:nvSpPr>
          <p:spPr>
            <a:xfrm>
              <a:off x="2366036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8</a:t>
              </a:r>
            </a:p>
          </p:txBody>
        </p:sp>
        <p:sp>
          <p:nvSpPr>
            <p:cNvPr id="584" name="CasellaDiTesto 583">
              <a:extLst>
                <a:ext uri="{FF2B5EF4-FFF2-40B4-BE49-F238E27FC236}">
                  <a16:creationId xmlns:a16="http://schemas.microsoft.com/office/drawing/2014/main" id="{BCEDE46F-4EBD-41B5-AFE6-9FACF6776D04}"/>
                </a:ext>
              </a:extLst>
            </p:cNvPr>
            <p:cNvSpPr txBox="1"/>
            <p:nvPr/>
          </p:nvSpPr>
          <p:spPr>
            <a:xfrm>
              <a:off x="2452727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7</a:t>
              </a:r>
            </a:p>
          </p:txBody>
        </p:sp>
        <p:sp>
          <p:nvSpPr>
            <p:cNvPr id="585" name="CasellaDiTesto 584">
              <a:extLst>
                <a:ext uri="{FF2B5EF4-FFF2-40B4-BE49-F238E27FC236}">
                  <a16:creationId xmlns:a16="http://schemas.microsoft.com/office/drawing/2014/main" id="{277D8E70-6575-4A7D-A2A0-6D4D65439D7D}"/>
                </a:ext>
              </a:extLst>
            </p:cNvPr>
            <p:cNvSpPr txBox="1"/>
            <p:nvPr/>
          </p:nvSpPr>
          <p:spPr>
            <a:xfrm>
              <a:off x="2540926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6</a:t>
              </a:r>
            </a:p>
          </p:txBody>
        </p:sp>
        <p:sp>
          <p:nvSpPr>
            <p:cNvPr id="586" name="CasellaDiTesto 585">
              <a:extLst>
                <a:ext uri="{FF2B5EF4-FFF2-40B4-BE49-F238E27FC236}">
                  <a16:creationId xmlns:a16="http://schemas.microsoft.com/office/drawing/2014/main" id="{BFC383B3-38E0-4E1D-8FBA-624B252EE2C4}"/>
                </a:ext>
              </a:extLst>
            </p:cNvPr>
            <p:cNvSpPr txBox="1"/>
            <p:nvPr/>
          </p:nvSpPr>
          <p:spPr>
            <a:xfrm>
              <a:off x="2610793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5</a:t>
              </a:r>
            </a:p>
          </p:txBody>
        </p:sp>
        <p:sp>
          <p:nvSpPr>
            <p:cNvPr id="587" name="CasellaDiTesto 586">
              <a:extLst>
                <a:ext uri="{FF2B5EF4-FFF2-40B4-BE49-F238E27FC236}">
                  <a16:creationId xmlns:a16="http://schemas.microsoft.com/office/drawing/2014/main" id="{F986337F-A07C-496A-BB2E-A88D0F865131}"/>
                </a:ext>
              </a:extLst>
            </p:cNvPr>
            <p:cNvSpPr txBox="1"/>
            <p:nvPr/>
          </p:nvSpPr>
          <p:spPr>
            <a:xfrm>
              <a:off x="2712752" y="437824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588" name="CasellaDiTesto 587">
              <a:extLst>
                <a:ext uri="{FF2B5EF4-FFF2-40B4-BE49-F238E27FC236}">
                  <a16:creationId xmlns:a16="http://schemas.microsoft.com/office/drawing/2014/main" id="{1F8E59DA-7059-4C2E-9D0D-71F3168E6FF3}"/>
                </a:ext>
              </a:extLst>
            </p:cNvPr>
            <p:cNvSpPr txBox="1"/>
            <p:nvPr/>
          </p:nvSpPr>
          <p:spPr>
            <a:xfrm>
              <a:off x="2763569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8</a:t>
              </a:r>
            </a:p>
          </p:txBody>
        </p:sp>
        <p:sp>
          <p:nvSpPr>
            <p:cNvPr id="589" name="CasellaDiTesto 588">
              <a:extLst>
                <a:ext uri="{FF2B5EF4-FFF2-40B4-BE49-F238E27FC236}">
                  <a16:creationId xmlns:a16="http://schemas.microsoft.com/office/drawing/2014/main" id="{0034A421-0F78-48A2-8C47-E853C87E3787}"/>
                </a:ext>
              </a:extLst>
            </p:cNvPr>
            <p:cNvSpPr txBox="1"/>
            <p:nvPr/>
          </p:nvSpPr>
          <p:spPr>
            <a:xfrm>
              <a:off x="2850260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7</a:t>
              </a:r>
            </a:p>
          </p:txBody>
        </p:sp>
        <p:sp>
          <p:nvSpPr>
            <p:cNvPr id="590" name="CasellaDiTesto 589">
              <a:extLst>
                <a:ext uri="{FF2B5EF4-FFF2-40B4-BE49-F238E27FC236}">
                  <a16:creationId xmlns:a16="http://schemas.microsoft.com/office/drawing/2014/main" id="{AF6DEE7F-0D53-4DD5-BB87-A8DE71959C84}"/>
                </a:ext>
              </a:extLst>
            </p:cNvPr>
            <p:cNvSpPr txBox="1"/>
            <p:nvPr/>
          </p:nvSpPr>
          <p:spPr>
            <a:xfrm>
              <a:off x="2938459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6</a:t>
              </a:r>
            </a:p>
          </p:txBody>
        </p:sp>
        <p:sp>
          <p:nvSpPr>
            <p:cNvPr id="591" name="CasellaDiTesto 590">
              <a:extLst>
                <a:ext uri="{FF2B5EF4-FFF2-40B4-BE49-F238E27FC236}">
                  <a16:creationId xmlns:a16="http://schemas.microsoft.com/office/drawing/2014/main" id="{2967C632-0B27-4E09-8BA8-9291E4DAF61B}"/>
                </a:ext>
              </a:extLst>
            </p:cNvPr>
            <p:cNvSpPr txBox="1"/>
            <p:nvPr/>
          </p:nvSpPr>
          <p:spPr>
            <a:xfrm>
              <a:off x="3008326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5</a:t>
              </a:r>
            </a:p>
          </p:txBody>
        </p:sp>
        <p:sp>
          <p:nvSpPr>
            <p:cNvPr id="592" name="CasellaDiTesto 591">
              <a:extLst>
                <a:ext uri="{FF2B5EF4-FFF2-40B4-BE49-F238E27FC236}">
                  <a16:creationId xmlns:a16="http://schemas.microsoft.com/office/drawing/2014/main" id="{4635BC04-83C4-44B3-8C11-48EC34164B67}"/>
                </a:ext>
              </a:extLst>
            </p:cNvPr>
            <p:cNvSpPr txBox="1"/>
            <p:nvPr/>
          </p:nvSpPr>
          <p:spPr>
            <a:xfrm>
              <a:off x="3104542" y="437824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593" name="CasellaDiTesto 592">
              <a:extLst>
                <a:ext uri="{FF2B5EF4-FFF2-40B4-BE49-F238E27FC236}">
                  <a16:creationId xmlns:a16="http://schemas.microsoft.com/office/drawing/2014/main" id="{4C527652-EFC8-45F4-9092-D4C63ED2FBE7}"/>
                </a:ext>
              </a:extLst>
            </p:cNvPr>
            <p:cNvSpPr txBox="1"/>
            <p:nvPr/>
          </p:nvSpPr>
          <p:spPr>
            <a:xfrm>
              <a:off x="3155359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8</a:t>
              </a:r>
            </a:p>
          </p:txBody>
        </p:sp>
        <p:sp>
          <p:nvSpPr>
            <p:cNvPr id="594" name="CasellaDiTesto 593">
              <a:extLst>
                <a:ext uri="{FF2B5EF4-FFF2-40B4-BE49-F238E27FC236}">
                  <a16:creationId xmlns:a16="http://schemas.microsoft.com/office/drawing/2014/main" id="{AFEABBFF-8F8F-4581-9395-F9F98CD6D0F4}"/>
                </a:ext>
              </a:extLst>
            </p:cNvPr>
            <p:cNvSpPr txBox="1"/>
            <p:nvPr/>
          </p:nvSpPr>
          <p:spPr>
            <a:xfrm>
              <a:off x="3242050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7</a:t>
              </a:r>
            </a:p>
          </p:txBody>
        </p:sp>
        <p:sp>
          <p:nvSpPr>
            <p:cNvPr id="595" name="CasellaDiTesto 594">
              <a:extLst>
                <a:ext uri="{FF2B5EF4-FFF2-40B4-BE49-F238E27FC236}">
                  <a16:creationId xmlns:a16="http://schemas.microsoft.com/office/drawing/2014/main" id="{45C2123E-0B17-4368-AE4F-BB5EB27E1142}"/>
                </a:ext>
              </a:extLst>
            </p:cNvPr>
            <p:cNvSpPr txBox="1"/>
            <p:nvPr/>
          </p:nvSpPr>
          <p:spPr>
            <a:xfrm>
              <a:off x="3330249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6</a:t>
              </a:r>
            </a:p>
          </p:txBody>
        </p:sp>
        <p:sp>
          <p:nvSpPr>
            <p:cNvPr id="596" name="CasellaDiTesto 595">
              <a:extLst>
                <a:ext uri="{FF2B5EF4-FFF2-40B4-BE49-F238E27FC236}">
                  <a16:creationId xmlns:a16="http://schemas.microsoft.com/office/drawing/2014/main" id="{D1A90839-1148-413C-BBEB-7F4548EAA411}"/>
                </a:ext>
              </a:extLst>
            </p:cNvPr>
            <p:cNvSpPr txBox="1"/>
            <p:nvPr/>
          </p:nvSpPr>
          <p:spPr>
            <a:xfrm>
              <a:off x="3400116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5</a:t>
              </a:r>
            </a:p>
          </p:txBody>
        </p:sp>
        <p:sp>
          <p:nvSpPr>
            <p:cNvPr id="597" name="CasellaDiTesto 596">
              <a:extLst>
                <a:ext uri="{FF2B5EF4-FFF2-40B4-BE49-F238E27FC236}">
                  <a16:creationId xmlns:a16="http://schemas.microsoft.com/office/drawing/2014/main" id="{19E4E7A9-836C-496D-8033-8F7EBAF5BEF3}"/>
                </a:ext>
              </a:extLst>
            </p:cNvPr>
            <p:cNvSpPr txBox="1"/>
            <p:nvPr/>
          </p:nvSpPr>
          <p:spPr>
            <a:xfrm>
              <a:off x="3498490" y="437824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598" name="CasellaDiTesto 597">
              <a:extLst>
                <a:ext uri="{FF2B5EF4-FFF2-40B4-BE49-F238E27FC236}">
                  <a16:creationId xmlns:a16="http://schemas.microsoft.com/office/drawing/2014/main" id="{4C4D1C6B-A94A-4A52-85FF-11015B5ADC82}"/>
                </a:ext>
              </a:extLst>
            </p:cNvPr>
            <p:cNvSpPr txBox="1"/>
            <p:nvPr/>
          </p:nvSpPr>
          <p:spPr>
            <a:xfrm>
              <a:off x="3549307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8</a:t>
              </a:r>
            </a:p>
          </p:txBody>
        </p:sp>
        <p:sp>
          <p:nvSpPr>
            <p:cNvPr id="599" name="CasellaDiTesto 598">
              <a:extLst>
                <a:ext uri="{FF2B5EF4-FFF2-40B4-BE49-F238E27FC236}">
                  <a16:creationId xmlns:a16="http://schemas.microsoft.com/office/drawing/2014/main" id="{8E7CCD5B-DBC9-4B96-8E87-92F330914529}"/>
                </a:ext>
              </a:extLst>
            </p:cNvPr>
            <p:cNvSpPr txBox="1"/>
            <p:nvPr/>
          </p:nvSpPr>
          <p:spPr>
            <a:xfrm>
              <a:off x="3635998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7</a:t>
              </a:r>
            </a:p>
          </p:txBody>
        </p:sp>
        <p:sp>
          <p:nvSpPr>
            <p:cNvPr id="600" name="CasellaDiTesto 599">
              <a:extLst>
                <a:ext uri="{FF2B5EF4-FFF2-40B4-BE49-F238E27FC236}">
                  <a16:creationId xmlns:a16="http://schemas.microsoft.com/office/drawing/2014/main" id="{351AF5FE-6879-4511-962F-90CA7B47D51C}"/>
                </a:ext>
              </a:extLst>
            </p:cNvPr>
            <p:cNvSpPr txBox="1"/>
            <p:nvPr/>
          </p:nvSpPr>
          <p:spPr>
            <a:xfrm>
              <a:off x="3724197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6</a:t>
              </a:r>
            </a:p>
          </p:txBody>
        </p:sp>
        <p:sp>
          <p:nvSpPr>
            <p:cNvPr id="601" name="CasellaDiTesto 600">
              <a:extLst>
                <a:ext uri="{FF2B5EF4-FFF2-40B4-BE49-F238E27FC236}">
                  <a16:creationId xmlns:a16="http://schemas.microsoft.com/office/drawing/2014/main" id="{D4C191C0-CB2F-474D-BA81-9AFE6062EFDD}"/>
                </a:ext>
              </a:extLst>
            </p:cNvPr>
            <p:cNvSpPr txBox="1"/>
            <p:nvPr/>
          </p:nvSpPr>
          <p:spPr>
            <a:xfrm>
              <a:off x="3794064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5</a:t>
              </a:r>
            </a:p>
          </p:txBody>
        </p:sp>
        <p:sp>
          <p:nvSpPr>
            <p:cNvPr id="602" name="CasellaDiTesto 601">
              <a:extLst>
                <a:ext uri="{FF2B5EF4-FFF2-40B4-BE49-F238E27FC236}">
                  <a16:creationId xmlns:a16="http://schemas.microsoft.com/office/drawing/2014/main" id="{34B768BB-4B91-4E2F-97DB-2F2CAA6D60E0}"/>
                </a:ext>
              </a:extLst>
            </p:cNvPr>
            <p:cNvSpPr txBox="1"/>
            <p:nvPr/>
          </p:nvSpPr>
          <p:spPr>
            <a:xfrm>
              <a:off x="3883930" y="437824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</a:t>
              </a:r>
            </a:p>
          </p:txBody>
        </p:sp>
        <p:sp>
          <p:nvSpPr>
            <p:cNvPr id="603" name="CasellaDiTesto 602">
              <a:extLst>
                <a:ext uri="{FF2B5EF4-FFF2-40B4-BE49-F238E27FC236}">
                  <a16:creationId xmlns:a16="http://schemas.microsoft.com/office/drawing/2014/main" id="{D9F95FC4-C208-4117-A107-CD313D407C22}"/>
                </a:ext>
              </a:extLst>
            </p:cNvPr>
            <p:cNvSpPr txBox="1"/>
            <p:nvPr/>
          </p:nvSpPr>
          <p:spPr>
            <a:xfrm>
              <a:off x="3934747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8</a:t>
              </a:r>
            </a:p>
          </p:txBody>
        </p:sp>
        <p:sp>
          <p:nvSpPr>
            <p:cNvPr id="604" name="CasellaDiTesto 603">
              <a:extLst>
                <a:ext uri="{FF2B5EF4-FFF2-40B4-BE49-F238E27FC236}">
                  <a16:creationId xmlns:a16="http://schemas.microsoft.com/office/drawing/2014/main" id="{A3814CB8-A397-4F54-B422-36A68439C1F3}"/>
                </a:ext>
              </a:extLst>
            </p:cNvPr>
            <p:cNvSpPr txBox="1"/>
            <p:nvPr/>
          </p:nvSpPr>
          <p:spPr>
            <a:xfrm>
              <a:off x="4021438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7</a:t>
              </a:r>
            </a:p>
          </p:txBody>
        </p:sp>
        <p:sp>
          <p:nvSpPr>
            <p:cNvPr id="605" name="CasellaDiTesto 604">
              <a:extLst>
                <a:ext uri="{FF2B5EF4-FFF2-40B4-BE49-F238E27FC236}">
                  <a16:creationId xmlns:a16="http://schemas.microsoft.com/office/drawing/2014/main" id="{EDB3E428-5D82-4F8F-98A6-92F76DEE51AF}"/>
                </a:ext>
              </a:extLst>
            </p:cNvPr>
            <p:cNvSpPr txBox="1"/>
            <p:nvPr/>
          </p:nvSpPr>
          <p:spPr>
            <a:xfrm>
              <a:off x="4109637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6</a:t>
              </a:r>
            </a:p>
          </p:txBody>
        </p:sp>
        <p:sp>
          <p:nvSpPr>
            <p:cNvPr id="606" name="CasellaDiTesto 605">
              <a:extLst>
                <a:ext uri="{FF2B5EF4-FFF2-40B4-BE49-F238E27FC236}">
                  <a16:creationId xmlns:a16="http://schemas.microsoft.com/office/drawing/2014/main" id="{AA8FA861-A8D2-4BBC-99A7-08B18FED17AB}"/>
                </a:ext>
              </a:extLst>
            </p:cNvPr>
            <p:cNvSpPr txBox="1"/>
            <p:nvPr/>
          </p:nvSpPr>
          <p:spPr>
            <a:xfrm>
              <a:off x="4179504" y="4378240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-5</a:t>
              </a:r>
            </a:p>
          </p:txBody>
        </p:sp>
        <p:sp>
          <p:nvSpPr>
            <p:cNvPr id="607" name="CasellaDiTesto 606">
              <a:extLst>
                <a:ext uri="{FF2B5EF4-FFF2-40B4-BE49-F238E27FC236}">
                  <a16:creationId xmlns:a16="http://schemas.microsoft.com/office/drawing/2014/main" id="{5F1BF572-3CE9-421C-9737-9D505F038F20}"/>
                </a:ext>
              </a:extLst>
            </p:cNvPr>
            <p:cNvSpPr txBox="1"/>
            <p:nvPr/>
          </p:nvSpPr>
          <p:spPr>
            <a:xfrm>
              <a:off x="3083322" y="4505984"/>
              <a:ext cx="6671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Log [AZD] (M)</a:t>
              </a:r>
            </a:p>
          </p:txBody>
        </p:sp>
        <p:cxnSp>
          <p:nvCxnSpPr>
            <p:cNvPr id="608" name="Connettore diritto 607">
              <a:extLst>
                <a:ext uri="{FF2B5EF4-FFF2-40B4-BE49-F238E27FC236}">
                  <a16:creationId xmlns:a16="http://schemas.microsoft.com/office/drawing/2014/main" id="{A7D0EA16-28A7-4592-90C8-DAA7DEE3F3BD}"/>
                </a:ext>
              </a:extLst>
            </p:cNvPr>
            <p:cNvCxnSpPr>
              <a:cxnSpLocks/>
            </p:cNvCxnSpPr>
            <p:nvPr/>
          </p:nvCxnSpPr>
          <p:spPr>
            <a:xfrm>
              <a:off x="2372426" y="4541306"/>
              <a:ext cx="19527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9" name="Connettore diritto 608">
              <a:extLst>
                <a:ext uri="{FF2B5EF4-FFF2-40B4-BE49-F238E27FC236}">
                  <a16:creationId xmlns:a16="http://schemas.microsoft.com/office/drawing/2014/main" id="{450C561C-7B1F-4A18-B82E-07437B9C9BE1}"/>
                </a:ext>
              </a:extLst>
            </p:cNvPr>
            <p:cNvCxnSpPr/>
            <p:nvPr/>
          </p:nvCxnSpPr>
          <p:spPr>
            <a:xfrm>
              <a:off x="2788172" y="322611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0" name="Connettore diritto 609">
              <a:extLst>
                <a:ext uri="{FF2B5EF4-FFF2-40B4-BE49-F238E27FC236}">
                  <a16:creationId xmlns:a16="http://schemas.microsoft.com/office/drawing/2014/main" id="{575637B9-05A3-4950-A3A7-56C07760582E}"/>
                </a:ext>
              </a:extLst>
            </p:cNvPr>
            <p:cNvCxnSpPr/>
            <p:nvPr/>
          </p:nvCxnSpPr>
          <p:spPr>
            <a:xfrm>
              <a:off x="3185942" y="322611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1" name="Connettore diritto 610">
              <a:extLst>
                <a:ext uri="{FF2B5EF4-FFF2-40B4-BE49-F238E27FC236}">
                  <a16:creationId xmlns:a16="http://schemas.microsoft.com/office/drawing/2014/main" id="{221DB1F5-4C86-47EA-87C0-57EF41B40492}"/>
                </a:ext>
              </a:extLst>
            </p:cNvPr>
            <p:cNvCxnSpPr/>
            <p:nvPr/>
          </p:nvCxnSpPr>
          <p:spPr>
            <a:xfrm>
              <a:off x="3597579" y="322611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2" name="Connettore diritto 611">
              <a:extLst>
                <a:ext uri="{FF2B5EF4-FFF2-40B4-BE49-F238E27FC236}">
                  <a16:creationId xmlns:a16="http://schemas.microsoft.com/office/drawing/2014/main" id="{B8DAF2B6-9DB8-47C7-BFD9-86B0B0E591EB}"/>
                </a:ext>
              </a:extLst>
            </p:cNvPr>
            <p:cNvCxnSpPr/>
            <p:nvPr/>
          </p:nvCxnSpPr>
          <p:spPr>
            <a:xfrm>
              <a:off x="3993905" y="322611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3" name="CasellaDiTesto 612">
              <a:extLst>
                <a:ext uri="{FF2B5EF4-FFF2-40B4-BE49-F238E27FC236}">
                  <a16:creationId xmlns:a16="http://schemas.microsoft.com/office/drawing/2014/main" id="{E1A41F39-704C-4742-8759-44B183672EA6}"/>
                </a:ext>
              </a:extLst>
            </p:cNvPr>
            <p:cNvSpPr txBox="1"/>
            <p:nvPr/>
          </p:nvSpPr>
          <p:spPr>
            <a:xfrm>
              <a:off x="2827377" y="3061457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.5</a:t>
              </a:r>
            </a:p>
          </p:txBody>
        </p:sp>
        <p:sp>
          <p:nvSpPr>
            <p:cNvPr id="614" name="CasellaDiTesto 613">
              <a:extLst>
                <a:ext uri="{FF2B5EF4-FFF2-40B4-BE49-F238E27FC236}">
                  <a16:creationId xmlns:a16="http://schemas.microsoft.com/office/drawing/2014/main" id="{D8AA8F34-8DF6-415C-9D85-A1DA5482B827}"/>
                </a:ext>
              </a:extLst>
            </p:cNvPr>
            <p:cNvSpPr txBox="1"/>
            <p:nvPr/>
          </p:nvSpPr>
          <p:spPr>
            <a:xfrm>
              <a:off x="3246255" y="306145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</a:t>
              </a:r>
            </a:p>
          </p:txBody>
        </p:sp>
        <p:sp>
          <p:nvSpPr>
            <p:cNvPr id="615" name="CasellaDiTesto 614">
              <a:extLst>
                <a:ext uri="{FF2B5EF4-FFF2-40B4-BE49-F238E27FC236}">
                  <a16:creationId xmlns:a16="http://schemas.microsoft.com/office/drawing/2014/main" id="{4E15D0D9-4E66-4C7B-81CD-0ACF1779207E}"/>
                </a:ext>
              </a:extLst>
            </p:cNvPr>
            <p:cNvSpPr txBox="1"/>
            <p:nvPr/>
          </p:nvSpPr>
          <p:spPr>
            <a:xfrm>
              <a:off x="3623331" y="3061457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.5</a:t>
              </a:r>
            </a:p>
          </p:txBody>
        </p:sp>
        <p:sp>
          <p:nvSpPr>
            <p:cNvPr id="616" name="CasellaDiTesto 615">
              <a:extLst>
                <a:ext uri="{FF2B5EF4-FFF2-40B4-BE49-F238E27FC236}">
                  <a16:creationId xmlns:a16="http://schemas.microsoft.com/office/drawing/2014/main" id="{2D3EF69D-C198-4DDF-9F27-2C8052396B3B}"/>
                </a:ext>
              </a:extLst>
            </p:cNvPr>
            <p:cNvSpPr txBox="1"/>
            <p:nvPr/>
          </p:nvSpPr>
          <p:spPr>
            <a:xfrm>
              <a:off x="4033528" y="306145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5</a:t>
              </a:r>
            </a:p>
          </p:txBody>
        </p:sp>
        <p:cxnSp>
          <p:nvCxnSpPr>
            <p:cNvPr id="617" name="Connettore diritto 616">
              <a:extLst>
                <a:ext uri="{FF2B5EF4-FFF2-40B4-BE49-F238E27FC236}">
                  <a16:creationId xmlns:a16="http://schemas.microsoft.com/office/drawing/2014/main" id="{FD133923-3095-4010-9F54-412015A01B2D}"/>
                </a:ext>
              </a:extLst>
            </p:cNvPr>
            <p:cNvCxnSpPr>
              <a:cxnSpLocks/>
            </p:cNvCxnSpPr>
            <p:nvPr/>
          </p:nvCxnSpPr>
          <p:spPr>
            <a:xfrm>
              <a:off x="2965166" y="3061457"/>
              <a:ext cx="120915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8" name="CasellaDiTesto 617">
              <a:extLst>
                <a:ext uri="{FF2B5EF4-FFF2-40B4-BE49-F238E27FC236}">
                  <a16:creationId xmlns:a16="http://schemas.microsoft.com/office/drawing/2014/main" id="{227AD1C1-D34A-4E19-A4F7-F8873161CCD0}"/>
                </a:ext>
              </a:extLst>
            </p:cNvPr>
            <p:cNvSpPr txBox="1"/>
            <p:nvPr/>
          </p:nvSpPr>
          <p:spPr>
            <a:xfrm>
              <a:off x="3277346" y="2872507"/>
              <a:ext cx="60465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[</a:t>
              </a:r>
              <a:r>
                <a:rPr lang="it-IT" sz="600" dirty="0" err="1"/>
                <a:t>Palbo</a:t>
              </a:r>
              <a:r>
                <a:rPr lang="it-IT" sz="600" dirty="0"/>
                <a:t>] (µM)</a:t>
              </a:r>
            </a:p>
          </p:txBody>
        </p:sp>
        <p:sp>
          <p:nvSpPr>
            <p:cNvPr id="619" name="CasellaDiTesto 618">
              <a:extLst>
                <a:ext uri="{FF2B5EF4-FFF2-40B4-BE49-F238E27FC236}">
                  <a16:creationId xmlns:a16="http://schemas.microsoft.com/office/drawing/2014/main" id="{55CD3976-C9A9-40FD-A612-441A43C9C693}"/>
                </a:ext>
              </a:extLst>
            </p:cNvPr>
            <p:cNvSpPr txBox="1"/>
            <p:nvPr/>
          </p:nvSpPr>
          <p:spPr>
            <a:xfrm>
              <a:off x="2323327" y="4209800"/>
              <a:ext cx="4171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 dirty="0"/>
                <a:t>Y537S</a:t>
              </a:r>
            </a:p>
          </p:txBody>
        </p:sp>
      </p:grpSp>
      <p:grpSp>
        <p:nvGrpSpPr>
          <p:cNvPr id="622" name="Gruppo 621">
            <a:extLst>
              <a:ext uri="{FF2B5EF4-FFF2-40B4-BE49-F238E27FC236}">
                <a16:creationId xmlns:a16="http://schemas.microsoft.com/office/drawing/2014/main" id="{CA0465DF-B29F-4C03-A883-FA4D37170FFB}"/>
              </a:ext>
            </a:extLst>
          </p:cNvPr>
          <p:cNvGrpSpPr/>
          <p:nvPr/>
        </p:nvGrpSpPr>
        <p:grpSpPr>
          <a:xfrm>
            <a:off x="2022991" y="6138233"/>
            <a:ext cx="2517169" cy="1818143"/>
            <a:chOff x="1952190" y="2872507"/>
            <a:chExt cx="2517169" cy="1818143"/>
          </a:xfrm>
        </p:grpSpPr>
        <p:pic>
          <p:nvPicPr>
            <p:cNvPr id="623" name="Immagine 622">
              <a:extLst>
                <a:ext uri="{FF2B5EF4-FFF2-40B4-BE49-F238E27FC236}">
                  <a16:creationId xmlns:a16="http://schemas.microsoft.com/office/drawing/2014/main" id="{67937900-2629-40DE-8C1E-C0E6132B049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309894" y="3010088"/>
              <a:ext cx="2093333" cy="1440000"/>
            </a:xfrm>
            <a:prstGeom prst="rect">
              <a:avLst/>
            </a:prstGeom>
          </p:spPr>
        </p:pic>
        <p:sp>
          <p:nvSpPr>
            <p:cNvPr id="624" name="CasellaDiTesto 623">
              <a:extLst>
                <a:ext uri="{FF2B5EF4-FFF2-40B4-BE49-F238E27FC236}">
                  <a16:creationId xmlns:a16="http://schemas.microsoft.com/office/drawing/2014/main" id="{ED82B03B-E458-40A6-9E66-7A18DEC3FEB9}"/>
                </a:ext>
              </a:extLst>
            </p:cNvPr>
            <p:cNvSpPr txBox="1"/>
            <p:nvPr/>
          </p:nvSpPr>
          <p:spPr>
            <a:xfrm rot="16200000">
              <a:off x="1387472" y="3582019"/>
              <a:ext cx="1406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600" dirty="0" err="1"/>
                <a:t>Number</a:t>
              </a:r>
              <a:r>
                <a:rPr lang="it-IT" sz="600" dirty="0"/>
                <a:t> of </a:t>
              </a:r>
              <a:r>
                <a:rPr lang="it-IT" sz="600" dirty="0" err="1"/>
                <a:t>cells</a:t>
              </a:r>
              <a:endParaRPr lang="it-IT" sz="600" dirty="0"/>
            </a:p>
            <a:p>
              <a:pPr algn="ctr"/>
              <a:r>
                <a:rPr lang="it-IT" sz="600" dirty="0"/>
                <a:t>(% on -)</a:t>
              </a:r>
              <a:endParaRPr lang="it-IT" sz="6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625" name="CasellaDiTesto 624">
              <a:extLst>
                <a:ext uri="{FF2B5EF4-FFF2-40B4-BE49-F238E27FC236}">
                  <a16:creationId xmlns:a16="http://schemas.microsoft.com/office/drawing/2014/main" id="{8FFC123A-F9CB-439D-B7FF-DA091F856D4F}"/>
                </a:ext>
              </a:extLst>
            </p:cNvPr>
            <p:cNvSpPr txBox="1"/>
            <p:nvPr/>
          </p:nvSpPr>
          <p:spPr>
            <a:xfrm>
              <a:off x="2092749" y="3614436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00</a:t>
              </a:r>
            </a:p>
          </p:txBody>
        </p:sp>
        <p:sp>
          <p:nvSpPr>
            <p:cNvPr id="626" name="CasellaDiTesto 625">
              <a:extLst>
                <a:ext uri="{FF2B5EF4-FFF2-40B4-BE49-F238E27FC236}">
                  <a16:creationId xmlns:a16="http://schemas.microsoft.com/office/drawing/2014/main" id="{93069D97-8F74-48FB-80B5-642302242216}"/>
                </a:ext>
              </a:extLst>
            </p:cNvPr>
            <p:cNvSpPr txBox="1"/>
            <p:nvPr/>
          </p:nvSpPr>
          <p:spPr>
            <a:xfrm>
              <a:off x="2179311" y="427875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</a:t>
              </a:r>
            </a:p>
          </p:txBody>
        </p:sp>
        <p:sp>
          <p:nvSpPr>
            <p:cNvPr id="627" name="CasellaDiTesto 626">
              <a:extLst>
                <a:ext uri="{FF2B5EF4-FFF2-40B4-BE49-F238E27FC236}">
                  <a16:creationId xmlns:a16="http://schemas.microsoft.com/office/drawing/2014/main" id="{BF5E7729-96B6-4167-849A-703ADE566A92}"/>
                </a:ext>
              </a:extLst>
            </p:cNvPr>
            <p:cNvSpPr txBox="1"/>
            <p:nvPr/>
          </p:nvSpPr>
          <p:spPr>
            <a:xfrm>
              <a:off x="2092749" y="2948806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00</a:t>
              </a:r>
            </a:p>
          </p:txBody>
        </p:sp>
        <p:grpSp>
          <p:nvGrpSpPr>
            <p:cNvPr id="628" name="Gruppo 627">
              <a:extLst>
                <a:ext uri="{FF2B5EF4-FFF2-40B4-BE49-F238E27FC236}">
                  <a16:creationId xmlns:a16="http://schemas.microsoft.com/office/drawing/2014/main" id="{F1106617-CE4F-48F6-9F40-154362B1A39A}"/>
                </a:ext>
              </a:extLst>
            </p:cNvPr>
            <p:cNvGrpSpPr/>
            <p:nvPr/>
          </p:nvGrpSpPr>
          <p:grpSpPr>
            <a:xfrm>
              <a:off x="2315219" y="4375851"/>
              <a:ext cx="570599" cy="184666"/>
              <a:chOff x="2315219" y="4378240"/>
              <a:chExt cx="570599" cy="184666"/>
            </a:xfrm>
          </p:grpSpPr>
          <p:sp>
            <p:nvSpPr>
              <p:cNvPr id="670" name="CasellaDiTesto 669">
                <a:extLst>
                  <a:ext uri="{FF2B5EF4-FFF2-40B4-BE49-F238E27FC236}">
                    <a16:creationId xmlns:a16="http://schemas.microsoft.com/office/drawing/2014/main" id="{D552CA6B-EEE8-40B1-AA39-AC1E085E8874}"/>
                  </a:ext>
                </a:extLst>
              </p:cNvPr>
              <p:cNvSpPr txBox="1"/>
              <p:nvPr/>
            </p:nvSpPr>
            <p:spPr>
              <a:xfrm>
                <a:off x="2315219" y="4378240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-</a:t>
                </a:r>
              </a:p>
            </p:txBody>
          </p:sp>
          <p:grpSp>
            <p:nvGrpSpPr>
              <p:cNvPr id="671" name="Gruppo 670">
                <a:extLst>
                  <a:ext uri="{FF2B5EF4-FFF2-40B4-BE49-F238E27FC236}">
                    <a16:creationId xmlns:a16="http://schemas.microsoft.com/office/drawing/2014/main" id="{BE34F4D1-8B6E-44E1-A6EF-462284D62099}"/>
                  </a:ext>
                </a:extLst>
              </p:cNvPr>
              <p:cNvGrpSpPr/>
              <p:nvPr/>
            </p:nvGrpSpPr>
            <p:grpSpPr>
              <a:xfrm>
                <a:off x="2366036" y="4378240"/>
                <a:ext cx="519782" cy="184666"/>
                <a:chOff x="2366036" y="4378240"/>
                <a:chExt cx="519782" cy="184666"/>
              </a:xfrm>
            </p:grpSpPr>
            <p:sp>
              <p:nvSpPr>
                <p:cNvPr id="672" name="CasellaDiTesto 671">
                  <a:extLst>
                    <a:ext uri="{FF2B5EF4-FFF2-40B4-BE49-F238E27FC236}">
                      <a16:creationId xmlns:a16="http://schemas.microsoft.com/office/drawing/2014/main" id="{6FB314D6-F4B0-4D4D-9137-39938B94CF25}"/>
                    </a:ext>
                  </a:extLst>
                </p:cNvPr>
                <p:cNvSpPr txBox="1"/>
                <p:nvPr/>
              </p:nvSpPr>
              <p:spPr>
                <a:xfrm>
                  <a:off x="2366036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9</a:t>
                  </a:r>
                </a:p>
              </p:txBody>
            </p:sp>
            <p:sp>
              <p:nvSpPr>
                <p:cNvPr id="673" name="CasellaDiTesto 672">
                  <a:extLst>
                    <a:ext uri="{FF2B5EF4-FFF2-40B4-BE49-F238E27FC236}">
                      <a16:creationId xmlns:a16="http://schemas.microsoft.com/office/drawing/2014/main" id="{049F8967-8B1E-4522-837F-B03A3808771A}"/>
                    </a:ext>
                  </a:extLst>
                </p:cNvPr>
                <p:cNvSpPr txBox="1"/>
                <p:nvPr/>
              </p:nvSpPr>
              <p:spPr>
                <a:xfrm>
                  <a:off x="2452727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8</a:t>
                  </a:r>
                </a:p>
              </p:txBody>
            </p:sp>
            <p:sp>
              <p:nvSpPr>
                <p:cNvPr id="674" name="CasellaDiTesto 673">
                  <a:extLst>
                    <a:ext uri="{FF2B5EF4-FFF2-40B4-BE49-F238E27FC236}">
                      <a16:creationId xmlns:a16="http://schemas.microsoft.com/office/drawing/2014/main" id="{0D2A5F1D-B1BE-4EBC-BFD7-EE36E69E387D}"/>
                    </a:ext>
                  </a:extLst>
                </p:cNvPr>
                <p:cNvSpPr txBox="1"/>
                <p:nvPr/>
              </p:nvSpPr>
              <p:spPr>
                <a:xfrm>
                  <a:off x="2514735" y="4378240"/>
                  <a:ext cx="30489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7.3</a:t>
                  </a:r>
                </a:p>
              </p:txBody>
            </p:sp>
            <p:sp>
              <p:nvSpPr>
                <p:cNvPr id="675" name="CasellaDiTesto 674">
                  <a:extLst>
                    <a:ext uri="{FF2B5EF4-FFF2-40B4-BE49-F238E27FC236}">
                      <a16:creationId xmlns:a16="http://schemas.microsoft.com/office/drawing/2014/main" id="{3EDE07E5-92F8-4F3D-A3C3-65769DC37F63}"/>
                    </a:ext>
                  </a:extLst>
                </p:cNvPr>
                <p:cNvSpPr txBox="1"/>
                <p:nvPr/>
              </p:nvSpPr>
              <p:spPr>
                <a:xfrm>
                  <a:off x="2632222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7</a:t>
                  </a:r>
                </a:p>
              </p:txBody>
            </p:sp>
          </p:grpSp>
        </p:grpSp>
        <p:sp>
          <p:nvSpPr>
            <p:cNvPr id="629" name="CasellaDiTesto 628">
              <a:extLst>
                <a:ext uri="{FF2B5EF4-FFF2-40B4-BE49-F238E27FC236}">
                  <a16:creationId xmlns:a16="http://schemas.microsoft.com/office/drawing/2014/main" id="{DCD45FD2-F210-4679-9CFC-7944FF3809D1}"/>
                </a:ext>
              </a:extLst>
            </p:cNvPr>
            <p:cNvSpPr txBox="1"/>
            <p:nvPr/>
          </p:nvSpPr>
          <p:spPr>
            <a:xfrm>
              <a:off x="3083322" y="4505984"/>
              <a:ext cx="6286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Log [GDC] (M)</a:t>
              </a:r>
            </a:p>
          </p:txBody>
        </p:sp>
        <p:cxnSp>
          <p:nvCxnSpPr>
            <p:cNvPr id="630" name="Connettore diritto 629">
              <a:extLst>
                <a:ext uri="{FF2B5EF4-FFF2-40B4-BE49-F238E27FC236}">
                  <a16:creationId xmlns:a16="http://schemas.microsoft.com/office/drawing/2014/main" id="{FF1B9C34-FE62-4181-9956-90C7958BF730}"/>
                </a:ext>
              </a:extLst>
            </p:cNvPr>
            <p:cNvCxnSpPr>
              <a:cxnSpLocks/>
            </p:cNvCxnSpPr>
            <p:nvPr/>
          </p:nvCxnSpPr>
          <p:spPr>
            <a:xfrm>
              <a:off x="2372426" y="4541306"/>
              <a:ext cx="19527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1" name="Connettore diritto 630">
              <a:extLst>
                <a:ext uri="{FF2B5EF4-FFF2-40B4-BE49-F238E27FC236}">
                  <a16:creationId xmlns:a16="http://schemas.microsoft.com/office/drawing/2014/main" id="{52A8BC37-2FF7-4E87-9905-56883B6C75B7}"/>
                </a:ext>
              </a:extLst>
            </p:cNvPr>
            <p:cNvCxnSpPr/>
            <p:nvPr/>
          </p:nvCxnSpPr>
          <p:spPr>
            <a:xfrm>
              <a:off x="2788172" y="322611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2" name="Connettore diritto 631">
              <a:extLst>
                <a:ext uri="{FF2B5EF4-FFF2-40B4-BE49-F238E27FC236}">
                  <a16:creationId xmlns:a16="http://schemas.microsoft.com/office/drawing/2014/main" id="{00CF9B13-34A0-452D-BCAE-A2ABAA87A04B}"/>
                </a:ext>
              </a:extLst>
            </p:cNvPr>
            <p:cNvCxnSpPr/>
            <p:nvPr/>
          </p:nvCxnSpPr>
          <p:spPr>
            <a:xfrm>
              <a:off x="3185942" y="322611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3" name="Connettore diritto 632">
              <a:extLst>
                <a:ext uri="{FF2B5EF4-FFF2-40B4-BE49-F238E27FC236}">
                  <a16:creationId xmlns:a16="http://schemas.microsoft.com/office/drawing/2014/main" id="{492EBEB2-4462-45F6-BC73-1D87BB899024}"/>
                </a:ext>
              </a:extLst>
            </p:cNvPr>
            <p:cNvCxnSpPr/>
            <p:nvPr/>
          </p:nvCxnSpPr>
          <p:spPr>
            <a:xfrm>
              <a:off x="3597579" y="322611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4" name="Connettore diritto 633">
              <a:extLst>
                <a:ext uri="{FF2B5EF4-FFF2-40B4-BE49-F238E27FC236}">
                  <a16:creationId xmlns:a16="http://schemas.microsoft.com/office/drawing/2014/main" id="{3673D0D4-9287-4B69-A2AF-4857FAE132F8}"/>
                </a:ext>
              </a:extLst>
            </p:cNvPr>
            <p:cNvCxnSpPr/>
            <p:nvPr/>
          </p:nvCxnSpPr>
          <p:spPr>
            <a:xfrm>
              <a:off x="3993905" y="3226112"/>
              <a:ext cx="3608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35" name="CasellaDiTesto 634">
              <a:extLst>
                <a:ext uri="{FF2B5EF4-FFF2-40B4-BE49-F238E27FC236}">
                  <a16:creationId xmlns:a16="http://schemas.microsoft.com/office/drawing/2014/main" id="{0E8C5F0C-7D98-4B36-A492-E800C7FB3DA3}"/>
                </a:ext>
              </a:extLst>
            </p:cNvPr>
            <p:cNvSpPr txBox="1"/>
            <p:nvPr/>
          </p:nvSpPr>
          <p:spPr>
            <a:xfrm>
              <a:off x="2827377" y="3061457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.5</a:t>
              </a:r>
            </a:p>
          </p:txBody>
        </p:sp>
        <p:sp>
          <p:nvSpPr>
            <p:cNvPr id="636" name="CasellaDiTesto 635">
              <a:extLst>
                <a:ext uri="{FF2B5EF4-FFF2-40B4-BE49-F238E27FC236}">
                  <a16:creationId xmlns:a16="http://schemas.microsoft.com/office/drawing/2014/main" id="{D890609C-510C-454E-8D09-CDC9B3529082}"/>
                </a:ext>
              </a:extLst>
            </p:cNvPr>
            <p:cNvSpPr txBox="1"/>
            <p:nvPr/>
          </p:nvSpPr>
          <p:spPr>
            <a:xfrm>
              <a:off x="3246255" y="306145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</a:t>
              </a:r>
            </a:p>
          </p:txBody>
        </p:sp>
        <p:sp>
          <p:nvSpPr>
            <p:cNvPr id="637" name="CasellaDiTesto 636">
              <a:extLst>
                <a:ext uri="{FF2B5EF4-FFF2-40B4-BE49-F238E27FC236}">
                  <a16:creationId xmlns:a16="http://schemas.microsoft.com/office/drawing/2014/main" id="{D8948756-9BBD-4CA2-9FA5-8F87083CFAB6}"/>
                </a:ext>
              </a:extLst>
            </p:cNvPr>
            <p:cNvSpPr txBox="1"/>
            <p:nvPr/>
          </p:nvSpPr>
          <p:spPr>
            <a:xfrm>
              <a:off x="3623331" y="3061457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.5</a:t>
              </a:r>
            </a:p>
          </p:txBody>
        </p:sp>
        <p:sp>
          <p:nvSpPr>
            <p:cNvPr id="638" name="CasellaDiTesto 637">
              <a:extLst>
                <a:ext uri="{FF2B5EF4-FFF2-40B4-BE49-F238E27FC236}">
                  <a16:creationId xmlns:a16="http://schemas.microsoft.com/office/drawing/2014/main" id="{11B75646-8B92-44A5-AD1E-B158FD098C30}"/>
                </a:ext>
              </a:extLst>
            </p:cNvPr>
            <p:cNvSpPr txBox="1"/>
            <p:nvPr/>
          </p:nvSpPr>
          <p:spPr>
            <a:xfrm>
              <a:off x="4033528" y="306145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5</a:t>
              </a:r>
            </a:p>
          </p:txBody>
        </p:sp>
        <p:cxnSp>
          <p:nvCxnSpPr>
            <p:cNvPr id="639" name="Connettore diritto 638">
              <a:extLst>
                <a:ext uri="{FF2B5EF4-FFF2-40B4-BE49-F238E27FC236}">
                  <a16:creationId xmlns:a16="http://schemas.microsoft.com/office/drawing/2014/main" id="{A15BE080-6580-42D1-A5C2-7FF16D8F7F24}"/>
                </a:ext>
              </a:extLst>
            </p:cNvPr>
            <p:cNvCxnSpPr>
              <a:cxnSpLocks/>
            </p:cNvCxnSpPr>
            <p:nvPr/>
          </p:nvCxnSpPr>
          <p:spPr>
            <a:xfrm>
              <a:off x="2965166" y="3061457"/>
              <a:ext cx="120915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0" name="CasellaDiTesto 639">
              <a:extLst>
                <a:ext uri="{FF2B5EF4-FFF2-40B4-BE49-F238E27FC236}">
                  <a16:creationId xmlns:a16="http://schemas.microsoft.com/office/drawing/2014/main" id="{82F1F096-BC8F-4D59-AD41-1B39D2117F9F}"/>
                </a:ext>
              </a:extLst>
            </p:cNvPr>
            <p:cNvSpPr txBox="1"/>
            <p:nvPr/>
          </p:nvSpPr>
          <p:spPr>
            <a:xfrm>
              <a:off x="3277346" y="2872507"/>
              <a:ext cx="60465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[</a:t>
              </a:r>
              <a:r>
                <a:rPr lang="it-IT" sz="600" dirty="0" err="1"/>
                <a:t>Palbo</a:t>
              </a:r>
              <a:r>
                <a:rPr lang="it-IT" sz="600" dirty="0"/>
                <a:t>] (µM)</a:t>
              </a:r>
            </a:p>
          </p:txBody>
        </p:sp>
        <p:sp>
          <p:nvSpPr>
            <p:cNvPr id="641" name="CasellaDiTesto 640">
              <a:extLst>
                <a:ext uri="{FF2B5EF4-FFF2-40B4-BE49-F238E27FC236}">
                  <a16:creationId xmlns:a16="http://schemas.microsoft.com/office/drawing/2014/main" id="{04D391D7-13E3-44B9-B2C1-C1A60B30BA6D}"/>
                </a:ext>
              </a:extLst>
            </p:cNvPr>
            <p:cNvSpPr txBox="1"/>
            <p:nvPr/>
          </p:nvSpPr>
          <p:spPr>
            <a:xfrm>
              <a:off x="2323327" y="4209800"/>
              <a:ext cx="4171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 dirty="0"/>
                <a:t>Y537S</a:t>
              </a:r>
            </a:p>
          </p:txBody>
        </p:sp>
        <p:grpSp>
          <p:nvGrpSpPr>
            <p:cNvPr id="642" name="Gruppo 641">
              <a:extLst>
                <a:ext uri="{FF2B5EF4-FFF2-40B4-BE49-F238E27FC236}">
                  <a16:creationId xmlns:a16="http://schemas.microsoft.com/office/drawing/2014/main" id="{09D16CA6-2DD6-4B82-95D7-CA21D17804C5}"/>
                </a:ext>
              </a:extLst>
            </p:cNvPr>
            <p:cNvGrpSpPr/>
            <p:nvPr/>
          </p:nvGrpSpPr>
          <p:grpSpPr>
            <a:xfrm>
              <a:off x="2712890" y="4375851"/>
              <a:ext cx="570599" cy="184666"/>
              <a:chOff x="2315219" y="4378240"/>
              <a:chExt cx="570599" cy="184666"/>
            </a:xfrm>
          </p:grpSpPr>
          <p:sp>
            <p:nvSpPr>
              <p:cNvPr id="664" name="CasellaDiTesto 663">
                <a:extLst>
                  <a:ext uri="{FF2B5EF4-FFF2-40B4-BE49-F238E27FC236}">
                    <a16:creationId xmlns:a16="http://schemas.microsoft.com/office/drawing/2014/main" id="{567D9D6D-64EA-445E-AF7D-F275453B7319}"/>
                  </a:ext>
                </a:extLst>
              </p:cNvPr>
              <p:cNvSpPr txBox="1"/>
              <p:nvPr/>
            </p:nvSpPr>
            <p:spPr>
              <a:xfrm>
                <a:off x="2315219" y="4378240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-</a:t>
                </a:r>
              </a:p>
            </p:txBody>
          </p:sp>
          <p:grpSp>
            <p:nvGrpSpPr>
              <p:cNvPr id="665" name="Gruppo 664">
                <a:extLst>
                  <a:ext uri="{FF2B5EF4-FFF2-40B4-BE49-F238E27FC236}">
                    <a16:creationId xmlns:a16="http://schemas.microsoft.com/office/drawing/2014/main" id="{25654170-BDFD-4BE5-A125-037BD2C784B0}"/>
                  </a:ext>
                </a:extLst>
              </p:cNvPr>
              <p:cNvGrpSpPr/>
              <p:nvPr/>
            </p:nvGrpSpPr>
            <p:grpSpPr>
              <a:xfrm>
                <a:off x="2366036" y="4378240"/>
                <a:ext cx="519782" cy="184666"/>
                <a:chOff x="2366036" y="4378240"/>
                <a:chExt cx="519782" cy="184666"/>
              </a:xfrm>
            </p:grpSpPr>
            <p:sp>
              <p:nvSpPr>
                <p:cNvPr id="666" name="CasellaDiTesto 665">
                  <a:extLst>
                    <a:ext uri="{FF2B5EF4-FFF2-40B4-BE49-F238E27FC236}">
                      <a16:creationId xmlns:a16="http://schemas.microsoft.com/office/drawing/2014/main" id="{1FD5DA5D-BD04-4554-88A6-9883CBD107CD}"/>
                    </a:ext>
                  </a:extLst>
                </p:cNvPr>
                <p:cNvSpPr txBox="1"/>
                <p:nvPr/>
              </p:nvSpPr>
              <p:spPr>
                <a:xfrm>
                  <a:off x="2366036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9</a:t>
                  </a:r>
                </a:p>
              </p:txBody>
            </p:sp>
            <p:sp>
              <p:nvSpPr>
                <p:cNvPr id="667" name="CasellaDiTesto 666">
                  <a:extLst>
                    <a:ext uri="{FF2B5EF4-FFF2-40B4-BE49-F238E27FC236}">
                      <a16:creationId xmlns:a16="http://schemas.microsoft.com/office/drawing/2014/main" id="{DEB16ECB-B6F5-4FD7-8471-FC33CFFC240D}"/>
                    </a:ext>
                  </a:extLst>
                </p:cNvPr>
                <p:cNvSpPr txBox="1"/>
                <p:nvPr/>
              </p:nvSpPr>
              <p:spPr>
                <a:xfrm>
                  <a:off x="2452727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8</a:t>
                  </a:r>
                </a:p>
              </p:txBody>
            </p:sp>
            <p:sp>
              <p:nvSpPr>
                <p:cNvPr id="668" name="CasellaDiTesto 667">
                  <a:extLst>
                    <a:ext uri="{FF2B5EF4-FFF2-40B4-BE49-F238E27FC236}">
                      <a16:creationId xmlns:a16="http://schemas.microsoft.com/office/drawing/2014/main" id="{7718D6FA-7CCF-4C48-B6DC-D91ECA1F05C8}"/>
                    </a:ext>
                  </a:extLst>
                </p:cNvPr>
                <p:cNvSpPr txBox="1"/>
                <p:nvPr/>
              </p:nvSpPr>
              <p:spPr>
                <a:xfrm>
                  <a:off x="2514735" y="4378240"/>
                  <a:ext cx="30489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7.3</a:t>
                  </a:r>
                </a:p>
              </p:txBody>
            </p:sp>
            <p:sp>
              <p:nvSpPr>
                <p:cNvPr id="669" name="CasellaDiTesto 668">
                  <a:extLst>
                    <a:ext uri="{FF2B5EF4-FFF2-40B4-BE49-F238E27FC236}">
                      <a16:creationId xmlns:a16="http://schemas.microsoft.com/office/drawing/2014/main" id="{44010134-A4A6-4EF1-87EF-F1D692E0CB16}"/>
                    </a:ext>
                  </a:extLst>
                </p:cNvPr>
                <p:cNvSpPr txBox="1"/>
                <p:nvPr/>
              </p:nvSpPr>
              <p:spPr>
                <a:xfrm>
                  <a:off x="2632222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7</a:t>
                  </a:r>
                </a:p>
              </p:txBody>
            </p:sp>
          </p:grpSp>
        </p:grpSp>
        <p:grpSp>
          <p:nvGrpSpPr>
            <p:cNvPr id="643" name="Gruppo 642">
              <a:extLst>
                <a:ext uri="{FF2B5EF4-FFF2-40B4-BE49-F238E27FC236}">
                  <a16:creationId xmlns:a16="http://schemas.microsoft.com/office/drawing/2014/main" id="{3FBBB281-459A-4732-8CAE-EA3678837323}"/>
                </a:ext>
              </a:extLst>
            </p:cNvPr>
            <p:cNvGrpSpPr/>
            <p:nvPr/>
          </p:nvGrpSpPr>
          <p:grpSpPr>
            <a:xfrm>
              <a:off x="3110562" y="4375851"/>
              <a:ext cx="570599" cy="184666"/>
              <a:chOff x="2315219" y="4378240"/>
              <a:chExt cx="570599" cy="184666"/>
            </a:xfrm>
          </p:grpSpPr>
          <p:sp>
            <p:nvSpPr>
              <p:cNvPr id="658" name="CasellaDiTesto 657">
                <a:extLst>
                  <a:ext uri="{FF2B5EF4-FFF2-40B4-BE49-F238E27FC236}">
                    <a16:creationId xmlns:a16="http://schemas.microsoft.com/office/drawing/2014/main" id="{9B9951BD-D141-403A-BC04-046CFF2C8A89}"/>
                  </a:ext>
                </a:extLst>
              </p:cNvPr>
              <p:cNvSpPr txBox="1"/>
              <p:nvPr/>
            </p:nvSpPr>
            <p:spPr>
              <a:xfrm>
                <a:off x="2315219" y="4378240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-</a:t>
                </a:r>
              </a:p>
            </p:txBody>
          </p:sp>
          <p:grpSp>
            <p:nvGrpSpPr>
              <p:cNvPr id="659" name="Gruppo 658">
                <a:extLst>
                  <a:ext uri="{FF2B5EF4-FFF2-40B4-BE49-F238E27FC236}">
                    <a16:creationId xmlns:a16="http://schemas.microsoft.com/office/drawing/2014/main" id="{27E86569-D0AA-4209-8525-597CAEDF74DE}"/>
                  </a:ext>
                </a:extLst>
              </p:cNvPr>
              <p:cNvGrpSpPr/>
              <p:nvPr/>
            </p:nvGrpSpPr>
            <p:grpSpPr>
              <a:xfrm>
                <a:off x="2366036" y="4378240"/>
                <a:ext cx="519782" cy="184666"/>
                <a:chOff x="2366036" y="4378240"/>
                <a:chExt cx="519782" cy="184666"/>
              </a:xfrm>
            </p:grpSpPr>
            <p:sp>
              <p:nvSpPr>
                <p:cNvPr id="660" name="CasellaDiTesto 659">
                  <a:extLst>
                    <a:ext uri="{FF2B5EF4-FFF2-40B4-BE49-F238E27FC236}">
                      <a16:creationId xmlns:a16="http://schemas.microsoft.com/office/drawing/2014/main" id="{D29A38BC-B737-455A-BF5F-D310C6722D2B}"/>
                    </a:ext>
                  </a:extLst>
                </p:cNvPr>
                <p:cNvSpPr txBox="1"/>
                <p:nvPr/>
              </p:nvSpPr>
              <p:spPr>
                <a:xfrm>
                  <a:off x="2366036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9</a:t>
                  </a:r>
                </a:p>
              </p:txBody>
            </p:sp>
            <p:sp>
              <p:nvSpPr>
                <p:cNvPr id="661" name="CasellaDiTesto 660">
                  <a:extLst>
                    <a:ext uri="{FF2B5EF4-FFF2-40B4-BE49-F238E27FC236}">
                      <a16:creationId xmlns:a16="http://schemas.microsoft.com/office/drawing/2014/main" id="{7C178CB7-BDF4-4D8A-A50A-B759028F88AE}"/>
                    </a:ext>
                  </a:extLst>
                </p:cNvPr>
                <p:cNvSpPr txBox="1"/>
                <p:nvPr/>
              </p:nvSpPr>
              <p:spPr>
                <a:xfrm>
                  <a:off x="2452727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8</a:t>
                  </a:r>
                </a:p>
              </p:txBody>
            </p:sp>
            <p:sp>
              <p:nvSpPr>
                <p:cNvPr id="662" name="CasellaDiTesto 661">
                  <a:extLst>
                    <a:ext uri="{FF2B5EF4-FFF2-40B4-BE49-F238E27FC236}">
                      <a16:creationId xmlns:a16="http://schemas.microsoft.com/office/drawing/2014/main" id="{DC04CEE0-9203-4FA3-8F92-C619E2060142}"/>
                    </a:ext>
                  </a:extLst>
                </p:cNvPr>
                <p:cNvSpPr txBox="1"/>
                <p:nvPr/>
              </p:nvSpPr>
              <p:spPr>
                <a:xfrm>
                  <a:off x="2514735" y="4378240"/>
                  <a:ext cx="30489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7.3</a:t>
                  </a:r>
                </a:p>
              </p:txBody>
            </p:sp>
            <p:sp>
              <p:nvSpPr>
                <p:cNvPr id="663" name="CasellaDiTesto 662">
                  <a:extLst>
                    <a:ext uri="{FF2B5EF4-FFF2-40B4-BE49-F238E27FC236}">
                      <a16:creationId xmlns:a16="http://schemas.microsoft.com/office/drawing/2014/main" id="{56847B7F-094F-43E2-BB57-0B338EC6DBDB}"/>
                    </a:ext>
                  </a:extLst>
                </p:cNvPr>
                <p:cNvSpPr txBox="1"/>
                <p:nvPr/>
              </p:nvSpPr>
              <p:spPr>
                <a:xfrm>
                  <a:off x="2632222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7</a:t>
                  </a:r>
                </a:p>
              </p:txBody>
            </p:sp>
          </p:grpSp>
        </p:grpSp>
        <p:grpSp>
          <p:nvGrpSpPr>
            <p:cNvPr id="644" name="Gruppo 643">
              <a:extLst>
                <a:ext uri="{FF2B5EF4-FFF2-40B4-BE49-F238E27FC236}">
                  <a16:creationId xmlns:a16="http://schemas.microsoft.com/office/drawing/2014/main" id="{F8CDC4ED-3DC1-4063-AC84-4F158E00D3F9}"/>
                </a:ext>
              </a:extLst>
            </p:cNvPr>
            <p:cNvGrpSpPr/>
            <p:nvPr/>
          </p:nvGrpSpPr>
          <p:grpSpPr>
            <a:xfrm>
              <a:off x="3503474" y="4375851"/>
              <a:ext cx="570599" cy="184666"/>
              <a:chOff x="2315219" y="4378240"/>
              <a:chExt cx="570599" cy="184666"/>
            </a:xfrm>
          </p:grpSpPr>
          <p:sp>
            <p:nvSpPr>
              <p:cNvPr id="652" name="CasellaDiTesto 651">
                <a:extLst>
                  <a:ext uri="{FF2B5EF4-FFF2-40B4-BE49-F238E27FC236}">
                    <a16:creationId xmlns:a16="http://schemas.microsoft.com/office/drawing/2014/main" id="{3C187B63-ED91-4978-834F-2E677F9E9037}"/>
                  </a:ext>
                </a:extLst>
              </p:cNvPr>
              <p:cNvSpPr txBox="1"/>
              <p:nvPr/>
            </p:nvSpPr>
            <p:spPr>
              <a:xfrm>
                <a:off x="2315219" y="4378240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-</a:t>
                </a:r>
              </a:p>
            </p:txBody>
          </p:sp>
          <p:grpSp>
            <p:nvGrpSpPr>
              <p:cNvPr id="653" name="Gruppo 652">
                <a:extLst>
                  <a:ext uri="{FF2B5EF4-FFF2-40B4-BE49-F238E27FC236}">
                    <a16:creationId xmlns:a16="http://schemas.microsoft.com/office/drawing/2014/main" id="{2E6CE36A-0921-4F3B-ABE4-24112C644A99}"/>
                  </a:ext>
                </a:extLst>
              </p:cNvPr>
              <p:cNvGrpSpPr/>
              <p:nvPr/>
            </p:nvGrpSpPr>
            <p:grpSpPr>
              <a:xfrm>
                <a:off x="2366036" y="4378240"/>
                <a:ext cx="519782" cy="184666"/>
                <a:chOff x="2366036" y="4378240"/>
                <a:chExt cx="519782" cy="184666"/>
              </a:xfrm>
            </p:grpSpPr>
            <p:sp>
              <p:nvSpPr>
                <p:cNvPr id="654" name="CasellaDiTesto 653">
                  <a:extLst>
                    <a:ext uri="{FF2B5EF4-FFF2-40B4-BE49-F238E27FC236}">
                      <a16:creationId xmlns:a16="http://schemas.microsoft.com/office/drawing/2014/main" id="{5B0A27B5-A21E-4417-82A5-678BE1AE1C8E}"/>
                    </a:ext>
                  </a:extLst>
                </p:cNvPr>
                <p:cNvSpPr txBox="1"/>
                <p:nvPr/>
              </p:nvSpPr>
              <p:spPr>
                <a:xfrm>
                  <a:off x="2366036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9</a:t>
                  </a:r>
                </a:p>
              </p:txBody>
            </p:sp>
            <p:sp>
              <p:nvSpPr>
                <p:cNvPr id="655" name="CasellaDiTesto 654">
                  <a:extLst>
                    <a:ext uri="{FF2B5EF4-FFF2-40B4-BE49-F238E27FC236}">
                      <a16:creationId xmlns:a16="http://schemas.microsoft.com/office/drawing/2014/main" id="{DAFF8041-C662-4565-B8BC-A6A760D7EBFC}"/>
                    </a:ext>
                  </a:extLst>
                </p:cNvPr>
                <p:cNvSpPr txBox="1"/>
                <p:nvPr/>
              </p:nvSpPr>
              <p:spPr>
                <a:xfrm>
                  <a:off x="2452727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8</a:t>
                  </a:r>
                </a:p>
              </p:txBody>
            </p:sp>
            <p:sp>
              <p:nvSpPr>
                <p:cNvPr id="656" name="CasellaDiTesto 655">
                  <a:extLst>
                    <a:ext uri="{FF2B5EF4-FFF2-40B4-BE49-F238E27FC236}">
                      <a16:creationId xmlns:a16="http://schemas.microsoft.com/office/drawing/2014/main" id="{E98F0E94-0C0F-47B0-ADEE-6F7BF6AC8BD6}"/>
                    </a:ext>
                  </a:extLst>
                </p:cNvPr>
                <p:cNvSpPr txBox="1"/>
                <p:nvPr/>
              </p:nvSpPr>
              <p:spPr>
                <a:xfrm>
                  <a:off x="2514735" y="4378240"/>
                  <a:ext cx="30489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7.3</a:t>
                  </a:r>
                </a:p>
              </p:txBody>
            </p:sp>
            <p:sp>
              <p:nvSpPr>
                <p:cNvPr id="657" name="CasellaDiTesto 656">
                  <a:extLst>
                    <a:ext uri="{FF2B5EF4-FFF2-40B4-BE49-F238E27FC236}">
                      <a16:creationId xmlns:a16="http://schemas.microsoft.com/office/drawing/2014/main" id="{ED9B5E9C-E396-4CB0-A9C6-398F4D3A1BD1}"/>
                    </a:ext>
                  </a:extLst>
                </p:cNvPr>
                <p:cNvSpPr txBox="1"/>
                <p:nvPr/>
              </p:nvSpPr>
              <p:spPr>
                <a:xfrm>
                  <a:off x="2632222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7</a:t>
                  </a:r>
                </a:p>
              </p:txBody>
            </p:sp>
          </p:grpSp>
        </p:grpSp>
        <p:grpSp>
          <p:nvGrpSpPr>
            <p:cNvPr id="645" name="Gruppo 644">
              <a:extLst>
                <a:ext uri="{FF2B5EF4-FFF2-40B4-BE49-F238E27FC236}">
                  <a16:creationId xmlns:a16="http://schemas.microsoft.com/office/drawing/2014/main" id="{B95C8970-CCFE-48AB-9DCC-9CC7DF312876}"/>
                </a:ext>
              </a:extLst>
            </p:cNvPr>
            <p:cNvGrpSpPr/>
            <p:nvPr/>
          </p:nvGrpSpPr>
          <p:grpSpPr>
            <a:xfrm>
              <a:off x="3898760" y="4375851"/>
              <a:ext cx="570599" cy="184666"/>
              <a:chOff x="2315219" y="4378240"/>
              <a:chExt cx="570599" cy="184666"/>
            </a:xfrm>
          </p:grpSpPr>
          <p:sp>
            <p:nvSpPr>
              <p:cNvPr id="646" name="CasellaDiTesto 645">
                <a:extLst>
                  <a:ext uri="{FF2B5EF4-FFF2-40B4-BE49-F238E27FC236}">
                    <a16:creationId xmlns:a16="http://schemas.microsoft.com/office/drawing/2014/main" id="{7CF55756-4DA8-43FB-AE17-DBD54EA3C1E6}"/>
                  </a:ext>
                </a:extLst>
              </p:cNvPr>
              <p:cNvSpPr txBox="1"/>
              <p:nvPr/>
            </p:nvSpPr>
            <p:spPr>
              <a:xfrm>
                <a:off x="2315219" y="4378240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-</a:t>
                </a:r>
              </a:p>
            </p:txBody>
          </p:sp>
          <p:grpSp>
            <p:nvGrpSpPr>
              <p:cNvPr id="647" name="Gruppo 646">
                <a:extLst>
                  <a:ext uri="{FF2B5EF4-FFF2-40B4-BE49-F238E27FC236}">
                    <a16:creationId xmlns:a16="http://schemas.microsoft.com/office/drawing/2014/main" id="{C1FAFFC3-23DF-40C7-BEEB-5081EFC17195}"/>
                  </a:ext>
                </a:extLst>
              </p:cNvPr>
              <p:cNvGrpSpPr/>
              <p:nvPr/>
            </p:nvGrpSpPr>
            <p:grpSpPr>
              <a:xfrm>
                <a:off x="2366036" y="4378240"/>
                <a:ext cx="519782" cy="184666"/>
                <a:chOff x="2366036" y="4378240"/>
                <a:chExt cx="519782" cy="184666"/>
              </a:xfrm>
            </p:grpSpPr>
            <p:sp>
              <p:nvSpPr>
                <p:cNvPr id="648" name="CasellaDiTesto 647">
                  <a:extLst>
                    <a:ext uri="{FF2B5EF4-FFF2-40B4-BE49-F238E27FC236}">
                      <a16:creationId xmlns:a16="http://schemas.microsoft.com/office/drawing/2014/main" id="{9191C5B0-8515-4159-8AC7-1791B1E46756}"/>
                    </a:ext>
                  </a:extLst>
                </p:cNvPr>
                <p:cNvSpPr txBox="1"/>
                <p:nvPr/>
              </p:nvSpPr>
              <p:spPr>
                <a:xfrm>
                  <a:off x="2366036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9</a:t>
                  </a:r>
                </a:p>
              </p:txBody>
            </p:sp>
            <p:sp>
              <p:nvSpPr>
                <p:cNvPr id="649" name="CasellaDiTesto 648">
                  <a:extLst>
                    <a:ext uri="{FF2B5EF4-FFF2-40B4-BE49-F238E27FC236}">
                      <a16:creationId xmlns:a16="http://schemas.microsoft.com/office/drawing/2014/main" id="{537E4774-8D49-42E4-8174-E4B79C9D5D7A}"/>
                    </a:ext>
                  </a:extLst>
                </p:cNvPr>
                <p:cNvSpPr txBox="1"/>
                <p:nvPr/>
              </p:nvSpPr>
              <p:spPr>
                <a:xfrm>
                  <a:off x="2452727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8</a:t>
                  </a:r>
                </a:p>
              </p:txBody>
            </p:sp>
            <p:sp>
              <p:nvSpPr>
                <p:cNvPr id="650" name="CasellaDiTesto 649">
                  <a:extLst>
                    <a:ext uri="{FF2B5EF4-FFF2-40B4-BE49-F238E27FC236}">
                      <a16:creationId xmlns:a16="http://schemas.microsoft.com/office/drawing/2014/main" id="{1D903A1E-949E-44C2-984D-133AE316FF78}"/>
                    </a:ext>
                  </a:extLst>
                </p:cNvPr>
                <p:cNvSpPr txBox="1"/>
                <p:nvPr/>
              </p:nvSpPr>
              <p:spPr>
                <a:xfrm>
                  <a:off x="2514735" y="4378240"/>
                  <a:ext cx="30489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7.3</a:t>
                  </a:r>
                </a:p>
              </p:txBody>
            </p:sp>
            <p:sp>
              <p:nvSpPr>
                <p:cNvPr id="651" name="CasellaDiTesto 650">
                  <a:extLst>
                    <a:ext uri="{FF2B5EF4-FFF2-40B4-BE49-F238E27FC236}">
                      <a16:creationId xmlns:a16="http://schemas.microsoft.com/office/drawing/2014/main" id="{162319D0-6074-4B18-8299-B955BCA2C8E4}"/>
                    </a:ext>
                  </a:extLst>
                </p:cNvPr>
                <p:cNvSpPr txBox="1"/>
                <p:nvPr/>
              </p:nvSpPr>
              <p:spPr>
                <a:xfrm>
                  <a:off x="2632222" y="4378240"/>
                  <a:ext cx="25359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600" dirty="0"/>
                    <a:t>-7</a:t>
                  </a:r>
                </a:p>
              </p:txBody>
            </p:sp>
          </p:grpSp>
        </p:grpSp>
      </p:grpSp>
      <p:sp>
        <p:nvSpPr>
          <p:cNvPr id="676" name="CasellaDiTesto 675">
            <a:extLst>
              <a:ext uri="{FF2B5EF4-FFF2-40B4-BE49-F238E27FC236}">
                <a16:creationId xmlns:a16="http://schemas.microsoft.com/office/drawing/2014/main" id="{1F42CF4F-133F-48BE-97C6-6CC82A510D0F}"/>
              </a:ext>
            </a:extLst>
          </p:cNvPr>
          <p:cNvSpPr txBox="1"/>
          <p:nvPr/>
        </p:nvSpPr>
        <p:spPr>
          <a:xfrm>
            <a:off x="1837582" y="64538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A</a:t>
            </a:r>
          </a:p>
        </p:txBody>
      </p:sp>
      <p:sp>
        <p:nvSpPr>
          <p:cNvPr id="677" name="CasellaDiTesto 676">
            <a:extLst>
              <a:ext uri="{FF2B5EF4-FFF2-40B4-BE49-F238E27FC236}">
                <a16:creationId xmlns:a16="http://schemas.microsoft.com/office/drawing/2014/main" id="{1C4FA949-6C2E-4A45-AA60-7F28B5E8A91B}"/>
              </a:ext>
            </a:extLst>
          </p:cNvPr>
          <p:cNvSpPr txBox="1"/>
          <p:nvPr/>
        </p:nvSpPr>
        <p:spPr>
          <a:xfrm>
            <a:off x="1837582" y="287763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B</a:t>
            </a:r>
          </a:p>
        </p:txBody>
      </p:sp>
      <p:sp>
        <p:nvSpPr>
          <p:cNvPr id="678" name="CasellaDiTesto 677">
            <a:extLst>
              <a:ext uri="{FF2B5EF4-FFF2-40B4-BE49-F238E27FC236}">
                <a16:creationId xmlns:a16="http://schemas.microsoft.com/office/drawing/2014/main" id="{56A50454-E681-4BED-B0CC-5AA325F581D7}"/>
              </a:ext>
            </a:extLst>
          </p:cNvPr>
          <p:cNvSpPr txBox="1"/>
          <p:nvPr/>
        </p:nvSpPr>
        <p:spPr>
          <a:xfrm>
            <a:off x="1837582" y="559114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3350188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49806123-6EB8-4F24-94BE-1C0DBFF7ED11}"/>
              </a:ext>
            </a:extLst>
          </p:cNvPr>
          <p:cNvSpPr txBox="1"/>
          <p:nvPr/>
        </p:nvSpPr>
        <p:spPr>
          <a:xfrm>
            <a:off x="1970792" y="30783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ure 7</a:t>
            </a:r>
          </a:p>
        </p:txBody>
      </p:sp>
      <p:grpSp>
        <p:nvGrpSpPr>
          <p:cNvPr id="201" name="Gruppo 200">
            <a:extLst>
              <a:ext uri="{FF2B5EF4-FFF2-40B4-BE49-F238E27FC236}">
                <a16:creationId xmlns:a16="http://schemas.microsoft.com/office/drawing/2014/main" id="{995619E0-F3E4-4A7D-98CB-BFA03F78540C}"/>
              </a:ext>
            </a:extLst>
          </p:cNvPr>
          <p:cNvGrpSpPr/>
          <p:nvPr/>
        </p:nvGrpSpPr>
        <p:grpSpPr>
          <a:xfrm>
            <a:off x="381284" y="651240"/>
            <a:ext cx="2535052" cy="1843888"/>
            <a:chOff x="-53731" y="2895226"/>
            <a:chExt cx="2535052" cy="1843888"/>
          </a:xfrm>
        </p:grpSpPr>
        <p:pic>
          <p:nvPicPr>
            <p:cNvPr id="127" name="Immagine 126">
              <a:extLst>
                <a:ext uri="{FF2B5EF4-FFF2-40B4-BE49-F238E27FC236}">
                  <a16:creationId xmlns:a16="http://schemas.microsoft.com/office/drawing/2014/main" id="{35B25ABA-186E-49EF-ABE2-17DC0852D37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2282" y="2948463"/>
              <a:ext cx="2077050" cy="1440000"/>
            </a:xfrm>
            <a:prstGeom prst="rect">
              <a:avLst/>
            </a:prstGeom>
          </p:spPr>
        </p:pic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0DDFF897-6DE9-4FFF-BC49-32018AD6B99F}"/>
                </a:ext>
              </a:extLst>
            </p:cNvPr>
            <p:cNvSpPr txBox="1"/>
            <p:nvPr/>
          </p:nvSpPr>
          <p:spPr>
            <a:xfrm>
              <a:off x="358409" y="2934484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/>
                <a:t>MCF-7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922710B2-5EED-40E6-9D11-04568DBCAF8A}"/>
                </a:ext>
              </a:extLst>
            </p:cNvPr>
            <p:cNvSpPr txBox="1"/>
            <p:nvPr/>
          </p:nvSpPr>
          <p:spPr>
            <a:xfrm>
              <a:off x="2048959" y="4554448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CCT</a:t>
              </a:r>
            </a:p>
          </p:txBody>
        </p:sp>
        <p:grpSp>
          <p:nvGrpSpPr>
            <p:cNvPr id="175" name="Gruppo 174">
              <a:extLst>
                <a:ext uri="{FF2B5EF4-FFF2-40B4-BE49-F238E27FC236}">
                  <a16:creationId xmlns:a16="http://schemas.microsoft.com/office/drawing/2014/main" id="{E25CE2AA-2A14-4B1A-87FF-A4960BDC3A4C}"/>
                </a:ext>
              </a:extLst>
            </p:cNvPr>
            <p:cNvGrpSpPr/>
            <p:nvPr/>
          </p:nvGrpSpPr>
          <p:grpSpPr>
            <a:xfrm>
              <a:off x="726600" y="4388463"/>
              <a:ext cx="527871" cy="184666"/>
              <a:chOff x="726600" y="4418665"/>
              <a:chExt cx="527871" cy="184666"/>
            </a:xfrm>
          </p:grpSpPr>
          <p:sp>
            <p:nvSpPr>
              <p:cNvPr id="17" name="CasellaDiTesto 16">
                <a:extLst>
                  <a:ext uri="{FF2B5EF4-FFF2-40B4-BE49-F238E27FC236}">
                    <a16:creationId xmlns:a16="http://schemas.microsoft.com/office/drawing/2014/main" id="{724583B1-F84C-4575-AAF5-393BDE32F3C6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B08FEB7C-6C81-4BA4-A0C2-BCEB60BAF4DC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3C1B3FDA-9C98-4F1F-8218-E2ACB970C6E6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0ADD6E72-A098-4FF9-AF10-634FED87F6CE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E354511C-C467-4213-910F-8DD58C101524}"/>
                </a:ext>
              </a:extLst>
            </p:cNvPr>
            <p:cNvSpPr txBox="1"/>
            <p:nvPr/>
          </p:nvSpPr>
          <p:spPr>
            <a:xfrm>
              <a:off x="832802" y="4554448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VE</a:t>
              </a: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4BB1EA8D-6450-4C1C-A6C3-436E48331EA3}"/>
                </a:ext>
              </a:extLst>
            </p:cNvPr>
            <p:cNvSpPr txBox="1"/>
            <p:nvPr/>
          </p:nvSpPr>
          <p:spPr>
            <a:xfrm>
              <a:off x="1216354" y="4554448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KU</a:t>
              </a: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F0D92F94-2A15-42A6-8E8C-B3B7B30413F6}"/>
                </a:ext>
              </a:extLst>
            </p:cNvPr>
            <p:cNvSpPr txBox="1"/>
            <p:nvPr/>
          </p:nvSpPr>
          <p:spPr>
            <a:xfrm>
              <a:off x="1640529" y="455444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MK</a:t>
              </a:r>
            </a:p>
          </p:txBody>
        </p:sp>
        <p:grpSp>
          <p:nvGrpSpPr>
            <p:cNvPr id="191" name="Gruppo 190">
              <a:extLst>
                <a:ext uri="{FF2B5EF4-FFF2-40B4-BE49-F238E27FC236}">
                  <a16:creationId xmlns:a16="http://schemas.microsoft.com/office/drawing/2014/main" id="{7D8D11F8-9D91-4BAA-8BF1-4A3E05C0EAFF}"/>
                </a:ext>
              </a:extLst>
            </p:cNvPr>
            <p:cNvGrpSpPr/>
            <p:nvPr/>
          </p:nvGrpSpPr>
          <p:grpSpPr>
            <a:xfrm>
              <a:off x="348853" y="4388463"/>
              <a:ext cx="502435" cy="184666"/>
              <a:chOff x="348853" y="4418665"/>
              <a:chExt cx="502435" cy="184666"/>
            </a:xfrm>
          </p:grpSpPr>
          <p:sp>
            <p:nvSpPr>
              <p:cNvPr id="35" name="CasellaDiTesto 34">
                <a:extLst>
                  <a:ext uri="{FF2B5EF4-FFF2-40B4-BE49-F238E27FC236}">
                    <a16:creationId xmlns:a16="http://schemas.microsoft.com/office/drawing/2014/main" id="{2CE14159-01AE-44EF-BB29-89C261C6E4B4}"/>
                  </a:ext>
                </a:extLst>
              </p:cNvPr>
              <p:cNvSpPr txBox="1"/>
              <p:nvPr/>
            </p:nvSpPr>
            <p:spPr>
              <a:xfrm>
                <a:off x="34885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36" name="CasellaDiTesto 35">
                <a:extLst>
                  <a:ext uri="{FF2B5EF4-FFF2-40B4-BE49-F238E27FC236}">
                    <a16:creationId xmlns:a16="http://schemas.microsoft.com/office/drawing/2014/main" id="{F8C4383D-DFE7-4746-B2D7-A8C449044141}"/>
                  </a:ext>
                </a:extLst>
              </p:cNvPr>
              <p:cNvSpPr txBox="1"/>
              <p:nvPr/>
            </p:nvSpPr>
            <p:spPr>
              <a:xfrm>
                <a:off x="433242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  <p:sp>
            <p:nvSpPr>
              <p:cNvPr id="37" name="CasellaDiTesto 36">
                <a:extLst>
                  <a:ext uri="{FF2B5EF4-FFF2-40B4-BE49-F238E27FC236}">
                    <a16:creationId xmlns:a16="http://schemas.microsoft.com/office/drawing/2014/main" id="{F3FF3AB5-9BB7-41B2-A33B-1E0BFB02160D}"/>
                  </a:ext>
                </a:extLst>
              </p:cNvPr>
              <p:cNvSpPr txBox="1"/>
              <p:nvPr/>
            </p:nvSpPr>
            <p:spPr>
              <a:xfrm>
                <a:off x="517567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5</a:t>
                </a:r>
              </a:p>
            </p:txBody>
          </p:sp>
          <p:sp>
            <p:nvSpPr>
              <p:cNvPr id="38" name="CasellaDiTesto 37">
                <a:extLst>
                  <a:ext uri="{FF2B5EF4-FFF2-40B4-BE49-F238E27FC236}">
                    <a16:creationId xmlns:a16="http://schemas.microsoft.com/office/drawing/2014/main" id="{B80AC9C6-43F7-480D-B70A-572451654237}"/>
                  </a:ext>
                </a:extLst>
              </p:cNvPr>
              <p:cNvSpPr txBox="1"/>
              <p:nvPr/>
            </p:nvSpPr>
            <p:spPr>
              <a:xfrm>
                <a:off x="580060" y="441866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0</a:t>
                </a:r>
              </a:p>
            </p:txBody>
          </p:sp>
        </p:grp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id="{28C9C284-F8CD-4DAC-ADAE-AC2EF0AD05F6}"/>
                </a:ext>
              </a:extLst>
            </p:cNvPr>
            <p:cNvSpPr txBox="1"/>
            <p:nvPr/>
          </p:nvSpPr>
          <p:spPr>
            <a:xfrm>
              <a:off x="415406" y="4554448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AZD</a:t>
              </a:r>
            </a:p>
          </p:txBody>
        </p:sp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E34B685F-AE94-46B0-9C98-56D4CE92BD49}"/>
                </a:ext>
              </a:extLst>
            </p:cNvPr>
            <p:cNvSpPr txBox="1"/>
            <p:nvPr/>
          </p:nvSpPr>
          <p:spPr>
            <a:xfrm rot="16200000">
              <a:off x="-200726" y="3506764"/>
              <a:ext cx="570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/>
                <a:t>ER</a:t>
              </a:r>
              <a:r>
                <a:rPr lang="el-GR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600" dirty="0" err="1">
                  <a:latin typeface="+mn-lt"/>
                  <a:cs typeface="Times New Roman" panose="02020603050405020304" pitchFamily="18" charset="0"/>
                </a:rPr>
                <a:t>levels</a:t>
              </a:r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(</a:t>
              </a:r>
              <a:r>
                <a:rPr lang="it-IT" sz="600" dirty="0" err="1">
                  <a:latin typeface="+mn-lt"/>
                  <a:cs typeface="Times New Roman" panose="02020603050405020304" pitchFamily="18" charset="0"/>
                </a:rPr>
                <a:t>Fold</a:t>
              </a:r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 on 0)</a:t>
              </a:r>
              <a:endParaRPr lang="it-IT" sz="600" dirty="0">
                <a:latin typeface="+mn-lt"/>
              </a:endParaRPr>
            </a:p>
          </p:txBody>
        </p:sp>
        <p:grpSp>
          <p:nvGrpSpPr>
            <p:cNvPr id="176" name="Gruppo 175">
              <a:extLst>
                <a:ext uri="{FF2B5EF4-FFF2-40B4-BE49-F238E27FC236}">
                  <a16:creationId xmlns:a16="http://schemas.microsoft.com/office/drawing/2014/main" id="{F5936C58-B1BD-4AD8-A4C9-7BB00596DFF9}"/>
                </a:ext>
              </a:extLst>
            </p:cNvPr>
            <p:cNvGrpSpPr/>
            <p:nvPr/>
          </p:nvGrpSpPr>
          <p:grpSpPr>
            <a:xfrm>
              <a:off x="1121704" y="4388463"/>
              <a:ext cx="527871" cy="184666"/>
              <a:chOff x="726600" y="4418665"/>
              <a:chExt cx="527871" cy="184666"/>
            </a:xfrm>
          </p:grpSpPr>
          <p:sp>
            <p:nvSpPr>
              <p:cNvPr id="177" name="CasellaDiTesto 176">
                <a:extLst>
                  <a:ext uri="{FF2B5EF4-FFF2-40B4-BE49-F238E27FC236}">
                    <a16:creationId xmlns:a16="http://schemas.microsoft.com/office/drawing/2014/main" id="{371F0A0A-9FB3-463B-B7E0-90DA8DAA5F26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178" name="CasellaDiTesto 177">
                <a:extLst>
                  <a:ext uri="{FF2B5EF4-FFF2-40B4-BE49-F238E27FC236}">
                    <a16:creationId xmlns:a16="http://schemas.microsoft.com/office/drawing/2014/main" id="{A2F3E442-4427-4115-8A9F-00FE3A429413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179" name="CasellaDiTesto 178">
                <a:extLst>
                  <a:ext uri="{FF2B5EF4-FFF2-40B4-BE49-F238E27FC236}">
                    <a16:creationId xmlns:a16="http://schemas.microsoft.com/office/drawing/2014/main" id="{6BFA1507-7795-4D90-8EFB-7DA1D0FC4EBD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180" name="CasellaDiTesto 179">
                <a:extLst>
                  <a:ext uri="{FF2B5EF4-FFF2-40B4-BE49-F238E27FC236}">
                    <a16:creationId xmlns:a16="http://schemas.microsoft.com/office/drawing/2014/main" id="{66BB1519-A55D-414A-AD39-DDF9282DFF77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grpSp>
          <p:nvGrpSpPr>
            <p:cNvPr id="181" name="Gruppo 180">
              <a:extLst>
                <a:ext uri="{FF2B5EF4-FFF2-40B4-BE49-F238E27FC236}">
                  <a16:creationId xmlns:a16="http://schemas.microsoft.com/office/drawing/2014/main" id="{A2CD5478-C9F0-4BCA-A88B-D1D4D165117F}"/>
                </a:ext>
              </a:extLst>
            </p:cNvPr>
            <p:cNvGrpSpPr/>
            <p:nvPr/>
          </p:nvGrpSpPr>
          <p:grpSpPr>
            <a:xfrm>
              <a:off x="1539553" y="4388463"/>
              <a:ext cx="527871" cy="184666"/>
              <a:chOff x="726600" y="4418665"/>
              <a:chExt cx="527871" cy="184666"/>
            </a:xfrm>
          </p:grpSpPr>
          <p:sp>
            <p:nvSpPr>
              <p:cNvPr id="182" name="CasellaDiTesto 181">
                <a:extLst>
                  <a:ext uri="{FF2B5EF4-FFF2-40B4-BE49-F238E27FC236}">
                    <a16:creationId xmlns:a16="http://schemas.microsoft.com/office/drawing/2014/main" id="{9042A1CB-B31A-43F3-BFE5-F439BB8EE801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183" name="CasellaDiTesto 182">
                <a:extLst>
                  <a:ext uri="{FF2B5EF4-FFF2-40B4-BE49-F238E27FC236}">
                    <a16:creationId xmlns:a16="http://schemas.microsoft.com/office/drawing/2014/main" id="{AE913C32-546E-45E1-8143-22360A8C3AA1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184" name="CasellaDiTesto 183">
                <a:extLst>
                  <a:ext uri="{FF2B5EF4-FFF2-40B4-BE49-F238E27FC236}">
                    <a16:creationId xmlns:a16="http://schemas.microsoft.com/office/drawing/2014/main" id="{F6AD805D-F2BE-489F-8CA9-E5E16121F945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185" name="CasellaDiTesto 184">
                <a:extLst>
                  <a:ext uri="{FF2B5EF4-FFF2-40B4-BE49-F238E27FC236}">
                    <a16:creationId xmlns:a16="http://schemas.microsoft.com/office/drawing/2014/main" id="{B4050953-907B-4FBB-BB47-AE022508915E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grpSp>
          <p:nvGrpSpPr>
            <p:cNvPr id="186" name="Gruppo 185">
              <a:extLst>
                <a:ext uri="{FF2B5EF4-FFF2-40B4-BE49-F238E27FC236}">
                  <a16:creationId xmlns:a16="http://schemas.microsoft.com/office/drawing/2014/main" id="{A939C31C-7A3F-4D08-AC98-7A612D0CBB24}"/>
                </a:ext>
              </a:extLst>
            </p:cNvPr>
            <p:cNvGrpSpPr/>
            <p:nvPr/>
          </p:nvGrpSpPr>
          <p:grpSpPr>
            <a:xfrm>
              <a:off x="1953450" y="4388463"/>
              <a:ext cx="527871" cy="184666"/>
              <a:chOff x="726600" y="4418665"/>
              <a:chExt cx="527871" cy="184666"/>
            </a:xfrm>
          </p:grpSpPr>
          <p:sp>
            <p:nvSpPr>
              <p:cNvPr id="187" name="CasellaDiTesto 186">
                <a:extLst>
                  <a:ext uri="{FF2B5EF4-FFF2-40B4-BE49-F238E27FC236}">
                    <a16:creationId xmlns:a16="http://schemas.microsoft.com/office/drawing/2014/main" id="{4AC6D943-3326-45CA-9FFF-D60C53903011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188" name="CasellaDiTesto 187">
                <a:extLst>
                  <a:ext uri="{FF2B5EF4-FFF2-40B4-BE49-F238E27FC236}">
                    <a16:creationId xmlns:a16="http://schemas.microsoft.com/office/drawing/2014/main" id="{711F7B37-ADF5-41FD-907F-F4F9D7A51AD2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189" name="CasellaDiTesto 188">
                <a:extLst>
                  <a:ext uri="{FF2B5EF4-FFF2-40B4-BE49-F238E27FC236}">
                    <a16:creationId xmlns:a16="http://schemas.microsoft.com/office/drawing/2014/main" id="{04FB3B33-BD86-4008-A6A2-5BB6EC86F22C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190" name="CasellaDiTesto 189">
                <a:extLst>
                  <a:ext uri="{FF2B5EF4-FFF2-40B4-BE49-F238E27FC236}">
                    <a16:creationId xmlns:a16="http://schemas.microsoft.com/office/drawing/2014/main" id="{AB22C0D7-F054-4B8C-AEF6-E932E6E99BB5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cxnSp>
          <p:nvCxnSpPr>
            <p:cNvPr id="193" name="Connettore diritto 192">
              <a:extLst>
                <a:ext uri="{FF2B5EF4-FFF2-40B4-BE49-F238E27FC236}">
                  <a16:creationId xmlns:a16="http://schemas.microsoft.com/office/drawing/2014/main" id="{DF9024DE-20D0-43AF-B2BC-4547BBC7674C}"/>
                </a:ext>
              </a:extLst>
            </p:cNvPr>
            <p:cNvCxnSpPr>
              <a:cxnSpLocks/>
            </p:cNvCxnSpPr>
            <p:nvPr/>
          </p:nvCxnSpPr>
          <p:spPr>
            <a:xfrm>
              <a:off x="422632" y="455908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4" name="Connettore diritto 193">
              <a:extLst>
                <a:ext uri="{FF2B5EF4-FFF2-40B4-BE49-F238E27FC236}">
                  <a16:creationId xmlns:a16="http://schemas.microsoft.com/office/drawing/2014/main" id="{5C686A03-8B1D-42D2-A6C2-B4F830ABACD8}"/>
                </a:ext>
              </a:extLst>
            </p:cNvPr>
            <p:cNvCxnSpPr>
              <a:cxnSpLocks/>
            </p:cNvCxnSpPr>
            <p:nvPr/>
          </p:nvCxnSpPr>
          <p:spPr>
            <a:xfrm>
              <a:off x="821631" y="455908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5" name="Connettore diritto 194">
              <a:extLst>
                <a:ext uri="{FF2B5EF4-FFF2-40B4-BE49-F238E27FC236}">
                  <a16:creationId xmlns:a16="http://schemas.microsoft.com/office/drawing/2014/main" id="{C50AC52C-B993-4601-ADFC-1501216B3401}"/>
                </a:ext>
              </a:extLst>
            </p:cNvPr>
            <p:cNvCxnSpPr>
              <a:cxnSpLocks/>
            </p:cNvCxnSpPr>
            <p:nvPr/>
          </p:nvCxnSpPr>
          <p:spPr>
            <a:xfrm>
              <a:off x="1216735" y="455908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6" name="Connettore diritto 195">
              <a:extLst>
                <a:ext uri="{FF2B5EF4-FFF2-40B4-BE49-F238E27FC236}">
                  <a16:creationId xmlns:a16="http://schemas.microsoft.com/office/drawing/2014/main" id="{42EC6D8B-DBB0-42A4-8412-E5E2EC98093B}"/>
                </a:ext>
              </a:extLst>
            </p:cNvPr>
            <p:cNvCxnSpPr>
              <a:cxnSpLocks/>
            </p:cNvCxnSpPr>
            <p:nvPr/>
          </p:nvCxnSpPr>
          <p:spPr>
            <a:xfrm>
              <a:off x="1640945" y="455908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7" name="Connettore diritto 196">
              <a:extLst>
                <a:ext uri="{FF2B5EF4-FFF2-40B4-BE49-F238E27FC236}">
                  <a16:creationId xmlns:a16="http://schemas.microsoft.com/office/drawing/2014/main" id="{EEF0205A-D8E0-4391-8DA2-92D4A321CD5C}"/>
                </a:ext>
              </a:extLst>
            </p:cNvPr>
            <p:cNvCxnSpPr>
              <a:cxnSpLocks/>
            </p:cNvCxnSpPr>
            <p:nvPr/>
          </p:nvCxnSpPr>
          <p:spPr>
            <a:xfrm>
              <a:off x="2055977" y="455908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8" name="CasellaDiTesto 197">
              <a:extLst>
                <a:ext uri="{FF2B5EF4-FFF2-40B4-BE49-F238E27FC236}">
                  <a16:creationId xmlns:a16="http://schemas.microsoft.com/office/drawing/2014/main" id="{3D868067-E2FD-4489-AAD3-3F276908733A}"/>
                </a:ext>
              </a:extLst>
            </p:cNvPr>
            <p:cNvSpPr txBox="1"/>
            <p:nvPr/>
          </p:nvSpPr>
          <p:spPr>
            <a:xfrm>
              <a:off x="137212" y="4225886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.0</a:t>
              </a:r>
            </a:p>
          </p:txBody>
        </p:sp>
        <p:sp>
          <p:nvSpPr>
            <p:cNvPr id="199" name="CasellaDiTesto 198">
              <a:extLst>
                <a:ext uri="{FF2B5EF4-FFF2-40B4-BE49-F238E27FC236}">
                  <a16:creationId xmlns:a16="http://schemas.microsoft.com/office/drawing/2014/main" id="{C6D13FBD-4597-4C57-9FA3-12107866B7B0}"/>
                </a:ext>
              </a:extLst>
            </p:cNvPr>
            <p:cNvSpPr txBox="1"/>
            <p:nvPr/>
          </p:nvSpPr>
          <p:spPr>
            <a:xfrm>
              <a:off x="137212" y="3562339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.0</a:t>
              </a:r>
            </a:p>
          </p:txBody>
        </p:sp>
        <p:sp>
          <p:nvSpPr>
            <p:cNvPr id="200" name="CasellaDiTesto 199">
              <a:extLst>
                <a:ext uri="{FF2B5EF4-FFF2-40B4-BE49-F238E27FC236}">
                  <a16:creationId xmlns:a16="http://schemas.microsoft.com/office/drawing/2014/main" id="{A97A4A86-8064-4A54-98B3-BB6408200E90}"/>
                </a:ext>
              </a:extLst>
            </p:cNvPr>
            <p:cNvSpPr txBox="1"/>
            <p:nvPr/>
          </p:nvSpPr>
          <p:spPr>
            <a:xfrm>
              <a:off x="137212" y="2895226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.0</a:t>
              </a:r>
            </a:p>
          </p:txBody>
        </p:sp>
      </p:grpSp>
      <p:grpSp>
        <p:nvGrpSpPr>
          <p:cNvPr id="245" name="Gruppo 244">
            <a:extLst>
              <a:ext uri="{FF2B5EF4-FFF2-40B4-BE49-F238E27FC236}">
                <a16:creationId xmlns:a16="http://schemas.microsoft.com/office/drawing/2014/main" id="{422723CA-9B12-46F4-8AE4-DA5A6898E9CF}"/>
              </a:ext>
            </a:extLst>
          </p:cNvPr>
          <p:cNvGrpSpPr/>
          <p:nvPr/>
        </p:nvGrpSpPr>
        <p:grpSpPr>
          <a:xfrm>
            <a:off x="3722898" y="651240"/>
            <a:ext cx="2535052" cy="1843888"/>
            <a:chOff x="3566877" y="665236"/>
            <a:chExt cx="2535052" cy="1843888"/>
          </a:xfrm>
        </p:grpSpPr>
        <p:pic>
          <p:nvPicPr>
            <p:cNvPr id="244" name="Immagine 243">
              <a:extLst>
                <a:ext uri="{FF2B5EF4-FFF2-40B4-BE49-F238E27FC236}">
                  <a16:creationId xmlns:a16="http://schemas.microsoft.com/office/drawing/2014/main" id="{C284D60D-CA31-4A11-8971-F50F26567EA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62890" y="718473"/>
              <a:ext cx="2129860" cy="1440000"/>
            </a:xfrm>
            <a:prstGeom prst="rect">
              <a:avLst/>
            </a:prstGeom>
          </p:spPr>
        </p:pic>
        <p:sp>
          <p:nvSpPr>
            <p:cNvPr id="204" name="CasellaDiTesto 203">
              <a:extLst>
                <a:ext uri="{FF2B5EF4-FFF2-40B4-BE49-F238E27FC236}">
                  <a16:creationId xmlns:a16="http://schemas.microsoft.com/office/drawing/2014/main" id="{5CA5C177-8038-4482-81BE-B740C0740375}"/>
                </a:ext>
              </a:extLst>
            </p:cNvPr>
            <p:cNvSpPr txBox="1"/>
            <p:nvPr/>
          </p:nvSpPr>
          <p:spPr>
            <a:xfrm>
              <a:off x="3979017" y="704494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/>
                <a:t>Y537S</a:t>
              </a:r>
            </a:p>
          </p:txBody>
        </p:sp>
        <p:sp>
          <p:nvSpPr>
            <p:cNvPr id="205" name="CasellaDiTesto 204">
              <a:extLst>
                <a:ext uri="{FF2B5EF4-FFF2-40B4-BE49-F238E27FC236}">
                  <a16:creationId xmlns:a16="http://schemas.microsoft.com/office/drawing/2014/main" id="{D51EEB8D-36FA-4795-B17A-7426BB7305A0}"/>
                </a:ext>
              </a:extLst>
            </p:cNvPr>
            <p:cNvSpPr txBox="1"/>
            <p:nvPr/>
          </p:nvSpPr>
          <p:spPr>
            <a:xfrm>
              <a:off x="5669567" y="2324458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CCT</a:t>
              </a:r>
            </a:p>
          </p:txBody>
        </p:sp>
        <p:grpSp>
          <p:nvGrpSpPr>
            <p:cNvPr id="206" name="Gruppo 205">
              <a:extLst>
                <a:ext uri="{FF2B5EF4-FFF2-40B4-BE49-F238E27FC236}">
                  <a16:creationId xmlns:a16="http://schemas.microsoft.com/office/drawing/2014/main" id="{B0C521EA-E3AE-4D71-82D9-79E18DAD2921}"/>
                </a:ext>
              </a:extLst>
            </p:cNvPr>
            <p:cNvGrpSpPr/>
            <p:nvPr/>
          </p:nvGrpSpPr>
          <p:grpSpPr>
            <a:xfrm>
              <a:off x="4347208" y="2158473"/>
              <a:ext cx="527871" cy="184666"/>
              <a:chOff x="726600" y="4418665"/>
              <a:chExt cx="527871" cy="184666"/>
            </a:xfrm>
          </p:grpSpPr>
          <p:sp>
            <p:nvSpPr>
              <p:cNvPr id="240" name="CasellaDiTesto 239">
                <a:extLst>
                  <a:ext uri="{FF2B5EF4-FFF2-40B4-BE49-F238E27FC236}">
                    <a16:creationId xmlns:a16="http://schemas.microsoft.com/office/drawing/2014/main" id="{4088450F-DD76-4950-8535-C27A7BA3660B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241" name="CasellaDiTesto 240">
                <a:extLst>
                  <a:ext uri="{FF2B5EF4-FFF2-40B4-BE49-F238E27FC236}">
                    <a16:creationId xmlns:a16="http://schemas.microsoft.com/office/drawing/2014/main" id="{6E88BECF-76E5-48DF-AA7F-5B52118C76F9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242" name="CasellaDiTesto 241">
                <a:extLst>
                  <a:ext uri="{FF2B5EF4-FFF2-40B4-BE49-F238E27FC236}">
                    <a16:creationId xmlns:a16="http://schemas.microsoft.com/office/drawing/2014/main" id="{48336E8C-AD7C-4F3D-88F7-83AF0D43398C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243" name="CasellaDiTesto 242">
                <a:extLst>
                  <a:ext uri="{FF2B5EF4-FFF2-40B4-BE49-F238E27FC236}">
                    <a16:creationId xmlns:a16="http://schemas.microsoft.com/office/drawing/2014/main" id="{8485EB3F-5733-4EC9-99E8-D6779E3D00EB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sp>
          <p:nvSpPr>
            <p:cNvPr id="207" name="CasellaDiTesto 206">
              <a:extLst>
                <a:ext uri="{FF2B5EF4-FFF2-40B4-BE49-F238E27FC236}">
                  <a16:creationId xmlns:a16="http://schemas.microsoft.com/office/drawing/2014/main" id="{E198B8C5-EC25-4D4F-9373-77822748CFB7}"/>
                </a:ext>
              </a:extLst>
            </p:cNvPr>
            <p:cNvSpPr txBox="1"/>
            <p:nvPr/>
          </p:nvSpPr>
          <p:spPr>
            <a:xfrm>
              <a:off x="4453410" y="2324458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VE</a:t>
              </a:r>
            </a:p>
          </p:txBody>
        </p:sp>
        <p:sp>
          <p:nvSpPr>
            <p:cNvPr id="208" name="CasellaDiTesto 207">
              <a:extLst>
                <a:ext uri="{FF2B5EF4-FFF2-40B4-BE49-F238E27FC236}">
                  <a16:creationId xmlns:a16="http://schemas.microsoft.com/office/drawing/2014/main" id="{C1F291EB-FD24-4905-AD43-ABEEB0A77AEA}"/>
                </a:ext>
              </a:extLst>
            </p:cNvPr>
            <p:cNvSpPr txBox="1"/>
            <p:nvPr/>
          </p:nvSpPr>
          <p:spPr>
            <a:xfrm>
              <a:off x="4836962" y="2324458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KU</a:t>
              </a:r>
            </a:p>
          </p:txBody>
        </p:sp>
        <p:sp>
          <p:nvSpPr>
            <p:cNvPr id="209" name="CasellaDiTesto 208">
              <a:extLst>
                <a:ext uri="{FF2B5EF4-FFF2-40B4-BE49-F238E27FC236}">
                  <a16:creationId xmlns:a16="http://schemas.microsoft.com/office/drawing/2014/main" id="{40489E15-D904-40D9-BA29-FE08CD690158}"/>
                </a:ext>
              </a:extLst>
            </p:cNvPr>
            <p:cNvSpPr txBox="1"/>
            <p:nvPr/>
          </p:nvSpPr>
          <p:spPr>
            <a:xfrm>
              <a:off x="5261137" y="232445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MK</a:t>
              </a:r>
            </a:p>
          </p:txBody>
        </p:sp>
        <p:grpSp>
          <p:nvGrpSpPr>
            <p:cNvPr id="210" name="Gruppo 209">
              <a:extLst>
                <a:ext uri="{FF2B5EF4-FFF2-40B4-BE49-F238E27FC236}">
                  <a16:creationId xmlns:a16="http://schemas.microsoft.com/office/drawing/2014/main" id="{682CEAC0-FB40-4982-B592-C7608E49F3CF}"/>
                </a:ext>
              </a:extLst>
            </p:cNvPr>
            <p:cNvGrpSpPr/>
            <p:nvPr/>
          </p:nvGrpSpPr>
          <p:grpSpPr>
            <a:xfrm>
              <a:off x="3969461" y="2158473"/>
              <a:ext cx="502435" cy="184666"/>
              <a:chOff x="348853" y="4418665"/>
              <a:chExt cx="502435" cy="184666"/>
            </a:xfrm>
          </p:grpSpPr>
          <p:sp>
            <p:nvSpPr>
              <p:cNvPr id="236" name="CasellaDiTesto 235">
                <a:extLst>
                  <a:ext uri="{FF2B5EF4-FFF2-40B4-BE49-F238E27FC236}">
                    <a16:creationId xmlns:a16="http://schemas.microsoft.com/office/drawing/2014/main" id="{5D225D50-5795-4BAA-96D1-C6EF481A0E31}"/>
                  </a:ext>
                </a:extLst>
              </p:cNvPr>
              <p:cNvSpPr txBox="1"/>
              <p:nvPr/>
            </p:nvSpPr>
            <p:spPr>
              <a:xfrm>
                <a:off x="34885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237" name="CasellaDiTesto 236">
                <a:extLst>
                  <a:ext uri="{FF2B5EF4-FFF2-40B4-BE49-F238E27FC236}">
                    <a16:creationId xmlns:a16="http://schemas.microsoft.com/office/drawing/2014/main" id="{9C124EE9-0405-45C8-BA78-C43A1B8D06CD}"/>
                  </a:ext>
                </a:extLst>
              </p:cNvPr>
              <p:cNvSpPr txBox="1"/>
              <p:nvPr/>
            </p:nvSpPr>
            <p:spPr>
              <a:xfrm>
                <a:off x="433242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  <p:sp>
            <p:nvSpPr>
              <p:cNvPr id="238" name="CasellaDiTesto 237">
                <a:extLst>
                  <a:ext uri="{FF2B5EF4-FFF2-40B4-BE49-F238E27FC236}">
                    <a16:creationId xmlns:a16="http://schemas.microsoft.com/office/drawing/2014/main" id="{605BC0DA-58FC-4817-A8A0-F58BADBDD056}"/>
                  </a:ext>
                </a:extLst>
              </p:cNvPr>
              <p:cNvSpPr txBox="1"/>
              <p:nvPr/>
            </p:nvSpPr>
            <p:spPr>
              <a:xfrm>
                <a:off x="517567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5</a:t>
                </a:r>
              </a:p>
            </p:txBody>
          </p:sp>
          <p:sp>
            <p:nvSpPr>
              <p:cNvPr id="239" name="CasellaDiTesto 238">
                <a:extLst>
                  <a:ext uri="{FF2B5EF4-FFF2-40B4-BE49-F238E27FC236}">
                    <a16:creationId xmlns:a16="http://schemas.microsoft.com/office/drawing/2014/main" id="{3858709F-7907-4975-90D8-7C0D2F145A7E}"/>
                  </a:ext>
                </a:extLst>
              </p:cNvPr>
              <p:cNvSpPr txBox="1"/>
              <p:nvPr/>
            </p:nvSpPr>
            <p:spPr>
              <a:xfrm>
                <a:off x="580060" y="441866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0</a:t>
                </a:r>
              </a:p>
            </p:txBody>
          </p:sp>
        </p:grpSp>
        <p:sp>
          <p:nvSpPr>
            <p:cNvPr id="211" name="CasellaDiTesto 210">
              <a:extLst>
                <a:ext uri="{FF2B5EF4-FFF2-40B4-BE49-F238E27FC236}">
                  <a16:creationId xmlns:a16="http://schemas.microsoft.com/office/drawing/2014/main" id="{ACEBE25D-30F7-43C3-81E2-2CE598EB2D68}"/>
                </a:ext>
              </a:extLst>
            </p:cNvPr>
            <p:cNvSpPr txBox="1"/>
            <p:nvPr/>
          </p:nvSpPr>
          <p:spPr>
            <a:xfrm>
              <a:off x="4036014" y="2324458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AZD</a:t>
              </a:r>
            </a:p>
          </p:txBody>
        </p:sp>
        <p:sp>
          <p:nvSpPr>
            <p:cNvPr id="212" name="CasellaDiTesto 211">
              <a:extLst>
                <a:ext uri="{FF2B5EF4-FFF2-40B4-BE49-F238E27FC236}">
                  <a16:creationId xmlns:a16="http://schemas.microsoft.com/office/drawing/2014/main" id="{84752527-D27A-422E-AF3B-D7E843045826}"/>
                </a:ext>
              </a:extLst>
            </p:cNvPr>
            <p:cNvSpPr txBox="1"/>
            <p:nvPr/>
          </p:nvSpPr>
          <p:spPr>
            <a:xfrm rot="16200000">
              <a:off x="3419882" y="1276774"/>
              <a:ext cx="570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/>
                <a:t>ER</a:t>
              </a:r>
              <a:r>
                <a:rPr lang="el-GR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600" dirty="0" err="1">
                  <a:latin typeface="+mn-lt"/>
                  <a:cs typeface="Times New Roman" panose="02020603050405020304" pitchFamily="18" charset="0"/>
                </a:rPr>
                <a:t>levels</a:t>
              </a:r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(</a:t>
              </a:r>
              <a:r>
                <a:rPr lang="it-IT" sz="600" dirty="0" err="1">
                  <a:latin typeface="+mn-lt"/>
                  <a:cs typeface="Times New Roman" panose="02020603050405020304" pitchFamily="18" charset="0"/>
                </a:rPr>
                <a:t>Fold</a:t>
              </a:r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 on 0)</a:t>
              </a:r>
              <a:endParaRPr lang="it-IT" sz="600" dirty="0">
                <a:latin typeface="+mn-lt"/>
              </a:endParaRPr>
            </a:p>
          </p:txBody>
        </p:sp>
        <p:grpSp>
          <p:nvGrpSpPr>
            <p:cNvPr id="213" name="Gruppo 212">
              <a:extLst>
                <a:ext uri="{FF2B5EF4-FFF2-40B4-BE49-F238E27FC236}">
                  <a16:creationId xmlns:a16="http://schemas.microsoft.com/office/drawing/2014/main" id="{0D9BCF0A-7766-473C-BB3B-9784C3AF6049}"/>
                </a:ext>
              </a:extLst>
            </p:cNvPr>
            <p:cNvGrpSpPr/>
            <p:nvPr/>
          </p:nvGrpSpPr>
          <p:grpSpPr>
            <a:xfrm>
              <a:off x="4742312" y="2158473"/>
              <a:ext cx="527871" cy="184666"/>
              <a:chOff x="726600" y="4418665"/>
              <a:chExt cx="527871" cy="184666"/>
            </a:xfrm>
          </p:grpSpPr>
          <p:sp>
            <p:nvSpPr>
              <p:cNvPr id="232" name="CasellaDiTesto 231">
                <a:extLst>
                  <a:ext uri="{FF2B5EF4-FFF2-40B4-BE49-F238E27FC236}">
                    <a16:creationId xmlns:a16="http://schemas.microsoft.com/office/drawing/2014/main" id="{5969BBF9-677D-46BE-A775-65B9868D1718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233" name="CasellaDiTesto 232">
                <a:extLst>
                  <a:ext uri="{FF2B5EF4-FFF2-40B4-BE49-F238E27FC236}">
                    <a16:creationId xmlns:a16="http://schemas.microsoft.com/office/drawing/2014/main" id="{1BEF739E-7F7A-4E5A-9489-A8FDCCB23094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234" name="CasellaDiTesto 233">
                <a:extLst>
                  <a:ext uri="{FF2B5EF4-FFF2-40B4-BE49-F238E27FC236}">
                    <a16:creationId xmlns:a16="http://schemas.microsoft.com/office/drawing/2014/main" id="{69A2BA7A-4FA8-452C-9840-92768D2C555A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235" name="CasellaDiTesto 234">
                <a:extLst>
                  <a:ext uri="{FF2B5EF4-FFF2-40B4-BE49-F238E27FC236}">
                    <a16:creationId xmlns:a16="http://schemas.microsoft.com/office/drawing/2014/main" id="{61811987-B2C6-4BB9-BE8F-C58CB9D62D7F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grpSp>
          <p:nvGrpSpPr>
            <p:cNvPr id="214" name="Gruppo 213">
              <a:extLst>
                <a:ext uri="{FF2B5EF4-FFF2-40B4-BE49-F238E27FC236}">
                  <a16:creationId xmlns:a16="http://schemas.microsoft.com/office/drawing/2014/main" id="{C2B2AF62-BD0E-4D83-BA63-12E959CC181E}"/>
                </a:ext>
              </a:extLst>
            </p:cNvPr>
            <p:cNvGrpSpPr/>
            <p:nvPr/>
          </p:nvGrpSpPr>
          <p:grpSpPr>
            <a:xfrm>
              <a:off x="5160161" y="2158473"/>
              <a:ext cx="527871" cy="184666"/>
              <a:chOff x="726600" y="4418665"/>
              <a:chExt cx="527871" cy="184666"/>
            </a:xfrm>
          </p:grpSpPr>
          <p:sp>
            <p:nvSpPr>
              <p:cNvPr id="228" name="CasellaDiTesto 227">
                <a:extLst>
                  <a:ext uri="{FF2B5EF4-FFF2-40B4-BE49-F238E27FC236}">
                    <a16:creationId xmlns:a16="http://schemas.microsoft.com/office/drawing/2014/main" id="{C535063A-8A2F-4479-8E9D-DF269790617F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229" name="CasellaDiTesto 228">
                <a:extLst>
                  <a:ext uri="{FF2B5EF4-FFF2-40B4-BE49-F238E27FC236}">
                    <a16:creationId xmlns:a16="http://schemas.microsoft.com/office/drawing/2014/main" id="{C41374ED-FE33-4F73-AD52-447C77EB62F2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230" name="CasellaDiTesto 229">
                <a:extLst>
                  <a:ext uri="{FF2B5EF4-FFF2-40B4-BE49-F238E27FC236}">
                    <a16:creationId xmlns:a16="http://schemas.microsoft.com/office/drawing/2014/main" id="{E5EA3F14-61E3-4F2B-8345-A4FCD548542C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231" name="CasellaDiTesto 230">
                <a:extLst>
                  <a:ext uri="{FF2B5EF4-FFF2-40B4-BE49-F238E27FC236}">
                    <a16:creationId xmlns:a16="http://schemas.microsoft.com/office/drawing/2014/main" id="{DB9B9C4F-8814-4FFA-9404-F1A8FFA7D70B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grpSp>
          <p:nvGrpSpPr>
            <p:cNvPr id="215" name="Gruppo 214">
              <a:extLst>
                <a:ext uri="{FF2B5EF4-FFF2-40B4-BE49-F238E27FC236}">
                  <a16:creationId xmlns:a16="http://schemas.microsoft.com/office/drawing/2014/main" id="{3B5347A3-3895-4053-9A97-1AF4C63337E2}"/>
                </a:ext>
              </a:extLst>
            </p:cNvPr>
            <p:cNvGrpSpPr/>
            <p:nvPr/>
          </p:nvGrpSpPr>
          <p:grpSpPr>
            <a:xfrm>
              <a:off x="5574058" y="2158473"/>
              <a:ext cx="527871" cy="184666"/>
              <a:chOff x="726600" y="4418665"/>
              <a:chExt cx="527871" cy="184666"/>
            </a:xfrm>
          </p:grpSpPr>
          <p:sp>
            <p:nvSpPr>
              <p:cNvPr id="224" name="CasellaDiTesto 223">
                <a:extLst>
                  <a:ext uri="{FF2B5EF4-FFF2-40B4-BE49-F238E27FC236}">
                    <a16:creationId xmlns:a16="http://schemas.microsoft.com/office/drawing/2014/main" id="{F83296F2-7D20-4678-860B-4CF1BCCF92D2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225" name="CasellaDiTesto 224">
                <a:extLst>
                  <a:ext uri="{FF2B5EF4-FFF2-40B4-BE49-F238E27FC236}">
                    <a16:creationId xmlns:a16="http://schemas.microsoft.com/office/drawing/2014/main" id="{BDDDD043-92CC-45A0-90EE-6532296D2148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226" name="CasellaDiTesto 225">
                <a:extLst>
                  <a:ext uri="{FF2B5EF4-FFF2-40B4-BE49-F238E27FC236}">
                    <a16:creationId xmlns:a16="http://schemas.microsoft.com/office/drawing/2014/main" id="{626B1528-B98C-4943-ADE3-10B8089E8D92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227" name="CasellaDiTesto 226">
                <a:extLst>
                  <a:ext uri="{FF2B5EF4-FFF2-40B4-BE49-F238E27FC236}">
                    <a16:creationId xmlns:a16="http://schemas.microsoft.com/office/drawing/2014/main" id="{3C6487EB-2557-463E-A4D1-B58E72BAD37A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cxnSp>
          <p:nvCxnSpPr>
            <p:cNvPr id="216" name="Connettore diritto 215">
              <a:extLst>
                <a:ext uri="{FF2B5EF4-FFF2-40B4-BE49-F238E27FC236}">
                  <a16:creationId xmlns:a16="http://schemas.microsoft.com/office/drawing/2014/main" id="{EFDF0B88-7533-4B70-8629-59C65AB93464}"/>
                </a:ext>
              </a:extLst>
            </p:cNvPr>
            <p:cNvCxnSpPr>
              <a:cxnSpLocks/>
            </p:cNvCxnSpPr>
            <p:nvPr/>
          </p:nvCxnSpPr>
          <p:spPr>
            <a:xfrm>
              <a:off x="4043240" y="232909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7" name="Connettore diritto 216">
              <a:extLst>
                <a:ext uri="{FF2B5EF4-FFF2-40B4-BE49-F238E27FC236}">
                  <a16:creationId xmlns:a16="http://schemas.microsoft.com/office/drawing/2014/main" id="{1A8EF527-1059-4991-A6DD-7FAAA0000B5D}"/>
                </a:ext>
              </a:extLst>
            </p:cNvPr>
            <p:cNvCxnSpPr>
              <a:cxnSpLocks/>
            </p:cNvCxnSpPr>
            <p:nvPr/>
          </p:nvCxnSpPr>
          <p:spPr>
            <a:xfrm>
              <a:off x="4442239" y="232909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8" name="Connettore diritto 217">
              <a:extLst>
                <a:ext uri="{FF2B5EF4-FFF2-40B4-BE49-F238E27FC236}">
                  <a16:creationId xmlns:a16="http://schemas.microsoft.com/office/drawing/2014/main" id="{1D30BC45-C119-4F16-B039-D5F3E4B31BE5}"/>
                </a:ext>
              </a:extLst>
            </p:cNvPr>
            <p:cNvCxnSpPr>
              <a:cxnSpLocks/>
            </p:cNvCxnSpPr>
            <p:nvPr/>
          </p:nvCxnSpPr>
          <p:spPr>
            <a:xfrm>
              <a:off x="4837343" y="232909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9" name="Connettore diritto 218">
              <a:extLst>
                <a:ext uri="{FF2B5EF4-FFF2-40B4-BE49-F238E27FC236}">
                  <a16:creationId xmlns:a16="http://schemas.microsoft.com/office/drawing/2014/main" id="{906D5873-3AC2-44DE-A154-BB8BC823F9A7}"/>
                </a:ext>
              </a:extLst>
            </p:cNvPr>
            <p:cNvCxnSpPr>
              <a:cxnSpLocks/>
            </p:cNvCxnSpPr>
            <p:nvPr/>
          </p:nvCxnSpPr>
          <p:spPr>
            <a:xfrm>
              <a:off x="5261553" y="232909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0" name="Connettore diritto 219">
              <a:extLst>
                <a:ext uri="{FF2B5EF4-FFF2-40B4-BE49-F238E27FC236}">
                  <a16:creationId xmlns:a16="http://schemas.microsoft.com/office/drawing/2014/main" id="{87EB1925-38EE-4C7E-87CF-C179C3E05DD8}"/>
                </a:ext>
              </a:extLst>
            </p:cNvPr>
            <p:cNvCxnSpPr>
              <a:cxnSpLocks/>
            </p:cNvCxnSpPr>
            <p:nvPr/>
          </p:nvCxnSpPr>
          <p:spPr>
            <a:xfrm>
              <a:off x="5676585" y="232909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1" name="CasellaDiTesto 220">
              <a:extLst>
                <a:ext uri="{FF2B5EF4-FFF2-40B4-BE49-F238E27FC236}">
                  <a16:creationId xmlns:a16="http://schemas.microsoft.com/office/drawing/2014/main" id="{7EB92A59-9A25-48F2-8E50-40FFD9945F06}"/>
                </a:ext>
              </a:extLst>
            </p:cNvPr>
            <p:cNvSpPr txBox="1"/>
            <p:nvPr/>
          </p:nvSpPr>
          <p:spPr>
            <a:xfrm>
              <a:off x="3757820" y="1995896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.0</a:t>
              </a:r>
            </a:p>
          </p:txBody>
        </p:sp>
        <p:sp>
          <p:nvSpPr>
            <p:cNvPr id="222" name="CasellaDiTesto 221">
              <a:extLst>
                <a:ext uri="{FF2B5EF4-FFF2-40B4-BE49-F238E27FC236}">
                  <a16:creationId xmlns:a16="http://schemas.microsoft.com/office/drawing/2014/main" id="{10AD58BF-F29E-4D9D-9776-45E9EE689763}"/>
                </a:ext>
              </a:extLst>
            </p:cNvPr>
            <p:cNvSpPr txBox="1"/>
            <p:nvPr/>
          </p:nvSpPr>
          <p:spPr>
            <a:xfrm>
              <a:off x="3757820" y="1332349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.0</a:t>
              </a:r>
            </a:p>
          </p:txBody>
        </p:sp>
        <p:sp>
          <p:nvSpPr>
            <p:cNvPr id="223" name="CasellaDiTesto 222">
              <a:extLst>
                <a:ext uri="{FF2B5EF4-FFF2-40B4-BE49-F238E27FC236}">
                  <a16:creationId xmlns:a16="http://schemas.microsoft.com/office/drawing/2014/main" id="{63C1A13A-1187-45A7-8F13-CAEC2DCA551B}"/>
                </a:ext>
              </a:extLst>
            </p:cNvPr>
            <p:cNvSpPr txBox="1"/>
            <p:nvPr/>
          </p:nvSpPr>
          <p:spPr>
            <a:xfrm>
              <a:off x="3757820" y="665236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2.0</a:t>
              </a:r>
            </a:p>
          </p:txBody>
        </p:sp>
      </p:grpSp>
      <p:grpSp>
        <p:nvGrpSpPr>
          <p:cNvPr id="461" name="Gruppo 460">
            <a:extLst>
              <a:ext uri="{FF2B5EF4-FFF2-40B4-BE49-F238E27FC236}">
                <a16:creationId xmlns:a16="http://schemas.microsoft.com/office/drawing/2014/main" id="{285F1E1E-DCB8-45D5-8AC3-A496EA28909A}"/>
              </a:ext>
            </a:extLst>
          </p:cNvPr>
          <p:cNvGrpSpPr/>
          <p:nvPr/>
        </p:nvGrpSpPr>
        <p:grpSpPr>
          <a:xfrm>
            <a:off x="381285" y="2771800"/>
            <a:ext cx="2535051" cy="1869288"/>
            <a:chOff x="118228" y="4307576"/>
            <a:chExt cx="2535051" cy="1869288"/>
          </a:xfrm>
        </p:grpSpPr>
        <p:pic>
          <p:nvPicPr>
            <p:cNvPr id="458" name="Immagine 457">
              <a:extLst>
                <a:ext uri="{FF2B5EF4-FFF2-40B4-BE49-F238E27FC236}">
                  <a16:creationId xmlns:a16="http://schemas.microsoft.com/office/drawing/2014/main" id="{C7F14180-F08D-4833-A029-4FE3674A534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14240" y="4386213"/>
              <a:ext cx="2133085" cy="1440000"/>
            </a:xfrm>
            <a:prstGeom prst="rect">
              <a:avLst/>
            </a:prstGeom>
          </p:spPr>
        </p:pic>
        <p:sp>
          <p:nvSpPr>
            <p:cNvPr id="376" name="CasellaDiTesto 375">
              <a:extLst>
                <a:ext uri="{FF2B5EF4-FFF2-40B4-BE49-F238E27FC236}">
                  <a16:creationId xmlns:a16="http://schemas.microsoft.com/office/drawing/2014/main" id="{A8B52F98-09C4-4CBF-A45A-15072AEE4EF5}"/>
                </a:ext>
              </a:extLst>
            </p:cNvPr>
            <p:cNvSpPr txBox="1"/>
            <p:nvPr/>
          </p:nvSpPr>
          <p:spPr>
            <a:xfrm>
              <a:off x="530367" y="4372234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/>
                <a:t>MCF-7</a:t>
              </a:r>
            </a:p>
          </p:txBody>
        </p:sp>
        <p:sp>
          <p:nvSpPr>
            <p:cNvPr id="377" name="CasellaDiTesto 376">
              <a:extLst>
                <a:ext uri="{FF2B5EF4-FFF2-40B4-BE49-F238E27FC236}">
                  <a16:creationId xmlns:a16="http://schemas.microsoft.com/office/drawing/2014/main" id="{C7C5A1AB-9240-4743-903D-7C9A6A5130CE}"/>
                </a:ext>
              </a:extLst>
            </p:cNvPr>
            <p:cNvSpPr txBox="1"/>
            <p:nvPr/>
          </p:nvSpPr>
          <p:spPr>
            <a:xfrm>
              <a:off x="2220917" y="5992198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CCT</a:t>
              </a:r>
            </a:p>
          </p:txBody>
        </p:sp>
        <p:grpSp>
          <p:nvGrpSpPr>
            <p:cNvPr id="378" name="Gruppo 377">
              <a:extLst>
                <a:ext uri="{FF2B5EF4-FFF2-40B4-BE49-F238E27FC236}">
                  <a16:creationId xmlns:a16="http://schemas.microsoft.com/office/drawing/2014/main" id="{7AFABCD1-A323-4EC3-8817-FA0E6EAE4132}"/>
                </a:ext>
              </a:extLst>
            </p:cNvPr>
            <p:cNvGrpSpPr/>
            <p:nvPr/>
          </p:nvGrpSpPr>
          <p:grpSpPr>
            <a:xfrm>
              <a:off x="898558" y="5826213"/>
              <a:ext cx="527871" cy="184666"/>
              <a:chOff x="726600" y="4418665"/>
              <a:chExt cx="527871" cy="184666"/>
            </a:xfrm>
          </p:grpSpPr>
          <p:sp>
            <p:nvSpPr>
              <p:cNvPr id="412" name="CasellaDiTesto 411">
                <a:extLst>
                  <a:ext uri="{FF2B5EF4-FFF2-40B4-BE49-F238E27FC236}">
                    <a16:creationId xmlns:a16="http://schemas.microsoft.com/office/drawing/2014/main" id="{9C274B5E-C60C-4FA7-B7EB-714EC117A93F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413" name="CasellaDiTesto 412">
                <a:extLst>
                  <a:ext uri="{FF2B5EF4-FFF2-40B4-BE49-F238E27FC236}">
                    <a16:creationId xmlns:a16="http://schemas.microsoft.com/office/drawing/2014/main" id="{858D76F1-9A5E-4CC6-BFC0-9FB0247659B4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414" name="CasellaDiTesto 413">
                <a:extLst>
                  <a:ext uri="{FF2B5EF4-FFF2-40B4-BE49-F238E27FC236}">
                    <a16:creationId xmlns:a16="http://schemas.microsoft.com/office/drawing/2014/main" id="{FB28EDEC-1FD7-4B40-89C3-704FD0BA0035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415" name="CasellaDiTesto 414">
                <a:extLst>
                  <a:ext uri="{FF2B5EF4-FFF2-40B4-BE49-F238E27FC236}">
                    <a16:creationId xmlns:a16="http://schemas.microsoft.com/office/drawing/2014/main" id="{CFE86D43-B4CA-4B13-B100-8555FDB83F6D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sp>
          <p:nvSpPr>
            <p:cNvPr id="379" name="CasellaDiTesto 378">
              <a:extLst>
                <a:ext uri="{FF2B5EF4-FFF2-40B4-BE49-F238E27FC236}">
                  <a16:creationId xmlns:a16="http://schemas.microsoft.com/office/drawing/2014/main" id="{0AE59FB5-AB75-4A1D-9694-8BE37891FB75}"/>
                </a:ext>
              </a:extLst>
            </p:cNvPr>
            <p:cNvSpPr txBox="1"/>
            <p:nvPr/>
          </p:nvSpPr>
          <p:spPr>
            <a:xfrm>
              <a:off x="1004760" y="5992198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VE</a:t>
              </a:r>
            </a:p>
          </p:txBody>
        </p:sp>
        <p:sp>
          <p:nvSpPr>
            <p:cNvPr id="380" name="CasellaDiTesto 379">
              <a:extLst>
                <a:ext uri="{FF2B5EF4-FFF2-40B4-BE49-F238E27FC236}">
                  <a16:creationId xmlns:a16="http://schemas.microsoft.com/office/drawing/2014/main" id="{9C2F5A91-28F5-4770-9E3A-90238AF0E1F4}"/>
                </a:ext>
              </a:extLst>
            </p:cNvPr>
            <p:cNvSpPr txBox="1"/>
            <p:nvPr/>
          </p:nvSpPr>
          <p:spPr>
            <a:xfrm>
              <a:off x="1388312" y="5992198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KU</a:t>
              </a:r>
            </a:p>
          </p:txBody>
        </p:sp>
        <p:sp>
          <p:nvSpPr>
            <p:cNvPr id="381" name="CasellaDiTesto 380">
              <a:extLst>
                <a:ext uri="{FF2B5EF4-FFF2-40B4-BE49-F238E27FC236}">
                  <a16:creationId xmlns:a16="http://schemas.microsoft.com/office/drawing/2014/main" id="{04585778-E12D-46AB-85BC-08C229899576}"/>
                </a:ext>
              </a:extLst>
            </p:cNvPr>
            <p:cNvSpPr txBox="1"/>
            <p:nvPr/>
          </p:nvSpPr>
          <p:spPr>
            <a:xfrm>
              <a:off x="1812487" y="599219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MK</a:t>
              </a:r>
            </a:p>
          </p:txBody>
        </p:sp>
        <p:grpSp>
          <p:nvGrpSpPr>
            <p:cNvPr id="382" name="Gruppo 381">
              <a:extLst>
                <a:ext uri="{FF2B5EF4-FFF2-40B4-BE49-F238E27FC236}">
                  <a16:creationId xmlns:a16="http://schemas.microsoft.com/office/drawing/2014/main" id="{1C41919A-AD25-4F43-9B9E-C3777CCD260A}"/>
                </a:ext>
              </a:extLst>
            </p:cNvPr>
            <p:cNvGrpSpPr/>
            <p:nvPr/>
          </p:nvGrpSpPr>
          <p:grpSpPr>
            <a:xfrm>
              <a:off x="520811" y="5826213"/>
              <a:ext cx="502435" cy="184666"/>
              <a:chOff x="348853" y="4418665"/>
              <a:chExt cx="502435" cy="184666"/>
            </a:xfrm>
          </p:grpSpPr>
          <p:sp>
            <p:nvSpPr>
              <p:cNvPr id="408" name="CasellaDiTesto 407">
                <a:extLst>
                  <a:ext uri="{FF2B5EF4-FFF2-40B4-BE49-F238E27FC236}">
                    <a16:creationId xmlns:a16="http://schemas.microsoft.com/office/drawing/2014/main" id="{8A4A15DC-C1BF-4B31-AC8B-999BDCE2B9DE}"/>
                  </a:ext>
                </a:extLst>
              </p:cNvPr>
              <p:cNvSpPr txBox="1"/>
              <p:nvPr/>
            </p:nvSpPr>
            <p:spPr>
              <a:xfrm>
                <a:off x="34885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409" name="CasellaDiTesto 408">
                <a:extLst>
                  <a:ext uri="{FF2B5EF4-FFF2-40B4-BE49-F238E27FC236}">
                    <a16:creationId xmlns:a16="http://schemas.microsoft.com/office/drawing/2014/main" id="{A51B961B-9426-4823-92FC-9F0C5C851BCB}"/>
                  </a:ext>
                </a:extLst>
              </p:cNvPr>
              <p:cNvSpPr txBox="1"/>
              <p:nvPr/>
            </p:nvSpPr>
            <p:spPr>
              <a:xfrm>
                <a:off x="433242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  <p:sp>
            <p:nvSpPr>
              <p:cNvPr id="410" name="CasellaDiTesto 409">
                <a:extLst>
                  <a:ext uri="{FF2B5EF4-FFF2-40B4-BE49-F238E27FC236}">
                    <a16:creationId xmlns:a16="http://schemas.microsoft.com/office/drawing/2014/main" id="{9047870A-80A4-41E8-B9F2-F6352540ACAF}"/>
                  </a:ext>
                </a:extLst>
              </p:cNvPr>
              <p:cNvSpPr txBox="1"/>
              <p:nvPr/>
            </p:nvSpPr>
            <p:spPr>
              <a:xfrm>
                <a:off x="517567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5</a:t>
                </a:r>
              </a:p>
            </p:txBody>
          </p:sp>
          <p:sp>
            <p:nvSpPr>
              <p:cNvPr id="411" name="CasellaDiTesto 410">
                <a:extLst>
                  <a:ext uri="{FF2B5EF4-FFF2-40B4-BE49-F238E27FC236}">
                    <a16:creationId xmlns:a16="http://schemas.microsoft.com/office/drawing/2014/main" id="{5156B84E-E031-44F3-A4AE-86C954EDB92C}"/>
                  </a:ext>
                </a:extLst>
              </p:cNvPr>
              <p:cNvSpPr txBox="1"/>
              <p:nvPr/>
            </p:nvSpPr>
            <p:spPr>
              <a:xfrm>
                <a:off x="580060" y="441866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0</a:t>
                </a:r>
              </a:p>
            </p:txBody>
          </p:sp>
        </p:grpSp>
        <p:sp>
          <p:nvSpPr>
            <p:cNvPr id="383" name="CasellaDiTesto 382">
              <a:extLst>
                <a:ext uri="{FF2B5EF4-FFF2-40B4-BE49-F238E27FC236}">
                  <a16:creationId xmlns:a16="http://schemas.microsoft.com/office/drawing/2014/main" id="{3F7C3A61-DCEB-4665-929D-76CF8571F7B2}"/>
                </a:ext>
              </a:extLst>
            </p:cNvPr>
            <p:cNvSpPr txBox="1"/>
            <p:nvPr/>
          </p:nvSpPr>
          <p:spPr>
            <a:xfrm>
              <a:off x="587364" y="5992198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AZD</a:t>
              </a:r>
            </a:p>
          </p:txBody>
        </p:sp>
        <p:sp>
          <p:nvSpPr>
            <p:cNvPr id="384" name="CasellaDiTesto 383">
              <a:extLst>
                <a:ext uri="{FF2B5EF4-FFF2-40B4-BE49-F238E27FC236}">
                  <a16:creationId xmlns:a16="http://schemas.microsoft.com/office/drawing/2014/main" id="{D49FA9D5-2F9A-415E-9B73-BD975FCCD525}"/>
                </a:ext>
              </a:extLst>
            </p:cNvPr>
            <p:cNvSpPr txBox="1"/>
            <p:nvPr/>
          </p:nvSpPr>
          <p:spPr>
            <a:xfrm rot="16200000">
              <a:off x="-56820" y="4944514"/>
              <a:ext cx="6270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RPA2 </a:t>
              </a:r>
              <a:r>
                <a:rPr lang="it-IT" sz="600" dirty="0" err="1">
                  <a:latin typeface="+mn-lt"/>
                  <a:cs typeface="Times New Roman" panose="02020603050405020304" pitchFamily="18" charset="0"/>
                </a:rPr>
                <a:t>levels</a:t>
              </a:r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(</a:t>
              </a:r>
              <a:r>
                <a:rPr lang="it-IT" sz="600" dirty="0" err="1">
                  <a:latin typeface="+mn-lt"/>
                  <a:cs typeface="Times New Roman" panose="02020603050405020304" pitchFamily="18" charset="0"/>
                </a:rPr>
                <a:t>Fold</a:t>
              </a:r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 on 0)</a:t>
              </a:r>
              <a:endParaRPr lang="it-IT" sz="600" dirty="0">
                <a:latin typeface="+mn-lt"/>
              </a:endParaRPr>
            </a:p>
          </p:txBody>
        </p:sp>
        <p:grpSp>
          <p:nvGrpSpPr>
            <p:cNvPr id="385" name="Gruppo 384">
              <a:extLst>
                <a:ext uri="{FF2B5EF4-FFF2-40B4-BE49-F238E27FC236}">
                  <a16:creationId xmlns:a16="http://schemas.microsoft.com/office/drawing/2014/main" id="{7BD2FABF-A86E-4C26-87C8-2038B8FB49CB}"/>
                </a:ext>
              </a:extLst>
            </p:cNvPr>
            <p:cNvGrpSpPr/>
            <p:nvPr/>
          </p:nvGrpSpPr>
          <p:grpSpPr>
            <a:xfrm>
              <a:off x="1293662" y="5826213"/>
              <a:ext cx="527871" cy="184666"/>
              <a:chOff x="726600" y="4418665"/>
              <a:chExt cx="527871" cy="184666"/>
            </a:xfrm>
          </p:grpSpPr>
          <p:sp>
            <p:nvSpPr>
              <p:cNvPr id="404" name="CasellaDiTesto 403">
                <a:extLst>
                  <a:ext uri="{FF2B5EF4-FFF2-40B4-BE49-F238E27FC236}">
                    <a16:creationId xmlns:a16="http://schemas.microsoft.com/office/drawing/2014/main" id="{A5A8FAAA-E879-4C9B-BC35-1EF35FCBAED2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405" name="CasellaDiTesto 404">
                <a:extLst>
                  <a:ext uri="{FF2B5EF4-FFF2-40B4-BE49-F238E27FC236}">
                    <a16:creationId xmlns:a16="http://schemas.microsoft.com/office/drawing/2014/main" id="{C6E7D5B6-BE12-4C5B-A29E-B709B55A7332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406" name="CasellaDiTesto 405">
                <a:extLst>
                  <a:ext uri="{FF2B5EF4-FFF2-40B4-BE49-F238E27FC236}">
                    <a16:creationId xmlns:a16="http://schemas.microsoft.com/office/drawing/2014/main" id="{FE573CB3-AEEA-4CAB-A87E-B2876F9B196E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407" name="CasellaDiTesto 406">
                <a:extLst>
                  <a:ext uri="{FF2B5EF4-FFF2-40B4-BE49-F238E27FC236}">
                    <a16:creationId xmlns:a16="http://schemas.microsoft.com/office/drawing/2014/main" id="{6819A1D6-EF0C-46AE-8426-0A2C07975818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grpSp>
          <p:nvGrpSpPr>
            <p:cNvPr id="386" name="Gruppo 385">
              <a:extLst>
                <a:ext uri="{FF2B5EF4-FFF2-40B4-BE49-F238E27FC236}">
                  <a16:creationId xmlns:a16="http://schemas.microsoft.com/office/drawing/2014/main" id="{69C4BF2C-4743-45F0-95B6-C03A9AFDD4EB}"/>
                </a:ext>
              </a:extLst>
            </p:cNvPr>
            <p:cNvGrpSpPr/>
            <p:nvPr/>
          </p:nvGrpSpPr>
          <p:grpSpPr>
            <a:xfrm>
              <a:off x="1711511" y="5826213"/>
              <a:ext cx="527871" cy="184666"/>
              <a:chOff x="726600" y="4418665"/>
              <a:chExt cx="527871" cy="184666"/>
            </a:xfrm>
          </p:grpSpPr>
          <p:sp>
            <p:nvSpPr>
              <p:cNvPr id="400" name="CasellaDiTesto 399">
                <a:extLst>
                  <a:ext uri="{FF2B5EF4-FFF2-40B4-BE49-F238E27FC236}">
                    <a16:creationId xmlns:a16="http://schemas.microsoft.com/office/drawing/2014/main" id="{7424BBC2-3B2C-466D-B968-EEAC604B384B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401" name="CasellaDiTesto 400">
                <a:extLst>
                  <a:ext uri="{FF2B5EF4-FFF2-40B4-BE49-F238E27FC236}">
                    <a16:creationId xmlns:a16="http://schemas.microsoft.com/office/drawing/2014/main" id="{4C05B479-6BC8-495C-9371-94D43CE4FC2D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402" name="CasellaDiTesto 401">
                <a:extLst>
                  <a:ext uri="{FF2B5EF4-FFF2-40B4-BE49-F238E27FC236}">
                    <a16:creationId xmlns:a16="http://schemas.microsoft.com/office/drawing/2014/main" id="{0A1AB195-7DCF-46E5-A1A3-D69F39DF3FF1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403" name="CasellaDiTesto 402">
                <a:extLst>
                  <a:ext uri="{FF2B5EF4-FFF2-40B4-BE49-F238E27FC236}">
                    <a16:creationId xmlns:a16="http://schemas.microsoft.com/office/drawing/2014/main" id="{618384D8-7A7E-47F6-834B-656734A88EE9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grpSp>
          <p:nvGrpSpPr>
            <p:cNvPr id="387" name="Gruppo 386">
              <a:extLst>
                <a:ext uri="{FF2B5EF4-FFF2-40B4-BE49-F238E27FC236}">
                  <a16:creationId xmlns:a16="http://schemas.microsoft.com/office/drawing/2014/main" id="{6DB79177-2D20-4070-A44E-59CA63588AB1}"/>
                </a:ext>
              </a:extLst>
            </p:cNvPr>
            <p:cNvGrpSpPr/>
            <p:nvPr/>
          </p:nvGrpSpPr>
          <p:grpSpPr>
            <a:xfrm>
              <a:off x="2125408" y="5826213"/>
              <a:ext cx="527871" cy="184666"/>
              <a:chOff x="726600" y="4418665"/>
              <a:chExt cx="527871" cy="184666"/>
            </a:xfrm>
          </p:grpSpPr>
          <p:sp>
            <p:nvSpPr>
              <p:cNvPr id="396" name="CasellaDiTesto 395">
                <a:extLst>
                  <a:ext uri="{FF2B5EF4-FFF2-40B4-BE49-F238E27FC236}">
                    <a16:creationId xmlns:a16="http://schemas.microsoft.com/office/drawing/2014/main" id="{BE9DC756-BBBD-4A87-A5E5-65387D04F818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397" name="CasellaDiTesto 396">
                <a:extLst>
                  <a:ext uri="{FF2B5EF4-FFF2-40B4-BE49-F238E27FC236}">
                    <a16:creationId xmlns:a16="http://schemas.microsoft.com/office/drawing/2014/main" id="{7D442AA9-E578-45BC-89B2-4F34C3855AD0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398" name="CasellaDiTesto 397">
                <a:extLst>
                  <a:ext uri="{FF2B5EF4-FFF2-40B4-BE49-F238E27FC236}">
                    <a16:creationId xmlns:a16="http://schemas.microsoft.com/office/drawing/2014/main" id="{5D7024A6-BFAC-443C-B128-0424287CD518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399" name="CasellaDiTesto 398">
                <a:extLst>
                  <a:ext uri="{FF2B5EF4-FFF2-40B4-BE49-F238E27FC236}">
                    <a16:creationId xmlns:a16="http://schemas.microsoft.com/office/drawing/2014/main" id="{57A15FCD-B8DD-4973-816C-6337C1509201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cxnSp>
          <p:nvCxnSpPr>
            <p:cNvPr id="388" name="Connettore diritto 387">
              <a:extLst>
                <a:ext uri="{FF2B5EF4-FFF2-40B4-BE49-F238E27FC236}">
                  <a16:creationId xmlns:a16="http://schemas.microsoft.com/office/drawing/2014/main" id="{B9F8DBB9-3159-436A-B615-7447AC1E03F2}"/>
                </a:ext>
              </a:extLst>
            </p:cNvPr>
            <p:cNvCxnSpPr>
              <a:cxnSpLocks/>
            </p:cNvCxnSpPr>
            <p:nvPr/>
          </p:nvCxnSpPr>
          <p:spPr>
            <a:xfrm>
              <a:off x="594590" y="599683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9" name="Connettore diritto 388">
              <a:extLst>
                <a:ext uri="{FF2B5EF4-FFF2-40B4-BE49-F238E27FC236}">
                  <a16:creationId xmlns:a16="http://schemas.microsoft.com/office/drawing/2014/main" id="{B8B25AA3-2AE6-483F-B0FA-A8B8CF26D0D4}"/>
                </a:ext>
              </a:extLst>
            </p:cNvPr>
            <p:cNvCxnSpPr>
              <a:cxnSpLocks/>
            </p:cNvCxnSpPr>
            <p:nvPr/>
          </p:nvCxnSpPr>
          <p:spPr>
            <a:xfrm>
              <a:off x="993589" y="599683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0" name="Connettore diritto 389">
              <a:extLst>
                <a:ext uri="{FF2B5EF4-FFF2-40B4-BE49-F238E27FC236}">
                  <a16:creationId xmlns:a16="http://schemas.microsoft.com/office/drawing/2014/main" id="{C7D4D7EB-A9B0-4FCF-B532-E5FDA2E01E31}"/>
                </a:ext>
              </a:extLst>
            </p:cNvPr>
            <p:cNvCxnSpPr>
              <a:cxnSpLocks/>
            </p:cNvCxnSpPr>
            <p:nvPr/>
          </p:nvCxnSpPr>
          <p:spPr>
            <a:xfrm>
              <a:off x="1388693" y="599683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1" name="Connettore diritto 390">
              <a:extLst>
                <a:ext uri="{FF2B5EF4-FFF2-40B4-BE49-F238E27FC236}">
                  <a16:creationId xmlns:a16="http://schemas.microsoft.com/office/drawing/2014/main" id="{702C9B1D-F48F-4807-B10D-902AC60CF86B}"/>
                </a:ext>
              </a:extLst>
            </p:cNvPr>
            <p:cNvCxnSpPr>
              <a:cxnSpLocks/>
            </p:cNvCxnSpPr>
            <p:nvPr/>
          </p:nvCxnSpPr>
          <p:spPr>
            <a:xfrm>
              <a:off x="1812903" y="599683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2" name="Connettore diritto 391">
              <a:extLst>
                <a:ext uri="{FF2B5EF4-FFF2-40B4-BE49-F238E27FC236}">
                  <a16:creationId xmlns:a16="http://schemas.microsoft.com/office/drawing/2014/main" id="{1A3759DB-0423-4EC9-AA08-C4FCB201D2E8}"/>
                </a:ext>
              </a:extLst>
            </p:cNvPr>
            <p:cNvCxnSpPr>
              <a:cxnSpLocks/>
            </p:cNvCxnSpPr>
            <p:nvPr/>
          </p:nvCxnSpPr>
          <p:spPr>
            <a:xfrm>
              <a:off x="2227935" y="599683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3" name="CasellaDiTesto 392">
              <a:extLst>
                <a:ext uri="{FF2B5EF4-FFF2-40B4-BE49-F238E27FC236}">
                  <a16:creationId xmlns:a16="http://schemas.microsoft.com/office/drawing/2014/main" id="{EC7356E7-3F31-42F1-8844-9E7483C33EFF}"/>
                </a:ext>
              </a:extLst>
            </p:cNvPr>
            <p:cNvSpPr txBox="1"/>
            <p:nvPr/>
          </p:nvSpPr>
          <p:spPr>
            <a:xfrm>
              <a:off x="309170" y="5663636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.0</a:t>
              </a:r>
            </a:p>
          </p:txBody>
        </p:sp>
        <p:sp>
          <p:nvSpPr>
            <p:cNvPr id="394" name="CasellaDiTesto 393">
              <a:extLst>
                <a:ext uri="{FF2B5EF4-FFF2-40B4-BE49-F238E27FC236}">
                  <a16:creationId xmlns:a16="http://schemas.microsoft.com/office/drawing/2014/main" id="{7253161A-8CAA-4A18-BD49-A1D2EF9BADF9}"/>
                </a:ext>
              </a:extLst>
            </p:cNvPr>
            <p:cNvSpPr txBox="1"/>
            <p:nvPr/>
          </p:nvSpPr>
          <p:spPr>
            <a:xfrm>
              <a:off x="309170" y="4974689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4.0</a:t>
              </a:r>
            </a:p>
          </p:txBody>
        </p:sp>
        <p:sp>
          <p:nvSpPr>
            <p:cNvPr id="395" name="CasellaDiTesto 394">
              <a:extLst>
                <a:ext uri="{FF2B5EF4-FFF2-40B4-BE49-F238E27FC236}">
                  <a16:creationId xmlns:a16="http://schemas.microsoft.com/office/drawing/2014/main" id="{D7022A56-3782-4607-8D16-9B45DDE139E7}"/>
                </a:ext>
              </a:extLst>
            </p:cNvPr>
            <p:cNvSpPr txBox="1"/>
            <p:nvPr/>
          </p:nvSpPr>
          <p:spPr>
            <a:xfrm>
              <a:off x="309170" y="4307576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8.0</a:t>
              </a:r>
            </a:p>
          </p:txBody>
        </p:sp>
      </p:grpSp>
      <p:grpSp>
        <p:nvGrpSpPr>
          <p:cNvPr id="460" name="Gruppo 459">
            <a:extLst>
              <a:ext uri="{FF2B5EF4-FFF2-40B4-BE49-F238E27FC236}">
                <a16:creationId xmlns:a16="http://schemas.microsoft.com/office/drawing/2014/main" id="{57E43942-19F4-4E34-AD4D-9B0CDDFF5BF2}"/>
              </a:ext>
            </a:extLst>
          </p:cNvPr>
          <p:cNvGrpSpPr/>
          <p:nvPr/>
        </p:nvGrpSpPr>
        <p:grpSpPr>
          <a:xfrm>
            <a:off x="3722898" y="2773070"/>
            <a:ext cx="2535052" cy="1866748"/>
            <a:chOff x="3562824" y="4310116"/>
            <a:chExt cx="2535052" cy="1866748"/>
          </a:xfrm>
        </p:grpSpPr>
        <p:pic>
          <p:nvPicPr>
            <p:cNvPr id="459" name="Immagine 458">
              <a:extLst>
                <a:ext uri="{FF2B5EF4-FFF2-40B4-BE49-F238E27FC236}">
                  <a16:creationId xmlns:a16="http://schemas.microsoft.com/office/drawing/2014/main" id="{5B0A417C-33A7-44B4-B6F2-C0026405D4A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958837" y="4386213"/>
              <a:ext cx="2093333" cy="1440000"/>
            </a:xfrm>
            <a:prstGeom prst="rect">
              <a:avLst/>
            </a:prstGeom>
          </p:spPr>
        </p:pic>
        <p:sp>
          <p:nvSpPr>
            <p:cNvPr id="418" name="CasellaDiTesto 417">
              <a:extLst>
                <a:ext uri="{FF2B5EF4-FFF2-40B4-BE49-F238E27FC236}">
                  <a16:creationId xmlns:a16="http://schemas.microsoft.com/office/drawing/2014/main" id="{3C9AB41C-963D-4F49-BD5F-33E32669E337}"/>
                </a:ext>
              </a:extLst>
            </p:cNvPr>
            <p:cNvSpPr txBox="1"/>
            <p:nvPr/>
          </p:nvSpPr>
          <p:spPr>
            <a:xfrm>
              <a:off x="3974964" y="4372234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/>
                <a:t>Y537S</a:t>
              </a:r>
            </a:p>
          </p:txBody>
        </p:sp>
        <p:sp>
          <p:nvSpPr>
            <p:cNvPr id="419" name="CasellaDiTesto 418">
              <a:extLst>
                <a:ext uri="{FF2B5EF4-FFF2-40B4-BE49-F238E27FC236}">
                  <a16:creationId xmlns:a16="http://schemas.microsoft.com/office/drawing/2014/main" id="{E05755A4-D715-40B8-BF1E-DB25FC65F5FE}"/>
                </a:ext>
              </a:extLst>
            </p:cNvPr>
            <p:cNvSpPr txBox="1"/>
            <p:nvPr/>
          </p:nvSpPr>
          <p:spPr>
            <a:xfrm>
              <a:off x="5665514" y="5992198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CCT</a:t>
              </a:r>
            </a:p>
          </p:txBody>
        </p:sp>
        <p:grpSp>
          <p:nvGrpSpPr>
            <p:cNvPr id="420" name="Gruppo 419">
              <a:extLst>
                <a:ext uri="{FF2B5EF4-FFF2-40B4-BE49-F238E27FC236}">
                  <a16:creationId xmlns:a16="http://schemas.microsoft.com/office/drawing/2014/main" id="{6367D3C3-6493-4C3C-A4DE-22091D5EA330}"/>
                </a:ext>
              </a:extLst>
            </p:cNvPr>
            <p:cNvGrpSpPr/>
            <p:nvPr/>
          </p:nvGrpSpPr>
          <p:grpSpPr>
            <a:xfrm>
              <a:off x="4343155" y="5826213"/>
              <a:ext cx="527871" cy="184666"/>
              <a:chOff x="726600" y="4418665"/>
              <a:chExt cx="527871" cy="184666"/>
            </a:xfrm>
          </p:grpSpPr>
          <p:sp>
            <p:nvSpPr>
              <p:cNvPr id="454" name="CasellaDiTesto 453">
                <a:extLst>
                  <a:ext uri="{FF2B5EF4-FFF2-40B4-BE49-F238E27FC236}">
                    <a16:creationId xmlns:a16="http://schemas.microsoft.com/office/drawing/2014/main" id="{5750FD1E-C70F-46BA-90A7-506B9CDDBDC8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455" name="CasellaDiTesto 454">
                <a:extLst>
                  <a:ext uri="{FF2B5EF4-FFF2-40B4-BE49-F238E27FC236}">
                    <a16:creationId xmlns:a16="http://schemas.microsoft.com/office/drawing/2014/main" id="{B54023EE-575F-4940-8D63-241D5E2065DF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456" name="CasellaDiTesto 455">
                <a:extLst>
                  <a:ext uri="{FF2B5EF4-FFF2-40B4-BE49-F238E27FC236}">
                    <a16:creationId xmlns:a16="http://schemas.microsoft.com/office/drawing/2014/main" id="{87165669-A65C-412F-B25E-8849E3FD8D38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457" name="CasellaDiTesto 456">
                <a:extLst>
                  <a:ext uri="{FF2B5EF4-FFF2-40B4-BE49-F238E27FC236}">
                    <a16:creationId xmlns:a16="http://schemas.microsoft.com/office/drawing/2014/main" id="{78D52EA7-A821-43AB-ABD2-091A697B20DE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sp>
          <p:nvSpPr>
            <p:cNvPr id="421" name="CasellaDiTesto 420">
              <a:extLst>
                <a:ext uri="{FF2B5EF4-FFF2-40B4-BE49-F238E27FC236}">
                  <a16:creationId xmlns:a16="http://schemas.microsoft.com/office/drawing/2014/main" id="{9385303F-B05C-48FB-B915-F4400DBBA58C}"/>
                </a:ext>
              </a:extLst>
            </p:cNvPr>
            <p:cNvSpPr txBox="1"/>
            <p:nvPr/>
          </p:nvSpPr>
          <p:spPr>
            <a:xfrm>
              <a:off x="4449357" y="5992198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VE</a:t>
              </a:r>
            </a:p>
          </p:txBody>
        </p:sp>
        <p:sp>
          <p:nvSpPr>
            <p:cNvPr id="422" name="CasellaDiTesto 421">
              <a:extLst>
                <a:ext uri="{FF2B5EF4-FFF2-40B4-BE49-F238E27FC236}">
                  <a16:creationId xmlns:a16="http://schemas.microsoft.com/office/drawing/2014/main" id="{419CDAD8-4810-458D-BA9D-3BD75EA1C1FC}"/>
                </a:ext>
              </a:extLst>
            </p:cNvPr>
            <p:cNvSpPr txBox="1"/>
            <p:nvPr/>
          </p:nvSpPr>
          <p:spPr>
            <a:xfrm>
              <a:off x="4832909" y="5992198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KU</a:t>
              </a:r>
            </a:p>
          </p:txBody>
        </p:sp>
        <p:sp>
          <p:nvSpPr>
            <p:cNvPr id="423" name="CasellaDiTesto 422">
              <a:extLst>
                <a:ext uri="{FF2B5EF4-FFF2-40B4-BE49-F238E27FC236}">
                  <a16:creationId xmlns:a16="http://schemas.microsoft.com/office/drawing/2014/main" id="{8C4C1BB4-3696-4899-B78A-D69A04CCF05C}"/>
                </a:ext>
              </a:extLst>
            </p:cNvPr>
            <p:cNvSpPr txBox="1"/>
            <p:nvPr/>
          </p:nvSpPr>
          <p:spPr>
            <a:xfrm>
              <a:off x="5257084" y="599219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MK</a:t>
              </a:r>
            </a:p>
          </p:txBody>
        </p:sp>
        <p:grpSp>
          <p:nvGrpSpPr>
            <p:cNvPr id="424" name="Gruppo 423">
              <a:extLst>
                <a:ext uri="{FF2B5EF4-FFF2-40B4-BE49-F238E27FC236}">
                  <a16:creationId xmlns:a16="http://schemas.microsoft.com/office/drawing/2014/main" id="{A01E6003-EF7A-49E9-8224-C16A6D58C197}"/>
                </a:ext>
              </a:extLst>
            </p:cNvPr>
            <p:cNvGrpSpPr/>
            <p:nvPr/>
          </p:nvGrpSpPr>
          <p:grpSpPr>
            <a:xfrm>
              <a:off x="3965408" y="5826213"/>
              <a:ext cx="502435" cy="184666"/>
              <a:chOff x="348853" y="4418665"/>
              <a:chExt cx="502435" cy="184666"/>
            </a:xfrm>
          </p:grpSpPr>
          <p:sp>
            <p:nvSpPr>
              <p:cNvPr id="450" name="CasellaDiTesto 449">
                <a:extLst>
                  <a:ext uri="{FF2B5EF4-FFF2-40B4-BE49-F238E27FC236}">
                    <a16:creationId xmlns:a16="http://schemas.microsoft.com/office/drawing/2014/main" id="{E76D6965-4747-427A-B14C-63DCF0DB3027}"/>
                  </a:ext>
                </a:extLst>
              </p:cNvPr>
              <p:cNvSpPr txBox="1"/>
              <p:nvPr/>
            </p:nvSpPr>
            <p:spPr>
              <a:xfrm>
                <a:off x="34885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451" name="CasellaDiTesto 450">
                <a:extLst>
                  <a:ext uri="{FF2B5EF4-FFF2-40B4-BE49-F238E27FC236}">
                    <a16:creationId xmlns:a16="http://schemas.microsoft.com/office/drawing/2014/main" id="{163A034F-D7E0-48EF-8314-A6A3611A2CDA}"/>
                  </a:ext>
                </a:extLst>
              </p:cNvPr>
              <p:cNvSpPr txBox="1"/>
              <p:nvPr/>
            </p:nvSpPr>
            <p:spPr>
              <a:xfrm>
                <a:off x="433242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  <p:sp>
            <p:nvSpPr>
              <p:cNvPr id="452" name="CasellaDiTesto 451">
                <a:extLst>
                  <a:ext uri="{FF2B5EF4-FFF2-40B4-BE49-F238E27FC236}">
                    <a16:creationId xmlns:a16="http://schemas.microsoft.com/office/drawing/2014/main" id="{771FA0C3-DF6C-49BF-ACA2-69309BC6DE04}"/>
                  </a:ext>
                </a:extLst>
              </p:cNvPr>
              <p:cNvSpPr txBox="1"/>
              <p:nvPr/>
            </p:nvSpPr>
            <p:spPr>
              <a:xfrm>
                <a:off x="517567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5</a:t>
                </a:r>
              </a:p>
            </p:txBody>
          </p:sp>
          <p:sp>
            <p:nvSpPr>
              <p:cNvPr id="453" name="CasellaDiTesto 452">
                <a:extLst>
                  <a:ext uri="{FF2B5EF4-FFF2-40B4-BE49-F238E27FC236}">
                    <a16:creationId xmlns:a16="http://schemas.microsoft.com/office/drawing/2014/main" id="{F6E3E440-FB13-436A-B77C-1A489F5A8496}"/>
                  </a:ext>
                </a:extLst>
              </p:cNvPr>
              <p:cNvSpPr txBox="1"/>
              <p:nvPr/>
            </p:nvSpPr>
            <p:spPr>
              <a:xfrm>
                <a:off x="580060" y="441866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0</a:t>
                </a:r>
              </a:p>
            </p:txBody>
          </p:sp>
        </p:grpSp>
        <p:sp>
          <p:nvSpPr>
            <p:cNvPr id="425" name="CasellaDiTesto 424">
              <a:extLst>
                <a:ext uri="{FF2B5EF4-FFF2-40B4-BE49-F238E27FC236}">
                  <a16:creationId xmlns:a16="http://schemas.microsoft.com/office/drawing/2014/main" id="{36F02D1A-90E3-4F4E-9723-F4C9850B4079}"/>
                </a:ext>
              </a:extLst>
            </p:cNvPr>
            <p:cNvSpPr txBox="1"/>
            <p:nvPr/>
          </p:nvSpPr>
          <p:spPr>
            <a:xfrm>
              <a:off x="4031961" y="5992198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AZD</a:t>
              </a:r>
            </a:p>
          </p:txBody>
        </p:sp>
        <p:sp>
          <p:nvSpPr>
            <p:cNvPr id="426" name="CasellaDiTesto 425">
              <a:extLst>
                <a:ext uri="{FF2B5EF4-FFF2-40B4-BE49-F238E27FC236}">
                  <a16:creationId xmlns:a16="http://schemas.microsoft.com/office/drawing/2014/main" id="{A7955280-9A07-4693-896A-91CC6805293D}"/>
                </a:ext>
              </a:extLst>
            </p:cNvPr>
            <p:cNvSpPr txBox="1"/>
            <p:nvPr/>
          </p:nvSpPr>
          <p:spPr>
            <a:xfrm rot="16200000">
              <a:off x="3388578" y="4944514"/>
              <a:ext cx="6254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/>
                <a:t>RPA2</a:t>
              </a:r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600" dirty="0" err="1">
                  <a:latin typeface="+mn-lt"/>
                  <a:cs typeface="Times New Roman" panose="02020603050405020304" pitchFamily="18" charset="0"/>
                </a:rPr>
                <a:t>levels</a:t>
              </a:r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(</a:t>
              </a:r>
              <a:r>
                <a:rPr lang="it-IT" sz="600" dirty="0" err="1">
                  <a:latin typeface="+mn-lt"/>
                  <a:cs typeface="Times New Roman" panose="02020603050405020304" pitchFamily="18" charset="0"/>
                </a:rPr>
                <a:t>Fold</a:t>
              </a:r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 on 0)</a:t>
              </a:r>
              <a:endParaRPr lang="it-IT" sz="600" dirty="0">
                <a:latin typeface="+mn-lt"/>
              </a:endParaRPr>
            </a:p>
          </p:txBody>
        </p:sp>
        <p:grpSp>
          <p:nvGrpSpPr>
            <p:cNvPr id="427" name="Gruppo 426">
              <a:extLst>
                <a:ext uri="{FF2B5EF4-FFF2-40B4-BE49-F238E27FC236}">
                  <a16:creationId xmlns:a16="http://schemas.microsoft.com/office/drawing/2014/main" id="{900B9610-FF80-4CC8-ADAE-8BAA21072E37}"/>
                </a:ext>
              </a:extLst>
            </p:cNvPr>
            <p:cNvGrpSpPr/>
            <p:nvPr/>
          </p:nvGrpSpPr>
          <p:grpSpPr>
            <a:xfrm>
              <a:off x="4738259" y="5826213"/>
              <a:ext cx="527871" cy="184666"/>
              <a:chOff x="726600" y="4418665"/>
              <a:chExt cx="527871" cy="184666"/>
            </a:xfrm>
          </p:grpSpPr>
          <p:sp>
            <p:nvSpPr>
              <p:cNvPr id="446" name="CasellaDiTesto 445">
                <a:extLst>
                  <a:ext uri="{FF2B5EF4-FFF2-40B4-BE49-F238E27FC236}">
                    <a16:creationId xmlns:a16="http://schemas.microsoft.com/office/drawing/2014/main" id="{95153423-3A62-498B-B9B7-451D8F3B24DD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447" name="CasellaDiTesto 446">
                <a:extLst>
                  <a:ext uri="{FF2B5EF4-FFF2-40B4-BE49-F238E27FC236}">
                    <a16:creationId xmlns:a16="http://schemas.microsoft.com/office/drawing/2014/main" id="{22BC765E-C743-4D86-89AB-A66155B1620D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448" name="CasellaDiTesto 447">
                <a:extLst>
                  <a:ext uri="{FF2B5EF4-FFF2-40B4-BE49-F238E27FC236}">
                    <a16:creationId xmlns:a16="http://schemas.microsoft.com/office/drawing/2014/main" id="{0D04E2F6-B50B-47DE-8C72-7CADC51632A4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449" name="CasellaDiTesto 448">
                <a:extLst>
                  <a:ext uri="{FF2B5EF4-FFF2-40B4-BE49-F238E27FC236}">
                    <a16:creationId xmlns:a16="http://schemas.microsoft.com/office/drawing/2014/main" id="{A12EDF2E-08E3-41B0-885D-82332271A806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grpSp>
          <p:nvGrpSpPr>
            <p:cNvPr id="428" name="Gruppo 427">
              <a:extLst>
                <a:ext uri="{FF2B5EF4-FFF2-40B4-BE49-F238E27FC236}">
                  <a16:creationId xmlns:a16="http://schemas.microsoft.com/office/drawing/2014/main" id="{380DE152-CA35-499F-A824-05425B6BA156}"/>
                </a:ext>
              </a:extLst>
            </p:cNvPr>
            <p:cNvGrpSpPr/>
            <p:nvPr/>
          </p:nvGrpSpPr>
          <p:grpSpPr>
            <a:xfrm>
              <a:off x="5156108" y="5826213"/>
              <a:ext cx="527871" cy="184666"/>
              <a:chOff x="726600" y="4418665"/>
              <a:chExt cx="527871" cy="184666"/>
            </a:xfrm>
          </p:grpSpPr>
          <p:sp>
            <p:nvSpPr>
              <p:cNvPr id="442" name="CasellaDiTesto 441">
                <a:extLst>
                  <a:ext uri="{FF2B5EF4-FFF2-40B4-BE49-F238E27FC236}">
                    <a16:creationId xmlns:a16="http://schemas.microsoft.com/office/drawing/2014/main" id="{BFB2C689-173D-40FE-8CF3-5F71F359734B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443" name="CasellaDiTesto 442">
                <a:extLst>
                  <a:ext uri="{FF2B5EF4-FFF2-40B4-BE49-F238E27FC236}">
                    <a16:creationId xmlns:a16="http://schemas.microsoft.com/office/drawing/2014/main" id="{808E9B6E-CA33-42A7-A256-9A8163B77568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444" name="CasellaDiTesto 443">
                <a:extLst>
                  <a:ext uri="{FF2B5EF4-FFF2-40B4-BE49-F238E27FC236}">
                    <a16:creationId xmlns:a16="http://schemas.microsoft.com/office/drawing/2014/main" id="{65BEC701-7FA9-45A9-88AD-2A7230B37A8E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445" name="CasellaDiTesto 444">
                <a:extLst>
                  <a:ext uri="{FF2B5EF4-FFF2-40B4-BE49-F238E27FC236}">
                    <a16:creationId xmlns:a16="http://schemas.microsoft.com/office/drawing/2014/main" id="{10379524-05F6-49AD-9BDD-291D49F7A0D2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grpSp>
          <p:nvGrpSpPr>
            <p:cNvPr id="429" name="Gruppo 428">
              <a:extLst>
                <a:ext uri="{FF2B5EF4-FFF2-40B4-BE49-F238E27FC236}">
                  <a16:creationId xmlns:a16="http://schemas.microsoft.com/office/drawing/2014/main" id="{DE6A3C93-28A1-4AFB-9A13-2230821C3A60}"/>
                </a:ext>
              </a:extLst>
            </p:cNvPr>
            <p:cNvGrpSpPr/>
            <p:nvPr/>
          </p:nvGrpSpPr>
          <p:grpSpPr>
            <a:xfrm>
              <a:off x="5570005" y="5826213"/>
              <a:ext cx="527871" cy="184666"/>
              <a:chOff x="726600" y="4418665"/>
              <a:chExt cx="527871" cy="184666"/>
            </a:xfrm>
          </p:grpSpPr>
          <p:sp>
            <p:nvSpPr>
              <p:cNvPr id="438" name="CasellaDiTesto 437">
                <a:extLst>
                  <a:ext uri="{FF2B5EF4-FFF2-40B4-BE49-F238E27FC236}">
                    <a16:creationId xmlns:a16="http://schemas.microsoft.com/office/drawing/2014/main" id="{291BF666-5C36-4AAF-821E-E5675270F960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439" name="CasellaDiTesto 438">
                <a:extLst>
                  <a:ext uri="{FF2B5EF4-FFF2-40B4-BE49-F238E27FC236}">
                    <a16:creationId xmlns:a16="http://schemas.microsoft.com/office/drawing/2014/main" id="{FFD145BB-E989-4EFF-8D2C-B272BAE54090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440" name="CasellaDiTesto 439">
                <a:extLst>
                  <a:ext uri="{FF2B5EF4-FFF2-40B4-BE49-F238E27FC236}">
                    <a16:creationId xmlns:a16="http://schemas.microsoft.com/office/drawing/2014/main" id="{4C27F1BE-FA5A-4858-8FDF-36DF9B379313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441" name="CasellaDiTesto 440">
                <a:extLst>
                  <a:ext uri="{FF2B5EF4-FFF2-40B4-BE49-F238E27FC236}">
                    <a16:creationId xmlns:a16="http://schemas.microsoft.com/office/drawing/2014/main" id="{11DC2B6C-2B97-4F9C-A4DF-8CB05CB8EE19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cxnSp>
          <p:nvCxnSpPr>
            <p:cNvPr id="430" name="Connettore diritto 429">
              <a:extLst>
                <a:ext uri="{FF2B5EF4-FFF2-40B4-BE49-F238E27FC236}">
                  <a16:creationId xmlns:a16="http://schemas.microsoft.com/office/drawing/2014/main" id="{EE7BF5F5-393C-4EC0-824C-ED9FC3E6CC0B}"/>
                </a:ext>
              </a:extLst>
            </p:cNvPr>
            <p:cNvCxnSpPr>
              <a:cxnSpLocks/>
            </p:cNvCxnSpPr>
            <p:nvPr/>
          </p:nvCxnSpPr>
          <p:spPr>
            <a:xfrm>
              <a:off x="4039187" y="599683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1" name="Connettore diritto 430">
              <a:extLst>
                <a:ext uri="{FF2B5EF4-FFF2-40B4-BE49-F238E27FC236}">
                  <a16:creationId xmlns:a16="http://schemas.microsoft.com/office/drawing/2014/main" id="{53CAC964-B356-415F-A97A-A6F3D094B3AA}"/>
                </a:ext>
              </a:extLst>
            </p:cNvPr>
            <p:cNvCxnSpPr>
              <a:cxnSpLocks/>
            </p:cNvCxnSpPr>
            <p:nvPr/>
          </p:nvCxnSpPr>
          <p:spPr>
            <a:xfrm>
              <a:off x="4438186" y="599683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2" name="Connettore diritto 431">
              <a:extLst>
                <a:ext uri="{FF2B5EF4-FFF2-40B4-BE49-F238E27FC236}">
                  <a16:creationId xmlns:a16="http://schemas.microsoft.com/office/drawing/2014/main" id="{61C5E6D5-A1C1-478B-B230-CC0F28926142}"/>
                </a:ext>
              </a:extLst>
            </p:cNvPr>
            <p:cNvCxnSpPr>
              <a:cxnSpLocks/>
            </p:cNvCxnSpPr>
            <p:nvPr/>
          </p:nvCxnSpPr>
          <p:spPr>
            <a:xfrm>
              <a:off x="4833290" y="599683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3" name="Connettore diritto 432">
              <a:extLst>
                <a:ext uri="{FF2B5EF4-FFF2-40B4-BE49-F238E27FC236}">
                  <a16:creationId xmlns:a16="http://schemas.microsoft.com/office/drawing/2014/main" id="{8A2526DB-5DBC-44A5-B01D-46A397B85DAE}"/>
                </a:ext>
              </a:extLst>
            </p:cNvPr>
            <p:cNvCxnSpPr>
              <a:cxnSpLocks/>
            </p:cNvCxnSpPr>
            <p:nvPr/>
          </p:nvCxnSpPr>
          <p:spPr>
            <a:xfrm>
              <a:off x="5257500" y="599683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4" name="Connettore diritto 433">
              <a:extLst>
                <a:ext uri="{FF2B5EF4-FFF2-40B4-BE49-F238E27FC236}">
                  <a16:creationId xmlns:a16="http://schemas.microsoft.com/office/drawing/2014/main" id="{AE60F383-D25D-4B75-B71D-6987ACC73ED0}"/>
                </a:ext>
              </a:extLst>
            </p:cNvPr>
            <p:cNvCxnSpPr>
              <a:cxnSpLocks/>
            </p:cNvCxnSpPr>
            <p:nvPr/>
          </p:nvCxnSpPr>
          <p:spPr>
            <a:xfrm>
              <a:off x="5672532" y="5996835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5" name="CasellaDiTesto 434">
              <a:extLst>
                <a:ext uri="{FF2B5EF4-FFF2-40B4-BE49-F238E27FC236}">
                  <a16:creationId xmlns:a16="http://schemas.microsoft.com/office/drawing/2014/main" id="{8F1FBF35-B26C-4ABF-9FDF-86C7D3D6D4AA}"/>
                </a:ext>
              </a:extLst>
            </p:cNvPr>
            <p:cNvSpPr txBox="1"/>
            <p:nvPr/>
          </p:nvSpPr>
          <p:spPr>
            <a:xfrm>
              <a:off x="3753767" y="5663636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.0</a:t>
              </a:r>
            </a:p>
          </p:txBody>
        </p:sp>
        <p:sp>
          <p:nvSpPr>
            <p:cNvPr id="436" name="CasellaDiTesto 435">
              <a:extLst>
                <a:ext uri="{FF2B5EF4-FFF2-40B4-BE49-F238E27FC236}">
                  <a16:creationId xmlns:a16="http://schemas.microsoft.com/office/drawing/2014/main" id="{59CDCF72-B6F9-4BBE-AE32-A3207A35E999}"/>
                </a:ext>
              </a:extLst>
            </p:cNvPr>
            <p:cNvSpPr txBox="1"/>
            <p:nvPr/>
          </p:nvSpPr>
          <p:spPr>
            <a:xfrm>
              <a:off x="3753767" y="4984849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4.0</a:t>
              </a:r>
            </a:p>
          </p:txBody>
        </p:sp>
        <p:sp>
          <p:nvSpPr>
            <p:cNvPr id="437" name="CasellaDiTesto 436">
              <a:extLst>
                <a:ext uri="{FF2B5EF4-FFF2-40B4-BE49-F238E27FC236}">
                  <a16:creationId xmlns:a16="http://schemas.microsoft.com/office/drawing/2014/main" id="{E9C9C7E2-A7E4-4394-84BE-0581BBA2F305}"/>
                </a:ext>
              </a:extLst>
            </p:cNvPr>
            <p:cNvSpPr txBox="1"/>
            <p:nvPr/>
          </p:nvSpPr>
          <p:spPr>
            <a:xfrm>
              <a:off x="3753767" y="4310116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8.0</a:t>
              </a:r>
            </a:p>
          </p:txBody>
        </p:sp>
      </p:grpSp>
      <p:grpSp>
        <p:nvGrpSpPr>
          <p:cNvPr id="632" name="Gruppo 631">
            <a:extLst>
              <a:ext uri="{FF2B5EF4-FFF2-40B4-BE49-F238E27FC236}">
                <a16:creationId xmlns:a16="http://schemas.microsoft.com/office/drawing/2014/main" id="{201447BE-4ABF-4285-9F72-81C6B4A7A579}"/>
              </a:ext>
            </a:extLst>
          </p:cNvPr>
          <p:cNvGrpSpPr/>
          <p:nvPr/>
        </p:nvGrpSpPr>
        <p:grpSpPr>
          <a:xfrm>
            <a:off x="381285" y="5004048"/>
            <a:ext cx="2535050" cy="1888450"/>
            <a:chOff x="200835" y="6547441"/>
            <a:chExt cx="2535050" cy="1888450"/>
          </a:xfrm>
        </p:grpSpPr>
        <p:pic>
          <p:nvPicPr>
            <p:cNvPr id="588" name="Immagine 587">
              <a:extLst>
                <a:ext uri="{FF2B5EF4-FFF2-40B4-BE49-F238E27FC236}">
                  <a16:creationId xmlns:a16="http://schemas.microsoft.com/office/drawing/2014/main" id="{3464A1BB-EC83-4692-8934-01681A32B28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96846" y="6645240"/>
              <a:ext cx="2110230" cy="1440000"/>
            </a:xfrm>
            <a:prstGeom prst="rect">
              <a:avLst/>
            </a:prstGeom>
          </p:spPr>
        </p:pic>
        <p:sp>
          <p:nvSpPr>
            <p:cNvPr id="464" name="CasellaDiTesto 463">
              <a:extLst>
                <a:ext uri="{FF2B5EF4-FFF2-40B4-BE49-F238E27FC236}">
                  <a16:creationId xmlns:a16="http://schemas.microsoft.com/office/drawing/2014/main" id="{8AD83EFB-F87E-4636-B7C6-F99F34D93EAA}"/>
                </a:ext>
              </a:extLst>
            </p:cNvPr>
            <p:cNvSpPr txBox="1"/>
            <p:nvPr/>
          </p:nvSpPr>
          <p:spPr>
            <a:xfrm>
              <a:off x="612973" y="6547441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/>
                <a:t>MCF-7</a:t>
              </a:r>
            </a:p>
          </p:txBody>
        </p:sp>
        <p:sp>
          <p:nvSpPr>
            <p:cNvPr id="465" name="CasellaDiTesto 464">
              <a:extLst>
                <a:ext uri="{FF2B5EF4-FFF2-40B4-BE49-F238E27FC236}">
                  <a16:creationId xmlns:a16="http://schemas.microsoft.com/office/drawing/2014/main" id="{AF2E13E1-DC1B-40E5-95C2-B6285056F700}"/>
                </a:ext>
              </a:extLst>
            </p:cNvPr>
            <p:cNvSpPr txBox="1"/>
            <p:nvPr/>
          </p:nvSpPr>
          <p:spPr>
            <a:xfrm>
              <a:off x="2303523" y="8251225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CCT</a:t>
              </a:r>
            </a:p>
          </p:txBody>
        </p:sp>
        <p:grpSp>
          <p:nvGrpSpPr>
            <p:cNvPr id="466" name="Gruppo 465">
              <a:extLst>
                <a:ext uri="{FF2B5EF4-FFF2-40B4-BE49-F238E27FC236}">
                  <a16:creationId xmlns:a16="http://schemas.microsoft.com/office/drawing/2014/main" id="{D691206F-873D-488E-89E3-304300E3AF5D}"/>
                </a:ext>
              </a:extLst>
            </p:cNvPr>
            <p:cNvGrpSpPr/>
            <p:nvPr/>
          </p:nvGrpSpPr>
          <p:grpSpPr>
            <a:xfrm>
              <a:off x="981164" y="8085240"/>
              <a:ext cx="527871" cy="184666"/>
              <a:chOff x="726600" y="4418665"/>
              <a:chExt cx="527871" cy="184666"/>
            </a:xfrm>
          </p:grpSpPr>
          <p:sp>
            <p:nvSpPr>
              <p:cNvPr id="500" name="CasellaDiTesto 499">
                <a:extLst>
                  <a:ext uri="{FF2B5EF4-FFF2-40B4-BE49-F238E27FC236}">
                    <a16:creationId xmlns:a16="http://schemas.microsoft.com/office/drawing/2014/main" id="{0F0D2AD4-A5D5-4556-8C5A-AE504B9DDB4D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501" name="CasellaDiTesto 500">
                <a:extLst>
                  <a:ext uri="{FF2B5EF4-FFF2-40B4-BE49-F238E27FC236}">
                    <a16:creationId xmlns:a16="http://schemas.microsoft.com/office/drawing/2014/main" id="{76048FC3-AD5E-4159-ADBA-A117BAFEEC47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502" name="CasellaDiTesto 501">
                <a:extLst>
                  <a:ext uri="{FF2B5EF4-FFF2-40B4-BE49-F238E27FC236}">
                    <a16:creationId xmlns:a16="http://schemas.microsoft.com/office/drawing/2014/main" id="{1A05A1CB-FA2C-48B1-B653-F10A1A721215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503" name="CasellaDiTesto 502">
                <a:extLst>
                  <a:ext uri="{FF2B5EF4-FFF2-40B4-BE49-F238E27FC236}">
                    <a16:creationId xmlns:a16="http://schemas.microsoft.com/office/drawing/2014/main" id="{20A2B465-489E-48C6-9236-0C52B0E21EB9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sp>
          <p:nvSpPr>
            <p:cNvPr id="467" name="CasellaDiTesto 466">
              <a:extLst>
                <a:ext uri="{FF2B5EF4-FFF2-40B4-BE49-F238E27FC236}">
                  <a16:creationId xmlns:a16="http://schemas.microsoft.com/office/drawing/2014/main" id="{23928B5A-0BBD-4C61-B31A-5A157BB130D8}"/>
                </a:ext>
              </a:extLst>
            </p:cNvPr>
            <p:cNvSpPr txBox="1"/>
            <p:nvPr/>
          </p:nvSpPr>
          <p:spPr>
            <a:xfrm>
              <a:off x="1087366" y="8251225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VE</a:t>
              </a:r>
            </a:p>
          </p:txBody>
        </p:sp>
        <p:sp>
          <p:nvSpPr>
            <p:cNvPr id="468" name="CasellaDiTesto 467">
              <a:extLst>
                <a:ext uri="{FF2B5EF4-FFF2-40B4-BE49-F238E27FC236}">
                  <a16:creationId xmlns:a16="http://schemas.microsoft.com/office/drawing/2014/main" id="{7BDC0BDB-4637-4219-976F-9E1DB6E5B1ED}"/>
                </a:ext>
              </a:extLst>
            </p:cNvPr>
            <p:cNvSpPr txBox="1"/>
            <p:nvPr/>
          </p:nvSpPr>
          <p:spPr>
            <a:xfrm>
              <a:off x="1470918" y="8251225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KU</a:t>
              </a:r>
            </a:p>
          </p:txBody>
        </p:sp>
        <p:sp>
          <p:nvSpPr>
            <p:cNvPr id="469" name="CasellaDiTesto 468">
              <a:extLst>
                <a:ext uri="{FF2B5EF4-FFF2-40B4-BE49-F238E27FC236}">
                  <a16:creationId xmlns:a16="http://schemas.microsoft.com/office/drawing/2014/main" id="{DD26FFC7-52A2-46E7-8218-C5B242A31715}"/>
                </a:ext>
              </a:extLst>
            </p:cNvPr>
            <p:cNvSpPr txBox="1"/>
            <p:nvPr/>
          </p:nvSpPr>
          <p:spPr>
            <a:xfrm>
              <a:off x="1895093" y="8251225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MK</a:t>
              </a:r>
            </a:p>
          </p:txBody>
        </p:sp>
        <p:grpSp>
          <p:nvGrpSpPr>
            <p:cNvPr id="470" name="Gruppo 469">
              <a:extLst>
                <a:ext uri="{FF2B5EF4-FFF2-40B4-BE49-F238E27FC236}">
                  <a16:creationId xmlns:a16="http://schemas.microsoft.com/office/drawing/2014/main" id="{5D5FED1B-5D22-4454-8D2B-B936EE9F1081}"/>
                </a:ext>
              </a:extLst>
            </p:cNvPr>
            <p:cNvGrpSpPr/>
            <p:nvPr/>
          </p:nvGrpSpPr>
          <p:grpSpPr>
            <a:xfrm>
              <a:off x="603417" y="8085240"/>
              <a:ext cx="502435" cy="184666"/>
              <a:chOff x="348853" y="4418665"/>
              <a:chExt cx="502435" cy="184666"/>
            </a:xfrm>
          </p:grpSpPr>
          <p:sp>
            <p:nvSpPr>
              <p:cNvPr id="496" name="CasellaDiTesto 495">
                <a:extLst>
                  <a:ext uri="{FF2B5EF4-FFF2-40B4-BE49-F238E27FC236}">
                    <a16:creationId xmlns:a16="http://schemas.microsoft.com/office/drawing/2014/main" id="{DF3D68DA-B5C1-4DA7-A768-891BD238B95C}"/>
                  </a:ext>
                </a:extLst>
              </p:cNvPr>
              <p:cNvSpPr txBox="1"/>
              <p:nvPr/>
            </p:nvSpPr>
            <p:spPr>
              <a:xfrm>
                <a:off x="34885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497" name="CasellaDiTesto 496">
                <a:extLst>
                  <a:ext uri="{FF2B5EF4-FFF2-40B4-BE49-F238E27FC236}">
                    <a16:creationId xmlns:a16="http://schemas.microsoft.com/office/drawing/2014/main" id="{5D73D03A-F20A-4715-8B78-B229AF4726FB}"/>
                  </a:ext>
                </a:extLst>
              </p:cNvPr>
              <p:cNvSpPr txBox="1"/>
              <p:nvPr/>
            </p:nvSpPr>
            <p:spPr>
              <a:xfrm>
                <a:off x="433242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  <p:sp>
            <p:nvSpPr>
              <p:cNvPr id="498" name="CasellaDiTesto 497">
                <a:extLst>
                  <a:ext uri="{FF2B5EF4-FFF2-40B4-BE49-F238E27FC236}">
                    <a16:creationId xmlns:a16="http://schemas.microsoft.com/office/drawing/2014/main" id="{0C7EAB58-F83B-44AC-BE85-E42D0DF58548}"/>
                  </a:ext>
                </a:extLst>
              </p:cNvPr>
              <p:cNvSpPr txBox="1"/>
              <p:nvPr/>
            </p:nvSpPr>
            <p:spPr>
              <a:xfrm>
                <a:off x="517567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5</a:t>
                </a:r>
              </a:p>
            </p:txBody>
          </p:sp>
          <p:sp>
            <p:nvSpPr>
              <p:cNvPr id="499" name="CasellaDiTesto 498">
                <a:extLst>
                  <a:ext uri="{FF2B5EF4-FFF2-40B4-BE49-F238E27FC236}">
                    <a16:creationId xmlns:a16="http://schemas.microsoft.com/office/drawing/2014/main" id="{E045944D-4D7B-412A-8424-9AA0C37AA526}"/>
                  </a:ext>
                </a:extLst>
              </p:cNvPr>
              <p:cNvSpPr txBox="1"/>
              <p:nvPr/>
            </p:nvSpPr>
            <p:spPr>
              <a:xfrm>
                <a:off x="580060" y="441866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0</a:t>
                </a:r>
              </a:p>
            </p:txBody>
          </p:sp>
        </p:grpSp>
        <p:sp>
          <p:nvSpPr>
            <p:cNvPr id="471" name="CasellaDiTesto 470">
              <a:extLst>
                <a:ext uri="{FF2B5EF4-FFF2-40B4-BE49-F238E27FC236}">
                  <a16:creationId xmlns:a16="http://schemas.microsoft.com/office/drawing/2014/main" id="{467A1F96-F92A-494D-8BD9-5C5FDA0BC23F}"/>
                </a:ext>
              </a:extLst>
            </p:cNvPr>
            <p:cNvSpPr txBox="1"/>
            <p:nvPr/>
          </p:nvSpPr>
          <p:spPr>
            <a:xfrm>
              <a:off x="669970" y="8251225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AZD</a:t>
              </a:r>
            </a:p>
          </p:txBody>
        </p:sp>
        <p:sp>
          <p:nvSpPr>
            <p:cNvPr id="472" name="CasellaDiTesto 471">
              <a:extLst>
                <a:ext uri="{FF2B5EF4-FFF2-40B4-BE49-F238E27FC236}">
                  <a16:creationId xmlns:a16="http://schemas.microsoft.com/office/drawing/2014/main" id="{7EFEC295-AA1C-4B3C-B88C-587E17B21A88}"/>
                </a:ext>
              </a:extLst>
            </p:cNvPr>
            <p:cNvSpPr txBox="1"/>
            <p:nvPr/>
          </p:nvSpPr>
          <p:spPr>
            <a:xfrm rot="16200000">
              <a:off x="2544" y="7203540"/>
              <a:ext cx="6735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l-GR" sz="600" dirty="0">
                  <a:latin typeface="Palatino Linotype" panose="02040502050505030304" pitchFamily="18" charset="0"/>
                </a:rPr>
                <a:t>γ</a:t>
              </a:r>
              <a:r>
                <a:rPr lang="it-IT" sz="600" dirty="0"/>
                <a:t>H2AX </a:t>
              </a:r>
              <a:r>
                <a:rPr lang="it-IT" sz="600" dirty="0" err="1">
                  <a:latin typeface="+mn-lt"/>
                  <a:cs typeface="Times New Roman" panose="02020603050405020304" pitchFamily="18" charset="0"/>
                </a:rPr>
                <a:t>levels</a:t>
              </a:r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(</a:t>
              </a:r>
              <a:r>
                <a:rPr lang="it-IT" sz="600" dirty="0" err="1">
                  <a:latin typeface="+mn-lt"/>
                  <a:cs typeface="Times New Roman" panose="02020603050405020304" pitchFamily="18" charset="0"/>
                </a:rPr>
                <a:t>Fold</a:t>
              </a:r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 on 0)</a:t>
              </a:r>
              <a:endParaRPr lang="it-IT" sz="600" dirty="0">
                <a:latin typeface="+mn-lt"/>
              </a:endParaRPr>
            </a:p>
          </p:txBody>
        </p:sp>
        <p:grpSp>
          <p:nvGrpSpPr>
            <p:cNvPr id="473" name="Gruppo 472">
              <a:extLst>
                <a:ext uri="{FF2B5EF4-FFF2-40B4-BE49-F238E27FC236}">
                  <a16:creationId xmlns:a16="http://schemas.microsoft.com/office/drawing/2014/main" id="{B34D5077-D515-4C72-896E-2DF723459649}"/>
                </a:ext>
              </a:extLst>
            </p:cNvPr>
            <p:cNvGrpSpPr/>
            <p:nvPr/>
          </p:nvGrpSpPr>
          <p:grpSpPr>
            <a:xfrm>
              <a:off x="1376268" y="8085240"/>
              <a:ext cx="527871" cy="184666"/>
              <a:chOff x="726600" y="4418665"/>
              <a:chExt cx="527871" cy="184666"/>
            </a:xfrm>
          </p:grpSpPr>
          <p:sp>
            <p:nvSpPr>
              <p:cNvPr id="492" name="CasellaDiTesto 491">
                <a:extLst>
                  <a:ext uri="{FF2B5EF4-FFF2-40B4-BE49-F238E27FC236}">
                    <a16:creationId xmlns:a16="http://schemas.microsoft.com/office/drawing/2014/main" id="{7B027673-F4A2-4450-8ED2-B3C1D6ABAFB3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493" name="CasellaDiTesto 492">
                <a:extLst>
                  <a:ext uri="{FF2B5EF4-FFF2-40B4-BE49-F238E27FC236}">
                    <a16:creationId xmlns:a16="http://schemas.microsoft.com/office/drawing/2014/main" id="{092B5D96-048B-4A69-BE41-D05B5814EA74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494" name="CasellaDiTesto 493">
                <a:extLst>
                  <a:ext uri="{FF2B5EF4-FFF2-40B4-BE49-F238E27FC236}">
                    <a16:creationId xmlns:a16="http://schemas.microsoft.com/office/drawing/2014/main" id="{A93708E3-8CF1-4213-9487-9984E78E18BA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495" name="CasellaDiTesto 494">
                <a:extLst>
                  <a:ext uri="{FF2B5EF4-FFF2-40B4-BE49-F238E27FC236}">
                    <a16:creationId xmlns:a16="http://schemas.microsoft.com/office/drawing/2014/main" id="{21E77D77-87CA-477A-AC5A-76B115CB5208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grpSp>
          <p:nvGrpSpPr>
            <p:cNvPr id="474" name="Gruppo 473">
              <a:extLst>
                <a:ext uri="{FF2B5EF4-FFF2-40B4-BE49-F238E27FC236}">
                  <a16:creationId xmlns:a16="http://schemas.microsoft.com/office/drawing/2014/main" id="{B3F1FE2A-25F3-4F7B-B392-B8575284E817}"/>
                </a:ext>
              </a:extLst>
            </p:cNvPr>
            <p:cNvGrpSpPr/>
            <p:nvPr/>
          </p:nvGrpSpPr>
          <p:grpSpPr>
            <a:xfrm>
              <a:off x="1794117" y="8085240"/>
              <a:ext cx="527871" cy="184666"/>
              <a:chOff x="726600" y="4418665"/>
              <a:chExt cx="527871" cy="184666"/>
            </a:xfrm>
          </p:grpSpPr>
          <p:sp>
            <p:nvSpPr>
              <p:cNvPr id="488" name="CasellaDiTesto 487">
                <a:extLst>
                  <a:ext uri="{FF2B5EF4-FFF2-40B4-BE49-F238E27FC236}">
                    <a16:creationId xmlns:a16="http://schemas.microsoft.com/office/drawing/2014/main" id="{DC877569-16CF-48E5-81B4-6CD432CA5B52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489" name="CasellaDiTesto 488">
                <a:extLst>
                  <a:ext uri="{FF2B5EF4-FFF2-40B4-BE49-F238E27FC236}">
                    <a16:creationId xmlns:a16="http://schemas.microsoft.com/office/drawing/2014/main" id="{A3B770AD-C4B0-4D56-AD5D-DFDA796EFCBD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490" name="CasellaDiTesto 489">
                <a:extLst>
                  <a:ext uri="{FF2B5EF4-FFF2-40B4-BE49-F238E27FC236}">
                    <a16:creationId xmlns:a16="http://schemas.microsoft.com/office/drawing/2014/main" id="{48C18B6D-0D86-4D8F-94BD-08B6FDEF23E0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491" name="CasellaDiTesto 490">
                <a:extLst>
                  <a:ext uri="{FF2B5EF4-FFF2-40B4-BE49-F238E27FC236}">
                    <a16:creationId xmlns:a16="http://schemas.microsoft.com/office/drawing/2014/main" id="{6A7B0534-8F9F-4E6E-A215-3C99DC7DCF68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grpSp>
          <p:nvGrpSpPr>
            <p:cNvPr id="475" name="Gruppo 474">
              <a:extLst>
                <a:ext uri="{FF2B5EF4-FFF2-40B4-BE49-F238E27FC236}">
                  <a16:creationId xmlns:a16="http://schemas.microsoft.com/office/drawing/2014/main" id="{1486E046-81CA-40CB-8E5F-A7D1F11AB59A}"/>
                </a:ext>
              </a:extLst>
            </p:cNvPr>
            <p:cNvGrpSpPr/>
            <p:nvPr/>
          </p:nvGrpSpPr>
          <p:grpSpPr>
            <a:xfrm>
              <a:off x="2208014" y="8085240"/>
              <a:ext cx="527871" cy="184666"/>
              <a:chOff x="726600" y="4418665"/>
              <a:chExt cx="527871" cy="184666"/>
            </a:xfrm>
          </p:grpSpPr>
          <p:sp>
            <p:nvSpPr>
              <p:cNvPr id="484" name="CasellaDiTesto 483">
                <a:extLst>
                  <a:ext uri="{FF2B5EF4-FFF2-40B4-BE49-F238E27FC236}">
                    <a16:creationId xmlns:a16="http://schemas.microsoft.com/office/drawing/2014/main" id="{5AFBA8A2-E41C-4B18-A3A9-BED6A55D093E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485" name="CasellaDiTesto 484">
                <a:extLst>
                  <a:ext uri="{FF2B5EF4-FFF2-40B4-BE49-F238E27FC236}">
                    <a16:creationId xmlns:a16="http://schemas.microsoft.com/office/drawing/2014/main" id="{AFBE5987-B8B6-4AEC-A573-1ECDF070F659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486" name="CasellaDiTesto 485">
                <a:extLst>
                  <a:ext uri="{FF2B5EF4-FFF2-40B4-BE49-F238E27FC236}">
                    <a16:creationId xmlns:a16="http://schemas.microsoft.com/office/drawing/2014/main" id="{536F2756-8CF2-497A-9DD6-9CB25950B798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487" name="CasellaDiTesto 486">
                <a:extLst>
                  <a:ext uri="{FF2B5EF4-FFF2-40B4-BE49-F238E27FC236}">
                    <a16:creationId xmlns:a16="http://schemas.microsoft.com/office/drawing/2014/main" id="{65BDE917-A59F-4097-802A-BDECD6691443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cxnSp>
          <p:nvCxnSpPr>
            <p:cNvPr id="476" name="Connettore diritto 475">
              <a:extLst>
                <a:ext uri="{FF2B5EF4-FFF2-40B4-BE49-F238E27FC236}">
                  <a16:creationId xmlns:a16="http://schemas.microsoft.com/office/drawing/2014/main" id="{50BA3E54-FFA3-4F7B-BCE4-6383914CEEE6}"/>
                </a:ext>
              </a:extLst>
            </p:cNvPr>
            <p:cNvCxnSpPr>
              <a:cxnSpLocks/>
            </p:cNvCxnSpPr>
            <p:nvPr/>
          </p:nvCxnSpPr>
          <p:spPr>
            <a:xfrm>
              <a:off x="677196" y="8255862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7" name="Connettore diritto 476">
              <a:extLst>
                <a:ext uri="{FF2B5EF4-FFF2-40B4-BE49-F238E27FC236}">
                  <a16:creationId xmlns:a16="http://schemas.microsoft.com/office/drawing/2014/main" id="{AF352FAB-16A2-4F6C-9560-C5B63B8D0EEC}"/>
                </a:ext>
              </a:extLst>
            </p:cNvPr>
            <p:cNvCxnSpPr>
              <a:cxnSpLocks/>
            </p:cNvCxnSpPr>
            <p:nvPr/>
          </p:nvCxnSpPr>
          <p:spPr>
            <a:xfrm>
              <a:off x="1076195" y="8255862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8" name="Connettore diritto 477">
              <a:extLst>
                <a:ext uri="{FF2B5EF4-FFF2-40B4-BE49-F238E27FC236}">
                  <a16:creationId xmlns:a16="http://schemas.microsoft.com/office/drawing/2014/main" id="{4B3EF7DA-BA81-4535-A6FF-671D787646AB}"/>
                </a:ext>
              </a:extLst>
            </p:cNvPr>
            <p:cNvCxnSpPr>
              <a:cxnSpLocks/>
            </p:cNvCxnSpPr>
            <p:nvPr/>
          </p:nvCxnSpPr>
          <p:spPr>
            <a:xfrm>
              <a:off x="1471299" y="8255862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9" name="Connettore diritto 478">
              <a:extLst>
                <a:ext uri="{FF2B5EF4-FFF2-40B4-BE49-F238E27FC236}">
                  <a16:creationId xmlns:a16="http://schemas.microsoft.com/office/drawing/2014/main" id="{9E078874-DEA2-4DA8-A24E-CE1862B24A99}"/>
                </a:ext>
              </a:extLst>
            </p:cNvPr>
            <p:cNvCxnSpPr>
              <a:cxnSpLocks/>
            </p:cNvCxnSpPr>
            <p:nvPr/>
          </p:nvCxnSpPr>
          <p:spPr>
            <a:xfrm>
              <a:off x="1895509" y="8255862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0" name="Connettore diritto 479">
              <a:extLst>
                <a:ext uri="{FF2B5EF4-FFF2-40B4-BE49-F238E27FC236}">
                  <a16:creationId xmlns:a16="http://schemas.microsoft.com/office/drawing/2014/main" id="{51F70B45-89F5-406C-9758-CEDBD3161E4E}"/>
                </a:ext>
              </a:extLst>
            </p:cNvPr>
            <p:cNvCxnSpPr>
              <a:cxnSpLocks/>
            </p:cNvCxnSpPr>
            <p:nvPr/>
          </p:nvCxnSpPr>
          <p:spPr>
            <a:xfrm>
              <a:off x="2310541" y="8255862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1" name="CasellaDiTesto 480">
              <a:extLst>
                <a:ext uri="{FF2B5EF4-FFF2-40B4-BE49-F238E27FC236}">
                  <a16:creationId xmlns:a16="http://schemas.microsoft.com/office/drawing/2014/main" id="{73611061-F4F5-4435-B286-B36BFC8E09A5}"/>
                </a:ext>
              </a:extLst>
            </p:cNvPr>
            <p:cNvSpPr txBox="1"/>
            <p:nvPr/>
          </p:nvSpPr>
          <p:spPr>
            <a:xfrm>
              <a:off x="391776" y="7907423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.0</a:t>
              </a:r>
            </a:p>
          </p:txBody>
        </p:sp>
        <p:sp>
          <p:nvSpPr>
            <p:cNvPr id="482" name="CasellaDiTesto 481">
              <a:extLst>
                <a:ext uri="{FF2B5EF4-FFF2-40B4-BE49-F238E27FC236}">
                  <a16:creationId xmlns:a16="http://schemas.microsoft.com/office/drawing/2014/main" id="{A8420A2A-F6E7-4FFB-A30D-E5F571338C1C}"/>
                </a:ext>
              </a:extLst>
            </p:cNvPr>
            <p:cNvSpPr txBox="1"/>
            <p:nvPr/>
          </p:nvSpPr>
          <p:spPr>
            <a:xfrm>
              <a:off x="348496" y="7248956"/>
              <a:ext cx="3353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5.0</a:t>
              </a:r>
            </a:p>
          </p:txBody>
        </p:sp>
        <p:sp>
          <p:nvSpPr>
            <p:cNvPr id="483" name="CasellaDiTesto 482">
              <a:extLst>
                <a:ext uri="{FF2B5EF4-FFF2-40B4-BE49-F238E27FC236}">
                  <a16:creationId xmlns:a16="http://schemas.microsoft.com/office/drawing/2014/main" id="{249F6C9C-FC88-48A5-A238-4F32993D7B4C}"/>
                </a:ext>
              </a:extLst>
            </p:cNvPr>
            <p:cNvSpPr txBox="1"/>
            <p:nvPr/>
          </p:nvSpPr>
          <p:spPr>
            <a:xfrm>
              <a:off x="348496" y="6581843"/>
              <a:ext cx="3353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30.0</a:t>
              </a:r>
            </a:p>
          </p:txBody>
        </p:sp>
      </p:grpSp>
      <p:grpSp>
        <p:nvGrpSpPr>
          <p:cNvPr id="631" name="Gruppo 630">
            <a:extLst>
              <a:ext uri="{FF2B5EF4-FFF2-40B4-BE49-F238E27FC236}">
                <a16:creationId xmlns:a16="http://schemas.microsoft.com/office/drawing/2014/main" id="{089AF3C7-993A-4507-BE2D-4BB7B7EB08B6}"/>
              </a:ext>
            </a:extLst>
          </p:cNvPr>
          <p:cNvGrpSpPr/>
          <p:nvPr/>
        </p:nvGrpSpPr>
        <p:grpSpPr>
          <a:xfrm>
            <a:off x="3722899" y="5004048"/>
            <a:ext cx="2535050" cy="1888450"/>
            <a:chOff x="3636983" y="6482495"/>
            <a:chExt cx="2535050" cy="1888450"/>
          </a:xfrm>
        </p:grpSpPr>
        <p:pic>
          <p:nvPicPr>
            <p:cNvPr id="630" name="Immagine 629">
              <a:extLst>
                <a:ext uri="{FF2B5EF4-FFF2-40B4-BE49-F238E27FC236}">
                  <a16:creationId xmlns:a16="http://schemas.microsoft.com/office/drawing/2014/main" id="{7A663C1C-ABE7-45F0-920D-DE2C23546CA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032994" y="6580294"/>
              <a:ext cx="2090322" cy="1440000"/>
            </a:xfrm>
            <a:prstGeom prst="rect">
              <a:avLst/>
            </a:prstGeom>
          </p:spPr>
        </p:pic>
        <p:sp>
          <p:nvSpPr>
            <p:cNvPr id="590" name="CasellaDiTesto 589">
              <a:extLst>
                <a:ext uri="{FF2B5EF4-FFF2-40B4-BE49-F238E27FC236}">
                  <a16:creationId xmlns:a16="http://schemas.microsoft.com/office/drawing/2014/main" id="{7C97C709-AE3E-44E5-8F3D-5B7DF7CADC05}"/>
                </a:ext>
              </a:extLst>
            </p:cNvPr>
            <p:cNvSpPr txBox="1"/>
            <p:nvPr/>
          </p:nvSpPr>
          <p:spPr>
            <a:xfrm>
              <a:off x="4049121" y="6482495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/>
                <a:t>Y537S</a:t>
              </a:r>
            </a:p>
          </p:txBody>
        </p:sp>
        <p:sp>
          <p:nvSpPr>
            <p:cNvPr id="591" name="CasellaDiTesto 590">
              <a:extLst>
                <a:ext uri="{FF2B5EF4-FFF2-40B4-BE49-F238E27FC236}">
                  <a16:creationId xmlns:a16="http://schemas.microsoft.com/office/drawing/2014/main" id="{34BB8974-47AE-4CD1-A29A-FDFB1F977811}"/>
                </a:ext>
              </a:extLst>
            </p:cNvPr>
            <p:cNvSpPr txBox="1"/>
            <p:nvPr/>
          </p:nvSpPr>
          <p:spPr>
            <a:xfrm>
              <a:off x="5739671" y="8186279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CCT</a:t>
              </a:r>
            </a:p>
          </p:txBody>
        </p:sp>
        <p:grpSp>
          <p:nvGrpSpPr>
            <p:cNvPr id="592" name="Gruppo 591">
              <a:extLst>
                <a:ext uri="{FF2B5EF4-FFF2-40B4-BE49-F238E27FC236}">
                  <a16:creationId xmlns:a16="http://schemas.microsoft.com/office/drawing/2014/main" id="{FCA95FBE-A4DC-4E10-A4D9-9D251141BEC3}"/>
                </a:ext>
              </a:extLst>
            </p:cNvPr>
            <p:cNvGrpSpPr/>
            <p:nvPr/>
          </p:nvGrpSpPr>
          <p:grpSpPr>
            <a:xfrm>
              <a:off x="4417312" y="8020294"/>
              <a:ext cx="527871" cy="184666"/>
              <a:chOff x="726600" y="4418665"/>
              <a:chExt cx="527871" cy="184666"/>
            </a:xfrm>
          </p:grpSpPr>
          <p:sp>
            <p:nvSpPr>
              <p:cNvPr id="593" name="CasellaDiTesto 592">
                <a:extLst>
                  <a:ext uri="{FF2B5EF4-FFF2-40B4-BE49-F238E27FC236}">
                    <a16:creationId xmlns:a16="http://schemas.microsoft.com/office/drawing/2014/main" id="{5CAA7D12-0A2D-4288-B30E-2CC967BE8950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594" name="CasellaDiTesto 593">
                <a:extLst>
                  <a:ext uri="{FF2B5EF4-FFF2-40B4-BE49-F238E27FC236}">
                    <a16:creationId xmlns:a16="http://schemas.microsoft.com/office/drawing/2014/main" id="{07711340-0830-422F-9A93-330B4E07BF53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595" name="CasellaDiTesto 594">
                <a:extLst>
                  <a:ext uri="{FF2B5EF4-FFF2-40B4-BE49-F238E27FC236}">
                    <a16:creationId xmlns:a16="http://schemas.microsoft.com/office/drawing/2014/main" id="{C8234794-3ED3-4558-AC9C-4A5E9039046C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596" name="CasellaDiTesto 595">
                <a:extLst>
                  <a:ext uri="{FF2B5EF4-FFF2-40B4-BE49-F238E27FC236}">
                    <a16:creationId xmlns:a16="http://schemas.microsoft.com/office/drawing/2014/main" id="{13F7B650-E826-47A3-BF2A-BAD22803A4E4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sp>
          <p:nvSpPr>
            <p:cNvPr id="597" name="CasellaDiTesto 596">
              <a:extLst>
                <a:ext uri="{FF2B5EF4-FFF2-40B4-BE49-F238E27FC236}">
                  <a16:creationId xmlns:a16="http://schemas.microsoft.com/office/drawing/2014/main" id="{628937DB-5C5A-4393-ADE4-665A4FABA8D3}"/>
                </a:ext>
              </a:extLst>
            </p:cNvPr>
            <p:cNvSpPr txBox="1"/>
            <p:nvPr/>
          </p:nvSpPr>
          <p:spPr>
            <a:xfrm>
              <a:off x="4523514" y="8186279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VE</a:t>
              </a:r>
            </a:p>
          </p:txBody>
        </p:sp>
        <p:sp>
          <p:nvSpPr>
            <p:cNvPr id="598" name="CasellaDiTesto 597">
              <a:extLst>
                <a:ext uri="{FF2B5EF4-FFF2-40B4-BE49-F238E27FC236}">
                  <a16:creationId xmlns:a16="http://schemas.microsoft.com/office/drawing/2014/main" id="{412F04E8-FD7D-4B8A-B9FA-C58DEDADC242}"/>
                </a:ext>
              </a:extLst>
            </p:cNvPr>
            <p:cNvSpPr txBox="1"/>
            <p:nvPr/>
          </p:nvSpPr>
          <p:spPr>
            <a:xfrm>
              <a:off x="4907066" y="8186279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KU</a:t>
              </a:r>
            </a:p>
          </p:txBody>
        </p:sp>
        <p:sp>
          <p:nvSpPr>
            <p:cNvPr id="599" name="CasellaDiTesto 598">
              <a:extLst>
                <a:ext uri="{FF2B5EF4-FFF2-40B4-BE49-F238E27FC236}">
                  <a16:creationId xmlns:a16="http://schemas.microsoft.com/office/drawing/2014/main" id="{CB814AD2-41F1-4A42-89A8-8B50EBCB1C69}"/>
                </a:ext>
              </a:extLst>
            </p:cNvPr>
            <p:cNvSpPr txBox="1"/>
            <p:nvPr/>
          </p:nvSpPr>
          <p:spPr>
            <a:xfrm>
              <a:off x="5331241" y="8186279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MK</a:t>
              </a:r>
            </a:p>
          </p:txBody>
        </p:sp>
        <p:grpSp>
          <p:nvGrpSpPr>
            <p:cNvPr id="600" name="Gruppo 599">
              <a:extLst>
                <a:ext uri="{FF2B5EF4-FFF2-40B4-BE49-F238E27FC236}">
                  <a16:creationId xmlns:a16="http://schemas.microsoft.com/office/drawing/2014/main" id="{23754F77-A586-41DC-B4CA-142EA3626DF8}"/>
                </a:ext>
              </a:extLst>
            </p:cNvPr>
            <p:cNvGrpSpPr/>
            <p:nvPr/>
          </p:nvGrpSpPr>
          <p:grpSpPr>
            <a:xfrm>
              <a:off x="4039565" y="8020294"/>
              <a:ext cx="502435" cy="184666"/>
              <a:chOff x="348853" y="4418665"/>
              <a:chExt cx="502435" cy="184666"/>
            </a:xfrm>
          </p:grpSpPr>
          <p:sp>
            <p:nvSpPr>
              <p:cNvPr id="601" name="CasellaDiTesto 600">
                <a:extLst>
                  <a:ext uri="{FF2B5EF4-FFF2-40B4-BE49-F238E27FC236}">
                    <a16:creationId xmlns:a16="http://schemas.microsoft.com/office/drawing/2014/main" id="{EE589B38-1460-4F57-B477-4CE915E3FE67}"/>
                  </a:ext>
                </a:extLst>
              </p:cNvPr>
              <p:cNvSpPr txBox="1"/>
              <p:nvPr/>
            </p:nvSpPr>
            <p:spPr>
              <a:xfrm>
                <a:off x="34885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602" name="CasellaDiTesto 601">
                <a:extLst>
                  <a:ext uri="{FF2B5EF4-FFF2-40B4-BE49-F238E27FC236}">
                    <a16:creationId xmlns:a16="http://schemas.microsoft.com/office/drawing/2014/main" id="{4AFF26A9-8CDD-4959-9FFD-F25158D2C8FE}"/>
                  </a:ext>
                </a:extLst>
              </p:cNvPr>
              <p:cNvSpPr txBox="1"/>
              <p:nvPr/>
            </p:nvSpPr>
            <p:spPr>
              <a:xfrm>
                <a:off x="433242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  <p:sp>
            <p:nvSpPr>
              <p:cNvPr id="603" name="CasellaDiTesto 602">
                <a:extLst>
                  <a:ext uri="{FF2B5EF4-FFF2-40B4-BE49-F238E27FC236}">
                    <a16:creationId xmlns:a16="http://schemas.microsoft.com/office/drawing/2014/main" id="{766B5342-0079-40DC-9E99-308EA100E6EE}"/>
                  </a:ext>
                </a:extLst>
              </p:cNvPr>
              <p:cNvSpPr txBox="1"/>
              <p:nvPr/>
            </p:nvSpPr>
            <p:spPr>
              <a:xfrm>
                <a:off x="517567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5</a:t>
                </a:r>
              </a:p>
            </p:txBody>
          </p:sp>
          <p:sp>
            <p:nvSpPr>
              <p:cNvPr id="604" name="CasellaDiTesto 603">
                <a:extLst>
                  <a:ext uri="{FF2B5EF4-FFF2-40B4-BE49-F238E27FC236}">
                    <a16:creationId xmlns:a16="http://schemas.microsoft.com/office/drawing/2014/main" id="{92DAB267-09BF-4530-BEA4-C8D8C322B8D6}"/>
                  </a:ext>
                </a:extLst>
              </p:cNvPr>
              <p:cNvSpPr txBox="1"/>
              <p:nvPr/>
            </p:nvSpPr>
            <p:spPr>
              <a:xfrm>
                <a:off x="580060" y="441866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0</a:t>
                </a:r>
              </a:p>
            </p:txBody>
          </p:sp>
        </p:grpSp>
        <p:sp>
          <p:nvSpPr>
            <p:cNvPr id="605" name="CasellaDiTesto 604">
              <a:extLst>
                <a:ext uri="{FF2B5EF4-FFF2-40B4-BE49-F238E27FC236}">
                  <a16:creationId xmlns:a16="http://schemas.microsoft.com/office/drawing/2014/main" id="{B6A68E76-8271-4DBB-906D-E7A7E7B9D377}"/>
                </a:ext>
              </a:extLst>
            </p:cNvPr>
            <p:cNvSpPr txBox="1"/>
            <p:nvPr/>
          </p:nvSpPr>
          <p:spPr>
            <a:xfrm>
              <a:off x="4106118" y="8186279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AZD</a:t>
              </a:r>
            </a:p>
          </p:txBody>
        </p:sp>
        <p:sp>
          <p:nvSpPr>
            <p:cNvPr id="606" name="CasellaDiTesto 605">
              <a:extLst>
                <a:ext uri="{FF2B5EF4-FFF2-40B4-BE49-F238E27FC236}">
                  <a16:creationId xmlns:a16="http://schemas.microsoft.com/office/drawing/2014/main" id="{3FDEF42D-FD3E-435D-AC4D-73D023704244}"/>
                </a:ext>
              </a:extLst>
            </p:cNvPr>
            <p:cNvSpPr txBox="1"/>
            <p:nvPr/>
          </p:nvSpPr>
          <p:spPr>
            <a:xfrm rot="16200000">
              <a:off x="3438692" y="7138594"/>
              <a:ext cx="6735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l-GR" sz="600" dirty="0">
                  <a:latin typeface="Palatino Linotype" panose="02040502050505030304" pitchFamily="18" charset="0"/>
                </a:rPr>
                <a:t>γ</a:t>
              </a:r>
              <a:r>
                <a:rPr lang="it-IT" sz="600" dirty="0"/>
                <a:t>H2AX </a:t>
              </a:r>
              <a:r>
                <a:rPr lang="it-IT" sz="600" dirty="0" err="1">
                  <a:latin typeface="+mn-lt"/>
                  <a:cs typeface="Times New Roman" panose="02020603050405020304" pitchFamily="18" charset="0"/>
                </a:rPr>
                <a:t>levels</a:t>
              </a:r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(</a:t>
              </a:r>
              <a:r>
                <a:rPr lang="it-IT" sz="600" dirty="0" err="1">
                  <a:latin typeface="+mn-lt"/>
                  <a:cs typeface="Times New Roman" panose="02020603050405020304" pitchFamily="18" charset="0"/>
                </a:rPr>
                <a:t>Fold</a:t>
              </a:r>
              <a:r>
                <a:rPr lang="it-IT" sz="600" dirty="0">
                  <a:latin typeface="+mn-lt"/>
                  <a:cs typeface="Times New Roman" panose="02020603050405020304" pitchFamily="18" charset="0"/>
                </a:rPr>
                <a:t> on 0)</a:t>
              </a:r>
              <a:endParaRPr lang="it-IT" sz="600" dirty="0">
                <a:latin typeface="+mn-lt"/>
              </a:endParaRPr>
            </a:p>
          </p:txBody>
        </p:sp>
        <p:grpSp>
          <p:nvGrpSpPr>
            <p:cNvPr id="607" name="Gruppo 606">
              <a:extLst>
                <a:ext uri="{FF2B5EF4-FFF2-40B4-BE49-F238E27FC236}">
                  <a16:creationId xmlns:a16="http://schemas.microsoft.com/office/drawing/2014/main" id="{66522A90-C438-4C22-944F-343CC3886527}"/>
                </a:ext>
              </a:extLst>
            </p:cNvPr>
            <p:cNvGrpSpPr/>
            <p:nvPr/>
          </p:nvGrpSpPr>
          <p:grpSpPr>
            <a:xfrm>
              <a:off x="4812416" y="8020294"/>
              <a:ext cx="527871" cy="184666"/>
              <a:chOff x="726600" y="4418665"/>
              <a:chExt cx="527871" cy="184666"/>
            </a:xfrm>
          </p:grpSpPr>
          <p:sp>
            <p:nvSpPr>
              <p:cNvPr id="608" name="CasellaDiTesto 607">
                <a:extLst>
                  <a:ext uri="{FF2B5EF4-FFF2-40B4-BE49-F238E27FC236}">
                    <a16:creationId xmlns:a16="http://schemas.microsoft.com/office/drawing/2014/main" id="{2C11F9DE-AF31-47E5-929A-0D4EDA2C632C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609" name="CasellaDiTesto 608">
                <a:extLst>
                  <a:ext uri="{FF2B5EF4-FFF2-40B4-BE49-F238E27FC236}">
                    <a16:creationId xmlns:a16="http://schemas.microsoft.com/office/drawing/2014/main" id="{EC032D37-700B-4822-AD81-6655BE9AE429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610" name="CasellaDiTesto 609">
                <a:extLst>
                  <a:ext uri="{FF2B5EF4-FFF2-40B4-BE49-F238E27FC236}">
                    <a16:creationId xmlns:a16="http://schemas.microsoft.com/office/drawing/2014/main" id="{D74E5089-D2E8-4482-8261-60E929A7C8D4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611" name="CasellaDiTesto 610">
                <a:extLst>
                  <a:ext uri="{FF2B5EF4-FFF2-40B4-BE49-F238E27FC236}">
                    <a16:creationId xmlns:a16="http://schemas.microsoft.com/office/drawing/2014/main" id="{5D7FDCD9-6693-4E4E-A76B-16D19D42991C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grpSp>
          <p:nvGrpSpPr>
            <p:cNvPr id="612" name="Gruppo 611">
              <a:extLst>
                <a:ext uri="{FF2B5EF4-FFF2-40B4-BE49-F238E27FC236}">
                  <a16:creationId xmlns:a16="http://schemas.microsoft.com/office/drawing/2014/main" id="{9D28C0CB-2A29-48CA-AE07-8A2341187B6F}"/>
                </a:ext>
              </a:extLst>
            </p:cNvPr>
            <p:cNvGrpSpPr/>
            <p:nvPr/>
          </p:nvGrpSpPr>
          <p:grpSpPr>
            <a:xfrm>
              <a:off x="5230265" y="8020294"/>
              <a:ext cx="527871" cy="184666"/>
              <a:chOff x="726600" y="4418665"/>
              <a:chExt cx="527871" cy="184666"/>
            </a:xfrm>
          </p:grpSpPr>
          <p:sp>
            <p:nvSpPr>
              <p:cNvPr id="613" name="CasellaDiTesto 612">
                <a:extLst>
                  <a:ext uri="{FF2B5EF4-FFF2-40B4-BE49-F238E27FC236}">
                    <a16:creationId xmlns:a16="http://schemas.microsoft.com/office/drawing/2014/main" id="{62312CCA-3D1F-4C70-AFDF-39F8819CEDFA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614" name="CasellaDiTesto 613">
                <a:extLst>
                  <a:ext uri="{FF2B5EF4-FFF2-40B4-BE49-F238E27FC236}">
                    <a16:creationId xmlns:a16="http://schemas.microsoft.com/office/drawing/2014/main" id="{281965F8-2995-4E18-9167-CCBA1BF2F955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615" name="CasellaDiTesto 614">
                <a:extLst>
                  <a:ext uri="{FF2B5EF4-FFF2-40B4-BE49-F238E27FC236}">
                    <a16:creationId xmlns:a16="http://schemas.microsoft.com/office/drawing/2014/main" id="{3A35B3CA-3891-473D-89E1-C2189C57D684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616" name="CasellaDiTesto 615">
                <a:extLst>
                  <a:ext uri="{FF2B5EF4-FFF2-40B4-BE49-F238E27FC236}">
                    <a16:creationId xmlns:a16="http://schemas.microsoft.com/office/drawing/2014/main" id="{206FD3C8-A092-4DB0-BE23-1C7410B80933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grpSp>
          <p:nvGrpSpPr>
            <p:cNvPr id="617" name="Gruppo 616">
              <a:extLst>
                <a:ext uri="{FF2B5EF4-FFF2-40B4-BE49-F238E27FC236}">
                  <a16:creationId xmlns:a16="http://schemas.microsoft.com/office/drawing/2014/main" id="{A69E6815-F866-4D29-B785-E3BA09942193}"/>
                </a:ext>
              </a:extLst>
            </p:cNvPr>
            <p:cNvGrpSpPr/>
            <p:nvPr/>
          </p:nvGrpSpPr>
          <p:grpSpPr>
            <a:xfrm>
              <a:off x="5644162" y="8020294"/>
              <a:ext cx="527871" cy="184666"/>
              <a:chOff x="726600" y="4418665"/>
              <a:chExt cx="527871" cy="184666"/>
            </a:xfrm>
          </p:grpSpPr>
          <p:sp>
            <p:nvSpPr>
              <p:cNvPr id="618" name="CasellaDiTesto 617">
                <a:extLst>
                  <a:ext uri="{FF2B5EF4-FFF2-40B4-BE49-F238E27FC236}">
                    <a16:creationId xmlns:a16="http://schemas.microsoft.com/office/drawing/2014/main" id="{E7B88066-7DE7-4971-8D54-22C4DF4654A8}"/>
                  </a:ext>
                </a:extLst>
              </p:cNvPr>
              <p:cNvSpPr txBox="1"/>
              <p:nvPr/>
            </p:nvSpPr>
            <p:spPr>
              <a:xfrm>
                <a:off x="726600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</a:t>
                </a:r>
              </a:p>
            </p:txBody>
          </p:sp>
          <p:sp>
            <p:nvSpPr>
              <p:cNvPr id="619" name="CasellaDiTesto 618">
                <a:extLst>
                  <a:ext uri="{FF2B5EF4-FFF2-40B4-BE49-F238E27FC236}">
                    <a16:creationId xmlns:a16="http://schemas.microsoft.com/office/drawing/2014/main" id="{3347B53D-0511-4CD4-B31A-0287E3996D6E}"/>
                  </a:ext>
                </a:extLst>
              </p:cNvPr>
              <p:cNvSpPr txBox="1"/>
              <p:nvPr/>
            </p:nvSpPr>
            <p:spPr>
              <a:xfrm>
                <a:off x="791045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1</a:t>
                </a:r>
              </a:p>
            </p:txBody>
          </p:sp>
          <p:sp>
            <p:nvSpPr>
              <p:cNvPr id="620" name="CasellaDiTesto 619">
                <a:extLst>
                  <a:ext uri="{FF2B5EF4-FFF2-40B4-BE49-F238E27FC236}">
                    <a16:creationId xmlns:a16="http://schemas.microsoft.com/office/drawing/2014/main" id="{EC70AEA2-DF30-4AA2-BBF7-E8B5CB98B4F9}"/>
                  </a:ext>
                </a:extLst>
              </p:cNvPr>
              <p:cNvSpPr txBox="1"/>
              <p:nvPr/>
            </p:nvSpPr>
            <p:spPr>
              <a:xfrm>
                <a:off x="908720" y="441866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0.5</a:t>
                </a:r>
              </a:p>
            </p:txBody>
          </p:sp>
          <p:sp>
            <p:nvSpPr>
              <p:cNvPr id="621" name="CasellaDiTesto 620">
                <a:extLst>
                  <a:ext uri="{FF2B5EF4-FFF2-40B4-BE49-F238E27FC236}">
                    <a16:creationId xmlns:a16="http://schemas.microsoft.com/office/drawing/2014/main" id="{B0A01331-D937-4DAE-B53E-1234D0F23DE4}"/>
                  </a:ext>
                </a:extLst>
              </p:cNvPr>
              <p:cNvSpPr txBox="1"/>
              <p:nvPr/>
            </p:nvSpPr>
            <p:spPr>
              <a:xfrm>
                <a:off x="1026523" y="4418665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/>
                  <a:t>1</a:t>
                </a:r>
              </a:p>
            </p:txBody>
          </p:sp>
        </p:grpSp>
        <p:cxnSp>
          <p:nvCxnSpPr>
            <p:cNvPr id="622" name="Connettore diritto 621">
              <a:extLst>
                <a:ext uri="{FF2B5EF4-FFF2-40B4-BE49-F238E27FC236}">
                  <a16:creationId xmlns:a16="http://schemas.microsoft.com/office/drawing/2014/main" id="{123C3D2B-C884-4616-A938-FE42AD9CA9DA}"/>
                </a:ext>
              </a:extLst>
            </p:cNvPr>
            <p:cNvCxnSpPr>
              <a:cxnSpLocks/>
            </p:cNvCxnSpPr>
            <p:nvPr/>
          </p:nvCxnSpPr>
          <p:spPr>
            <a:xfrm>
              <a:off x="4113344" y="8190916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3" name="Connettore diritto 622">
              <a:extLst>
                <a:ext uri="{FF2B5EF4-FFF2-40B4-BE49-F238E27FC236}">
                  <a16:creationId xmlns:a16="http://schemas.microsoft.com/office/drawing/2014/main" id="{82D29C80-328F-46B5-9293-A8972F2C9590}"/>
                </a:ext>
              </a:extLst>
            </p:cNvPr>
            <p:cNvCxnSpPr>
              <a:cxnSpLocks/>
            </p:cNvCxnSpPr>
            <p:nvPr/>
          </p:nvCxnSpPr>
          <p:spPr>
            <a:xfrm>
              <a:off x="4512343" y="8190916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4" name="Connettore diritto 623">
              <a:extLst>
                <a:ext uri="{FF2B5EF4-FFF2-40B4-BE49-F238E27FC236}">
                  <a16:creationId xmlns:a16="http://schemas.microsoft.com/office/drawing/2014/main" id="{CC583077-452A-4EC3-90E2-5CBCE4E20905}"/>
                </a:ext>
              </a:extLst>
            </p:cNvPr>
            <p:cNvCxnSpPr>
              <a:cxnSpLocks/>
            </p:cNvCxnSpPr>
            <p:nvPr/>
          </p:nvCxnSpPr>
          <p:spPr>
            <a:xfrm>
              <a:off x="4907447" y="8190916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5" name="Connettore diritto 624">
              <a:extLst>
                <a:ext uri="{FF2B5EF4-FFF2-40B4-BE49-F238E27FC236}">
                  <a16:creationId xmlns:a16="http://schemas.microsoft.com/office/drawing/2014/main" id="{BBA2B35C-561D-4AAF-96C1-DC8EE3732761}"/>
                </a:ext>
              </a:extLst>
            </p:cNvPr>
            <p:cNvCxnSpPr>
              <a:cxnSpLocks/>
            </p:cNvCxnSpPr>
            <p:nvPr/>
          </p:nvCxnSpPr>
          <p:spPr>
            <a:xfrm>
              <a:off x="5331657" y="8190916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6" name="Connettore diritto 625">
              <a:extLst>
                <a:ext uri="{FF2B5EF4-FFF2-40B4-BE49-F238E27FC236}">
                  <a16:creationId xmlns:a16="http://schemas.microsoft.com/office/drawing/2014/main" id="{44FC66C1-DD1B-47B2-8B2E-831FA2A0BC9B}"/>
                </a:ext>
              </a:extLst>
            </p:cNvPr>
            <p:cNvCxnSpPr>
              <a:cxnSpLocks/>
            </p:cNvCxnSpPr>
            <p:nvPr/>
          </p:nvCxnSpPr>
          <p:spPr>
            <a:xfrm>
              <a:off x="5746689" y="8190916"/>
              <a:ext cx="318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27" name="CasellaDiTesto 626">
              <a:extLst>
                <a:ext uri="{FF2B5EF4-FFF2-40B4-BE49-F238E27FC236}">
                  <a16:creationId xmlns:a16="http://schemas.microsoft.com/office/drawing/2014/main" id="{325C96F4-7638-40EA-A7EC-599490BBD03A}"/>
                </a:ext>
              </a:extLst>
            </p:cNvPr>
            <p:cNvSpPr txBox="1"/>
            <p:nvPr/>
          </p:nvSpPr>
          <p:spPr>
            <a:xfrm>
              <a:off x="3827924" y="7842477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0.0</a:t>
              </a:r>
            </a:p>
          </p:txBody>
        </p:sp>
        <p:sp>
          <p:nvSpPr>
            <p:cNvPr id="628" name="CasellaDiTesto 627">
              <a:extLst>
                <a:ext uri="{FF2B5EF4-FFF2-40B4-BE49-F238E27FC236}">
                  <a16:creationId xmlns:a16="http://schemas.microsoft.com/office/drawing/2014/main" id="{47CC8932-4048-4FC7-A266-878875285923}"/>
                </a:ext>
              </a:extLst>
            </p:cNvPr>
            <p:cNvSpPr txBox="1"/>
            <p:nvPr/>
          </p:nvSpPr>
          <p:spPr>
            <a:xfrm>
              <a:off x="3784644" y="7184010"/>
              <a:ext cx="3353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15.0</a:t>
              </a:r>
            </a:p>
          </p:txBody>
        </p:sp>
        <p:sp>
          <p:nvSpPr>
            <p:cNvPr id="629" name="CasellaDiTesto 628">
              <a:extLst>
                <a:ext uri="{FF2B5EF4-FFF2-40B4-BE49-F238E27FC236}">
                  <a16:creationId xmlns:a16="http://schemas.microsoft.com/office/drawing/2014/main" id="{9D78BE89-DF1D-4389-BC38-75BE69ED06EE}"/>
                </a:ext>
              </a:extLst>
            </p:cNvPr>
            <p:cNvSpPr txBox="1"/>
            <p:nvPr/>
          </p:nvSpPr>
          <p:spPr>
            <a:xfrm>
              <a:off x="3784644" y="6516897"/>
              <a:ext cx="3353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/>
                <a:t>30.0</a:t>
              </a:r>
            </a:p>
          </p:txBody>
        </p:sp>
      </p:grpSp>
      <p:grpSp>
        <p:nvGrpSpPr>
          <p:cNvPr id="664" name="Gruppo 663">
            <a:extLst>
              <a:ext uri="{FF2B5EF4-FFF2-40B4-BE49-F238E27FC236}">
                <a16:creationId xmlns:a16="http://schemas.microsoft.com/office/drawing/2014/main" id="{6801F6E5-6095-4117-897C-7D3665B81C7B}"/>
              </a:ext>
            </a:extLst>
          </p:cNvPr>
          <p:cNvGrpSpPr/>
          <p:nvPr/>
        </p:nvGrpSpPr>
        <p:grpSpPr>
          <a:xfrm>
            <a:off x="329915" y="7247382"/>
            <a:ext cx="2637791" cy="1732591"/>
            <a:chOff x="174077" y="7277692"/>
            <a:chExt cx="2637791" cy="1732591"/>
          </a:xfrm>
        </p:grpSpPr>
        <p:sp>
          <p:nvSpPr>
            <p:cNvPr id="112" name="CasellaDiTesto 111">
              <a:extLst>
                <a:ext uri="{FF2B5EF4-FFF2-40B4-BE49-F238E27FC236}">
                  <a16:creationId xmlns:a16="http://schemas.microsoft.com/office/drawing/2014/main" id="{104CF94A-72E4-4877-905B-CD35A52523D4}"/>
                </a:ext>
              </a:extLst>
            </p:cNvPr>
            <p:cNvSpPr txBox="1"/>
            <p:nvPr/>
          </p:nvSpPr>
          <p:spPr>
            <a:xfrm>
              <a:off x="895051" y="8794839"/>
              <a:ext cx="3818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ER</a:t>
              </a:r>
              <a:r>
                <a:rPr lang="el-G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it-IT" sz="800" dirty="0"/>
            </a:p>
          </p:txBody>
        </p:sp>
        <p:sp>
          <p:nvSpPr>
            <p:cNvPr id="114" name="CasellaDiTesto 113">
              <a:extLst>
                <a:ext uri="{FF2B5EF4-FFF2-40B4-BE49-F238E27FC236}">
                  <a16:creationId xmlns:a16="http://schemas.microsoft.com/office/drawing/2014/main" id="{A1BD986B-0B05-4403-991B-A7654FE0C786}"/>
                </a:ext>
              </a:extLst>
            </p:cNvPr>
            <p:cNvSpPr txBox="1"/>
            <p:nvPr/>
          </p:nvSpPr>
          <p:spPr>
            <a:xfrm>
              <a:off x="2216906" y="8793257"/>
              <a:ext cx="5148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800" dirty="0">
                  <a:latin typeface="Palatino Linotype" panose="02040502050505030304" pitchFamily="18" charset="0"/>
                </a:rPr>
                <a:t>γ</a:t>
              </a:r>
              <a:r>
                <a:rPr lang="it-IT" sz="800" dirty="0"/>
                <a:t>H2AX</a:t>
              </a:r>
            </a:p>
          </p:txBody>
        </p:sp>
        <p:sp>
          <p:nvSpPr>
            <p:cNvPr id="115" name="CasellaDiTesto 114">
              <a:extLst>
                <a:ext uri="{FF2B5EF4-FFF2-40B4-BE49-F238E27FC236}">
                  <a16:creationId xmlns:a16="http://schemas.microsoft.com/office/drawing/2014/main" id="{EA5C8D52-CF10-4B79-91E9-9202823D9378}"/>
                </a:ext>
              </a:extLst>
            </p:cNvPr>
            <p:cNvSpPr txBox="1"/>
            <p:nvPr/>
          </p:nvSpPr>
          <p:spPr>
            <a:xfrm>
              <a:off x="1556526" y="8793257"/>
              <a:ext cx="453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RPA2</a:t>
              </a:r>
            </a:p>
          </p:txBody>
        </p:sp>
        <p:pic>
          <p:nvPicPr>
            <p:cNvPr id="633" name="Immagine 632">
              <a:extLst>
                <a:ext uri="{FF2B5EF4-FFF2-40B4-BE49-F238E27FC236}">
                  <a16:creationId xmlns:a16="http://schemas.microsoft.com/office/drawing/2014/main" id="{E2AFECE9-243E-43AF-84C0-711F788086A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95403" y="7353257"/>
              <a:ext cx="2116465" cy="1440000"/>
            </a:xfrm>
            <a:prstGeom prst="rect">
              <a:avLst/>
            </a:prstGeom>
          </p:spPr>
        </p:pic>
        <p:pic>
          <p:nvPicPr>
            <p:cNvPr id="634" name="Immagine 633">
              <a:extLst>
                <a:ext uri="{FF2B5EF4-FFF2-40B4-BE49-F238E27FC236}">
                  <a16:creationId xmlns:a16="http://schemas.microsoft.com/office/drawing/2014/main" id="{A410E42B-9E0D-4FAA-8A28-E00F3EDFAC3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45248" y="7353257"/>
              <a:ext cx="157936" cy="720000"/>
            </a:xfrm>
            <a:prstGeom prst="rect">
              <a:avLst/>
            </a:prstGeom>
          </p:spPr>
        </p:pic>
        <p:sp>
          <p:nvSpPr>
            <p:cNvPr id="635" name="CasellaDiTesto 634">
              <a:extLst>
                <a:ext uri="{FF2B5EF4-FFF2-40B4-BE49-F238E27FC236}">
                  <a16:creationId xmlns:a16="http://schemas.microsoft.com/office/drawing/2014/main" id="{BE784ECA-9A07-4625-B54C-84C303788E45}"/>
                </a:ext>
              </a:extLst>
            </p:cNvPr>
            <p:cNvSpPr txBox="1"/>
            <p:nvPr/>
          </p:nvSpPr>
          <p:spPr>
            <a:xfrm>
              <a:off x="960574" y="7284543"/>
              <a:ext cx="3946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CTR</a:t>
              </a:r>
            </a:p>
          </p:txBody>
        </p:sp>
        <p:sp>
          <p:nvSpPr>
            <p:cNvPr id="636" name="CasellaDiTesto 635">
              <a:extLst>
                <a:ext uri="{FF2B5EF4-FFF2-40B4-BE49-F238E27FC236}">
                  <a16:creationId xmlns:a16="http://schemas.microsoft.com/office/drawing/2014/main" id="{9CD2330C-12AE-45D1-9A92-0D8EE6BC1644}"/>
                </a:ext>
              </a:extLst>
            </p:cNvPr>
            <p:cNvSpPr txBox="1"/>
            <p:nvPr/>
          </p:nvSpPr>
          <p:spPr>
            <a:xfrm>
              <a:off x="960574" y="7418486"/>
              <a:ext cx="3321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HU</a:t>
              </a:r>
            </a:p>
          </p:txBody>
        </p:sp>
        <p:sp>
          <p:nvSpPr>
            <p:cNvPr id="637" name="CasellaDiTesto 636">
              <a:extLst>
                <a:ext uri="{FF2B5EF4-FFF2-40B4-BE49-F238E27FC236}">
                  <a16:creationId xmlns:a16="http://schemas.microsoft.com/office/drawing/2014/main" id="{C0693577-8F71-47D7-96D6-4ADD3894975A}"/>
                </a:ext>
              </a:extLst>
            </p:cNvPr>
            <p:cNvSpPr txBox="1"/>
            <p:nvPr/>
          </p:nvSpPr>
          <p:spPr>
            <a:xfrm>
              <a:off x="960574" y="7542066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ET</a:t>
              </a:r>
            </a:p>
          </p:txBody>
        </p:sp>
        <p:sp>
          <p:nvSpPr>
            <p:cNvPr id="638" name="CasellaDiTesto 637">
              <a:extLst>
                <a:ext uri="{FF2B5EF4-FFF2-40B4-BE49-F238E27FC236}">
                  <a16:creationId xmlns:a16="http://schemas.microsoft.com/office/drawing/2014/main" id="{D4598CFE-7C56-4E22-9980-84459DCC3BE5}"/>
                </a:ext>
              </a:extLst>
            </p:cNvPr>
            <p:cNvSpPr txBox="1"/>
            <p:nvPr/>
          </p:nvSpPr>
          <p:spPr>
            <a:xfrm>
              <a:off x="960574" y="7669642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CPT</a:t>
              </a:r>
            </a:p>
          </p:txBody>
        </p:sp>
        <p:sp>
          <p:nvSpPr>
            <p:cNvPr id="639" name="CasellaDiTesto 638">
              <a:extLst>
                <a:ext uri="{FF2B5EF4-FFF2-40B4-BE49-F238E27FC236}">
                  <a16:creationId xmlns:a16="http://schemas.microsoft.com/office/drawing/2014/main" id="{AD6B4E77-FAF0-454A-9262-B42226CF8EDD}"/>
                </a:ext>
              </a:extLst>
            </p:cNvPr>
            <p:cNvSpPr txBox="1"/>
            <p:nvPr/>
          </p:nvSpPr>
          <p:spPr>
            <a:xfrm>
              <a:off x="960574" y="7797192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 err="1"/>
                <a:t>Aph</a:t>
              </a:r>
              <a:endParaRPr lang="it-IT" sz="800" dirty="0"/>
            </a:p>
          </p:txBody>
        </p:sp>
        <p:sp>
          <p:nvSpPr>
            <p:cNvPr id="640" name="CasellaDiTesto 639">
              <a:extLst>
                <a:ext uri="{FF2B5EF4-FFF2-40B4-BE49-F238E27FC236}">
                  <a16:creationId xmlns:a16="http://schemas.microsoft.com/office/drawing/2014/main" id="{727386A9-E6C5-464F-8CB1-F96EECCA507B}"/>
                </a:ext>
              </a:extLst>
            </p:cNvPr>
            <p:cNvSpPr txBox="1"/>
            <p:nvPr/>
          </p:nvSpPr>
          <p:spPr>
            <a:xfrm>
              <a:off x="960574" y="7919867"/>
              <a:ext cx="58541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Rx 10Gy</a:t>
              </a:r>
            </a:p>
          </p:txBody>
        </p:sp>
        <p:sp>
          <p:nvSpPr>
            <p:cNvPr id="641" name="CasellaDiTesto 640">
              <a:extLst>
                <a:ext uri="{FF2B5EF4-FFF2-40B4-BE49-F238E27FC236}">
                  <a16:creationId xmlns:a16="http://schemas.microsoft.com/office/drawing/2014/main" id="{C1DD63F2-A8FF-4685-AFC9-07A71B60D5B8}"/>
                </a:ext>
              </a:extLst>
            </p:cNvPr>
            <p:cNvSpPr txBox="1"/>
            <p:nvPr/>
          </p:nvSpPr>
          <p:spPr>
            <a:xfrm>
              <a:off x="790908" y="8196664"/>
              <a:ext cx="4956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/>
                <a:t>MCF-7</a:t>
              </a:r>
            </a:p>
          </p:txBody>
        </p:sp>
        <p:sp>
          <p:nvSpPr>
            <p:cNvPr id="642" name="CasellaDiTesto 641">
              <a:extLst>
                <a:ext uri="{FF2B5EF4-FFF2-40B4-BE49-F238E27FC236}">
                  <a16:creationId xmlns:a16="http://schemas.microsoft.com/office/drawing/2014/main" id="{59879B6F-72AC-452E-BE9D-5109159119A7}"/>
                </a:ext>
              </a:extLst>
            </p:cNvPr>
            <p:cNvSpPr txBox="1"/>
            <p:nvPr/>
          </p:nvSpPr>
          <p:spPr>
            <a:xfrm>
              <a:off x="466900" y="8612559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0.0</a:t>
              </a:r>
            </a:p>
          </p:txBody>
        </p:sp>
        <p:sp>
          <p:nvSpPr>
            <p:cNvPr id="643" name="CasellaDiTesto 642">
              <a:extLst>
                <a:ext uri="{FF2B5EF4-FFF2-40B4-BE49-F238E27FC236}">
                  <a16:creationId xmlns:a16="http://schemas.microsoft.com/office/drawing/2014/main" id="{5B94EBE7-3A41-43C5-A983-EF67190E451F}"/>
                </a:ext>
              </a:extLst>
            </p:cNvPr>
            <p:cNvSpPr txBox="1"/>
            <p:nvPr/>
          </p:nvSpPr>
          <p:spPr>
            <a:xfrm>
              <a:off x="466900" y="7927473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5.0</a:t>
              </a:r>
            </a:p>
          </p:txBody>
        </p:sp>
        <p:sp>
          <p:nvSpPr>
            <p:cNvPr id="644" name="CasellaDiTesto 643">
              <a:extLst>
                <a:ext uri="{FF2B5EF4-FFF2-40B4-BE49-F238E27FC236}">
                  <a16:creationId xmlns:a16="http://schemas.microsoft.com/office/drawing/2014/main" id="{82129971-52FA-46D9-85CA-E3B0F86BABF4}"/>
                </a:ext>
              </a:extLst>
            </p:cNvPr>
            <p:cNvSpPr txBox="1"/>
            <p:nvPr/>
          </p:nvSpPr>
          <p:spPr>
            <a:xfrm>
              <a:off x="409192" y="7277692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40.0</a:t>
              </a:r>
            </a:p>
          </p:txBody>
        </p:sp>
        <p:sp>
          <p:nvSpPr>
            <p:cNvPr id="645" name="CasellaDiTesto 644">
              <a:extLst>
                <a:ext uri="{FF2B5EF4-FFF2-40B4-BE49-F238E27FC236}">
                  <a16:creationId xmlns:a16="http://schemas.microsoft.com/office/drawing/2014/main" id="{774021C9-938A-468D-8790-34FAC81C89CD}"/>
                </a:ext>
              </a:extLst>
            </p:cNvPr>
            <p:cNvSpPr txBox="1"/>
            <p:nvPr/>
          </p:nvSpPr>
          <p:spPr>
            <a:xfrm rot="16200000">
              <a:off x="-75992" y="7870704"/>
              <a:ext cx="8386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 err="1"/>
                <a:t>Protein</a:t>
              </a:r>
              <a:r>
                <a:rPr lang="it-IT" sz="800" dirty="0"/>
                <a:t> </a:t>
              </a:r>
              <a:r>
                <a:rPr lang="it-IT" sz="800" dirty="0" err="1"/>
                <a:t>Levels</a:t>
              </a:r>
              <a:endParaRPr lang="it-IT" sz="800" dirty="0"/>
            </a:p>
            <a:p>
              <a:pPr algn="ctr"/>
              <a:r>
                <a:rPr lang="it-IT" sz="800" dirty="0"/>
                <a:t>(</a:t>
              </a:r>
              <a:r>
                <a:rPr lang="it-IT" sz="800" dirty="0" err="1"/>
                <a:t>Fold</a:t>
              </a:r>
              <a:r>
                <a:rPr lang="it-IT" sz="800" dirty="0"/>
                <a:t> on CTR)</a:t>
              </a:r>
            </a:p>
          </p:txBody>
        </p:sp>
      </p:grpSp>
      <p:grpSp>
        <p:nvGrpSpPr>
          <p:cNvPr id="663" name="Gruppo 662">
            <a:extLst>
              <a:ext uri="{FF2B5EF4-FFF2-40B4-BE49-F238E27FC236}">
                <a16:creationId xmlns:a16="http://schemas.microsoft.com/office/drawing/2014/main" id="{E47DEF8B-B12E-430E-A4FA-C710F51472ED}"/>
              </a:ext>
            </a:extLst>
          </p:cNvPr>
          <p:cNvGrpSpPr/>
          <p:nvPr/>
        </p:nvGrpSpPr>
        <p:grpSpPr>
          <a:xfrm>
            <a:off x="3671529" y="7247382"/>
            <a:ext cx="2637791" cy="1732591"/>
            <a:chOff x="3522846" y="7217071"/>
            <a:chExt cx="2637791" cy="1732591"/>
          </a:xfrm>
        </p:grpSpPr>
        <p:pic>
          <p:nvPicPr>
            <p:cNvPr id="662" name="Immagine 661">
              <a:extLst>
                <a:ext uri="{FF2B5EF4-FFF2-40B4-BE49-F238E27FC236}">
                  <a16:creationId xmlns:a16="http://schemas.microsoft.com/office/drawing/2014/main" id="{B3E28D3D-F602-4051-9FB4-C9042903324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044172" y="7292636"/>
              <a:ext cx="2116465" cy="1440000"/>
            </a:xfrm>
            <a:prstGeom prst="rect">
              <a:avLst/>
            </a:prstGeom>
          </p:spPr>
        </p:pic>
        <p:sp>
          <p:nvSpPr>
            <p:cNvPr id="646" name="CasellaDiTesto 645">
              <a:extLst>
                <a:ext uri="{FF2B5EF4-FFF2-40B4-BE49-F238E27FC236}">
                  <a16:creationId xmlns:a16="http://schemas.microsoft.com/office/drawing/2014/main" id="{6DFACB0B-141B-4E3D-9EA8-BBF5717D48B6}"/>
                </a:ext>
              </a:extLst>
            </p:cNvPr>
            <p:cNvSpPr txBox="1"/>
            <p:nvPr/>
          </p:nvSpPr>
          <p:spPr>
            <a:xfrm>
              <a:off x="4243820" y="8734218"/>
              <a:ext cx="3818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ER</a:t>
              </a:r>
              <a:r>
                <a:rPr lang="el-G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it-IT" sz="800" dirty="0"/>
            </a:p>
          </p:txBody>
        </p:sp>
        <p:sp>
          <p:nvSpPr>
            <p:cNvPr id="647" name="CasellaDiTesto 646">
              <a:extLst>
                <a:ext uri="{FF2B5EF4-FFF2-40B4-BE49-F238E27FC236}">
                  <a16:creationId xmlns:a16="http://schemas.microsoft.com/office/drawing/2014/main" id="{2B0E1C1C-2F31-4DA3-9D2A-22A6DB6B8D23}"/>
                </a:ext>
              </a:extLst>
            </p:cNvPr>
            <p:cNvSpPr txBox="1"/>
            <p:nvPr/>
          </p:nvSpPr>
          <p:spPr>
            <a:xfrm>
              <a:off x="5565675" y="8732636"/>
              <a:ext cx="5148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800" dirty="0">
                  <a:latin typeface="Palatino Linotype" panose="02040502050505030304" pitchFamily="18" charset="0"/>
                </a:rPr>
                <a:t>γ</a:t>
              </a:r>
              <a:r>
                <a:rPr lang="it-IT" sz="800" dirty="0"/>
                <a:t>H2AX</a:t>
              </a:r>
            </a:p>
          </p:txBody>
        </p:sp>
        <p:sp>
          <p:nvSpPr>
            <p:cNvPr id="648" name="CasellaDiTesto 647">
              <a:extLst>
                <a:ext uri="{FF2B5EF4-FFF2-40B4-BE49-F238E27FC236}">
                  <a16:creationId xmlns:a16="http://schemas.microsoft.com/office/drawing/2014/main" id="{E62D167C-793D-4CD9-92A7-2A1CA2C8F26B}"/>
                </a:ext>
              </a:extLst>
            </p:cNvPr>
            <p:cNvSpPr txBox="1"/>
            <p:nvPr/>
          </p:nvSpPr>
          <p:spPr>
            <a:xfrm>
              <a:off x="4905295" y="8732636"/>
              <a:ext cx="453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RPA2</a:t>
              </a:r>
            </a:p>
          </p:txBody>
        </p:sp>
        <p:pic>
          <p:nvPicPr>
            <p:cNvPr id="650" name="Immagine 649">
              <a:extLst>
                <a:ext uri="{FF2B5EF4-FFF2-40B4-BE49-F238E27FC236}">
                  <a16:creationId xmlns:a16="http://schemas.microsoft.com/office/drawing/2014/main" id="{BA46438E-9426-42F0-941B-B8CB92BFD16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194017" y="7292636"/>
              <a:ext cx="157936" cy="720000"/>
            </a:xfrm>
            <a:prstGeom prst="rect">
              <a:avLst/>
            </a:prstGeom>
          </p:spPr>
        </p:pic>
        <p:sp>
          <p:nvSpPr>
            <p:cNvPr id="651" name="CasellaDiTesto 650">
              <a:extLst>
                <a:ext uri="{FF2B5EF4-FFF2-40B4-BE49-F238E27FC236}">
                  <a16:creationId xmlns:a16="http://schemas.microsoft.com/office/drawing/2014/main" id="{C0F32B31-5A9B-4961-8ADB-03E49F31A7A8}"/>
                </a:ext>
              </a:extLst>
            </p:cNvPr>
            <p:cNvSpPr txBox="1"/>
            <p:nvPr/>
          </p:nvSpPr>
          <p:spPr>
            <a:xfrm>
              <a:off x="4309343" y="7223922"/>
              <a:ext cx="3946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CTR</a:t>
              </a:r>
            </a:p>
          </p:txBody>
        </p:sp>
        <p:sp>
          <p:nvSpPr>
            <p:cNvPr id="652" name="CasellaDiTesto 651">
              <a:extLst>
                <a:ext uri="{FF2B5EF4-FFF2-40B4-BE49-F238E27FC236}">
                  <a16:creationId xmlns:a16="http://schemas.microsoft.com/office/drawing/2014/main" id="{D90C61C0-D667-4ABD-BA9A-95B7C61CE38F}"/>
                </a:ext>
              </a:extLst>
            </p:cNvPr>
            <p:cNvSpPr txBox="1"/>
            <p:nvPr/>
          </p:nvSpPr>
          <p:spPr>
            <a:xfrm>
              <a:off x="4309343" y="7357865"/>
              <a:ext cx="3321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HU</a:t>
              </a:r>
            </a:p>
          </p:txBody>
        </p:sp>
        <p:sp>
          <p:nvSpPr>
            <p:cNvPr id="653" name="CasellaDiTesto 652">
              <a:extLst>
                <a:ext uri="{FF2B5EF4-FFF2-40B4-BE49-F238E27FC236}">
                  <a16:creationId xmlns:a16="http://schemas.microsoft.com/office/drawing/2014/main" id="{6E2676A1-FFAF-42D9-842C-75E6252CBB4D}"/>
                </a:ext>
              </a:extLst>
            </p:cNvPr>
            <p:cNvSpPr txBox="1"/>
            <p:nvPr/>
          </p:nvSpPr>
          <p:spPr>
            <a:xfrm>
              <a:off x="4309343" y="7481445"/>
              <a:ext cx="3161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ET</a:t>
              </a:r>
            </a:p>
          </p:txBody>
        </p:sp>
        <p:sp>
          <p:nvSpPr>
            <p:cNvPr id="654" name="CasellaDiTesto 653">
              <a:extLst>
                <a:ext uri="{FF2B5EF4-FFF2-40B4-BE49-F238E27FC236}">
                  <a16:creationId xmlns:a16="http://schemas.microsoft.com/office/drawing/2014/main" id="{FD78B50C-4494-4591-A37B-E84A22040212}"/>
                </a:ext>
              </a:extLst>
            </p:cNvPr>
            <p:cNvSpPr txBox="1"/>
            <p:nvPr/>
          </p:nvSpPr>
          <p:spPr>
            <a:xfrm>
              <a:off x="4309343" y="7609021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CPT</a:t>
              </a:r>
            </a:p>
          </p:txBody>
        </p:sp>
        <p:sp>
          <p:nvSpPr>
            <p:cNvPr id="655" name="CasellaDiTesto 654">
              <a:extLst>
                <a:ext uri="{FF2B5EF4-FFF2-40B4-BE49-F238E27FC236}">
                  <a16:creationId xmlns:a16="http://schemas.microsoft.com/office/drawing/2014/main" id="{27C3DA2D-BB87-451C-8EE8-981EE04128DA}"/>
                </a:ext>
              </a:extLst>
            </p:cNvPr>
            <p:cNvSpPr txBox="1"/>
            <p:nvPr/>
          </p:nvSpPr>
          <p:spPr>
            <a:xfrm>
              <a:off x="4309343" y="7736571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 err="1"/>
                <a:t>Aph</a:t>
              </a:r>
              <a:endParaRPr lang="it-IT" sz="800" dirty="0"/>
            </a:p>
          </p:txBody>
        </p:sp>
        <p:sp>
          <p:nvSpPr>
            <p:cNvPr id="656" name="CasellaDiTesto 655">
              <a:extLst>
                <a:ext uri="{FF2B5EF4-FFF2-40B4-BE49-F238E27FC236}">
                  <a16:creationId xmlns:a16="http://schemas.microsoft.com/office/drawing/2014/main" id="{2D4B08DC-B673-4AAE-8327-9EF603BA5DA5}"/>
                </a:ext>
              </a:extLst>
            </p:cNvPr>
            <p:cNvSpPr txBox="1"/>
            <p:nvPr/>
          </p:nvSpPr>
          <p:spPr>
            <a:xfrm>
              <a:off x="4309343" y="7859246"/>
              <a:ext cx="58541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Rx 10Gy</a:t>
              </a:r>
            </a:p>
          </p:txBody>
        </p:sp>
        <p:sp>
          <p:nvSpPr>
            <p:cNvPr id="657" name="CasellaDiTesto 656">
              <a:extLst>
                <a:ext uri="{FF2B5EF4-FFF2-40B4-BE49-F238E27FC236}">
                  <a16:creationId xmlns:a16="http://schemas.microsoft.com/office/drawing/2014/main" id="{706B9D02-9C02-4CC0-BA11-A62B38F1D941}"/>
                </a:ext>
              </a:extLst>
            </p:cNvPr>
            <p:cNvSpPr txBox="1"/>
            <p:nvPr/>
          </p:nvSpPr>
          <p:spPr>
            <a:xfrm>
              <a:off x="4139677" y="8136043"/>
              <a:ext cx="4956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/>
                <a:t>Y537S</a:t>
              </a:r>
            </a:p>
          </p:txBody>
        </p:sp>
        <p:sp>
          <p:nvSpPr>
            <p:cNvPr id="658" name="CasellaDiTesto 657">
              <a:extLst>
                <a:ext uri="{FF2B5EF4-FFF2-40B4-BE49-F238E27FC236}">
                  <a16:creationId xmlns:a16="http://schemas.microsoft.com/office/drawing/2014/main" id="{3D839ED6-60C4-4CC2-8930-8F2FD58C81DC}"/>
                </a:ext>
              </a:extLst>
            </p:cNvPr>
            <p:cNvSpPr txBox="1"/>
            <p:nvPr/>
          </p:nvSpPr>
          <p:spPr>
            <a:xfrm>
              <a:off x="3815669" y="8551938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0.0</a:t>
              </a:r>
            </a:p>
          </p:txBody>
        </p:sp>
        <p:sp>
          <p:nvSpPr>
            <p:cNvPr id="659" name="CasellaDiTesto 658">
              <a:extLst>
                <a:ext uri="{FF2B5EF4-FFF2-40B4-BE49-F238E27FC236}">
                  <a16:creationId xmlns:a16="http://schemas.microsoft.com/office/drawing/2014/main" id="{D84525FF-24F1-456F-8814-70BE1DDB83D8}"/>
                </a:ext>
              </a:extLst>
            </p:cNvPr>
            <p:cNvSpPr txBox="1"/>
            <p:nvPr/>
          </p:nvSpPr>
          <p:spPr>
            <a:xfrm>
              <a:off x="3815669" y="7866852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5.0</a:t>
              </a:r>
            </a:p>
          </p:txBody>
        </p:sp>
        <p:sp>
          <p:nvSpPr>
            <p:cNvPr id="660" name="CasellaDiTesto 659">
              <a:extLst>
                <a:ext uri="{FF2B5EF4-FFF2-40B4-BE49-F238E27FC236}">
                  <a16:creationId xmlns:a16="http://schemas.microsoft.com/office/drawing/2014/main" id="{8F86B1BE-595D-428F-9654-A3EA8E68131D}"/>
                </a:ext>
              </a:extLst>
            </p:cNvPr>
            <p:cNvSpPr txBox="1"/>
            <p:nvPr/>
          </p:nvSpPr>
          <p:spPr>
            <a:xfrm>
              <a:off x="3757961" y="721707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40.0</a:t>
              </a:r>
            </a:p>
          </p:txBody>
        </p:sp>
        <p:sp>
          <p:nvSpPr>
            <p:cNvPr id="661" name="CasellaDiTesto 660">
              <a:extLst>
                <a:ext uri="{FF2B5EF4-FFF2-40B4-BE49-F238E27FC236}">
                  <a16:creationId xmlns:a16="http://schemas.microsoft.com/office/drawing/2014/main" id="{ADB6F71A-8B50-4234-8E2A-92BD23677A9F}"/>
                </a:ext>
              </a:extLst>
            </p:cNvPr>
            <p:cNvSpPr txBox="1"/>
            <p:nvPr/>
          </p:nvSpPr>
          <p:spPr>
            <a:xfrm rot="16200000">
              <a:off x="3272777" y="7810083"/>
              <a:ext cx="8386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 err="1"/>
                <a:t>Protein</a:t>
              </a:r>
              <a:r>
                <a:rPr lang="it-IT" sz="800" dirty="0"/>
                <a:t> </a:t>
              </a:r>
              <a:r>
                <a:rPr lang="it-IT" sz="800" dirty="0" err="1"/>
                <a:t>Levels</a:t>
              </a:r>
              <a:endParaRPr lang="it-IT" sz="800" dirty="0"/>
            </a:p>
            <a:p>
              <a:pPr algn="ctr"/>
              <a:r>
                <a:rPr lang="it-IT" sz="800" dirty="0"/>
                <a:t>(</a:t>
              </a:r>
              <a:r>
                <a:rPr lang="it-IT" sz="800" dirty="0" err="1"/>
                <a:t>Fold</a:t>
              </a:r>
              <a:r>
                <a:rPr lang="it-IT" sz="800" dirty="0"/>
                <a:t> on CTR)</a:t>
              </a:r>
            </a:p>
          </p:txBody>
        </p:sp>
      </p:grpSp>
      <p:sp>
        <p:nvSpPr>
          <p:cNvPr id="665" name="CasellaDiTesto 664">
            <a:extLst>
              <a:ext uri="{FF2B5EF4-FFF2-40B4-BE49-F238E27FC236}">
                <a16:creationId xmlns:a16="http://schemas.microsoft.com/office/drawing/2014/main" id="{C30AD504-8939-4AFE-B510-3149357D2E7B}"/>
              </a:ext>
            </a:extLst>
          </p:cNvPr>
          <p:cNvSpPr txBox="1"/>
          <p:nvPr/>
        </p:nvSpPr>
        <p:spPr>
          <a:xfrm>
            <a:off x="174598" y="45998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A</a:t>
            </a:r>
          </a:p>
        </p:txBody>
      </p:sp>
      <p:sp>
        <p:nvSpPr>
          <p:cNvPr id="666" name="CasellaDiTesto 665">
            <a:extLst>
              <a:ext uri="{FF2B5EF4-FFF2-40B4-BE49-F238E27FC236}">
                <a16:creationId xmlns:a16="http://schemas.microsoft.com/office/drawing/2014/main" id="{7AD48628-674B-4EFD-8303-2441258707C5}"/>
              </a:ext>
            </a:extLst>
          </p:cNvPr>
          <p:cNvSpPr txBox="1"/>
          <p:nvPr/>
        </p:nvSpPr>
        <p:spPr>
          <a:xfrm>
            <a:off x="3558119" y="44379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E</a:t>
            </a:r>
          </a:p>
        </p:txBody>
      </p:sp>
      <p:sp>
        <p:nvSpPr>
          <p:cNvPr id="667" name="CasellaDiTesto 666">
            <a:extLst>
              <a:ext uri="{FF2B5EF4-FFF2-40B4-BE49-F238E27FC236}">
                <a16:creationId xmlns:a16="http://schemas.microsoft.com/office/drawing/2014/main" id="{63DB0A4B-B65E-40A0-A874-5B61A4EDB3F1}"/>
              </a:ext>
            </a:extLst>
          </p:cNvPr>
          <p:cNvSpPr txBox="1"/>
          <p:nvPr/>
        </p:nvSpPr>
        <p:spPr>
          <a:xfrm>
            <a:off x="174598" y="256160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B</a:t>
            </a:r>
          </a:p>
        </p:txBody>
      </p:sp>
      <p:sp>
        <p:nvSpPr>
          <p:cNvPr id="668" name="CasellaDiTesto 667">
            <a:extLst>
              <a:ext uri="{FF2B5EF4-FFF2-40B4-BE49-F238E27FC236}">
                <a16:creationId xmlns:a16="http://schemas.microsoft.com/office/drawing/2014/main" id="{ABC334DD-252A-475E-8B59-93F90492C498}"/>
              </a:ext>
            </a:extLst>
          </p:cNvPr>
          <p:cNvSpPr txBox="1"/>
          <p:nvPr/>
        </p:nvSpPr>
        <p:spPr>
          <a:xfrm>
            <a:off x="3558119" y="256160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F</a:t>
            </a:r>
          </a:p>
        </p:txBody>
      </p:sp>
      <p:sp>
        <p:nvSpPr>
          <p:cNvPr id="669" name="CasellaDiTesto 668">
            <a:extLst>
              <a:ext uri="{FF2B5EF4-FFF2-40B4-BE49-F238E27FC236}">
                <a16:creationId xmlns:a16="http://schemas.microsoft.com/office/drawing/2014/main" id="{337075A9-A06A-4CA5-AA6F-9061E50802EC}"/>
              </a:ext>
            </a:extLst>
          </p:cNvPr>
          <p:cNvSpPr txBox="1"/>
          <p:nvPr/>
        </p:nvSpPr>
        <p:spPr>
          <a:xfrm>
            <a:off x="174598" y="474147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C</a:t>
            </a:r>
          </a:p>
        </p:txBody>
      </p:sp>
      <p:sp>
        <p:nvSpPr>
          <p:cNvPr id="670" name="CasellaDiTesto 669">
            <a:extLst>
              <a:ext uri="{FF2B5EF4-FFF2-40B4-BE49-F238E27FC236}">
                <a16:creationId xmlns:a16="http://schemas.microsoft.com/office/drawing/2014/main" id="{A2A06F85-C998-4DD1-B442-D3A53E537960}"/>
              </a:ext>
            </a:extLst>
          </p:cNvPr>
          <p:cNvSpPr txBox="1"/>
          <p:nvPr/>
        </p:nvSpPr>
        <p:spPr>
          <a:xfrm>
            <a:off x="3558119" y="4741478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G</a:t>
            </a:r>
          </a:p>
        </p:txBody>
      </p:sp>
      <p:sp>
        <p:nvSpPr>
          <p:cNvPr id="671" name="CasellaDiTesto 670">
            <a:extLst>
              <a:ext uri="{FF2B5EF4-FFF2-40B4-BE49-F238E27FC236}">
                <a16:creationId xmlns:a16="http://schemas.microsoft.com/office/drawing/2014/main" id="{5C3B9A74-39CE-4C63-8B10-928CFD6A71FA}"/>
              </a:ext>
            </a:extLst>
          </p:cNvPr>
          <p:cNvSpPr txBox="1"/>
          <p:nvPr/>
        </p:nvSpPr>
        <p:spPr>
          <a:xfrm>
            <a:off x="174598" y="70219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D</a:t>
            </a:r>
          </a:p>
        </p:txBody>
      </p:sp>
      <p:sp>
        <p:nvSpPr>
          <p:cNvPr id="672" name="CasellaDiTesto 671">
            <a:extLst>
              <a:ext uri="{FF2B5EF4-FFF2-40B4-BE49-F238E27FC236}">
                <a16:creationId xmlns:a16="http://schemas.microsoft.com/office/drawing/2014/main" id="{73600A0C-6473-487C-9674-4B85DE71D5B6}"/>
              </a:ext>
            </a:extLst>
          </p:cNvPr>
          <p:cNvSpPr txBox="1"/>
          <p:nvPr/>
        </p:nvSpPr>
        <p:spPr>
          <a:xfrm>
            <a:off x="3558119" y="70219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2336920806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45</TotalTime>
  <Words>1444</Words>
  <Application>Microsoft Office PowerPoint</Application>
  <PresentationFormat>Presentazione su schermo (4:3)</PresentationFormat>
  <Paragraphs>957</Paragraphs>
  <Slides>7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7</vt:i4>
      </vt:variant>
    </vt:vector>
  </HeadingPairs>
  <TitlesOfParts>
    <vt:vector size="12" baseType="lpstr">
      <vt:lpstr>Arial</vt:lpstr>
      <vt:lpstr>Calibri</vt:lpstr>
      <vt:lpstr>Palatino Linotype</vt:lpstr>
      <vt:lpstr>Times New Roman</vt:lpstr>
      <vt:lpstr>Default Design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ilippo Acconcia</dc:creator>
  <cp:lastModifiedBy>Filippo Acconcia</cp:lastModifiedBy>
  <cp:revision>618</cp:revision>
  <cp:lastPrinted>2022-02-04T16:08:39Z</cp:lastPrinted>
  <dcterms:created xsi:type="dcterms:W3CDTF">2014-12-18T14:53:45Z</dcterms:created>
  <dcterms:modified xsi:type="dcterms:W3CDTF">2022-03-25T14:34:56Z</dcterms:modified>
</cp:coreProperties>
</file>